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56" r:id="rId2"/>
    <p:sldId id="366" r:id="rId3"/>
    <p:sldId id="364" r:id="rId4"/>
    <p:sldId id="365" r:id="rId5"/>
    <p:sldId id="296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8000"/>
    <a:srgbClr val="808000"/>
    <a:srgbClr val="006600"/>
    <a:srgbClr val="003399"/>
    <a:srgbClr val="000099"/>
    <a:srgbClr val="A50021"/>
    <a:srgbClr val="9933FF"/>
    <a:srgbClr val="FF9933"/>
    <a:srgbClr val="0099CC"/>
    <a:srgbClr val="FF99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196E1E8-070C-474D-888C-CEA90273A304}" v="20" dt="2020-04-14T11:23:48.671"/>
    <p1510:client id="{64D1738D-F0F2-4F33-B73E-6056640154D5}" v="1000" dt="2020-04-15T08:26:39.59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755" autoAdjust="0"/>
    <p:restoredTop sz="78713" autoAdjust="0"/>
  </p:normalViewPr>
  <p:slideViewPr>
    <p:cSldViewPr snapToGrid="0">
      <p:cViewPr varScale="1">
        <p:scale>
          <a:sx n="75" d="100"/>
          <a:sy n="75" d="100"/>
        </p:scale>
        <p:origin x="3161" y="5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40" d="100"/>
        <a:sy n="4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ew Leng Lim" userId="f4956819b06a5395" providerId="LiveId" clId="{BBF1F103-3A88-452F-9C24-5AE70FC726E3}"/>
    <pc:docChg chg="custSel modSld">
      <pc:chgData name="Chew Leng Lim" userId="f4956819b06a5395" providerId="LiveId" clId="{BBF1F103-3A88-452F-9C24-5AE70FC726E3}" dt="2019-12-12T09:13:04.531" v="21" actId="478"/>
      <pc:docMkLst>
        <pc:docMk/>
      </pc:docMkLst>
      <pc:sldChg chg="addSp delSp modSp">
        <pc:chgData name="Chew Leng Lim" userId="f4956819b06a5395" providerId="LiveId" clId="{BBF1F103-3A88-452F-9C24-5AE70FC726E3}" dt="2019-12-12T09:13:04.531" v="21" actId="478"/>
        <pc:sldMkLst>
          <pc:docMk/>
          <pc:sldMk cId="1761259662" sldId="299"/>
        </pc:sldMkLst>
        <pc:spChg chg="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5" creationId="{664BD555-5A2A-434F-9F90-A76B6AB950A9}"/>
          </ac:spMkLst>
        </pc:spChg>
        <pc:spChg chg="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10" creationId="{FCB424C4-2B80-466D-A4DB-68CFC53BD9E2}"/>
          </ac:spMkLst>
        </pc:spChg>
        <pc:spChg chg="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16" creationId="{E66FF22E-1403-46D9-BA93-58E08026AB77}"/>
          </ac:spMkLst>
        </pc:spChg>
        <pc:spChg chg="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17" creationId="{7104BCE7-79D7-40CD-8C69-0BE78A74D4BE}"/>
          </ac:spMkLst>
        </pc:spChg>
        <pc:spChg chg="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21" creationId="{81DB62B1-7594-4AB4-B7FF-87D4205D66AA}"/>
          </ac:spMkLst>
        </pc:spChg>
        <pc:spChg chg="add mod">
          <ac:chgData name="Chew Leng Lim" userId="f4956819b06a5395" providerId="LiveId" clId="{BBF1F103-3A88-452F-9C24-5AE70FC726E3}" dt="2019-12-12T08:59:00.750" v="11" actId="20577"/>
          <ac:spMkLst>
            <pc:docMk/>
            <pc:sldMk cId="1761259662" sldId="299"/>
            <ac:spMk id="40" creationId="{0BDA73C9-680F-4A7D-897C-F6512617106B}"/>
          </ac:spMkLst>
        </pc:spChg>
        <pc:spChg chg="add 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42" creationId="{6BF8AA07-0B8C-4831-A2D1-3C95D9C9B57F}"/>
          </ac:spMkLst>
        </pc:spChg>
        <pc:spChg chg="add 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43" creationId="{FADEE728-F02B-4238-A1ED-A88BD1D42CD1}"/>
          </ac:spMkLst>
        </pc:spChg>
        <pc:spChg chg="add 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44" creationId="{6A16373F-977D-4B1E-A01B-910838C1649A}"/>
          </ac:spMkLst>
        </pc:spChg>
        <pc:spChg chg="add 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45" creationId="{C5CC6924-1631-45DA-915C-6091E2376E7D}"/>
          </ac:spMkLst>
        </pc:spChg>
        <pc:spChg chg="add 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47" creationId="{E5AB3F53-B6FF-4B2C-9CF4-8A54021B65DC}"/>
          </ac:spMkLst>
        </pc:spChg>
        <pc:spChg chg="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49" creationId="{6A426DB6-2199-491E-9987-385CFB0EC68B}"/>
          </ac:spMkLst>
        </pc:spChg>
        <pc:spChg chg="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50" creationId="{33496F61-95E1-4923-9BBC-9F1EF1E94CC0}"/>
          </ac:spMkLst>
        </pc:spChg>
        <pc:spChg chg="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51" creationId="{1A245848-2B4E-4BFA-B85A-684FE3B08D67}"/>
          </ac:spMkLst>
        </pc:spChg>
        <pc:spChg chg="add 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52" creationId="{E34DF870-38B4-493D-920E-304D333AFB0A}"/>
          </ac:spMkLst>
        </pc:spChg>
        <pc:spChg chg="add 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53" creationId="{0EB01689-4EAA-4563-BE5F-CE35B574AB85}"/>
          </ac:spMkLst>
        </pc:spChg>
        <pc:spChg chg="add 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54" creationId="{B37AF1B1-AB63-4F5A-82AB-370DC6C5B0AC}"/>
          </ac:spMkLst>
        </pc:spChg>
        <pc:spChg chg="add 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55" creationId="{1B815593-B551-42BB-A93B-F48C6AD3CFE3}"/>
          </ac:spMkLst>
        </pc:spChg>
        <pc:spChg chg="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57" creationId="{F8586946-7F9B-4996-AD5D-F7C4AD100132}"/>
          </ac:spMkLst>
        </pc:spChg>
        <pc:spChg chg="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58" creationId="{9FBF6673-07D8-4339-8B68-7BCF00C49722}"/>
          </ac:spMkLst>
        </pc:spChg>
        <pc:spChg chg="add 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59" creationId="{CF5AB144-D142-4577-8671-BB4006F1C73A}"/>
          </ac:spMkLst>
        </pc:spChg>
        <pc:spChg chg="add 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60" creationId="{DAB93605-FB74-4885-B96B-0C67AC00919E}"/>
          </ac:spMkLst>
        </pc:spChg>
        <pc:spChg chg="add 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61" creationId="{BA014A3D-0FA5-45F3-A85E-1802777CB116}"/>
          </ac:spMkLst>
        </pc:spChg>
        <pc:spChg chg="add 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62" creationId="{01A981AC-A5E4-494B-8482-D69120C6AAF8}"/>
          </ac:spMkLst>
        </pc:spChg>
        <pc:spChg chg="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63" creationId="{EDC85653-7182-4813-B94C-4806ADE2893D}"/>
          </ac:spMkLst>
        </pc:spChg>
        <pc:spChg chg="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64" creationId="{DB4AF7EA-EAF0-4D0D-BEBA-040B85638E21}"/>
          </ac:spMkLst>
        </pc:spChg>
        <pc:spChg chg="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65" creationId="{8006EEE2-AAB1-4661-8295-BEB9AB12BCC7}"/>
          </ac:spMkLst>
        </pc:spChg>
        <pc:spChg chg="add 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66" creationId="{919B5D36-0A98-418A-B25E-492BB428620F}"/>
          </ac:spMkLst>
        </pc:spChg>
        <pc:spChg chg="add del mod">
          <ac:chgData name="Chew Leng Lim" userId="f4956819b06a5395" providerId="LiveId" clId="{BBF1F103-3A88-452F-9C24-5AE70FC726E3}" dt="2019-12-12T09:13:04.531" v="21" actId="478"/>
          <ac:spMkLst>
            <pc:docMk/>
            <pc:sldMk cId="1761259662" sldId="299"/>
            <ac:spMk id="67" creationId="{5C2D999D-95ED-4038-8CDC-278AB23BB57C}"/>
          </ac:spMkLst>
        </pc:spChg>
        <pc:spChg chg="add 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68" creationId="{B7BEBF5D-1041-4E50-9DF7-7C6EBCCC4265}"/>
          </ac:spMkLst>
        </pc:spChg>
        <pc:spChg chg="add 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69" creationId="{D49DC4BE-735A-4A7D-BC37-9B21BDF4A770}"/>
          </ac:spMkLst>
        </pc:spChg>
        <pc:spChg chg="add 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70" creationId="{E07BA918-FBF6-49AE-B057-88EA7DC78281}"/>
          </ac:spMkLst>
        </pc:spChg>
        <pc:spChg chg="add 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71" creationId="{5015C4D3-48E3-4FC3-AC3F-EA624166ADBD}"/>
          </ac:spMkLst>
        </pc:spChg>
        <pc:spChg chg="add 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72" creationId="{7B16B695-86F3-4BB9-AE90-BCC20DBD3BC8}"/>
          </ac:spMkLst>
        </pc:spChg>
        <pc:spChg chg="add 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74" creationId="{EBEC7003-8E98-4B0B-8CFB-E0DC7FDE9BF6}"/>
          </ac:spMkLst>
        </pc:spChg>
        <pc:spChg chg="add 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75" creationId="{27BD3765-94C4-421D-AA0A-1FD6576A6B1F}"/>
          </ac:spMkLst>
        </pc:spChg>
        <pc:spChg chg="add 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76" creationId="{B2F8908B-4C06-45FE-9062-4972EEB7069E}"/>
          </ac:spMkLst>
        </pc:spChg>
        <pc:spChg chg="add 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77" creationId="{0792E0AE-DB88-4172-8838-5FBBBAB7D439}"/>
          </ac:spMkLst>
        </pc:spChg>
        <pc:spChg chg="add 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78" creationId="{6CD6268A-1AB8-4874-9324-4C2AFA4DFFB8}"/>
          </ac:spMkLst>
        </pc:spChg>
        <pc:spChg chg="add 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79" creationId="{3CA37550-CE0B-42B1-8087-07A8FD4E086D}"/>
          </ac:spMkLst>
        </pc:spChg>
        <pc:spChg chg="add 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80" creationId="{6363EBBE-9F36-4D1D-88EC-6087AB6527AC}"/>
          </ac:spMkLst>
        </pc:spChg>
        <pc:spChg chg="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90" creationId="{3CD640B7-F59B-4615-BC1C-6532C95C998C}"/>
          </ac:spMkLst>
        </pc:spChg>
        <pc:spChg chg="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91" creationId="{327C55C4-11AC-4FC2-97C6-E11DA5D64E30}"/>
          </ac:spMkLst>
        </pc:spChg>
        <pc:spChg chg="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95" creationId="{A0981889-8B65-46E0-BDC6-BADAF36C0876}"/>
          </ac:spMkLst>
        </pc:spChg>
        <pc:spChg chg="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96" creationId="{1DF1364A-FFB4-4463-8388-B6022B423D63}"/>
          </ac:spMkLst>
        </pc:spChg>
        <pc:spChg chg="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100" creationId="{CFC3A3A9-A13B-43C3-B397-FAA837AABE7A}"/>
          </ac:spMkLst>
        </pc:spChg>
        <pc:spChg chg="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116" creationId="{9460A5E8-DA84-4761-AD0A-3578D46E645B}"/>
          </ac:spMkLst>
        </pc:spChg>
        <pc:spChg chg="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134" creationId="{80F9DA30-BCF3-4877-AC3A-6D0896EB02F5}"/>
          </ac:spMkLst>
        </pc:spChg>
        <pc:spChg chg="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135" creationId="{1FB06D5A-4FFF-4EBD-8B79-F09FAABF6051}"/>
          </ac:spMkLst>
        </pc:spChg>
        <pc:spChg chg="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140" creationId="{3E90037C-293B-4361-A040-EC3648E308CC}"/>
          </ac:spMkLst>
        </pc:spChg>
        <pc:spChg chg="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146" creationId="{A92697C3-5BF6-4188-80A9-BF751903E73E}"/>
          </ac:spMkLst>
        </pc:spChg>
        <pc:spChg chg="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150" creationId="{61108F21-3155-45DE-8B4A-332ACB3D577E}"/>
          </ac:spMkLst>
        </pc:spChg>
        <pc:spChg chg="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151" creationId="{1FCD2F2E-8426-4B36-A502-6D14FBEAFEA3}"/>
          </ac:spMkLst>
        </pc:spChg>
        <pc:spChg chg="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161" creationId="{CEE6DA04-F3CB-4415-804C-4F4EBA2FE4BA}"/>
          </ac:spMkLst>
        </pc:spChg>
        <pc:spChg chg="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178" creationId="{0C9088CA-9CD7-4B52-A2EE-57323C725F82}"/>
          </ac:spMkLst>
        </pc:spChg>
        <pc:spChg chg="mod">
          <ac:chgData name="Chew Leng Lim" userId="f4956819b06a5395" providerId="LiveId" clId="{BBF1F103-3A88-452F-9C24-5AE70FC726E3}" dt="2019-12-12T08:58:52.532" v="2" actId="1076"/>
          <ac:spMkLst>
            <pc:docMk/>
            <pc:sldMk cId="1761259662" sldId="299"/>
            <ac:spMk id="191" creationId="{74C6EC32-69C1-4F32-8E97-62A38A8471DD}"/>
          </ac:spMkLst>
        </pc:spChg>
        <pc:grpChg chg="mod">
          <ac:chgData name="Chew Leng Lim" userId="f4956819b06a5395" providerId="LiveId" clId="{BBF1F103-3A88-452F-9C24-5AE70FC726E3}" dt="2019-12-12T08:58:52.532" v="2" actId="1076"/>
          <ac:grpSpMkLst>
            <pc:docMk/>
            <pc:sldMk cId="1761259662" sldId="299"/>
            <ac:grpSpMk id="3" creationId="{9A8B2EAF-EFD4-4344-98AF-B389B435F11F}"/>
          </ac:grpSpMkLst>
        </pc:grpChg>
        <pc:graphicFrameChg chg="mod">
          <ac:chgData name="Chew Leng Lim" userId="f4956819b06a5395" providerId="LiveId" clId="{BBF1F103-3A88-452F-9C24-5AE70FC726E3}" dt="2019-12-12T08:58:52.532" v="2" actId="1076"/>
          <ac:graphicFrameMkLst>
            <pc:docMk/>
            <pc:sldMk cId="1761259662" sldId="299"/>
            <ac:graphicFrameMk id="9" creationId="{375A63CD-F656-4DBC-9E97-A61C06BB2E31}"/>
          </ac:graphicFrameMkLst>
        </pc:graphicFrameChg>
        <pc:graphicFrameChg chg="add mod">
          <ac:chgData name="Chew Leng Lim" userId="f4956819b06a5395" providerId="LiveId" clId="{BBF1F103-3A88-452F-9C24-5AE70FC726E3}" dt="2019-12-12T09:12:22.959" v="15"/>
          <ac:graphicFrameMkLst>
            <pc:docMk/>
            <pc:sldMk cId="1761259662" sldId="299"/>
            <ac:graphicFrameMk id="41" creationId="{E053C582-9EDB-4C2A-8316-AE1F97B54AB6}"/>
          </ac:graphicFrameMkLst>
        </pc:graphicFrameChg>
        <pc:graphicFrameChg chg="add mod">
          <ac:chgData name="Chew Leng Lim" userId="f4956819b06a5395" providerId="LiveId" clId="{BBF1F103-3A88-452F-9C24-5AE70FC726E3}" dt="2019-12-12T09:12:39.403" v="17"/>
          <ac:graphicFrameMkLst>
            <pc:docMk/>
            <pc:sldMk cId="1761259662" sldId="299"/>
            <ac:graphicFrameMk id="46" creationId="{76820563-9C99-4E40-959D-F8774CC02C23}"/>
          </ac:graphicFrameMkLst>
        </pc:graphicFrameChg>
        <pc:graphicFrameChg chg="mod">
          <ac:chgData name="Chew Leng Lim" userId="f4956819b06a5395" providerId="LiveId" clId="{BBF1F103-3A88-452F-9C24-5AE70FC726E3}" dt="2019-12-12T08:58:52.532" v="2" actId="1076"/>
          <ac:graphicFrameMkLst>
            <pc:docMk/>
            <pc:sldMk cId="1761259662" sldId="299"/>
            <ac:graphicFrameMk id="48" creationId="{61777650-55B6-468A-89D8-A1A2EBDBCAEC}"/>
          </ac:graphicFrameMkLst>
        </pc:graphicFrameChg>
        <pc:graphicFrameChg chg="add mod">
          <ac:chgData name="Chew Leng Lim" userId="f4956819b06a5395" providerId="LiveId" clId="{BBF1F103-3A88-452F-9C24-5AE70FC726E3}" dt="2019-12-12T09:12:57.825" v="19"/>
          <ac:graphicFrameMkLst>
            <pc:docMk/>
            <pc:sldMk cId="1761259662" sldId="299"/>
            <ac:graphicFrameMk id="56" creationId="{73158DE8-DBE0-4DEE-A5D2-3C9502DF4E53}"/>
          </ac:graphicFrameMkLst>
        </pc:graphicFrameChg>
        <pc:graphicFrameChg chg="add mod">
          <ac:chgData name="Chew Leng Lim" userId="f4956819b06a5395" providerId="LiveId" clId="{BBF1F103-3A88-452F-9C24-5AE70FC726E3}" dt="2019-12-12T09:12:05.613" v="13"/>
          <ac:graphicFrameMkLst>
            <pc:docMk/>
            <pc:sldMk cId="1761259662" sldId="299"/>
            <ac:graphicFrameMk id="73" creationId="{738FFADE-1236-4723-B407-0F6CBB40EC39}"/>
          </ac:graphicFrameMkLst>
        </pc:graphicFrameChg>
        <pc:graphicFrameChg chg="mod">
          <ac:chgData name="Chew Leng Lim" userId="f4956819b06a5395" providerId="LiveId" clId="{BBF1F103-3A88-452F-9C24-5AE70FC726E3}" dt="2019-12-12T08:58:52.532" v="2" actId="1076"/>
          <ac:graphicFrameMkLst>
            <pc:docMk/>
            <pc:sldMk cId="1761259662" sldId="299"/>
            <ac:graphicFrameMk id="89" creationId="{F12495DD-6928-4DC5-9F54-D9B81C965D7B}"/>
          </ac:graphicFrameMkLst>
        </pc:graphicFrameChg>
        <pc:graphicFrameChg chg="mod">
          <ac:chgData name="Chew Leng Lim" userId="f4956819b06a5395" providerId="LiveId" clId="{BBF1F103-3A88-452F-9C24-5AE70FC726E3}" dt="2019-12-12T08:58:52.532" v="2" actId="1076"/>
          <ac:graphicFrameMkLst>
            <pc:docMk/>
            <pc:sldMk cId="1761259662" sldId="299"/>
            <ac:graphicFrameMk id="125" creationId="{4C93C5FB-CC3C-4F3A-97B6-ED0C0E763C80}"/>
          </ac:graphicFrameMkLst>
        </pc:graphicFrameChg>
      </pc:sldChg>
    </pc:docChg>
  </pc:docChgLst>
  <pc:docChgLst>
    <pc:chgData name="Chew Leng Lim" userId="f4956819b06a5395" providerId="LiveId" clId="{E071FD12-64A3-45B6-9B4A-7FB56FDAA452}"/>
    <pc:docChg chg="delSld modSld">
      <pc:chgData name="Chew Leng Lim" userId="f4956819b06a5395" providerId="LiveId" clId="{E071FD12-64A3-45B6-9B4A-7FB56FDAA452}" dt="2019-11-04T09:38:52.706" v="45" actId="20577"/>
      <pc:docMkLst>
        <pc:docMk/>
      </pc:docMkLst>
      <pc:sldChg chg="addSp modSp">
        <pc:chgData name="Chew Leng Lim" userId="f4956819b06a5395" providerId="LiveId" clId="{E071FD12-64A3-45B6-9B4A-7FB56FDAA452}" dt="2019-11-04T09:38:52.706" v="45" actId="20577"/>
        <pc:sldMkLst>
          <pc:docMk/>
          <pc:sldMk cId="895125365" sldId="263"/>
        </pc:sldMkLst>
        <pc:spChg chg="add mod">
          <ac:chgData name="Chew Leng Lim" userId="f4956819b06a5395" providerId="LiveId" clId="{E071FD12-64A3-45B6-9B4A-7FB56FDAA452}" dt="2019-11-04T09:38:37.569" v="42" actId="1076"/>
          <ac:spMkLst>
            <pc:docMk/>
            <pc:sldMk cId="895125365" sldId="263"/>
            <ac:spMk id="4" creationId="{D027DB8B-B385-433D-A5F4-E1093040E143}"/>
          </ac:spMkLst>
        </pc:spChg>
        <pc:spChg chg="add mod">
          <ac:chgData name="Chew Leng Lim" userId="f4956819b06a5395" providerId="LiveId" clId="{E071FD12-64A3-45B6-9B4A-7FB56FDAA452}" dt="2019-11-04T09:38:52.706" v="45" actId="20577"/>
          <ac:spMkLst>
            <pc:docMk/>
            <pc:sldMk cId="895125365" sldId="263"/>
            <ac:spMk id="5" creationId="{A1062791-33C9-4714-BFA6-A71B840B43E6}"/>
          </ac:spMkLst>
        </pc:spChg>
      </pc:sldChg>
    </pc:docChg>
  </pc:docChgLst>
  <pc:docChgLst>
    <pc:chgData name="Chew Leng Lim" userId="f4956819b06a5395" providerId="LiveId" clId="{18C7B61E-2F46-44F3-B4F9-D9413F1F6D22}"/>
    <pc:docChg chg="undo redo custSel addSld delSld modSld sldOrd">
      <pc:chgData name="Chew Leng Lim" userId="f4956819b06a5395" providerId="LiveId" clId="{18C7B61E-2F46-44F3-B4F9-D9413F1F6D22}" dt="2020-03-12T07:41:13.703" v="7023" actId="6549"/>
      <pc:docMkLst>
        <pc:docMk/>
      </pc:docMkLst>
      <pc:sldChg chg="addSp delSp modSp">
        <pc:chgData name="Chew Leng Lim" userId="f4956819b06a5395" providerId="LiveId" clId="{18C7B61E-2F46-44F3-B4F9-D9413F1F6D22}" dt="2020-03-12T06:29:23.842" v="998" actId="14100"/>
        <pc:sldMkLst>
          <pc:docMk/>
          <pc:sldMk cId="1428766084" sldId="261"/>
        </pc:sldMkLst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8" creationId="{1E366CCF-4695-4DB0-9CD6-EE077D570F03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9" creationId="{13DD80AA-B2F2-4366-9783-0E522D351A8C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10" creationId="{5442A20A-0D2E-4514-92A5-46A2C5D12E31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11" creationId="{90D78407-EFC6-480F-AB77-92C7C259C184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12" creationId="{16A1853A-FA4C-475B-9759-9F4AF6BE4758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21" creationId="{8A1760D5-80EF-4A08-9768-97CE378191EA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28" creationId="{93FD5A04-5CC8-4DC9-8DF2-B8929CFB05A4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29" creationId="{8A58921D-2F82-4961-A587-E93308C4CA9B}"/>
          </ac:spMkLst>
        </pc:spChg>
        <pc:spChg chg="mod">
          <ac:chgData name="Chew Leng Lim" userId="f4956819b06a5395" providerId="LiveId" clId="{18C7B61E-2F46-44F3-B4F9-D9413F1F6D22}" dt="2020-03-12T06:22:31.173" v="823" actId="20577"/>
          <ac:spMkLst>
            <pc:docMk/>
            <pc:sldMk cId="1428766084" sldId="261"/>
            <ac:spMk id="30" creationId="{62214AF6-8060-4FB2-A387-35E4E2AE08DE}"/>
          </ac:spMkLst>
        </pc:spChg>
        <pc:spChg chg="mod topLvl">
          <ac:chgData name="Chew Leng Lim" userId="f4956819b06a5395" providerId="LiveId" clId="{18C7B61E-2F46-44F3-B4F9-D9413F1F6D22}" dt="2020-03-12T06:28:06.805" v="972" actId="1036"/>
          <ac:spMkLst>
            <pc:docMk/>
            <pc:sldMk cId="1428766084" sldId="261"/>
            <ac:spMk id="34" creationId="{FA50F7F9-22AA-4616-803C-8242230E5D85}"/>
          </ac:spMkLst>
        </pc:spChg>
        <pc:spChg chg="mod topLvl">
          <ac:chgData name="Chew Leng Lim" userId="f4956819b06a5395" providerId="LiveId" clId="{18C7B61E-2F46-44F3-B4F9-D9413F1F6D22}" dt="2020-03-12T06:28:06.805" v="972" actId="1036"/>
          <ac:spMkLst>
            <pc:docMk/>
            <pc:sldMk cId="1428766084" sldId="261"/>
            <ac:spMk id="35" creationId="{CDE15712-01F4-430B-9E2C-92F4AF0A1AF7}"/>
          </ac:spMkLst>
        </pc:spChg>
        <pc:spChg chg="del mod">
          <ac:chgData name="Chew Leng Lim" userId="f4956819b06a5395" providerId="LiveId" clId="{18C7B61E-2F46-44F3-B4F9-D9413F1F6D22}" dt="2020-03-12T06:11:12.003" v="376" actId="478"/>
          <ac:spMkLst>
            <pc:docMk/>
            <pc:sldMk cId="1428766084" sldId="261"/>
            <ac:spMk id="37" creationId="{AA16DF06-E6F8-4045-8AC1-7073FBFDB5F9}"/>
          </ac:spMkLst>
        </pc:spChg>
        <pc:spChg chg="mod">
          <ac:chgData name="Chew Leng Lim" userId="f4956819b06a5395" providerId="LiveId" clId="{18C7B61E-2F46-44F3-B4F9-D9413F1F6D22}" dt="2020-03-03T09:57:59.076" v="310" actId="1076"/>
          <ac:spMkLst>
            <pc:docMk/>
            <pc:sldMk cId="1428766084" sldId="261"/>
            <ac:spMk id="44" creationId="{095451D7-CB3E-4761-80B4-B07E4857B18C}"/>
          </ac:spMkLst>
        </pc:spChg>
        <pc:spChg chg="mod">
          <ac:chgData name="Chew Leng Lim" userId="f4956819b06a5395" providerId="LiveId" clId="{18C7B61E-2F46-44F3-B4F9-D9413F1F6D22}" dt="2020-03-12T06:17:10.814" v="658" actId="20577"/>
          <ac:spMkLst>
            <pc:docMk/>
            <pc:sldMk cId="1428766084" sldId="261"/>
            <ac:spMk id="45" creationId="{801B3942-42FC-4E74-AE92-E3653ED1AEBE}"/>
          </ac:spMkLst>
        </pc:spChg>
        <pc:spChg chg="mod">
          <ac:chgData name="Chew Leng Lim" userId="f4956819b06a5395" providerId="LiveId" clId="{18C7B61E-2F46-44F3-B4F9-D9413F1F6D22}" dt="2020-03-12T06:17:08.151" v="657" actId="20577"/>
          <ac:spMkLst>
            <pc:docMk/>
            <pc:sldMk cId="1428766084" sldId="261"/>
            <ac:spMk id="46" creationId="{632BD00C-7687-4705-BA3C-82D9259B705D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70" creationId="{8073CA5F-F20B-4179-A6E0-BE2A45AFF5A9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71" creationId="{F4A14208-871A-4D20-BCCA-C70E11C6D9EF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72" creationId="{DCB526DD-A278-45F6-AC33-596EACDBE97A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73" creationId="{59CC46A3-8DA8-4DC5-8D09-1C3FB7345D07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74" creationId="{8CB2A5C3-044C-4D16-B52E-51D92E36D244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75" creationId="{3D1661FC-06AC-478E-A591-4B6CAF26DEB3}"/>
          </ac:spMkLst>
        </pc:spChg>
        <pc:spChg chg="mod">
          <ac:chgData name="Chew Leng Lim" userId="f4956819b06a5395" providerId="LiveId" clId="{18C7B61E-2F46-44F3-B4F9-D9413F1F6D22}" dt="2020-03-03T09:57:59.076" v="310" actId="1076"/>
          <ac:spMkLst>
            <pc:docMk/>
            <pc:sldMk cId="1428766084" sldId="261"/>
            <ac:spMk id="77" creationId="{39AC1390-2164-47A8-B125-547BC1C87474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78" creationId="{56917DA3-90A2-4C24-92C6-EDC9501D79DA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81" creationId="{B345B18E-59FD-4FD4-8AA6-ACE24B50D85D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82" creationId="{BBF8A6A0-566D-4640-9619-619A71E78DEF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84" creationId="{2F3FCCD3-A19F-4246-BA30-D8BB21C9C0C5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85" creationId="{A2525612-3DD9-4698-851B-1EA5080DC6FC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86" creationId="{B6E20A49-1F20-4E82-BB55-1CB42D6F056B}"/>
          </ac:spMkLst>
        </pc:spChg>
        <pc:spChg chg="mod topLvl">
          <ac:chgData name="Chew Leng Lim" userId="f4956819b06a5395" providerId="LiveId" clId="{18C7B61E-2F46-44F3-B4F9-D9413F1F6D22}" dt="2020-03-12T06:26:51.655" v="902" actId="1038"/>
          <ac:spMkLst>
            <pc:docMk/>
            <pc:sldMk cId="1428766084" sldId="261"/>
            <ac:spMk id="90" creationId="{C00F8D30-8189-4309-9058-9138B773DD50}"/>
          </ac:spMkLst>
        </pc:spChg>
        <pc:spChg chg="mod topLvl">
          <ac:chgData name="Chew Leng Lim" userId="f4956819b06a5395" providerId="LiveId" clId="{18C7B61E-2F46-44F3-B4F9-D9413F1F6D22}" dt="2020-03-12T06:27:12.592" v="919" actId="1036"/>
          <ac:spMkLst>
            <pc:docMk/>
            <pc:sldMk cId="1428766084" sldId="261"/>
            <ac:spMk id="91" creationId="{9570806E-9394-48BD-B7C6-BE4F32D6CFC8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96" creationId="{FF4E31A8-21D7-4CC5-ABCA-B130B9499030}"/>
          </ac:spMkLst>
        </pc:spChg>
        <pc:spChg chg="mod topLvl">
          <ac:chgData name="Chew Leng Lim" userId="f4956819b06a5395" providerId="LiveId" clId="{18C7B61E-2F46-44F3-B4F9-D9413F1F6D22}" dt="2020-03-12T06:27:09.691" v="918" actId="1036"/>
          <ac:spMkLst>
            <pc:docMk/>
            <pc:sldMk cId="1428766084" sldId="261"/>
            <ac:spMk id="98" creationId="{0C37A7B3-302A-4F12-84F2-64E3010506ED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100" creationId="{73D59EB8-09B1-4DA5-B684-F989A1F48EBB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101" creationId="{99ADE885-6CD2-4371-ACAC-B240F1A0C3C5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102" creationId="{6F02CF55-80A6-4F76-9142-FEAB3BAAE907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103" creationId="{B96D19E7-F1F5-4743-8920-192C431AFDDC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104" creationId="{9B4E1507-F839-413D-9549-AE7D0FA6FA72}"/>
          </ac:spMkLst>
        </pc:spChg>
        <pc:spChg chg="mod topLvl">
          <ac:chgData name="Chew Leng Lim" userId="f4956819b06a5395" providerId="LiveId" clId="{18C7B61E-2F46-44F3-B4F9-D9413F1F6D22}" dt="2020-03-12T06:28:36.122" v="976" actId="1035"/>
          <ac:spMkLst>
            <pc:docMk/>
            <pc:sldMk cId="1428766084" sldId="261"/>
            <ac:spMk id="107" creationId="{329B51E8-EE61-40C6-90B4-3195648CAADA}"/>
          </ac:spMkLst>
        </pc:spChg>
        <pc:spChg chg="mod topLvl">
          <ac:chgData name="Chew Leng Lim" userId="f4956819b06a5395" providerId="LiveId" clId="{18C7B61E-2F46-44F3-B4F9-D9413F1F6D22}" dt="2020-03-12T06:29:05.372" v="996" actId="1037"/>
          <ac:spMkLst>
            <pc:docMk/>
            <pc:sldMk cId="1428766084" sldId="261"/>
            <ac:spMk id="108" creationId="{751125B1-89E4-4E30-93EE-069FC2A5ACD4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112" creationId="{12B379DD-63E7-4034-8C71-4DECA7782E99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114" creationId="{CACFE5BF-FCA1-475B-8F56-306B9B7DD8BF}"/>
          </ac:spMkLst>
        </pc:spChg>
        <pc:spChg chg="del mod">
          <ac:chgData name="Chew Leng Lim" userId="f4956819b06a5395" providerId="LiveId" clId="{18C7B61E-2F46-44F3-B4F9-D9413F1F6D22}" dt="2020-03-12T06:11:12.003" v="376" actId="478"/>
          <ac:spMkLst>
            <pc:docMk/>
            <pc:sldMk cId="1428766084" sldId="261"/>
            <ac:spMk id="116" creationId="{9549C060-58FC-4C6E-BA7B-76B7DBD4B615}"/>
          </ac:spMkLst>
        </pc:spChg>
        <pc:spChg chg="mod">
          <ac:chgData name="Chew Leng Lim" userId="f4956819b06a5395" providerId="LiveId" clId="{18C7B61E-2F46-44F3-B4F9-D9413F1F6D22}" dt="2020-03-12T06:17:15.703" v="659" actId="20577"/>
          <ac:spMkLst>
            <pc:docMk/>
            <pc:sldMk cId="1428766084" sldId="261"/>
            <ac:spMk id="117" creationId="{823D79EF-9CA9-4F4E-B84F-4ED8676D3FF0}"/>
          </ac:spMkLst>
        </pc:spChg>
        <pc:spChg chg="add mod">
          <ac:chgData name="Chew Leng Lim" userId="f4956819b06a5395" providerId="LiveId" clId="{18C7B61E-2F46-44F3-B4F9-D9413F1F6D22}" dt="2020-03-03T10:03:47.609" v="331" actId="1076"/>
          <ac:spMkLst>
            <pc:docMk/>
            <pc:sldMk cId="1428766084" sldId="261"/>
            <ac:spMk id="120" creationId="{89771BD3-BF15-4ACE-BBB9-A26CD9EA4245}"/>
          </ac:spMkLst>
        </pc:spChg>
        <pc:spChg chg="add mod">
          <ac:chgData name="Chew Leng Lim" userId="f4956819b06a5395" providerId="LiveId" clId="{18C7B61E-2F46-44F3-B4F9-D9413F1F6D22}" dt="2020-03-03T09:57:54.482" v="309" actId="1076"/>
          <ac:spMkLst>
            <pc:docMk/>
            <pc:sldMk cId="1428766084" sldId="261"/>
            <ac:spMk id="121" creationId="{76F705C4-E930-4CAF-BCD6-C04DF823CAFD}"/>
          </ac:spMkLst>
        </pc:spChg>
        <pc:spChg chg="add mod">
          <ac:chgData name="Chew Leng Lim" userId="f4956819b06a5395" providerId="LiveId" clId="{18C7B61E-2F46-44F3-B4F9-D9413F1F6D22}" dt="2020-03-03T09:57:54.482" v="309" actId="1076"/>
          <ac:spMkLst>
            <pc:docMk/>
            <pc:sldMk cId="1428766084" sldId="261"/>
            <ac:spMk id="123" creationId="{B905FF05-745A-483C-AD7D-00C6CEE91B04}"/>
          </ac:spMkLst>
        </pc:spChg>
        <pc:spChg chg="add mod">
          <ac:chgData name="Chew Leng Lim" userId="f4956819b06a5395" providerId="LiveId" clId="{18C7B61E-2F46-44F3-B4F9-D9413F1F6D22}" dt="2020-03-03T09:57:54.482" v="309" actId="1076"/>
          <ac:spMkLst>
            <pc:docMk/>
            <pc:sldMk cId="1428766084" sldId="261"/>
            <ac:spMk id="124" creationId="{A6E1723A-4EBF-41B3-A86F-14046D664922}"/>
          </ac:spMkLst>
        </pc:spChg>
        <pc:spChg chg="add mod">
          <ac:chgData name="Chew Leng Lim" userId="f4956819b06a5395" providerId="LiveId" clId="{18C7B61E-2F46-44F3-B4F9-D9413F1F6D22}" dt="2020-03-03T09:57:54.482" v="309" actId="1076"/>
          <ac:spMkLst>
            <pc:docMk/>
            <pc:sldMk cId="1428766084" sldId="261"/>
            <ac:spMk id="125" creationId="{8DBBF995-E4E6-4BBE-A526-012FE84434BD}"/>
          </ac:spMkLst>
        </pc:spChg>
        <pc:spChg chg="add mod">
          <ac:chgData name="Chew Leng Lim" userId="f4956819b06a5395" providerId="LiveId" clId="{18C7B61E-2F46-44F3-B4F9-D9413F1F6D22}" dt="2020-03-03T09:57:54.482" v="309" actId="1076"/>
          <ac:spMkLst>
            <pc:docMk/>
            <pc:sldMk cId="1428766084" sldId="261"/>
            <ac:spMk id="126" creationId="{4D2F6826-8BE8-4CC5-B0A6-917FF476AF57}"/>
          </ac:spMkLst>
        </pc:spChg>
        <pc:spChg chg="add mod">
          <ac:chgData name="Chew Leng Lim" userId="f4956819b06a5395" providerId="LiveId" clId="{18C7B61E-2F46-44F3-B4F9-D9413F1F6D22}" dt="2020-03-03T09:57:54.482" v="309" actId="1076"/>
          <ac:spMkLst>
            <pc:docMk/>
            <pc:sldMk cId="1428766084" sldId="261"/>
            <ac:spMk id="127" creationId="{5DEBD0FC-783D-45BA-9030-7818BFA9E3FB}"/>
          </ac:spMkLst>
        </pc:spChg>
        <pc:spChg chg="add mod">
          <ac:chgData name="Chew Leng Lim" userId="f4956819b06a5395" providerId="LiveId" clId="{18C7B61E-2F46-44F3-B4F9-D9413F1F6D22}" dt="2020-03-12T06:24:32.333" v="868" actId="1038"/>
          <ac:spMkLst>
            <pc:docMk/>
            <pc:sldMk cId="1428766084" sldId="261"/>
            <ac:spMk id="128" creationId="{5B862B6A-85A2-417C-8EA2-6B0C1BC22BD9}"/>
          </ac:spMkLst>
        </pc:spChg>
        <pc:spChg chg="add mod">
          <ac:chgData name="Chew Leng Lim" userId="f4956819b06a5395" providerId="LiveId" clId="{18C7B61E-2F46-44F3-B4F9-D9413F1F6D22}" dt="2020-03-03T09:57:54.482" v="309" actId="1076"/>
          <ac:spMkLst>
            <pc:docMk/>
            <pc:sldMk cId="1428766084" sldId="261"/>
            <ac:spMk id="132" creationId="{6CBD189D-9377-4FC2-991E-C61250646124}"/>
          </ac:spMkLst>
        </pc:spChg>
        <pc:spChg chg="add mod">
          <ac:chgData name="Chew Leng Lim" userId="f4956819b06a5395" providerId="LiveId" clId="{18C7B61E-2F46-44F3-B4F9-D9413F1F6D22}" dt="2020-03-03T09:57:54.482" v="309" actId="1076"/>
          <ac:spMkLst>
            <pc:docMk/>
            <pc:sldMk cId="1428766084" sldId="261"/>
            <ac:spMk id="133" creationId="{51C6A9B4-5E58-4CBA-B4AD-B37EEF6222BE}"/>
          </ac:spMkLst>
        </pc:spChg>
        <pc:spChg chg="add mod">
          <ac:chgData name="Chew Leng Lim" userId="f4956819b06a5395" providerId="LiveId" clId="{18C7B61E-2F46-44F3-B4F9-D9413F1F6D22}" dt="2020-03-03T09:57:54.482" v="309" actId="1076"/>
          <ac:spMkLst>
            <pc:docMk/>
            <pc:sldMk cId="1428766084" sldId="261"/>
            <ac:spMk id="134" creationId="{A1B16BE3-E3DC-4389-AC93-4DCF15904673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136" creationId="{4D3E1084-DB82-4222-92C8-FC7D44F01840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137" creationId="{A6C789D8-BB4E-4B09-9BEA-22D45EE4C4C4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138" creationId="{7AECE475-0856-4A91-8CB8-0E0648535BFC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139" creationId="{3C18D8EC-6478-44D0-A724-A2DEE3CF842A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140" creationId="{F3360B35-325A-4402-AE98-A61CAD03B4C1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141" creationId="{B5020E00-32EB-4E5A-A613-68A286D251F3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142" creationId="{6C375AD2-A466-4093-BF8E-72A4EFEE0DA9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143" creationId="{477037BC-A6D8-4A9F-AE62-D87186985CA0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144" creationId="{BCFDBF16-0EA8-4E8A-A126-B148A1416CF7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146" creationId="{1E9B0C54-1BEC-4E89-B2DD-9993F87DDC5C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185" creationId="{E0CF3FE2-CE78-443D-9755-5FFAF53DAEB9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186" creationId="{30018E6D-0EAB-4078-B6F3-563A793EE6D8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187" creationId="{F18D0FFA-01E9-448D-BDD9-E70D78962863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188" creationId="{F8FD783D-C790-4CD6-8DC8-0500437334FB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189" creationId="{224B98AD-7D38-4153-B24E-66DAE149071F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190" creationId="{CFF89134-ACE0-4875-B868-B9035CFA136B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191" creationId="{742828D2-7E29-44D3-A350-D6802B13E2DD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192" creationId="{CFA6CB51-87FA-4491-AFFC-6B73BEB9A398}"/>
          </ac:spMkLst>
        </pc:spChg>
        <pc:spChg chg="mod topLvl">
          <ac:chgData name="Chew Leng Lim" userId="f4956819b06a5395" providerId="LiveId" clId="{18C7B61E-2F46-44F3-B4F9-D9413F1F6D22}" dt="2020-03-12T06:25:12.436" v="883" actId="165"/>
          <ac:spMkLst>
            <pc:docMk/>
            <pc:sldMk cId="1428766084" sldId="261"/>
            <ac:spMk id="193" creationId="{51131C5E-2864-4CF8-8E91-D8D143B4967F}"/>
          </ac:spMkLst>
        </pc:spChg>
        <pc:grpChg chg="del mod">
          <ac:chgData name="Chew Leng Lim" userId="f4956819b06a5395" providerId="LiveId" clId="{18C7B61E-2F46-44F3-B4F9-D9413F1F6D22}" dt="2020-03-12T06:11:12.003" v="376" actId="478"/>
          <ac:grpSpMkLst>
            <pc:docMk/>
            <pc:sldMk cId="1428766084" sldId="261"/>
            <ac:grpSpMk id="2" creationId="{CAA2FE99-9476-434A-A188-488364475B75}"/>
          </ac:grpSpMkLst>
        </pc:grpChg>
        <pc:grpChg chg="del mod">
          <ac:chgData name="Chew Leng Lim" userId="f4956819b06a5395" providerId="LiveId" clId="{18C7B61E-2F46-44F3-B4F9-D9413F1F6D22}" dt="2020-03-12T06:25:12.436" v="883" actId="165"/>
          <ac:grpSpMkLst>
            <pc:docMk/>
            <pc:sldMk cId="1428766084" sldId="261"/>
            <ac:grpSpMk id="3" creationId="{57CC341F-7957-433C-8F67-62BBACAEB72C}"/>
          </ac:grpSpMkLst>
        </pc:grpChg>
        <pc:grpChg chg="del mod">
          <ac:chgData name="Chew Leng Lim" userId="f4956819b06a5395" providerId="LiveId" clId="{18C7B61E-2F46-44F3-B4F9-D9413F1F6D22}" dt="2020-03-12T06:25:12.436" v="883" actId="165"/>
          <ac:grpSpMkLst>
            <pc:docMk/>
            <pc:sldMk cId="1428766084" sldId="261"/>
            <ac:grpSpMk id="7" creationId="{DE563A90-1089-4390-89EA-050B5C6DB1DA}"/>
          </ac:grpSpMkLst>
        </pc:grpChg>
        <pc:grpChg chg="del mod">
          <ac:chgData name="Chew Leng Lim" userId="f4956819b06a5395" providerId="LiveId" clId="{18C7B61E-2F46-44F3-B4F9-D9413F1F6D22}" dt="2020-03-12T06:11:12.003" v="376" actId="478"/>
          <ac:grpSpMkLst>
            <pc:docMk/>
            <pc:sldMk cId="1428766084" sldId="261"/>
            <ac:grpSpMk id="14" creationId="{5D2A0F80-8BFF-4321-AB22-E18BC6099579}"/>
          </ac:grpSpMkLst>
        </pc:grpChg>
        <pc:grpChg chg="del mod">
          <ac:chgData name="Chew Leng Lim" userId="f4956819b06a5395" providerId="LiveId" clId="{18C7B61E-2F46-44F3-B4F9-D9413F1F6D22}" dt="2020-03-12T06:25:12.436" v="883" actId="165"/>
          <ac:grpSpMkLst>
            <pc:docMk/>
            <pc:sldMk cId="1428766084" sldId="261"/>
            <ac:grpSpMk id="16" creationId="{2E50853B-6AAD-4873-B91B-0CFB79887321}"/>
          </ac:grpSpMkLst>
        </pc:grpChg>
        <pc:grpChg chg="del mod">
          <ac:chgData name="Chew Leng Lim" userId="f4956819b06a5395" providerId="LiveId" clId="{18C7B61E-2F46-44F3-B4F9-D9413F1F6D22}" dt="2020-03-12T06:25:12.436" v="883" actId="165"/>
          <ac:grpSpMkLst>
            <pc:docMk/>
            <pc:sldMk cId="1428766084" sldId="261"/>
            <ac:grpSpMk id="17" creationId="{97B5AC63-40E7-4D59-A1EE-47B9568D6C1D}"/>
          </ac:grpSpMkLst>
        </pc:grpChg>
        <pc:grpChg chg="del mod">
          <ac:chgData name="Chew Leng Lim" userId="f4956819b06a5395" providerId="LiveId" clId="{18C7B61E-2F46-44F3-B4F9-D9413F1F6D22}" dt="2020-03-12T06:25:12.436" v="883" actId="165"/>
          <ac:grpSpMkLst>
            <pc:docMk/>
            <pc:sldMk cId="1428766084" sldId="261"/>
            <ac:grpSpMk id="205" creationId="{9C5FF07B-3AF6-4B0F-AC6A-080919A0DC53}"/>
          </ac:grpSpMkLst>
        </pc:grpChg>
        <pc:grpChg chg="del mod">
          <ac:chgData name="Chew Leng Lim" userId="f4956819b06a5395" providerId="LiveId" clId="{18C7B61E-2F46-44F3-B4F9-D9413F1F6D22}" dt="2020-03-12T06:25:12.436" v="883" actId="165"/>
          <ac:grpSpMkLst>
            <pc:docMk/>
            <pc:sldMk cId="1428766084" sldId="261"/>
            <ac:grpSpMk id="206" creationId="{439E6DE1-F44B-49AD-AD8D-9BCDFAB25C18}"/>
          </ac:grpSpMkLst>
        </pc:grpChg>
        <pc:graphicFrameChg chg="mod topLvl">
          <ac:chgData name="Chew Leng Lim" userId="f4956819b06a5395" providerId="LiveId" clId="{18C7B61E-2F46-44F3-B4F9-D9413F1F6D22}" dt="2020-03-12T06:25:12.436" v="883" actId="165"/>
          <ac:graphicFrameMkLst>
            <pc:docMk/>
            <pc:sldMk cId="1428766084" sldId="261"/>
            <ac:graphicFrameMk id="6" creationId="{991507A3-7274-4E7A-BEF3-A27BD3D5C3FF}"/>
          </ac:graphicFrameMkLst>
        </pc:graphicFrameChg>
        <pc:graphicFrameChg chg="mod">
          <ac:chgData name="Chew Leng Lim" userId="f4956819b06a5395" providerId="LiveId" clId="{18C7B61E-2F46-44F3-B4F9-D9413F1F6D22}" dt="2020-03-03T09:57:22.656" v="304" actId="1076"/>
          <ac:graphicFrameMkLst>
            <pc:docMk/>
            <pc:sldMk cId="1428766084" sldId="261"/>
            <ac:graphicFrameMk id="38" creationId="{870F0212-B9C0-4666-849B-FDCEA1EA4E49}"/>
          </ac:graphicFrameMkLst>
        </pc:graphicFrameChg>
        <pc:graphicFrameChg chg="mod topLvl">
          <ac:chgData name="Chew Leng Lim" userId="f4956819b06a5395" providerId="LiveId" clId="{18C7B61E-2F46-44F3-B4F9-D9413F1F6D22}" dt="2020-03-12T06:25:12.436" v="883" actId="165"/>
          <ac:graphicFrameMkLst>
            <pc:docMk/>
            <pc:sldMk cId="1428766084" sldId="261"/>
            <ac:graphicFrameMk id="69" creationId="{C057413A-1021-435D-AB69-9A491737E78A}"/>
          </ac:graphicFrameMkLst>
        </pc:graphicFrameChg>
        <pc:graphicFrameChg chg="mod topLvl">
          <ac:chgData name="Chew Leng Lim" userId="f4956819b06a5395" providerId="LiveId" clId="{18C7B61E-2F46-44F3-B4F9-D9413F1F6D22}" dt="2020-03-12T06:25:12.436" v="883" actId="165"/>
          <ac:graphicFrameMkLst>
            <pc:docMk/>
            <pc:sldMk cId="1428766084" sldId="261"/>
            <ac:graphicFrameMk id="80" creationId="{46262B4F-0989-4CC1-8383-D70A2EC1695D}"/>
          </ac:graphicFrameMkLst>
        </pc:graphicFrameChg>
        <pc:graphicFrameChg chg="mod topLvl">
          <ac:chgData name="Chew Leng Lim" userId="f4956819b06a5395" providerId="LiveId" clId="{18C7B61E-2F46-44F3-B4F9-D9413F1F6D22}" dt="2020-03-12T06:25:12.436" v="883" actId="165"/>
          <ac:graphicFrameMkLst>
            <pc:docMk/>
            <pc:sldMk cId="1428766084" sldId="261"/>
            <ac:graphicFrameMk id="99" creationId="{DAD8D310-D559-4499-B5FD-5E67DE3A07B3}"/>
          </ac:graphicFrameMkLst>
        </pc:graphicFrameChg>
        <pc:graphicFrameChg chg="add mod">
          <ac:chgData name="Chew Leng Lim" userId="f4956819b06a5395" providerId="LiveId" clId="{18C7B61E-2F46-44F3-B4F9-D9413F1F6D22}" dt="2020-03-12T06:27:59.466" v="948" actId="1076"/>
          <ac:graphicFrameMkLst>
            <pc:docMk/>
            <pc:sldMk cId="1428766084" sldId="261"/>
            <ac:graphicFrameMk id="122" creationId="{D36BE223-E92E-4D39-BB78-C373F8587BA0}"/>
          </ac:graphicFrameMkLst>
        </pc:graphicFrameChg>
        <pc:cxnChg chg="mod topLvl">
          <ac:chgData name="Chew Leng Lim" userId="f4956819b06a5395" providerId="LiveId" clId="{18C7B61E-2F46-44F3-B4F9-D9413F1F6D22}" dt="2020-03-12T06:28:06.805" v="972" actId="1036"/>
          <ac:cxnSpMkLst>
            <pc:docMk/>
            <pc:sldMk cId="1428766084" sldId="261"/>
            <ac:cxnSpMk id="25" creationId="{16B2E33D-6281-4DD4-89CB-8FFED174EDC7}"/>
          </ac:cxnSpMkLst>
        </pc:cxnChg>
        <pc:cxnChg chg="mod topLvl">
          <ac:chgData name="Chew Leng Lim" userId="f4956819b06a5395" providerId="LiveId" clId="{18C7B61E-2F46-44F3-B4F9-D9413F1F6D22}" dt="2020-03-12T06:28:06.805" v="972" actId="1036"/>
          <ac:cxnSpMkLst>
            <pc:docMk/>
            <pc:sldMk cId="1428766084" sldId="261"/>
            <ac:cxnSpMk id="26" creationId="{62503267-04CA-42A8-BE0A-072461B4FD3C}"/>
          </ac:cxnSpMkLst>
        </pc:cxnChg>
        <pc:cxnChg chg="mod topLvl">
          <ac:chgData name="Chew Leng Lim" userId="f4956819b06a5395" providerId="LiveId" clId="{18C7B61E-2F46-44F3-B4F9-D9413F1F6D22}" dt="2020-03-12T06:28:06.805" v="972" actId="1036"/>
          <ac:cxnSpMkLst>
            <pc:docMk/>
            <pc:sldMk cId="1428766084" sldId="261"/>
            <ac:cxnSpMk id="31" creationId="{43598DEB-311B-4BC5-82D0-710210F162B4}"/>
          </ac:cxnSpMkLst>
        </pc:cxnChg>
        <pc:cxnChg chg="mod topLvl">
          <ac:chgData name="Chew Leng Lim" userId="f4956819b06a5395" providerId="LiveId" clId="{18C7B61E-2F46-44F3-B4F9-D9413F1F6D22}" dt="2020-03-12T06:28:06.805" v="972" actId="1036"/>
          <ac:cxnSpMkLst>
            <pc:docMk/>
            <pc:sldMk cId="1428766084" sldId="261"/>
            <ac:cxnSpMk id="32" creationId="{E85F2392-1147-4203-8B54-505C779523ED}"/>
          </ac:cxnSpMkLst>
        </pc:cxnChg>
        <pc:cxnChg chg="mod topLvl">
          <ac:chgData name="Chew Leng Lim" userId="f4956819b06a5395" providerId="LiveId" clId="{18C7B61E-2F46-44F3-B4F9-D9413F1F6D22}" dt="2020-03-12T06:28:06.805" v="972" actId="1036"/>
          <ac:cxnSpMkLst>
            <pc:docMk/>
            <pc:sldMk cId="1428766084" sldId="261"/>
            <ac:cxnSpMk id="33" creationId="{8D667F4B-B356-47CA-9070-BBF90F773958}"/>
          </ac:cxnSpMkLst>
        </pc:cxnChg>
        <pc:cxnChg chg="mod topLvl">
          <ac:chgData name="Chew Leng Lim" userId="f4956819b06a5395" providerId="LiveId" clId="{18C7B61E-2F46-44F3-B4F9-D9413F1F6D22}" dt="2020-03-12T06:26:51.655" v="902" actId="1038"/>
          <ac:cxnSpMkLst>
            <pc:docMk/>
            <pc:sldMk cId="1428766084" sldId="261"/>
            <ac:cxnSpMk id="88" creationId="{9D87A062-6766-41F6-820C-024330BACB33}"/>
          </ac:cxnSpMkLst>
        </pc:cxnChg>
        <pc:cxnChg chg="mod topLvl">
          <ac:chgData name="Chew Leng Lim" userId="f4956819b06a5395" providerId="LiveId" clId="{18C7B61E-2F46-44F3-B4F9-D9413F1F6D22}" dt="2020-03-12T06:26:51.655" v="902" actId="1038"/>
          <ac:cxnSpMkLst>
            <pc:docMk/>
            <pc:sldMk cId="1428766084" sldId="261"/>
            <ac:cxnSpMk id="89" creationId="{67E2D418-47C3-4EC2-9CC8-ED62A70F567B}"/>
          </ac:cxnSpMkLst>
        </pc:cxnChg>
        <pc:cxnChg chg="mod topLvl">
          <ac:chgData name="Chew Leng Lim" userId="f4956819b06a5395" providerId="LiveId" clId="{18C7B61E-2F46-44F3-B4F9-D9413F1F6D22}" dt="2020-03-12T06:26:51.655" v="902" actId="1038"/>
          <ac:cxnSpMkLst>
            <pc:docMk/>
            <pc:sldMk cId="1428766084" sldId="261"/>
            <ac:cxnSpMk id="92" creationId="{B3E1918E-1EC0-4F55-934C-04A321573402}"/>
          </ac:cxnSpMkLst>
        </pc:cxnChg>
        <pc:cxnChg chg="mod topLvl">
          <ac:chgData name="Chew Leng Lim" userId="f4956819b06a5395" providerId="LiveId" clId="{18C7B61E-2F46-44F3-B4F9-D9413F1F6D22}" dt="2020-03-12T06:26:51.655" v="902" actId="1038"/>
          <ac:cxnSpMkLst>
            <pc:docMk/>
            <pc:sldMk cId="1428766084" sldId="261"/>
            <ac:cxnSpMk id="93" creationId="{F7590234-53C5-42C5-BCB8-877016184A9E}"/>
          </ac:cxnSpMkLst>
        </pc:cxnChg>
        <pc:cxnChg chg="mod topLvl">
          <ac:chgData name="Chew Leng Lim" userId="f4956819b06a5395" providerId="LiveId" clId="{18C7B61E-2F46-44F3-B4F9-D9413F1F6D22}" dt="2020-03-12T06:26:51.655" v="902" actId="1038"/>
          <ac:cxnSpMkLst>
            <pc:docMk/>
            <pc:sldMk cId="1428766084" sldId="261"/>
            <ac:cxnSpMk id="94" creationId="{28ED4A4D-9ACF-480F-98EC-6FA53C25C604}"/>
          </ac:cxnSpMkLst>
        </pc:cxnChg>
        <pc:cxnChg chg="mod topLvl">
          <ac:chgData name="Chew Leng Lim" userId="f4956819b06a5395" providerId="LiveId" clId="{18C7B61E-2F46-44F3-B4F9-D9413F1F6D22}" dt="2020-03-12T06:26:51.655" v="902" actId="1038"/>
          <ac:cxnSpMkLst>
            <pc:docMk/>
            <pc:sldMk cId="1428766084" sldId="261"/>
            <ac:cxnSpMk id="97" creationId="{5D8DB720-B925-49E0-ABB9-9B514C274304}"/>
          </ac:cxnSpMkLst>
        </pc:cxnChg>
        <pc:cxnChg chg="mod topLvl">
          <ac:chgData name="Chew Leng Lim" userId="f4956819b06a5395" providerId="LiveId" clId="{18C7B61E-2F46-44F3-B4F9-D9413F1F6D22}" dt="2020-03-12T06:28:21.504" v="973" actId="554"/>
          <ac:cxnSpMkLst>
            <pc:docMk/>
            <pc:sldMk cId="1428766084" sldId="261"/>
            <ac:cxnSpMk id="105" creationId="{B4396CE3-E160-4CB8-A9B2-ACBB92AD6453}"/>
          </ac:cxnSpMkLst>
        </pc:cxnChg>
        <pc:cxnChg chg="mod topLvl">
          <ac:chgData name="Chew Leng Lim" userId="f4956819b06a5395" providerId="LiveId" clId="{18C7B61E-2F46-44F3-B4F9-D9413F1F6D22}" dt="2020-03-12T06:29:00.382" v="983" actId="553"/>
          <ac:cxnSpMkLst>
            <pc:docMk/>
            <pc:sldMk cId="1428766084" sldId="261"/>
            <ac:cxnSpMk id="106" creationId="{859F79A1-26A2-4978-8A7F-875E00C58B7B}"/>
          </ac:cxnSpMkLst>
        </pc:cxnChg>
        <pc:cxnChg chg="mod topLvl">
          <ac:chgData name="Chew Leng Lim" userId="f4956819b06a5395" providerId="LiveId" clId="{18C7B61E-2F46-44F3-B4F9-D9413F1F6D22}" dt="2020-03-12T06:28:49.200" v="977" actId="552"/>
          <ac:cxnSpMkLst>
            <pc:docMk/>
            <pc:sldMk cId="1428766084" sldId="261"/>
            <ac:cxnSpMk id="109" creationId="{B2EDBC53-1C65-4FBB-AA3A-C17AA3733F51}"/>
          </ac:cxnSpMkLst>
        </pc:cxnChg>
        <pc:cxnChg chg="mod topLvl">
          <ac:chgData name="Chew Leng Lim" userId="f4956819b06a5395" providerId="LiveId" clId="{18C7B61E-2F46-44F3-B4F9-D9413F1F6D22}" dt="2020-03-12T06:28:21.504" v="973" actId="554"/>
          <ac:cxnSpMkLst>
            <pc:docMk/>
            <pc:sldMk cId="1428766084" sldId="261"/>
            <ac:cxnSpMk id="110" creationId="{B8336AF4-8DC4-4104-B7F5-64A6F0C1073C}"/>
          </ac:cxnSpMkLst>
        </pc:cxnChg>
        <pc:cxnChg chg="mod topLvl">
          <ac:chgData name="Chew Leng Lim" userId="f4956819b06a5395" providerId="LiveId" clId="{18C7B61E-2F46-44F3-B4F9-D9413F1F6D22}" dt="2020-03-12T06:29:11.527" v="997" actId="552"/>
          <ac:cxnSpMkLst>
            <pc:docMk/>
            <pc:sldMk cId="1428766084" sldId="261"/>
            <ac:cxnSpMk id="111" creationId="{403F05C5-36A2-4CD8-B9A4-4FF0A7B58C20}"/>
          </ac:cxnSpMkLst>
        </pc:cxnChg>
        <pc:cxnChg chg="mod topLvl">
          <ac:chgData name="Chew Leng Lim" userId="f4956819b06a5395" providerId="LiveId" clId="{18C7B61E-2F46-44F3-B4F9-D9413F1F6D22}" dt="2020-03-12T06:29:23.842" v="998" actId="14100"/>
          <ac:cxnSpMkLst>
            <pc:docMk/>
            <pc:sldMk cId="1428766084" sldId="261"/>
            <ac:cxnSpMk id="113" creationId="{6DDCD14D-6408-40F7-B0F3-3CD43D646326}"/>
          </ac:cxnSpMkLst>
        </pc:cxnChg>
        <pc:cxnChg chg="add mod">
          <ac:chgData name="Chew Leng Lim" userId="f4956819b06a5395" providerId="LiveId" clId="{18C7B61E-2F46-44F3-B4F9-D9413F1F6D22}" dt="2020-03-12T06:24:59.123" v="882" actId="552"/>
          <ac:cxnSpMkLst>
            <pc:docMk/>
            <pc:sldMk cId="1428766084" sldId="261"/>
            <ac:cxnSpMk id="129" creationId="{DF0C095F-092A-4198-AEDB-8C57FC6401DE}"/>
          </ac:cxnSpMkLst>
        </pc:cxnChg>
        <pc:cxnChg chg="add mod">
          <ac:chgData name="Chew Leng Lim" userId="f4956819b06a5395" providerId="LiveId" clId="{18C7B61E-2F46-44F3-B4F9-D9413F1F6D22}" dt="2020-03-12T06:24:59.123" v="882" actId="552"/>
          <ac:cxnSpMkLst>
            <pc:docMk/>
            <pc:sldMk cId="1428766084" sldId="261"/>
            <ac:cxnSpMk id="130" creationId="{AEE4730F-D1B5-4D39-B774-D7B809579A70}"/>
          </ac:cxnSpMkLst>
        </pc:cxnChg>
        <pc:cxnChg chg="add mod">
          <ac:chgData name="Chew Leng Lim" userId="f4956819b06a5395" providerId="LiveId" clId="{18C7B61E-2F46-44F3-B4F9-D9413F1F6D22}" dt="2020-03-12T06:24:50.572" v="876" actId="553"/>
          <ac:cxnSpMkLst>
            <pc:docMk/>
            <pc:sldMk cId="1428766084" sldId="261"/>
            <ac:cxnSpMk id="131" creationId="{E5256EB5-9A6A-442F-A8DF-470D02502D3B}"/>
          </ac:cxnSpMkLst>
        </pc:cxnChg>
      </pc:sldChg>
      <pc:sldChg chg="delSp modSp del">
        <pc:chgData name="Chew Leng Lim" userId="f4956819b06a5395" providerId="LiveId" clId="{18C7B61E-2F46-44F3-B4F9-D9413F1F6D22}" dt="2020-03-03T10:05:26.976" v="339" actId="2696"/>
        <pc:sldMkLst>
          <pc:docMk/>
          <pc:sldMk cId="129379560" sldId="295"/>
        </pc:sldMkLst>
        <pc:spChg chg="mod">
          <ac:chgData name="Chew Leng Lim" userId="f4956819b06a5395" providerId="LiveId" clId="{18C7B61E-2F46-44F3-B4F9-D9413F1F6D22}" dt="2020-03-03T10:05:00.859" v="338" actId="1076"/>
          <ac:spMkLst>
            <pc:docMk/>
            <pc:sldMk cId="129379560" sldId="295"/>
            <ac:spMk id="56" creationId="{64C060FB-CAF9-4F7D-9505-A6240E94336C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99" creationId="{409E17C7-4701-44C6-B5FE-79CD980A027A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00" creationId="{77A1BF7F-C15B-42D9-B89C-31DC4683950F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06" creationId="{7CBBA212-157F-484E-A1CB-98B408BC79D1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10" creationId="{3B16565B-F1AA-4A9C-9F74-E95366F50B58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13" creationId="{A191C67F-7F2A-42F8-A013-1B80C96D81C3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16" creationId="{C4ECC555-00EE-4577-9671-B421BF499D59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17" creationId="{CC828BE9-FAF4-45D2-B912-B7C3A46B3652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19" creationId="{C3DA5CD0-1840-4E81-A049-2728C24657B6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20" creationId="{3D6F10CC-8C3A-4686-9C97-4FFF097757A5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22" creationId="{7A7375FD-5A12-4910-AE0F-3791FB45CC54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23" creationId="{E7EE2B5B-589A-4FDA-A432-640FBFFE7203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24" creationId="{6539115E-152F-4214-9251-60A33465A958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25" creationId="{A98501AB-76C5-4F4D-A654-ABD2B10B4038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26" creationId="{AACB294E-CFB5-4A7C-9DAC-FFEBEA043380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41" creationId="{68E790DC-44D9-4B05-83EB-CA3CC9DDDFDD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53" creationId="{D5A04AA4-64A2-47CD-961C-067C7F85C20E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54" creationId="{999F4F04-28D8-4AB7-9E89-97F945F4EF68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58" creationId="{058580B5-AF37-4A35-B7A5-576F3D49B991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59" creationId="{779A73BD-0CBF-4F7F-B4AC-4583C4017F41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60" creationId="{D9AC1CD2-99C6-412C-B508-A7A17BB74DF9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61" creationId="{280FA2A3-3132-42C9-877E-0BC412FD3754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63" creationId="{F4A1BE81-D9F5-4800-AF07-5871ABE43025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69" creationId="{08257E8E-FA50-4ACF-BF4C-96BE939A05C4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72" creationId="{6EE5C238-4380-49DA-B295-8C828D09C735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73" creationId="{943584EA-499C-43A2-9B6E-012A65FD769C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74" creationId="{807B200E-0F80-4EE9-8C6E-C0E6060F3D15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75" creationId="{AF64334C-A116-405E-B7D9-7B3BD798198F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76" creationId="{8FA410D4-1F28-438D-9FAE-AD52EF8EABF6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79" creationId="{83A5CF1E-565D-49AD-A079-DA3917B6A4BB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80" creationId="{E2A6E13E-3143-4125-B32B-6228EC70865B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84" creationId="{24219249-6E98-495B-9B89-A8390676B630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90" creationId="{5A3D3865-61DF-4B21-A513-493BF72A4E2F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91" creationId="{50CD04FA-9313-4F79-85B9-C604FA620F55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92" creationId="{276D8CDA-0629-455A-BE86-1E6604D17AC3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93" creationId="{D9479CC2-3AFE-429B-B9CB-6EDFABDBADB5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94" creationId="{E54F6718-7BAD-4C35-8BC9-099745D43FD9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95" creationId="{A7556020-405A-4312-83B8-290F22F9316E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96" creationId="{A971748D-6DC8-441B-B3A4-4EC5E2513F05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97" creationId="{17A1789D-838E-4275-AC1D-36C4DA5091CD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98" creationId="{0F0803D5-C42A-4847-8BAC-103C46F232D8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199" creationId="{BF69A443-C15A-43E2-BA6E-BB6C14C165E5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203" creationId="{8F77818A-02A3-4C21-9056-46897183C8B2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204" creationId="{ED323F9B-4949-4226-B8C4-EF3B3A08AA2E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208" creationId="{67B9D7BA-026D-4564-954B-474A1FE04319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209" creationId="{0C23EBC1-8D26-4E4B-95FB-C2EB629A0A91}"/>
          </ac:spMkLst>
        </pc:spChg>
        <pc:spChg chg="del">
          <ac:chgData name="Chew Leng Lim" userId="f4956819b06a5395" providerId="LiveId" clId="{18C7B61E-2F46-44F3-B4F9-D9413F1F6D22}" dt="2020-03-03T10:04:35.637" v="334" actId="478"/>
          <ac:spMkLst>
            <pc:docMk/>
            <pc:sldMk cId="129379560" sldId="295"/>
            <ac:spMk id="210" creationId="{200DDC37-203D-49BF-979F-4F5756D46EEE}"/>
          </ac:spMkLst>
        </pc:spChg>
        <pc:graphicFrameChg chg="del">
          <ac:chgData name="Chew Leng Lim" userId="f4956819b06a5395" providerId="LiveId" clId="{18C7B61E-2F46-44F3-B4F9-D9413F1F6D22}" dt="2020-03-03T10:04:35.637" v="334" actId="478"/>
          <ac:graphicFrameMkLst>
            <pc:docMk/>
            <pc:sldMk cId="129379560" sldId="295"/>
            <ac:graphicFrameMk id="98" creationId="{D3EB3D33-28EE-45D3-AE15-7C67392ED26B}"/>
          </ac:graphicFrameMkLst>
        </pc:graphicFrameChg>
        <pc:graphicFrameChg chg="del">
          <ac:chgData name="Chew Leng Lim" userId="f4956819b06a5395" providerId="LiveId" clId="{18C7B61E-2F46-44F3-B4F9-D9413F1F6D22}" dt="2020-03-03T10:04:35.637" v="334" actId="478"/>
          <ac:graphicFrameMkLst>
            <pc:docMk/>
            <pc:sldMk cId="129379560" sldId="295"/>
            <ac:graphicFrameMk id="157" creationId="{5A442EA5-4E25-4063-AB66-64522CCADEA2}"/>
          </ac:graphicFrameMkLst>
        </pc:graphicFrameChg>
        <pc:graphicFrameChg chg="del">
          <ac:chgData name="Chew Leng Lim" userId="f4956819b06a5395" providerId="LiveId" clId="{18C7B61E-2F46-44F3-B4F9-D9413F1F6D22}" dt="2020-03-03T10:04:35.637" v="334" actId="478"/>
          <ac:graphicFrameMkLst>
            <pc:docMk/>
            <pc:sldMk cId="129379560" sldId="295"/>
            <ac:graphicFrameMk id="189" creationId="{5F5B5F91-672B-41B8-8448-45871599C5BF}"/>
          </ac:graphicFrameMkLst>
        </pc:graphicFrameChg>
        <pc:cxnChg chg="del">
          <ac:chgData name="Chew Leng Lim" userId="f4956819b06a5395" providerId="LiveId" clId="{18C7B61E-2F46-44F3-B4F9-D9413F1F6D22}" dt="2020-03-03T10:04:35.637" v="334" actId="478"/>
          <ac:cxnSpMkLst>
            <pc:docMk/>
            <pc:sldMk cId="129379560" sldId="295"/>
            <ac:cxnSpMk id="127" creationId="{50C76F91-6244-447D-B140-D274952103D9}"/>
          </ac:cxnSpMkLst>
        </pc:cxnChg>
        <pc:cxnChg chg="del">
          <ac:chgData name="Chew Leng Lim" userId="f4956819b06a5395" providerId="LiveId" clId="{18C7B61E-2F46-44F3-B4F9-D9413F1F6D22}" dt="2020-03-03T10:04:35.637" v="334" actId="478"/>
          <ac:cxnSpMkLst>
            <pc:docMk/>
            <pc:sldMk cId="129379560" sldId="295"/>
            <ac:cxnSpMk id="128" creationId="{BB3AE685-A98E-410F-B339-6AEE7E63C507}"/>
          </ac:cxnSpMkLst>
        </pc:cxnChg>
        <pc:cxnChg chg="del">
          <ac:chgData name="Chew Leng Lim" userId="f4956819b06a5395" providerId="LiveId" clId="{18C7B61E-2F46-44F3-B4F9-D9413F1F6D22}" dt="2020-03-03T10:04:35.637" v="334" actId="478"/>
          <ac:cxnSpMkLst>
            <pc:docMk/>
            <pc:sldMk cId="129379560" sldId="295"/>
            <ac:cxnSpMk id="129" creationId="{39205B86-7A62-45E7-9842-2C9972021FA4}"/>
          </ac:cxnSpMkLst>
        </pc:cxnChg>
        <pc:cxnChg chg="del">
          <ac:chgData name="Chew Leng Lim" userId="f4956819b06a5395" providerId="LiveId" clId="{18C7B61E-2F46-44F3-B4F9-D9413F1F6D22}" dt="2020-03-03T10:04:35.637" v="334" actId="478"/>
          <ac:cxnSpMkLst>
            <pc:docMk/>
            <pc:sldMk cId="129379560" sldId="295"/>
            <ac:cxnSpMk id="144" creationId="{2FC9A154-E822-4C3D-9EDB-EB5150E1D5DE}"/>
          </ac:cxnSpMkLst>
        </pc:cxnChg>
        <pc:cxnChg chg="del">
          <ac:chgData name="Chew Leng Lim" userId="f4956819b06a5395" providerId="LiveId" clId="{18C7B61E-2F46-44F3-B4F9-D9413F1F6D22}" dt="2020-03-03T10:04:35.637" v="334" actId="478"/>
          <ac:cxnSpMkLst>
            <pc:docMk/>
            <pc:sldMk cId="129379560" sldId="295"/>
            <ac:cxnSpMk id="146" creationId="{3F5A0563-3610-445E-9F81-A1228ECC7F02}"/>
          </ac:cxnSpMkLst>
        </pc:cxnChg>
        <pc:cxnChg chg="del">
          <ac:chgData name="Chew Leng Lim" userId="f4956819b06a5395" providerId="LiveId" clId="{18C7B61E-2F46-44F3-B4F9-D9413F1F6D22}" dt="2020-03-03T10:04:35.637" v="334" actId="478"/>
          <ac:cxnSpMkLst>
            <pc:docMk/>
            <pc:sldMk cId="129379560" sldId="295"/>
            <ac:cxnSpMk id="148" creationId="{2D2EDF35-5E1E-4BFC-AC37-9630C1B63A97}"/>
          </ac:cxnSpMkLst>
        </pc:cxnChg>
        <pc:cxnChg chg="del">
          <ac:chgData name="Chew Leng Lim" userId="f4956819b06a5395" providerId="LiveId" clId="{18C7B61E-2F46-44F3-B4F9-D9413F1F6D22}" dt="2020-03-03T10:04:35.637" v="334" actId="478"/>
          <ac:cxnSpMkLst>
            <pc:docMk/>
            <pc:sldMk cId="129379560" sldId="295"/>
            <ac:cxnSpMk id="177" creationId="{AB8A47BD-E462-486F-B364-360282AF84B7}"/>
          </ac:cxnSpMkLst>
        </pc:cxnChg>
        <pc:cxnChg chg="del">
          <ac:chgData name="Chew Leng Lim" userId="f4956819b06a5395" providerId="LiveId" clId="{18C7B61E-2F46-44F3-B4F9-D9413F1F6D22}" dt="2020-03-03T10:04:35.637" v="334" actId="478"/>
          <ac:cxnSpMkLst>
            <pc:docMk/>
            <pc:sldMk cId="129379560" sldId="295"/>
            <ac:cxnSpMk id="178" creationId="{1B7E16A7-7AD0-4FC6-AA06-158FDC88463B}"/>
          </ac:cxnSpMkLst>
        </pc:cxnChg>
        <pc:cxnChg chg="del">
          <ac:chgData name="Chew Leng Lim" userId="f4956819b06a5395" providerId="LiveId" clId="{18C7B61E-2F46-44F3-B4F9-D9413F1F6D22}" dt="2020-03-03T10:04:35.637" v="334" actId="478"/>
          <ac:cxnSpMkLst>
            <pc:docMk/>
            <pc:sldMk cId="129379560" sldId="295"/>
            <ac:cxnSpMk id="181" creationId="{7E0FB8BA-6A48-4BBC-BFA2-121C6725F2B7}"/>
          </ac:cxnSpMkLst>
        </pc:cxnChg>
        <pc:cxnChg chg="del">
          <ac:chgData name="Chew Leng Lim" userId="f4956819b06a5395" providerId="LiveId" clId="{18C7B61E-2F46-44F3-B4F9-D9413F1F6D22}" dt="2020-03-03T10:04:35.637" v="334" actId="478"/>
          <ac:cxnSpMkLst>
            <pc:docMk/>
            <pc:sldMk cId="129379560" sldId="295"/>
            <ac:cxnSpMk id="182" creationId="{60733E15-EC91-4EAB-A838-9EFF58B40B77}"/>
          </ac:cxnSpMkLst>
        </pc:cxnChg>
        <pc:cxnChg chg="del">
          <ac:chgData name="Chew Leng Lim" userId="f4956819b06a5395" providerId="LiveId" clId="{18C7B61E-2F46-44F3-B4F9-D9413F1F6D22}" dt="2020-03-03T10:04:35.637" v="334" actId="478"/>
          <ac:cxnSpMkLst>
            <pc:docMk/>
            <pc:sldMk cId="129379560" sldId="295"/>
            <ac:cxnSpMk id="183" creationId="{3B8FECA4-E767-4493-AAAE-5E0370661E9B}"/>
          </ac:cxnSpMkLst>
        </pc:cxnChg>
        <pc:cxnChg chg="del">
          <ac:chgData name="Chew Leng Lim" userId="f4956819b06a5395" providerId="LiveId" clId="{18C7B61E-2F46-44F3-B4F9-D9413F1F6D22}" dt="2020-03-03T10:04:35.637" v="334" actId="478"/>
          <ac:cxnSpMkLst>
            <pc:docMk/>
            <pc:sldMk cId="129379560" sldId="295"/>
            <ac:cxnSpMk id="185" creationId="{2CCCE4D4-FA16-4084-B280-D17BABD89211}"/>
          </ac:cxnSpMkLst>
        </pc:cxnChg>
        <pc:cxnChg chg="del">
          <ac:chgData name="Chew Leng Lim" userId="f4956819b06a5395" providerId="LiveId" clId="{18C7B61E-2F46-44F3-B4F9-D9413F1F6D22}" dt="2020-03-03T10:04:35.637" v="334" actId="478"/>
          <ac:cxnSpMkLst>
            <pc:docMk/>
            <pc:sldMk cId="129379560" sldId="295"/>
            <ac:cxnSpMk id="186" creationId="{AE2137F0-06D1-4856-9456-831F8531FF1A}"/>
          </ac:cxnSpMkLst>
        </pc:cxnChg>
        <pc:cxnChg chg="del">
          <ac:chgData name="Chew Leng Lim" userId="f4956819b06a5395" providerId="LiveId" clId="{18C7B61E-2F46-44F3-B4F9-D9413F1F6D22}" dt="2020-03-03T10:04:35.637" v="334" actId="478"/>
          <ac:cxnSpMkLst>
            <pc:docMk/>
            <pc:sldMk cId="129379560" sldId="295"/>
            <ac:cxnSpMk id="187" creationId="{8D7A09EE-78F5-46B8-A214-1DDFDAF1F679}"/>
          </ac:cxnSpMkLst>
        </pc:cxnChg>
        <pc:cxnChg chg="del">
          <ac:chgData name="Chew Leng Lim" userId="f4956819b06a5395" providerId="LiveId" clId="{18C7B61E-2F46-44F3-B4F9-D9413F1F6D22}" dt="2020-03-03T10:04:35.637" v="334" actId="478"/>
          <ac:cxnSpMkLst>
            <pc:docMk/>
            <pc:sldMk cId="129379560" sldId="295"/>
            <ac:cxnSpMk id="201" creationId="{251E741A-FB87-4ADC-B357-01F4141AA603}"/>
          </ac:cxnSpMkLst>
        </pc:cxnChg>
        <pc:cxnChg chg="del">
          <ac:chgData name="Chew Leng Lim" userId="f4956819b06a5395" providerId="LiveId" clId="{18C7B61E-2F46-44F3-B4F9-D9413F1F6D22}" dt="2020-03-03T10:04:35.637" v="334" actId="478"/>
          <ac:cxnSpMkLst>
            <pc:docMk/>
            <pc:sldMk cId="129379560" sldId="295"/>
            <ac:cxnSpMk id="202" creationId="{3163A85B-69FF-4640-96F8-C988B282D979}"/>
          </ac:cxnSpMkLst>
        </pc:cxnChg>
        <pc:cxnChg chg="del">
          <ac:chgData name="Chew Leng Lim" userId="f4956819b06a5395" providerId="LiveId" clId="{18C7B61E-2F46-44F3-B4F9-D9413F1F6D22}" dt="2020-03-03T10:04:35.637" v="334" actId="478"/>
          <ac:cxnSpMkLst>
            <pc:docMk/>
            <pc:sldMk cId="129379560" sldId="295"/>
            <ac:cxnSpMk id="205" creationId="{AC047DB6-5715-44C5-89D3-DF39F79682BF}"/>
          </ac:cxnSpMkLst>
        </pc:cxnChg>
        <pc:cxnChg chg="del">
          <ac:chgData name="Chew Leng Lim" userId="f4956819b06a5395" providerId="LiveId" clId="{18C7B61E-2F46-44F3-B4F9-D9413F1F6D22}" dt="2020-03-03T10:04:35.637" v="334" actId="478"/>
          <ac:cxnSpMkLst>
            <pc:docMk/>
            <pc:sldMk cId="129379560" sldId="295"/>
            <ac:cxnSpMk id="206" creationId="{3FE62509-E658-41B4-B091-13E2F230ACE6}"/>
          </ac:cxnSpMkLst>
        </pc:cxnChg>
        <pc:cxnChg chg="del">
          <ac:chgData name="Chew Leng Lim" userId="f4956819b06a5395" providerId="LiveId" clId="{18C7B61E-2F46-44F3-B4F9-D9413F1F6D22}" dt="2020-03-03T10:04:35.637" v="334" actId="478"/>
          <ac:cxnSpMkLst>
            <pc:docMk/>
            <pc:sldMk cId="129379560" sldId="295"/>
            <ac:cxnSpMk id="207" creationId="{09972716-88E6-4F24-89D5-54706DA3B28F}"/>
          </ac:cxnSpMkLst>
        </pc:cxnChg>
      </pc:sldChg>
      <pc:sldChg chg="delSp modSp">
        <pc:chgData name="Chew Leng Lim" userId="f4956819b06a5395" providerId="LiveId" clId="{18C7B61E-2F46-44F3-B4F9-D9413F1F6D22}" dt="2020-03-12T07:41:13.703" v="7023" actId="6549"/>
        <pc:sldMkLst>
          <pc:docMk/>
          <pc:sldMk cId="1896826950" sldId="296"/>
        </pc:sldMkLst>
        <pc:spChg chg="mod topLvl">
          <ac:chgData name="Chew Leng Lim" userId="f4956819b06a5395" providerId="LiveId" clId="{18C7B61E-2F46-44F3-B4F9-D9413F1F6D22}" dt="2020-03-12T07:10:40.335" v="2618" actId="1036"/>
          <ac:spMkLst>
            <pc:docMk/>
            <pc:sldMk cId="1896826950" sldId="296"/>
            <ac:spMk id="5" creationId="{4268448E-44BF-4DE0-9D1F-4D88C3BC9B2B}"/>
          </ac:spMkLst>
        </pc:spChg>
        <pc:spChg chg="mod topLvl">
          <ac:chgData name="Chew Leng Lim" userId="f4956819b06a5395" providerId="LiveId" clId="{18C7B61E-2F46-44F3-B4F9-D9413F1F6D22}" dt="2020-03-12T07:10:40.335" v="2618" actId="1036"/>
          <ac:spMkLst>
            <pc:docMk/>
            <pc:sldMk cId="1896826950" sldId="296"/>
            <ac:spMk id="6" creationId="{156A1A7C-B13B-47C9-BEA5-5C1CC741772A}"/>
          </ac:spMkLst>
        </pc:spChg>
        <pc:spChg chg="mod topLvl">
          <ac:chgData name="Chew Leng Lim" userId="f4956819b06a5395" providerId="LiveId" clId="{18C7B61E-2F46-44F3-B4F9-D9413F1F6D22}" dt="2020-03-12T07:10:40.335" v="2618" actId="1036"/>
          <ac:spMkLst>
            <pc:docMk/>
            <pc:sldMk cId="1896826950" sldId="296"/>
            <ac:spMk id="7" creationId="{5DB68B95-4C0D-4591-A0B4-9747034CFA57}"/>
          </ac:spMkLst>
        </pc:spChg>
        <pc:spChg chg="mod topLvl">
          <ac:chgData name="Chew Leng Lim" userId="f4956819b06a5395" providerId="LiveId" clId="{18C7B61E-2F46-44F3-B4F9-D9413F1F6D22}" dt="2020-03-12T07:10:40.335" v="2618" actId="1036"/>
          <ac:spMkLst>
            <pc:docMk/>
            <pc:sldMk cId="1896826950" sldId="296"/>
            <ac:spMk id="8" creationId="{46D33681-C30D-4DC2-889C-015EA2AD0192}"/>
          </ac:spMkLst>
        </pc:spChg>
        <pc:spChg chg="mod topLvl">
          <ac:chgData name="Chew Leng Lim" userId="f4956819b06a5395" providerId="LiveId" clId="{18C7B61E-2F46-44F3-B4F9-D9413F1F6D22}" dt="2020-03-12T07:10:40.335" v="2618" actId="1036"/>
          <ac:spMkLst>
            <pc:docMk/>
            <pc:sldMk cId="1896826950" sldId="296"/>
            <ac:spMk id="9" creationId="{F898C9EA-E551-4797-B21E-2B716AF4595A}"/>
          </ac:spMkLst>
        </pc:spChg>
        <pc:spChg chg="del">
          <ac:chgData name="Chew Leng Lim" userId="f4956819b06a5395" providerId="LiveId" clId="{18C7B61E-2F46-44F3-B4F9-D9413F1F6D22}" dt="2020-03-03T10:39:25" v="374" actId="478"/>
          <ac:spMkLst>
            <pc:docMk/>
            <pc:sldMk cId="1896826950" sldId="296"/>
            <ac:spMk id="12" creationId="{43FB64F8-20B0-489A-8E62-6808647F2017}"/>
          </ac:spMkLst>
        </pc:spChg>
        <pc:spChg chg="mod topLvl">
          <ac:chgData name="Chew Leng Lim" userId="f4956819b06a5395" providerId="LiveId" clId="{18C7B61E-2F46-44F3-B4F9-D9413F1F6D22}" dt="2020-03-12T07:10:40.335" v="2618" actId="1036"/>
          <ac:spMkLst>
            <pc:docMk/>
            <pc:sldMk cId="1896826950" sldId="296"/>
            <ac:spMk id="14" creationId="{718A5641-272C-4916-B1F8-D7E4B0A94BC6}"/>
          </ac:spMkLst>
        </pc:spChg>
        <pc:spChg chg="mod topLvl">
          <ac:chgData name="Chew Leng Lim" userId="f4956819b06a5395" providerId="LiveId" clId="{18C7B61E-2F46-44F3-B4F9-D9413F1F6D22}" dt="2020-03-12T07:10:40.335" v="2618" actId="1036"/>
          <ac:spMkLst>
            <pc:docMk/>
            <pc:sldMk cId="1896826950" sldId="296"/>
            <ac:spMk id="17" creationId="{0954B336-05A4-409F-9A22-FB80BC45CDC2}"/>
          </ac:spMkLst>
        </pc:spChg>
        <pc:spChg chg="mod topLvl">
          <ac:chgData name="Chew Leng Lim" userId="f4956819b06a5395" providerId="LiveId" clId="{18C7B61E-2F46-44F3-B4F9-D9413F1F6D22}" dt="2020-03-12T07:15:17.428" v="3189" actId="1038"/>
          <ac:spMkLst>
            <pc:docMk/>
            <pc:sldMk cId="1896826950" sldId="296"/>
            <ac:spMk id="28" creationId="{CFF408E8-1137-4B0F-8B2C-9E62E531342A}"/>
          </ac:spMkLst>
        </pc:spChg>
        <pc:spChg chg="mod topLvl">
          <ac:chgData name="Chew Leng Lim" userId="f4956819b06a5395" providerId="LiveId" clId="{18C7B61E-2F46-44F3-B4F9-D9413F1F6D22}" dt="2020-03-12T06:29:48.371" v="1000" actId="165"/>
          <ac:spMkLst>
            <pc:docMk/>
            <pc:sldMk cId="1896826950" sldId="296"/>
            <ac:spMk id="75" creationId="{5E64093C-0FD7-4751-8301-4905C704167A}"/>
          </ac:spMkLst>
        </pc:spChg>
        <pc:spChg chg="mod topLvl">
          <ac:chgData name="Chew Leng Lim" userId="f4956819b06a5395" providerId="LiveId" clId="{18C7B61E-2F46-44F3-B4F9-D9413F1F6D22}" dt="2020-03-12T06:29:48.371" v="1000" actId="165"/>
          <ac:spMkLst>
            <pc:docMk/>
            <pc:sldMk cId="1896826950" sldId="296"/>
            <ac:spMk id="76" creationId="{0E995113-8686-49A5-A658-A892B4C28274}"/>
          </ac:spMkLst>
        </pc:spChg>
        <pc:spChg chg="mod topLvl">
          <ac:chgData name="Chew Leng Lim" userId="f4956819b06a5395" providerId="LiveId" clId="{18C7B61E-2F46-44F3-B4F9-D9413F1F6D22}" dt="2020-03-12T06:29:48.371" v="1000" actId="165"/>
          <ac:spMkLst>
            <pc:docMk/>
            <pc:sldMk cId="1896826950" sldId="296"/>
            <ac:spMk id="77" creationId="{C2D1AAC6-7A95-41B8-BB03-4A99BBE9DA27}"/>
          </ac:spMkLst>
        </pc:spChg>
        <pc:spChg chg="mod topLvl">
          <ac:chgData name="Chew Leng Lim" userId="f4956819b06a5395" providerId="LiveId" clId="{18C7B61E-2F46-44F3-B4F9-D9413F1F6D22}" dt="2020-03-12T06:29:48.371" v="1000" actId="165"/>
          <ac:spMkLst>
            <pc:docMk/>
            <pc:sldMk cId="1896826950" sldId="296"/>
            <ac:spMk id="78" creationId="{0EBF6B40-6603-4B4B-85DF-37349797F661}"/>
          </ac:spMkLst>
        </pc:spChg>
        <pc:spChg chg="mod topLvl">
          <ac:chgData name="Chew Leng Lim" userId="f4956819b06a5395" providerId="LiveId" clId="{18C7B61E-2F46-44F3-B4F9-D9413F1F6D22}" dt="2020-03-12T06:29:48.371" v="1000" actId="165"/>
          <ac:spMkLst>
            <pc:docMk/>
            <pc:sldMk cId="1896826950" sldId="296"/>
            <ac:spMk id="85" creationId="{9B946AD5-A5BA-418C-982E-BB878404D5B8}"/>
          </ac:spMkLst>
        </pc:spChg>
        <pc:spChg chg="mod topLvl">
          <ac:chgData name="Chew Leng Lim" userId="f4956819b06a5395" providerId="LiveId" clId="{18C7B61E-2F46-44F3-B4F9-D9413F1F6D22}" dt="2020-03-12T06:29:48.371" v="1000" actId="165"/>
          <ac:spMkLst>
            <pc:docMk/>
            <pc:sldMk cId="1896826950" sldId="296"/>
            <ac:spMk id="89" creationId="{20720433-FD2C-4912-A1C4-2CCDB8BA5B95}"/>
          </ac:spMkLst>
        </pc:spChg>
        <pc:spChg chg="mod topLvl">
          <ac:chgData name="Chew Leng Lim" userId="f4956819b06a5395" providerId="LiveId" clId="{18C7B61E-2F46-44F3-B4F9-D9413F1F6D22}" dt="2020-03-12T07:10:40.335" v="2618" actId="1036"/>
          <ac:spMkLst>
            <pc:docMk/>
            <pc:sldMk cId="1896826950" sldId="296"/>
            <ac:spMk id="105" creationId="{E37771D6-7698-406D-8A0E-1A7DC90DDCF4}"/>
          </ac:spMkLst>
        </pc:spChg>
        <pc:spChg chg="mod topLvl">
          <ac:chgData name="Chew Leng Lim" userId="f4956819b06a5395" providerId="LiveId" clId="{18C7B61E-2F46-44F3-B4F9-D9413F1F6D22}" dt="2020-03-12T07:10:40.335" v="2618" actId="1036"/>
          <ac:spMkLst>
            <pc:docMk/>
            <pc:sldMk cId="1896826950" sldId="296"/>
            <ac:spMk id="106" creationId="{70795C53-8CAB-4346-BC9D-72B3FE644471}"/>
          </ac:spMkLst>
        </pc:spChg>
        <pc:spChg chg="mod topLvl">
          <ac:chgData name="Chew Leng Lim" userId="f4956819b06a5395" providerId="LiveId" clId="{18C7B61E-2F46-44F3-B4F9-D9413F1F6D22}" dt="2020-03-12T07:10:40.335" v="2618" actId="1036"/>
          <ac:spMkLst>
            <pc:docMk/>
            <pc:sldMk cId="1896826950" sldId="296"/>
            <ac:spMk id="108" creationId="{4F7BB5FA-9A05-435B-96BA-D73932F5F41B}"/>
          </ac:spMkLst>
        </pc:spChg>
        <pc:spChg chg="mod topLvl">
          <ac:chgData name="Chew Leng Lim" userId="f4956819b06a5395" providerId="LiveId" clId="{18C7B61E-2F46-44F3-B4F9-D9413F1F6D22}" dt="2020-03-12T07:10:40.335" v="2618" actId="1036"/>
          <ac:spMkLst>
            <pc:docMk/>
            <pc:sldMk cId="1896826950" sldId="296"/>
            <ac:spMk id="110" creationId="{9ECF6F32-78E9-403A-A9BF-412EC3B11CD8}"/>
          </ac:spMkLst>
        </pc:spChg>
        <pc:spChg chg="mod topLvl">
          <ac:chgData name="Chew Leng Lim" userId="f4956819b06a5395" providerId="LiveId" clId="{18C7B61E-2F46-44F3-B4F9-D9413F1F6D22}" dt="2020-03-12T07:10:40.335" v="2618" actId="1036"/>
          <ac:spMkLst>
            <pc:docMk/>
            <pc:sldMk cId="1896826950" sldId="296"/>
            <ac:spMk id="111" creationId="{F6126135-E109-4FC6-B8BA-374C12EC135D}"/>
          </ac:spMkLst>
        </pc:spChg>
        <pc:spChg chg="mod topLvl">
          <ac:chgData name="Chew Leng Lim" userId="f4956819b06a5395" providerId="LiveId" clId="{18C7B61E-2F46-44F3-B4F9-D9413F1F6D22}" dt="2020-03-12T07:10:40.335" v="2618" actId="1036"/>
          <ac:spMkLst>
            <pc:docMk/>
            <pc:sldMk cId="1896826950" sldId="296"/>
            <ac:spMk id="112" creationId="{5C0ABBB1-40EF-4EE0-AB3F-462005945458}"/>
          </ac:spMkLst>
        </pc:spChg>
        <pc:spChg chg="mod">
          <ac:chgData name="Chew Leng Lim" userId="f4956819b06a5395" providerId="LiveId" clId="{18C7B61E-2F46-44F3-B4F9-D9413F1F6D22}" dt="2020-03-12T06:23:24.005" v="853" actId="20577"/>
          <ac:spMkLst>
            <pc:docMk/>
            <pc:sldMk cId="1896826950" sldId="296"/>
            <ac:spMk id="122" creationId="{F1B87FB9-D37D-4264-9D00-601230AE8349}"/>
          </ac:spMkLst>
        </pc:spChg>
        <pc:spChg chg="mod topLvl">
          <ac:chgData name="Chew Leng Lim" userId="f4956819b06a5395" providerId="LiveId" clId="{18C7B61E-2F46-44F3-B4F9-D9413F1F6D22}" dt="2020-03-12T06:29:48.371" v="1000" actId="165"/>
          <ac:spMkLst>
            <pc:docMk/>
            <pc:sldMk cId="1896826950" sldId="296"/>
            <ac:spMk id="128" creationId="{4439A77E-D0B2-4D25-B227-297AECF015AD}"/>
          </ac:spMkLst>
        </pc:spChg>
        <pc:spChg chg="mod topLvl">
          <ac:chgData name="Chew Leng Lim" userId="f4956819b06a5395" providerId="LiveId" clId="{18C7B61E-2F46-44F3-B4F9-D9413F1F6D22}" dt="2020-03-12T06:29:48.371" v="1000" actId="165"/>
          <ac:spMkLst>
            <pc:docMk/>
            <pc:sldMk cId="1896826950" sldId="296"/>
            <ac:spMk id="133" creationId="{61743EE2-3112-420B-8D1D-B65303BFE202}"/>
          </ac:spMkLst>
        </pc:spChg>
        <pc:spChg chg="mod topLvl">
          <ac:chgData name="Chew Leng Lim" userId="f4956819b06a5395" providerId="LiveId" clId="{18C7B61E-2F46-44F3-B4F9-D9413F1F6D22}" dt="2020-03-12T06:24:15.623" v="856" actId="165"/>
          <ac:spMkLst>
            <pc:docMk/>
            <pc:sldMk cId="1896826950" sldId="296"/>
            <ac:spMk id="139" creationId="{8178C2F4-AA83-461F-B9EE-8E385622E54A}"/>
          </ac:spMkLst>
        </pc:spChg>
        <pc:spChg chg="mod topLvl">
          <ac:chgData name="Chew Leng Lim" userId="f4956819b06a5395" providerId="LiveId" clId="{18C7B61E-2F46-44F3-B4F9-D9413F1F6D22}" dt="2020-03-12T06:29:48.371" v="1000" actId="165"/>
          <ac:spMkLst>
            <pc:docMk/>
            <pc:sldMk cId="1896826950" sldId="296"/>
            <ac:spMk id="141" creationId="{10300C7A-FC44-4FA3-9276-2A8BB0981A15}"/>
          </ac:spMkLst>
        </pc:spChg>
        <pc:spChg chg="mod topLvl">
          <ac:chgData name="Chew Leng Lim" userId="f4956819b06a5395" providerId="LiveId" clId="{18C7B61E-2F46-44F3-B4F9-D9413F1F6D22}" dt="2020-03-12T06:29:38.152" v="999" actId="165"/>
          <ac:spMkLst>
            <pc:docMk/>
            <pc:sldMk cId="1896826950" sldId="296"/>
            <ac:spMk id="144" creationId="{BA30624C-AE16-4EB1-9A93-89D820B05A66}"/>
          </ac:spMkLst>
        </pc:spChg>
        <pc:spChg chg="mod topLvl">
          <ac:chgData name="Chew Leng Lim" userId="f4956819b06a5395" providerId="LiveId" clId="{18C7B61E-2F46-44F3-B4F9-D9413F1F6D22}" dt="2020-03-12T06:29:48.371" v="1000" actId="165"/>
          <ac:spMkLst>
            <pc:docMk/>
            <pc:sldMk cId="1896826950" sldId="296"/>
            <ac:spMk id="147" creationId="{EA5EAD66-48DE-4612-852C-9DFDF98283B3}"/>
          </ac:spMkLst>
        </pc:spChg>
        <pc:spChg chg="mod topLvl">
          <ac:chgData name="Chew Leng Lim" userId="f4956819b06a5395" providerId="LiveId" clId="{18C7B61E-2F46-44F3-B4F9-D9413F1F6D22}" dt="2020-03-12T07:15:12.145" v="3146" actId="1036"/>
          <ac:spMkLst>
            <pc:docMk/>
            <pc:sldMk cId="1896826950" sldId="296"/>
            <ac:spMk id="151" creationId="{CAC8FEDA-9FF7-4359-8F5F-EDE35E1B5AD9}"/>
          </ac:spMkLst>
        </pc:spChg>
        <pc:spChg chg="mod topLvl">
          <ac:chgData name="Chew Leng Lim" userId="f4956819b06a5395" providerId="LiveId" clId="{18C7B61E-2F46-44F3-B4F9-D9413F1F6D22}" dt="2020-03-12T07:15:05.052" v="3103" actId="1036"/>
          <ac:spMkLst>
            <pc:docMk/>
            <pc:sldMk cId="1896826950" sldId="296"/>
            <ac:spMk id="154" creationId="{8CE62314-8B7B-4611-B009-54A86E564A90}"/>
          </ac:spMkLst>
        </pc:spChg>
        <pc:spChg chg="del">
          <ac:chgData name="Chew Leng Lim" userId="f4956819b06a5395" providerId="LiveId" clId="{18C7B61E-2F46-44F3-B4F9-D9413F1F6D22}" dt="2020-03-03T10:39:25" v="374" actId="478"/>
          <ac:spMkLst>
            <pc:docMk/>
            <pc:sldMk cId="1896826950" sldId="296"/>
            <ac:spMk id="174" creationId="{FCE96318-D13D-4769-9802-188ADA73DDE3}"/>
          </ac:spMkLst>
        </pc:spChg>
        <pc:spChg chg="mod topLvl">
          <ac:chgData name="Chew Leng Lim" userId="f4956819b06a5395" providerId="LiveId" clId="{18C7B61E-2F46-44F3-B4F9-D9413F1F6D22}" dt="2020-03-12T07:13:30.564" v="2870" actId="1037"/>
          <ac:spMkLst>
            <pc:docMk/>
            <pc:sldMk cId="1896826950" sldId="296"/>
            <ac:spMk id="201" creationId="{413CBB3C-460D-4401-8671-41B1AE06C709}"/>
          </ac:spMkLst>
        </pc:spChg>
        <pc:spChg chg="mod topLvl">
          <ac:chgData name="Chew Leng Lim" userId="f4956819b06a5395" providerId="LiveId" clId="{18C7B61E-2F46-44F3-B4F9-D9413F1F6D22}" dt="2020-03-12T07:13:34.830" v="2873" actId="1036"/>
          <ac:spMkLst>
            <pc:docMk/>
            <pc:sldMk cId="1896826950" sldId="296"/>
            <ac:spMk id="206" creationId="{E76EA11E-A169-433E-9D8A-C91378949941}"/>
          </ac:spMkLst>
        </pc:spChg>
        <pc:spChg chg="mod topLvl">
          <ac:chgData name="Chew Leng Lim" userId="f4956819b06a5395" providerId="LiveId" clId="{18C7B61E-2F46-44F3-B4F9-D9413F1F6D22}" dt="2020-03-12T07:13:24.321" v="2860" actId="1035"/>
          <ac:spMkLst>
            <pc:docMk/>
            <pc:sldMk cId="1896826950" sldId="296"/>
            <ac:spMk id="209" creationId="{6E3BE21B-3521-445C-8D4B-4909CF64F12F}"/>
          </ac:spMkLst>
        </pc:spChg>
        <pc:spChg chg="mod">
          <ac:chgData name="Chew Leng Lim" userId="f4956819b06a5395" providerId="LiveId" clId="{18C7B61E-2F46-44F3-B4F9-D9413F1F6D22}" dt="2020-03-12T07:41:13.703" v="7023" actId="6549"/>
          <ac:spMkLst>
            <pc:docMk/>
            <pc:sldMk cId="1896826950" sldId="296"/>
            <ac:spMk id="239" creationId="{8B2133BF-0AB1-4213-B5E1-A8C9B7AF17DC}"/>
          </ac:spMkLst>
        </pc:spChg>
        <pc:grpChg chg="del mod topLvl">
          <ac:chgData name="Chew Leng Lim" userId="f4956819b06a5395" providerId="LiveId" clId="{18C7B61E-2F46-44F3-B4F9-D9413F1F6D22}" dt="2020-03-12T06:29:48.371" v="1000" actId="165"/>
          <ac:grpSpMkLst>
            <pc:docMk/>
            <pc:sldMk cId="1896826950" sldId="296"/>
            <ac:grpSpMk id="2" creationId="{E506187C-0C87-4095-BFE0-1AFC13D0CF8A}"/>
          </ac:grpSpMkLst>
        </pc:grpChg>
        <pc:grpChg chg="del">
          <ac:chgData name="Chew Leng Lim" userId="f4956819b06a5395" providerId="LiveId" clId="{18C7B61E-2F46-44F3-B4F9-D9413F1F6D22}" dt="2020-03-03T10:39:25" v="374" actId="478"/>
          <ac:grpSpMkLst>
            <pc:docMk/>
            <pc:sldMk cId="1896826950" sldId="296"/>
            <ac:grpSpMk id="11" creationId="{355801B5-A7A6-444C-A101-91B091E93839}"/>
          </ac:grpSpMkLst>
        </pc:grpChg>
        <pc:grpChg chg="del">
          <ac:chgData name="Chew Leng Lim" userId="f4956819b06a5395" providerId="LiveId" clId="{18C7B61E-2F46-44F3-B4F9-D9413F1F6D22}" dt="2020-03-12T06:24:15.623" v="856" actId="165"/>
          <ac:grpSpMkLst>
            <pc:docMk/>
            <pc:sldMk cId="1896826950" sldId="296"/>
            <ac:grpSpMk id="13" creationId="{C070997F-8443-46C0-8F43-B84371F745E6}"/>
          </ac:grpSpMkLst>
        </pc:grpChg>
        <pc:grpChg chg="mod">
          <ac:chgData name="Chew Leng Lim" userId="f4956819b06a5395" providerId="LiveId" clId="{18C7B61E-2F46-44F3-B4F9-D9413F1F6D22}" dt="2020-03-12T06:23:57.643" v="855"/>
          <ac:grpSpMkLst>
            <pc:docMk/>
            <pc:sldMk cId="1896826950" sldId="296"/>
            <ac:grpSpMk id="18" creationId="{C939EAD9-F48C-4A5C-B075-863E93C0EFBB}"/>
          </ac:grpSpMkLst>
        </pc:grpChg>
        <pc:grpChg chg="del">
          <ac:chgData name="Chew Leng Lim" userId="f4956819b06a5395" providerId="LiveId" clId="{18C7B61E-2F46-44F3-B4F9-D9413F1F6D22}" dt="2020-03-12T06:29:38.152" v="999" actId="165"/>
          <ac:grpSpMkLst>
            <pc:docMk/>
            <pc:sldMk cId="1896826950" sldId="296"/>
            <ac:grpSpMk id="19" creationId="{F08956ED-B985-4469-B04D-10AD55DF5F68}"/>
          </ac:grpSpMkLst>
        </pc:grpChg>
        <pc:grpChg chg="mod">
          <ac:chgData name="Chew Leng Lim" userId="f4956819b06a5395" providerId="LiveId" clId="{18C7B61E-2F46-44F3-B4F9-D9413F1F6D22}" dt="2020-03-12T07:10:52.494" v="2642" actId="1038"/>
          <ac:grpSpMkLst>
            <pc:docMk/>
            <pc:sldMk cId="1896826950" sldId="296"/>
            <ac:grpSpMk id="63" creationId="{872CFF0B-0FCE-4473-B77A-C5E7C664036F}"/>
          </ac:grpSpMkLst>
        </pc:grpChg>
        <pc:graphicFrameChg chg="mod topLvl">
          <ac:chgData name="Chew Leng Lim" userId="f4956819b06a5395" providerId="LiveId" clId="{18C7B61E-2F46-44F3-B4F9-D9413F1F6D22}" dt="2020-03-12T07:10:40.335" v="2618" actId="1036"/>
          <ac:graphicFrameMkLst>
            <pc:docMk/>
            <pc:sldMk cId="1896826950" sldId="296"/>
            <ac:graphicFrameMk id="4" creationId="{0A0CA5D8-924E-4388-A5D7-0A6ED0A7F17E}"/>
          </ac:graphicFrameMkLst>
        </pc:graphicFrameChg>
        <pc:graphicFrameChg chg="mod topLvl">
          <ac:chgData name="Chew Leng Lim" userId="f4956819b06a5395" providerId="LiveId" clId="{18C7B61E-2F46-44F3-B4F9-D9413F1F6D22}" dt="2020-03-12T07:09:21.389" v="2421" actId="1076"/>
          <ac:graphicFrameMkLst>
            <pc:docMk/>
            <pc:sldMk cId="1896826950" sldId="296"/>
            <ac:graphicFrameMk id="73" creationId="{114C88B8-DBD7-4D64-A12B-7E1BD835DB19}"/>
          </ac:graphicFrameMkLst>
        </pc:graphicFrameChg>
        <pc:graphicFrameChg chg="mod">
          <ac:chgData name="Chew Leng Lim" userId="f4956819b06a5395" providerId="LiveId" clId="{18C7B61E-2F46-44F3-B4F9-D9413F1F6D22}" dt="2020-03-12T06:23:57.643" v="855"/>
          <ac:graphicFrameMkLst>
            <pc:docMk/>
            <pc:sldMk cId="1896826950" sldId="296"/>
            <ac:graphicFrameMk id="99" creationId="{94A0858B-D660-4B49-96E5-BFE10DEE1D3B}"/>
          </ac:graphicFrameMkLst>
        </pc:graphicFrameChg>
        <pc:cxnChg chg="mod topLvl">
          <ac:chgData name="Chew Leng Lim" userId="f4956819b06a5395" providerId="LiveId" clId="{18C7B61E-2F46-44F3-B4F9-D9413F1F6D22}" dt="2020-03-12T06:30:15.011" v="1004" actId="552"/>
          <ac:cxnSpMkLst>
            <pc:docMk/>
            <pc:sldMk cId="1896826950" sldId="296"/>
            <ac:cxnSpMk id="134" creationId="{A47F9DC1-1A38-4252-96F6-685D9A22A168}"/>
          </ac:cxnSpMkLst>
        </pc:cxnChg>
        <pc:cxnChg chg="mod topLvl">
          <ac:chgData name="Chew Leng Lim" userId="f4956819b06a5395" providerId="LiveId" clId="{18C7B61E-2F46-44F3-B4F9-D9413F1F6D22}" dt="2020-03-12T06:30:26.484" v="1014" actId="553"/>
          <ac:cxnSpMkLst>
            <pc:docMk/>
            <pc:sldMk cId="1896826950" sldId="296"/>
            <ac:cxnSpMk id="135" creationId="{43FAE959-C576-4E41-ACF2-B529413D5FF5}"/>
          </ac:cxnSpMkLst>
        </pc:cxnChg>
        <pc:cxnChg chg="mod topLvl">
          <ac:chgData name="Chew Leng Lim" userId="f4956819b06a5395" providerId="LiveId" clId="{18C7B61E-2F46-44F3-B4F9-D9413F1F6D22}" dt="2020-03-12T06:30:26.484" v="1014" actId="553"/>
          <ac:cxnSpMkLst>
            <pc:docMk/>
            <pc:sldMk cId="1896826950" sldId="296"/>
            <ac:cxnSpMk id="136" creationId="{F66DBBDA-4FDA-4C20-A2AF-B907405903D1}"/>
          </ac:cxnSpMkLst>
        </pc:cxnChg>
        <pc:cxnChg chg="mod topLvl">
          <ac:chgData name="Chew Leng Lim" userId="f4956819b06a5395" providerId="LiveId" clId="{18C7B61E-2F46-44F3-B4F9-D9413F1F6D22}" dt="2020-03-12T06:30:36.265" v="1015" actId="552"/>
          <ac:cxnSpMkLst>
            <pc:docMk/>
            <pc:sldMk cId="1896826950" sldId="296"/>
            <ac:cxnSpMk id="142" creationId="{57C45F81-4B96-46B7-B9C5-4400B3350B7E}"/>
          </ac:cxnSpMkLst>
        </pc:cxnChg>
        <pc:cxnChg chg="mod topLvl">
          <ac:chgData name="Chew Leng Lim" userId="f4956819b06a5395" providerId="LiveId" clId="{18C7B61E-2F46-44F3-B4F9-D9413F1F6D22}" dt="2020-03-12T06:30:43.231" v="1023" actId="553"/>
          <ac:cxnSpMkLst>
            <pc:docMk/>
            <pc:sldMk cId="1896826950" sldId="296"/>
            <ac:cxnSpMk id="143" creationId="{FF1CFA28-7706-467D-935C-C5C09D444D05}"/>
          </ac:cxnSpMkLst>
        </pc:cxnChg>
        <pc:cxnChg chg="mod topLvl">
          <ac:chgData name="Chew Leng Lim" userId="f4956819b06a5395" providerId="LiveId" clId="{18C7B61E-2F46-44F3-B4F9-D9413F1F6D22}" dt="2020-03-12T06:30:43.231" v="1023" actId="553"/>
          <ac:cxnSpMkLst>
            <pc:docMk/>
            <pc:sldMk cId="1896826950" sldId="296"/>
            <ac:cxnSpMk id="146" creationId="{02A5B074-1917-4E99-8F72-FFD5F41CAF8A}"/>
          </ac:cxnSpMkLst>
        </pc:cxnChg>
        <pc:cxnChg chg="mod topLvl">
          <ac:chgData name="Chew Leng Lim" userId="f4956819b06a5395" providerId="LiveId" clId="{18C7B61E-2F46-44F3-B4F9-D9413F1F6D22}" dt="2020-03-12T06:30:49.279" v="1024" actId="552"/>
          <ac:cxnSpMkLst>
            <pc:docMk/>
            <pc:sldMk cId="1896826950" sldId="296"/>
            <ac:cxnSpMk id="149" creationId="{F6628273-71A3-4443-A17B-653F858B7FE0}"/>
          </ac:cxnSpMkLst>
        </pc:cxnChg>
        <pc:cxnChg chg="mod topLvl">
          <ac:chgData name="Chew Leng Lim" userId="f4956819b06a5395" providerId="LiveId" clId="{18C7B61E-2F46-44F3-B4F9-D9413F1F6D22}" dt="2020-03-12T06:30:49.279" v="1024" actId="552"/>
          <ac:cxnSpMkLst>
            <pc:docMk/>
            <pc:sldMk cId="1896826950" sldId="296"/>
            <ac:cxnSpMk id="150" creationId="{8E88681E-7DCD-49AC-B5C3-E95253A09C6E}"/>
          </ac:cxnSpMkLst>
        </pc:cxnChg>
        <pc:cxnChg chg="mod topLvl">
          <ac:chgData name="Chew Leng Lim" userId="f4956819b06a5395" providerId="LiveId" clId="{18C7B61E-2F46-44F3-B4F9-D9413F1F6D22}" dt="2020-03-12T07:14:54.470" v="3058" actId="1036"/>
          <ac:cxnSpMkLst>
            <pc:docMk/>
            <pc:sldMk cId="1896826950" sldId="296"/>
            <ac:cxnSpMk id="152" creationId="{DCD346C0-0C88-41C4-884D-85AD5A3D05E8}"/>
          </ac:cxnSpMkLst>
        </pc:cxnChg>
        <pc:cxnChg chg="mod topLvl">
          <ac:chgData name="Chew Leng Lim" userId="f4956819b06a5395" providerId="LiveId" clId="{18C7B61E-2F46-44F3-B4F9-D9413F1F6D22}" dt="2020-03-12T07:14:54.470" v="3058" actId="1036"/>
          <ac:cxnSpMkLst>
            <pc:docMk/>
            <pc:sldMk cId="1896826950" sldId="296"/>
            <ac:cxnSpMk id="157" creationId="{48026C68-F15A-4452-A092-8ECF58BD9BE2}"/>
          </ac:cxnSpMkLst>
        </pc:cxnChg>
        <pc:cxnChg chg="mod topLvl">
          <ac:chgData name="Chew Leng Lim" userId="f4956819b06a5395" providerId="LiveId" clId="{18C7B61E-2F46-44F3-B4F9-D9413F1F6D22}" dt="2020-03-12T07:14:54.470" v="3058" actId="1036"/>
          <ac:cxnSpMkLst>
            <pc:docMk/>
            <pc:sldMk cId="1896826950" sldId="296"/>
            <ac:cxnSpMk id="158" creationId="{1B7585AA-519B-4104-A0F6-1B2B92F2F303}"/>
          </ac:cxnSpMkLst>
        </pc:cxnChg>
        <pc:cxnChg chg="mod topLvl">
          <ac:chgData name="Chew Leng Lim" userId="f4956819b06a5395" providerId="LiveId" clId="{18C7B61E-2F46-44F3-B4F9-D9413F1F6D22}" dt="2020-03-12T07:14:54.470" v="3058" actId="1036"/>
          <ac:cxnSpMkLst>
            <pc:docMk/>
            <pc:sldMk cId="1896826950" sldId="296"/>
            <ac:cxnSpMk id="159" creationId="{624E08F4-4B96-4284-BD8C-8CF7BCC12067}"/>
          </ac:cxnSpMkLst>
        </pc:cxnChg>
        <pc:cxnChg chg="mod topLvl">
          <ac:chgData name="Chew Leng Lim" userId="f4956819b06a5395" providerId="LiveId" clId="{18C7B61E-2F46-44F3-B4F9-D9413F1F6D22}" dt="2020-03-12T07:14:54.470" v="3058" actId="1036"/>
          <ac:cxnSpMkLst>
            <pc:docMk/>
            <pc:sldMk cId="1896826950" sldId="296"/>
            <ac:cxnSpMk id="160" creationId="{EE6ADA0F-D5D1-4E32-8959-7C0A107AD76E}"/>
          </ac:cxnSpMkLst>
        </pc:cxnChg>
        <pc:cxnChg chg="mod topLvl">
          <ac:chgData name="Chew Leng Lim" userId="f4956819b06a5395" providerId="LiveId" clId="{18C7B61E-2F46-44F3-B4F9-D9413F1F6D22}" dt="2020-03-12T07:14:54.470" v="3058" actId="1036"/>
          <ac:cxnSpMkLst>
            <pc:docMk/>
            <pc:sldMk cId="1896826950" sldId="296"/>
            <ac:cxnSpMk id="189" creationId="{41B80044-A19D-4466-A623-5FA3416202B7}"/>
          </ac:cxnSpMkLst>
        </pc:cxnChg>
        <pc:cxnChg chg="mod topLvl">
          <ac:chgData name="Chew Leng Lim" userId="f4956819b06a5395" providerId="LiveId" clId="{18C7B61E-2F46-44F3-B4F9-D9413F1F6D22}" dt="2020-03-12T07:12:48.723" v="2851" actId="1036"/>
          <ac:cxnSpMkLst>
            <pc:docMk/>
            <pc:sldMk cId="1896826950" sldId="296"/>
            <ac:cxnSpMk id="208" creationId="{E9BB49C3-6C2B-4DCA-8486-14E0E0AD63FC}"/>
          </ac:cxnSpMkLst>
        </pc:cxnChg>
        <pc:cxnChg chg="mod topLvl">
          <ac:chgData name="Chew Leng Lim" userId="f4956819b06a5395" providerId="LiveId" clId="{18C7B61E-2F46-44F3-B4F9-D9413F1F6D22}" dt="2020-03-12T07:12:48.723" v="2851" actId="1036"/>
          <ac:cxnSpMkLst>
            <pc:docMk/>
            <pc:sldMk cId="1896826950" sldId="296"/>
            <ac:cxnSpMk id="210" creationId="{A90F4410-CB2D-40CA-A8DF-6764B5A2ACED}"/>
          </ac:cxnSpMkLst>
        </pc:cxnChg>
        <pc:cxnChg chg="mod topLvl">
          <ac:chgData name="Chew Leng Lim" userId="f4956819b06a5395" providerId="LiveId" clId="{18C7B61E-2F46-44F3-B4F9-D9413F1F6D22}" dt="2020-03-12T07:12:48.723" v="2851" actId="1036"/>
          <ac:cxnSpMkLst>
            <pc:docMk/>
            <pc:sldMk cId="1896826950" sldId="296"/>
            <ac:cxnSpMk id="211" creationId="{1C6CCECA-937A-493B-BA8C-982588E063D5}"/>
          </ac:cxnSpMkLst>
        </pc:cxnChg>
        <pc:cxnChg chg="mod topLvl">
          <ac:chgData name="Chew Leng Lim" userId="f4956819b06a5395" providerId="LiveId" clId="{18C7B61E-2F46-44F3-B4F9-D9413F1F6D22}" dt="2020-03-12T07:12:56.987" v="2853" actId="14100"/>
          <ac:cxnSpMkLst>
            <pc:docMk/>
            <pc:sldMk cId="1896826950" sldId="296"/>
            <ac:cxnSpMk id="212" creationId="{880FDC7A-D89D-4BA2-A554-56CE6F72785C}"/>
          </ac:cxnSpMkLst>
        </pc:cxnChg>
        <pc:cxnChg chg="mod topLvl">
          <ac:chgData name="Chew Leng Lim" userId="f4956819b06a5395" providerId="LiveId" clId="{18C7B61E-2F46-44F3-B4F9-D9413F1F6D22}" dt="2020-03-12T07:12:48.723" v="2851" actId="1036"/>
          <ac:cxnSpMkLst>
            <pc:docMk/>
            <pc:sldMk cId="1896826950" sldId="296"/>
            <ac:cxnSpMk id="213" creationId="{CB12A863-0BFB-4A79-AEAF-602BD4D21513}"/>
          </ac:cxnSpMkLst>
        </pc:cxnChg>
        <pc:cxnChg chg="mod topLvl">
          <ac:chgData name="Chew Leng Lim" userId="f4956819b06a5395" providerId="LiveId" clId="{18C7B61E-2F46-44F3-B4F9-D9413F1F6D22}" dt="2020-03-12T07:12:48.723" v="2851" actId="1036"/>
          <ac:cxnSpMkLst>
            <pc:docMk/>
            <pc:sldMk cId="1896826950" sldId="296"/>
            <ac:cxnSpMk id="214" creationId="{CBA53A73-3AA1-4715-8127-9B0361F3D495}"/>
          </ac:cxnSpMkLst>
        </pc:cxnChg>
      </pc:sldChg>
      <pc:sldChg chg="modSp">
        <pc:chgData name="Chew Leng Lim" userId="f4956819b06a5395" providerId="LiveId" clId="{18C7B61E-2F46-44F3-B4F9-D9413F1F6D22}" dt="2020-03-03T10:07:01.272" v="369" actId="113"/>
        <pc:sldMkLst>
          <pc:docMk/>
          <pc:sldMk cId="1761259662" sldId="299"/>
        </pc:sldMkLst>
        <pc:spChg chg="mod">
          <ac:chgData name="Chew Leng Lim" userId="f4956819b06a5395" providerId="LiveId" clId="{18C7B61E-2F46-44F3-B4F9-D9413F1F6D22}" dt="2020-03-03T10:07:01.272" v="369" actId="113"/>
          <ac:spMkLst>
            <pc:docMk/>
            <pc:sldMk cId="1761259662" sldId="299"/>
            <ac:spMk id="2" creationId="{9006FD5F-E9F5-4916-8FD1-659895FDAA02}"/>
          </ac:spMkLst>
        </pc:spChg>
      </pc:sldChg>
      <pc:sldChg chg="modSp">
        <pc:chgData name="Chew Leng Lim" userId="f4956819b06a5395" providerId="LiveId" clId="{18C7B61E-2F46-44F3-B4F9-D9413F1F6D22}" dt="2020-03-12T07:29:06.098" v="5646" actId="1038"/>
        <pc:sldMkLst>
          <pc:docMk/>
          <pc:sldMk cId="2352783057" sldId="303"/>
        </pc:sldMkLst>
        <pc:spChg chg="mod">
          <ac:chgData name="Chew Leng Lim" userId="f4956819b06a5395" providerId="LiveId" clId="{18C7B61E-2F46-44F3-B4F9-D9413F1F6D22}" dt="2020-03-03T10:06:44.292" v="366" actId="113"/>
          <ac:spMkLst>
            <pc:docMk/>
            <pc:sldMk cId="2352783057" sldId="303"/>
            <ac:spMk id="62" creationId="{D6F591BD-BD60-4822-A0F8-4C14C47BEC33}"/>
          </ac:spMkLst>
        </pc:spChg>
        <pc:spChg chg="mod">
          <ac:chgData name="Chew Leng Lim" userId="f4956819b06a5395" providerId="LiveId" clId="{18C7B61E-2F46-44F3-B4F9-D9413F1F6D22}" dt="2020-03-12T07:28:18.972" v="5533" actId="1038"/>
          <ac:spMkLst>
            <pc:docMk/>
            <pc:sldMk cId="2352783057" sldId="303"/>
            <ac:spMk id="63" creationId="{76CD3956-4202-4DDA-8E0B-23A08AD39BC4}"/>
          </ac:spMkLst>
        </pc:spChg>
        <pc:spChg chg="mod">
          <ac:chgData name="Chew Leng Lim" userId="f4956819b06a5395" providerId="LiveId" clId="{18C7B61E-2F46-44F3-B4F9-D9413F1F6D22}" dt="2020-03-12T07:25:56.914" v="5050" actId="1036"/>
          <ac:spMkLst>
            <pc:docMk/>
            <pc:sldMk cId="2352783057" sldId="303"/>
            <ac:spMk id="65" creationId="{99EBA92A-F832-48E8-A93C-9DC3C8272BE8}"/>
          </ac:spMkLst>
        </pc:spChg>
        <pc:spChg chg="mod">
          <ac:chgData name="Chew Leng Lim" userId="f4956819b06a5395" providerId="LiveId" clId="{18C7B61E-2F46-44F3-B4F9-D9413F1F6D22}" dt="2020-03-12T07:29:06.098" v="5646" actId="1038"/>
          <ac:spMkLst>
            <pc:docMk/>
            <pc:sldMk cId="2352783057" sldId="303"/>
            <ac:spMk id="72" creationId="{61BEC96E-1E07-40BD-87D6-740D0FE4C726}"/>
          </ac:spMkLst>
        </pc:spChg>
        <pc:spChg chg="mod">
          <ac:chgData name="Chew Leng Lim" userId="f4956819b06a5395" providerId="LiveId" clId="{18C7B61E-2F46-44F3-B4F9-D9413F1F6D22}" dt="2020-03-12T07:29:02.160" v="5641" actId="1036"/>
          <ac:spMkLst>
            <pc:docMk/>
            <pc:sldMk cId="2352783057" sldId="303"/>
            <ac:spMk id="76" creationId="{94B8BD76-F5C6-472E-AC18-BC9471AB03A7}"/>
          </ac:spMkLst>
        </pc:spChg>
        <pc:spChg chg="mod">
          <ac:chgData name="Chew Leng Lim" userId="f4956819b06a5395" providerId="LiveId" clId="{18C7B61E-2F46-44F3-B4F9-D9413F1F6D22}" dt="2020-03-12T07:29:00.177" v="5638" actId="1037"/>
          <ac:spMkLst>
            <pc:docMk/>
            <pc:sldMk cId="2352783057" sldId="303"/>
            <ac:spMk id="77" creationId="{5D1E5CC5-D812-4DCD-B416-A90ED8536B0A}"/>
          </ac:spMkLst>
        </pc:spChg>
        <pc:spChg chg="mod">
          <ac:chgData name="Chew Leng Lim" userId="f4956819b06a5395" providerId="LiveId" clId="{18C7B61E-2F46-44F3-B4F9-D9413F1F6D22}" dt="2020-03-12T07:26:01.464" v="5061" actId="1036"/>
          <ac:spMkLst>
            <pc:docMk/>
            <pc:sldMk cId="2352783057" sldId="303"/>
            <ac:spMk id="78" creationId="{F30B2BE5-49EC-4F71-AD97-7E33DB6B44B4}"/>
          </ac:spMkLst>
        </pc:spChg>
        <pc:spChg chg="mod">
          <ac:chgData name="Chew Leng Lim" userId="f4956819b06a5395" providerId="LiveId" clId="{18C7B61E-2F46-44F3-B4F9-D9413F1F6D22}" dt="2020-03-12T07:26:07.149" v="5091" actId="1036"/>
          <ac:spMkLst>
            <pc:docMk/>
            <pc:sldMk cId="2352783057" sldId="303"/>
            <ac:spMk id="79" creationId="{6C8A0764-7036-4479-8417-5081E422E455}"/>
          </ac:spMkLst>
        </pc:spChg>
        <pc:spChg chg="mod">
          <ac:chgData name="Chew Leng Lim" userId="f4956819b06a5395" providerId="LiveId" clId="{18C7B61E-2F46-44F3-B4F9-D9413F1F6D22}" dt="2020-03-12T07:26:11.773" v="5126" actId="1035"/>
          <ac:spMkLst>
            <pc:docMk/>
            <pc:sldMk cId="2352783057" sldId="303"/>
            <ac:spMk id="80" creationId="{DB7D9CE7-0F46-44B4-9C78-40AFA30475F0}"/>
          </ac:spMkLst>
        </pc:spChg>
        <pc:spChg chg="mod">
          <ac:chgData name="Chew Leng Lim" userId="f4956819b06a5395" providerId="LiveId" clId="{18C7B61E-2F46-44F3-B4F9-D9413F1F6D22}" dt="2020-03-12T07:26:16.498" v="5167" actId="1036"/>
          <ac:spMkLst>
            <pc:docMk/>
            <pc:sldMk cId="2352783057" sldId="303"/>
            <ac:spMk id="81" creationId="{6B9E7652-A7A6-4158-A48F-8616049A2FA1}"/>
          </ac:spMkLst>
        </pc:spChg>
        <pc:spChg chg="mod">
          <ac:chgData name="Chew Leng Lim" userId="f4956819b06a5395" providerId="LiveId" clId="{18C7B61E-2F46-44F3-B4F9-D9413F1F6D22}" dt="2020-03-12T07:24:36.227" v="4773" actId="1035"/>
          <ac:spMkLst>
            <pc:docMk/>
            <pc:sldMk cId="2352783057" sldId="303"/>
            <ac:spMk id="83" creationId="{6CC308C5-22F3-4794-9F3A-296C8C2B4698}"/>
          </ac:spMkLst>
        </pc:spChg>
        <pc:spChg chg="mod">
          <ac:chgData name="Chew Leng Lim" userId="f4956819b06a5395" providerId="LiveId" clId="{18C7B61E-2F46-44F3-B4F9-D9413F1F6D22}" dt="2020-03-12T07:24:46.265" v="4780" actId="1036"/>
          <ac:spMkLst>
            <pc:docMk/>
            <pc:sldMk cId="2352783057" sldId="303"/>
            <ac:spMk id="84" creationId="{C7CEA3B3-CB7D-417D-AC90-82DE4D1113FD}"/>
          </ac:spMkLst>
        </pc:spChg>
        <pc:spChg chg="mod">
          <ac:chgData name="Chew Leng Lim" userId="f4956819b06a5395" providerId="LiveId" clId="{18C7B61E-2F46-44F3-B4F9-D9413F1F6D22}" dt="2020-03-12T07:24:50.251" v="4802" actId="1036"/>
          <ac:spMkLst>
            <pc:docMk/>
            <pc:sldMk cId="2352783057" sldId="303"/>
            <ac:spMk id="85" creationId="{04C53E39-A367-4784-A9BD-B1266FF52526}"/>
          </ac:spMkLst>
        </pc:spChg>
        <pc:spChg chg="mod">
          <ac:chgData name="Chew Leng Lim" userId="f4956819b06a5395" providerId="LiveId" clId="{18C7B61E-2F46-44F3-B4F9-D9413F1F6D22}" dt="2020-03-12T07:24:54.862" v="4833" actId="1036"/>
          <ac:spMkLst>
            <pc:docMk/>
            <pc:sldMk cId="2352783057" sldId="303"/>
            <ac:spMk id="86" creationId="{AA41C000-6EA3-4830-9743-44132511D41C}"/>
          </ac:spMkLst>
        </pc:spChg>
        <pc:spChg chg="mod">
          <ac:chgData name="Chew Leng Lim" userId="f4956819b06a5395" providerId="LiveId" clId="{18C7B61E-2F46-44F3-B4F9-D9413F1F6D22}" dt="2020-03-12T07:24:58.940" v="4865" actId="1036"/>
          <ac:spMkLst>
            <pc:docMk/>
            <pc:sldMk cId="2352783057" sldId="303"/>
            <ac:spMk id="87" creationId="{E0EED011-549A-4EEF-8E70-61C29F25203F}"/>
          </ac:spMkLst>
        </pc:spChg>
        <pc:spChg chg="mod">
          <ac:chgData name="Chew Leng Lim" userId="f4956819b06a5395" providerId="LiveId" clId="{18C7B61E-2F46-44F3-B4F9-D9413F1F6D22}" dt="2020-03-12T07:23:50.376" v="4752" actId="12789"/>
          <ac:spMkLst>
            <pc:docMk/>
            <pc:sldMk cId="2352783057" sldId="303"/>
            <ac:spMk id="88" creationId="{C60C3C09-D450-4C72-ABF3-2A5A24F092DE}"/>
          </ac:spMkLst>
        </pc:spChg>
        <pc:spChg chg="mod">
          <ac:chgData name="Chew Leng Lim" userId="f4956819b06a5395" providerId="LiveId" clId="{18C7B61E-2F46-44F3-B4F9-D9413F1F6D22}" dt="2020-03-12T07:28:02.714" v="5478" actId="1035"/>
          <ac:spMkLst>
            <pc:docMk/>
            <pc:sldMk cId="2352783057" sldId="303"/>
            <ac:spMk id="89" creationId="{BF6F9342-B17A-40B2-A1A6-01EEE09B773C}"/>
          </ac:spMkLst>
        </pc:spChg>
        <pc:spChg chg="mod">
          <ac:chgData name="Chew Leng Lim" userId="f4956819b06a5395" providerId="LiveId" clId="{18C7B61E-2F46-44F3-B4F9-D9413F1F6D22}" dt="2020-03-12T07:28:02.714" v="5478" actId="1035"/>
          <ac:spMkLst>
            <pc:docMk/>
            <pc:sldMk cId="2352783057" sldId="303"/>
            <ac:spMk id="90" creationId="{DE40EBC8-FFD8-4FE5-826D-E27A714914B6}"/>
          </ac:spMkLst>
        </pc:spChg>
        <pc:spChg chg="mod">
          <ac:chgData name="Chew Leng Lim" userId="f4956819b06a5395" providerId="LiveId" clId="{18C7B61E-2F46-44F3-B4F9-D9413F1F6D22}" dt="2020-03-12T07:28:02.714" v="5478" actId="1035"/>
          <ac:spMkLst>
            <pc:docMk/>
            <pc:sldMk cId="2352783057" sldId="303"/>
            <ac:spMk id="91" creationId="{0347DC07-7ACE-4231-A868-D71C8A00C851}"/>
          </ac:spMkLst>
        </pc:spChg>
        <pc:spChg chg="mod">
          <ac:chgData name="Chew Leng Lim" userId="f4956819b06a5395" providerId="LiveId" clId="{18C7B61E-2F46-44F3-B4F9-D9413F1F6D22}" dt="2020-03-12T07:28:02.714" v="5478" actId="1035"/>
          <ac:spMkLst>
            <pc:docMk/>
            <pc:sldMk cId="2352783057" sldId="303"/>
            <ac:spMk id="92" creationId="{5C7E415C-1F8D-4BC6-B0D9-28B9C5E41EEA}"/>
          </ac:spMkLst>
        </pc:spChg>
        <pc:spChg chg="mod">
          <ac:chgData name="Chew Leng Lim" userId="f4956819b06a5395" providerId="LiveId" clId="{18C7B61E-2F46-44F3-B4F9-D9413F1F6D22}" dt="2020-03-12T07:26:43.492" v="5301" actId="1036"/>
          <ac:spMkLst>
            <pc:docMk/>
            <pc:sldMk cId="2352783057" sldId="303"/>
            <ac:spMk id="98" creationId="{8DDCDB3B-5039-48C8-88D1-BA4516C11C00}"/>
          </ac:spMkLst>
        </pc:spChg>
        <pc:spChg chg="mod">
          <ac:chgData name="Chew Leng Lim" userId="f4956819b06a5395" providerId="LiveId" clId="{18C7B61E-2F46-44F3-B4F9-D9413F1F6D22}" dt="2020-03-12T07:25:03.377" v="4885" actId="1035"/>
          <ac:spMkLst>
            <pc:docMk/>
            <pc:sldMk cId="2352783057" sldId="303"/>
            <ac:spMk id="108" creationId="{0D2BBFB2-F9A9-419F-8E42-C466A32F67EA}"/>
          </ac:spMkLst>
        </pc:spChg>
        <pc:spChg chg="mod">
          <ac:chgData name="Chew Leng Lim" userId="f4956819b06a5395" providerId="LiveId" clId="{18C7B61E-2F46-44F3-B4F9-D9413F1F6D22}" dt="2020-03-12T07:25:07.070" v="4898" actId="1036"/>
          <ac:spMkLst>
            <pc:docMk/>
            <pc:sldMk cId="2352783057" sldId="303"/>
            <ac:spMk id="109" creationId="{4CDA43DF-8EF5-42E8-B32D-B00CDDC2EA59}"/>
          </ac:spMkLst>
        </pc:spChg>
        <pc:spChg chg="mod">
          <ac:chgData name="Chew Leng Lim" userId="f4956819b06a5395" providerId="LiveId" clId="{18C7B61E-2F46-44F3-B4F9-D9413F1F6D22}" dt="2020-03-12T07:25:11.012" v="4925" actId="1035"/>
          <ac:spMkLst>
            <pc:docMk/>
            <pc:sldMk cId="2352783057" sldId="303"/>
            <ac:spMk id="111" creationId="{59EA5145-D37E-4369-91F7-0431FBA911A4}"/>
          </ac:spMkLst>
        </pc:spChg>
        <pc:spChg chg="mod">
          <ac:chgData name="Chew Leng Lim" userId="f4956819b06a5395" providerId="LiveId" clId="{18C7B61E-2F46-44F3-B4F9-D9413F1F6D22}" dt="2020-03-12T07:25:15.411" v="4966" actId="1036"/>
          <ac:spMkLst>
            <pc:docMk/>
            <pc:sldMk cId="2352783057" sldId="303"/>
            <ac:spMk id="112" creationId="{31746764-9EB8-4523-8C89-5799862B7DD7}"/>
          </ac:spMkLst>
        </pc:spChg>
        <pc:spChg chg="mod">
          <ac:chgData name="Chew Leng Lim" userId="f4956819b06a5395" providerId="LiveId" clId="{18C7B61E-2F46-44F3-B4F9-D9413F1F6D22}" dt="2020-03-12T07:23:40.536" v="4751" actId="12789"/>
          <ac:spMkLst>
            <pc:docMk/>
            <pc:sldMk cId="2352783057" sldId="303"/>
            <ac:spMk id="113" creationId="{ADE618AD-04BB-454E-8C7D-79EF294233D8}"/>
          </ac:spMkLst>
        </pc:spChg>
        <pc:spChg chg="mod">
          <ac:chgData name="Chew Leng Lim" userId="f4956819b06a5395" providerId="LiveId" clId="{18C7B61E-2F46-44F3-B4F9-D9413F1F6D22}" dt="2020-03-12T07:25:42.751" v="5030" actId="554"/>
          <ac:spMkLst>
            <pc:docMk/>
            <pc:sldMk cId="2352783057" sldId="303"/>
            <ac:spMk id="114" creationId="{1A533221-1090-4B77-B0F3-71D1E06B888F}"/>
          </ac:spMkLst>
        </pc:spChg>
        <pc:spChg chg="mod">
          <ac:chgData name="Chew Leng Lim" userId="f4956819b06a5395" providerId="LiveId" clId="{18C7B61E-2F46-44F3-B4F9-D9413F1F6D22}" dt="2020-03-12T07:25:42.751" v="5030" actId="554"/>
          <ac:spMkLst>
            <pc:docMk/>
            <pc:sldMk cId="2352783057" sldId="303"/>
            <ac:spMk id="115" creationId="{3C434F2C-6B8B-4CA5-8364-DD04256D0FC6}"/>
          </ac:spMkLst>
        </pc:spChg>
        <pc:spChg chg="mod">
          <ac:chgData name="Chew Leng Lim" userId="f4956819b06a5395" providerId="LiveId" clId="{18C7B61E-2F46-44F3-B4F9-D9413F1F6D22}" dt="2020-03-12T07:25:42.751" v="5030" actId="554"/>
          <ac:spMkLst>
            <pc:docMk/>
            <pc:sldMk cId="2352783057" sldId="303"/>
            <ac:spMk id="116" creationId="{72B7CFA6-2812-40B2-83AD-FF0EB4566724}"/>
          </ac:spMkLst>
        </pc:spChg>
        <pc:spChg chg="mod">
          <ac:chgData name="Chew Leng Lim" userId="f4956819b06a5395" providerId="LiveId" clId="{18C7B61E-2F46-44F3-B4F9-D9413F1F6D22}" dt="2020-03-12T07:25:42.751" v="5030" actId="554"/>
          <ac:spMkLst>
            <pc:docMk/>
            <pc:sldMk cId="2352783057" sldId="303"/>
            <ac:spMk id="117" creationId="{4A376A54-446B-446D-AB91-960E30E0AEAB}"/>
          </ac:spMkLst>
        </pc:spChg>
        <pc:spChg chg="mod">
          <ac:chgData name="Chew Leng Lim" userId="f4956819b06a5395" providerId="LiveId" clId="{18C7B61E-2F46-44F3-B4F9-D9413F1F6D22}" dt="2020-03-12T07:25:42.751" v="5030" actId="554"/>
          <ac:spMkLst>
            <pc:docMk/>
            <pc:sldMk cId="2352783057" sldId="303"/>
            <ac:spMk id="119" creationId="{EA8862EC-F59E-4518-A083-9D5755F3BD7F}"/>
          </ac:spMkLst>
        </pc:spChg>
        <pc:spChg chg="mod">
          <ac:chgData name="Chew Leng Lim" userId="f4956819b06a5395" providerId="LiveId" clId="{18C7B61E-2F46-44F3-B4F9-D9413F1F6D22}" dt="2020-03-12T07:25:42.751" v="5030" actId="554"/>
          <ac:spMkLst>
            <pc:docMk/>
            <pc:sldMk cId="2352783057" sldId="303"/>
            <ac:spMk id="120" creationId="{C3E8B9C3-8164-4748-A977-D94F8C23D92B}"/>
          </ac:spMkLst>
        </pc:spChg>
        <pc:spChg chg="mod">
          <ac:chgData name="Chew Leng Lim" userId="f4956819b06a5395" providerId="LiveId" clId="{18C7B61E-2F46-44F3-B4F9-D9413F1F6D22}" dt="2020-03-12T07:25:42.751" v="5030" actId="554"/>
          <ac:spMkLst>
            <pc:docMk/>
            <pc:sldMk cId="2352783057" sldId="303"/>
            <ac:spMk id="121" creationId="{B4791457-3FBE-485C-8F45-7DF87D450EE3}"/>
          </ac:spMkLst>
        </pc:spChg>
        <pc:spChg chg="mod">
          <ac:chgData name="Chew Leng Lim" userId="f4956819b06a5395" providerId="LiveId" clId="{18C7B61E-2F46-44F3-B4F9-D9413F1F6D22}" dt="2020-03-12T07:25:42.751" v="5030" actId="554"/>
          <ac:spMkLst>
            <pc:docMk/>
            <pc:sldMk cId="2352783057" sldId="303"/>
            <ac:spMk id="122" creationId="{FC398615-FD18-4A8A-903D-1A57E0E1EE60}"/>
          </ac:spMkLst>
        </pc:spChg>
        <pc:spChg chg="mod">
          <ac:chgData name="Chew Leng Lim" userId="f4956819b06a5395" providerId="LiveId" clId="{18C7B61E-2F46-44F3-B4F9-D9413F1F6D22}" dt="2020-03-12T07:26:20.773" v="5187" actId="1035"/>
          <ac:spMkLst>
            <pc:docMk/>
            <pc:sldMk cId="2352783057" sldId="303"/>
            <ac:spMk id="123" creationId="{9979580A-28AA-4361-8CC9-04EC12B8F9D6}"/>
          </ac:spMkLst>
        </pc:spChg>
        <pc:spChg chg="mod">
          <ac:chgData name="Chew Leng Lim" userId="f4956819b06a5395" providerId="LiveId" clId="{18C7B61E-2F46-44F3-B4F9-D9413F1F6D22}" dt="2020-03-12T07:25:42.751" v="5030" actId="554"/>
          <ac:spMkLst>
            <pc:docMk/>
            <pc:sldMk cId="2352783057" sldId="303"/>
            <ac:spMk id="124" creationId="{90A8E483-9A94-4114-851D-EC775D7B1577}"/>
          </ac:spMkLst>
        </pc:spChg>
        <pc:spChg chg="mod">
          <ac:chgData name="Chew Leng Lim" userId="f4956819b06a5395" providerId="LiveId" clId="{18C7B61E-2F46-44F3-B4F9-D9413F1F6D22}" dt="2020-03-12T07:26:25.410" v="5208" actId="1035"/>
          <ac:spMkLst>
            <pc:docMk/>
            <pc:sldMk cId="2352783057" sldId="303"/>
            <ac:spMk id="125" creationId="{AF2B8464-83EA-4836-9FC8-C0D0220B4ED8}"/>
          </ac:spMkLst>
        </pc:spChg>
        <pc:spChg chg="mod">
          <ac:chgData name="Chew Leng Lim" userId="f4956819b06a5395" providerId="LiveId" clId="{18C7B61E-2F46-44F3-B4F9-D9413F1F6D22}" dt="2020-03-12T07:26:29.539" v="5228" actId="1035"/>
          <ac:spMkLst>
            <pc:docMk/>
            <pc:sldMk cId="2352783057" sldId="303"/>
            <ac:spMk id="126" creationId="{56F8A849-DB58-45B7-B199-7E56BA0888FE}"/>
          </ac:spMkLst>
        </pc:spChg>
        <pc:spChg chg="mod">
          <ac:chgData name="Chew Leng Lim" userId="f4956819b06a5395" providerId="LiveId" clId="{18C7B61E-2F46-44F3-B4F9-D9413F1F6D22}" dt="2020-03-12T07:26:35.140" v="5259" actId="1035"/>
          <ac:spMkLst>
            <pc:docMk/>
            <pc:sldMk cId="2352783057" sldId="303"/>
            <ac:spMk id="127" creationId="{CC62A2C1-1268-4828-B08D-CED580798E60}"/>
          </ac:spMkLst>
        </pc:spChg>
        <pc:spChg chg="mod">
          <ac:chgData name="Chew Leng Lim" userId="f4956819b06a5395" providerId="LiveId" clId="{18C7B61E-2F46-44F3-B4F9-D9413F1F6D22}" dt="2020-03-12T07:26:46.606" v="5303" actId="1035"/>
          <ac:spMkLst>
            <pc:docMk/>
            <pc:sldMk cId="2352783057" sldId="303"/>
            <ac:spMk id="128" creationId="{D9D0C8CA-4AF3-4A44-A6C1-14D68BCE3625}"/>
          </ac:spMkLst>
        </pc:spChg>
        <pc:spChg chg="mod">
          <ac:chgData name="Chew Leng Lim" userId="f4956819b06a5395" providerId="LiveId" clId="{18C7B61E-2F46-44F3-B4F9-D9413F1F6D22}" dt="2020-03-12T07:23:50.376" v="4752" actId="12789"/>
          <ac:spMkLst>
            <pc:docMk/>
            <pc:sldMk cId="2352783057" sldId="303"/>
            <ac:spMk id="129" creationId="{474FCB39-5A16-41E8-8BD8-EAC760DF0DFF}"/>
          </ac:spMkLst>
        </pc:spChg>
        <pc:spChg chg="mod">
          <ac:chgData name="Chew Leng Lim" userId="f4956819b06a5395" providerId="LiveId" clId="{18C7B61E-2F46-44F3-B4F9-D9413F1F6D22}" dt="2020-03-12T07:26:50.449" v="5322" actId="1035"/>
          <ac:spMkLst>
            <pc:docMk/>
            <pc:sldMk cId="2352783057" sldId="303"/>
            <ac:spMk id="130" creationId="{1107C72D-D9B5-4150-B99B-BDA4607FB2F3}"/>
          </ac:spMkLst>
        </pc:spChg>
        <pc:spChg chg="mod">
          <ac:chgData name="Chew Leng Lim" userId="f4956819b06a5395" providerId="LiveId" clId="{18C7B61E-2F46-44F3-B4F9-D9413F1F6D22}" dt="2020-03-12T07:26:53.580" v="5337" actId="1035"/>
          <ac:spMkLst>
            <pc:docMk/>
            <pc:sldMk cId="2352783057" sldId="303"/>
            <ac:spMk id="131" creationId="{8C6E31EE-6930-42E1-BB65-9123233D8A9E}"/>
          </ac:spMkLst>
        </pc:spChg>
        <pc:spChg chg="mod">
          <ac:chgData name="Chew Leng Lim" userId="f4956819b06a5395" providerId="LiveId" clId="{18C7B61E-2F46-44F3-B4F9-D9413F1F6D22}" dt="2020-03-12T07:26:57.378" v="5366" actId="1036"/>
          <ac:spMkLst>
            <pc:docMk/>
            <pc:sldMk cId="2352783057" sldId="303"/>
            <ac:spMk id="133" creationId="{C19FA46C-A268-4673-B7B9-3503C6E8F02B}"/>
          </ac:spMkLst>
        </pc:spChg>
        <pc:spChg chg="mod">
          <ac:chgData name="Chew Leng Lim" userId="f4956819b06a5395" providerId="LiveId" clId="{18C7B61E-2F46-44F3-B4F9-D9413F1F6D22}" dt="2020-03-12T07:27:01.356" v="5399" actId="1036"/>
          <ac:spMkLst>
            <pc:docMk/>
            <pc:sldMk cId="2352783057" sldId="303"/>
            <ac:spMk id="134" creationId="{C2F3D555-57B4-4B87-B61C-DC38FDFB7CA9}"/>
          </ac:spMkLst>
        </pc:spChg>
        <pc:spChg chg="mod">
          <ac:chgData name="Chew Leng Lim" userId="f4956819b06a5395" providerId="LiveId" clId="{18C7B61E-2F46-44F3-B4F9-D9413F1F6D22}" dt="2020-03-12T07:28:02.714" v="5478" actId="1035"/>
          <ac:spMkLst>
            <pc:docMk/>
            <pc:sldMk cId="2352783057" sldId="303"/>
            <ac:spMk id="136" creationId="{25CC13E5-38AE-4A6A-8460-10BD8C44E3E9}"/>
          </ac:spMkLst>
        </pc:spChg>
        <pc:spChg chg="mod">
          <ac:chgData name="Chew Leng Lim" userId="f4956819b06a5395" providerId="LiveId" clId="{18C7B61E-2F46-44F3-B4F9-D9413F1F6D22}" dt="2020-03-12T07:28:02.714" v="5478" actId="1035"/>
          <ac:spMkLst>
            <pc:docMk/>
            <pc:sldMk cId="2352783057" sldId="303"/>
            <ac:spMk id="137" creationId="{8C73A436-1FA2-41A9-BCA2-895B35643995}"/>
          </ac:spMkLst>
        </pc:spChg>
        <pc:spChg chg="mod">
          <ac:chgData name="Chew Leng Lim" userId="f4956819b06a5395" providerId="LiveId" clId="{18C7B61E-2F46-44F3-B4F9-D9413F1F6D22}" dt="2020-03-12T07:28:02.714" v="5478" actId="1035"/>
          <ac:spMkLst>
            <pc:docMk/>
            <pc:sldMk cId="2352783057" sldId="303"/>
            <ac:spMk id="138" creationId="{F31FAB75-2440-4B9C-ADA3-37B0182393D6}"/>
          </ac:spMkLst>
        </pc:spChg>
        <pc:spChg chg="mod">
          <ac:chgData name="Chew Leng Lim" userId="f4956819b06a5395" providerId="LiveId" clId="{18C7B61E-2F46-44F3-B4F9-D9413F1F6D22}" dt="2020-03-12T07:28:02.714" v="5478" actId="1035"/>
          <ac:spMkLst>
            <pc:docMk/>
            <pc:sldMk cId="2352783057" sldId="303"/>
            <ac:spMk id="139" creationId="{9808A3A1-C7B6-4654-983C-AE6F2645D4C5}"/>
          </ac:spMkLst>
        </pc:spChg>
        <pc:spChg chg="mod">
          <ac:chgData name="Chew Leng Lim" userId="f4956819b06a5395" providerId="LiveId" clId="{18C7B61E-2F46-44F3-B4F9-D9413F1F6D22}" dt="2020-03-12T07:28:02.714" v="5478" actId="1035"/>
          <ac:spMkLst>
            <pc:docMk/>
            <pc:sldMk cId="2352783057" sldId="303"/>
            <ac:spMk id="140" creationId="{C92DA7B8-EF55-4E58-B8BB-36B6B0FAE3AF}"/>
          </ac:spMkLst>
        </pc:spChg>
        <pc:spChg chg="mod">
          <ac:chgData name="Chew Leng Lim" userId="f4956819b06a5395" providerId="LiveId" clId="{18C7B61E-2F46-44F3-B4F9-D9413F1F6D22}" dt="2020-03-12T07:28:02.714" v="5478" actId="1035"/>
          <ac:spMkLst>
            <pc:docMk/>
            <pc:sldMk cId="2352783057" sldId="303"/>
            <ac:spMk id="141" creationId="{20516AC8-E065-4B2C-B125-A0792858B091}"/>
          </ac:spMkLst>
        </pc:spChg>
        <pc:spChg chg="mod">
          <ac:chgData name="Chew Leng Lim" userId="f4956819b06a5395" providerId="LiveId" clId="{18C7B61E-2F46-44F3-B4F9-D9413F1F6D22}" dt="2020-03-12T07:28:02.714" v="5478" actId="1035"/>
          <ac:spMkLst>
            <pc:docMk/>
            <pc:sldMk cId="2352783057" sldId="303"/>
            <ac:spMk id="142" creationId="{6F04F6DF-F696-4E6E-BA61-A94ABC578D86}"/>
          </ac:spMkLst>
        </pc:spChg>
        <pc:spChg chg="mod">
          <ac:chgData name="Chew Leng Lim" userId="f4956819b06a5395" providerId="LiveId" clId="{18C7B61E-2F46-44F3-B4F9-D9413F1F6D22}" dt="2020-03-12T07:28:02.714" v="5478" actId="1035"/>
          <ac:spMkLst>
            <pc:docMk/>
            <pc:sldMk cId="2352783057" sldId="303"/>
            <ac:spMk id="143" creationId="{D5A428D4-35E1-45EB-A7BC-F42E00D3B145}"/>
          </ac:spMkLst>
        </pc:spChg>
        <pc:spChg chg="mod">
          <ac:chgData name="Chew Leng Lim" userId="f4956819b06a5395" providerId="LiveId" clId="{18C7B61E-2F46-44F3-B4F9-D9413F1F6D22}" dt="2020-03-12T07:23:40.536" v="4751" actId="12789"/>
          <ac:spMkLst>
            <pc:docMk/>
            <pc:sldMk cId="2352783057" sldId="303"/>
            <ac:spMk id="145" creationId="{A669F274-CFAB-4842-A3F4-6234AEA654F3}"/>
          </ac:spMkLst>
        </pc:spChg>
        <pc:spChg chg="mod">
          <ac:chgData name="Chew Leng Lim" userId="f4956819b06a5395" providerId="LiveId" clId="{18C7B61E-2F46-44F3-B4F9-D9413F1F6D22}" dt="2020-03-12T07:25:27.856" v="4992" actId="1038"/>
          <ac:spMkLst>
            <pc:docMk/>
            <pc:sldMk cId="2352783057" sldId="303"/>
            <ac:spMk id="147" creationId="{B6DEA4E9-8E61-4A53-832A-A3398D3792AA}"/>
          </ac:spMkLst>
        </pc:spChg>
        <pc:spChg chg="mod">
          <ac:chgData name="Chew Leng Lim" userId="f4956819b06a5395" providerId="LiveId" clId="{18C7B61E-2F46-44F3-B4F9-D9413F1F6D22}" dt="2020-03-12T07:25:27.856" v="4992" actId="1038"/>
          <ac:spMkLst>
            <pc:docMk/>
            <pc:sldMk cId="2352783057" sldId="303"/>
            <ac:spMk id="148" creationId="{4BC5927F-1B5F-4238-BB57-8B7728BCDF53}"/>
          </ac:spMkLst>
        </pc:spChg>
        <pc:graphicFrameChg chg="mod">
          <ac:chgData name="Chew Leng Lim" userId="f4956819b06a5395" providerId="LiveId" clId="{18C7B61E-2F46-44F3-B4F9-D9413F1F6D22}" dt="2020-03-12T07:23:50.376" v="4752" actId="12789"/>
          <ac:graphicFrameMkLst>
            <pc:docMk/>
            <pc:sldMk cId="2352783057" sldId="303"/>
            <ac:graphicFrameMk id="64" creationId="{F7BBCD3D-F04B-4D4C-85C4-3819108B8429}"/>
          </ac:graphicFrameMkLst>
        </pc:graphicFrameChg>
        <pc:graphicFrameChg chg="mod">
          <ac:chgData name="Chew Leng Lim" userId="f4956819b06a5395" providerId="LiveId" clId="{18C7B61E-2F46-44F3-B4F9-D9413F1F6D22}" dt="2020-03-12T07:23:40.536" v="4751" actId="12789"/>
          <ac:graphicFrameMkLst>
            <pc:docMk/>
            <pc:sldMk cId="2352783057" sldId="303"/>
            <ac:graphicFrameMk id="82" creationId="{30F93569-02D5-41F2-8B0D-ACB3F9481E14}"/>
          </ac:graphicFrameMkLst>
        </pc:graphicFrameChg>
        <pc:graphicFrameChg chg="mod">
          <ac:chgData name="Chew Leng Lim" userId="f4956819b06a5395" providerId="LiveId" clId="{18C7B61E-2F46-44F3-B4F9-D9413F1F6D22}" dt="2020-03-12T07:23:40.536" v="4751" actId="12789"/>
          <ac:graphicFrameMkLst>
            <pc:docMk/>
            <pc:sldMk cId="2352783057" sldId="303"/>
            <ac:graphicFrameMk id="101" creationId="{09816226-A95F-4D55-AE08-BA7D46777699}"/>
          </ac:graphicFrameMkLst>
        </pc:graphicFrameChg>
        <pc:graphicFrameChg chg="mod">
          <ac:chgData name="Chew Leng Lim" userId="f4956819b06a5395" providerId="LiveId" clId="{18C7B61E-2F46-44F3-B4F9-D9413F1F6D22}" dt="2020-03-12T07:23:50.376" v="4752" actId="12789"/>
          <ac:graphicFrameMkLst>
            <pc:docMk/>
            <pc:sldMk cId="2352783057" sldId="303"/>
            <ac:graphicFrameMk id="102" creationId="{DF817276-B741-4CA3-BF5E-57D2A3ACFF6E}"/>
          </ac:graphicFrameMkLst>
        </pc:graphicFrameChg>
        <pc:graphicFrameChg chg="mod">
          <ac:chgData name="Chew Leng Lim" userId="f4956819b06a5395" providerId="LiveId" clId="{18C7B61E-2F46-44F3-B4F9-D9413F1F6D22}" dt="2020-03-12T07:23:50.376" v="4752" actId="12789"/>
          <ac:graphicFrameMkLst>
            <pc:docMk/>
            <pc:sldMk cId="2352783057" sldId="303"/>
            <ac:graphicFrameMk id="103" creationId="{C19A3F99-15A4-42D8-A8A6-4BED89EC3036}"/>
          </ac:graphicFrameMkLst>
        </pc:graphicFrameChg>
        <pc:cxnChg chg="mod">
          <ac:chgData name="Chew Leng Lim" userId="f4956819b06a5395" providerId="LiveId" clId="{18C7B61E-2F46-44F3-B4F9-D9413F1F6D22}" dt="2020-03-12T07:28:18.972" v="5533" actId="1038"/>
          <ac:cxnSpMkLst>
            <pc:docMk/>
            <pc:sldMk cId="2352783057" sldId="303"/>
            <ac:cxnSpMk id="66" creationId="{70B2492C-E2CF-4BDF-ADC0-52653781029C}"/>
          </ac:cxnSpMkLst>
        </pc:cxnChg>
        <pc:cxnChg chg="mod">
          <ac:chgData name="Chew Leng Lim" userId="f4956819b06a5395" providerId="LiveId" clId="{18C7B61E-2F46-44F3-B4F9-D9413F1F6D22}" dt="2020-03-12T07:28:55.540" v="5632" actId="1035"/>
          <ac:cxnSpMkLst>
            <pc:docMk/>
            <pc:sldMk cId="2352783057" sldId="303"/>
            <ac:cxnSpMk id="67" creationId="{5F14F05B-3F35-4453-98A5-2615F17CB7FF}"/>
          </ac:cxnSpMkLst>
        </pc:cxnChg>
        <pc:cxnChg chg="mod">
          <ac:chgData name="Chew Leng Lim" userId="f4956819b06a5395" providerId="LiveId" clId="{18C7B61E-2F46-44F3-B4F9-D9413F1F6D22}" dt="2020-03-12T07:28:18.972" v="5533" actId="1038"/>
          <ac:cxnSpMkLst>
            <pc:docMk/>
            <pc:sldMk cId="2352783057" sldId="303"/>
            <ac:cxnSpMk id="68" creationId="{049A5F86-99BD-4A73-BEFF-F44C20E301F8}"/>
          </ac:cxnSpMkLst>
        </pc:cxnChg>
        <pc:cxnChg chg="mod">
          <ac:chgData name="Chew Leng Lim" userId="f4956819b06a5395" providerId="LiveId" clId="{18C7B61E-2F46-44F3-B4F9-D9413F1F6D22}" dt="2020-03-12T07:28:26.466" v="5537" actId="14100"/>
          <ac:cxnSpMkLst>
            <pc:docMk/>
            <pc:sldMk cId="2352783057" sldId="303"/>
            <ac:cxnSpMk id="69" creationId="{7851EFCC-0B90-415F-8868-47D7DF51E9B8}"/>
          </ac:cxnSpMkLst>
        </pc:cxnChg>
        <pc:cxnChg chg="mod">
          <ac:chgData name="Chew Leng Lim" userId="f4956819b06a5395" providerId="LiveId" clId="{18C7B61E-2F46-44F3-B4F9-D9413F1F6D22}" dt="2020-03-12T07:28:55.540" v="5632" actId="1035"/>
          <ac:cxnSpMkLst>
            <pc:docMk/>
            <pc:sldMk cId="2352783057" sldId="303"/>
            <ac:cxnSpMk id="70" creationId="{A0F6C711-B696-447B-9123-1C1C705EB54A}"/>
          </ac:cxnSpMkLst>
        </pc:cxnChg>
        <pc:cxnChg chg="mod">
          <ac:chgData name="Chew Leng Lim" userId="f4956819b06a5395" providerId="LiveId" clId="{18C7B61E-2F46-44F3-B4F9-D9413F1F6D22}" dt="2020-03-12T07:28:55.540" v="5632" actId="1035"/>
          <ac:cxnSpMkLst>
            <pc:docMk/>
            <pc:sldMk cId="2352783057" sldId="303"/>
            <ac:cxnSpMk id="71" creationId="{2EBF13DC-1567-4D21-9A9B-E441FD023408}"/>
          </ac:cxnSpMkLst>
        </pc:cxnChg>
        <pc:cxnChg chg="mod">
          <ac:chgData name="Chew Leng Lim" userId="f4956819b06a5395" providerId="LiveId" clId="{18C7B61E-2F46-44F3-B4F9-D9413F1F6D22}" dt="2020-03-12T07:28:55.540" v="5632" actId="1035"/>
          <ac:cxnSpMkLst>
            <pc:docMk/>
            <pc:sldMk cId="2352783057" sldId="303"/>
            <ac:cxnSpMk id="73" creationId="{B12D9158-0E00-4E6E-8A19-A15CB8B32E9B}"/>
          </ac:cxnSpMkLst>
        </pc:cxnChg>
        <pc:cxnChg chg="mod">
          <ac:chgData name="Chew Leng Lim" userId="f4956819b06a5395" providerId="LiveId" clId="{18C7B61E-2F46-44F3-B4F9-D9413F1F6D22}" dt="2020-03-12T07:28:55.540" v="5632" actId="1035"/>
          <ac:cxnSpMkLst>
            <pc:docMk/>
            <pc:sldMk cId="2352783057" sldId="303"/>
            <ac:cxnSpMk id="74" creationId="{C2BBF189-0E65-4473-BB2B-F377C3CFDF29}"/>
          </ac:cxnSpMkLst>
        </pc:cxnChg>
        <pc:cxnChg chg="mod">
          <ac:chgData name="Chew Leng Lim" userId="f4956819b06a5395" providerId="LiveId" clId="{18C7B61E-2F46-44F3-B4F9-D9413F1F6D22}" dt="2020-03-12T07:28:55.540" v="5632" actId="1035"/>
          <ac:cxnSpMkLst>
            <pc:docMk/>
            <pc:sldMk cId="2352783057" sldId="303"/>
            <ac:cxnSpMk id="75" creationId="{E9E2257E-B4DB-4F8C-A3A9-367BD181371B}"/>
          </ac:cxnSpMkLst>
        </pc:cxnChg>
      </pc:sldChg>
      <pc:sldChg chg="addSp modSp ord">
        <pc:chgData name="Chew Leng Lim" userId="f4956819b06a5395" providerId="LiveId" clId="{18C7B61E-2F46-44F3-B4F9-D9413F1F6D22}" dt="2020-03-12T07:40:15.348" v="7006" actId="1035"/>
        <pc:sldMkLst>
          <pc:docMk/>
          <pc:sldMk cId="4078230159" sldId="304"/>
        </pc:sldMkLst>
        <pc:spChg chg="mod">
          <ac:chgData name="Chew Leng Lim" userId="f4956819b06a5395" providerId="LiveId" clId="{18C7B61E-2F46-44F3-B4F9-D9413F1F6D22}" dt="2020-03-12T07:37:12.911" v="6824" actId="1037"/>
          <ac:spMkLst>
            <pc:docMk/>
            <pc:sldMk cId="4078230159" sldId="304"/>
            <ac:spMk id="12" creationId="{BCB1B8DC-0882-426A-B855-4C9A9634FD41}"/>
          </ac:spMkLst>
        </pc:spChg>
        <pc:spChg chg="mod">
          <ac:chgData name="Chew Leng Lim" userId="f4956819b06a5395" providerId="LiveId" clId="{18C7B61E-2F46-44F3-B4F9-D9413F1F6D22}" dt="2020-03-12T07:37:12.911" v="6824" actId="1037"/>
          <ac:spMkLst>
            <pc:docMk/>
            <pc:sldMk cId="4078230159" sldId="304"/>
            <ac:spMk id="13" creationId="{0CA9D9CD-7067-48FE-AEC0-95EE1BE702A5}"/>
          </ac:spMkLst>
        </pc:spChg>
        <pc:spChg chg="mod">
          <ac:chgData name="Chew Leng Lim" userId="f4956819b06a5395" providerId="LiveId" clId="{18C7B61E-2F46-44F3-B4F9-D9413F1F6D22}" dt="2020-03-12T07:37:12.911" v="6824" actId="1037"/>
          <ac:spMkLst>
            <pc:docMk/>
            <pc:sldMk cId="4078230159" sldId="304"/>
            <ac:spMk id="14" creationId="{5CF4056F-922A-49AC-A738-F0A1B1DD307A}"/>
          </ac:spMkLst>
        </pc:spChg>
        <pc:spChg chg="mod">
          <ac:chgData name="Chew Leng Lim" userId="f4956819b06a5395" providerId="LiveId" clId="{18C7B61E-2F46-44F3-B4F9-D9413F1F6D22}" dt="2020-03-12T07:37:12.911" v="6824" actId="1037"/>
          <ac:spMkLst>
            <pc:docMk/>
            <pc:sldMk cId="4078230159" sldId="304"/>
            <ac:spMk id="15" creationId="{A8F540DD-6BAB-458E-AC75-E00A801B1B9B}"/>
          </ac:spMkLst>
        </pc:spChg>
        <pc:spChg chg="mod">
          <ac:chgData name="Chew Leng Lim" userId="f4956819b06a5395" providerId="LiveId" clId="{18C7B61E-2F46-44F3-B4F9-D9413F1F6D22}" dt="2020-03-12T07:37:12.911" v="6824" actId="1037"/>
          <ac:spMkLst>
            <pc:docMk/>
            <pc:sldMk cId="4078230159" sldId="304"/>
            <ac:spMk id="16" creationId="{CF8EC215-9A28-4B13-A791-13A1B277880F}"/>
          </ac:spMkLst>
        </pc:spChg>
        <pc:spChg chg="mod">
          <ac:chgData name="Chew Leng Lim" userId="f4956819b06a5395" providerId="LiveId" clId="{18C7B61E-2F46-44F3-B4F9-D9413F1F6D22}" dt="2020-03-12T07:37:39.377" v="6859" actId="1038"/>
          <ac:spMkLst>
            <pc:docMk/>
            <pc:sldMk cId="4078230159" sldId="304"/>
            <ac:spMk id="17" creationId="{DCB12DD8-DE24-463D-A68C-1AB2BBB327D3}"/>
          </ac:spMkLst>
        </pc:spChg>
        <pc:spChg chg="mod">
          <ac:chgData name="Chew Leng Lim" userId="f4956819b06a5395" providerId="LiveId" clId="{18C7B61E-2F46-44F3-B4F9-D9413F1F6D22}" dt="2020-03-12T07:37:12.911" v="6824" actId="1037"/>
          <ac:spMkLst>
            <pc:docMk/>
            <pc:sldMk cId="4078230159" sldId="304"/>
            <ac:spMk id="22" creationId="{CEF14E02-37F1-4D2F-9883-46002522BB3B}"/>
          </ac:spMkLst>
        </pc:spChg>
        <pc:spChg chg="mod">
          <ac:chgData name="Chew Leng Lim" userId="f4956819b06a5395" providerId="LiveId" clId="{18C7B61E-2F46-44F3-B4F9-D9413F1F6D22}" dt="2020-03-12T07:40:15.348" v="7006" actId="1035"/>
          <ac:spMkLst>
            <pc:docMk/>
            <pc:sldMk cId="4078230159" sldId="304"/>
            <ac:spMk id="24" creationId="{3EE0209A-EB39-4FD5-BC2E-5B97D50EB3D6}"/>
          </ac:spMkLst>
        </pc:spChg>
        <pc:spChg chg="mod">
          <ac:chgData name="Chew Leng Lim" userId="f4956819b06a5395" providerId="LiveId" clId="{18C7B61E-2F46-44F3-B4F9-D9413F1F6D22}" dt="2020-03-12T07:37:20.224" v="6833" actId="1037"/>
          <ac:spMkLst>
            <pc:docMk/>
            <pc:sldMk cId="4078230159" sldId="304"/>
            <ac:spMk id="34" creationId="{60344ECC-0FDC-4001-B2CC-3D8B4A7B850D}"/>
          </ac:spMkLst>
        </pc:spChg>
        <pc:spChg chg="mod">
          <ac:chgData name="Chew Leng Lim" userId="f4956819b06a5395" providerId="LiveId" clId="{18C7B61E-2F46-44F3-B4F9-D9413F1F6D22}" dt="2020-03-12T07:37:20.224" v="6833" actId="1037"/>
          <ac:spMkLst>
            <pc:docMk/>
            <pc:sldMk cId="4078230159" sldId="304"/>
            <ac:spMk id="35" creationId="{52593526-BADF-4DCA-9783-AE50237EE42B}"/>
          </ac:spMkLst>
        </pc:spChg>
        <pc:spChg chg="mod">
          <ac:chgData name="Chew Leng Lim" userId="f4956819b06a5395" providerId="LiveId" clId="{18C7B61E-2F46-44F3-B4F9-D9413F1F6D22}" dt="2020-03-12T07:37:20.224" v="6833" actId="1037"/>
          <ac:spMkLst>
            <pc:docMk/>
            <pc:sldMk cId="4078230159" sldId="304"/>
            <ac:spMk id="36" creationId="{53C26EF9-CDC0-47DA-A8B8-F7B00567CC9F}"/>
          </ac:spMkLst>
        </pc:spChg>
        <pc:spChg chg="mod">
          <ac:chgData name="Chew Leng Lim" userId="f4956819b06a5395" providerId="LiveId" clId="{18C7B61E-2F46-44F3-B4F9-D9413F1F6D22}" dt="2020-03-12T07:37:20.224" v="6833" actId="1037"/>
          <ac:spMkLst>
            <pc:docMk/>
            <pc:sldMk cId="4078230159" sldId="304"/>
            <ac:spMk id="38" creationId="{FD3B3532-F396-4532-8723-BC320D23E2C5}"/>
          </ac:spMkLst>
        </pc:spChg>
        <pc:spChg chg="mod">
          <ac:chgData name="Chew Leng Lim" userId="f4956819b06a5395" providerId="LiveId" clId="{18C7B61E-2F46-44F3-B4F9-D9413F1F6D22}" dt="2020-03-12T07:37:25.982" v="6842" actId="1037"/>
          <ac:spMkLst>
            <pc:docMk/>
            <pc:sldMk cId="4078230159" sldId="304"/>
            <ac:spMk id="39" creationId="{7630177B-181A-462D-938E-3DE48EB12B97}"/>
          </ac:spMkLst>
        </pc:spChg>
        <pc:spChg chg="mod">
          <ac:chgData name="Chew Leng Lim" userId="f4956819b06a5395" providerId="LiveId" clId="{18C7B61E-2F46-44F3-B4F9-D9413F1F6D22}" dt="2020-03-12T07:37:25.982" v="6842" actId="1037"/>
          <ac:spMkLst>
            <pc:docMk/>
            <pc:sldMk cId="4078230159" sldId="304"/>
            <ac:spMk id="40" creationId="{86EE2203-2203-44DF-96BC-ED9A54D3259C}"/>
          </ac:spMkLst>
        </pc:spChg>
        <pc:spChg chg="mod">
          <ac:chgData name="Chew Leng Lim" userId="f4956819b06a5395" providerId="LiveId" clId="{18C7B61E-2F46-44F3-B4F9-D9413F1F6D22}" dt="2020-03-12T07:37:25.982" v="6842" actId="1037"/>
          <ac:spMkLst>
            <pc:docMk/>
            <pc:sldMk cId="4078230159" sldId="304"/>
            <ac:spMk id="41" creationId="{08DC3FC6-A5A8-4634-880F-3780A8BA7078}"/>
          </ac:spMkLst>
        </pc:spChg>
        <pc:spChg chg="mod">
          <ac:chgData name="Chew Leng Lim" userId="f4956819b06a5395" providerId="LiveId" clId="{18C7B61E-2F46-44F3-B4F9-D9413F1F6D22}" dt="2020-03-12T07:37:25.982" v="6842" actId="1037"/>
          <ac:spMkLst>
            <pc:docMk/>
            <pc:sldMk cId="4078230159" sldId="304"/>
            <ac:spMk id="42" creationId="{69D4D1D5-3B69-48DD-9FB7-3D0DEDE0A1A8}"/>
          </ac:spMkLst>
        </pc:spChg>
        <pc:spChg chg="mod">
          <ac:chgData name="Chew Leng Lim" userId="f4956819b06a5395" providerId="LiveId" clId="{18C7B61E-2F46-44F3-B4F9-D9413F1F6D22}" dt="2020-03-12T07:37:25.982" v="6842" actId="1037"/>
          <ac:spMkLst>
            <pc:docMk/>
            <pc:sldMk cId="4078230159" sldId="304"/>
            <ac:spMk id="43" creationId="{6A967BC9-4B81-455A-98C0-515E4B575805}"/>
          </ac:spMkLst>
        </pc:spChg>
        <pc:spChg chg="mod">
          <ac:chgData name="Chew Leng Lim" userId="f4956819b06a5395" providerId="LiveId" clId="{18C7B61E-2F46-44F3-B4F9-D9413F1F6D22}" dt="2020-03-03T10:06:24.594" v="363" actId="113"/>
          <ac:spMkLst>
            <pc:docMk/>
            <pc:sldMk cId="4078230159" sldId="304"/>
            <ac:spMk id="45" creationId="{109F8E0E-298C-47CD-AB37-C9CE844D1384}"/>
          </ac:spMkLst>
        </pc:spChg>
        <pc:spChg chg="mod">
          <ac:chgData name="Chew Leng Lim" userId="f4956819b06a5395" providerId="LiveId" clId="{18C7B61E-2F46-44F3-B4F9-D9413F1F6D22}" dt="2020-03-12T07:37:45.709" v="6862" actId="1038"/>
          <ac:spMkLst>
            <pc:docMk/>
            <pc:sldMk cId="4078230159" sldId="304"/>
            <ac:spMk id="49" creationId="{27D7296A-ECEE-4B27-9166-FBDB7F1BF6F5}"/>
          </ac:spMkLst>
        </pc:spChg>
        <pc:spChg chg="mod">
          <ac:chgData name="Chew Leng Lim" userId="f4956819b06a5395" providerId="LiveId" clId="{18C7B61E-2F46-44F3-B4F9-D9413F1F6D22}" dt="2020-03-12T07:37:32.711" v="6851" actId="1037"/>
          <ac:spMkLst>
            <pc:docMk/>
            <pc:sldMk cId="4078230159" sldId="304"/>
            <ac:spMk id="50" creationId="{AF297971-81B5-4976-8C2A-43CB08E090C3}"/>
          </ac:spMkLst>
        </pc:spChg>
        <pc:spChg chg="mod">
          <ac:chgData name="Chew Leng Lim" userId="f4956819b06a5395" providerId="LiveId" clId="{18C7B61E-2F46-44F3-B4F9-D9413F1F6D22}" dt="2020-03-12T07:37:32.711" v="6851" actId="1037"/>
          <ac:spMkLst>
            <pc:docMk/>
            <pc:sldMk cId="4078230159" sldId="304"/>
            <ac:spMk id="51" creationId="{8172092E-F505-407B-8D73-473EEF26B232}"/>
          </ac:spMkLst>
        </pc:spChg>
        <pc:spChg chg="mod">
          <ac:chgData name="Chew Leng Lim" userId="f4956819b06a5395" providerId="LiveId" clId="{18C7B61E-2F46-44F3-B4F9-D9413F1F6D22}" dt="2020-03-12T07:37:32.711" v="6851" actId="1037"/>
          <ac:spMkLst>
            <pc:docMk/>
            <pc:sldMk cId="4078230159" sldId="304"/>
            <ac:spMk id="52" creationId="{703EE93B-FDBC-4CE5-8865-4CC2417A94D2}"/>
          </ac:spMkLst>
        </pc:spChg>
        <pc:spChg chg="mod">
          <ac:chgData name="Chew Leng Lim" userId="f4956819b06a5395" providerId="LiveId" clId="{18C7B61E-2F46-44F3-B4F9-D9413F1F6D22}" dt="2020-03-12T07:37:32.711" v="6851" actId="1037"/>
          <ac:spMkLst>
            <pc:docMk/>
            <pc:sldMk cId="4078230159" sldId="304"/>
            <ac:spMk id="53" creationId="{1C5D0AA7-CE2E-4205-950C-1BB76A3F8909}"/>
          </ac:spMkLst>
        </pc:spChg>
        <pc:spChg chg="mod">
          <ac:chgData name="Chew Leng Lim" userId="f4956819b06a5395" providerId="LiveId" clId="{18C7B61E-2F46-44F3-B4F9-D9413F1F6D22}" dt="2020-03-12T07:37:49.374" v="6866" actId="1038"/>
          <ac:spMkLst>
            <pc:docMk/>
            <pc:sldMk cId="4078230159" sldId="304"/>
            <ac:spMk id="55" creationId="{5DB31EF2-92BF-4868-A33F-0E1FC9C954F4}"/>
          </ac:spMkLst>
        </pc:spChg>
        <pc:spChg chg="mod">
          <ac:chgData name="Chew Leng Lim" userId="f4956819b06a5395" providerId="LiveId" clId="{18C7B61E-2F46-44F3-B4F9-D9413F1F6D22}" dt="2020-03-12T07:37:51.936" v="6867" actId="1037"/>
          <ac:spMkLst>
            <pc:docMk/>
            <pc:sldMk cId="4078230159" sldId="304"/>
            <ac:spMk id="57" creationId="{DA3327B8-1E4F-4C5C-83D6-3CEC7595290F}"/>
          </ac:spMkLst>
        </pc:spChg>
        <pc:spChg chg="mod">
          <ac:chgData name="Chew Leng Lim" userId="f4956819b06a5395" providerId="LiveId" clId="{18C7B61E-2F46-44F3-B4F9-D9413F1F6D22}" dt="2020-03-12T07:37:35.368" v="6857" actId="6549"/>
          <ac:spMkLst>
            <pc:docMk/>
            <pc:sldMk cId="4078230159" sldId="304"/>
            <ac:spMk id="58" creationId="{A65C94D2-BD94-4D24-BBD6-55BE3923BB56}"/>
          </ac:spMkLst>
        </pc:spChg>
        <pc:graphicFrameChg chg="mod">
          <ac:chgData name="Chew Leng Lim" userId="f4956819b06a5395" providerId="LiveId" clId="{18C7B61E-2F46-44F3-B4F9-D9413F1F6D22}" dt="2020-03-12T07:35:36.271" v="6332" actId="12789"/>
          <ac:graphicFrameMkLst>
            <pc:docMk/>
            <pc:sldMk cId="4078230159" sldId="304"/>
            <ac:graphicFrameMk id="2" creationId="{93E3B522-5319-4FCE-9C0C-F05A780072FD}"/>
          </ac:graphicFrameMkLst>
        </pc:graphicFrameChg>
        <pc:graphicFrameChg chg="mod">
          <ac:chgData name="Chew Leng Lim" userId="f4956819b06a5395" providerId="LiveId" clId="{18C7B61E-2F46-44F3-B4F9-D9413F1F6D22}" dt="2020-03-12T07:35:36.271" v="6332" actId="12789"/>
          <ac:graphicFrameMkLst>
            <pc:docMk/>
            <pc:sldMk cId="4078230159" sldId="304"/>
            <ac:graphicFrameMk id="3" creationId="{74D1BB55-120B-4D14-80C9-5264090FCC49}"/>
          </ac:graphicFrameMkLst>
        </pc:graphicFrameChg>
        <pc:graphicFrameChg chg="mod">
          <ac:chgData name="Chew Leng Lim" userId="f4956819b06a5395" providerId="LiveId" clId="{18C7B61E-2F46-44F3-B4F9-D9413F1F6D22}" dt="2020-03-12T07:35:36.271" v="6332" actId="12789"/>
          <ac:graphicFrameMkLst>
            <pc:docMk/>
            <pc:sldMk cId="4078230159" sldId="304"/>
            <ac:graphicFrameMk id="4" creationId="{CC958755-FF9A-47B7-A39B-A67C18C24446}"/>
          </ac:graphicFrameMkLst>
        </pc:graphicFrameChg>
        <pc:graphicFrameChg chg="mod">
          <ac:chgData name="Chew Leng Lim" userId="f4956819b06a5395" providerId="LiveId" clId="{18C7B61E-2F46-44F3-B4F9-D9413F1F6D22}" dt="2020-03-12T07:35:36.271" v="6332" actId="12789"/>
          <ac:graphicFrameMkLst>
            <pc:docMk/>
            <pc:sldMk cId="4078230159" sldId="304"/>
            <ac:graphicFrameMk id="5" creationId="{9EFF4D88-8905-4328-912E-7888DF8E879F}"/>
          </ac:graphicFrameMkLst>
        </pc:graphicFrameChg>
        <pc:graphicFrameChg chg="add mod">
          <ac:chgData name="Chew Leng Lim" userId="f4956819b06a5395" providerId="LiveId" clId="{18C7B61E-2F46-44F3-B4F9-D9413F1F6D22}" dt="2020-03-12T07:22:51.559" v="4698" actId="571"/>
          <ac:graphicFrameMkLst>
            <pc:docMk/>
            <pc:sldMk cId="4078230159" sldId="304"/>
            <ac:graphicFrameMk id="46" creationId="{3C15C628-9C98-4A4E-8B9C-D2F300740D7E}"/>
          </ac:graphicFrameMkLst>
        </pc:graphicFrameChg>
        <pc:graphicFrameChg chg="add mod">
          <ac:chgData name="Chew Leng Lim" userId="f4956819b06a5395" providerId="LiveId" clId="{18C7B61E-2F46-44F3-B4F9-D9413F1F6D22}" dt="2020-03-12T07:22:51.559" v="4698" actId="571"/>
          <ac:graphicFrameMkLst>
            <pc:docMk/>
            <pc:sldMk cId="4078230159" sldId="304"/>
            <ac:graphicFrameMk id="47" creationId="{B22DCBE0-5A70-4254-A6A7-5171AAA8188D}"/>
          </ac:graphicFrameMkLst>
        </pc:graphicFrameChg>
        <pc:graphicFrameChg chg="add mod">
          <ac:chgData name="Chew Leng Lim" userId="f4956819b06a5395" providerId="LiveId" clId="{18C7B61E-2F46-44F3-B4F9-D9413F1F6D22}" dt="2020-03-12T07:22:51.559" v="4698" actId="571"/>
          <ac:graphicFrameMkLst>
            <pc:docMk/>
            <pc:sldMk cId="4078230159" sldId="304"/>
            <ac:graphicFrameMk id="48" creationId="{C444AAFC-1EE9-4A51-857D-C3709378F6DA}"/>
          </ac:graphicFrameMkLst>
        </pc:graphicFrameChg>
      </pc:sldChg>
      <pc:sldChg chg="delSp modSp ord">
        <pc:chgData name="Chew Leng Lim" userId="f4956819b06a5395" providerId="LiveId" clId="{18C7B61E-2F46-44F3-B4F9-D9413F1F6D22}" dt="2020-03-12T07:40:00.492" v="6981"/>
        <pc:sldMkLst>
          <pc:docMk/>
          <pc:sldMk cId="2182335463" sldId="325"/>
        </pc:sldMkLst>
        <pc:spChg chg="del">
          <ac:chgData name="Chew Leng Lim" userId="f4956819b06a5395" providerId="LiveId" clId="{18C7B61E-2F46-44F3-B4F9-D9413F1F6D22}" dt="2020-03-03T10:39:38.401" v="375" actId="478"/>
          <ac:spMkLst>
            <pc:docMk/>
            <pc:sldMk cId="2182335463" sldId="325"/>
            <ac:spMk id="47" creationId="{A6267E6F-2386-4601-B24C-0D56D3F6F50E}"/>
          </ac:spMkLst>
        </pc:spChg>
        <pc:spChg chg="del">
          <ac:chgData name="Chew Leng Lim" userId="f4956819b06a5395" providerId="LiveId" clId="{18C7B61E-2F46-44F3-B4F9-D9413F1F6D22}" dt="2020-03-03T10:39:38.401" v="375" actId="478"/>
          <ac:spMkLst>
            <pc:docMk/>
            <pc:sldMk cId="2182335463" sldId="325"/>
            <ac:spMk id="48" creationId="{25FFF2FC-ABE8-4321-984F-9EAD1AAAA035}"/>
          </ac:spMkLst>
        </pc:spChg>
        <pc:spChg chg="mod">
          <ac:chgData name="Chew Leng Lim" userId="f4956819b06a5395" providerId="LiveId" clId="{18C7B61E-2F46-44F3-B4F9-D9413F1F6D22}" dt="2020-03-12T07:39:47.548" v="6979" actId="6549"/>
          <ac:spMkLst>
            <pc:docMk/>
            <pc:sldMk cId="2182335463" sldId="325"/>
            <ac:spMk id="88" creationId="{4E164404-3247-4925-ACC9-3BA596511132}"/>
          </ac:spMkLst>
        </pc:spChg>
        <pc:spChg chg="mod">
          <ac:chgData name="Chew Leng Lim" userId="f4956819b06a5395" providerId="LiveId" clId="{18C7B61E-2F46-44F3-B4F9-D9413F1F6D22}" dt="2020-03-03T10:06:30.435" v="364" actId="113"/>
          <ac:spMkLst>
            <pc:docMk/>
            <pc:sldMk cId="2182335463" sldId="325"/>
            <ac:spMk id="151" creationId="{25A1AB35-BF14-4722-8AD9-BA0B4BD22EB0}"/>
          </ac:spMkLst>
        </pc:spChg>
        <pc:spChg chg="del">
          <ac:chgData name="Chew Leng Lim" userId="f4956819b06a5395" providerId="LiveId" clId="{18C7B61E-2F46-44F3-B4F9-D9413F1F6D22}" dt="2020-03-03T10:39:38.401" v="375" actId="478"/>
          <ac:spMkLst>
            <pc:docMk/>
            <pc:sldMk cId="2182335463" sldId="325"/>
            <ac:spMk id="154" creationId="{F7A737D5-7578-4A06-9D45-36F4B1E62924}"/>
          </ac:spMkLst>
        </pc:spChg>
        <pc:grpChg chg="mod">
          <ac:chgData name="Chew Leng Lim" userId="f4956819b06a5395" providerId="LiveId" clId="{18C7B61E-2F46-44F3-B4F9-D9413F1F6D22}" dt="2020-03-12T07:40:00.492" v="6981"/>
          <ac:grpSpMkLst>
            <pc:docMk/>
            <pc:sldMk cId="2182335463" sldId="325"/>
            <ac:grpSpMk id="13" creationId="{F838DFE0-BD30-4885-A589-7A18193CEFDA}"/>
          </ac:grpSpMkLst>
        </pc:grpChg>
        <pc:grpChg chg="mod">
          <ac:chgData name="Chew Leng Lim" userId="f4956819b06a5395" providerId="LiveId" clId="{18C7B61E-2F46-44F3-B4F9-D9413F1F6D22}" dt="2020-03-12T07:40:00.492" v="6981"/>
          <ac:grpSpMkLst>
            <pc:docMk/>
            <pc:sldMk cId="2182335463" sldId="325"/>
            <ac:grpSpMk id="26" creationId="{E3A26052-EC29-4B70-9717-E4CB34EE2321}"/>
          </ac:grpSpMkLst>
        </pc:grpChg>
        <pc:graphicFrameChg chg="mod">
          <ac:chgData name="Chew Leng Lim" userId="f4956819b06a5395" providerId="LiveId" clId="{18C7B61E-2F46-44F3-B4F9-D9413F1F6D22}" dt="2020-03-12T07:40:00.492" v="6981"/>
          <ac:graphicFrameMkLst>
            <pc:docMk/>
            <pc:sldMk cId="2182335463" sldId="325"/>
            <ac:graphicFrameMk id="135" creationId="{5B3745C6-93DC-430E-A4B3-357942A2CB49}"/>
          </ac:graphicFrameMkLst>
        </pc:graphicFrameChg>
        <pc:graphicFrameChg chg="del">
          <ac:chgData name="Chew Leng Lim" userId="f4956819b06a5395" providerId="LiveId" clId="{18C7B61E-2F46-44F3-B4F9-D9413F1F6D22}" dt="2020-03-03T10:39:38.401" v="375" actId="478"/>
          <ac:graphicFrameMkLst>
            <pc:docMk/>
            <pc:sldMk cId="2182335463" sldId="325"/>
            <ac:graphicFrameMk id="149" creationId="{35F5E9E6-947B-4355-ADB6-90BFD6108AD5}"/>
          </ac:graphicFrameMkLst>
        </pc:graphicFrameChg>
        <pc:graphicFrameChg chg="del">
          <ac:chgData name="Chew Leng Lim" userId="f4956819b06a5395" providerId="LiveId" clId="{18C7B61E-2F46-44F3-B4F9-D9413F1F6D22}" dt="2020-03-03T10:39:38.401" v="375" actId="478"/>
          <ac:graphicFrameMkLst>
            <pc:docMk/>
            <pc:sldMk cId="2182335463" sldId="325"/>
            <ac:graphicFrameMk id="150" creationId="{12E83BFF-1846-4855-8C26-AF66C910471C}"/>
          </ac:graphicFrameMkLst>
        </pc:graphicFrameChg>
      </pc:sldChg>
      <pc:sldChg chg="modSp">
        <pc:chgData name="Chew Leng Lim" userId="f4956819b06a5395" providerId="LiveId" clId="{18C7B61E-2F46-44F3-B4F9-D9413F1F6D22}" dt="2020-03-12T07:35:11.612" v="6331" actId="1038"/>
        <pc:sldMkLst>
          <pc:docMk/>
          <pc:sldMk cId="1759144904" sldId="326"/>
        </pc:sldMkLst>
        <pc:spChg chg="mod">
          <ac:chgData name="Chew Leng Lim" userId="f4956819b06a5395" providerId="LiveId" clId="{18C7B61E-2F46-44F3-B4F9-D9413F1F6D22}" dt="2020-03-12T07:30:22.692" v="5838" actId="1036"/>
          <ac:spMkLst>
            <pc:docMk/>
            <pc:sldMk cId="1759144904" sldId="326"/>
            <ac:spMk id="43" creationId="{65E8C6D9-3FE0-4E71-A070-2DBC5D563DAF}"/>
          </ac:spMkLst>
        </pc:spChg>
        <pc:spChg chg="mod">
          <ac:chgData name="Chew Leng Lim" userId="f4956819b06a5395" providerId="LiveId" clId="{18C7B61E-2F46-44F3-B4F9-D9413F1F6D22}" dt="2020-03-12T07:30:24.410" v="5840" actId="1036"/>
          <ac:spMkLst>
            <pc:docMk/>
            <pc:sldMk cId="1759144904" sldId="326"/>
            <ac:spMk id="44" creationId="{88C6A947-946B-4914-850F-B9F440738342}"/>
          </ac:spMkLst>
        </pc:spChg>
        <pc:spChg chg="mod">
          <ac:chgData name="Chew Leng Lim" userId="f4956819b06a5395" providerId="LiveId" clId="{18C7B61E-2F46-44F3-B4F9-D9413F1F6D22}" dt="2020-03-12T07:30:28.146" v="5860" actId="1036"/>
          <ac:spMkLst>
            <pc:docMk/>
            <pc:sldMk cId="1759144904" sldId="326"/>
            <ac:spMk id="45" creationId="{333A7AEB-2074-4F5F-9AA0-72C7A6D89D40}"/>
          </ac:spMkLst>
        </pc:spChg>
        <pc:spChg chg="mod">
          <ac:chgData name="Chew Leng Lim" userId="f4956819b06a5395" providerId="LiveId" clId="{18C7B61E-2F46-44F3-B4F9-D9413F1F6D22}" dt="2020-03-12T07:30:33.665" v="5896" actId="1035"/>
          <ac:spMkLst>
            <pc:docMk/>
            <pc:sldMk cId="1759144904" sldId="326"/>
            <ac:spMk id="46" creationId="{EF0F67B4-F713-4B74-8429-74CE408F2A4D}"/>
          </ac:spMkLst>
        </pc:spChg>
        <pc:spChg chg="mod">
          <ac:chgData name="Chew Leng Lim" userId="f4956819b06a5395" providerId="LiveId" clId="{18C7B61E-2F46-44F3-B4F9-D9413F1F6D22}" dt="2020-03-12T07:30:36.630" v="5927" actId="1035"/>
          <ac:spMkLst>
            <pc:docMk/>
            <pc:sldMk cId="1759144904" sldId="326"/>
            <ac:spMk id="47" creationId="{383F0FFA-5219-4511-8D90-6EF4A58E3261}"/>
          </ac:spMkLst>
        </pc:spChg>
        <pc:spChg chg="mod">
          <ac:chgData name="Chew Leng Lim" userId="f4956819b06a5395" providerId="LiveId" clId="{18C7B61E-2F46-44F3-B4F9-D9413F1F6D22}" dt="2020-03-12T07:33:42.322" v="5946" actId="1035"/>
          <ac:spMkLst>
            <pc:docMk/>
            <pc:sldMk cId="1759144904" sldId="326"/>
            <ac:spMk id="49" creationId="{B3CE5B5D-2E1D-4E71-9395-CFAB78DB04E8}"/>
          </ac:spMkLst>
        </pc:spChg>
        <pc:spChg chg="mod">
          <ac:chgData name="Chew Leng Lim" userId="f4956819b06a5395" providerId="LiveId" clId="{18C7B61E-2F46-44F3-B4F9-D9413F1F6D22}" dt="2020-03-12T07:29:58.568" v="5689" actId="1036"/>
          <ac:spMkLst>
            <pc:docMk/>
            <pc:sldMk cId="1759144904" sldId="326"/>
            <ac:spMk id="50" creationId="{BF364605-BD05-4894-B332-98F465DFEF1F}"/>
          </ac:spMkLst>
        </pc:spChg>
        <pc:spChg chg="mod">
          <ac:chgData name="Chew Leng Lim" userId="f4956819b06a5395" providerId="LiveId" clId="{18C7B61E-2F46-44F3-B4F9-D9413F1F6D22}" dt="2020-03-12T07:30:01.522" v="5707" actId="1036"/>
          <ac:spMkLst>
            <pc:docMk/>
            <pc:sldMk cId="1759144904" sldId="326"/>
            <ac:spMk id="51" creationId="{B916B9C2-6D7C-4911-9B26-209ADEF5B369}"/>
          </ac:spMkLst>
        </pc:spChg>
        <pc:spChg chg="mod">
          <ac:chgData name="Chew Leng Lim" userId="f4956819b06a5395" providerId="LiveId" clId="{18C7B61E-2F46-44F3-B4F9-D9413F1F6D22}" dt="2020-03-12T07:30:06.393" v="5738" actId="1035"/>
          <ac:spMkLst>
            <pc:docMk/>
            <pc:sldMk cId="1759144904" sldId="326"/>
            <ac:spMk id="52" creationId="{CD522047-EF1F-482D-BF6F-A6B8749D1E87}"/>
          </ac:spMkLst>
        </pc:spChg>
        <pc:spChg chg="mod">
          <ac:chgData name="Chew Leng Lim" userId="f4956819b06a5395" providerId="LiveId" clId="{18C7B61E-2F46-44F3-B4F9-D9413F1F6D22}" dt="2020-03-12T07:30:11.098" v="5771" actId="1035"/>
          <ac:spMkLst>
            <pc:docMk/>
            <pc:sldMk cId="1759144904" sldId="326"/>
            <ac:spMk id="53" creationId="{78953C15-02CD-45BD-967F-0A756F1AF664}"/>
          </ac:spMkLst>
        </pc:spChg>
        <pc:spChg chg="mod">
          <ac:chgData name="Chew Leng Lim" userId="f4956819b06a5395" providerId="LiveId" clId="{18C7B61E-2F46-44F3-B4F9-D9413F1F6D22}" dt="2020-03-12T07:30:16.038" v="5813" actId="1036"/>
          <ac:spMkLst>
            <pc:docMk/>
            <pc:sldMk cId="1759144904" sldId="326"/>
            <ac:spMk id="54" creationId="{6066E554-9646-4ACB-89A9-C3BE0E020520}"/>
          </ac:spMkLst>
        </pc:spChg>
        <pc:spChg chg="mod">
          <ac:chgData name="Chew Leng Lim" userId="f4956819b06a5395" providerId="LiveId" clId="{18C7B61E-2F46-44F3-B4F9-D9413F1F6D22}" dt="2020-03-12T07:29:55.092" v="5678" actId="1036"/>
          <ac:spMkLst>
            <pc:docMk/>
            <pc:sldMk cId="1759144904" sldId="326"/>
            <ac:spMk id="56" creationId="{95C642A8-1A49-4D24-969B-681EEB179B78}"/>
          </ac:spMkLst>
        </pc:spChg>
        <pc:spChg chg="mod">
          <ac:chgData name="Chew Leng Lim" userId="f4956819b06a5395" providerId="LiveId" clId="{18C7B61E-2F46-44F3-B4F9-D9413F1F6D22}" dt="2020-03-12T07:35:11.612" v="6331" actId="1038"/>
          <ac:spMkLst>
            <pc:docMk/>
            <pc:sldMk cId="1759144904" sldId="326"/>
            <ac:spMk id="57" creationId="{3DB0ECB5-8BED-41E9-A8D7-1EFB9DBF1BB0}"/>
          </ac:spMkLst>
        </pc:spChg>
        <pc:spChg chg="mod">
          <ac:chgData name="Chew Leng Lim" userId="f4956819b06a5395" providerId="LiveId" clId="{18C7B61E-2F46-44F3-B4F9-D9413F1F6D22}" dt="2020-03-12T07:33:44.783" v="5956" actId="1035"/>
          <ac:spMkLst>
            <pc:docMk/>
            <pc:sldMk cId="1759144904" sldId="326"/>
            <ac:spMk id="58" creationId="{714C603C-0E23-4053-B41C-BA8BF261AC0F}"/>
          </ac:spMkLst>
        </pc:spChg>
        <pc:spChg chg="mod">
          <ac:chgData name="Chew Leng Lim" userId="f4956819b06a5395" providerId="LiveId" clId="{18C7B61E-2F46-44F3-B4F9-D9413F1F6D22}" dt="2020-03-12T07:33:48.590" v="5979" actId="1035"/>
          <ac:spMkLst>
            <pc:docMk/>
            <pc:sldMk cId="1759144904" sldId="326"/>
            <ac:spMk id="60" creationId="{B5EAFEDC-B7E7-4650-B60C-54CEA3991CDA}"/>
          </ac:spMkLst>
        </pc:spChg>
        <pc:spChg chg="mod">
          <ac:chgData name="Chew Leng Lim" userId="f4956819b06a5395" providerId="LiveId" clId="{18C7B61E-2F46-44F3-B4F9-D9413F1F6D22}" dt="2020-03-12T07:33:55.995" v="6022" actId="1036"/>
          <ac:spMkLst>
            <pc:docMk/>
            <pc:sldMk cId="1759144904" sldId="326"/>
            <ac:spMk id="61" creationId="{0A9C46F0-C155-4850-9DBA-45510832EB15}"/>
          </ac:spMkLst>
        </pc:spChg>
        <pc:spChg chg="mod">
          <ac:chgData name="Chew Leng Lim" userId="f4956819b06a5395" providerId="LiveId" clId="{18C7B61E-2F46-44F3-B4F9-D9413F1F6D22}" dt="2020-03-12T07:35:06.730" v="6321" actId="1038"/>
          <ac:spMkLst>
            <pc:docMk/>
            <pc:sldMk cId="1759144904" sldId="326"/>
            <ac:spMk id="62" creationId="{29781129-B277-4F11-94A4-6B6C531B5642}"/>
          </ac:spMkLst>
        </pc:spChg>
        <pc:spChg chg="mod">
          <ac:chgData name="Chew Leng Lim" userId="f4956819b06a5395" providerId="LiveId" clId="{18C7B61E-2F46-44F3-B4F9-D9413F1F6D22}" dt="2020-03-12T07:29:47.141" v="5656" actId="12789"/>
          <ac:spMkLst>
            <pc:docMk/>
            <pc:sldMk cId="1759144904" sldId="326"/>
            <ac:spMk id="63" creationId="{7F363B60-4345-4D66-B586-11FF7074D5BF}"/>
          </ac:spMkLst>
        </pc:spChg>
        <pc:spChg chg="mod">
          <ac:chgData name="Chew Leng Lim" userId="f4956819b06a5395" providerId="LiveId" clId="{18C7B61E-2F46-44F3-B4F9-D9413F1F6D22}" dt="2020-03-12T07:34:00.188" v="6060" actId="1035"/>
          <ac:spMkLst>
            <pc:docMk/>
            <pc:sldMk cId="1759144904" sldId="326"/>
            <ac:spMk id="64" creationId="{7C847B10-81FE-493D-A527-8057B7B8260D}"/>
          </ac:spMkLst>
        </pc:spChg>
        <pc:spChg chg="mod">
          <ac:chgData name="Chew Leng Lim" userId="f4956819b06a5395" providerId="LiveId" clId="{18C7B61E-2F46-44F3-B4F9-D9413F1F6D22}" dt="2020-03-12T07:34:33.120" v="6201" actId="1035"/>
          <ac:spMkLst>
            <pc:docMk/>
            <pc:sldMk cId="1759144904" sldId="326"/>
            <ac:spMk id="66" creationId="{92BACDF4-47CA-4D4E-9028-9D0FDA03C92C}"/>
          </ac:spMkLst>
        </pc:spChg>
        <pc:spChg chg="mod">
          <ac:chgData name="Chew Leng Lim" userId="f4956819b06a5395" providerId="LiveId" clId="{18C7B61E-2F46-44F3-B4F9-D9413F1F6D22}" dt="2020-03-12T07:34:57.910" v="6316" actId="1038"/>
          <ac:spMkLst>
            <pc:docMk/>
            <pc:sldMk cId="1759144904" sldId="326"/>
            <ac:spMk id="67" creationId="{BE74C571-F08C-4F7C-AD16-5CE08462A79E}"/>
          </ac:spMkLst>
        </pc:spChg>
        <pc:spChg chg="mod">
          <ac:chgData name="Chew Leng Lim" userId="f4956819b06a5395" providerId="LiveId" clId="{18C7B61E-2F46-44F3-B4F9-D9413F1F6D22}" dt="2020-03-12T07:29:30.474" v="5654" actId="6549"/>
          <ac:spMkLst>
            <pc:docMk/>
            <pc:sldMk cId="1759144904" sldId="326"/>
            <ac:spMk id="72" creationId="{24BABAEB-A4D6-4B1B-8F38-59C3ABD68862}"/>
          </ac:spMkLst>
        </pc:spChg>
        <pc:spChg chg="mod">
          <ac:chgData name="Chew Leng Lim" userId="f4956819b06a5395" providerId="LiveId" clId="{18C7B61E-2F46-44F3-B4F9-D9413F1F6D22}" dt="2020-03-12T07:34:02.989" v="6077" actId="1036"/>
          <ac:spMkLst>
            <pc:docMk/>
            <pc:sldMk cId="1759144904" sldId="326"/>
            <ac:spMk id="79" creationId="{DD336327-0C28-48AE-8D92-4DC3626D90E7}"/>
          </ac:spMkLst>
        </pc:spChg>
        <pc:spChg chg="mod">
          <ac:chgData name="Chew Leng Lim" userId="f4956819b06a5395" providerId="LiveId" clId="{18C7B61E-2F46-44F3-B4F9-D9413F1F6D22}" dt="2020-03-12T07:34:06.243" v="6092" actId="1036"/>
          <ac:spMkLst>
            <pc:docMk/>
            <pc:sldMk cId="1759144904" sldId="326"/>
            <ac:spMk id="88" creationId="{5BB6E7D2-F674-489B-A3D5-D40D5F623268}"/>
          </ac:spMkLst>
        </pc:spChg>
        <pc:spChg chg="mod">
          <ac:chgData name="Chew Leng Lim" userId="f4956819b06a5395" providerId="LiveId" clId="{18C7B61E-2F46-44F3-B4F9-D9413F1F6D22}" dt="2020-03-12T07:34:10.664" v="6127" actId="1035"/>
          <ac:spMkLst>
            <pc:docMk/>
            <pc:sldMk cId="1759144904" sldId="326"/>
            <ac:spMk id="89" creationId="{2C876F91-EF0C-4419-AA73-02C10C9EABBE}"/>
          </ac:spMkLst>
        </pc:spChg>
        <pc:spChg chg="mod">
          <ac:chgData name="Chew Leng Lim" userId="f4956819b06a5395" providerId="LiveId" clId="{18C7B61E-2F46-44F3-B4F9-D9413F1F6D22}" dt="2020-03-12T07:34:16.051" v="6168" actId="1035"/>
          <ac:spMkLst>
            <pc:docMk/>
            <pc:sldMk cId="1759144904" sldId="326"/>
            <ac:spMk id="90" creationId="{E1DDEA9E-4532-413B-8BA2-30802B7244EB}"/>
          </ac:spMkLst>
        </pc:spChg>
        <pc:spChg chg="mod">
          <ac:chgData name="Chew Leng Lim" userId="f4956819b06a5395" providerId="LiveId" clId="{18C7B61E-2F46-44F3-B4F9-D9413F1F6D22}" dt="2020-03-12T07:34:24.015" v="6189" actId="1036"/>
          <ac:spMkLst>
            <pc:docMk/>
            <pc:sldMk cId="1759144904" sldId="326"/>
            <ac:spMk id="92" creationId="{FF3AB5FA-0249-472C-B20F-445EB5455B7F}"/>
          </ac:spMkLst>
        </pc:spChg>
        <pc:spChg chg="mod">
          <ac:chgData name="Chew Leng Lim" userId="f4956819b06a5395" providerId="LiveId" clId="{18C7B61E-2F46-44F3-B4F9-D9413F1F6D22}" dt="2020-03-12T07:34:35.903" v="6205" actId="1036"/>
          <ac:spMkLst>
            <pc:docMk/>
            <pc:sldMk cId="1759144904" sldId="326"/>
            <ac:spMk id="93" creationId="{5E02FABB-B953-4FBE-8139-EAC6A435FB13}"/>
          </ac:spMkLst>
        </pc:spChg>
        <pc:spChg chg="mod">
          <ac:chgData name="Chew Leng Lim" userId="f4956819b06a5395" providerId="LiveId" clId="{18C7B61E-2F46-44F3-B4F9-D9413F1F6D22}" dt="2020-03-12T07:34:42.363" v="6235" actId="1035"/>
          <ac:spMkLst>
            <pc:docMk/>
            <pc:sldMk cId="1759144904" sldId="326"/>
            <ac:spMk id="94" creationId="{5F161AB3-8B2F-4945-9D5A-2F9239954F27}"/>
          </ac:spMkLst>
        </pc:spChg>
        <pc:spChg chg="mod">
          <ac:chgData name="Chew Leng Lim" userId="f4956819b06a5395" providerId="LiveId" clId="{18C7B61E-2F46-44F3-B4F9-D9413F1F6D22}" dt="2020-03-12T07:34:47.179" v="6264" actId="1036"/>
          <ac:spMkLst>
            <pc:docMk/>
            <pc:sldMk cId="1759144904" sldId="326"/>
            <ac:spMk id="95" creationId="{A5260C0E-4997-4568-A869-1FC184180695}"/>
          </ac:spMkLst>
        </pc:spChg>
        <pc:spChg chg="mod">
          <ac:chgData name="Chew Leng Lim" userId="f4956819b06a5395" providerId="LiveId" clId="{18C7B61E-2F46-44F3-B4F9-D9413F1F6D22}" dt="2020-03-12T07:34:52.401" v="6305" actId="1036"/>
          <ac:spMkLst>
            <pc:docMk/>
            <pc:sldMk cId="1759144904" sldId="326"/>
            <ac:spMk id="96" creationId="{65BC36E3-F0DA-4FD8-8D6F-7CC048208E8F}"/>
          </ac:spMkLst>
        </pc:spChg>
        <pc:spChg chg="mod">
          <ac:chgData name="Chew Leng Lim" userId="f4956819b06a5395" providerId="LiveId" clId="{18C7B61E-2F46-44F3-B4F9-D9413F1F6D22}" dt="2020-03-03T10:06:49.261" v="367" actId="113"/>
          <ac:spMkLst>
            <pc:docMk/>
            <pc:sldMk cId="1759144904" sldId="326"/>
            <ac:spMk id="101" creationId="{BEC4EFF3-800D-4B2D-84C2-C6946D47B9E4}"/>
          </ac:spMkLst>
        </pc:spChg>
        <pc:graphicFrameChg chg="mod">
          <ac:chgData name="Chew Leng Lim" userId="f4956819b06a5395" providerId="LiveId" clId="{18C7B61E-2F46-44F3-B4F9-D9413F1F6D22}" dt="2020-03-12T07:29:38.355" v="5655" actId="12789"/>
          <ac:graphicFrameMkLst>
            <pc:docMk/>
            <pc:sldMk cId="1759144904" sldId="326"/>
            <ac:graphicFrameMk id="31" creationId="{94D6A217-C557-4030-BA9B-CD51F7CCB70C}"/>
          </ac:graphicFrameMkLst>
        </pc:graphicFrameChg>
        <pc:graphicFrameChg chg="mod">
          <ac:chgData name="Chew Leng Lim" userId="f4956819b06a5395" providerId="LiveId" clId="{18C7B61E-2F46-44F3-B4F9-D9413F1F6D22}" dt="2020-03-12T07:29:38.355" v="5655" actId="12789"/>
          <ac:graphicFrameMkLst>
            <pc:docMk/>
            <pc:sldMk cId="1759144904" sldId="326"/>
            <ac:graphicFrameMk id="32" creationId="{8C32667D-9726-4D01-9224-783A5EDE8DAD}"/>
          </ac:graphicFrameMkLst>
        </pc:graphicFrameChg>
        <pc:graphicFrameChg chg="mod">
          <ac:chgData name="Chew Leng Lim" userId="f4956819b06a5395" providerId="LiveId" clId="{18C7B61E-2F46-44F3-B4F9-D9413F1F6D22}" dt="2020-03-12T07:29:47.141" v="5656" actId="12789"/>
          <ac:graphicFrameMkLst>
            <pc:docMk/>
            <pc:sldMk cId="1759144904" sldId="326"/>
            <ac:graphicFrameMk id="33" creationId="{046C3DEF-E85F-48C2-86EC-21FED874BF38}"/>
          </ac:graphicFrameMkLst>
        </pc:graphicFrameChg>
        <pc:graphicFrameChg chg="mod">
          <ac:chgData name="Chew Leng Lim" userId="f4956819b06a5395" providerId="LiveId" clId="{18C7B61E-2F46-44F3-B4F9-D9413F1F6D22}" dt="2020-03-12T07:29:47.141" v="5656" actId="12789"/>
          <ac:graphicFrameMkLst>
            <pc:docMk/>
            <pc:sldMk cId="1759144904" sldId="326"/>
            <ac:graphicFrameMk id="34" creationId="{2BC8E8AF-63F4-4D76-8702-906E1700AFF9}"/>
          </ac:graphicFrameMkLst>
        </pc:graphicFrameChg>
        <pc:graphicFrameChg chg="mod">
          <ac:chgData name="Chew Leng Lim" userId="f4956819b06a5395" providerId="LiveId" clId="{18C7B61E-2F46-44F3-B4F9-D9413F1F6D22}" dt="2020-03-12T07:29:47.141" v="5656" actId="12789"/>
          <ac:graphicFrameMkLst>
            <pc:docMk/>
            <pc:sldMk cId="1759144904" sldId="326"/>
            <ac:graphicFrameMk id="35" creationId="{0247C3F7-9CCB-489B-AE21-48E2F719553F}"/>
          </ac:graphicFrameMkLst>
        </pc:graphicFrameChg>
      </pc:sldChg>
      <pc:sldChg chg="addSp delSp modSp del">
        <pc:chgData name="Chew Leng Lim" userId="f4956819b06a5395" providerId="LiveId" clId="{18C7B61E-2F46-44F3-B4F9-D9413F1F6D22}" dt="2020-03-03T09:56:43.666" v="302" actId="2696"/>
        <pc:sldMkLst>
          <pc:docMk/>
          <pc:sldMk cId="1886770596" sldId="327"/>
        </pc:sldMkLst>
        <pc:spChg chg="del mod">
          <ac:chgData name="Chew Leng Lim" userId="f4956819b06a5395" providerId="LiveId" clId="{18C7B61E-2F46-44F3-B4F9-D9413F1F6D22}" dt="2020-03-03T09:56:34.605" v="299"/>
          <ac:spMkLst>
            <pc:docMk/>
            <pc:sldMk cId="1886770596" sldId="327"/>
            <ac:spMk id="4" creationId="{83C4E298-DB88-46FC-951D-1C1E9F99CCBC}"/>
          </ac:spMkLst>
        </pc:spChg>
        <pc:spChg chg="del mod">
          <ac:chgData name="Chew Leng Lim" userId="f4956819b06a5395" providerId="LiveId" clId="{18C7B61E-2F46-44F3-B4F9-D9413F1F6D22}" dt="2020-03-03T09:56:34.605" v="299"/>
          <ac:spMkLst>
            <pc:docMk/>
            <pc:sldMk cId="1886770596" sldId="327"/>
            <ac:spMk id="30" creationId="{814816BC-FD9C-40AB-8EFF-5FDD3DF88E31}"/>
          </ac:spMkLst>
        </pc:spChg>
        <pc:spChg chg="add del mod">
          <ac:chgData name="Chew Leng Lim" userId="f4956819b06a5395" providerId="LiveId" clId="{18C7B61E-2F46-44F3-B4F9-D9413F1F6D22}" dt="2020-03-03T09:56:34.605" v="299"/>
          <ac:spMkLst>
            <pc:docMk/>
            <pc:sldMk cId="1886770596" sldId="327"/>
            <ac:spMk id="39" creationId="{D18DD0BB-B9FA-4610-8D75-0EE141BB631F}"/>
          </ac:spMkLst>
        </pc:spChg>
        <pc:spChg chg="del mod">
          <ac:chgData name="Chew Leng Lim" userId="f4956819b06a5395" providerId="LiveId" clId="{18C7B61E-2F46-44F3-B4F9-D9413F1F6D22}" dt="2020-03-03T09:56:34.605" v="299"/>
          <ac:spMkLst>
            <pc:docMk/>
            <pc:sldMk cId="1886770596" sldId="327"/>
            <ac:spMk id="40" creationId="{E9C2C70B-0439-421D-9CC1-B26677F00E25}"/>
          </ac:spMkLst>
        </pc:spChg>
        <pc:spChg chg="del mod">
          <ac:chgData name="Chew Leng Lim" userId="f4956819b06a5395" providerId="LiveId" clId="{18C7B61E-2F46-44F3-B4F9-D9413F1F6D22}" dt="2020-03-03T09:56:34.605" v="299"/>
          <ac:spMkLst>
            <pc:docMk/>
            <pc:sldMk cId="1886770596" sldId="327"/>
            <ac:spMk id="41" creationId="{9EFC8017-9029-4659-9EEB-B74807FC8228}"/>
          </ac:spMkLst>
        </pc:spChg>
        <pc:spChg chg="del mod">
          <ac:chgData name="Chew Leng Lim" userId="f4956819b06a5395" providerId="LiveId" clId="{18C7B61E-2F46-44F3-B4F9-D9413F1F6D22}" dt="2020-03-03T09:56:34.605" v="299"/>
          <ac:spMkLst>
            <pc:docMk/>
            <pc:sldMk cId="1886770596" sldId="327"/>
            <ac:spMk id="42" creationId="{267000B2-9DC2-40CB-B0A4-5F5D579ED5D0}"/>
          </ac:spMkLst>
        </pc:spChg>
        <pc:spChg chg="del mod">
          <ac:chgData name="Chew Leng Lim" userId="f4956819b06a5395" providerId="LiveId" clId="{18C7B61E-2F46-44F3-B4F9-D9413F1F6D22}" dt="2020-03-03T09:56:34.605" v="299"/>
          <ac:spMkLst>
            <pc:docMk/>
            <pc:sldMk cId="1886770596" sldId="327"/>
            <ac:spMk id="43" creationId="{8AF1E8A2-250C-49DA-9114-C6286CFBA5A5}"/>
          </ac:spMkLst>
        </pc:spChg>
        <pc:spChg chg="del mod">
          <ac:chgData name="Chew Leng Lim" userId="f4956819b06a5395" providerId="LiveId" clId="{18C7B61E-2F46-44F3-B4F9-D9413F1F6D22}" dt="2020-03-03T09:56:34.605" v="299"/>
          <ac:spMkLst>
            <pc:docMk/>
            <pc:sldMk cId="1886770596" sldId="327"/>
            <ac:spMk id="44" creationId="{3648CA99-DE12-4090-BCA9-6E77C2E95E0F}"/>
          </ac:spMkLst>
        </pc:spChg>
        <pc:spChg chg="del mod">
          <ac:chgData name="Chew Leng Lim" userId="f4956819b06a5395" providerId="LiveId" clId="{18C7B61E-2F46-44F3-B4F9-D9413F1F6D22}" dt="2020-03-03T09:56:34.605" v="299"/>
          <ac:spMkLst>
            <pc:docMk/>
            <pc:sldMk cId="1886770596" sldId="327"/>
            <ac:spMk id="45" creationId="{F2DBE96F-AB9B-4654-B05E-6F175F023446}"/>
          </ac:spMkLst>
        </pc:spChg>
        <pc:spChg chg="del">
          <ac:chgData name="Chew Leng Lim" userId="f4956819b06a5395" providerId="LiveId" clId="{18C7B61E-2F46-44F3-B4F9-D9413F1F6D22}" dt="2020-03-03T09:50:57.503" v="23" actId="478"/>
          <ac:spMkLst>
            <pc:docMk/>
            <pc:sldMk cId="1886770596" sldId="327"/>
            <ac:spMk id="47" creationId="{8DC3F17B-77EA-4B03-8AC6-F8B18A793D4E}"/>
          </ac:spMkLst>
        </pc:spChg>
        <pc:spChg chg="del mod">
          <ac:chgData name="Chew Leng Lim" userId="f4956819b06a5395" providerId="LiveId" clId="{18C7B61E-2F46-44F3-B4F9-D9413F1F6D22}" dt="2020-03-03T09:56:34.605" v="299"/>
          <ac:spMkLst>
            <pc:docMk/>
            <pc:sldMk cId="1886770596" sldId="327"/>
            <ac:spMk id="48" creationId="{1EB9E689-7D86-4D90-B5F3-ED467ACB257F}"/>
          </ac:spMkLst>
        </pc:spChg>
        <pc:spChg chg="add del mod">
          <ac:chgData name="Chew Leng Lim" userId="f4956819b06a5395" providerId="LiveId" clId="{18C7B61E-2F46-44F3-B4F9-D9413F1F6D22}" dt="2020-03-03T09:56:34.605" v="299"/>
          <ac:spMkLst>
            <pc:docMk/>
            <pc:sldMk cId="1886770596" sldId="327"/>
            <ac:spMk id="50" creationId="{5F38DFA2-ABBA-42DC-8C5C-6916949BEFA7}"/>
          </ac:spMkLst>
        </pc:spChg>
        <pc:grpChg chg="del">
          <ac:chgData name="Chew Leng Lim" userId="f4956819b06a5395" providerId="LiveId" clId="{18C7B61E-2F46-44F3-B4F9-D9413F1F6D22}" dt="2020-03-03T09:49:31.099" v="4" actId="478"/>
          <ac:grpSpMkLst>
            <pc:docMk/>
            <pc:sldMk cId="1886770596" sldId="327"/>
            <ac:grpSpMk id="7" creationId="{CB804B3D-AB1B-4FCD-8E3B-4A98DCD7841F}"/>
          </ac:grpSpMkLst>
        </pc:grpChg>
        <pc:graphicFrameChg chg="del mod">
          <ac:chgData name="Chew Leng Lim" userId="f4956819b06a5395" providerId="LiveId" clId="{18C7B61E-2F46-44F3-B4F9-D9413F1F6D22}" dt="2020-03-03T09:56:34.605" v="299"/>
          <ac:graphicFrameMkLst>
            <pc:docMk/>
            <pc:sldMk cId="1886770596" sldId="327"/>
            <ac:graphicFrameMk id="32" creationId="{BEBA518E-19C1-4610-A2AA-0CB56FD67B65}"/>
          </ac:graphicFrameMkLst>
        </pc:graphicFrameChg>
        <pc:cxnChg chg="del mod">
          <ac:chgData name="Chew Leng Lim" userId="f4956819b06a5395" providerId="LiveId" clId="{18C7B61E-2F46-44F3-B4F9-D9413F1F6D22}" dt="2020-03-03T09:56:34.605" v="299"/>
          <ac:cxnSpMkLst>
            <pc:docMk/>
            <pc:sldMk cId="1886770596" sldId="327"/>
            <ac:cxnSpMk id="46" creationId="{01217045-0DD7-423D-B200-1B4BC0A864B3}"/>
          </ac:cxnSpMkLst>
        </pc:cxnChg>
        <pc:cxnChg chg="del mod">
          <ac:chgData name="Chew Leng Lim" userId="f4956819b06a5395" providerId="LiveId" clId="{18C7B61E-2F46-44F3-B4F9-D9413F1F6D22}" dt="2020-03-03T09:56:34.605" v="299"/>
          <ac:cxnSpMkLst>
            <pc:docMk/>
            <pc:sldMk cId="1886770596" sldId="327"/>
            <ac:cxnSpMk id="49" creationId="{7FBEE582-AC9D-4198-AC7B-64190E1C0C99}"/>
          </ac:cxnSpMkLst>
        </pc:cxnChg>
        <pc:cxnChg chg="del">
          <ac:chgData name="Chew Leng Lim" userId="f4956819b06a5395" providerId="LiveId" clId="{18C7B61E-2F46-44F3-B4F9-D9413F1F6D22}" dt="2020-03-03T09:50:58.332" v="24" actId="478"/>
          <ac:cxnSpMkLst>
            <pc:docMk/>
            <pc:sldMk cId="1886770596" sldId="327"/>
            <ac:cxnSpMk id="51" creationId="{4B82026D-6587-4585-8426-B75D1E090F90}"/>
          </ac:cxnSpMkLst>
        </pc:cxnChg>
        <pc:cxnChg chg="del">
          <ac:chgData name="Chew Leng Lim" userId="f4956819b06a5395" providerId="LiveId" clId="{18C7B61E-2F46-44F3-B4F9-D9413F1F6D22}" dt="2020-03-03T09:50:55.718" v="22" actId="478"/>
          <ac:cxnSpMkLst>
            <pc:docMk/>
            <pc:sldMk cId="1886770596" sldId="327"/>
            <ac:cxnSpMk id="55" creationId="{6E4F0EFF-8422-4F8A-AD6F-88C9AB1FEA5B}"/>
          </ac:cxnSpMkLst>
        </pc:cxnChg>
        <pc:cxnChg chg="del mod">
          <ac:chgData name="Chew Leng Lim" userId="f4956819b06a5395" providerId="LiveId" clId="{18C7B61E-2F46-44F3-B4F9-D9413F1F6D22}" dt="2020-03-03T09:56:34.605" v="299"/>
          <ac:cxnSpMkLst>
            <pc:docMk/>
            <pc:sldMk cId="1886770596" sldId="327"/>
            <ac:cxnSpMk id="56" creationId="{50FA7CBB-096C-4F10-A597-9589B5D28910}"/>
          </ac:cxnSpMkLst>
        </pc:cxnChg>
      </pc:sldChg>
      <pc:sldChg chg="modSp">
        <pc:chgData name="Chew Leng Lim" userId="f4956819b06a5395" providerId="LiveId" clId="{18C7B61E-2F46-44F3-B4F9-D9413F1F6D22}" dt="2020-03-03T10:06:55.990" v="368" actId="113"/>
        <pc:sldMkLst>
          <pc:docMk/>
          <pc:sldMk cId="1306267762" sldId="343"/>
        </pc:sldMkLst>
        <pc:spChg chg="mod">
          <ac:chgData name="Chew Leng Lim" userId="f4956819b06a5395" providerId="LiveId" clId="{18C7B61E-2F46-44F3-B4F9-D9413F1F6D22}" dt="2020-03-03T10:06:55.990" v="368" actId="113"/>
          <ac:spMkLst>
            <pc:docMk/>
            <pc:sldMk cId="1306267762" sldId="343"/>
            <ac:spMk id="2" creationId="{9006FD5F-E9F5-4916-8FD1-659895FDAA02}"/>
          </ac:spMkLst>
        </pc:spChg>
      </pc:sldChg>
      <pc:sldChg chg="del">
        <pc:chgData name="Chew Leng Lim" userId="f4956819b06a5395" providerId="LiveId" clId="{18C7B61E-2F46-44F3-B4F9-D9413F1F6D22}" dt="2020-03-03T10:07:19.339" v="370" actId="2696"/>
        <pc:sldMkLst>
          <pc:docMk/>
          <pc:sldMk cId="1084153008" sldId="360"/>
        </pc:sldMkLst>
      </pc:sldChg>
      <pc:sldChg chg="modSp">
        <pc:chgData name="Chew Leng Lim" userId="f4956819b06a5395" providerId="LiveId" clId="{18C7B61E-2F46-44F3-B4F9-D9413F1F6D22}" dt="2020-03-12T07:21:53" v="4693" actId="1035"/>
        <pc:sldMkLst>
          <pc:docMk/>
          <pc:sldMk cId="835735679" sldId="362"/>
        </pc:sldMkLst>
        <pc:spChg chg="mod">
          <ac:chgData name="Chew Leng Lim" userId="f4956819b06a5395" providerId="LiveId" clId="{18C7B61E-2F46-44F3-B4F9-D9413F1F6D22}" dt="2020-03-12T07:17:24.449" v="3629" actId="1035"/>
          <ac:spMkLst>
            <pc:docMk/>
            <pc:sldMk cId="835735679" sldId="362"/>
            <ac:spMk id="29" creationId="{80B474F0-7053-43B6-BEEC-E0BE03CABCD7}"/>
          </ac:spMkLst>
        </pc:spChg>
        <pc:spChg chg="mod">
          <ac:chgData name="Chew Leng Lim" userId="f4956819b06a5395" providerId="LiveId" clId="{18C7B61E-2F46-44F3-B4F9-D9413F1F6D22}" dt="2020-03-12T07:17:24.449" v="3629" actId="1035"/>
          <ac:spMkLst>
            <pc:docMk/>
            <pc:sldMk cId="835735679" sldId="362"/>
            <ac:spMk id="48" creationId="{CA838B5B-0C44-4B99-8A99-450611C3E23A}"/>
          </ac:spMkLst>
        </pc:spChg>
        <pc:spChg chg="mod">
          <ac:chgData name="Chew Leng Lim" userId="f4956819b06a5395" providerId="LiveId" clId="{18C7B61E-2F46-44F3-B4F9-D9413F1F6D22}" dt="2020-03-12T07:17:24.449" v="3629" actId="1035"/>
          <ac:spMkLst>
            <pc:docMk/>
            <pc:sldMk cId="835735679" sldId="362"/>
            <ac:spMk id="49" creationId="{9E722F8C-9D6C-438D-9D36-7D1F1FABFF77}"/>
          </ac:spMkLst>
        </pc:spChg>
        <pc:spChg chg="mod">
          <ac:chgData name="Chew Leng Lim" userId="f4956819b06a5395" providerId="LiveId" clId="{18C7B61E-2F46-44F3-B4F9-D9413F1F6D22}" dt="2020-03-12T07:17:24.449" v="3629" actId="1035"/>
          <ac:spMkLst>
            <pc:docMk/>
            <pc:sldMk cId="835735679" sldId="362"/>
            <ac:spMk id="50" creationId="{7C993F45-2A85-4B38-8A21-307F70B09AB7}"/>
          </ac:spMkLst>
        </pc:spChg>
        <pc:spChg chg="mod">
          <ac:chgData name="Chew Leng Lim" userId="f4956819b06a5395" providerId="LiveId" clId="{18C7B61E-2F46-44F3-B4F9-D9413F1F6D22}" dt="2020-03-12T07:17:24.449" v="3629" actId="1035"/>
          <ac:spMkLst>
            <pc:docMk/>
            <pc:sldMk cId="835735679" sldId="362"/>
            <ac:spMk id="51" creationId="{4F9EE00E-64BA-4E1D-9E00-431223F78525}"/>
          </ac:spMkLst>
        </pc:spChg>
        <pc:spChg chg="mod">
          <ac:chgData name="Chew Leng Lim" userId="f4956819b06a5395" providerId="LiveId" clId="{18C7B61E-2F46-44F3-B4F9-D9413F1F6D22}" dt="2020-03-12T07:17:24.449" v="3629" actId="1035"/>
          <ac:spMkLst>
            <pc:docMk/>
            <pc:sldMk cId="835735679" sldId="362"/>
            <ac:spMk id="52" creationId="{4DCB0E8E-337F-479C-88BD-33937B9ECE20}"/>
          </ac:spMkLst>
        </pc:spChg>
        <pc:spChg chg="mod">
          <ac:chgData name="Chew Leng Lim" userId="f4956819b06a5395" providerId="LiveId" clId="{18C7B61E-2F46-44F3-B4F9-D9413F1F6D22}" dt="2020-03-12T07:18:44.191" v="3964" actId="1036"/>
          <ac:spMkLst>
            <pc:docMk/>
            <pc:sldMk cId="835735679" sldId="362"/>
            <ac:spMk id="53" creationId="{47C58E3A-F3A6-4DA2-BA75-B4FBE68DEEFC}"/>
          </ac:spMkLst>
        </pc:spChg>
        <pc:spChg chg="mod">
          <ac:chgData name="Chew Leng Lim" userId="f4956819b06a5395" providerId="LiveId" clId="{18C7B61E-2F46-44F3-B4F9-D9413F1F6D22}" dt="2020-03-12T07:17:24.449" v="3629" actId="1035"/>
          <ac:spMkLst>
            <pc:docMk/>
            <pc:sldMk cId="835735679" sldId="362"/>
            <ac:spMk id="54" creationId="{CE0AD4D1-4958-4B94-A24C-8FF7E0A0A778}"/>
          </ac:spMkLst>
        </pc:spChg>
        <pc:spChg chg="mod">
          <ac:chgData name="Chew Leng Lim" userId="f4956819b06a5395" providerId="LiveId" clId="{18C7B61E-2F46-44F3-B4F9-D9413F1F6D22}" dt="2020-03-12T07:18:58.203" v="4077" actId="1038"/>
          <ac:spMkLst>
            <pc:docMk/>
            <pc:sldMk cId="835735679" sldId="362"/>
            <ac:spMk id="56" creationId="{0E3D82E6-E9FD-478F-89C7-6556227C6924}"/>
          </ac:spMkLst>
        </pc:spChg>
        <pc:spChg chg="mod">
          <ac:chgData name="Chew Leng Lim" userId="f4956819b06a5395" providerId="LiveId" clId="{18C7B61E-2F46-44F3-B4F9-D9413F1F6D22}" dt="2020-03-12T07:18:58.203" v="4077" actId="1038"/>
          <ac:spMkLst>
            <pc:docMk/>
            <pc:sldMk cId="835735679" sldId="362"/>
            <ac:spMk id="57" creationId="{91C45102-82F8-4545-BD90-6F3871037F37}"/>
          </ac:spMkLst>
        </pc:spChg>
        <pc:spChg chg="mod">
          <ac:chgData name="Chew Leng Lim" userId="f4956819b06a5395" providerId="LiveId" clId="{18C7B61E-2F46-44F3-B4F9-D9413F1F6D22}" dt="2020-03-12T07:18:58.203" v="4077" actId="1038"/>
          <ac:spMkLst>
            <pc:docMk/>
            <pc:sldMk cId="835735679" sldId="362"/>
            <ac:spMk id="59" creationId="{F2255AB6-331E-460D-BDE9-318864B831EB}"/>
          </ac:spMkLst>
        </pc:spChg>
        <pc:spChg chg="mod">
          <ac:chgData name="Chew Leng Lim" userId="f4956819b06a5395" providerId="LiveId" clId="{18C7B61E-2F46-44F3-B4F9-D9413F1F6D22}" dt="2020-03-12T07:18:58.203" v="4077" actId="1038"/>
          <ac:spMkLst>
            <pc:docMk/>
            <pc:sldMk cId="835735679" sldId="362"/>
            <ac:spMk id="60" creationId="{EB4759B2-DA79-4023-B080-E39BE93898C6}"/>
          </ac:spMkLst>
        </pc:spChg>
        <pc:spChg chg="mod">
          <ac:chgData name="Chew Leng Lim" userId="f4956819b06a5395" providerId="LiveId" clId="{18C7B61E-2F46-44F3-B4F9-D9413F1F6D22}" dt="2020-03-12T07:18:58.203" v="4077" actId="1038"/>
          <ac:spMkLst>
            <pc:docMk/>
            <pc:sldMk cId="835735679" sldId="362"/>
            <ac:spMk id="62" creationId="{DB4783F4-1D8E-4D58-95F4-68B589B3B128}"/>
          </ac:spMkLst>
        </pc:spChg>
        <pc:spChg chg="mod">
          <ac:chgData name="Chew Leng Lim" userId="f4956819b06a5395" providerId="LiveId" clId="{18C7B61E-2F46-44F3-B4F9-D9413F1F6D22}" dt="2020-03-12T07:21:53" v="4693" actId="1035"/>
          <ac:spMkLst>
            <pc:docMk/>
            <pc:sldMk cId="835735679" sldId="362"/>
            <ac:spMk id="72" creationId="{FCFEED18-EDDD-4227-A8BF-F19FAF70AE7A}"/>
          </ac:spMkLst>
        </pc:spChg>
        <pc:spChg chg="mod">
          <ac:chgData name="Chew Leng Lim" userId="f4956819b06a5395" providerId="LiveId" clId="{18C7B61E-2F46-44F3-B4F9-D9413F1F6D22}" dt="2020-03-12T07:21:53" v="4693" actId="1035"/>
          <ac:spMkLst>
            <pc:docMk/>
            <pc:sldMk cId="835735679" sldId="362"/>
            <ac:spMk id="73" creationId="{5A0C0184-199D-42CA-9C11-64C56A75D59A}"/>
          </ac:spMkLst>
        </pc:spChg>
        <pc:spChg chg="mod">
          <ac:chgData name="Chew Leng Lim" userId="f4956819b06a5395" providerId="LiveId" clId="{18C7B61E-2F46-44F3-B4F9-D9413F1F6D22}" dt="2020-03-12T07:21:53" v="4693" actId="1035"/>
          <ac:spMkLst>
            <pc:docMk/>
            <pc:sldMk cId="835735679" sldId="362"/>
            <ac:spMk id="74" creationId="{50660BC9-D514-43E8-8B33-A9582B7045D4}"/>
          </ac:spMkLst>
        </pc:spChg>
        <pc:spChg chg="mod">
          <ac:chgData name="Chew Leng Lim" userId="f4956819b06a5395" providerId="LiveId" clId="{18C7B61E-2F46-44F3-B4F9-D9413F1F6D22}" dt="2020-03-12T07:21:53" v="4693" actId="1035"/>
          <ac:spMkLst>
            <pc:docMk/>
            <pc:sldMk cId="835735679" sldId="362"/>
            <ac:spMk id="75" creationId="{45D33B87-B245-494B-AC8E-6110D422AAD0}"/>
          </ac:spMkLst>
        </pc:spChg>
        <pc:spChg chg="mod">
          <ac:chgData name="Chew Leng Lim" userId="f4956819b06a5395" providerId="LiveId" clId="{18C7B61E-2F46-44F3-B4F9-D9413F1F6D22}" dt="2020-03-12T07:21:53" v="4693" actId="1035"/>
          <ac:spMkLst>
            <pc:docMk/>
            <pc:sldMk cId="835735679" sldId="362"/>
            <ac:spMk id="76" creationId="{EFAE1FB3-DA63-4A77-8809-8F387B1620E8}"/>
          </ac:spMkLst>
        </pc:spChg>
        <pc:spChg chg="mod">
          <ac:chgData name="Chew Leng Lim" userId="f4956819b06a5395" providerId="LiveId" clId="{18C7B61E-2F46-44F3-B4F9-D9413F1F6D22}" dt="2020-03-12T07:21:53" v="4693" actId="1035"/>
          <ac:spMkLst>
            <pc:docMk/>
            <pc:sldMk cId="835735679" sldId="362"/>
            <ac:spMk id="94" creationId="{F41F0F44-AE5B-4099-ACFC-D1A03E658D5B}"/>
          </ac:spMkLst>
        </pc:spChg>
        <pc:spChg chg="mod">
          <ac:chgData name="Chew Leng Lim" userId="f4956819b06a5395" providerId="LiveId" clId="{18C7B61E-2F46-44F3-B4F9-D9413F1F6D22}" dt="2020-03-12T07:21:53" v="4693" actId="1035"/>
          <ac:spMkLst>
            <pc:docMk/>
            <pc:sldMk cId="835735679" sldId="362"/>
            <ac:spMk id="95" creationId="{72E29307-07F0-4A7B-8EE4-8CD7981196E3}"/>
          </ac:spMkLst>
        </pc:spChg>
        <pc:spChg chg="mod">
          <ac:chgData name="Chew Leng Lim" userId="f4956819b06a5395" providerId="LiveId" clId="{18C7B61E-2F46-44F3-B4F9-D9413F1F6D22}" dt="2020-03-12T07:21:53" v="4693" actId="1035"/>
          <ac:spMkLst>
            <pc:docMk/>
            <pc:sldMk cId="835735679" sldId="362"/>
            <ac:spMk id="96" creationId="{6061268A-5FE9-4677-9BAF-BD0AE4FF83C5}"/>
          </ac:spMkLst>
        </pc:spChg>
        <pc:spChg chg="mod">
          <ac:chgData name="Chew Leng Lim" userId="f4956819b06a5395" providerId="LiveId" clId="{18C7B61E-2F46-44F3-B4F9-D9413F1F6D22}" dt="2020-03-12T07:21:53" v="4693" actId="1035"/>
          <ac:spMkLst>
            <pc:docMk/>
            <pc:sldMk cId="835735679" sldId="362"/>
            <ac:spMk id="97" creationId="{DA4774DD-C1D2-4E3B-A557-8233BCCF36DE}"/>
          </ac:spMkLst>
        </pc:spChg>
        <pc:spChg chg="mod">
          <ac:chgData name="Chew Leng Lim" userId="f4956819b06a5395" providerId="LiveId" clId="{18C7B61E-2F46-44F3-B4F9-D9413F1F6D22}" dt="2020-03-12T07:21:53" v="4693" actId="1035"/>
          <ac:spMkLst>
            <pc:docMk/>
            <pc:sldMk cId="835735679" sldId="362"/>
            <ac:spMk id="98" creationId="{8BED6139-9446-499E-941F-86B0168A866A}"/>
          </ac:spMkLst>
        </pc:spChg>
        <pc:spChg chg="mod">
          <ac:chgData name="Chew Leng Lim" userId="f4956819b06a5395" providerId="LiveId" clId="{18C7B61E-2F46-44F3-B4F9-D9413F1F6D22}" dt="2020-03-12T07:21:53" v="4693" actId="1035"/>
          <ac:spMkLst>
            <pc:docMk/>
            <pc:sldMk cId="835735679" sldId="362"/>
            <ac:spMk id="99" creationId="{53B4215A-F5C8-469B-AC3E-ABB06FD4F675}"/>
          </ac:spMkLst>
        </pc:spChg>
        <pc:spChg chg="mod">
          <ac:chgData name="Chew Leng Lim" userId="f4956819b06a5395" providerId="LiveId" clId="{18C7B61E-2F46-44F3-B4F9-D9413F1F6D22}" dt="2020-03-12T07:21:53" v="4693" actId="1035"/>
          <ac:spMkLst>
            <pc:docMk/>
            <pc:sldMk cId="835735679" sldId="362"/>
            <ac:spMk id="104" creationId="{BED65025-9C0F-4697-A02D-E514F14FE334}"/>
          </ac:spMkLst>
        </pc:spChg>
        <pc:spChg chg="mod">
          <ac:chgData name="Chew Leng Lim" userId="f4956819b06a5395" providerId="LiveId" clId="{18C7B61E-2F46-44F3-B4F9-D9413F1F6D22}" dt="2020-03-12T07:18:58.203" v="4077" actId="1038"/>
          <ac:spMkLst>
            <pc:docMk/>
            <pc:sldMk cId="835735679" sldId="362"/>
            <ac:spMk id="105" creationId="{84BB76F6-7488-4B1B-8398-4F17944D3F4E}"/>
          </ac:spMkLst>
        </pc:spChg>
        <pc:spChg chg="mod">
          <ac:chgData name="Chew Leng Lim" userId="f4956819b06a5395" providerId="LiveId" clId="{18C7B61E-2F46-44F3-B4F9-D9413F1F6D22}" dt="2020-03-12T07:21:53" v="4693" actId="1035"/>
          <ac:spMkLst>
            <pc:docMk/>
            <pc:sldMk cId="835735679" sldId="362"/>
            <ac:spMk id="106" creationId="{AAED3BF0-D8B5-4DC1-80D6-A3CD24F2F981}"/>
          </ac:spMkLst>
        </pc:spChg>
        <pc:spChg chg="mod">
          <ac:chgData name="Chew Leng Lim" userId="f4956819b06a5395" providerId="LiveId" clId="{18C7B61E-2F46-44F3-B4F9-D9413F1F6D22}" dt="2020-03-12T06:37:13.143" v="1851" actId="6549"/>
          <ac:spMkLst>
            <pc:docMk/>
            <pc:sldMk cId="835735679" sldId="362"/>
            <ac:spMk id="109" creationId="{4732DCA8-8D21-4776-B008-1FC55926C591}"/>
          </ac:spMkLst>
        </pc:spChg>
        <pc:spChg chg="mod">
          <ac:chgData name="Chew Leng Lim" userId="f4956819b06a5395" providerId="LiveId" clId="{18C7B61E-2F46-44F3-B4F9-D9413F1F6D22}" dt="2020-03-12T07:21:53" v="4693" actId="1035"/>
          <ac:spMkLst>
            <pc:docMk/>
            <pc:sldMk cId="835735679" sldId="362"/>
            <ac:spMk id="126" creationId="{57C803E6-3859-42AD-AD41-457AD89C0E50}"/>
          </ac:spMkLst>
        </pc:spChg>
        <pc:spChg chg="mod">
          <ac:chgData name="Chew Leng Lim" userId="f4956819b06a5395" providerId="LiveId" clId="{18C7B61E-2F46-44F3-B4F9-D9413F1F6D22}" dt="2020-03-12T07:21:53" v="4693" actId="1035"/>
          <ac:spMkLst>
            <pc:docMk/>
            <pc:sldMk cId="835735679" sldId="362"/>
            <ac:spMk id="127" creationId="{6D7C4176-02EB-46C9-9468-FBFA3D43A755}"/>
          </ac:spMkLst>
        </pc:spChg>
        <pc:spChg chg="mod">
          <ac:chgData name="Chew Leng Lim" userId="f4956819b06a5395" providerId="LiveId" clId="{18C7B61E-2F46-44F3-B4F9-D9413F1F6D22}" dt="2020-03-12T07:21:53" v="4693" actId="1035"/>
          <ac:spMkLst>
            <pc:docMk/>
            <pc:sldMk cId="835735679" sldId="362"/>
            <ac:spMk id="128" creationId="{C199D322-DCAA-44BC-96A9-5F9B1446A192}"/>
          </ac:spMkLst>
        </pc:spChg>
        <pc:spChg chg="mod">
          <ac:chgData name="Chew Leng Lim" userId="f4956819b06a5395" providerId="LiveId" clId="{18C7B61E-2F46-44F3-B4F9-D9413F1F6D22}" dt="2020-03-12T07:21:53" v="4693" actId="1035"/>
          <ac:spMkLst>
            <pc:docMk/>
            <pc:sldMk cId="835735679" sldId="362"/>
            <ac:spMk id="129" creationId="{A5CA9725-FE8B-429D-81D7-27C757107A99}"/>
          </ac:spMkLst>
        </pc:spChg>
        <pc:spChg chg="mod">
          <ac:chgData name="Chew Leng Lim" userId="f4956819b06a5395" providerId="LiveId" clId="{18C7B61E-2F46-44F3-B4F9-D9413F1F6D22}" dt="2020-03-12T07:21:53" v="4693" actId="1035"/>
          <ac:spMkLst>
            <pc:docMk/>
            <pc:sldMk cId="835735679" sldId="362"/>
            <ac:spMk id="130" creationId="{84681A5F-CB82-41C5-A162-0B0396301698}"/>
          </ac:spMkLst>
        </pc:spChg>
        <pc:spChg chg="mod">
          <ac:chgData name="Chew Leng Lim" userId="f4956819b06a5395" providerId="LiveId" clId="{18C7B61E-2F46-44F3-B4F9-D9413F1F6D22}" dt="2020-03-12T07:21:53" v="4693" actId="1035"/>
          <ac:spMkLst>
            <pc:docMk/>
            <pc:sldMk cId="835735679" sldId="362"/>
            <ac:spMk id="131" creationId="{44114566-6EDE-4B6C-9330-78971C8DB84A}"/>
          </ac:spMkLst>
        </pc:spChg>
        <pc:spChg chg="mod">
          <ac:chgData name="Chew Leng Lim" userId="f4956819b06a5395" providerId="LiveId" clId="{18C7B61E-2F46-44F3-B4F9-D9413F1F6D22}" dt="2020-03-12T07:21:53" v="4693" actId="1035"/>
          <ac:spMkLst>
            <pc:docMk/>
            <pc:sldMk cId="835735679" sldId="362"/>
            <ac:spMk id="132" creationId="{4DC00B12-906C-482B-8252-BC087618A830}"/>
          </ac:spMkLst>
        </pc:spChg>
        <pc:spChg chg="mod">
          <ac:chgData name="Chew Leng Lim" userId="f4956819b06a5395" providerId="LiveId" clId="{18C7B61E-2F46-44F3-B4F9-D9413F1F6D22}" dt="2020-03-12T07:21:53" v="4693" actId="1035"/>
          <ac:spMkLst>
            <pc:docMk/>
            <pc:sldMk cId="835735679" sldId="362"/>
            <ac:spMk id="133" creationId="{4361BD0E-5CC3-4379-A90C-5F770BCDFA9B}"/>
          </ac:spMkLst>
        </pc:spChg>
        <pc:spChg chg="mod">
          <ac:chgData name="Chew Leng Lim" userId="f4956819b06a5395" providerId="LiveId" clId="{18C7B61E-2F46-44F3-B4F9-D9413F1F6D22}" dt="2020-03-03T10:06:38.604" v="365" actId="113"/>
          <ac:spMkLst>
            <pc:docMk/>
            <pc:sldMk cId="835735679" sldId="362"/>
            <ac:spMk id="151" creationId="{25A1AB35-BF14-4722-8AD9-BA0B4BD22EB0}"/>
          </ac:spMkLst>
        </pc:spChg>
        <pc:graphicFrameChg chg="mod">
          <ac:chgData name="Chew Leng Lim" userId="f4956819b06a5395" providerId="LiveId" clId="{18C7B61E-2F46-44F3-B4F9-D9413F1F6D22}" dt="2020-03-12T07:18:44.191" v="3964" actId="1036"/>
          <ac:graphicFrameMkLst>
            <pc:docMk/>
            <pc:sldMk cId="835735679" sldId="362"/>
            <ac:graphicFrameMk id="3" creationId="{6F8B8A1E-B820-47CA-8D30-AAAB5FF8645E}"/>
          </ac:graphicFrameMkLst>
        </pc:graphicFrameChg>
        <pc:graphicFrameChg chg="mod">
          <ac:chgData name="Chew Leng Lim" userId="f4956819b06a5395" providerId="LiveId" clId="{18C7B61E-2F46-44F3-B4F9-D9413F1F6D22}" dt="2020-03-12T07:18:58.203" v="4077" actId="1038"/>
          <ac:graphicFrameMkLst>
            <pc:docMk/>
            <pc:sldMk cId="835735679" sldId="362"/>
            <ac:graphicFrameMk id="4" creationId="{563EC79B-9AC0-49DC-9447-7C68610E8D0F}"/>
          </ac:graphicFrameMkLst>
        </pc:graphicFrameChg>
        <pc:graphicFrameChg chg="mod">
          <ac:chgData name="Chew Leng Lim" userId="f4956819b06a5395" providerId="LiveId" clId="{18C7B61E-2F46-44F3-B4F9-D9413F1F6D22}" dt="2020-03-12T07:21:53" v="4693" actId="1035"/>
          <ac:graphicFrameMkLst>
            <pc:docMk/>
            <pc:sldMk cId="835735679" sldId="362"/>
            <ac:graphicFrameMk id="6" creationId="{6014448D-0B98-4534-929C-E4E8AB99E2B7}"/>
          </ac:graphicFrameMkLst>
        </pc:graphicFrameChg>
        <pc:graphicFrameChg chg="mod">
          <ac:chgData name="Chew Leng Lim" userId="f4956819b06a5395" providerId="LiveId" clId="{18C7B61E-2F46-44F3-B4F9-D9413F1F6D22}" dt="2020-03-12T07:21:53" v="4693" actId="1035"/>
          <ac:graphicFrameMkLst>
            <pc:docMk/>
            <pc:sldMk cId="835735679" sldId="362"/>
            <ac:graphicFrameMk id="9" creationId="{53803493-0463-4DB9-BB49-2A61F67C7666}"/>
          </ac:graphicFrameMkLst>
        </pc:graphicFrameChg>
        <pc:graphicFrameChg chg="mod">
          <ac:chgData name="Chew Leng Lim" userId="f4956819b06a5395" providerId="LiveId" clId="{18C7B61E-2F46-44F3-B4F9-D9413F1F6D22}" dt="2020-03-12T07:21:53" v="4693" actId="1035"/>
          <ac:graphicFrameMkLst>
            <pc:docMk/>
            <pc:sldMk cId="835735679" sldId="362"/>
            <ac:graphicFrameMk id="125" creationId="{429450BC-E6FA-4849-8420-37A9105A7399}"/>
          </ac:graphicFrameMkLst>
        </pc:graphicFrameChg>
      </pc:sldChg>
      <pc:sldChg chg="add del">
        <pc:chgData name="Chew Leng Lim" userId="f4956819b06a5395" providerId="LiveId" clId="{18C7B61E-2F46-44F3-B4F9-D9413F1F6D22}" dt="2020-03-03T10:06:10.118" v="361" actId="2696"/>
        <pc:sldMkLst>
          <pc:docMk/>
          <pc:sldMk cId="57734692" sldId="363"/>
        </pc:sldMkLst>
      </pc:sldChg>
      <pc:sldChg chg="modSp add ord">
        <pc:chgData name="Chew Leng Lim" userId="f4956819b06a5395" providerId="LiveId" clId="{18C7B61E-2F46-44F3-B4F9-D9413F1F6D22}" dt="2020-03-12T07:39:35.621" v="6973" actId="6549"/>
        <pc:sldMkLst>
          <pc:docMk/>
          <pc:sldMk cId="3170069621" sldId="364"/>
        </pc:sldMkLst>
        <pc:spChg chg="mod">
          <ac:chgData name="Chew Leng Lim" userId="f4956819b06a5395" providerId="LiveId" clId="{18C7B61E-2F46-44F3-B4F9-D9413F1F6D22}" dt="2020-03-03T10:05:54.777" v="360" actId="1076"/>
          <ac:spMkLst>
            <pc:docMk/>
            <pc:sldMk cId="3170069621" sldId="364"/>
            <ac:spMk id="56" creationId="{64C060FB-CAF9-4F7D-9505-A6240E94336C}"/>
          </ac:spMkLst>
        </pc:spChg>
        <pc:spChg chg="mod">
          <ac:chgData name="Chew Leng Lim" userId="f4956819b06a5395" providerId="LiveId" clId="{18C7B61E-2F46-44F3-B4F9-D9413F1F6D22}" dt="2020-03-12T07:38:04.817" v="6873" actId="6549"/>
          <ac:spMkLst>
            <pc:docMk/>
            <pc:sldMk cId="3170069621" sldId="364"/>
            <ac:spMk id="81" creationId="{05BF436C-FFEE-40A9-9879-301B7802CE5D}"/>
          </ac:spMkLst>
        </pc:spChg>
        <pc:spChg chg="mod">
          <ac:chgData name="Chew Leng Lim" userId="f4956819b06a5395" providerId="LiveId" clId="{18C7B61E-2F46-44F3-B4F9-D9413F1F6D22}" dt="2020-03-12T07:39:01.039" v="6917" actId="6549"/>
          <ac:spMkLst>
            <pc:docMk/>
            <pc:sldMk cId="3170069621" sldId="364"/>
            <ac:spMk id="117" creationId="{CC828BE9-FAF4-45D2-B912-B7C3A46B3652}"/>
          </ac:spMkLst>
        </pc:spChg>
        <pc:spChg chg="mod">
          <ac:chgData name="Chew Leng Lim" userId="f4956819b06a5395" providerId="LiveId" clId="{18C7B61E-2F46-44F3-B4F9-D9413F1F6D22}" dt="2020-03-12T07:38:58.127" v="6911" actId="6549"/>
          <ac:spMkLst>
            <pc:docMk/>
            <pc:sldMk cId="3170069621" sldId="364"/>
            <ac:spMk id="120" creationId="{3D6F10CC-8C3A-4686-9C97-4FFF097757A5}"/>
          </ac:spMkLst>
        </pc:spChg>
        <pc:spChg chg="mod">
          <ac:chgData name="Chew Leng Lim" userId="f4956819b06a5395" providerId="LiveId" clId="{18C7B61E-2F46-44F3-B4F9-D9413F1F6D22}" dt="2020-03-12T07:39:04.568" v="6923" actId="6549"/>
          <ac:spMkLst>
            <pc:docMk/>
            <pc:sldMk cId="3170069621" sldId="364"/>
            <ac:spMk id="123" creationId="{E7EE2B5B-589A-4FDA-A432-640FBFFE7203}"/>
          </ac:spMkLst>
        </pc:spChg>
        <pc:spChg chg="mod">
          <ac:chgData name="Chew Leng Lim" userId="f4956819b06a5395" providerId="LiveId" clId="{18C7B61E-2F46-44F3-B4F9-D9413F1F6D22}" dt="2020-03-12T07:38:54.870" v="6905" actId="6549"/>
          <ac:spMkLst>
            <pc:docMk/>
            <pc:sldMk cId="3170069621" sldId="364"/>
            <ac:spMk id="124" creationId="{6539115E-152F-4214-9251-60A33465A958}"/>
          </ac:spMkLst>
        </pc:spChg>
        <pc:spChg chg="mod">
          <ac:chgData name="Chew Leng Lim" userId="f4956819b06a5395" providerId="LiveId" clId="{18C7B61E-2F46-44F3-B4F9-D9413F1F6D22}" dt="2020-03-12T07:38:21.098" v="6897" actId="6549"/>
          <ac:spMkLst>
            <pc:docMk/>
            <pc:sldMk cId="3170069621" sldId="364"/>
            <ac:spMk id="136" creationId="{EC074743-2914-4992-A941-2F1BA626D848}"/>
          </ac:spMkLst>
        </pc:spChg>
        <pc:spChg chg="mod">
          <ac:chgData name="Chew Leng Lim" userId="f4956819b06a5395" providerId="LiveId" clId="{18C7B61E-2F46-44F3-B4F9-D9413F1F6D22}" dt="2020-03-12T07:38:13.867" v="6885" actId="6549"/>
          <ac:spMkLst>
            <pc:docMk/>
            <pc:sldMk cId="3170069621" sldId="364"/>
            <ac:spMk id="138" creationId="{077D57F7-325C-4B28-A082-87810B9BDEA5}"/>
          </ac:spMkLst>
        </pc:spChg>
        <pc:spChg chg="mod">
          <ac:chgData name="Chew Leng Lim" userId="f4956819b06a5395" providerId="LiveId" clId="{18C7B61E-2F46-44F3-B4F9-D9413F1F6D22}" dt="2020-03-12T07:38:17.167" v="6891" actId="6549"/>
          <ac:spMkLst>
            <pc:docMk/>
            <pc:sldMk cId="3170069621" sldId="364"/>
            <ac:spMk id="142" creationId="{551DA58D-A36C-4A0C-B930-CFFEB558F6D0}"/>
          </ac:spMkLst>
        </pc:spChg>
        <pc:spChg chg="mod">
          <ac:chgData name="Chew Leng Lim" userId="f4956819b06a5395" providerId="LiveId" clId="{18C7B61E-2F46-44F3-B4F9-D9413F1F6D22}" dt="2020-03-12T07:38:09.738" v="6879" actId="6549"/>
          <ac:spMkLst>
            <pc:docMk/>
            <pc:sldMk cId="3170069621" sldId="364"/>
            <ac:spMk id="152" creationId="{49D6FB6F-A982-4F92-BE44-957435B8EB41}"/>
          </ac:spMkLst>
        </pc:spChg>
        <pc:spChg chg="mod">
          <ac:chgData name="Chew Leng Lim" userId="f4956819b06a5395" providerId="LiveId" clId="{18C7B61E-2F46-44F3-B4F9-D9413F1F6D22}" dt="2020-03-12T07:39:16.902" v="6947" actId="6549"/>
          <ac:spMkLst>
            <pc:docMk/>
            <pc:sldMk cId="3170069621" sldId="364"/>
            <ac:spMk id="169" creationId="{08257E8E-FA50-4ACF-BF4C-96BE939A05C4}"/>
          </ac:spMkLst>
        </pc:spChg>
        <pc:spChg chg="mod">
          <ac:chgData name="Chew Leng Lim" userId="f4956819b06a5395" providerId="LiveId" clId="{18C7B61E-2F46-44F3-B4F9-D9413F1F6D22}" dt="2020-03-12T07:39:10.827" v="6935" actId="6549"/>
          <ac:spMkLst>
            <pc:docMk/>
            <pc:sldMk cId="3170069621" sldId="364"/>
            <ac:spMk id="173" creationId="{943584EA-499C-43A2-9B6E-012A65FD769C}"/>
          </ac:spMkLst>
        </pc:spChg>
        <pc:spChg chg="mod">
          <ac:chgData name="Chew Leng Lim" userId="f4956819b06a5395" providerId="LiveId" clId="{18C7B61E-2F46-44F3-B4F9-D9413F1F6D22}" dt="2020-03-12T07:39:13.815" v="6941" actId="6549"/>
          <ac:spMkLst>
            <pc:docMk/>
            <pc:sldMk cId="3170069621" sldId="364"/>
            <ac:spMk id="175" creationId="{AF64334C-A116-405E-B7D9-7B3BD798198F}"/>
          </ac:spMkLst>
        </pc:spChg>
        <pc:spChg chg="mod">
          <ac:chgData name="Chew Leng Lim" userId="f4956819b06a5395" providerId="LiveId" clId="{18C7B61E-2F46-44F3-B4F9-D9413F1F6D22}" dt="2020-03-12T07:39:07.725" v="6929" actId="6549"/>
          <ac:spMkLst>
            <pc:docMk/>
            <pc:sldMk cId="3170069621" sldId="364"/>
            <ac:spMk id="176" creationId="{8FA410D4-1F28-438D-9FAE-AD52EF8EABF6}"/>
          </ac:spMkLst>
        </pc:spChg>
        <pc:spChg chg="mod">
          <ac:chgData name="Chew Leng Lim" userId="f4956819b06a5395" providerId="LiveId" clId="{18C7B61E-2F46-44F3-B4F9-D9413F1F6D22}" dt="2020-03-12T07:39:35.621" v="6973" actId="6549"/>
          <ac:spMkLst>
            <pc:docMk/>
            <pc:sldMk cId="3170069621" sldId="364"/>
            <ac:spMk id="194" creationId="{E54F6718-7BAD-4C35-8BC9-099745D43FD9}"/>
          </ac:spMkLst>
        </pc:spChg>
        <pc:spChg chg="mod">
          <ac:chgData name="Chew Leng Lim" userId="f4956819b06a5395" providerId="LiveId" clId="{18C7B61E-2F46-44F3-B4F9-D9413F1F6D22}" dt="2020-03-12T07:39:22.895" v="6959" actId="6549"/>
          <ac:spMkLst>
            <pc:docMk/>
            <pc:sldMk cId="3170069621" sldId="364"/>
            <ac:spMk id="196" creationId="{A971748D-6DC8-441B-B3A4-4EC5E2513F05}"/>
          </ac:spMkLst>
        </pc:spChg>
        <pc:spChg chg="mod">
          <ac:chgData name="Chew Leng Lim" userId="f4956819b06a5395" providerId="LiveId" clId="{18C7B61E-2F46-44F3-B4F9-D9413F1F6D22}" dt="2020-03-12T07:39:32.408" v="6967" actId="20577"/>
          <ac:spMkLst>
            <pc:docMk/>
            <pc:sldMk cId="3170069621" sldId="364"/>
            <ac:spMk id="198" creationId="{0F0803D5-C42A-4847-8BAC-103C46F232D8}"/>
          </ac:spMkLst>
        </pc:spChg>
        <pc:spChg chg="mod">
          <ac:chgData name="Chew Leng Lim" userId="f4956819b06a5395" providerId="LiveId" clId="{18C7B61E-2F46-44F3-B4F9-D9413F1F6D22}" dt="2020-03-12T07:39:20.051" v="6953" actId="6549"/>
          <ac:spMkLst>
            <pc:docMk/>
            <pc:sldMk cId="3170069621" sldId="364"/>
            <ac:spMk id="199" creationId="{BF69A443-C15A-43E2-BA6E-BB6C14C165E5}"/>
          </ac:spMkLst>
        </pc:spChg>
        <pc:grpChg chg="mod">
          <ac:chgData name="Chew Leng Lim" userId="f4956819b06a5395" providerId="LiveId" clId="{18C7B61E-2F46-44F3-B4F9-D9413F1F6D22}" dt="2020-03-12T07:38:48.027" v="6899"/>
          <ac:grpSpMkLst>
            <pc:docMk/>
            <pc:sldMk cId="3170069621" sldId="364"/>
            <ac:grpSpMk id="4" creationId="{520D7BD3-C2C8-4EBE-AC2F-4D1AF994CEC2}"/>
          </ac:grpSpMkLst>
        </pc:grpChg>
        <pc:grpChg chg="mod">
          <ac:chgData name="Chew Leng Lim" userId="f4956819b06a5395" providerId="LiveId" clId="{18C7B61E-2F46-44F3-B4F9-D9413F1F6D22}" dt="2020-03-12T07:38:48.027" v="6899"/>
          <ac:grpSpMkLst>
            <pc:docMk/>
            <pc:sldMk cId="3170069621" sldId="364"/>
            <ac:grpSpMk id="5" creationId="{9F591A7B-EB8B-4509-B4E7-21861D4DB552}"/>
          </ac:grpSpMkLst>
        </pc:grpChg>
        <pc:graphicFrameChg chg="mod">
          <ac:chgData name="Chew Leng Lim" userId="f4956819b06a5395" providerId="LiveId" clId="{18C7B61E-2F46-44F3-B4F9-D9413F1F6D22}" dt="2020-03-12T07:38:48.027" v="6899"/>
          <ac:graphicFrameMkLst>
            <pc:docMk/>
            <pc:sldMk cId="3170069621" sldId="364"/>
            <ac:graphicFrameMk id="62" creationId="{526897DF-36CD-46A2-AE95-2E369D41A64F}"/>
          </ac:graphicFrameMkLst>
        </pc:graphicFrameChg>
      </pc:sldChg>
    </pc:docChg>
  </pc:docChgLst>
  <pc:docChgLst>
    <pc:chgData name="Chew Leng Lim" userId="f4956819b06a5395" providerId="LiveId" clId="{C2CF6F2B-4DBD-4F07-A176-00F22443DF3E}"/>
    <pc:docChg chg="custSel modSld">
      <pc:chgData name="Chew Leng Lim" userId="f4956819b06a5395" providerId="LiveId" clId="{C2CF6F2B-4DBD-4F07-A176-00F22443DF3E}" dt="2019-12-12T09:17:03.596" v="211" actId="1036"/>
      <pc:docMkLst>
        <pc:docMk/>
      </pc:docMkLst>
      <pc:sldChg chg="addSp delSp modSp">
        <pc:chgData name="Chew Leng Lim" userId="f4956819b06a5395" providerId="LiveId" clId="{C2CF6F2B-4DBD-4F07-A176-00F22443DF3E}" dt="2019-12-12T09:17:03.596" v="211" actId="1036"/>
        <pc:sldMkLst>
          <pc:docMk/>
          <pc:sldMk cId="1761259662" sldId="299"/>
        </pc:sldMkLst>
        <pc:spChg chg="mod">
          <ac:chgData name="Chew Leng Lim" userId="f4956819b06a5395" providerId="LiveId" clId="{C2CF6F2B-4DBD-4F07-A176-00F22443DF3E}" dt="2019-12-12T09:17:03.596" v="211" actId="1036"/>
          <ac:spMkLst>
            <pc:docMk/>
            <pc:sldMk cId="1761259662" sldId="299"/>
            <ac:spMk id="40" creationId="{0BDA73C9-680F-4A7D-897C-F6512617106B}"/>
          </ac:spMkLst>
        </pc:spChg>
        <pc:spChg chg="mod">
          <ac:chgData name="Chew Leng Lim" userId="f4956819b06a5395" providerId="LiveId" clId="{C2CF6F2B-4DBD-4F07-A176-00F22443DF3E}" dt="2019-12-12T09:17:03.596" v="211" actId="1036"/>
          <ac:spMkLst>
            <pc:docMk/>
            <pc:sldMk cId="1761259662" sldId="299"/>
            <ac:spMk id="42" creationId="{6BF8AA07-0B8C-4831-A2D1-3C95D9C9B57F}"/>
          </ac:spMkLst>
        </pc:spChg>
        <pc:spChg chg="mod">
          <ac:chgData name="Chew Leng Lim" userId="f4956819b06a5395" providerId="LiveId" clId="{C2CF6F2B-4DBD-4F07-A176-00F22443DF3E}" dt="2019-12-12T09:17:03.596" v="211" actId="1036"/>
          <ac:spMkLst>
            <pc:docMk/>
            <pc:sldMk cId="1761259662" sldId="299"/>
            <ac:spMk id="43" creationId="{FADEE728-F02B-4238-A1ED-A88BD1D42CD1}"/>
          </ac:spMkLst>
        </pc:spChg>
        <pc:spChg chg="del">
          <ac:chgData name="Chew Leng Lim" userId="f4956819b06a5395" providerId="LiveId" clId="{C2CF6F2B-4DBD-4F07-A176-00F22443DF3E}" dt="2019-12-12T09:14:44.653" v="30" actId="478"/>
          <ac:spMkLst>
            <pc:docMk/>
            <pc:sldMk cId="1761259662" sldId="299"/>
            <ac:spMk id="44" creationId="{6A16373F-977D-4B1E-A01B-910838C1649A}"/>
          </ac:spMkLst>
        </pc:spChg>
        <pc:spChg chg="mod">
          <ac:chgData name="Chew Leng Lim" userId="f4956819b06a5395" providerId="LiveId" clId="{C2CF6F2B-4DBD-4F07-A176-00F22443DF3E}" dt="2019-12-12T09:17:03.596" v="211" actId="1036"/>
          <ac:spMkLst>
            <pc:docMk/>
            <pc:sldMk cId="1761259662" sldId="299"/>
            <ac:spMk id="45" creationId="{C5CC6924-1631-45DA-915C-6091E2376E7D}"/>
          </ac:spMkLst>
        </pc:spChg>
        <pc:spChg chg="mod">
          <ac:chgData name="Chew Leng Lim" userId="f4956819b06a5395" providerId="LiveId" clId="{C2CF6F2B-4DBD-4F07-A176-00F22443DF3E}" dt="2019-12-12T09:17:03.596" v="211" actId="1036"/>
          <ac:spMkLst>
            <pc:docMk/>
            <pc:sldMk cId="1761259662" sldId="299"/>
            <ac:spMk id="47" creationId="{E5AB3F53-B6FF-4B2C-9CF4-8A54021B65DC}"/>
          </ac:spMkLst>
        </pc:spChg>
        <pc:spChg chg="mod">
          <ac:chgData name="Chew Leng Lim" userId="f4956819b06a5395" providerId="LiveId" clId="{C2CF6F2B-4DBD-4F07-A176-00F22443DF3E}" dt="2019-12-12T09:17:03.596" v="211" actId="1036"/>
          <ac:spMkLst>
            <pc:docMk/>
            <pc:sldMk cId="1761259662" sldId="299"/>
            <ac:spMk id="52" creationId="{E34DF870-38B4-493D-920E-304D333AFB0A}"/>
          </ac:spMkLst>
        </pc:spChg>
        <pc:spChg chg="mod">
          <ac:chgData name="Chew Leng Lim" userId="f4956819b06a5395" providerId="LiveId" clId="{C2CF6F2B-4DBD-4F07-A176-00F22443DF3E}" dt="2019-12-12T09:17:03.596" v="211" actId="1036"/>
          <ac:spMkLst>
            <pc:docMk/>
            <pc:sldMk cId="1761259662" sldId="299"/>
            <ac:spMk id="53" creationId="{0EB01689-4EAA-4563-BE5F-CE35B574AB85}"/>
          </ac:spMkLst>
        </pc:spChg>
        <pc:spChg chg="mod">
          <ac:chgData name="Chew Leng Lim" userId="f4956819b06a5395" providerId="LiveId" clId="{C2CF6F2B-4DBD-4F07-A176-00F22443DF3E}" dt="2019-12-12T09:17:03.596" v="211" actId="1036"/>
          <ac:spMkLst>
            <pc:docMk/>
            <pc:sldMk cId="1761259662" sldId="299"/>
            <ac:spMk id="54" creationId="{B37AF1B1-AB63-4F5A-82AB-370DC6C5B0AC}"/>
          </ac:spMkLst>
        </pc:spChg>
        <pc:spChg chg="mod">
          <ac:chgData name="Chew Leng Lim" userId="f4956819b06a5395" providerId="LiveId" clId="{C2CF6F2B-4DBD-4F07-A176-00F22443DF3E}" dt="2019-12-12T09:17:03.596" v="211" actId="1036"/>
          <ac:spMkLst>
            <pc:docMk/>
            <pc:sldMk cId="1761259662" sldId="299"/>
            <ac:spMk id="55" creationId="{1B815593-B551-42BB-A93B-F48C6AD3CFE3}"/>
          </ac:spMkLst>
        </pc:spChg>
        <pc:spChg chg="del">
          <ac:chgData name="Chew Leng Lim" userId="f4956819b06a5395" providerId="LiveId" clId="{C2CF6F2B-4DBD-4F07-A176-00F22443DF3E}" dt="2019-12-12T09:16:06.873" v="130" actId="478"/>
          <ac:spMkLst>
            <pc:docMk/>
            <pc:sldMk cId="1761259662" sldId="299"/>
            <ac:spMk id="59" creationId="{CF5AB144-D142-4577-8671-BB4006F1C73A}"/>
          </ac:spMkLst>
        </pc:spChg>
        <pc:spChg chg="mod">
          <ac:chgData name="Chew Leng Lim" userId="f4956819b06a5395" providerId="LiveId" clId="{C2CF6F2B-4DBD-4F07-A176-00F22443DF3E}" dt="2019-12-12T09:17:03.596" v="211" actId="1036"/>
          <ac:spMkLst>
            <pc:docMk/>
            <pc:sldMk cId="1761259662" sldId="299"/>
            <ac:spMk id="60" creationId="{DAB93605-FB74-4885-B96B-0C67AC00919E}"/>
          </ac:spMkLst>
        </pc:spChg>
        <pc:spChg chg="mod">
          <ac:chgData name="Chew Leng Lim" userId="f4956819b06a5395" providerId="LiveId" clId="{C2CF6F2B-4DBD-4F07-A176-00F22443DF3E}" dt="2019-12-12T09:17:03.596" v="211" actId="1036"/>
          <ac:spMkLst>
            <pc:docMk/>
            <pc:sldMk cId="1761259662" sldId="299"/>
            <ac:spMk id="61" creationId="{BA014A3D-0FA5-45F3-A85E-1802777CB116}"/>
          </ac:spMkLst>
        </pc:spChg>
        <pc:spChg chg="del">
          <ac:chgData name="Chew Leng Lim" userId="f4956819b06a5395" providerId="LiveId" clId="{C2CF6F2B-4DBD-4F07-A176-00F22443DF3E}" dt="2019-12-12T09:16:12.977" v="132" actId="478"/>
          <ac:spMkLst>
            <pc:docMk/>
            <pc:sldMk cId="1761259662" sldId="299"/>
            <ac:spMk id="62" creationId="{01A981AC-A5E4-494B-8482-D69120C6AAF8}"/>
          </ac:spMkLst>
        </pc:spChg>
        <pc:spChg chg="mod">
          <ac:chgData name="Chew Leng Lim" userId="f4956819b06a5395" providerId="LiveId" clId="{C2CF6F2B-4DBD-4F07-A176-00F22443DF3E}" dt="2019-12-12T09:17:03.596" v="211" actId="1036"/>
          <ac:spMkLst>
            <pc:docMk/>
            <pc:sldMk cId="1761259662" sldId="299"/>
            <ac:spMk id="66" creationId="{919B5D36-0A98-418A-B25E-492BB428620F}"/>
          </ac:spMkLst>
        </pc:spChg>
        <pc:spChg chg="mod">
          <ac:chgData name="Chew Leng Lim" userId="f4956819b06a5395" providerId="LiveId" clId="{C2CF6F2B-4DBD-4F07-A176-00F22443DF3E}" dt="2019-12-12T09:17:03.596" v="211" actId="1036"/>
          <ac:spMkLst>
            <pc:docMk/>
            <pc:sldMk cId="1761259662" sldId="299"/>
            <ac:spMk id="68" creationId="{B7BEBF5D-1041-4E50-9DF7-7C6EBCCC4265}"/>
          </ac:spMkLst>
        </pc:spChg>
        <pc:spChg chg="del">
          <ac:chgData name="Chew Leng Lim" userId="f4956819b06a5395" providerId="LiveId" clId="{C2CF6F2B-4DBD-4F07-A176-00F22443DF3E}" dt="2019-12-12T09:16:50.293" v="137" actId="478"/>
          <ac:spMkLst>
            <pc:docMk/>
            <pc:sldMk cId="1761259662" sldId="299"/>
            <ac:spMk id="69" creationId="{D49DC4BE-735A-4A7D-BC37-9B21BDF4A770}"/>
          </ac:spMkLst>
        </pc:spChg>
        <pc:spChg chg="del">
          <ac:chgData name="Chew Leng Lim" userId="f4956819b06a5395" providerId="LiveId" clId="{C2CF6F2B-4DBD-4F07-A176-00F22443DF3E}" dt="2019-12-12T09:16:50.293" v="137" actId="478"/>
          <ac:spMkLst>
            <pc:docMk/>
            <pc:sldMk cId="1761259662" sldId="299"/>
            <ac:spMk id="70" creationId="{E07BA918-FBF6-49AE-B057-88EA7DC78281}"/>
          </ac:spMkLst>
        </pc:spChg>
        <pc:spChg chg="del">
          <ac:chgData name="Chew Leng Lim" userId="f4956819b06a5395" providerId="LiveId" clId="{C2CF6F2B-4DBD-4F07-A176-00F22443DF3E}" dt="2019-12-12T09:16:50.293" v="137" actId="478"/>
          <ac:spMkLst>
            <pc:docMk/>
            <pc:sldMk cId="1761259662" sldId="299"/>
            <ac:spMk id="71" creationId="{5015C4D3-48E3-4FC3-AC3F-EA624166ADBD}"/>
          </ac:spMkLst>
        </pc:spChg>
        <pc:spChg chg="del">
          <ac:chgData name="Chew Leng Lim" userId="f4956819b06a5395" providerId="LiveId" clId="{C2CF6F2B-4DBD-4F07-A176-00F22443DF3E}" dt="2019-12-12T09:16:50.293" v="137" actId="478"/>
          <ac:spMkLst>
            <pc:docMk/>
            <pc:sldMk cId="1761259662" sldId="299"/>
            <ac:spMk id="72" creationId="{7B16B695-86F3-4BB9-AE90-BCC20DBD3BC8}"/>
          </ac:spMkLst>
        </pc:spChg>
        <pc:spChg chg="mod">
          <ac:chgData name="Chew Leng Lim" userId="f4956819b06a5395" providerId="LiveId" clId="{C2CF6F2B-4DBD-4F07-A176-00F22443DF3E}" dt="2019-12-12T09:17:03.596" v="211" actId="1036"/>
          <ac:spMkLst>
            <pc:docMk/>
            <pc:sldMk cId="1761259662" sldId="299"/>
            <ac:spMk id="74" creationId="{EBEC7003-8E98-4B0B-8CFB-E0DC7FDE9BF6}"/>
          </ac:spMkLst>
        </pc:spChg>
        <pc:spChg chg="mod">
          <ac:chgData name="Chew Leng Lim" userId="f4956819b06a5395" providerId="LiveId" clId="{C2CF6F2B-4DBD-4F07-A176-00F22443DF3E}" dt="2019-12-12T09:17:03.596" v="211" actId="1036"/>
          <ac:spMkLst>
            <pc:docMk/>
            <pc:sldMk cId="1761259662" sldId="299"/>
            <ac:spMk id="75" creationId="{27BD3765-94C4-421D-AA0A-1FD6576A6B1F}"/>
          </ac:spMkLst>
        </pc:spChg>
        <pc:spChg chg="mod">
          <ac:chgData name="Chew Leng Lim" userId="f4956819b06a5395" providerId="LiveId" clId="{C2CF6F2B-4DBD-4F07-A176-00F22443DF3E}" dt="2019-12-12T09:17:03.596" v="211" actId="1036"/>
          <ac:spMkLst>
            <pc:docMk/>
            <pc:sldMk cId="1761259662" sldId="299"/>
            <ac:spMk id="76" creationId="{B2F8908B-4C06-45FE-9062-4972EEB7069E}"/>
          </ac:spMkLst>
        </pc:spChg>
        <pc:spChg chg="mod">
          <ac:chgData name="Chew Leng Lim" userId="f4956819b06a5395" providerId="LiveId" clId="{C2CF6F2B-4DBD-4F07-A176-00F22443DF3E}" dt="2019-12-12T09:17:03.596" v="211" actId="1036"/>
          <ac:spMkLst>
            <pc:docMk/>
            <pc:sldMk cId="1761259662" sldId="299"/>
            <ac:spMk id="77" creationId="{0792E0AE-DB88-4172-8838-5FBBBAB7D439}"/>
          </ac:spMkLst>
        </pc:spChg>
        <pc:spChg chg="mod">
          <ac:chgData name="Chew Leng Lim" userId="f4956819b06a5395" providerId="LiveId" clId="{C2CF6F2B-4DBD-4F07-A176-00F22443DF3E}" dt="2019-12-12T09:17:03.596" v="211" actId="1036"/>
          <ac:spMkLst>
            <pc:docMk/>
            <pc:sldMk cId="1761259662" sldId="299"/>
            <ac:spMk id="78" creationId="{6CD6268A-1AB8-4874-9324-4C2AFA4DFFB8}"/>
          </ac:spMkLst>
        </pc:spChg>
        <pc:spChg chg="del">
          <ac:chgData name="Chew Leng Lim" userId="f4956819b06a5395" providerId="LiveId" clId="{C2CF6F2B-4DBD-4F07-A176-00F22443DF3E}" dt="2019-12-12T09:14:48.604" v="32" actId="478"/>
          <ac:spMkLst>
            <pc:docMk/>
            <pc:sldMk cId="1761259662" sldId="299"/>
            <ac:spMk id="79" creationId="{3CA37550-CE0B-42B1-8087-07A8FD4E086D}"/>
          </ac:spMkLst>
        </pc:spChg>
        <pc:spChg chg="mod">
          <ac:chgData name="Chew Leng Lim" userId="f4956819b06a5395" providerId="LiveId" clId="{C2CF6F2B-4DBD-4F07-A176-00F22443DF3E}" dt="2019-12-12T09:17:03.596" v="211" actId="1036"/>
          <ac:spMkLst>
            <pc:docMk/>
            <pc:sldMk cId="1761259662" sldId="299"/>
            <ac:spMk id="80" creationId="{6363EBBE-9F36-4D1D-88EC-6087AB6527AC}"/>
          </ac:spMkLst>
        </pc:spChg>
        <pc:spChg chg="add mod">
          <ac:chgData name="Chew Leng Lim" userId="f4956819b06a5395" providerId="LiveId" clId="{C2CF6F2B-4DBD-4F07-A176-00F22443DF3E}" dt="2019-12-12T09:17:03.596" v="211" actId="1036"/>
          <ac:spMkLst>
            <pc:docMk/>
            <pc:sldMk cId="1761259662" sldId="299"/>
            <ac:spMk id="81" creationId="{302EBEF3-0E20-43B2-AC8E-7F3E38F1A128}"/>
          </ac:spMkLst>
        </pc:spChg>
        <pc:spChg chg="add mod">
          <ac:chgData name="Chew Leng Lim" userId="f4956819b06a5395" providerId="LiveId" clId="{C2CF6F2B-4DBD-4F07-A176-00F22443DF3E}" dt="2019-12-12T09:17:03.596" v="211" actId="1036"/>
          <ac:spMkLst>
            <pc:docMk/>
            <pc:sldMk cId="1761259662" sldId="299"/>
            <ac:spMk id="82" creationId="{2A6E646A-F920-4A9C-AA5B-5A709EC4D6D9}"/>
          </ac:spMkLst>
        </pc:spChg>
        <pc:spChg chg="add mod">
          <ac:chgData name="Chew Leng Lim" userId="f4956819b06a5395" providerId="LiveId" clId="{C2CF6F2B-4DBD-4F07-A176-00F22443DF3E}" dt="2019-12-12T09:17:03.596" v="211" actId="1036"/>
          <ac:spMkLst>
            <pc:docMk/>
            <pc:sldMk cId="1761259662" sldId="299"/>
            <ac:spMk id="83" creationId="{5096B330-5CD7-411E-B29B-3E4B9964E854}"/>
          </ac:spMkLst>
        </pc:spChg>
        <pc:graphicFrameChg chg="mod">
          <ac:chgData name="Chew Leng Lim" userId="f4956819b06a5395" providerId="LiveId" clId="{C2CF6F2B-4DBD-4F07-A176-00F22443DF3E}" dt="2019-12-12T09:17:03.596" v="211" actId="1036"/>
          <ac:graphicFrameMkLst>
            <pc:docMk/>
            <pc:sldMk cId="1761259662" sldId="299"/>
            <ac:graphicFrameMk id="41" creationId="{E053C582-9EDB-4C2A-8316-AE1F97B54AB6}"/>
          </ac:graphicFrameMkLst>
        </pc:graphicFrameChg>
        <pc:graphicFrameChg chg="mod">
          <ac:chgData name="Chew Leng Lim" userId="f4956819b06a5395" providerId="LiveId" clId="{C2CF6F2B-4DBD-4F07-A176-00F22443DF3E}" dt="2019-12-12T09:17:03.596" v="211" actId="1036"/>
          <ac:graphicFrameMkLst>
            <pc:docMk/>
            <pc:sldMk cId="1761259662" sldId="299"/>
            <ac:graphicFrameMk id="46" creationId="{76820563-9C99-4E40-959D-F8774CC02C23}"/>
          </ac:graphicFrameMkLst>
        </pc:graphicFrameChg>
        <pc:graphicFrameChg chg="mod">
          <ac:chgData name="Chew Leng Lim" userId="f4956819b06a5395" providerId="LiveId" clId="{C2CF6F2B-4DBD-4F07-A176-00F22443DF3E}" dt="2019-12-12T09:17:03.596" v="211" actId="1036"/>
          <ac:graphicFrameMkLst>
            <pc:docMk/>
            <pc:sldMk cId="1761259662" sldId="299"/>
            <ac:graphicFrameMk id="56" creationId="{73158DE8-DBE0-4DEE-A5D2-3C9502DF4E53}"/>
          </ac:graphicFrameMkLst>
        </pc:graphicFrameChg>
        <pc:graphicFrameChg chg="mod">
          <ac:chgData name="Chew Leng Lim" userId="f4956819b06a5395" providerId="LiveId" clId="{C2CF6F2B-4DBD-4F07-A176-00F22443DF3E}" dt="2019-12-12T09:17:03.596" v="211" actId="1036"/>
          <ac:graphicFrameMkLst>
            <pc:docMk/>
            <pc:sldMk cId="1761259662" sldId="299"/>
            <ac:graphicFrameMk id="73" creationId="{738FFADE-1236-4723-B407-0F6CBB40EC39}"/>
          </ac:graphicFrameMkLst>
        </pc:graphicFrameChg>
      </pc:sldChg>
    </pc:docChg>
  </pc:docChgLst>
  <pc:docChgLst>
    <pc:chgData name="Chew Leng Lim" userId="f4956819b06a5395" providerId="LiveId" clId="{2196E1E8-070C-474D-888C-CEA90273A304}"/>
    <pc:docChg chg="custSel modSld">
      <pc:chgData name="Chew Leng Lim" userId="f4956819b06a5395" providerId="LiveId" clId="{2196E1E8-070C-474D-888C-CEA90273A304}" dt="2020-04-14T11:23:48.667" v="37"/>
      <pc:docMkLst>
        <pc:docMk/>
      </pc:docMkLst>
      <pc:sldChg chg="modSp">
        <pc:chgData name="Chew Leng Lim" userId="f4956819b06a5395" providerId="LiveId" clId="{2196E1E8-070C-474D-888C-CEA90273A304}" dt="2020-04-13T04:00:13.052" v="23"/>
        <pc:sldMkLst>
          <pc:docMk/>
          <pc:sldMk cId="1428766084" sldId="261"/>
        </pc:sldMkLst>
        <pc:graphicFrameChg chg="mod">
          <ac:chgData name="Chew Leng Lim" userId="f4956819b06a5395" providerId="LiveId" clId="{2196E1E8-070C-474D-888C-CEA90273A304}" dt="2020-04-13T03:59:35.065" v="18"/>
          <ac:graphicFrameMkLst>
            <pc:docMk/>
            <pc:sldMk cId="1428766084" sldId="261"/>
            <ac:graphicFrameMk id="6" creationId="{991507A3-7274-4E7A-BEF3-A27BD3D5C3FF}"/>
          </ac:graphicFrameMkLst>
        </pc:graphicFrameChg>
        <pc:graphicFrameChg chg="mod">
          <ac:chgData name="Chew Leng Lim" userId="f4956819b06a5395" providerId="LiveId" clId="{2196E1E8-070C-474D-888C-CEA90273A304}" dt="2020-04-13T04:00:13.052" v="23"/>
          <ac:graphicFrameMkLst>
            <pc:docMk/>
            <pc:sldMk cId="1428766084" sldId="261"/>
            <ac:graphicFrameMk id="69" creationId="{C057413A-1021-435D-AB69-9A491737E78A}"/>
          </ac:graphicFrameMkLst>
        </pc:graphicFrameChg>
        <pc:graphicFrameChg chg="mod">
          <ac:chgData name="Chew Leng Lim" userId="f4956819b06a5395" providerId="LiveId" clId="{2196E1E8-070C-474D-888C-CEA90273A304}" dt="2020-04-13T03:59:00.103" v="16"/>
          <ac:graphicFrameMkLst>
            <pc:docMk/>
            <pc:sldMk cId="1428766084" sldId="261"/>
            <ac:graphicFrameMk id="80" creationId="{46262B4F-0989-4CC1-8383-D70A2EC1695D}"/>
          </ac:graphicFrameMkLst>
        </pc:graphicFrameChg>
        <pc:graphicFrameChg chg="mod">
          <ac:chgData name="Chew Leng Lim" userId="f4956819b06a5395" providerId="LiveId" clId="{2196E1E8-070C-474D-888C-CEA90273A304}" dt="2020-04-13T03:59:58.237" v="21"/>
          <ac:graphicFrameMkLst>
            <pc:docMk/>
            <pc:sldMk cId="1428766084" sldId="261"/>
            <ac:graphicFrameMk id="99" creationId="{DAD8D310-D559-4499-B5FD-5E67DE3A07B3}"/>
          </ac:graphicFrameMkLst>
        </pc:graphicFrameChg>
      </pc:sldChg>
      <pc:sldChg chg="modSp">
        <pc:chgData name="Chew Leng Lim" userId="f4956819b06a5395" providerId="LiveId" clId="{2196E1E8-070C-474D-888C-CEA90273A304}" dt="2020-04-14T11:23:48.667" v="37"/>
        <pc:sldMkLst>
          <pc:docMk/>
          <pc:sldMk cId="1896826950" sldId="296"/>
        </pc:sldMkLst>
        <pc:graphicFrameChg chg="mod">
          <ac:chgData name="Chew Leng Lim" userId="f4956819b06a5395" providerId="LiveId" clId="{2196E1E8-070C-474D-888C-CEA90273A304}" dt="2020-04-14T11:23:48.667" v="37"/>
          <ac:graphicFrameMkLst>
            <pc:docMk/>
            <pc:sldMk cId="1896826950" sldId="296"/>
            <ac:graphicFrameMk id="4" creationId="{0A0CA5D8-924E-4388-A5D7-0A6ED0A7F17E}"/>
          </ac:graphicFrameMkLst>
        </pc:graphicFrameChg>
        <pc:graphicFrameChg chg="mod">
          <ac:chgData name="Chew Leng Lim" userId="f4956819b06a5395" providerId="LiveId" clId="{2196E1E8-070C-474D-888C-CEA90273A304}" dt="2020-04-13T05:05:42.087" v="25"/>
          <ac:graphicFrameMkLst>
            <pc:docMk/>
            <pc:sldMk cId="1896826950" sldId="296"/>
            <ac:graphicFrameMk id="99" creationId="{94A0858B-D660-4B49-96E5-BFE10DEE1D3B}"/>
          </ac:graphicFrameMkLst>
        </pc:graphicFrameChg>
      </pc:sldChg>
      <pc:sldChg chg="addSp delSp modSp">
        <pc:chgData name="Chew Leng Lim" userId="f4956819b06a5395" providerId="LiveId" clId="{2196E1E8-070C-474D-888C-CEA90273A304}" dt="2020-04-13T09:20:04.573" v="34" actId="1076"/>
        <pc:sldMkLst>
          <pc:docMk/>
          <pc:sldMk cId="2182335463" sldId="325"/>
        </pc:sldMkLst>
        <pc:spChg chg="del mod topLvl">
          <ac:chgData name="Chew Leng Lim" userId="f4956819b06a5395" providerId="LiveId" clId="{2196E1E8-070C-474D-888C-CEA90273A304}" dt="2020-04-13T09:19:41.687" v="30" actId="478"/>
          <ac:spMkLst>
            <pc:docMk/>
            <pc:sldMk cId="2182335463" sldId="325"/>
            <ac:spMk id="53" creationId="{1DCD0C1C-D4C4-4C79-81C9-410BE564ADDD}"/>
          </ac:spMkLst>
        </pc:spChg>
        <pc:spChg chg="del mod topLvl">
          <ac:chgData name="Chew Leng Lim" userId="f4956819b06a5395" providerId="LiveId" clId="{2196E1E8-070C-474D-888C-CEA90273A304}" dt="2020-04-13T09:19:41.687" v="30" actId="478"/>
          <ac:spMkLst>
            <pc:docMk/>
            <pc:sldMk cId="2182335463" sldId="325"/>
            <ac:spMk id="54" creationId="{739E461F-A3DA-4110-97F5-6B1B7D077B1A}"/>
          </ac:spMkLst>
        </pc:spChg>
        <pc:spChg chg="del mod topLvl">
          <ac:chgData name="Chew Leng Lim" userId="f4956819b06a5395" providerId="LiveId" clId="{2196E1E8-070C-474D-888C-CEA90273A304}" dt="2020-04-13T09:19:41.687" v="30" actId="478"/>
          <ac:spMkLst>
            <pc:docMk/>
            <pc:sldMk cId="2182335463" sldId="325"/>
            <ac:spMk id="55" creationId="{6081F49C-3240-4D57-B29A-9CE270513AC1}"/>
          </ac:spMkLst>
        </pc:spChg>
        <pc:spChg chg="mod topLvl">
          <ac:chgData name="Chew Leng Lim" userId="f4956819b06a5395" providerId="LiveId" clId="{2196E1E8-070C-474D-888C-CEA90273A304}" dt="2020-04-13T09:20:04.573" v="34" actId="1076"/>
          <ac:spMkLst>
            <pc:docMk/>
            <pc:sldMk cId="2182335463" sldId="325"/>
            <ac:spMk id="56" creationId="{8B8E8CFD-899D-4D67-9B64-BFC6E49C9BA2}"/>
          </ac:spMkLst>
        </pc:spChg>
        <pc:spChg chg="mod topLvl">
          <ac:chgData name="Chew Leng Lim" userId="f4956819b06a5395" providerId="LiveId" clId="{2196E1E8-070C-474D-888C-CEA90273A304}" dt="2020-04-13T09:20:04.573" v="34" actId="1076"/>
          <ac:spMkLst>
            <pc:docMk/>
            <pc:sldMk cId="2182335463" sldId="325"/>
            <ac:spMk id="57" creationId="{02C3851E-0B22-4EA0-A766-F624063A20EA}"/>
          </ac:spMkLst>
        </pc:spChg>
        <pc:spChg chg="del mod topLvl">
          <ac:chgData name="Chew Leng Lim" userId="f4956819b06a5395" providerId="LiveId" clId="{2196E1E8-070C-474D-888C-CEA90273A304}" dt="2020-04-13T09:19:41.687" v="30" actId="478"/>
          <ac:spMkLst>
            <pc:docMk/>
            <pc:sldMk cId="2182335463" sldId="325"/>
            <ac:spMk id="59" creationId="{2637BA57-46E5-4FE3-9D6A-495ECD1DEA4F}"/>
          </ac:spMkLst>
        </pc:spChg>
        <pc:spChg chg="del mod topLvl">
          <ac:chgData name="Chew Leng Lim" userId="f4956819b06a5395" providerId="LiveId" clId="{2196E1E8-070C-474D-888C-CEA90273A304}" dt="2020-04-13T09:19:41.687" v="30" actId="478"/>
          <ac:spMkLst>
            <pc:docMk/>
            <pc:sldMk cId="2182335463" sldId="325"/>
            <ac:spMk id="60" creationId="{7D6DB103-2585-4BEC-8F2E-A3EB5F1EDEFE}"/>
          </ac:spMkLst>
        </pc:spChg>
        <pc:spChg chg="del mod topLvl">
          <ac:chgData name="Chew Leng Lim" userId="f4956819b06a5395" providerId="LiveId" clId="{2196E1E8-070C-474D-888C-CEA90273A304}" dt="2020-04-13T09:19:42.840" v="31" actId="478"/>
          <ac:spMkLst>
            <pc:docMk/>
            <pc:sldMk cId="2182335463" sldId="325"/>
            <ac:spMk id="61" creationId="{053817C3-9607-4C9E-94B0-9110A41AA00D}"/>
          </ac:spMkLst>
        </pc:spChg>
        <pc:spChg chg="mod topLvl">
          <ac:chgData name="Chew Leng Lim" userId="f4956819b06a5395" providerId="LiveId" clId="{2196E1E8-070C-474D-888C-CEA90273A304}" dt="2020-04-13T09:20:04.573" v="34" actId="1076"/>
          <ac:spMkLst>
            <pc:docMk/>
            <pc:sldMk cId="2182335463" sldId="325"/>
            <ac:spMk id="62" creationId="{2DAC8580-0A70-4CFA-A607-CF9B8CAB6511}"/>
          </ac:spMkLst>
        </pc:spChg>
        <pc:spChg chg="mod topLvl">
          <ac:chgData name="Chew Leng Lim" userId="f4956819b06a5395" providerId="LiveId" clId="{2196E1E8-070C-474D-888C-CEA90273A304}" dt="2020-04-13T09:20:04.573" v="34" actId="1076"/>
          <ac:spMkLst>
            <pc:docMk/>
            <pc:sldMk cId="2182335463" sldId="325"/>
            <ac:spMk id="63" creationId="{DA9EB389-2B78-4CA7-868F-AA0833B597E0}"/>
          </ac:spMkLst>
        </pc:spChg>
        <pc:grpChg chg="mod">
          <ac:chgData name="Chew Leng Lim" userId="f4956819b06a5395" providerId="LiveId" clId="{2196E1E8-070C-474D-888C-CEA90273A304}" dt="2020-04-13T09:19:59.030" v="33"/>
          <ac:grpSpMkLst>
            <pc:docMk/>
            <pc:sldMk cId="2182335463" sldId="325"/>
            <ac:grpSpMk id="13" creationId="{F838DFE0-BD30-4885-A589-7A18193CEFDA}"/>
          </ac:grpSpMkLst>
        </pc:grpChg>
        <pc:grpChg chg="mod">
          <ac:chgData name="Chew Leng Lim" userId="f4956819b06a5395" providerId="LiveId" clId="{2196E1E8-070C-474D-888C-CEA90273A304}" dt="2020-04-13T09:19:59.030" v="33"/>
          <ac:grpSpMkLst>
            <pc:docMk/>
            <pc:sldMk cId="2182335463" sldId="325"/>
            <ac:grpSpMk id="26" creationId="{E3A26052-EC29-4B70-9717-E4CB34EE2321}"/>
          </ac:grpSpMkLst>
        </pc:grpChg>
        <pc:grpChg chg="add del mod">
          <ac:chgData name="Chew Leng Lim" userId="f4956819b06a5395" providerId="LiveId" clId="{2196E1E8-070C-474D-888C-CEA90273A304}" dt="2020-04-13T09:19:27.361" v="28" actId="165"/>
          <ac:grpSpMkLst>
            <pc:docMk/>
            <pc:sldMk cId="2182335463" sldId="325"/>
            <ac:grpSpMk id="52" creationId="{68A8CD1D-6E3C-4CD0-91BF-0B413B0E5325}"/>
          </ac:grpSpMkLst>
        </pc:grpChg>
        <pc:grpChg chg="del mod topLvl">
          <ac:chgData name="Chew Leng Lim" userId="f4956819b06a5395" providerId="LiveId" clId="{2196E1E8-070C-474D-888C-CEA90273A304}" dt="2020-04-13T09:19:35.854" v="29" actId="165"/>
          <ac:grpSpMkLst>
            <pc:docMk/>
            <pc:sldMk cId="2182335463" sldId="325"/>
            <ac:grpSpMk id="58" creationId="{94C40F6A-7B6A-481A-90D7-AC582C8C1608}"/>
          </ac:grpSpMkLst>
        </pc:grpChg>
        <pc:graphicFrameChg chg="mod">
          <ac:chgData name="Chew Leng Lim" userId="f4956819b06a5395" providerId="LiveId" clId="{2196E1E8-070C-474D-888C-CEA90273A304}" dt="2020-04-13T09:19:59.030" v="33"/>
          <ac:graphicFrameMkLst>
            <pc:docMk/>
            <pc:sldMk cId="2182335463" sldId="325"/>
            <ac:graphicFrameMk id="135" creationId="{5B3745C6-93DC-430E-A4B3-357942A2CB49}"/>
          </ac:graphicFrameMkLst>
        </pc:graphicFrameChg>
      </pc:sldChg>
      <pc:sldChg chg="modSp">
        <pc:chgData name="Chew Leng Lim" userId="f4956819b06a5395" providerId="LiveId" clId="{2196E1E8-070C-474D-888C-CEA90273A304}" dt="2020-04-13T09:20:27.502" v="36"/>
        <pc:sldMkLst>
          <pc:docMk/>
          <pc:sldMk cId="3170069621" sldId="364"/>
        </pc:sldMkLst>
        <pc:grpChg chg="mod">
          <ac:chgData name="Chew Leng Lim" userId="f4956819b06a5395" providerId="LiveId" clId="{2196E1E8-070C-474D-888C-CEA90273A304}" dt="2020-04-13T09:20:27.502" v="36"/>
          <ac:grpSpMkLst>
            <pc:docMk/>
            <pc:sldMk cId="3170069621" sldId="364"/>
            <ac:grpSpMk id="4" creationId="{520D7BD3-C2C8-4EBE-AC2F-4D1AF994CEC2}"/>
          </ac:grpSpMkLst>
        </pc:grpChg>
        <pc:grpChg chg="mod">
          <ac:chgData name="Chew Leng Lim" userId="f4956819b06a5395" providerId="LiveId" clId="{2196E1E8-070C-474D-888C-CEA90273A304}" dt="2020-04-13T09:20:27.502" v="36"/>
          <ac:grpSpMkLst>
            <pc:docMk/>
            <pc:sldMk cId="3170069621" sldId="364"/>
            <ac:grpSpMk id="5" creationId="{9F591A7B-EB8B-4509-B4E7-21861D4DB552}"/>
          </ac:grpSpMkLst>
        </pc:grpChg>
        <pc:graphicFrameChg chg="mod">
          <ac:chgData name="Chew Leng Lim" userId="f4956819b06a5395" providerId="LiveId" clId="{2196E1E8-070C-474D-888C-CEA90273A304}" dt="2020-04-13T09:20:27.502" v="36"/>
          <ac:graphicFrameMkLst>
            <pc:docMk/>
            <pc:sldMk cId="3170069621" sldId="364"/>
            <ac:graphicFrameMk id="62" creationId="{526897DF-36CD-46A2-AE95-2E369D41A64F}"/>
          </ac:graphicFrameMkLst>
        </pc:graphicFrameChg>
      </pc:sldChg>
      <pc:sldChg chg="addSp modSp">
        <pc:chgData name="Chew Leng Lim" userId="f4956819b06a5395" providerId="LiveId" clId="{2196E1E8-070C-474D-888C-CEA90273A304}" dt="2020-04-07T06:42:18.028" v="13" actId="1076"/>
        <pc:sldMkLst>
          <pc:docMk/>
          <pc:sldMk cId="3269692437" sldId="365"/>
        </pc:sldMkLst>
        <pc:spChg chg="add mod">
          <ac:chgData name="Chew Leng Lim" userId="f4956819b06a5395" providerId="LiveId" clId="{2196E1E8-070C-474D-888C-CEA90273A304}" dt="2020-04-07T06:42:18.028" v="13" actId="1076"/>
          <ac:spMkLst>
            <pc:docMk/>
            <pc:sldMk cId="3269692437" sldId="365"/>
            <ac:spMk id="2" creationId="{C496CA6B-71AE-4B3B-9EF5-2F1413B12F19}"/>
          </ac:spMkLst>
        </pc:spChg>
      </pc:sldChg>
    </pc:docChg>
  </pc:docChgLst>
  <pc:docChgLst>
    <pc:chgData name="Chew Leng Lim" userId="f4956819b06a5395" providerId="LiveId" clId="{64D1738D-F0F2-4F33-B73E-6056640154D5}"/>
    <pc:docChg chg="undo redo custSel addSld delSld modSld sldOrd">
      <pc:chgData name="Chew Leng Lim" userId="f4956819b06a5395" providerId="LiveId" clId="{64D1738D-F0F2-4F33-B73E-6056640154D5}" dt="2020-04-15T08:26:42.648" v="34375" actId="478"/>
      <pc:docMkLst>
        <pc:docMk/>
      </pc:docMkLst>
      <pc:sldChg chg="addSp delSp modSp">
        <pc:chgData name="Chew Leng Lim" userId="f4956819b06a5395" providerId="LiveId" clId="{64D1738D-F0F2-4F33-B73E-6056640154D5}" dt="2020-04-13T11:29:28.571" v="32219" actId="20577"/>
        <pc:sldMkLst>
          <pc:docMk/>
          <pc:sldMk cId="1428766084" sldId="261"/>
        </pc:sldMkLst>
        <pc:spChg chg="add mod">
          <ac:chgData name="Chew Leng Lim" userId="f4956819b06a5395" providerId="LiveId" clId="{64D1738D-F0F2-4F33-B73E-6056640154D5}" dt="2020-04-13T04:05:15.953" v="2122" actId="164"/>
          <ac:spMkLst>
            <pc:docMk/>
            <pc:sldMk cId="1428766084" sldId="261"/>
            <ac:spMk id="2" creationId="{3FC9EFF7-E448-4A36-B110-940135701144}"/>
          </ac:spMkLst>
        </pc:spChg>
        <pc:spChg chg="mod">
          <ac:chgData name="Chew Leng Lim" userId="f4956819b06a5395" providerId="LiveId" clId="{64D1738D-F0F2-4F33-B73E-6056640154D5}" dt="2020-04-13T04:05:07.038" v="2120" actId="164"/>
          <ac:spMkLst>
            <pc:docMk/>
            <pc:sldMk cId="1428766084" sldId="261"/>
            <ac:spMk id="8" creationId="{1E366CCF-4695-4DB0-9CD6-EE077D570F03}"/>
          </ac:spMkLst>
        </pc:spChg>
        <pc:spChg chg="mod">
          <ac:chgData name="Chew Leng Lim" userId="f4956819b06a5395" providerId="LiveId" clId="{64D1738D-F0F2-4F33-B73E-6056640154D5}" dt="2020-04-13T04:05:07.038" v="2120" actId="164"/>
          <ac:spMkLst>
            <pc:docMk/>
            <pc:sldMk cId="1428766084" sldId="261"/>
            <ac:spMk id="9" creationId="{13DD80AA-B2F2-4366-9783-0E522D351A8C}"/>
          </ac:spMkLst>
        </pc:spChg>
        <pc:spChg chg="mod">
          <ac:chgData name="Chew Leng Lim" userId="f4956819b06a5395" providerId="LiveId" clId="{64D1738D-F0F2-4F33-B73E-6056640154D5}" dt="2020-04-13T04:05:07.038" v="2120" actId="164"/>
          <ac:spMkLst>
            <pc:docMk/>
            <pc:sldMk cId="1428766084" sldId="261"/>
            <ac:spMk id="10" creationId="{5442A20A-0D2E-4514-92A5-46A2C5D12E31}"/>
          </ac:spMkLst>
        </pc:spChg>
        <pc:spChg chg="mod">
          <ac:chgData name="Chew Leng Lim" userId="f4956819b06a5395" providerId="LiveId" clId="{64D1738D-F0F2-4F33-B73E-6056640154D5}" dt="2020-04-13T04:05:07.038" v="2120" actId="164"/>
          <ac:spMkLst>
            <pc:docMk/>
            <pc:sldMk cId="1428766084" sldId="261"/>
            <ac:spMk id="11" creationId="{90D78407-EFC6-480F-AB77-92C7C259C184}"/>
          </ac:spMkLst>
        </pc:spChg>
        <pc:spChg chg="mod">
          <ac:chgData name="Chew Leng Lim" userId="f4956819b06a5395" providerId="LiveId" clId="{64D1738D-F0F2-4F33-B73E-6056640154D5}" dt="2020-04-13T04:09:22.773" v="2789" actId="1036"/>
          <ac:spMkLst>
            <pc:docMk/>
            <pc:sldMk cId="1428766084" sldId="261"/>
            <ac:spMk id="12" creationId="{16A1853A-FA4C-475B-9759-9F4AF6BE4758}"/>
          </ac:spMkLst>
        </pc:spChg>
        <pc:spChg chg="add mod topLvl">
          <ac:chgData name="Chew Leng Lim" userId="f4956819b06a5395" providerId="LiveId" clId="{64D1738D-F0F2-4F33-B73E-6056640154D5}" dt="2020-04-13T04:40:42.161" v="4911" actId="1038"/>
          <ac:spMkLst>
            <pc:docMk/>
            <pc:sldMk cId="1428766084" sldId="261"/>
            <ac:spMk id="14" creationId="{B712FAF6-2358-42E9-BF6D-A9DCACC68559}"/>
          </ac:spMkLst>
        </pc:spChg>
        <pc:spChg chg="del mod">
          <ac:chgData name="Chew Leng Lim" userId="f4956819b06a5395" providerId="LiveId" clId="{64D1738D-F0F2-4F33-B73E-6056640154D5}" dt="2020-04-13T03:57:16.313" v="1659" actId="478"/>
          <ac:spMkLst>
            <pc:docMk/>
            <pc:sldMk cId="1428766084" sldId="261"/>
            <ac:spMk id="21" creationId="{8A1760D5-80EF-4A08-9768-97CE378191EA}"/>
          </ac:spMkLst>
        </pc:spChg>
        <pc:spChg chg="mod">
          <ac:chgData name="Chew Leng Lim" userId="f4956819b06a5395" providerId="LiveId" clId="{64D1738D-F0F2-4F33-B73E-6056640154D5}" dt="2020-04-13T04:05:07.038" v="2120" actId="164"/>
          <ac:spMkLst>
            <pc:docMk/>
            <pc:sldMk cId="1428766084" sldId="261"/>
            <ac:spMk id="28" creationId="{93FD5A04-5CC8-4DC9-8DF2-B8929CFB05A4}"/>
          </ac:spMkLst>
        </pc:spChg>
        <pc:spChg chg="mod">
          <ac:chgData name="Chew Leng Lim" userId="f4956819b06a5395" providerId="LiveId" clId="{64D1738D-F0F2-4F33-B73E-6056640154D5}" dt="2020-04-13T04:05:07.038" v="2120" actId="164"/>
          <ac:spMkLst>
            <pc:docMk/>
            <pc:sldMk cId="1428766084" sldId="261"/>
            <ac:spMk id="29" creationId="{8A58921D-2F82-4961-A587-E93308C4CA9B}"/>
          </ac:spMkLst>
        </pc:spChg>
        <pc:spChg chg="mod">
          <ac:chgData name="Chew Leng Lim" userId="f4956819b06a5395" providerId="LiveId" clId="{64D1738D-F0F2-4F33-B73E-6056640154D5}" dt="2020-04-13T11:29:28.571" v="32219" actId="20577"/>
          <ac:spMkLst>
            <pc:docMk/>
            <pc:sldMk cId="1428766084" sldId="261"/>
            <ac:spMk id="30" creationId="{62214AF6-8060-4FB2-A387-35E4E2AE08DE}"/>
          </ac:spMkLst>
        </pc:spChg>
        <pc:spChg chg="mod">
          <ac:chgData name="Chew Leng Lim" userId="f4956819b06a5395" providerId="LiveId" clId="{64D1738D-F0F2-4F33-B73E-6056640154D5}" dt="2020-04-13T04:33:04.922" v="4593" actId="1036"/>
          <ac:spMkLst>
            <pc:docMk/>
            <pc:sldMk cId="1428766084" sldId="261"/>
            <ac:spMk id="34" creationId="{FA50F7F9-22AA-4616-803C-8242230E5D85}"/>
          </ac:spMkLst>
        </pc:spChg>
        <pc:spChg chg="mod">
          <ac:chgData name="Chew Leng Lim" userId="f4956819b06a5395" providerId="LiveId" clId="{64D1738D-F0F2-4F33-B73E-6056640154D5}" dt="2020-04-13T04:33:36.454" v="4620" actId="1036"/>
          <ac:spMkLst>
            <pc:docMk/>
            <pc:sldMk cId="1428766084" sldId="261"/>
            <ac:spMk id="35" creationId="{CDE15712-01F4-430B-9E2C-92F4AF0A1AF7}"/>
          </ac:spMkLst>
        </pc:spChg>
        <pc:spChg chg="del mod">
          <ac:chgData name="Chew Leng Lim" userId="f4956819b06a5395" providerId="LiveId" clId="{64D1738D-F0F2-4F33-B73E-6056640154D5}" dt="2020-04-13T04:24:37.814" v="4414" actId="478"/>
          <ac:spMkLst>
            <pc:docMk/>
            <pc:sldMk cId="1428766084" sldId="261"/>
            <ac:spMk id="44" creationId="{095451D7-CB3E-4761-80B4-B07E4857B18C}"/>
          </ac:spMkLst>
        </pc:spChg>
        <pc:spChg chg="del mod">
          <ac:chgData name="Chew Leng Lim" userId="f4956819b06a5395" providerId="LiveId" clId="{64D1738D-F0F2-4F33-B73E-6056640154D5}" dt="2020-04-13T04:24:37.814" v="4414" actId="478"/>
          <ac:spMkLst>
            <pc:docMk/>
            <pc:sldMk cId="1428766084" sldId="261"/>
            <ac:spMk id="45" creationId="{801B3942-42FC-4E74-AE92-E3653ED1AEBE}"/>
          </ac:spMkLst>
        </pc:spChg>
        <pc:spChg chg="mod">
          <ac:chgData name="Chew Leng Lim" userId="f4956819b06a5395" providerId="LiveId" clId="{64D1738D-F0F2-4F33-B73E-6056640154D5}" dt="2020-04-13T04:40:42.161" v="4911" actId="1038"/>
          <ac:spMkLst>
            <pc:docMk/>
            <pc:sldMk cId="1428766084" sldId="261"/>
            <ac:spMk id="46" creationId="{632BD00C-7687-4705-BA3C-82D9259B705D}"/>
          </ac:spMkLst>
        </pc:spChg>
        <pc:spChg chg="mod">
          <ac:chgData name="Chew Leng Lim" userId="f4956819b06a5395" providerId="LiveId" clId="{64D1738D-F0F2-4F33-B73E-6056640154D5}" dt="2020-04-13T04:14:19.606" v="3299" actId="164"/>
          <ac:spMkLst>
            <pc:docMk/>
            <pc:sldMk cId="1428766084" sldId="261"/>
            <ac:spMk id="70" creationId="{8073CA5F-F20B-4179-A6E0-BE2A45AFF5A9}"/>
          </ac:spMkLst>
        </pc:spChg>
        <pc:spChg chg="mod">
          <ac:chgData name="Chew Leng Lim" userId="f4956819b06a5395" providerId="LiveId" clId="{64D1738D-F0F2-4F33-B73E-6056640154D5}" dt="2020-04-13T04:14:19.606" v="3299" actId="164"/>
          <ac:spMkLst>
            <pc:docMk/>
            <pc:sldMk cId="1428766084" sldId="261"/>
            <ac:spMk id="71" creationId="{F4A14208-871A-4D20-BCCA-C70E11C6D9EF}"/>
          </ac:spMkLst>
        </pc:spChg>
        <pc:spChg chg="mod">
          <ac:chgData name="Chew Leng Lim" userId="f4956819b06a5395" providerId="LiveId" clId="{64D1738D-F0F2-4F33-B73E-6056640154D5}" dt="2020-04-13T04:14:19.606" v="3299" actId="164"/>
          <ac:spMkLst>
            <pc:docMk/>
            <pc:sldMk cId="1428766084" sldId="261"/>
            <ac:spMk id="72" creationId="{DCB526DD-A278-45F6-AC33-596EACDBE97A}"/>
          </ac:spMkLst>
        </pc:spChg>
        <pc:spChg chg="mod">
          <ac:chgData name="Chew Leng Lim" userId="f4956819b06a5395" providerId="LiveId" clId="{64D1738D-F0F2-4F33-B73E-6056640154D5}" dt="2020-04-13T04:14:19.606" v="3299" actId="164"/>
          <ac:spMkLst>
            <pc:docMk/>
            <pc:sldMk cId="1428766084" sldId="261"/>
            <ac:spMk id="73" creationId="{59CC46A3-8DA8-4DC5-8D09-1C3FB7345D07}"/>
          </ac:spMkLst>
        </pc:spChg>
        <pc:spChg chg="mod">
          <ac:chgData name="Chew Leng Lim" userId="f4956819b06a5395" providerId="LiveId" clId="{64D1738D-F0F2-4F33-B73E-6056640154D5}" dt="2020-04-13T04:14:19.606" v="3299" actId="164"/>
          <ac:spMkLst>
            <pc:docMk/>
            <pc:sldMk cId="1428766084" sldId="261"/>
            <ac:spMk id="74" creationId="{8CB2A5C3-044C-4D16-B52E-51D92E36D244}"/>
          </ac:spMkLst>
        </pc:spChg>
        <pc:spChg chg="mod">
          <ac:chgData name="Chew Leng Lim" userId="f4956819b06a5395" providerId="LiveId" clId="{64D1738D-F0F2-4F33-B73E-6056640154D5}" dt="2020-04-13T04:14:19.606" v="3299" actId="164"/>
          <ac:spMkLst>
            <pc:docMk/>
            <pc:sldMk cId="1428766084" sldId="261"/>
            <ac:spMk id="75" creationId="{3D1661FC-06AC-478E-A591-4B6CAF26DEB3}"/>
          </ac:spMkLst>
        </pc:spChg>
        <pc:spChg chg="mod">
          <ac:chgData name="Chew Leng Lim" userId="f4956819b06a5395" providerId="LiveId" clId="{64D1738D-F0F2-4F33-B73E-6056640154D5}" dt="2020-04-13T04:14:19.606" v="3299" actId="164"/>
          <ac:spMkLst>
            <pc:docMk/>
            <pc:sldMk cId="1428766084" sldId="261"/>
            <ac:spMk id="77" creationId="{39AC1390-2164-47A8-B125-547BC1C87474}"/>
          </ac:spMkLst>
        </pc:spChg>
        <pc:spChg chg="mod">
          <ac:chgData name="Chew Leng Lim" userId="f4956819b06a5395" providerId="LiveId" clId="{64D1738D-F0F2-4F33-B73E-6056640154D5}" dt="2020-04-13T04:05:07.038" v="2120" actId="164"/>
          <ac:spMkLst>
            <pc:docMk/>
            <pc:sldMk cId="1428766084" sldId="261"/>
            <ac:spMk id="78" creationId="{56917DA3-90A2-4C24-92C6-EDC9501D79DA}"/>
          </ac:spMkLst>
        </pc:spChg>
        <pc:spChg chg="mod topLvl">
          <ac:chgData name="Chew Leng Lim" userId="f4956819b06a5395" providerId="LiveId" clId="{64D1738D-F0F2-4F33-B73E-6056640154D5}" dt="2020-04-13T06:42:30.434" v="11130" actId="164"/>
          <ac:spMkLst>
            <pc:docMk/>
            <pc:sldMk cId="1428766084" sldId="261"/>
            <ac:spMk id="81" creationId="{B345B18E-59FD-4FD4-8AA6-ACE24B50D85D}"/>
          </ac:spMkLst>
        </pc:spChg>
        <pc:spChg chg="mod topLvl">
          <ac:chgData name="Chew Leng Lim" userId="f4956819b06a5395" providerId="LiveId" clId="{64D1738D-F0F2-4F33-B73E-6056640154D5}" dt="2020-04-13T06:42:30.434" v="11130" actId="164"/>
          <ac:spMkLst>
            <pc:docMk/>
            <pc:sldMk cId="1428766084" sldId="261"/>
            <ac:spMk id="82" creationId="{BBF8A6A0-566D-4640-9619-619A71E78DEF}"/>
          </ac:spMkLst>
        </pc:spChg>
        <pc:spChg chg="mod topLvl">
          <ac:chgData name="Chew Leng Lim" userId="f4956819b06a5395" providerId="LiveId" clId="{64D1738D-F0F2-4F33-B73E-6056640154D5}" dt="2020-04-13T06:42:30.434" v="11130" actId="164"/>
          <ac:spMkLst>
            <pc:docMk/>
            <pc:sldMk cId="1428766084" sldId="261"/>
            <ac:spMk id="84" creationId="{2F3FCCD3-A19F-4246-BA30-D8BB21C9C0C5}"/>
          </ac:spMkLst>
        </pc:spChg>
        <pc:spChg chg="mod topLvl">
          <ac:chgData name="Chew Leng Lim" userId="f4956819b06a5395" providerId="LiveId" clId="{64D1738D-F0F2-4F33-B73E-6056640154D5}" dt="2020-04-13T06:42:30.434" v="11130" actId="164"/>
          <ac:spMkLst>
            <pc:docMk/>
            <pc:sldMk cId="1428766084" sldId="261"/>
            <ac:spMk id="85" creationId="{A2525612-3DD9-4698-851B-1EA5080DC6FC}"/>
          </ac:spMkLst>
        </pc:spChg>
        <pc:spChg chg="mod topLvl">
          <ac:chgData name="Chew Leng Lim" userId="f4956819b06a5395" providerId="LiveId" clId="{64D1738D-F0F2-4F33-B73E-6056640154D5}" dt="2020-04-13T06:42:30.434" v="11130" actId="164"/>
          <ac:spMkLst>
            <pc:docMk/>
            <pc:sldMk cId="1428766084" sldId="261"/>
            <ac:spMk id="86" creationId="{B6E20A49-1F20-4E82-BB55-1CB42D6F056B}"/>
          </ac:spMkLst>
        </pc:spChg>
        <pc:spChg chg="mod topLvl">
          <ac:chgData name="Chew Leng Lim" userId="f4956819b06a5395" providerId="LiveId" clId="{64D1738D-F0F2-4F33-B73E-6056640154D5}" dt="2020-04-13T06:42:30.434" v="11130" actId="164"/>
          <ac:spMkLst>
            <pc:docMk/>
            <pc:sldMk cId="1428766084" sldId="261"/>
            <ac:spMk id="90" creationId="{C00F8D30-8189-4309-9058-9138B773DD50}"/>
          </ac:spMkLst>
        </pc:spChg>
        <pc:spChg chg="mod topLvl">
          <ac:chgData name="Chew Leng Lim" userId="f4956819b06a5395" providerId="LiveId" clId="{64D1738D-F0F2-4F33-B73E-6056640154D5}" dt="2020-04-13T06:42:30.434" v="11130" actId="164"/>
          <ac:spMkLst>
            <pc:docMk/>
            <pc:sldMk cId="1428766084" sldId="261"/>
            <ac:spMk id="91" creationId="{9570806E-9394-48BD-B7C6-BE4F32D6CFC8}"/>
          </ac:spMkLst>
        </pc:spChg>
        <pc:spChg chg="add mod topLvl">
          <ac:chgData name="Chew Leng Lim" userId="f4956819b06a5395" providerId="LiveId" clId="{64D1738D-F0F2-4F33-B73E-6056640154D5}" dt="2020-04-13T09:21:25.830" v="19192" actId="165"/>
          <ac:spMkLst>
            <pc:docMk/>
            <pc:sldMk cId="1428766084" sldId="261"/>
            <ac:spMk id="95" creationId="{A0E185DA-D573-4C67-A645-0EF4D9ABD666}"/>
          </ac:spMkLst>
        </pc:spChg>
        <pc:spChg chg="mod topLvl">
          <ac:chgData name="Chew Leng Lim" userId="f4956819b06a5395" providerId="LiveId" clId="{64D1738D-F0F2-4F33-B73E-6056640154D5}" dt="2020-04-13T06:42:30.434" v="11130" actId="164"/>
          <ac:spMkLst>
            <pc:docMk/>
            <pc:sldMk cId="1428766084" sldId="261"/>
            <ac:spMk id="96" creationId="{FF4E31A8-21D7-4CC5-ABCA-B130B9499030}"/>
          </ac:spMkLst>
        </pc:spChg>
        <pc:spChg chg="mod topLvl">
          <ac:chgData name="Chew Leng Lim" userId="f4956819b06a5395" providerId="LiveId" clId="{64D1738D-F0F2-4F33-B73E-6056640154D5}" dt="2020-04-13T06:42:30.434" v="11130" actId="164"/>
          <ac:spMkLst>
            <pc:docMk/>
            <pc:sldMk cId="1428766084" sldId="261"/>
            <ac:spMk id="98" creationId="{0C37A7B3-302A-4F12-84F2-64E3010506ED}"/>
          </ac:spMkLst>
        </pc:spChg>
        <pc:spChg chg="mod topLvl">
          <ac:chgData name="Chew Leng Lim" userId="f4956819b06a5395" providerId="LiveId" clId="{64D1738D-F0F2-4F33-B73E-6056640154D5}" dt="2020-04-13T06:43:04.725" v="11136" actId="164"/>
          <ac:spMkLst>
            <pc:docMk/>
            <pc:sldMk cId="1428766084" sldId="261"/>
            <ac:spMk id="100" creationId="{73D59EB8-09B1-4DA5-B684-F989A1F48EBB}"/>
          </ac:spMkLst>
        </pc:spChg>
        <pc:spChg chg="mod topLvl">
          <ac:chgData name="Chew Leng Lim" userId="f4956819b06a5395" providerId="LiveId" clId="{64D1738D-F0F2-4F33-B73E-6056640154D5}" dt="2020-04-13T06:43:04.725" v="11136" actId="164"/>
          <ac:spMkLst>
            <pc:docMk/>
            <pc:sldMk cId="1428766084" sldId="261"/>
            <ac:spMk id="101" creationId="{99ADE885-6CD2-4371-ACAC-B240F1A0C3C5}"/>
          </ac:spMkLst>
        </pc:spChg>
        <pc:spChg chg="mod topLvl">
          <ac:chgData name="Chew Leng Lim" userId="f4956819b06a5395" providerId="LiveId" clId="{64D1738D-F0F2-4F33-B73E-6056640154D5}" dt="2020-04-13T06:43:04.725" v="11136" actId="164"/>
          <ac:spMkLst>
            <pc:docMk/>
            <pc:sldMk cId="1428766084" sldId="261"/>
            <ac:spMk id="102" creationId="{6F02CF55-80A6-4F76-9142-FEAB3BAAE907}"/>
          </ac:spMkLst>
        </pc:spChg>
        <pc:spChg chg="mod topLvl">
          <ac:chgData name="Chew Leng Lim" userId="f4956819b06a5395" providerId="LiveId" clId="{64D1738D-F0F2-4F33-B73E-6056640154D5}" dt="2020-04-13T06:43:04.725" v="11136" actId="164"/>
          <ac:spMkLst>
            <pc:docMk/>
            <pc:sldMk cId="1428766084" sldId="261"/>
            <ac:spMk id="103" creationId="{B96D19E7-F1F5-4743-8920-192C431AFDDC}"/>
          </ac:spMkLst>
        </pc:spChg>
        <pc:spChg chg="mod topLvl">
          <ac:chgData name="Chew Leng Lim" userId="f4956819b06a5395" providerId="LiveId" clId="{64D1738D-F0F2-4F33-B73E-6056640154D5}" dt="2020-04-13T06:43:04.725" v="11136" actId="164"/>
          <ac:spMkLst>
            <pc:docMk/>
            <pc:sldMk cId="1428766084" sldId="261"/>
            <ac:spMk id="104" creationId="{9B4E1507-F839-413D-9549-AE7D0FA6FA72}"/>
          </ac:spMkLst>
        </pc:spChg>
        <pc:spChg chg="mod topLvl">
          <ac:chgData name="Chew Leng Lim" userId="f4956819b06a5395" providerId="LiveId" clId="{64D1738D-F0F2-4F33-B73E-6056640154D5}" dt="2020-04-13T06:43:04.725" v="11136" actId="164"/>
          <ac:spMkLst>
            <pc:docMk/>
            <pc:sldMk cId="1428766084" sldId="261"/>
            <ac:spMk id="107" creationId="{329B51E8-EE61-40C6-90B4-3195648CAADA}"/>
          </ac:spMkLst>
        </pc:spChg>
        <pc:spChg chg="mod topLvl">
          <ac:chgData name="Chew Leng Lim" userId="f4956819b06a5395" providerId="LiveId" clId="{64D1738D-F0F2-4F33-B73E-6056640154D5}" dt="2020-04-13T06:43:04.725" v="11136" actId="164"/>
          <ac:spMkLst>
            <pc:docMk/>
            <pc:sldMk cId="1428766084" sldId="261"/>
            <ac:spMk id="108" creationId="{751125B1-89E4-4E30-93EE-069FC2A5ACD4}"/>
          </ac:spMkLst>
        </pc:spChg>
        <pc:spChg chg="mod topLvl">
          <ac:chgData name="Chew Leng Lim" userId="f4956819b06a5395" providerId="LiveId" clId="{64D1738D-F0F2-4F33-B73E-6056640154D5}" dt="2020-04-13T06:43:04.725" v="11136" actId="164"/>
          <ac:spMkLst>
            <pc:docMk/>
            <pc:sldMk cId="1428766084" sldId="261"/>
            <ac:spMk id="112" creationId="{12B379DD-63E7-4034-8C71-4DECA7782E99}"/>
          </ac:spMkLst>
        </pc:spChg>
        <pc:spChg chg="mod topLvl">
          <ac:chgData name="Chew Leng Lim" userId="f4956819b06a5395" providerId="LiveId" clId="{64D1738D-F0F2-4F33-B73E-6056640154D5}" dt="2020-04-13T06:43:04.725" v="11136" actId="164"/>
          <ac:spMkLst>
            <pc:docMk/>
            <pc:sldMk cId="1428766084" sldId="261"/>
            <ac:spMk id="114" creationId="{CACFE5BF-FCA1-475B-8F56-306B9B7DD8BF}"/>
          </ac:spMkLst>
        </pc:spChg>
        <pc:spChg chg="add mod topLvl">
          <ac:chgData name="Chew Leng Lim" userId="f4956819b06a5395" providerId="LiveId" clId="{64D1738D-F0F2-4F33-B73E-6056640154D5}" dt="2020-04-13T09:21:25.830" v="19192" actId="165"/>
          <ac:spMkLst>
            <pc:docMk/>
            <pc:sldMk cId="1428766084" sldId="261"/>
            <ac:spMk id="115" creationId="{4FCD53EB-17FA-4C27-B318-E7D15D555FCB}"/>
          </ac:spMkLst>
        </pc:spChg>
        <pc:spChg chg="add mod topLvl">
          <ac:chgData name="Chew Leng Lim" userId="f4956819b06a5395" providerId="LiveId" clId="{64D1738D-F0F2-4F33-B73E-6056640154D5}" dt="2020-04-13T09:21:25.830" v="19192" actId="165"/>
          <ac:spMkLst>
            <pc:docMk/>
            <pc:sldMk cId="1428766084" sldId="261"/>
            <ac:spMk id="116" creationId="{B4148393-0291-46A3-A281-5A02F8C263E0}"/>
          </ac:spMkLst>
        </pc:spChg>
        <pc:spChg chg="mod">
          <ac:chgData name="Chew Leng Lim" userId="f4956819b06a5395" providerId="LiveId" clId="{64D1738D-F0F2-4F33-B73E-6056640154D5}" dt="2020-04-13T05:10:33.570" v="6595" actId="1037"/>
          <ac:spMkLst>
            <pc:docMk/>
            <pc:sldMk cId="1428766084" sldId="261"/>
            <ac:spMk id="117" creationId="{823D79EF-9CA9-4F4E-B84F-4ED8676D3FF0}"/>
          </ac:spMkLst>
        </pc:spChg>
        <pc:spChg chg="add mod topLvl">
          <ac:chgData name="Chew Leng Lim" userId="f4956819b06a5395" providerId="LiveId" clId="{64D1738D-F0F2-4F33-B73E-6056640154D5}" dt="2020-04-13T09:21:25.830" v="19192" actId="165"/>
          <ac:spMkLst>
            <pc:docMk/>
            <pc:sldMk cId="1428766084" sldId="261"/>
            <ac:spMk id="118" creationId="{D245ABCF-2F23-47A9-8719-F4C9FE13F4E4}"/>
          </ac:spMkLst>
        </pc:spChg>
        <pc:spChg chg="add mod topLvl">
          <ac:chgData name="Chew Leng Lim" userId="f4956819b06a5395" providerId="LiveId" clId="{64D1738D-F0F2-4F33-B73E-6056640154D5}" dt="2020-04-13T09:21:25.830" v="19192" actId="165"/>
          <ac:spMkLst>
            <pc:docMk/>
            <pc:sldMk cId="1428766084" sldId="261"/>
            <ac:spMk id="119" creationId="{A713F50E-6085-4241-895D-DC8FB81F81BD}"/>
          </ac:spMkLst>
        </pc:spChg>
        <pc:spChg chg="add del mod">
          <ac:chgData name="Chew Leng Lim" userId="f4956819b06a5395" providerId="LiveId" clId="{64D1738D-F0F2-4F33-B73E-6056640154D5}" dt="2020-04-13T09:12:01.337" v="19114" actId="478"/>
          <ac:spMkLst>
            <pc:docMk/>
            <pc:sldMk cId="1428766084" sldId="261"/>
            <ac:spMk id="120" creationId="{2D8C5E10-0592-402F-B2BD-66D777E03A04}"/>
          </ac:spMkLst>
        </pc:spChg>
        <pc:spChg chg="del mod">
          <ac:chgData name="Chew Leng Lim" userId="f4956819b06a5395" providerId="LiveId" clId="{64D1738D-F0F2-4F33-B73E-6056640154D5}" dt="2020-04-13T04:40:32.972" v="4901" actId="478"/>
          <ac:spMkLst>
            <pc:docMk/>
            <pc:sldMk cId="1428766084" sldId="261"/>
            <ac:spMk id="120" creationId="{89771BD3-BF15-4ACE-BBB9-A26CD9EA4245}"/>
          </ac:spMkLst>
        </pc:spChg>
        <pc:spChg chg="mod topLvl">
          <ac:chgData name="Chew Leng Lim" userId="f4956819b06a5395" providerId="LiveId" clId="{64D1738D-F0F2-4F33-B73E-6056640154D5}" dt="2020-04-13T04:40:42.161" v="4911" actId="1038"/>
          <ac:spMkLst>
            <pc:docMk/>
            <pc:sldMk cId="1428766084" sldId="261"/>
            <ac:spMk id="121" creationId="{76F705C4-E930-4CAF-BCD6-C04DF823CAFD}"/>
          </ac:spMkLst>
        </pc:spChg>
        <pc:spChg chg="mod">
          <ac:chgData name="Chew Leng Lim" userId="f4956819b06a5395" providerId="LiveId" clId="{64D1738D-F0F2-4F33-B73E-6056640154D5}" dt="2020-04-13T04:05:26.881" v="2124" actId="164"/>
          <ac:spMkLst>
            <pc:docMk/>
            <pc:sldMk cId="1428766084" sldId="261"/>
            <ac:spMk id="123" creationId="{B905FF05-745A-483C-AD7D-00C6CEE91B04}"/>
          </ac:spMkLst>
        </pc:spChg>
        <pc:spChg chg="mod">
          <ac:chgData name="Chew Leng Lim" userId="f4956819b06a5395" providerId="LiveId" clId="{64D1738D-F0F2-4F33-B73E-6056640154D5}" dt="2020-04-13T04:05:26.881" v="2124" actId="164"/>
          <ac:spMkLst>
            <pc:docMk/>
            <pc:sldMk cId="1428766084" sldId="261"/>
            <ac:spMk id="124" creationId="{A6E1723A-4EBF-41B3-A86F-14046D664922}"/>
          </ac:spMkLst>
        </pc:spChg>
        <pc:spChg chg="mod">
          <ac:chgData name="Chew Leng Lim" userId="f4956819b06a5395" providerId="LiveId" clId="{64D1738D-F0F2-4F33-B73E-6056640154D5}" dt="2020-04-13T04:09:34.363" v="2800" actId="1035"/>
          <ac:spMkLst>
            <pc:docMk/>
            <pc:sldMk cId="1428766084" sldId="261"/>
            <ac:spMk id="125" creationId="{8DBBF995-E4E6-4BBE-A526-012FE84434BD}"/>
          </ac:spMkLst>
        </pc:spChg>
        <pc:spChg chg="mod">
          <ac:chgData name="Chew Leng Lim" userId="f4956819b06a5395" providerId="LiveId" clId="{64D1738D-F0F2-4F33-B73E-6056640154D5}" dt="2020-04-13T04:05:26.881" v="2124" actId="164"/>
          <ac:spMkLst>
            <pc:docMk/>
            <pc:sldMk cId="1428766084" sldId="261"/>
            <ac:spMk id="126" creationId="{4D2F6826-8BE8-4CC5-B0A6-917FF476AF57}"/>
          </ac:spMkLst>
        </pc:spChg>
        <pc:spChg chg="mod">
          <ac:chgData name="Chew Leng Lim" userId="f4956819b06a5395" providerId="LiveId" clId="{64D1738D-F0F2-4F33-B73E-6056640154D5}" dt="2020-04-13T04:05:26.881" v="2124" actId="164"/>
          <ac:spMkLst>
            <pc:docMk/>
            <pc:sldMk cId="1428766084" sldId="261"/>
            <ac:spMk id="127" creationId="{5DEBD0FC-783D-45BA-9030-7818BFA9E3FB}"/>
          </ac:spMkLst>
        </pc:spChg>
        <pc:spChg chg="mod">
          <ac:chgData name="Chew Leng Lim" userId="f4956819b06a5395" providerId="LiveId" clId="{64D1738D-F0F2-4F33-B73E-6056640154D5}" dt="2020-04-13T06:43:23.353" v="11141" actId="1036"/>
          <ac:spMkLst>
            <pc:docMk/>
            <pc:sldMk cId="1428766084" sldId="261"/>
            <ac:spMk id="128" creationId="{5B862B6A-85A2-417C-8EA2-6B0C1BC22BD9}"/>
          </ac:spMkLst>
        </pc:spChg>
        <pc:spChg chg="mod">
          <ac:chgData name="Chew Leng Lim" userId="f4956819b06a5395" providerId="LiveId" clId="{64D1738D-F0F2-4F33-B73E-6056640154D5}" dt="2020-04-13T04:05:26.881" v="2124" actId="164"/>
          <ac:spMkLst>
            <pc:docMk/>
            <pc:sldMk cId="1428766084" sldId="261"/>
            <ac:spMk id="132" creationId="{6CBD189D-9377-4FC2-991E-C61250646124}"/>
          </ac:spMkLst>
        </pc:spChg>
        <pc:spChg chg="mod">
          <ac:chgData name="Chew Leng Lim" userId="f4956819b06a5395" providerId="LiveId" clId="{64D1738D-F0F2-4F33-B73E-6056640154D5}" dt="2020-04-13T04:05:26.881" v="2124" actId="164"/>
          <ac:spMkLst>
            <pc:docMk/>
            <pc:sldMk cId="1428766084" sldId="261"/>
            <ac:spMk id="133" creationId="{51C6A9B4-5E58-4CBA-B4AD-B37EEF6222BE}"/>
          </ac:spMkLst>
        </pc:spChg>
        <pc:spChg chg="mod">
          <ac:chgData name="Chew Leng Lim" userId="f4956819b06a5395" providerId="LiveId" clId="{64D1738D-F0F2-4F33-B73E-6056640154D5}" dt="2020-04-13T04:05:26.881" v="2124" actId="164"/>
          <ac:spMkLst>
            <pc:docMk/>
            <pc:sldMk cId="1428766084" sldId="261"/>
            <ac:spMk id="134" creationId="{A1B16BE3-E3DC-4389-AC93-4DCF15904673}"/>
          </ac:spMkLst>
        </pc:spChg>
        <pc:spChg chg="add mod topLvl">
          <ac:chgData name="Chew Leng Lim" userId="f4956819b06a5395" providerId="LiveId" clId="{64D1738D-F0F2-4F33-B73E-6056640154D5}" dt="2020-04-13T09:21:25.830" v="19192" actId="165"/>
          <ac:spMkLst>
            <pc:docMk/>
            <pc:sldMk cId="1428766084" sldId="261"/>
            <ac:spMk id="135" creationId="{BF3DBD79-91B7-4959-8172-9AD830DCB03D}"/>
          </ac:spMkLst>
        </pc:spChg>
        <pc:spChg chg="mod">
          <ac:chgData name="Chew Leng Lim" userId="f4956819b06a5395" providerId="LiveId" clId="{64D1738D-F0F2-4F33-B73E-6056640154D5}" dt="2020-04-13T04:05:15.953" v="2122" actId="164"/>
          <ac:spMkLst>
            <pc:docMk/>
            <pc:sldMk cId="1428766084" sldId="261"/>
            <ac:spMk id="136" creationId="{4D3E1084-DB82-4222-92C8-FC7D44F01840}"/>
          </ac:spMkLst>
        </pc:spChg>
        <pc:spChg chg="mod">
          <ac:chgData name="Chew Leng Lim" userId="f4956819b06a5395" providerId="LiveId" clId="{64D1738D-F0F2-4F33-B73E-6056640154D5}" dt="2020-04-13T04:05:15.953" v="2122" actId="164"/>
          <ac:spMkLst>
            <pc:docMk/>
            <pc:sldMk cId="1428766084" sldId="261"/>
            <ac:spMk id="137" creationId="{A6C789D8-BB4E-4B09-9BEA-22D45EE4C4C4}"/>
          </ac:spMkLst>
        </pc:spChg>
        <pc:spChg chg="del mod">
          <ac:chgData name="Chew Leng Lim" userId="f4956819b06a5395" providerId="LiveId" clId="{64D1738D-F0F2-4F33-B73E-6056640154D5}" dt="2020-04-13T03:57:30.034" v="1722" actId="478"/>
          <ac:spMkLst>
            <pc:docMk/>
            <pc:sldMk cId="1428766084" sldId="261"/>
            <ac:spMk id="138" creationId="{7AECE475-0856-4A91-8CB8-0E0648535BFC}"/>
          </ac:spMkLst>
        </pc:spChg>
        <pc:spChg chg="add mod">
          <ac:chgData name="Chew Leng Lim" userId="f4956819b06a5395" providerId="LiveId" clId="{64D1738D-F0F2-4F33-B73E-6056640154D5}" dt="2020-04-13T05:10:51.817" v="6603" actId="14100"/>
          <ac:spMkLst>
            <pc:docMk/>
            <pc:sldMk cId="1428766084" sldId="261"/>
            <ac:spMk id="138" creationId="{9FBEC59F-0211-409A-98B9-A2B056D1DC20}"/>
          </ac:spMkLst>
        </pc:spChg>
        <pc:spChg chg="mod">
          <ac:chgData name="Chew Leng Lim" userId="f4956819b06a5395" providerId="LiveId" clId="{64D1738D-F0F2-4F33-B73E-6056640154D5}" dt="2020-04-13T04:05:15.953" v="2122" actId="164"/>
          <ac:spMkLst>
            <pc:docMk/>
            <pc:sldMk cId="1428766084" sldId="261"/>
            <ac:spMk id="139" creationId="{3C18D8EC-6478-44D0-A724-A2DEE3CF842A}"/>
          </ac:spMkLst>
        </pc:spChg>
        <pc:spChg chg="mod">
          <ac:chgData name="Chew Leng Lim" userId="f4956819b06a5395" providerId="LiveId" clId="{64D1738D-F0F2-4F33-B73E-6056640154D5}" dt="2020-04-13T04:05:15.953" v="2122" actId="164"/>
          <ac:spMkLst>
            <pc:docMk/>
            <pc:sldMk cId="1428766084" sldId="261"/>
            <ac:spMk id="140" creationId="{F3360B35-325A-4402-AE98-A61CAD03B4C1}"/>
          </ac:spMkLst>
        </pc:spChg>
        <pc:spChg chg="add mod">
          <ac:chgData name="Chew Leng Lim" userId="f4956819b06a5395" providerId="LiveId" clId="{64D1738D-F0F2-4F33-B73E-6056640154D5}" dt="2020-04-13T05:11:04.976" v="6608" actId="1036"/>
          <ac:spMkLst>
            <pc:docMk/>
            <pc:sldMk cId="1428766084" sldId="261"/>
            <ac:spMk id="141" creationId="{AA52D2B1-C26B-4A43-B795-21D36BB29C0E}"/>
          </ac:spMkLst>
        </pc:spChg>
        <pc:spChg chg="del mod">
          <ac:chgData name="Chew Leng Lim" userId="f4956819b06a5395" providerId="LiveId" clId="{64D1738D-F0F2-4F33-B73E-6056640154D5}" dt="2020-04-13T03:57:29.382" v="1721" actId="478"/>
          <ac:spMkLst>
            <pc:docMk/>
            <pc:sldMk cId="1428766084" sldId="261"/>
            <ac:spMk id="141" creationId="{B5020E00-32EB-4E5A-A613-68A286D251F3}"/>
          </ac:spMkLst>
        </pc:spChg>
        <pc:spChg chg="mod">
          <ac:chgData name="Chew Leng Lim" userId="f4956819b06a5395" providerId="LiveId" clId="{64D1738D-F0F2-4F33-B73E-6056640154D5}" dt="2020-04-13T04:18:35.040" v="3751" actId="6549"/>
          <ac:spMkLst>
            <pc:docMk/>
            <pc:sldMk cId="1428766084" sldId="261"/>
            <ac:spMk id="142" creationId="{6C375AD2-A466-4093-BF8E-72A4EFEE0DA9}"/>
          </ac:spMkLst>
        </pc:spChg>
        <pc:spChg chg="del mod">
          <ac:chgData name="Chew Leng Lim" userId="f4956819b06a5395" providerId="LiveId" clId="{64D1738D-F0F2-4F33-B73E-6056640154D5}" dt="2020-04-13T03:57:39.320" v="1743" actId="478"/>
          <ac:spMkLst>
            <pc:docMk/>
            <pc:sldMk cId="1428766084" sldId="261"/>
            <ac:spMk id="143" creationId="{477037BC-A6D8-4A9F-AE62-D87186985CA0}"/>
          </ac:spMkLst>
        </pc:spChg>
        <pc:spChg chg="add mod">
          <ac:chgData name="Chew Leng Lim" userId="f4956819b06a5395" providerId="LiveId" clId="{64D1738D-F0F2-4F33-B73E-6056640154D5}" dt="2020-04-13T05:11:04.976" v="6608" actId="1036"/>
          <ac:spMkLst>
            <pc:docMk/>
            <pc:sldMk cId="1428766084" sldId="261"/>
            <ac:spMk id="143" creationId="{4A0EA091-C59C-477C-962F-7A1867A1CF32}"/>
          </ac:spMkLst>
        </pc:spChg>
        <pc:spChg chg="del mod">
          <ac:chgData name="Chew Leng Lim" userId="f4956819b06a5395" providerId="LiveId" clId="{64D1738D-F0F2-4F33-B73E-6056640154D5}" dt="2020-04-13T04:02:15.447" v="1760" actId="478"/>
          <ac:spMkLst>
            <pc:docMk/>
            <pc:sldMk cId="1428766084" sldId="261"/>
            <ac:spMk id="144" creationId="{BCFDBF16-0EA8-4E8A-A126-B148A1416CF7}"/>
          </ac:spMkLst>
        </pc:spChg>
        <pc:spChg chg="add mod">
          <ac:chgData name="Chew Leng Lim" userId="f4956819b06a5395" providerId="LiveId" clId="{64D1738D-F0F2-4F33-B73E-6056640154D5}" dt="2020-04-13T05:10:56.017" v="6605" actId="1035"/>
          <ac:spMkLst>
            <pc:docMk/>
            <pc:sldMk cId="1428766084" sldId="261"/>
            <ac:spMk id="145" creationId="{9A8E870E-D0A4-405B-9550-A0F9B4C046CE}"/>
          </ac:spMkLst>
        </pc:spChg>
        <pc:spChg chg="del">
          <ac:chgData name="Chew Leng Lim" userId="f4956819b06a5395" providerId="LiveId" clId="{64D1738D-F0F2-4F33-B73E-6056640154D5}" dt="2020-04-13T04:03:32.175" v="1885" actId="478"/>
          <ac:spMkLst>
            <pc:docMk/>
            <pc:sldMk cId="1428766084" sldId="261"/>
            <ac:spMk id="146" creationId="{1E9B0C54-1BEC-4E89-B2DD-9993F87DDC5C}"/>
          </ac:spMkLst>
        </pc:spChg>
        <pc:spChg chg="del">
          <ac:chgData name="Chew Leng Lim" userId="f4956819b06a5395" providerId="LiveId" clId="{64D1738D-F0F2-4F33-B73E-6056640154D5}" dt="2020-04-13T04:03:32.175" v="1885" actId="478"/>
          <ac:spMkLst>
            <pc:docMk/>
            <pc:sldMk cId="1428766084" sldId="261"/>
            <ac:spMk id="185" creationId="{E0CF3FE2-CE78-443D-9755-5FFAF53DAEB9}"/>
          </ac:spMkLst>
        </pc:spChg>
        <pc:spChg chg="del">
          <ac:chgData name="Chew Leng Lim" userId="f4956819b06a5395" providerId="LiveId" clId="{64D1738D-F0F2-4F33-B73E-6056640154D5}" dt="2020-04-13T04:03:32.175" v="1885" actId="478"/>
          <ac:spMkLst>
            <pc:docMk/>
            <pc:sldMk cId="1428766084" sldId="261"/>
            <ac:spMk id="186" creationId="{30018E6D-0EAB-4078-B6F3-563A793EE6D8}"/>
          </ac:spMkLst>
        </pc:spChg>
        <pc:spChg chg="del">
          <ac:chgData name="Chew Leng Lim" userId="f4956819b06a5395" providerId="LiveId" clId="{64D1738D-F0F2-4F33-B73E-6056640154D5}" dt="2020-04-13T04:03:32.175" v="1885" actId="478"/>
          <ac:spMkLst>
            <pc:docMk/>
            <pc:sldMk cId="1428766084" sldId="261"/>
            <ac:spMk id="187" creationId="{F18D0FFA-01E9-448D-BDD9-E70D78962863}"/>
          </ac:spMkLst>
        </pc:spChg>
        <pc:spChg chg="del">
          <ac:chgData name="Chew Leng Lim" userId="f4956819b06a5395" providerId="LiveId" clId="{64D1738D-F0F2-4F33-B73E-6056640154D5}" dt="2020-04-13T04:03:32.175" v="1885" actId="478"/>
          <ac:spMkLst>
            <pc:docMk/>
            <pc:sldMk cId="1428766084" sldId="261"/>
            <ac:spMk id="188" creationId="{F8FD783D-C790-4CD6-8DC8-0500437334FB}"/>
          </ac:spMkLst>
        </pc:spChg>
        <pc:spChg chg="del">
          <ac:chgData name="Chew Leng Lim" userId="f4956819b06a5395" providerId="LiveId" clId="{64D1738D-F0F2-4F33-B73E-6056640154D5}" dt="2020-04-13T04:03:32.175" v="1885" actId="478"/>
          <ac:spMkLst>
            <pc:docMk/>
            <pc:sldMk cId="1428766084" sldId="261"/>
            <ac:spMk id="189" creationId="{224B98AD-7D38-4153-B24E-66DAE149071F}"/>
          </ac:spMkLst>
        </pc:spChg>
        <pc:spChg chg="del">
          <ac:chgData name="Chew Leng Lim" userId="f4956819b06a5395" providerId="LiveId" clId="{64D1738D-F0F2-4F33-B73E-6056640154D5}" dt="2020-04-13T04:03:32.175" v="1885" actId="478"/>
          <ac:spMkLst>
            <pc:docMk/>
            <pc:sldMk cId="1428766084" sldId="261"/>
            <ac:spMk id="190" creationId="{CFF89134-ACE0-4875-B868-B9035CFA136B}"/>
          </ac:spMkLst>
        </pc:spChg>
        <pc:spChg chg="del">
          <ac:chgData name="Chew Leng Lim" userId="f4956819b06a5395" providerId="LiveId" clId="{64D1738D-F0F2-4F33-B73E-6056640154D5}" dt="2020-04-13T04:03:32.175" v="1885" actId="478"/>
          <ac:spMkLst>
            <pc:docMk/>
            <pc:sldMk cId="1428766084" sldId="261"/>
            <ac:spMk id="191" creationId="{742828D2-7E29-44D3-A350-D6802B13E2DD}"/>
          </ac:spMkLst>
        </pc:spChg>
        <pc:spChg chg="del">
          <ac:chgData name="Chew Leng Lim" userId="f4956819b06a5395" providerId="LiveId" clId="{64D1738D-F0F2-4F33-B73E-6056640154D5}" dt="2020-04-13T04:03:32.175" v="1885" actId="478"/>
          <ac:spMkLst>
            <pc:docMk/>
            <pc:sldMk cId="1428766084" sldId="261"/>
            <ac:spMk id="192" creationId="{CFA6CB51-87FA-4491-AFFC-6B73BEB9A398}"/>
          </ac:spMkLst>
        </pc:spChg>
        <pc:spChg chg="del">
          <ac:chgData name="Chew Leng Lim" userId="f4956819b06a5395" providerId="LiveId" clId="{64D1738D-F0F2-4F33-B73E-6056640154D5}" dt="2020-04-13T04:03:32.175" v="1885" actId="478"/>
          <ac:spMkLst>
            <pc:docMk/>
            <pc:sldMk cId="1428766084" sldId="261"/>
            <ac:spMk id="193" creationId="{51131C5E-2864-4CF8-8E91-D8D143B4967F}"/>
          </ac:spMkLst>
        </pc:spChg>
        <pc:grpChg chg="add mod">
          <ac:chgData name="Chew Leng Lim" userId="f4956819b06a5395" providerId="LiveId" clId="{64D1738D-F0F2-4F33-B73E-6056640154D5}" dt="2020-04-13T05:11:15.814" v="6612" actId="1035"/>
          <ac:grpSpMkLst>
            <pc:docMk/>
            <pc:sldMk cId="1428766084" sldId="261"/>
            <ac:grpSpMk id="3" creationId="{3DB526E3-146A-473F-86EA-5A640BFBB60C}"/>
          </ac:grpSpMkLst>
        </pc:grpChg>
        <pc:grpChg chg="add del mod">
          <ac:chgData name="Chew Leng Lim" userId="f4956819b06a5395" providerId="LiveId" clId="{64D1738D-F0F2-4F33-B73E-6056640154D5}" dt="2020-04-13T06:42:08.417" v="11123" actId="165"/>
          <ac:grpSpMkLst>
            <pc:docMk/>
            <pc:sldMk cId="1428766084" sldId="261"/>
            <ac:grpSpMk id="4" creationId="{5EF8A717-0E2F-4DE2-B8F2-E4D7F278E0AF}"/>
          </ac:grpSpMkLst>
        </pc:grpChg>
        <pc:grpChg chg="add mod">
          <ac:chgData name="Chew Leng Lim" userId="f4956819b06a5395" providerId="LiveId" clId="{64D1738D-F0F2-4F33-B73E-6056640154D5}" dt="2020-04-13T04:40:42.161" v="4911" actId="1038"/>
          <ac:grpSpMkLst>
            <pc:docMk/>
            <pc:sldMk cId="1428766084" sldId="261"/>
            <ac:grpSpMk id="5" creationId="{3AF112F4-AD0F-4BD9-9F66-17701EC5AE3C}"/>
          </ac:grpSpMkLst>
        </pc:grpChg>
        <pc:grpChg chg="add del mod">
          <ac:chgData name="Chew Leng Lim" userId="f4956819b06a5395" providerId="LiveId" clId="{64D1738D-F0F2-4F33-B73E-6056640154D5}" dt="2020-04-13T09:21:25.830" v="19192" actId="165"/>
          <ac:grpSpMkLst>
            <pc:docMk/>
            <pc:sldMk cId="1428766084" sldId="261"/>
            <ac:grpSpMk id="7" creationId="{2971869F-89F3-4CAD-8BE8-2759139A52FB}"/>
          </ac:grpSpMkLst>
        </pc:grpChg>
        <pc:grpChg chg="add mod topLvl">
          <ac:chgData name="Chew Leng Lim" userId="f4956819b06a5395" providerId="LiveId" clId="{64D1738D-F0F2-4F33-B73E-6056640154D5}" dt="2020-04-13T05:10:17.067" v="6588" actId="1038"/>
          <ac:grpSpMkLst>
            <pc:docMk/>
            <pc:sldMk cId="1428766084" sldId="261"/>
            <ac:grpSpMk id="13" creationId="{0D65FBD3-8311-46B7-BE9C-96881A6AC280}"/>
          </ac:grpSpMkLst>
        </pc:grpChg>
        <pc:grpChg chg="add del mod">
          <ac:chgData name="Chew Leng Lim" userId="f4956819b06a5395" providerId="LiveId" clId="{64D1738D-F0F2-4F33-B73E-6056640154D5}" dt="2020-04-13T06:42:34.979" v="11131" actId="165"/>
          <ac:grpSpMkLst>
            <pc:docMk/>
            <pc:sldMk cId="1428766084" sldId="261"/>
            <ac:grpSpMk id="15" creationId="{ACD5542F-8332-4DD6-BDD2-ABD74CAA8292}"/>
          </ac:grpSpMkLst>
        </pc:grpChg>
        <pc:grpChg chg="add mod">
          <ac:chgData name="Chew Leng Lim" userId="f4956819b06a5395" providerId="LiveId" clId="{64D1738D-F0F2-4F33-B73E-6056640154D5}" dt="2020-04-13T05:11:10.249" v="6609" actId="1036"/>
          <ac:grpSpMkLst>
            <pc:docMk/>
            <pc:sldMk cId="1428766084" sldId="261"/>
            <ac:grpSpMk id="16" creationId="{9D839385-374D-4736-80B7-B66B43AD2903}"/>
          </ac:grpSpMkLst>
        </pc:grpChg>
        <pc:grpChg chg="add mod">
          <ac:chgData name="Chew Leng Lim" userId="f4956819b06a5395" providerId="LiveId" clId="{64D1738D-F0F2-4F33-B73E-6056640154D5}" dt="2020-04-13T06:42:30.434" v="11130" actId="164"/>
          <ac:grpSpMkLst>
            <pc:docMk/>
            <pc:sldMk cId="1428766084" sldId="261"/>
            <ac:grpSpMk id="17" creationId="{2459C13A-79C5-4D33-BF80-742D4FC4255F}"/>
          </ac:grpSpMkLst>
        </pc:grpChg>
        <pc:grpChg chg="add del mod">
          <ac:chgData name="Chew Leng Lim" userId="f4956819b06a5395" providerId="LiveId" clId="{64D1738D-F0F2-4F33-B73E-6056640154D5}" dt="2020-04-13T04:22:10.223" v="4205" actId="165"/>
          <ac:grpSpMkLst>
            <pc:docMk/>
            <pc:sldMk cId="1428766084" sldId="261"/>
            <ac:grpSpMk id="17" creationId="{8645AA9D-A68D-45C5-95F4-519ED0B0081F}"/>
          </ac:grpSpMkLst>
        </pc:grpChg>
        <pc:grpChg chg="add mod">
          <ac:chgData name="Chew Leng Lim" userId="f4956819b06a5395" providerId="LiveId" clId="{64D1738D-F0F2-4F33-B73E-6056640154D5}" dt="2020-04-13T06:43:04.725" v="11136" actId="164"/>
          <ac:grpSpMkLst>
            <pc:docMk/>
            <pc:sldMk cId="1428766084" sldId="261"/>
            <ac:grpSpMk id="18" creationId="{B2EB6EA8-A424-4E79-B87B-F656CEF5C6F4}"/>
          </ac:grpSpMkLst>
        </pc:grpChg>
        <pc:graphicFrameChg chg="mod">
          <ac:chgData name="Chew Leng Lim" userId="f4956819b06a5395" providerId="LiveId" clId="{64D1738D-F0F2-4F33-B73E-6056640154D5}" dt="2020-04-13T04:05:07.038" v="2120" actId="164"/>
          <ac:graphicFrameMkLst>
            <pc:docMk/>
            <pc:sldMk cId="1428766084" sldId="261"/>
            <ac:graphicFrameMk id="6" creationId="{991507A3-7274-4E7A-BEF3-A27BD3D5C3FF}"/>
          </ac:graphicFrameMkLst>
        </pc:graphicFrameChg>
        <pc:graphicFrameChg chg="mod">
          <ac:chgData name="Chew Leng Lim" userId="f4956819b06a5395" providerId="LiveId" clId="{64D1738D-F0F2-4F33-B73E-6056640154D5}" dt="2020-04-13T04:14:19.606" v="3299" actId="164"/>
          <ac:graphicFrameMkLst>
            <pc:docMk/>
            <pc:sldMk cId="1428766084" sldId="261"/>
            <ac:graphicFrameMk id="69" creationId="{C057413A-1021-435D-AB69-9A491737E78A}"/>
          </ac:graphicFrameMkLst>
        </pc:graphicFrameChg>
        <pc:graphicFrameChg chg="mod topLvl">
          <ac:chgData name="Chew Leng Lim" userId="f4956819b06a5395" providerId="LiveId" clId="{64D1738D-F0F2-4F33-B73E-6056640154D5}" dt="2020-04-13T06:42:30.434" v="11130" actId="164"/>
          <ac:graphicFrameMkLst>
            <pc:docMk/>
            <pc:sldMk cId="1428766084" sldId="261"/>
            <ac:graphicFrameMk id="80" creationId="{46262B4F-0989-4CC1-8383-D70A2EC1695D}"/>
          </ac:graphicFrameMkLst>
        </pc:graphicFrameChg>
        <pc:graphicFrameChg chg="mod topLvl">
          <ac:chgData name="Chew Leng Lim" userId="f4956819b06a5395" providerId="LiveId" clId="{64D1738D-F0F2-4F33-B73E-6056640154D5}" dt="2020-04-13T06:43:04.725" v="11136" actId="164"/>
          <ac:graphicFrameMkLst>
            <pc:docMk/>
            <pc:sldMk cId="1428766084" sldId="261"/>
            <ac:graphicFrameMk id="99" creationId="{DAD8D310-D559-4499-B5FD-5E67DE3A07B3}"/>
          </ac:graphicFrameMkLst>
        </pc:graphicFrameChg>
        <pc:graphicFrameChg chg="add mod">
          <ac:chgData name="Chew Leng Lim" userId="f4956819b06a5395" providerId="LiveId" clId="{64D1738D-F0F2-4F33-B73E-6056640154D5}" dt="2020-04-13T03:46:45.242" v="488" actId="571"/>
          <ac:graphicFrameMkLst>
            <pc:docMk/>
            <pc:sldMk cId="1428766084" sldId="261"/>
            <ac:graphicFrameMk id="115" creationId="{2429680B-0719-4427-A145-417DB0DE625F}"/>
          </ac:graphicFrameMkLst>
        </pc:graphicFrameChg>
        <pc:graphicFrameChg chg="add mod">
          <ac:chgData name="Chew Leng Lim" userId="f4956819b06a5395" providerId="LiveId" clId="{64D1738D-F0F2-4F33-B73E-6056640154D5}" dt="2020-04-13T03:46:45.242" v="488" actId="571"/>
          <ac:graphicFrameMkLst>
            <pc:docMk/>
            <pc:sldMk cId="1428766084" sldId="261"/>
            <ac:graphicFrameMk id="116" creationId="{B8B15408-0EBD-4034-B59A-77888ECBFC7B}"/>
          </ac:graphicFrameMkLst>
        </pc:graphicFrameChg>
        <pc:graphicFrameChg chg="add mod">
          <ac:chgData name="Chew Leng Lim" userId="f4956819b06a5395" providerId="LiveId" clId="{64D1738D-F0F2-4F33-B73E-6056640154D5}" dt="2020-04-13T03:46:45.242" v="488" actId="571"/>
          <ac:graphicFrameMkLst>
            <pc:docMk/>
            <pc:sldMk cId="1428766084" sldId="261"/>
            <ac:graphicFrameMk id="118" creationId="{39F08D90-E08E-4566-BCF6-931C8B8BBAEC}"/>
          </ac:graphicFrameMkLst>
        </pc:graphicFrameChg>
        <pc:graphicFrameChg chg="mod">
          <ac:chgData name="Chew Leng Lim" userId="f4956819b06a5395" providerId="LiveId" clId="{64D1738D-F0F2-4F33-B73E-6056640154D5}" dt="2020-04-13T04:05:26.881" v="2124" actId="164"/>
          <ac:graphicFrameMkLst>
            <pc:docMk/>
            <pc:sldMk cId="1428766084" sldId="261"/>
            <ac:graphicFrameMk id="122" creationId="{D36BE223-E92E-4D39-BB78-C373F8587BA0}"/>
          </ac:graphicFrameMkLst>
        </pc:graphicFrameChg>
        <pc:cxnChg chg="mod">
          <ac:chgData name="Chew Leng Lim" userId="f4956819b06a5395" providerId="LiveId" clId="{64D1738D-F0F2-4F33-B73E-6056640154D5}" dt="2020-04-13T04:05:07.038" v="2120" actId="164"/>
          <ac:cxnSpMkLst>
            <pc:docMk/>
            <pc:sldMk cId="1428766084" sldId="261"/>
            <ac:cxnSpMk id="25" creationId="{16B2E33D-6281-4DD4-89CB-8FFED174EDC7}"/>
          </ac:cxnSpMkLst>
        </pc:cxnChg>
        <pc:cxnChg chg="mod">
          <ac:chgData name="Chew Leng Lim" userId="f4956819b06a5395" providerId="LiveId" clId="{64D1738D-F0F2-4F33-B73E-6056640154D5}" dt="2020-04-13T04:05:07.038" v="2120" actId="164"/>
          <ac:cxnSpMkLst>
            <pc:docMk/>
            <pc:sldMk cId="1428766084" sldId="261"/>
            <ac:cxnSpMk id="26" creationId="{62503267-04CA-42A8-BE0A-072461B4FD3C}"/>
          </ac:cxnSpMkLst>
        </pc:cxnChg>
        <pc:cxnChg chg="mod">
          <ac:chgData name="Chew Leng Lim" userId="f4956819b06a5395" providerId="LiveId" clId="{64D1738D-F0F2-4F33-B73E-6056640154D5}" dt="2020-04-13T04:05:07.038" v="2120" actId="164"/>
          <ac:cxnSpMkLst>
            <pc:docMk/>
            <pc:sldMk cId="1428766084" sldId="261"/>
            <ac:cxnSpMk id="31" creationId="{43598DEB-311B-4BC5-82D0-710210F162B4}"/>
          </ac:cxnSpMkLst>
        </pc:cxnChg>
        <pc:cxnChg chg="mod">
          <ac:chgData name="Chew Leng Lim" userId="f4956819b06a5395" providerId="LiveId" clId="{64D1738D-F0F2-4F33-B73E-6056640154D5}" dt="2020-04-13T04:05:07.038" v="2120" actId="164"/>
          <ac:cxnSpMkLst>
            <pc:docMk/>
            <pc:sldMk cId="1428766084" sldId="261"/>
            <ac:cxnSpMk id="32" creationId="{E85F2392-1147-4203-8B54-505C779523ED}"/>
          </ac:cxnSpMkLst>
        </pc:cxnChg>
        <pc:cxnChg chg="mod">
          <ac:chgData name="Chew Leng Lim" userId="f4956819b06a5395" providerId="LiveId" clId="{64D1738D-F0F2-4F33-B73E-6056640154D5}" dt="2020-04-13T04:05:07.038" v="2120" actId="164"/>
          <ac:cxnSpMkLst>
            <pc:docMk/>
            <pc:sldMk cId="1428766084" sldId="261"/>
            <ac:cxnSpMk id="33" creationId="{8D667F4B-B356-47CA-9070-BBF90F773958}"/>
          </ac:cxnSpMkLst>
        </pc:cxnChg>
        <pc:cxnChg chg="mod topLvl">
          <ac:chgData name="Chew Leng Lim" userId="f4956819b06a5395" providerId="LiveId" clId="{64D1738D-F0F2-4F33-B73E-6056640154D5}" dt="2020-04-13T06:42:30.434" v="11130" actId="164"/>
          <ac:cxnSpMkLst>
            <pc:docMk/>
            <pc:sldMk cId="1428766084" sldId="261"/>
            <ac:cxnSpMk id="88" creationId="{9D87A062-6766-41F6-820C-024330BACB33}"/>
          </ac:cxnSpMkLst>
        </pc:cxnChg>
        <pc:cxnChg chg="mod topLvl">
          <ac:chgData name="Chew Leng Lim" userId="f4956819b06a5395" providerId="LiveId" clId="{64D1738D-F0F2-4F33-B73E-6056640154D5}" dt="2020-04-13T06:42:30.434" v="11130" actId="164"/>
          <ac:cxnSpMkLst>
            <pc:docMk/>
            <pc:sldMk cId="1428766084" sldId="261"/>
            <ac:cxnSpMk id="89" creationId="{67E2D418-47C3-4EC2-9CC8-ED62A70F567B}"/>
          </ac:cxnSpMkLst>
        </pc:cxnChg>
        <pc:cxnChg chg="mod topLvl">
          <ac:chgData name="Chew Leng Lim" userId="f4956819b06a5395" providerId="LiveId" clId="{64D1738D-F0F2-4F33-B73E-6056640154D5}" dt="2020-04-13T06:42:30.434" v="11130" actId="164"/>
          <ac:cxnSpMkLst>
            <pc:docMk/>
            <pc:sldMk cId="1428766084" sldId="261"/>
            <ac:cxnSpMk id="92" creationId="{B3E1918E-1EC0-4F55-934C-04A321573402}"/>
          </ac:cxnSpMkLst>
        </pc:cxnChg>
        <pc:cxnChg chg="mod topLvl">
          <ac:chgData name="Chew Leng Lim" userId="f4956819b06a5395" providerId="LiveId" clId="{64D1738D-F0F2-4F33-B73E-6056640154D5}" dt="2020-04-13T06:42:30.434" v="11130" actId="164"/>
          <ac:cxnSpMkLst>
            <pc:docMk/>
            <pc:sldMk cId="1428766084" sldId="261"/>
            <ac:cxnSpMk id="93" creationId="{F7590234-53C5-42C5-BCB8-877016184A9E}"/>
          </ac:cxnSpMkLst>
        </pc:cxnChg>
        <pc:cxnChg chg="mod topLvl">
          <ac:chgData name="Chew Leng Lim" userId="f4956819b06a5395" providerId="LiveId" clId="{64D1738D-F0F2-4F33-B73E-6056640154D5}" dt="2020-04-13T06:42:30.434" v="11130" actId="164"/>
          <ac:cxnSpMkLst>
            <pc:docMk/>
            <pc:sldMk cId="1428766084" sldId="261"/>
            <ac:cxnSpMk id="94" creationId="{28ED4A4D-9ACF-480F-98EC-6FA53C25C604}"/>
          </ac:cxnSpMkLst>
        </pc:cxnChg>
        <pc:cxnChg chg="mod topLvl">
          <ac:chgData name="Chew Leng Lim" userId="f4956819b06a5395" providerId="LiveId" clId="{64D1738D-F0F2-4F33-B73E-6056640154D5}" dt="2020-04-13T06:42:30.434" v="11130" actId="164"/>
          <ac:cxnSpMkLst>
            <pc:docMk/>
            <pc:sldMk cId="1428766084" sldId="261"/>
            <ac:cxnSpMk id="97" creationId="{5D8DB720-B925-49E0-ABB9-9B514C274304}"/>
          </ac:cxnSpMkLst>
        </pc:cxnChg>
        <pc:cxnChg chg="mod topLvl">
          <ac:chgData name="Chew Leng Lim" userId="f4956819b06a5395" providerId="LiveId" clId="{64D1738D-F0F2-4F33-B73E-6056640154D5}" dt="2020-04-13T06:43:04.725" v="11136" actId="164"/>
          <ac:cxnSpMkLst>
            <pc:docMk/>
            <pc:sldMk cId="1428766084" sldId="261"/>
            <ac:cxnSpMk id="105" creationId="{B4396CE3-E160-4CB8-A9B2-ACBB92AD6453}"/>
          </ac:cxnSpMkLst>
        </pc:cxnChg>
        <pc:cxnChg chg="mod topLvl">
          <ac:chgData name="Chew Leng Lim" userId="f4956819b06a5395" providerId="LiveId" clId="{64D1738D-F0F2-4F33-B73E-6056640154D5}" dt="2020-04-13T06:43:04.725" v="11136" actId="164"/>
          <ac:cxnSpMkLst>
            <pc:docMk/>
            <pc:sldMk cId="1428766084" sldId="261"/>
            <ac:cxnSpMk id="106" creationId="{859F79A1-26A2-4978-8A7F-875E00C58B7B}"/>
          </ac:cxnSpMkLst>
        </pc:cxnChg>
        <pc:cxnChg chg="mod topLvl">
          <ac:chgData name="Chew Leng Lim" userId="f4956819b06a5395" providerId="LiveId" clId="{64D1738D-F0F2-4F33-B73E-6056640154D5}" dt="2020-04-13T06:43:04.725" v="11136" actId="164"/>
          <ac:cxnSpMkLst>
            <pc:docMk/>
            <pc:sldMk cId="1428766084" sldId="261"/>
            <ac:cxnSpMk id="109" creationId="{B2EDBC53-1C65-4FBB-AA3A-C17AA3733F51}"/>
          </ac:cxnSpMkLst>
        </pc:cxnChg>
        <pc:cxnChg chg="mod topLvl">
          <ac:chgData name="Chew Leng Lim" userId="f4956819b06a5395" providerId="LiveId" clId="{64D1738D-F0F2-4F33-B73E-6056640154D5}" dt="2020-04-13T06:43:04.725" v="11136" actId="164"/>
          <ac:cxnSpMkLst>
            <pc:docMk/>
            <pc:sldMk cId="1428766084" sldId="261"/>
            <ac:cxnSpMk id="110" creationId="{B8336AF4-8DC4-4104-B7F5-64A6F0C1073C}"/>
          </ac:cxnSpMkLst>
        </pc:cxnChg>
        <pc:cxnChg chg="mod topLvl">
          <ac:chgData name="Chew Leng Lim" userId="f4956819b06a5395" providerId="LiveId" clId="{64D1738D-F0F2-4F33-B73E-6056640154D5}" dt="2020-04-13T06:43:04.725" v="11136" actId="164"/>
          <ac:cxnSpMkLst>
            <pc:docMk/>
            <pc:sldMk cId="1428766084" sldId="261"/>
            <ac:cxnSpMk id="111" creationId="{403F05C5-36A2-4CD8-B9A4-4FF0A7B58C20}"/>
          </ac:cxnSpMkLst>
        </pc:cxnChg>
        <pc:cxnChg chg="mod topLvl">
          <ac:chgData name="Chew Leng Lim" userId="f4956819b06a5395" providerId="LiveId" clId="{64D1738D-F0F2-4F33-B73E-6056640154D5}" dt="2020-04-13T06:43:04.725" v="11136" actId="164"/>
          <ac:cxnSpMkLst>
            <pc:docMk/>
            <pc:sldMk cId="1428766084" sldId="261"/>
            <ac:cxnSpMk id="113" creationId="{6DDCD14D-6408-40F7-B0F3-3CD43D646326}"/>
          </ac:cxnSpMkLst>
        </pc:cxnChg>
        <pc:cxnChg chg="mod">
          <ac:chgData name="Chew Leng Lim" userId="f4956819b06a5395" providerId="LiveId" clId="{64D1738D-F0F2-4F33-B73E-6056640154D5}" dt="2020-04-13T06:43:23.353" v="11141" actId="1036"/>
          <ac:cxnSpMkLst>
            <pc:docMk/>
            <pc:sldMk cId="1428766084" sldId="261"/>
            <ac:cxnSpMk id="129" creationId="{DF0C095F-092A-4198-AEDB-8C57FC6401DE}"/>
          </ac:cxnSpMkLst>
        </pc:cxnChg>
        <pc:cxnChg chg="mod">
          <ac:chgData name="Chew Leng Lim" userId="f4956819b06a5395" providerId="LiveId" clId="{64D1738D-F0F2-4F33-B73E-6056640154D5}" dt="2020-04-13T06:43:23.353" v="11141" actId="1036"/>
          <ac:cxnSpMkLst>
            <pc:docMk/>
            <pc:sldMk cId="1428766084" sldId="261"/>
            <ac:cxnSpMk id="130" creationId="{AEE4730F-D1B5-4D39-B774-D7B809579A70}"/>
          </ac:cxnSpMkLst>
        </pc:cxnChg>
        <pc:cxnChg chg="mod">
          <ac:chgData name="Chew Leng Lim" userId="f4956819b06a5395" providerId="LiveId" clId="{64D1738D-F0F2-4F33-B73E-6056640154D5}" dt="2020-04-13T06:43:23.353" v="11141" actId="1036"/>
          <ac:cxnSpMkLst>
            <pc:docMk/>
            <pc:sldMk cId="1428766084" sldId="261"/>
            <ac:cxnSpMk id="131" creationId="{E5256EB5-9A6A-442F-A8DF-470D02502D3B}"/>
          </ac:cxnSpMkLst>
        </pc:cxnChg>
      </pc:sldChg>
      <pc:sldChg chg="del">
        <pc:chgData name="Chew Leng Lim" userId="f4956819b06a5395" providerId="LiveId" clId="{64D1738D-F0F2-4F33-B73E-6056640154D5}" dt="2020-04-13T06:28:50.821" v="10601" actId="2696"/>
        <pc:sldMkLst>
          <pc:docMk/>
          <pc:sldMk cId="895125365" sldId="263"/>
        </pc:sldMkLst>
      </pc:sldChg>
      <pc:sldChg chg="addSp delSp modSp">
        <pc:chgData name="Chew Leng Lim" userId="f4956819b06a5395" providerId="LiveId" clId="{64D1738D-F0F2-4F33-B73E-6056640154D5}" dt="2020-04-13T11:30:52.251" v="32238" actId="20577"/>
        <pc:sldMkLst>
          <pc:docMk/>
          <pc:sldMk cId="1896826950" sldId="296"/>
        </pc:sldMkLst>
        <pc:spChg chg="add mod topLvl">
          <ac:chgData name="Chew Leng Lim" userId="f4956819b06a5395" providerId="LiveId" clId="{64D1738D-F0F2-4F33-B73E-6056640154D5}" dt="2020-04-13T05:14:20.081" v="6840" actId="164"/>
          <ac:spMkLst>
            <pc:docMk/>
            <pc:sldMk cId="1896826950" sldId="296"/>
            <ac:spMk id="2" creationId="{B8135D6D-14C4-4B3E-AE19-3549285BD9F7}"/>
          </ac:spMkLst>
        </pc:spChg>
        <pc:spChg chg="mod">
          <ac:chgData name="Chew Leng Lim" userId="f4956819b06a5395" providerId="LiveId" clId="{64D1738D-F0F2-4F33-B73E-6056640154D5}" dt="2020-04-13T05:22:50.240" v="7329" actId="164"/>
          <ac:spMkLst>
            <pc:docMk/>
            <pc:sldMk cId="1896826950" sldId="296"/>
            <ac:spMk id="5" creationId="{4268448E-44BF-4DE0-9D1F-4D88C3BC9B2B}"/>
          </ac:spMkLst>
        </pc:spChg>
        <pc:spChg chg="mod">
          <ac:chgData name="Chew Leng Lim" userId="f4956819b06a5395" providerId="LiveId" clId="{64D1738D-F0F2-4F33-B73E-6056640154D5}" dt="2020-04-13T05:22:50.240" v="7329" actId="164"/>
          <ac:spMkLst>
            <pc:docMk/>
            <pc:sldMk cId="1896826950" sldId="296"/>
            <ac:spMk id="6" creationId="{156A1A7C-B13B-47C9-BEA5-5C1CC741772A}"/>
          </ac:spMkLst>
        </pc:spChg>
        <pc:spChg chg="mod">
          <ac:chgData name="Chew Leng Lim" userId="f4956819b06a5395" providerId="LiveId" clId="{64D1738D-F0F2-4F33-B73E-6056640154D5}" dt="2020-04-13T05:22:50.240" v="7329" actId="164"/>
          <ac:spMkLst>
            <pc:docMk/>
            <pc:sldMk cId="1896826950" sldId="296"/>
            <ac:spMk id="7" creationId="{5DB68B95-4C0D-4591-A0B4-9747034CFA57}"/>
          </ac:spMkLst>
        </pc:spChg>
        <pc:spChg chg="mod">
          <ac:chgData name="Chew Leng Lim" userId="f4956819b06a5395" providerId="LiveId" clId="{64D1738D-F0F2-4F33-B73E-6056640154D5}" dt="2020-04-13T05:22:50.240" v="7329" actId="164"/>
          <ac:spMkLst>
            <pc:docMk/>
            <pc:sldMk cId="1896826950" sldId="296"/>
            <ac:spMk id="8" creationId="{46D33681-C30D-4DC2-889C-015EA2AD0192}"/>
          </ac:spMkLst>
        </pc:spChg>
        <pc:spChg chg="mod">
          <ac:chgData name="Chew Leng Lim" userId="f4956819b06a5395" providerId="LiveId" clId="{64D1738D-F0F2-4F33-B73E-6056640154D5}" dt="2020-04-13T05:22:50.240" v="7329" actId="164"/>
          <ac:spMkLst>
            <pc:docMk/>
            <pc:sldMk cId="1896826950" sldId="296"/>
            <ac:spMk id="9" creationId="{F898C9EA-E551-4797-B21E-2B716AF4595A}"/>
          </ac:spMkLst>
        </pc:spChg>
        <pc:spChg chg="add mod topLvl">
          <ac:chgData name="Chew Leng Lim" userId="f4956819b06a5395" providerId="LiveId" clId="{64D1738D-F0F2-4F33-B73E-6056640154D5}" dt="2020-04-13T05:14:20.081" v="6840" actId="164"/>
          <ac:spMkLst>
            <pc:docMk/>
            <pc:sldMk cId="1896826950" sldId="296"/>
            <ac:spMk id="10" creationId="{02CCC518-1434-497E-9159-FBFB755618B6}"/>
          </ac:spMkLst>
        </pc:spChg>
        <pc:spChg chg="add mod topLvl">
          <ac:chgData name="Chew Leng Lim" userId="f4956819b06a5395" providerId="LiveId" clId="{64D1738D-F0F2-4F33-B73E-6056640154D5}" dt="2020-04-13T05:14:20.081" v="6840" actId="164"/>
          <ac:spMkLst>
            <pc:docMk/>
            <pc:sldMk cId="1896826950" sldId="296"/>
            <ac:spMk id="11" creationId="{A9503C49-BF4C-43F6-B31D-809763B88BFC}"/>
          </ac:spMkLst>
        </pc:spChg>
        <pc:spChg chg="add mod topLvl">
          <ac:chgData name="Chew Leng Lim" userId="f4956819b06a5395" providerId="LiveId" clId="{64D1738D-F0F2-4F33-B73E-6056640154D5}" dt="2020-04-13T05:14:20.081" v="6840" actId="164"/>
          <ac:spMkLst>
            <pc:docMk/>
            <pc:sldMk cId="1896826950" sldId="296"/>
            <ac:spMk id="12" creationId="{5944AEB7-96A9-4741-890B-A8CBA27152EC}"/>
          </ac:spMkLst>
        </pc:spChg>
        <pc:spChg chg="add mod">
          <ac:chgData name="Chew Leng Lim" userId="f4956819b06a5395" providerId="LiveId" clId="{64D1738D-F0F2-4F33-B73E-6056640154D5}" dt="2020-04-13T05:13:39.540" v="6769" actId="164"/>
          <ac:spMkLst>
            <pc:docMk/>
            <pc:sldMk cId="1896826950" sldId="296"/>
            <ac:spMk id="13" creationId="{A99BEAF5-4F8A-4AF3-B7F8-73FA3F874F9D}"/>
          </ac:spMkLst>
        </pc:spChg>
        <pc:spChg chg="mod">
          <ac:chgData name="Chew Leng Lim" userId="f4956819b06a5395" providerId="LiveId" clId="{64D1738D-F0F2-4F33-B73E-6056640154D5}" dt="2020-04-13T05:22:50.240" v="7329" actId="164"/>
          <ac:spMkLst>
            <pc:docMk/>
            <pc:sldMk cId="1896826950" sldId="296"/>
            <ac:spMk id="14" creationId="{718A5641-272C-4916-B1F8-D7E4B0A94BC6}"/>
          </ac:spMkLst>
        </pc:spChg>
        <pc:spChg chg="mod">
          <ac:chgData name="Chew Leng Lim" userId="f4956819b06a5395" providerId="LiveId" clId="{64D1738D-F0F2-4F33-B73E-6056640154D5}" dt="2020-04-13T05:22:50.240" v="7329" actId="164"/>
          <ac:spMkLst>
            <pc:docMk/>
            <pc:sldMk cId="1896826950" sldId="296"/>
            <ac:spMk id="17" creationId="{0954B336-05A4-409F-9A22-FB80BC45CDC2}"/>
          </ac:spMkLst>
        </pc:spChg>
        <pc:spChg chg="mod">
          <ac:chgData name="Chew Leng Lim" userId="f4956819b06a5395" providerId="LiveId" clId="{64D1738D-F0F2-4F33-B73E-6056640154D5}" dt="2020-04-13T05:22:50.240" v="7329" actId="164"/>
          <ac:spMkLst>
            <pc:docMk/>
            <pc:sldMk cId="1896826950" sldId="296"/>
            <ac:spMk id="28" creationId="{CFF408E8-1137-4B0F-8B2C-9E62E531342A}"/>
          </ac:spMkLst>
        </pc:spChg>
        <pc:spChg chg="mod">
          <ac:chgData name="Chew Leng Lim" userId="f4956819b06a5395" providerId="LiveId" clId="{64D1738D-F0F2-4F33-B73E-6056640154D5}" dt="2020-04-13T05:08:42.898" v="6445" actId="164"/>
          <ac:spMkLst>
            <pc:docMk/>
            <pc:sldMk cId="1896826950" sldId="296"/>
            <ac:spMk id="75" creationId="{5E64093C-0FD7-4751-8301-4905C704167A}"/>
          </ac:spMkLst>
        </pc:spChg>
        <pc:spChg chg="mod">
          <ac:chgData name="Chew Leng Lim" userId="f4956819b06a5395" providerId="LiveId" clId="{64D1738D-F0F2-4F33-B73E-6056640154D5}" dt="2020-04-13T05:08:42.898" v="6445" actId="164"/>
          <ac:spMkLst>
            <pc:docMk/>
            <pc:sldMk cId="1896826950" sldId="296"/>
            <ac:spMk id="76" creationId="{0E995113-8686-49A5-A658-A892B4C28274}"/>
          </ac:spMkLst>
        </pc:spChg>
        <pc:spChg chg="mod">
          <ac:chgData name="Chew Leng Lim" userId="f4956819b06a5395" providerId="LiveId" clId="{64D1738D-F0F2-4F33-B73E-6056640154D5}" dt="2020-04-13T05:08:42.898" v="6445" actId="164"/>
          <ac:spMkLst>
            <pc:docMk/>
            <pc:sldMk cId="1896826950" sldId="296"/>
            <ac:spMk id="77" creationId="{C2D1AAC6-7A95-41B8-BB03-4A99BBE9DA27}"/>
          </ac:spMkLst>
        </pc:spChg>
        <pc:spChg chg="mod">
          <ac:chgData name="Chew Leng Lim" userId="f4956819b06a5395" providerId="LiveId" clId="{64D1738D-F0F2-4F33-B73E-6056640154D5}" dt="2020-04-13T05:08:42.898" v="6445" actId="164"/>
          <ac:spMkLst>
            <pc:docMk/>
            <pc:sldMk cId="1896826950" sldId="296"/>
            <ac:spMk id="78" creationId="{0EBF6B40-6603-4B4B-85DF-37349797F661}"/>
          </ac:spMkLst>
        </pc:spChg>
        <pc:spChg chg="mod">
          <ac:chgData name="Chew Leng Lim" userId="f4956819b06a5395" providerId="LiveId" clId="{64D1738D-F0F2-4F33-B73E-6056640154D5}" dt="2020-04-13T05:08:42.898" v="6445" actId="164"/>
          <ac:spMkLst>
            <pc:docMk/>
            <pc:sldMk cId="1896826950" sldId="296"/>
            <ac:spMk id="85" creationId="{9B946AD5-A5BA-418C-982E-BB878404D5B8}"/>
          </ac:spMkLst>
        </pc:spChg>
        <pc:spChg chg="mod">
          <ac:chgData name="Chew Leng Lim" userId="f4956819b06a5395" providerId="LiveId" clId="{64D1738D-F0F2-4F33-B73E-6056640154D5}" dt="2020-04-13T05:08:42.898" v="6445" actId="164"/>
          <ac:spMkLst>
            <pc:docMk/>
            <pc:sldMk cId="1896826950" sldId="296"/>
            <ac:spMk id="89" creationId="{20720433-FD2C-4912-A1C4-2CCDB8BA5B95}"/>
          </ac:spMkLst>
        </pc:spChg>
        <pc:spChg chg="add mod">
          <ac:chgData name="Chew Leng Lim" userId="f4956819b06a5395" providerId="LiveId" clId="{64D1738D-F0F2-4F33-B73E-6056640154D5}" dt="2020-04-13T05:15:08.357" v="6919" actId="1036"/>
          <ac:spMkLst>
            <pc:docMk/>
            <pc:sldMk cId="1896826950" sldId="296"/>
            <ac:spMk id="94" creationId="{AAB1C811-58FA-444F-8B10-4A7C8809A0E1}"/>
          </ac:spMkLst>
        </pc:spChg>
        <pc:spChg chg="mod topLvl">
          <ac:chgData name="Chew Leng Lim" userId="f4956819b06a5395" providerId="LiveId" clId="{64D1738D-F0F2-4F33-B73E-6056640154D5}" dt="2020-04-13T05:14:02.609" v="6798" actId="164"/>
          <ac:spMkLst>
            <pc:docMk/>
            <pc:sldMk cId="1896826950" sldId="296"/>
            <ac:spMk id="100" creationId="{33BA0149-4524-4081-AAEF-52B8703AEE8B}"/>
          </ac:spMkLst>
        </pc:spChg>
        <pc:spChg chg="mod topLvl">
          <ac:chgData name="Chew Leng Lim" userId="f4956819b06a5395" providerId="LiveId" clId="{64D1738D-F0F2-4F33-B73E-6056640154D5}" dt="2020-04-13T05:14:02.609" v="6798" actId="164"/>
          <ac:spMkLst>
            <pc:docMk/>
            <pc:sldMk cId="1896826950" sldId="296"/>
            <ac:spMk id="101" creationId="{239A7EB7-C8DB-44F2-BFCB-22D0BAAD84DA}"/>
          </ac:spMkLst>
        </pc:spChg>
        <pc:spChg chg="mod topLvl">
          <ac:chgData name="Chew Leng Lim" userId="f4956819b06a5395" providerId="LiveId" clId="{64D1738D-F0F2-4F33-B73E-6056640154D5}" dt="2020-04-13T05:14:02.609" v="6798" actId="164"/>
          <ac:spMkLst>
            <pc:docMk/>
            <pc:sldMk cId="1896826950" sldId="296"/>
            <ac:spMk id="102" creationId="{07DC6693-A533-40CD-A8F2-4F708B6E9DCD}"/>
          </ac:spMkLst>
        </pc:spChg>
        <pc:spChg chg="mod">
          <ac:chgData name="Chew Leng Lim" userId="f4956819b06a5395" providerId="LiveId" clId="{64D1738D-F0F2-4F33-B73E-6056640154D5}" dt="2020-04-13T05:22:50.240" v="7329" actId="164"/>
          <ac:spMkLst>
            <pc:docMk/>
            <pc:sldMk cId="1896826950" sldId="296"/>
            <ac:spMk id="105" creationId="{E37771D6-7698-406D-8A0E-1A7DC90DDCF4}"/>
          </ac:spMkLst>
        </pc:spChg>
        <pc:spChg chg="mod">
          <ac:chgData name="Chew Leng Lim" userId="f4956819b06a5395" providerId="LiveId" clId="{64D1738D-F0F2-4F33-B73E-6056640154D5}" dt="2020-04-13T05:22:50.240" v="7329" actId="164"/>
          <ac:spMkLst>
            <pc:docMk/>
            <pc:sldMk cId="1896826950" sldId="296"/>
            <ac:spMk id="106" creationId="{70795C53-8CAB-4346-BC9D-72B3FE644471}"/>
          </ac:spMkLst>
        </pc:spChg>
        <pc:spChg chg="mod topLvl">
          <ac:chgData name="Chew Leng Lim" userId="f4956819b06a5395" providerId="LiveId" clId="{64D1738D-F0F2-4F33-B73E-6056640154D5}" dt="2020-04-13T05:14:02.609" v="6798" actId="164"/>
          <ac:spMkLst>
            <pc:docMk/>
            <pc:sldMk cId="1896826950" sldId="296"/>
            <ac:spMk id="107" creationId="{A5242835-4FBC-4D00-B42C-21493E290184}"/>
          </ac:spMkLst>
        </pc:spChg>
        <pc:spChg chg="mod">
          <ac:chgData name="Chew Leng Lim" userId="f4956819b06a5395" providerId="LiveId" clId="{64D1738D-F0F2-4F33-B73E-6056640154D5}" dt="2020-04-13T05:22:50.240" v="7329" actId="164"/>
          <ac:spMkLst>
            <pc:docMk/>
            <pc:sldMk cId="1896826950" sldId="296"/>
            <ac:spMk id="108" creationId="{4F7BB5FA-9A05-435B-96BA-D73932F5F41B}"/>
          </ac:spMkLst>
        </pc:spChg>
        <pc:spChg chg="mod topLvl">
          <ac:chgData name="Chew Leng Lim" userId="f4956819b06a5395" providerId="LiveId" clId="{64D1738D-F0F2-4F33-B73E-6056640154D5}" dt="2020-04-13T05:14:02.609" v="6798" actId="164"/>
          <ac:spMkLst>
            <pc:docMk/>
            <pc:sldMk cId="1896826950" sldId="296"/>
            <ac:spMk id="109" creationId="{1C24BA95-6100-4F5A-9115-EB50587B2CBC}"/>
          </ac:spMkLst>
        </pc:spChg>
        <pc:spChg chg="mod">
          <ac:chgData name="Chew Leng Lim" userId="f4956819b06a5395" providerId="LiveId" clId="{64D1738D-F0F2-4F33-B73E-6056640154D5}" dt="2020-04-13T05:22:50.240" v="7329" actId="164"/>
          <ac:spMkLst>
            <pc:docMk/>
            <pc:sldMk cId="1896826950" sldId="296"/>
            <ac:spMk id="110" creationId="{9ECF6F32-78E9-403A-A9BF-412EC3B11CD8}"/>
          </ac:spMkLst>
        </pc:spChg>
        <pc:spChg chg="mod">
          <ac:chgData name="Chew Leng Lim" userId="f4956819b06a5395" providerId="LiveId" clId="{64D1738D-F0F2-4F33-B73E-6056640154D5}" dt="2020-04-13T05:22:50.240" v="7329" actId="164"/>
          <ac:spMkLst>
            <pc:docMk/>
            <pc:sldMk cId="1896826950" sldId="296"/>
            <ac:spMk id="111" creationId="{F6126135-E109-4FC6-B8BA-374C12EC135D}"/>
          </ac:spMkLst>
        </pc:spChg>
        <pc:spChg chg="mod">
          <ac:chgData name="Chew Leng Lim" userId="f4956819b06a5395" providerId="LiveId" clId="{64D1738D-F0F2-4F33-B73E-6056640154D5}" dt="2020-04-13T05:22:50.240" v="7329" actId="164"/>
          <ac:spMkLst>
            <pc:docMk/>
            <pc:sldMk cId="1896826950" sldId="296"/>
            <ac:spMk id="112" creationId="{5C0ABBB1-40EF-4EE0-AB3F-462005945458}"/>
          </ac:spMkLst>
        </pc:spChg>
        <pc:spChg chg="mod topLvl">
          <ac:chgData name="Chew Leng Lim" userId="f4956819b06a5395" providerId="LiveId" clId="{64D1738D-F0F2-4F33-B73E-6056640154D5}" dt="2020-04-13T05:23:12.214" v="7336" actId="164"/>
          <ac:spMkLst>
            <pc:docMk/>
            <pc:sldMk cId="1896826950" sldId="296"/>
            <ac:spMk id="120" creationId="{FDCD3B8D-A37A-4FD0-927E-A417FD820736}"/>
          </ac:spMkLst>
        </pc:spChg>
        <pc:spChg chg="mod topLvl">
          <ac:chgData name="Chew Leng Lim" userId="f4956819b06a5395" providerId="LiveId" clId="{64D1738D-F0F2-4F33-B73E-6056640154D5}" dt="2020-04-13T05:23:12.214" v="7336" actId="164"/>
          <ac:spMkLst>
            <pc:docMk/>
            <pc:sldMk cId="1896826950" sldId="296"/>
            <ac:spMk id="121" creationId="{C8950F38-8274-49AA-B566-EC7A2FE58322}"/>
          </ac:spMkLst>
        </pc:spChg>
        <pc:spChg chg="mod topLvl">
          <ac:chgData name="Chew Leng Lim" userId="f4956819b06a5395" providerId="LiveId" clId="{64D1738D-F0F2-4F33-B73E-6056640154D5}" dt="2020-04-13T05:23:12.214" v="7336" actId="164"/>
          <ac:spMkLst>
            <pc:docMk/>
            <pc:sldMk cId="1896826950" sldId="296"/>
            <ac:spMk id="122" creationId="{F1B87FB9-D37D-4264-9D00-601230AE8349}"/>
          </ac:spMkLst>
        </pc:spChg>
        <pc:spChg chg="mod topLvl">
          <ac:chgData name="Chew Leng Lim" userId="f4956819b06a5395" providerId="LiveId" clId="{64D1738D-F0F2-4F33-B73E-6056640154D5}" dt="2020-04-13T05:23:12.214" v="7336" actId="164"/>
          <ac:spMkLst>
            <pc:docMk/>
            <pc:sldMk cId="1896826950" sldId="296"/>
            <ac:spMk id="123" creationId="{C9249BAF-B6B9-4718-95DF-44DC9D17F989}"/>
          </ac:spMkLst>
        </pc:spChg>
        <pc:spChg chg="mod topLvl">
          <ac:chgData name="Chew Leng Lim" userId="f4956819b06a5395" providerId="LiveId" clId="{64D1738D-F0F2-4F33-B73E-6056640154D5}" dt="2020-04-13T05:23:12.214" v="7336" actId="164"/>
          <ac:spMkLst>
            <pc:docMk/>
            <pc:sldMk cId="1896826950" sldId="296"/>
            <ac:spMk id="124" creationId="{2D5B0A6F-93A9-4E8D-8C4C-B9C1E9A1D663}"/>
          </ac:spMkLst>
        </pc:spChg>
        <pc:spChg chg="mod topLvl">
          <ac:chgData name="Chew Leng Lim" userId="f4956819b06a5395" providerId="LiveId" clId="{64D1738D-F0F2-4F33-B73E-6056640154D5}" dt="2020-04-13T05:23:12.214" v="7336" actId="164"/>
          <ac:spMkLst>
            <pc:docMk/>
            <pc:sldMk cId="1896826950" sldId="296"/>
            <ac:spMk id="125" creationId="{E1ED3D26-2C26-46A7-A796-1C263B061B22}"/>
          </ac:spMkLst>
        </pc:spChg>
        <pc:spChg chg="mod topLvl">
          <ac:chgData name="Chew Leng Lim" userId="f4956819b06a5395" providerId="LiveId" clId="{64D1738D-F0F2-4F33-B73E-6056640154D5}" dt="2020-04-13T05:23:12.214" v="7336" actId="164"/>
          <ac:spMkLst>
            <pc:docMk/>
            <pc:sldMk cId="1896826950" sldId="296"/>
            <ac:spMk id="126" creationId="{BEC0D342-5CFD-4935-B1B3-788FD5FB6E68}"/>
          </ac:spMkLst>
        </pc:spChg>
        <pc:spChg chg="add mod">
          <ac:chgData name="Chew Leng Lim" userId="f4956819b06a5395" providerId="LiveId" clId="{64D1738D-F0F2-4F33-B73E-6056640154D5}" dt="2020-04-13T05:23:40.895" v="7347" actId="1036"/>
          <ac:spMkLst>
            <pc:docMk/>
            <pc:sldMk cId="1896826950" sldId="296"/>
            <ac:spMk id="127" creationId="{E7B44F4D-FD3A-44ED-88C7-46D61ADFC1E5}"/>
          </ac:spMkLst>
        </pc:spChg>
        <pc:spChg chg="mod">
          <ac:chgData name="Chew Leng Lim" userId="f4956819b06a5395" providerId="LiveId" clId="{64D1738D-F0F2-4F33-B73E-6056640154D5}" dt="2020-04-13T05:08:42.898" v="6445" actId="164"/>
          <ac:spMkLst>
            <pc:docMk/>
            <pc:sldMk cId="1896826950" sldId="296"/>
            <ac:spMk id="128" creationId="{4439A77E-D0B2-4D25-B227-297AECF015AD}"/>
          </ac:spMkLst>
        </pc:spChg>
        <pc:spChg chg="mod">
          <ac:chgData name="Chew Leng Lim" userId="f4956819b06a5395" providerId="LiveId" clId="{64D1738D-F0F2-4F33-B73E-6056640154D5}" dt="2020-04-13T05:08:42.898" v="6445" actId="164"/>
          <ac:spMkLst>
            <pc:docMk/>
            <pc:sldMk cId="1896826950" sldId="296"/>
            <ac:spMk id="133" creationId="{61743EE2-3112-420B-8D1D-B65303BFE202}"/>
          </ac:spMkLst>
        </pc:spChg>
        <pc:spChg chg="mod topLvl">
          <ac:chgData name="Chew Leng Lim" userId="f4956819b06a5395" providerId="LiveId" clId="{64D1738D-F0F2-4F33-B73E-6056640154D5}" dt="2020-04-13T05:14:02.609" v="6798" actId="164"/>
          <ac:spMkLst>
            <pc:docMk/>
            <pc:sldMk cId="1896826950" sldId="296"/>
            <ac:spMk id="137" creationId="{6C5257D5-A18E-45C2-BEB1-7A8485D50878}"/>
          </ac:spMkLst>
        </pc:spChg>
        <pc:spChg chg="mod">
          <ac:chgData name="Chew Leng Lim" userId="f4956819b06a5395" providerId="LiveId" clId="{64D1738D-F0F2-4F33-B73E-6056640154D5}" dt="2020-04-13T05:23:40.895" v="7347" actId="1036"/>
          <ac:spMkLst>
            <pc:docMk/>
            <pc:sldMk cId="1896826950" sldId="296"/>
            <ac:spMk id="139" creationId="{8178C2F4-AA83-461F-B9EE-8E385622E54A}"/>
          </ac:spMkLst>
        </pc:spChg>
        <pc:spChg chg="mod topLvl">
          <ac:chgData name="Chew Leng Lim" userId="f4956819b06a5395" providerId="LiveId" clId="{64D1738D-F0F2-4F33-B73E-6056640154D5}" dt="2020-04-13T05:15:08.357" v="6919" actId="1036"/>
          <ac:spMkLst>
            <pc:docMk/>
            <pc:sldMk cId="1896826950" sldId="296"/>
            <ac:spMk id="140" creationId="{D18CEFB3-71D1-4718-80CC-13D71DCA10F9}"/>
          </ac:spMkLst>
        </pc:spChg>
        <pc:spChg chg="mod">
          <ac:chgData name="Chew Leng Lim" userId="f4956819b06a5395" providerId="LiveId" clId="{64D1738D-F0F2-4F33-B73E-6056640154D5}" dt="2020-04-13T05:08:42.898" v="6445" actId="164"/>
          <ac:spMkLst>
            <pc:docMk/>
            <pc:sldMk cId="1896826950" sldId="296"/>
            <ac:spMk id="141" creationId="{10300C7A-FC44-4FA3-9276-2A8BB0981A15}"/>
          </ac:spMkLst>
        </pc:spChg>
        <pc:spChg chg="mod">
          <ac:chgData name="Chew Leng Lim" userId="f4956819b06a5395" providerId="LiveId" clId="{64D1738D-F0F2-4F33-B73E-6056640154D5}" dt="2020-04-13T05:15:08.357" v="6919" actId="1036"/>
          <ac:spMkLst>
            <pc:docMk/>
            <pc:sldMk cId="1896826950" sldId="296"/>
            <ac:spMk id="144" creationId="{BA30624C-AE16-4EB1-9A93-89D820B05A66}"/>
          </ac:spMkLst>
        </pc:spChg>
        <pc:spChg chg="mod topLvl">
          <ac:chgData name="Chew Leng Lim" userId="f4956819b06a5395" providerId="LiveId" clId="{64D1738D-F0F2-4F33-B73E-6056640154D5}" dt="2020-04-13T05:15:08.357" v="6919" actId="1036"/>
          <ac:spMkLst>
            <pc:docMk/>
            <pc:sldMk cId="1896826950" sldId="296"/>
            <ac:spMk id="145" creationId="{DF7393E3-7F2F-472A-AC11-ED783FA3CAAB}"/>
          </ac:spMkLst>
        </pc:spChg>
        <pc:spChg chg="mod">
          <ac:chgData name="Chew Leng Lim" userId="f4956819b06a5395" providerId="LiveId" clId="{64D1738D-F0F2-4F33-B73E-6056640154D5}" dt="2020-04-13T05:08:42.898" v="6445" actId="164"/>
          <ac:spMkLst>
            <pc:docMk/>
            <pc:sldMk cId="1896826950" sldId="296"/>
            <ac:spMk id="147" creationId="{EA5EAD66-48DE-4612-852C-9DFDF98283B3}"/>
          </ac:spMkLst>
        </pc:spChg>
        <pc:spChg chg="add mod">
          <ac:chgData name="Chew Leng Lim" userId="f4956819b06a5395" providerId="LiveId" clId="{64D1738D-F0F2-4F33-B73E-6056640154D5}" dt="2020-04-13T05:15:08.357" v="6919" actId="1036"/>
          <ac:spMkLst>
            <pc:docMk/>
            <pc:sldMk cId="1896826950" sldId="296"/>
            <ac:spMk id="148" creationId="{DA1CCD93-F6DA-4E3C-9D4C-1C8ECAF514C2}"/>
          </ac:spMkLst>
        </pc:spChg>
        <pc:spChg chg="mod">
          <ac:chgData name="Chew Leng Lim" userId="f4956819b06a5395" providerId="LiveId" clId="{64D1738D-F0F2-4F33-B73E-6056640154D5}" dt="2020-04-13T05:22:50.240" v="7329" actId="164"/>
          <ac:spMkLst>
            <pc:docMk/>
            <pc:sldMk cId="1896826950" sldId="296"/>
            <ac:spMk id="151" creationId="{CAC8FEDA-9FF7-4359-8F5F-EDE35E1B5AD9}"/>
          </ac:spMkLst>
        </pc:spChg>
        <pc:spChg chg="add mod topLvl">
          <ac:chgData name="Chew Leng Lim" userId="f4956819b06a5395" providerId="LiveId" clId="{64D1738D-F0F2-4F33-B73E-6056640154D5}" dt="2020-04-13T05:14:20.081" v="6840" actId="164"/>
          <ac:spMkLst>
            <pc:docMk/>
            <pc:sldMk cId="1896826950" sldId="296"/>
            <ac:spMk id="153" creationId="{7F210FE0-0E92-4C86-BE6E-92E861EAD733}"/>
          </ac:spMkLst>
        </pc:spChg>
        <pc:spChg chg="mod">
          <ac:chgData name="Chew Leng Lim" userId="f4956819b06a5395" providerId="LiveId" clId="{64D1738D-F0F2-4F33-B73E-6056640154D5}" dt="2020-04-13T05:22:50.240" v="7329" actId="164"/>
          <ac:spMkLst>
            <pc:docMk/>
            <pc:sldMk cId="1896826950" sldId="296"/>
            <ac:spMk id="154" creationId="{8CE62314-8B7B-4611-B009-54A86E564A90}"/>
          </ac:spMkLst>
        </pc:spChg>
        <pc:spChg chg="add del">
          <ac:chgData name="Chew Leng Lim" userId="f4956819b06a5395" providerId="LiveId" clId="{64D1738D-F0F2-4F33-B73E-6056640154D5}" dt="2020-04-13T04:55:14.350" v="5733" actId="478"/>
          <ac:spMkLst>
            <pc:docMk/>
            <pc:sldMk cId="1896826950" sldId="296"/>
            <ac:spMk id="155" creationId="{E0CBB7D5-8358-49CC-99AF-04E8B8D3C4FC}"/>
          </ac:spMkLst>
        </pc:spChg>
        <pc:spChg chg="add mod">
          <ac:chgData name="Chew Leng Lim" userId="f4956819b06a5395" providerId="LiveId" clId="{64D1738D-F0F2-4F33-B73E-6056640154D5}" dt="2020-04-13T05:13:39.540" v="6769" actId="164"/>
          <ac:spMkLst>
            <pc:docMk/>
            <pc:sldMk cId="1896826950" sldId="296"/>
            <ac:spMk id="156" creationId="{E2264537-E2E7-443D-8806-8D7EF1AFC7D2}"/>
          </ac:spMkLst>
        </pc:spChg>
        <pc:spChg chg="add mod">
          <ac:chgData name="Chew Leng Lim" userId="f4956819b06a5395" providerId="LiveId" clId="{64D1738D-F0F2-4F33-B73E-6056640154D5}" dt="2020-04-13T05:13:39.540" v="6769" actId="164"/>
          <ac:spMkLst>
            <pc:docMk/>
            <pc:sldMk cId="1896826950" sldId="296"/>
            <ac:spMk id="163" creationId="{DC5206E8-D15B-4435-B7FB-38ED9C368E92}"/>
          </ac:spMkLst>
        </pc:spChg>
        <pc:spChg chg="add mod">
          <ac:chgData name="Chew Leng Lim" userId="f4956819b06a5395" providerId="LiveId" clId="{64D1738D-F0F2-4F33-B73E-6056640154D5}" dt="2020-04-13T05:13:39.540" v="6769" actId="164"/>
          <ac:spMkLst>
            <pc:docMk/>
            <pc:sldMk cId="1896826950" sldId="296"/>
            <ac:spMk id="174" creationId="{900AED6E-5951-4F13-ACAD-A14968BD3D61}"/>
          </ac:spMkLst>
        </pc:spChg>
        <pc:spChg chg="add mod">
          <ac:chgData name="Chew Leng Lim" userId="f4956819b06a5395" providerId="LiveId" clId="{64D1738D-F0F2-4F33-B73E-6056640154D5}" dt="2020-04-13T05:13:39.540" v="6769" actId="164"/>
          <ac:spMkLst>
            <pc:docMk/>
            <pc:sldMk cId="1896826950" sldId="296"/>
            <ac:spMk id="175" creationId="{30A01C32-F6CC-4A93-AF29-E3C898C4872F}"/>
          </ac:spMkLst>
        </pc:spChg>
        <pc:spChg chg="mod">
          <ac:chgData name="Chew Leng Lim" userId="f4956819b06a5395" providerId="LiveId" clId="{64D1738D-F0F2-4F33-B73E-6056640154D5}" dt="2020-04-13T05:22:50.240" v="7329" actId="164"/>
          <ac:spMkLst>
            <pc:docMk/>
            <pc:sldMk cId="1896826950" sldId="296"/>
            <ac:spMk id="201" creationId="{413CBB3C-460D-4401-8671-41B1AE06C709}"/>
          </ac:spMkLst>
        </pc:spChg>
        <pc:spChg chg="mod">
          <ac:chgData name="Chew Leng Lim" userId="f4956819b06a5395" providerId="LiveId" clId="{64D1738D-F0F2-4F33-B73E-6056640154D5}" dt="2020-04-13T05:22:50.240" v="7329" actId="164"/>
          <ac:spMkLst>
            <pc:docMk/>
            <pc:sldMk cId="1896826950" sldId="296"/>
            <ac:spMk id="206" creationId="{E76EA11E-A169-433E-9D8A-C91378949941}"/>
          </ac:spMkLst>
        </pc:spChg>
        <pc:spChg chg="mod">
          <ac:chgData name="Chew Leng Lim" userId="f4956819b06a5395" providerId="LiveId" clId="{64D1738D-F0F2-4F33-B73E-6056640154D5}" dt="2020-04-13T09:14:12.866" v="19147" actId="1036"/>
          <ac:spMkLst>
            <pc:docMk/>
            <pc:sldMk cId="1896826950" sldId="296"/>
            <ac:spMk id="209" creationId="{6E3BE21B-3521-445C-8D4B-4909CF64F12F}"/>
          </ac:spMkLst>
        </pc:spChg>
        <pc:spChg chg="mod">
          <ac:chgData name="Chew Leng Lim" userId="f4956819b06a5395" providerId="LiveId" clId="{64D1738D-F0F2-4F33-B73E-6056640154D5}" dt="2020-04-13T11:30:52.251" v="32238" actId="20577"/>
          <ac:spMkLst>
            <pc:docMk/>
            <pc:sldMk cId="1896826950" sldId="296"/>
            <ac:spMk id="239" creationId="{8B2133BF-0AB1-4213-B5E1-A8C9B7AF17DC}"/>
          </ac:spMkLst>
        </pc:spChg>
        <pc:grpChg chg="add mod">
          <ac:chgData name="Chew Leng Lim" userId="f4956819b06a5395" providerId="LiveId" clId="{64D1738D-F0F2-4F33-B73E-6056640154D5}" dt="2020-04-13T05:15:08.357" v="6919" actId="1036"/>
          <ac:grpSpMkLst>
            <pc:docMk/>
            <pc:sldMk cId="1896826950" sldId="296"/>
            <ac:grpSpMk id="3" creationId="{881E1FC8-E69A-4546-AFE0-CB99B0601331}"/>
          </ac:grpSpMkLst>
        </pc:grpChg>
        <pc:grpChg chg="del mod">
          <ac:chgData name="Chew Leng Lim" userId="f4956819b06a5395" providerId="LiveId" clId="{64D1738D-F0F2-4F33-B73E-6056640154D5}" dt="2020-04-13T04:41:41.523" v="4919" actId="478"/>
          <ac:grpSpMkLst>
            <pc:docMk/>
            <pc:sldMk cId="1896826950" sldId="296"/>
            <ac:grpSpMk id="15" creationId="{234469C6-2517-4A47-9536-EEEFF3F58070}"/>
          </ac:grpSpMkLst>
        </pc:grpChg>
        <pc:grpChg chg="add del mod">
          <ac:chgData name="Chew Leng Lim" userId="f4956819b06a5395" providerId="LiveId" clId="{64D1738D-F0F2-4F33-B73E-6056640154D5}" dt="2020-04-13T05:13:57.958" v="6797" actId="165"/>
          <ac:grpSpMkLst>
            <pc:docMk/>
            <pc:sldMk cId="1896826950" sldId="296"/>
            <ac:grpSpMk id="15" creationId="{5F265426-59FC-4AB1-81A1-8F546575444F}"/>
          </ac:grpSpMkLst>
        </pc:grpChg>
        <pc:grpChg chg="add mod">
          <ac:chgData name="Chew Leng Lim" userId="f4956819b06a5395" providerId="LiveId" clId="{64D1738D-F0F2-4F33-B73E-6056640154D5}" dt="2020-04-13T05:14:20.081" v="6840" actId="164"/>
          <ac:grpSpMkLst>
            <pc:docMk/>
            <pc:sldMk cId="1896826950" sldId="296"/>
            <ac:grpSpMk id="16" creationId="{AC50857B-19B8-4461-8A44-82CF359BD1ED}"/>
          </ac:grpSpMkLst>
        </pc:grpChg>
        <pc:grpChg chg="del mod topLvl">
          <ac:chgData name="Chew Leng Lim" userId="f4956819b06a5395" providerId="LiveId" clId="{64D1738D-F0F2-4F33-B73E-6056640154D5}" dt="2020-04-13T04:42:12.038" v="4921" actId="165"/>
          <ac:grpSpMkLst>
            <pc:docMk/>
            <pc:sldMk cId="1896826950" sldId="296"/>
            <ac:grpSpMk id="16" creationId="{F87C90E8-7590-4D1C-B391-63F05257CEF8}"/>
          </ac:grpSpMkLst>
        </pc:grpChg>
        <pc:grpChg chg="del mod">
          <ac:chgData name="Chew Leng Lim" userId="f4956819b06a5395" providerId="LiveId" clId="{64D1738D-F0F2-4F33-B73E-6056640154D5}" dt="2020-04-13T04:41:21.948" v="4917" actId="165"/>
          <ac:grpSpMkLst>
            <pc:docMk/>
            <pc:sldMk cId="1896826950" sldId="296"/>
            <ac:grpSpMk id="18" creationId="{C939EAD9-F48C-4A5C-B075-863E93C0EFBB}"/>
          </ac:grpSpMkLst>
        </pc:grpChg>
        <pc:grpChg chg="add mod">
          <ac:chgData name="Chew Leng Lim" userId="f4956819b06a5395" providerId="LiveId" clId="{64D1738D-F0F2-4F33-B73E-6056640154D5}" dt="2020-04-13T05:15:08.357" v="6919" actId="1036"/>
          <ac:grpSpMkLst>
            <pc:docMk/>
            <pc:sldMk cId="1896826950" sldId="296"/>
            <ac:grpSpMk id="18" creationId="{D1567F55-DFCD-4EAD-BD43-C608ADD9ADB9}"/>
          </ac:grpSpMkLst>
        </pc:grpChg>
        <pc:grpChg chg="add mod">
          <ac:chgData name="Chew Leng Lim" userId="f4956819b06a5395" providerId="LiveId" clId="{64D1738D-F0F2-4F33-B73E-6056640154D5}" dt="2020-04-13T05:15:08.357" v="6919" actId="1036"/>
          <ac:grpSpMkLst>
            <pc:docMk/>
            <pc:sldMk cId="1896826950" sldId="296"/>
            <ac:grpSpMk id="19" creationId="{989EF911-A3EF-41C4-B6BB-34CD1A8F0619}"/>
          </ac:grpSpMkLst>
        </pc:grpChg>
        <pc:grpChg chg="add mod">
          <ac:chgData name="Chew Leng Lim" userId="f4956819b06a5395" providerId="LiveId" clId="{64D1738D-F0F2-4F33-B73E-6056640154D5}" dt="2020-04-13T05:23:47.273" v="7348" actId="1036"/>
          <ac:grpSpMkLst>
            <pc:docMk/>
            <pc:sldMk cId="1896826950" sldId="296"/>
            <ac:grpSpMk id="20" creationId="{D8F39B5C-DD86-4921-85B3-CF3AC97329AC}"/>
          </ac:grpSpMkLst>
        </pc:grpChg>
        <pc:grpChg chg="add mod">
          <ac:chgData name="Chew Leng Lim" userId="f4956819b06a5395" providerId="LiveId" clId="{64D1738D-F0F2-4F33-B73E-6056640154D5}" dt="2020-04-13T05:23:12.214" v="7336" actId="164"/>
          <ac:grpSpMkLst>
            <pc:docMk/>
            <pc:sldMk cId="1896826950" sldId="296"/>
            <ac:grpSpMk id="21" creationId="{D84F9112-7388-419B-8840-5BBD25403A1B}"/>
          </ac:grpSpMkLst>
        </pc:grpChg>
        <pc:grpChg chg="del mod">
          <ac:chgData name="Chew Leng Lim" userId="f4956819b06a5395" providerId="LiveId" clId="{64D1738D-F0F2-4F33-B73E-6056640154D5}" dt="2020-04-13T04:42:09.060" v="4920" actId="165"/>
          <ac:grpSpMkLst>
            <pc:docMk/>
            <pc:sldMk cId="1896826950" sldId="296"/>
            <ac:grpSpMk id="63" creationId="{872CFF0B-0FCE-4473-B77A-C5E7C664036F}"/>
          </ac:grpSpMkLst>
        </pc:grpChg>
        <pc:graphicFrameChg chg="mod">
          <ac:chgData name="Chew Leng Lim" userId="f4956819b06a5395" providerId="LiveId" clId="{64D1738D-F0F2-4F33-B73E-6056640154D5}" dt="2020-04-13T05:22:50.240" v="7329" actId="164"/>
          <ac:graphicFrameMkLst>
            <pc:docMk/>
            <pc:sldMk cId="1896826950" sldId="296"/>
            <ac:graphicFrameMk id="4" creationId="{0A0CA5D8-924E-4388-A5D7-0A6ED0A7F17E}"/>
          </ac:graphicFrameMkLst>
        </pc:graphicFrameChg>
        <pc:graphicFrameChg chg="mod">
          <ac:chgData name="Chew Leng Lim" userId="f4956819b06a5395" providerId="LiveId" clId="{64D1738D-F0F2-4F33-B73E-6056640154D5}" dt="2020-04-13T05:08:42.898" v="6445" actId="164"/>
          <ac:graphicFrameMkLst>
            <pc:docMk/>
            <pc:sldMk cId="1896826950" sldId="296"/>
            <ac:graphicFrameMk id="73" creationId="{114C88B8-DBD7-4D64-A12B-7E1BD835DB19}"/>
          </ac:graphicFrameMkLst>
        </pc:graphicFrameChg>
        <pc:graphicFrameChg chg="mod topLvl">
          <ac:chgData name="Chew Leng Lim" userId="f4956819b06a5395" providerId="LiveId" clId="{64D1738D-F0F2-4F33-B73E-6056640154D5}" dt="2020-04-13T05:14:02.609" v="6798" actId="164"/>
          <ac:graphicFrameMkLst>
            <pc:docMk/>
            <pc:sldMk cId="1896826950" sldId="296"/>
            <ac:graphicFrameMk id="99" creationId="{94A0858B-D660-4B49-96E5-BFE10DEE1D3B}"/>
          </ac:graphicFrameMkLst>
        </pc:graphicFrameChg>
        <pc:picChg chg="mod topLvl">
          <ac:chgData name="Chew Leng Lim" userId="f4956819b06a5395" providerId="LiveId" clId="{64D1738D-F0F2-4F33-B73E-6056640154D5}" dt="2020-04-13T05:23:12.214" v="7336" actId="164"/>
          <ac:picMkLst>
            <pc:docMk/>
            <pc:sldMk cId="1896826950" sldId="296"/>
            <ac:picMk id="65" creationId="{80A59F2F-FE41-49A5-9D58-FFA27DFB6C5F}"/>
          </ac:picMkLst>
        </pc:picChg>
        <pc:picChg chg="mod topLvl">
          <ac:chgData name="Chew Leng Lim" userId="f4956819b06a5395" providerId="LiveId" clId="{64D1738D-F0F2-4F33-B73E-6056640154D5}" dt="2020-04-13T05:23:12.214" v="7336" actId="164"/>
          <ac:picMkLst>
            <pc:docMk/>
            <pc:sldMk cId="1896826950" sldId="296"/>
            <ac:picMk id="66" creationId="{19E090FE-2149-4319-B1C7-CE57277CDCF0}"/>
          </ac:picMkLst>
        </pc:picChg>
        <pc:picChg chg="mod topLvl">
          <ac:chgData name="Chew Leng Lim" userId="f4956819b06a5395" providerId="LiveId" clId="{64D1738D-F0F2-4F33-B73E-6056640154D5}" dt="2020-04-13T05:23:12.214" v="7336" actId="164"/>
          <ac:picMkLst>
            <pc:docMk/>
            <pc:sldMk cId="1896826950" sldId="296"/>
            <ac:picMk id="67" creationId="{1AEB5FFD-BD53-41DA-945C-6BD6140FCA77}"/>
          </ac:picMkLst>
        </pc:picChg>
        <pc:picChg chg="mod topLvl">
          <ac:chgData name="Chew Leng Lim" userId="f4956819b06a5395" providerId="LiveId" clId="{64D1738D-F0F2-4F33-B73E-6056640154D5}" dt="2020-04-13T05:23:12.214" v="7336" actId="164"/>
          <ac:picMkLst>
            <pc:docMk/>
            <pc:sldMk cId="1896826950" sldId="296"/>
            <ac:picMk id="68" creationId="{9139534B-3A97-436D-B381-8C5B51F4B78F}"/>
          </ac:picMkLst>
        </pc:picChg>
        <pc:picChg chg="mod topLvl">
          <ac:chgData name="Chew Leng Lim" userId="f4956819b06a5395" providerId="LiveId" clId="{64D1738D-F0F2-4F33-B73E-6056640154D5}" dt="2020-04-13T05:23:12.214" v="7336" actId="164"/>
          <ac:picMkLst>
            <pc:docMk/>
            <pc:sldMk cId="1896826950" sldId="296"/>
            <ac:picMk id="70" creationId="{E59A8BF8-F50C-4FC8-BC47-66762511C095}"/>
          </ac:picMkLst>
        </pc:picChg>
        <pc:picChg chg="mod topLvl">
          <ac:chgData name="Chew Leng Lim" userId="f4956819b06a5395" providerId="LiveId" clId="{64D1738D-F0F2-4F33-B73E-6056640154D5}" dt="2020-04-13T05:23:12.214" v="7336" actId="164"/>
          <ac:picMkLst>
            <pc:docMk/>
            <pc:sldMk cId="1896826950" sldId="296"/>
            <ac:picMk id="71" creationId="{F9EDBE06-E3ED-4F7C-BDED-AEBFCF2A04FC}"/>
          </ac:picMkLst>
        </pc:picChg>
        <pc:cxnChg chg="mod topLvl">
          <ac:chgData name="Chew Leng Lim" userId="f4956819b06a5395" providerId="LiveId" clId="{64D1738D-F0F2-4F33-B73E-6056640154D5}" dt="2020-04-13T05:23:12.214" v="7336" actId="164"/>
          <ac:cxnSpMkLst>
            <pc:docMk/>
            <pc:sldMk cId="1896826950" sldId="296"/>
            <ac:cxnSpMk id="118" creationId="{A28B5A27-378F-46B1-BA1F-08519E2A7F33}"/>
          </ac:cxnSpMkLst>
        </pc:cxnChg>
        <pc:cxnChg chg="mod topLvl">
          <ac:chgData name="Chew Leng Lim" userId="f4956819b06a5395" providerId="LiveId" clId="{64D1738D-F0F2-4F33-B73E-6056640154D5}" dt="2020-04-13T05:23:12.214" v="7336" actId="164"/>
          <ac:cxnSpMkLst>
            <pc:docMk/>
            <pc:sldMk cId="1896826950" sldId="296"/>
            <ac:cxnSpMk id="119" creationId="{1DFF7467-B3BE-4127-A8FC-8B653DAEF361}"/>
          </ac:cxnSpMkLst>
        </pc:cxnChg>
        <pc:cxnChg chg="mod">
          <ac:chgData name="Chew Leng Lim" userId="f4956819b06a5395" providerId="LiveId" clId="{64D1738D-F0F2-4F33-B73E-6056640154D5}" dt="2020-04-13T05:08:42.898" v="6445" actId="164"/>
          <ac:cxnSpMkLst>
            <pc:docMk/>
            <pc:sldMk cId="1896826950" sldId="296"/>
            <ac:cxnSpMk id="134" creationId="{A47F9DC1-1A38-4252-96F6-685D9A22A168}"/>
          </ac:cxnSpMkLst>
        </pc:cxnChg>
        <pc:cxnChg chg="mod">
          <ac:chgData name="Chew Leng Lim" userId="f4956819b06a5395" providerId="LiveId" clId="{64D1738D-F0F2-4F33-B73E-6056640154D5}" dt="2020-04-13T05:08:42.898" v="6445" actId="164"/>
          <ac:cxnSpMkLst>
            <pc:docMk/>
            <pc:sldMk cId="1896826950" sldId="296"/>
            <ac:cxnSpMk id="135" creationId="{43FAE959-C576-4E41-ACF2-B529413D5FF5}"/>
          </ac:cxnSpMkLst>
        </pc:cxnChg>
        <pc:cxnChg chg="mod">
          <ac:chgData name="Chew Leng Lim" userId="f4956819b06a5395" providerId="LiveId" clId="{64D1738D-F0F2-4F33-B73E-6056640154D5}" dt="2020-04-13T05:08:42.898" v="6445" actId="164"/>
          <ac:cxnSpMkLst>
            <pc:docMk/>
            <pc:sldMk cId="1896826950" sldId="296"/>
            <ac:cxnSpMk id="136" creationId="{F66DBBDA-4FDA-4C20-A2AF-B907405903D1}"/>
          </ac:cxnSpMkLst>
        </pc:cxnChg>
        <pc:cxnChg chg="mod">
          <ac:chgData name="Chew Leng Lim" userId="f4956819b06a5395" providerId="LiveId" clId="{64D1738D-F0F2-4F33-B73E-6056640154D5}" dt="2020-04-13T05:08:42.898" v="6445" actId="164"/>
          <ac:cxnSpMkLst>
            <pc:docMk/>
            <pc:sldMk cId="1896826950" sldId="296"/>
            <ac:cxnSpMk id="142" creationId="{57C45F81-4B96-46B7-B9C5-4400B3350B7E}"/>
          </ac:cxnSpMkLst>
        </pc:cxnChg>
        <pc:cxnChg chg="mod">
          <ac:chgData name="Chew Leng Lim" userId="f4956819b06a5395" providerId="LiveId" clId="{64D1738D-F0F2-4F33-B73E-6056640154D5}" dt="2020-04-13T05:08:42.898" v="6445" actId="164"/>
          <ac:cxnSpMkLst>
            <pc:docMk/>
            <pc:sldMk cId="1896826950" sldId="296"/>
            <ac:cxnSpMk id="143" creationId="{FF1CFA28-7706-467D-935C-C5C09D444D05}"/>
          </ac:cxnSpMkLst>
        </pc:cxnChg>
        <pc:cxnChg chg="mod">
          <ac:chgData name="Chew Leng Lim" userId="f4956819b06a5395" providerId="LiveId" clId="{64D1738D-F0F2-4F33-B73E-6056640154D5}" dt="2020-04-13T05:08:42.898" v="6445" actId="164"/>
          <ac:cxnSpMkLst>
            <pc:docMk/>
            <pc:sldMk cId="1896826950" sldId="296"/>
            <ac:cxnSpMk id="146" creationId="{02A5B074-1917-4E99-8F72-FFD5F41CAF8A}"/>
          </ac:cxnSpMkLst>
        </pc:cxnChg>
        <pc:cxnChg chg="mod">
          <ac:chgData name="Chew Leng Lim" userId="f4956819b06a5395" providerId="LiveId" clId="{64D1738D-F0F2-4F33-B73E-6056640154D5}" dt="2020-04-13T05:08:42.898" v="6445" actId="164"/>
          <ac:cxnSpMkLst>
            <pc:docMk/>
            <pc:sldMk cId="1896826950" sldId="296"/>
            <ac:cxnSpMk id="149" creationId="{F6628273-71A3-4443-A17B-653F858B7FE0}"/>
          </ac:cxnSpMkLst>
        </pc:cxnChg>
        <pc:cxnChg chg="mod">
          <ac:chgData name="Chew Leng Lim" userId="f4956819b06a5395" providerId="LiveId" clId="{64D1738D-F0F2-4F33-B73E-6056640154D5}" dt="2020-04-13T05:08:42.898" v="6445" actId="164"/>
          <ac:cxnSpMkLst>
            <pc:docMk/>
            <pc:sldMk cId="1896826950" sldId="296"/>
            <ac:cxnSpMk id="150" creationId="{8E88681E-7DCD-49AC-B5C3-E95253A09C6E}"/>
          </ac:cxnSpMkLst>
        </pc:cxnChg>
        <pc:cxnChg chg="mod">
          <ac:chgData name="Chew Leng Lim" userId="f4956819b06a5395" providerId="LiveId" clId="{64D1738D-F0F2-4F33-B73E-6056640154D5}" dt="2020-04-13T05:22:50.240" v="7329" actId="164"/>
          <ac:cxnSpMkLst>
            <pc:docMk/>
            <pc:sldMk cId="1896826950" sldId="296"/>
            <ac:cxnSpMk id="152" creationId="{DCD346C0-0C88-41C4-884D-85AD5A3D05E8}"/>
          </ac:cxnSpMkLst>
        </pc:cxnChg>
        <pc:cxnChg chg="mod">
          <ac:chgData name="Chew Leng Lim" userId="f4956819b06a5395" providerId="LiveId" clId="{64D1738D-F0F2-4F33-B73E-6056640154D5}" dt="2020-04-13T05:22:50.240" v="7329" actId="164"/>
          <ac:cxnSpMkLst>
            <pc:docMk/>
            <pc:sldMk cId="1896826950" sldId="296"/>
            <ac:cxnSpMk id="157" creationId="{48026C68-F15A-4452-A092-8ECF58BD9BE2}"/>
          </ac:cxnSpMkLst>
        </pc:cxnChg>
        <pc:cxnChg chg="mod">
          <ac:chgData name="Chew Leng Lim" userId="f4956819b06a5395" providerId="LiveId" clId="{64D1738D-F0F2-4F33-B73E-6056640154D5}" dt="2020-04-13T05:22:50.240" v="7329" actId="164"/>
          <ac:cxnSpMkLst>
            <pc:docMk/>
            <pc:sldMk cId="1896826950" sldId="296"/>
            <ac:cxnSpMk id="158" creationId="{1B7585AA-519B-4104-A0F6-1B2B92F2F303}"/>
          </ac:cxnSpMkLst>
        </pc:cxnChg>
        <pc:cxnChg chg="mod">
          <ac:chgData name="Chew Leng Lim" userId="f4956819b06a5395" providerId="LiveId" clId="{64D1738D-F0F2-4F33-B73E-6056640154D5}" dt="2020-04-13T05:22:50.240" v="7329" actId="164"/>
          <ac:cxnSpMkLst>
            <pc:docMk/>
            <pc:sldMk cId="1896826950" sldId="296"/>
            <ac:cxnSpMk id="159" creationId="{624E08F4-4B96-4284-BD8C-8CF7BCC12067}"/>
          </ac:cxnSpMkLst>
        </pc:cxnChg>
        <pc:cxnChg chg="mod">
          <ac:chgData name="Chew Leng Lim" userId="f4956819b06a5395" providerId="LiveId" clId="{64D1738D-F0F2-4F33-B73E-6056640154D5}" dt="2020-04-13T05:22:50.240" v="7329" actId="164"/>
          <ac:cxnSpMkLst>
            <pc:docMk/>
            <pc:sldMk cId="1896826950" sldId="296"/>
            <ac:cxnSpMk id="160" creationId="{EE6ADA0F-D5D1-4E32-8959-7C0A107AD76E}"/>
          </ac:cxnSpMkLst>
        </pc:cxnChg>
        <pc:cxnChg chg="mod">
          <ac:chgData name="Chew Leng Lim" userId="f4956819b06a5395" providerId="LiveId" clId="{64D1738D-F0F2-4F33-B73E-6056640154D5}" dt="2020-04-13T05:22:50.240" v="7329" actId="164"/>
          <ac:cxnSpMkLst>
            <pc:docMk/>
            <pc:sldMk cId="1896826950" sldId="296"/>
            <ac:cxnSpMk id="189" creationId="{41B80044-A19D-4466-A623-5FA3416202B7}"/>
          </ac:cxnSpMkLst>
        </pc:cxnChg>
        <pc:cxnChg chg="mod">
          <ac:chgData name="Chew Leng Lim" userId="f4956819b06a5395" providerId="LiveId" clId="{64D1738D-F0F2-4F33-B73E-6056640154D5}" dt="2020-04-13T05:22:50.240" v="7329" actId="164"/>
          <ac:cxnSpMkLst>
            <pc:docMk/>
            <pc:sldMk cId="1896826950" sldId="296"/>
            <ac:cxnSpMk id="208" creationId="{E9BB49C3-6C2B-4DCA-8486-14E0E0AD63FC}"/>
          </ac:cxnSpMkLst>
        </pc:cxnChg>
        <pc:cxnChg chg="mod">
          <ac:chgData name="Chew Leng Lim" userId="f4956819b06a5395" providerId="LiveId" clId="{64D1738D-F0F2-4F33-B73E-6056640154D5}" dt="2020-04-13T05:22:50.240" v="7329" actId="164"/>
          <ac:cxnSpMkLst>
            <pc:docMk/>
            <pc:sldMk cId="1896826950" sldId="296"/>
            <ac:cxnSpMk id="210" creationId="{A90F4410-CB2D-40CA-A8DF-6764B5A2ACED}"/>
          </ac:cxnSpMkLst>
        </pc:cxnChg>
        <pc:cxnChg chg="mod">
          <ac:chgData name="Chew Leng Lim" userId="f4956819b06a5395" providerId="LiveId" clId="{64D1738D-F0F2-4F33-B73E-6056640154D5}" dt="2020-04-13T05:22:50.240" v="7329" actId="164"/>
          <ac:cxnSpMkLst>
            <pc:docMk/>
            <pc:sldMk cId="1896826950" sldId="296"/>
            <ac:cxnSpMk id="211" creationId="{1C6CCECA-937A-493B-BA8C-982588E063D5}"/>
          </ac:cxnSpMkLst>
        </pc:cxnChg>
        <pc:cxnChg chg="mod">
          <ac:chgData name="Chew Leng Lim" userId="f4956819b06a5395" providerId="LiveId" clId="{64D1738D-F0F2-4F33-B73E-6056640154D5}" dt="2020-04-13T05:22:50.240" v="7329" actId="164"/>
          <ac:cxnSpMkLst>
            <pc:docMk/>
            <pc:sldMk cId="1896826950" sldId="296"/>
            <ac:cxnSpMk id="212" creationId="{880FDC7A-D89D-4BA2-A554-56CE6F72785C}"/>
          </ac:cxnSpMkLst>
        </pc:cxnChg>
        <pc:cxnChg chg="mod">
          <ac:chgData name="Chew Leng Lim" userId="f4956819b06a5395" providerId="LiveId" clId="{64D1738D-F0F2-4F33-B73E-6056640154D5}" dt="2020-04-13T05:22:50.240" v="7329" actId="164"/>
          <ac:cxnSpMkLst>
            <pc:docMk/>
            <pc:sldMk cId="1896826950" sldId="296"/>
            <ac:cxnSpMk id="213" creationId="{CB12A863-0BFB-4A79-AEAF-602BD4D21513}"/>
          </ac:cxnSpMkLst>
        </pc:cxnChg>
        <pc:cxnChg chg="mod">
          <ac:chgData name="Chew Leng Lim" userId="f4956819b06a5395" providerId="LiveId" clId="{64D1738D-F0F2-4F33-B73E-6056640154D5}" dt="2020-04-13T05:22:50.240" v="7329" actId="164"/>
          <ac:cxnSpMkLst>
            <pc:docMk/>
            <pc:sldMk cId="1896826950" sldId="296"/>
            <ac:cxnSpMk id="214" creationId="{CBA53A73-3AA1-4715-8127-9B0361F3D495}"/>
          </ac:cxnSpMkLst>
        </pc:cxnChg>
      </pc:sldChg>
      <pc:sldChg chg="addSp delSp modSp del">
        <pc:chgData name="Chew Leng Lim" userId="f4956819b06a5395" providerId="LiveId" clId="{64D1738D-F0F2-4F33-B73E-6056640154D5}" dt="2020-04-13T08:57:02.716" v="18280" actId="2696"/>
        <pc:sldMkLst>
          <pc:docMk/>
          <pc:sldMk cId="1761259662" sldId="299"/>
        </pc:sldMkLst>
        <pc:spChg chg="mod">
          <ac:chgData name="Chew Leng Lim" userId="f4956819b06a5395" providerId="LiveId" clId="{64D1738D-F0F2-4F33-B73E-6056640154D5}" dt="2020-04-13T08:56:55.730" v="18277" actId="207"/>
          <ac:spMkLst>
            <pc:docMk/>
            <pc:sldMk cId="1761259662" sldId="299"/>
            <ac:spMk id="2" creationId="{9006FD5F-E9F5-4916-8FD1-659895FDAA02}"/>
          </ac:spMkLst>
        </pc:spChg>
        <pc:spChg chg="del mod">
          <ac:chgData name="Chew Leng Lim" userId="f4956819b06a5395" providerId="LiveId" clId="{64D1738D-F0F2-4F33-B73E-6056640154D5}" dt="2020-04-13T08:54:32.861" v="18178"/>
          <ac:spMkLst>
            <pc:docMk/>
            <pc:sldMk cId="1761259662" sldId="299"/>
            <ac:spMk id="5" creationId="{664BD555-5A2A-434F-9F90-A76B6AB950A9}"/>
          </ac:spMkLst>
        </pc:spChg>
        <pc:spChg chg="mod">
          <ac:chgData name="Chew Leng Lim" userId="f4956819b06a5395" providerId="LiveId" clId="{64D1738D-F0F2-4F33-B73E-6056640154D5}" dt="2020-04-13T08:46:10.856" v="17116" actId="164"/>
          <ac:spMkLst>
            <pc:docMk/>
            <pc:sldMk cId="1761259662" sldId="299"/>
            <ac:spMk id="10" creationId="{FCB424C4-2B80-466D-A4DB-68CFC53BD9E2}"/>
          </ac:spMkLst>
        </pc:spChg>
        <pc:spChg chg="mod">
          <ac:chgData name="Chew Leng Lim" userId="f4956819b06a5395" providerId="LiveId" clId="{64D1738D-F0F2-4F33-B73E-6056640154D5}" dt="2020-04-13T08:46:10.856" v="17116" actId="164"/>
          <ac:spMkLst>
            <pc:docMk/>
            <pc:sldMk cId="1761259662" sldId="299"/>
            <ac:spMk id="16" creationId="{E66FF22E-1403-46D9-BA93-58E08026AB77}"/>
          </ac:spMkLst>
        </pc:spChg>
        <pc:spChg chg="mod">
          <ac:chgData name="Chew Leng Lim" userId="f4956819b06a5395" providerId="LiveId" clId="{64D1738D-F0F2-4F33-B73E-6056640154D5}" dt="2020-04-13T08:46:10.856" v="17116" actId="164"/>
          <ac:spMkLst>
            <pc:docMk/>
            <pc:sldMk cId="1761259662" sldId="299"/>
            <ac:spMk id="17" creationId="{7104BCE7-79D7-40CD-8C69-0BE78A74D4BE}"/>
          </ac:spMkLst>
        </pc:spChg>
        <pc:spChg chg="mod">
          <ac:chgData name="Chew Leng Lim" userId="f4956819b06a5395" providerId="LiveId" clId="{64D1738D-F0F2-4F33-B73E-6056640154D5}" dt="2020-04-13T08:46:10.856" v="17116" actId="164"/>
          <ac:spMkLst>
            <pc:docMk/>
            <pc:sldMk cId="1761259662" sldId="299"/>
            <ac:spMk id="21" creationId="{81DB62B1-7594-4AB4-B7FF-87D4205D66AA}"/>
          </ac:spMkLst>
        </pc:spChg>
        <pc:spChg chg="del mod">
          <ac:chgData name="Chew Leng Lim" userId="f4956819b06a5395" providerId="LiveId" clId="{64D1738D-F0F2-4F33-B73E-6056640154D5}" dt="2020-04-13T08:54:32.861" v="18178"/>
          <ac:spMkLst>
            <pc:docMk/>
            <pc:sldMk cId="1761259662" sldId="299"/>
            <ac:spMk id="40" creationId="{0BDA73C9-680F-4A7D-897C-F6512617106B}"/>
          </ac:spMkLst>
        </pc:spChg>
        <pc:spChg chg="mod">
          <ac:chgData name="Chew Leng Lim" userId="f4956819b06a5395" providerId="LiveId" clId="{64D1738D-F0F2-4F33-B73E-6056640154D5}" dt="2020-04-13T08:48:06.107" v="17533" actId="164"/>
          <ac:spMkLst>
            <pc:docMk/>
            <pc:sldMk cId="1761259662" sldId="299"/>
            <ac:spMk id="42" creationId="{6BF8AA07-0B8C-4831-A2D1-3C95D9C9B57F}"/>
          </ac:spMkLst>
        </pc:spChg>
        <pc:spChg chg="mod">
          <ac:chgData name="Chew Leng Lim" userId="f4956819b06a5395" providerId="LiveId" clId="{64D1738D-F0F2-4F33-B73E-6056640154D5}" dt="2020-04-13T08:48:06.107" v="17533" actId="164"/>
          <ac:spMkLst>
            <pc:docMk/>
            <pc:sldMk cId="1761259662" sldId="299"/>
            <ac:spMk id="43" creationId="{FADEE728-F02B-4238-A1ED-A88BD1D42CD1}"/>
          </ac:spMkLst>
        </pc:spChg>
        <pc:spChg chg="mod">
          <ac:chgData name="Chew Leng Lim" userId="f4956819b06a5395" providerId="LiveId" clId="{64D1738D-F0F2-4F33-B73E-6056640154D5}" dt="2020-04-13T08:48:06.107" v="17533" actId="164"/>
          <ac:spMkLst>
            <pc:docMk/>
            <pc:sldMk cId="1761259662" sldId="299"/>
            <ac:spMk id="45" creationId="{C5CC6924-1631-45DA-915C-6091E2376E7D}"/>
          </ac:spMkLst>
        </pc:spChg>
        <pc:spChg chg="mod">
          <ac:chgData name="Chew Leng Lim" userId="f4956819b06a5395" providerId="LiveId" clId="{64D1738D-F0F2-4F33-B73E-6056640154D5}" dt="2020-04-13T08:47:58.163" v="17521" actId="164"/>
          <ac:spMkLst>
            <pc:docMk/>
            <pc:sldMk cId="1761259662" sldId="299"/>
            <ac:spMk id="47" creationId="{E5AB3F53-B6FF-4B2C-9CF4-8A54021B65DC}"/>
          </ac:spMkLst>
        </pc:spChg>
        <pc:spChg chg="mod">
          <ac:chgData name="Chew Leng Lim" userId="f4956819b06a5395" providerId="LiveId" clId="{64D1738D-F0F2-4F33-B73E-6056640154D5}" dt="2020-04-13T08:46:08.800" v="17115" actId="164"/>
          <ac:spMkLst>
            <pc:docMk/>
            <pc:sldMk cId="1761259662" sldId="299"/>
            <ac:spMk id="49" creationId="{6A426DB6-2199-491E-9987-385CFB0EC68B}"/>
          </ac:spMkLst>
        </pc:spChg>
        <pc:spChg chg="mod">
          <ac:chgData name="Chew Leng Lim" userId="f4956819b06a5395" providerId="LiveId" clId="{64D1738D-F0F2-4F33-B73E-6056640154D5}" dt="2020-04-13T08:46:08.800" v="17115" actId="164"/>
          <ac:spMkLst>
            <pc:docMk/>
            <pc:sldMk cId="1761259662" sldId="299"/>
            <ac:spMk id="50" creationId="{33496F61-95E1-4923-9BBC-9F1EF1E94CC0}"/>
          </ac:spMkLst>
        </pc:spChg>
        <pc:spChg chg="mod">
          <ac:chgData name="Chew Leng Lim" userId="f4956819b06a5395" providerId="LiveId" clId="{64D1738D-F0F2-4F33-B73E-6056640154D5}" dt="2020-04-13T08:46:08.800" v="17115" actId="164"/>
          <ac:spMkLst>
            <pc:docMk/>
            <pc:sldMk cId="1761259662" sldId="299"/>
            <ac:spMk id="51" creationId="{1A245848-2B4E-4BFA-B85A-684FE3B08D67}"/>
          </ac:spMkLst>
        </pc:spChg>
        <pc:spChg chg="mod">
          <ac:chgData name="Chew Leng Lim" userId="f4956819b06a5395" providerId="LiveId" clId="{64D1738D-F0F2-4F33-B73E-6056640154D5}" dt="2020-04-13T08:47:58.163" v="17521" actId="164"/>
          <ac:spMkLst>
            <pc:docMk/>
            <pc:sldMk cId="1761259662" sldId="299"/>
            <ac:spMk id="52" creationId="{E34DF870-38B4-493D-920E-304D333AFB0A}"/>
          </ac:spMkLst>
        </pc:spChg>
        <pc:spChg chg="mod">
          <ac:chgData name="Chew Leng Lim" userId="f4956819b06a5395" providerId="LiveId" clId="{64D1738D-F0F2-4F33-B73E-6056640154D5}" dt="2020-04-13T08:47:58.163" v="17521" actId="164"/>
          <ac:spMkLst>
            <pc:docMk/>
            <pc:sldMk cId="1761259662" sldId="299"/>
            <ac:spMk id="53" creationId="{0EB01689-4EAA-4563-BE5F-CE35B574AB85}"/>
          </ac:spMkLst>
        </pc:spChg>
        <pc:spChg chg="mod">
          <ac:chgData name="Chew Leng Lim" userId="f4956819b06a5395" providerId="LiveId" clId="{64D1738D-F0F2-4F33-B73E-6056640154D5}" dt="2020-04-13T08:47:58.163" v="17521" actId="164"/>
          <ac:spMkLst>
            <pc:docMk/>
            <pc:sldMk cId="1761259662" sldId="299"/>
            <ac:spMk id="54" creationId="{B37AF1B1-AB63-4F5A-82AB-370DC6C5B0AC}"/>
          </ac:spMkLst>
        </pc:spChg>
        <pc:spChg chg="mod">
          <ac:chgData name="Chew Leng Lim" userId="f4956819b06a5395" providerId="LiveId" clId="{64D1738D-F0F2-4F33-B73E-6056640154D5}" dt="2020-04-13T08:47:58.163" v="17521" actId="164"/>
          <ac:spMkLst>
            <pc:docMk/>
            <pc:sldMk cId="1761259662" sldId="299"/>
            <ac:spMk id="55" creationId="{1B815593-B551-42BB-A93B-F48C6AD3CFE3}"/>
          </ac:spMkLst>
        </pc:spChg>
        <pc:spChg chg="mod">
          <ac:chgData name="Chew Leng Lim" userId="f4956819b06a5395" providerId="LiveId" clId="{64D1738D-F0F2-4F33-B73E-6056640154D5}" dt="2020-04-13T08:46:08.800" v="17115" actId="164"/>
          <ac:spMkLst>
            <pc:docMk/>
            <pc:sldMk cId="1761259662" sldId="299"/>
            <ac:spMk id="57" creationId="{F8586946-7F9B-4996-AD5D-F7C4AD100132}"/>
          </ac:spMkLst>
        </pc:spChg>
        <pc:spChg chg="mod">
          <ac:chgData name="Chew Leng Lim" userId="f4956819b06a5395" providerId="LiveId" clId="{64D1738D-F0F2-4F33-B73E-6056640154D5}" dt="2020-04-13T08:46:08.800" v="17115" actId="164"/>
          <ac:spMkLst>
            <pc:docMk/>
            <pc:sldMk cId="1761259662" sldId="299"/>
            <ac:spMk id="58" creationId="{9FBF6673-07D8-4339-8B68-7BCF00C49722}"/>
          </ac:spMkLst>
        </pc:spChg>
        <pc:spChg chg="mod">
          <ac:chgData name="Chew Leng Lim" userId="f4956819b06a5395" providerId="LiveId" clId="{64D1738D-F0F2-4F33-B73E-6056640154D5}" dt="2020-04-13T08:47:45.910" v="17505" actId="164"/>
          <ac:spMkLst>
            <pc:docMk/>
            <pc:sldMk cId="1761259662" sldId="299"/>
            <ac:spMk id="60" creationId="{DAB93605-FB74-4885-B96B-0C67AC00919E}"/>
          </ac:spMkLst>
        </pc:spChg>
        <pc:spChg chg="mod">
          <ac:chgData name="Chew Leng Lim" userId="f4956819b06a5395" providerId="LiveId" clId="{64D1738D-F0F2-4F33-B73E-6056640154D5}" dt="2020-04-13T08:47:45.910" v="17505" actId="164"/>
          <ac:spMkLst>
            <pc:docMk/>
            <pc:sldMk cId="1761259662" sldId="299"/>
            <ac:spMk id="61" creationId="{BA014A3D-0FA5-45F3-A85E-1802777CB116}"/>
          </ac:spMkLst>
        </pc:spChg>
        <pc:spChg chg="mod">
          <ac:chgData name="Chew Leng Lim" userId="f4956819b06a5395" providerId="LiveId" clId="{64D1738D-F0F2-4F33-B73E-6056640154D5}" dt="2020-04-13T08:46:10.856" v="17116" actId="164"/>
          <ac:spMkLst>
            <pc:docMk/>
            <pc:sldMk cId="1761259662" sldId="299"/>
            <ac:spMk id="63" creationId="{EDC85653-7182-4813-B94C-4806ADE2893D}"/>
          </ac:spMkLst>
        </pc:spChg>
        <pc:spChg chg="mod">
          <ac:chgData name="Chew Leng Lim" userId="f4956819b06a5395" providerId="LiveId" clId="{64D1738D-F0F2-4F33-B73E-6056640154D5}" dt="2020-04-13T08:46:10.856" v="17116" actId="164"/>
          <ac:spMkLst>
            <pc:docMk/>
            <pc:sldMk cId="1761259662" sldId="299"/>
            <ac:spMk id="64" creationId="{DB4AF7EA-EAF0-4D0D-BEBA-040B85638E21}"/>
          </ac:spMkLst>
        </pc:spChg>
        <pc:spChg chg="mod">
          <ac:chgData name="Chew Leng Lim" userId="f4956819b06a5395" providerId="LiveId" clId="{64D1738D-F0F2-4F33-B73E-6056640154D5}" dt="2020-04-13T08:46:05.756" v="17114" actId="164"/>
          <ac:spMkLst>
            <pc:docMk/>
            <pc:sldMk cId="1761259662" sldId="299"/>
            <ac:spMk id="65" creationId="{8006EEE2-AAB1-4661-8295-BEB9AB12BCC7}"/>
          </ac:spMkLst>
        </pc:spChg>
        <pc:spChg chg="mod">
          <ac:chgData name="Chew Leng Lim" userId="f4956819b06a5395" providerId="LiveId" clId="{64D1738D-F0F2-4F33-B73E-6056640154D5}" dt="2020-04-13T08:47:45.910" v="17505" actId="164"/>
          <ac:spMkLst>
            <pc:docMk/>
            <pc:sldMk cId="1761259662" sldId="299"/>
            <ac:spMk id="66" creationId="{919B5D36-0A98-418A-B25E-492BB428620F}"/>
          </ac:spMkLst>
        </pc:spChg>
        <pc:spChg chg="add del mod">
          <ac:chgData name="Chew Leng Lim" userId="f4956819b06a5395" providerId="LiveId" clId="{64D1738D-F0F2-4F33-B73E-6056640154D5}" dt="2020-04-13T08:54:56.916" v="18253"/>
          <ac:spMkLst>
            <pc:docMk/>
            <pc:sldMk cId="1761259662" sldId="299"/>
            <ac:spMk id="67" creationId="{9E693988-5B09-4C40-B895-E255E4D59F79}"/>
          </ac:spMkLst>
        </pc:spChg>
        <pc:spChg chg="del mod">
          <ac:chgData name="Chew Leng Lim" userId="f4956819b06a5395" providerId="LiveId" clId="{64D1738D-F0F2-4F33-B73E-6056640154D5}" dt="2020-04-13T08:51:18.798" v="17901" actId="478"/>
          <ac:spMkLst>
            <pc:docMk/>
            <pc:sldMk cId="1761259662" sldId="299"/>
            <ac:spMk id="68" creationId="{B7BEBF5D-1041-4E50-9DF7-7C6EBCCC4265}"/>
          </ac:spMkLst>
        </pc:spChg>
        <pc:spChg chg="mod">
          <ac:chgData name="Chew Leng Lim" userId="f4956819b06a5395" providerId="LiveId" clId="{64D1738D-F0F2-4F33-B73E-6056640154D5}" dt="2020-04-13T08:48:14.306" v="17546" actId="164"/>
          <ac:spMkLst>
            <pc:docMk/>
            <pc:sldMk cId="1761259662" sldId="299"/>
            <ac:spMk id="74" creationId="{EBEC7003-8E98-4B0B-8CFB-E0DC7FDE9BF6}"/>
          </ac:spMkLst>
        </pc:spChg>
        <pc:spChg chg="mod">
          <ac:chgData name="Chew Leng Lim" userId="f4956819b06a5395" providerId="LiveId" clId="{64D1738D-F0F2-4F33-B73E-6056640154D5}" dt="2020-04-13T08:48:14.306" v="17546" actId="164"/>
          <ac:spMkLst>
            <pc:docMk/>
            <pc:sldMk cId="1761259662" sldId="299"/>
            <ac:spMk id="75" creationId="{27BD3765-94C4-421D-AA0A-1FD6576A6B1F}"/>
          </ac:spMkLst>
        </pc:spChg>
        <pc:spChg chg="mod">
          <ac:chgData name="Chew Leng Lim" userId="f4956819b06a5395" providerId="LiveId" clId="{64D1738D-F0F2-4F33-B73E-6056640154D5}" dt="2020-04-13T08:48:14.306" v="17546" actId="164"/>
          <ac:spMkLst>
            <pc:docMk/>
            <pc:sldMk cId="1761259662" sldId="299"/>
            <ac:spMk id="76" creationId="{B2F8908B-4C06-45FE-9062-4972EEB7069E}"/>
          </ac:spMkLst>
        </pc:spChg>
        <pc:spChg chg="mod">
          <ac:chgData name="Chew Leng Lim" userId="f4956819b06a5395" providerId="LiveId" clId="{64D1738D-F0F2-4F33-B73E-6056640154D5}" dt="2020-04-13T08:48:14.306" v="17546" actId="164"/>
          <ac:spMkLst>
            <pc:docMk/>
            <pc:sldMk cId="1761259662" sldId="299"/>
            <ac:spMk id="77" creationId="{0792E0AE-DB88-4172-8838-5FBBBAB7D439}"/>
          </ac:spMkLst>
        </pc:spChg>
        <pc:spChg chg="mod">
          <ac:chgData name="Chew Leng Lim" userId="f4956819b06a5395" providerId="LiveId" clId="{64D1738D-F0F2-4F33-B73E-6056640154D5}" dt="2020-04-13T08:48:06.107" v="17533" actId="164"/>
          <ac:spMkLst>
            <pc:docMk/>
            <pc:sldMk cId="1761259662" sldId="299"/>
            <ac:spMk id="78" creationId="{6CD6268A-1AB8-4874-9324-4C2AFA4DFFB8}"/>
          </ac:spMkLst>
        </pc:spChg>
        <pc:spChg chg="mod">
          <ac:chgData name="Chew Leng Lim" userId="f4956819b06a5395" providerId="LiveId" clId="{64D1738D-F0F2-4F33-B73E-6056640154D5}" dt="2020-04-13T08:47:45.910" v="17505" actId="164"/>
          <ac:spMkLst>
            <pc:docMk/>
            <pc:sldMk cId="1761259662" sldId="299"/>
            <ac:spMk id="80" creationId="{6363EBBE-9F36-4D1D-88EC-6087AB6527AC}"/>
          </ac:spMkLst>
        </pc:spChg>
        <pc:spChg chg="mod">
          <ac:chgData name="Chew Leng Lim" userId="f4956819b06a5395" providerId="LiveId" clId="{64D1738D-F0F2-4F33-B73E-6056640154D5}" dt="2020-04-13T08:48:14.306" v="17546" actId="164"/>
          <ac:spMkLst>
            <pc:docMk/>
            <pc:sldMk cId="1761259662" sldId="299"/>
            <ac:spMk id="81" creationId="{302EBEF3-0E20-43B2-AC8E-7F3E38F1A128}"/>
          </ac:spMkLst>
        </pc:spChg>
        <pc:spChg chg="mod">
          <ac:chgData name="Chew Leng Lim" userId="f4956819b06a5395" providerId="LiveId" clId="{64D1738D-F0F2-4F33-B73E-6056640154D5}" dt="2020-04-13T08:48:14.306" v="17546" actId="164"/>
          <ac:spMkLst>
            <pc:docMk/>
            <pc:sldMk cId="1761259662" sldId="299"/>
            <ac:spMk id="82" creationId="{2A6E646A-F920-4A9C-AA5B-5A709EC4D6D9}"/>
          </ac:spMkLst>
        </pc:spChg>
        <pc:spChg chg="mod">
          <ac:chgData name="Chew Leng Lim" userId="f4956819b06a5395" providerId="LiveId" clId="{64D1738D-F0F2-4F33-B73E-6056640154D5}" dt="2020-04-13T08:47:58.163" v="17521" actId="164"/>
          <ac:spMkLst>
            <pc:docMk/>
            <pc:sldMk cId="1761259662" sldId="299"/>
            <ac:spMk id="83" creationId="{5096B330-5CD7-411E-B29B-3E4B9964E854}"/>
          </ac:spMkLst>
        </pc:spChg>
        <pc:spChg chg="mod">
          <ac:chgData name="Chew Leng Lim" userId="f4956819b06a5395" providerId="LiveId" clId="{64D1738D-F0F2-4F33-B73E-6056640154D5}" dt="2020-04-13T08:46:05.756" v="17114" actId="164"/>
          <ac:spMkLst>
            <pc:docMk/>
            <pc:sldMk cId="1761259662" sldId="299"/>
            <ac:spMk id="90" creationId="{3CD640B7-F59B-4615-BC1C-6532C95C998C}"/>
          </ac:spMkLst>
        </pc:spChg>
        <pc:spChg chg="mod">
          <ac:chgData name="Chew Leng Lim" userId="f4956819b06a5395" providerId="LiveId" clId="{64D1738D-F0F2-4F33-B73E-6056640154D5}" dt="2020-04-13T08:46:05.756" v="17114" actId="164"/>
          <ac:spMkLst>
            <pc:docMk/>
            <pc:sldMk cId="1761259662" sldId="299"/>
            <ac:spMk id="91" creationId="{327C55C4-11AC-4FC2-97C6-E11DA5D64E30}"/>
          </ac:spMkLst>
        </pc:spChg>
        <pc:spChg chg="mod">
          <ac:chgData name="Chew Leng Lim" userId="f4956819b06a5395" providerId="LiveId" clId="{64D1738D-F0F2-4F33-B73E-6056640154D5}" dt="2020-04-13T08:46:05.756" v="17114" actId="164"/>
          <ac:spMkLst>
            <pc:docMk/>
            <pc:sldMk cId="1761259662" sldId="299"/>
            <ac:spMk id="95" creationId="{A0981889-8B65-46E0-BDC6-BADAF36C0876}"/>
          </ac:spMkLst>
        </pc:spChg>
        <pc:spChg chg="mod">
          <ac:chgData name="Chew Leng Lim" userId="f4956819b06a5395" providerId="LiveId" clId="{64D1738D-F0F2-4F33-B73E-6056640154D5}" dt="2020-04-13T08:46:05.756" v="17114" actId="164"/>
          <ac:spMkLst>
            <pc:docMk/>
            <pc:sldMk cId="1761259662" sldId="299"/>
            <ac:spMk id="96" creationId="{1DF1364A-FFB4-4463-8388-B6022B423D63}"/>
          </ac:spMkLst>
        </pc:spChg>
        <pc:spChg chg="mod">
          <ac:chgData name="Chew Leng Lim" userId="f4956819b06a5395" providerId="LiveId" clId="{64D1738D-F0F2-4F33-B73E-6056640154D5}" dt="2020-04-13T08:46:05.756" v="17114" actId="164"/>
          <ac:spMkLst>
            <pc:docMk/>
            <pc:sldMk cId="1761259662" sldId="299"/>
            <ac:spMk id="100" creationId="{CFC3A3A9-A13B-43C3-B397-FAA837AABE7A}"/>
          </ac:spMkLst>
        </pc:spChg>
        <pc:spChg chg="mod">
          <ac:chgData name="Chew Leng Lim" userId="f4956819b06a5395" providerId="LiveId" clId="{64D1738D-F0F2-4F33-B73E-6056640154D5}" dt="2020-04-13T08:46:05.756" v="17114" actId="164"/>
          <ac:spMkLst>
            <pc:docMk/>
            <pc:sldMk cId="1761259662" sldId="299"/>
            <ac:spMk id="116" creationId="{9460A5E8-DA84-4761-AD0A-3578D46E645B}"/>
          </ac:spMkLst>
        </pc:spChg>
        <pc:spChg chg="mod">
          <ac:chgData name="Chew Leng Lim" userId="f4956819b06a5395" providerId="LiveId" clId="{64D1738D-F0F2-4F33-B73E-6056640154D5}" dt="2020-04-13T08:46:14.041" v="17117" actId="164"/>
          <ac:spMkLst>
            <pc:docMk/>
            <pc:sldMk cId="1761259662" sldId="299"/>
            <ac:spMk id="134" creationId="{80F9DA30-BCF3-4877-AC3A-6D0896EB02F5}"/>
          </ac:spMkLst>
        </pc:spChg>
        <pc:spChg chg="mod">
          <ac:chgData name="Chew Leng Lim" userId="f4956819b06a5395" providerId="LiveId" clId="{64D1738D-F0F2-4F33-B73E-6056640154D5}" dt="2020-04-13T08:46:14.041" v="17117" actId="164"/>
          <ac:spMkLst>
            <pc:docMk/>
            <pc:sldMk cId="1761259662" sldId="299"/>
            <ac:spMk id="135" creationId="{1FB06D5A-4FFF-4EBD-8B79-F09FAABF6051}"/>
          </ac:spMkLst>
        </pc:spChg>
        <pc:spChg chg="del mod">
          <ac:chgData name="Chew Leng Lim" userId="f4956819b06a5395" providerId="LiveId" clId="{64D1738D-F0F2-4F33-B73E-6056640154D5}" dt="2020-04-13T08:54:32.861" v="18178"/>
          <ac:spMkLst>
            <pc:docMk/>
            <pc:sldMk cId="1761259662" sldId="299"/>
            <ac:spMk id="140" creationId="{3E90037C-293B-4361-A040-EC3648E308CC}"/>
          </ac:spMkLst>
        </pc:spChg>
        <pc:spChg chg="del mod">
          <ac:chgData name="Chew Leng Lim" userId="f4956819b06a5395" providerId="LiveId" clId="{64D1738D-F0F2-4F33-B73E-6056640154D5}" dt="2020-04-13T08:54:32.861" v="18178"/>
          <ac:spMkLst>
            <pc:docMk/>
            <pc:sldMk cId="1761259662" sldId="299"/>
            <ac:spMk id="146" creationId="{A92697C3-5BF6-4188-80A9-BF751903E73E}"/>
          </ac:spMkLst>
        </pc:spChg>
        <pc:spChg chg="del mod">
          <ac:chgData name="Chew Leng Lim" userId="f4956819b06a5395" providerId="LiveId" clId="{64D1738D-F0F2-4F33-B73E-6056640154D5}" dt="2020-04-13T08:54:32.861" v="18178"/>
          <ac:spMkLst>
            <pc:docMk/>
            <pc:sldMk cId="1761259662" sldId="299"/>
            <ac:spMk id="150" creationId="{61108F21-3155-45DE-8B4A-332ACB3D577E}"/>
          </ac:spMkLst>
        </pc:spChg>
        <pc:spChg chg="del mod">
          <ac:chgData name="Chew Leng Lim" userId="f4956819b06a5395" providerId="LiveId" clId="{64D1738D-F0F2-4F33-B73E-6056640154D5}" dt="2020-04-13T08:54:32.861" v="18178"/>
          <ac:spMkLst>
            <pc:docMk/>
            <pc:sldMk cId="1761259662" sldId="299"/>
            <ac:spMk id="151" creationId="{1FCD2F2E-8426-4B36-A502-6D14FBEAFEA3}"/>
          </ac:spMkLst>
        </pc:spChg>
        <pc:spChg chg="mod">
          <ac:chgData name="Chew Leng Lim" userId="f4956819b06a5395" providerId="LiveId" clId="{64D1738D-F0F2-4F33-B73E-6056640154D5}" dt="2020-04-13T08:46:14.041" v="17117" actId="164"/>
          <ac:spMkLst>
            <pc:docMk/>
            <pc:sldMk cId="1761259662" sldId="299"/>
            <ac:spMk id="161" creationId="{CEE6DA04-F3CB-4415-804C-4F4EBA2FE4BA}"/>
          </ac:spMkLst>
        </pc:spChg>
        <pc:spChg chg="del mod">
          <ac:chgData name="Chew Leng Lim" userId="f4956819b06a5395" providerId="LiveId" clId="{64D1738D-F0F2-4F33-B73E-6056640154D5}" dt="2020-04-13T08:54:32.861" v="18178"/>
          <ac:spMkLst>
            <pc:docMk/>
            <pc:sldMk cId="1761259662" sldId="299"/>
            <ac:spMk id="178" creationId="{0C9088CA-9CD7-4B52-A2EE-57323C725F82}"/>
          </ac:spMkLst>
        </pc:spChg>
        <pc:spChg chg="mod">
          <ac:chgData name="Chew Leng Lim" userId="f4956819b06a5395" providerId="LiveId" clId="{64D1738D-F0F2-4F33-B73E-6056640154D5}" dt="2020-04-13T08:46:14.041" v="17117" actId="164"/>
          <ac:spMkLst>
            <pc:docMk/>
            <pc:sldMk cId="1761259662" sldId="299"/>
            <ac:spMk id="191" creationId="{74C6EC32-69C1-4F32-8E97-62A38A8471DD}"/>
          </ac:spMkLst>
        </pc:spChg>
        <pc:grpChg chg="del">
          <ac:chgData name="Chew Leng Lim" userId="f4956819b06a5395" providerId="LiveId" clId="{64D1738D-F0F2-4F33-B73E-6056640154D5}" dt="2020-04-13T06:23:39.084" v="10415" actId="478"/>
          <ac:grpSpMkLst>
            <pc:docMk/>
            <pc:sldMk cId="1761259662" sldId="299"/>
            <ac:grpSpMk id="3" creationId="{9A8B2EAF-EFD4-4344-98AF-B389B435F11F}"/>
          </ac:grpSpMkLst>
        </pc:grpChg>
        <pc:grpChg chg="add del mod">
          <ac:chgData name="Chew Leng Lim" userId="f4956819b06a5395" providerId="LiveId" clId="{64D1738D-F0F2-4F33-B73E-6056640154D5}" dt="2020-04-13T08:54:32.861" v="18178"/>
          <ac:grpSpMkLst>
            <pc:docMk/>
            <pc:sldMk cId="1761259662" sldId="299"/>
            <ac:grpSpMk id="4" creationId="{EF5EEAA3-17F0-447B-9EA9-87B96360E21E}"/>
          </ac:grpSpMkLst>
        </pc:grpChg>
        <pc:grpChg chg="add del mod">
          <ac:chgData name="Chew Leng Lim" userId="f4956819b06a5395" providerId="LiveId" clId="{64D1738D-F0F2-4F33-B73E-6056640154D5}" dt="2020-04-13T08:54:32.861" v="18178"/>
          <ac:grpSpMkLst>
            <pc:docMk/>
            <pc:sldMk cId="1761259662" sldId="299"/>
            <ac:grpSpMk id="6" creationId="{14C27509-A8DC-45AC-82CA-788434FCB71A}"/>
          </ac:grpSpMkLst>
        </pc:grpChg>
        <pc:grpChg chg="add del mod">
          <ac:chgData name="Chew Leng Lim" userId="f4956819b06a5395" providerId="LiveId" clId="{64D1738D-F0F2-4F33-B73E-6056640154D5}" dt="2020-04-13T08:54:32.861" v="18178"/>
          <ac:grpSpMkLst>
            <pc:docMk/>
            <pc:sldMk cId="1761259662" sldId="299"/>
            <ac:grpSpMk id="7" creationId="{F8B2D2A8-53E3-429A-8B2B-2EB1C5E424F2}"/>
          </ac:grpSpMkLst>
        </pc:grpChg>
        <pc:grpChg chg="add del mod">
          <ac:chgData name="Chew Leng Lim" userId="f4956819b06a5395" providerId="LiveId" clId="{64D1738D-F0F2-4F33-B73E-6056640154D5}" dt="2020-04-13T08:54:32.861" v="18178"/>
          <ac:grpSpMkLst>
            <pc:docMk/>
            <pc:sldMk cId="1761259662" sldId="299"/>
            <ac:grpSpMk id="8" creationId="{73F9BB3A-B875-4E62-B56D-21A299735CDB}"/>
          </ac:grpSpMkLst>
        </pc:grpChg>
        <pc:grpChg chg="add del mod">
          <ac:chgData name="Chew Leng Lim" userId="f4956819b06a5395" providerId="LiveId" clId="{64D1738D-F0F2-4F33-B73E-6056640154D5}" dt="2020-04-13T08:54:32.861" v="18178"/>
          <ac:grpSpMkLst>
            <pc:docMk/>
            <pc:sldMk cId="1761259662" sldId="299"/>
            <ac:grpSpMk id="11" creationId="{0316E4CD-6C6D-42BE-A90B-AEAC0C7BAA51}"/>
          </ac:grpSpMkLst>
        </pc:grpChg>
        <pc:grpChg chg="add del mod">
          <ac:chgData name="Chew Leng Lim" userId="f4956819b06a5395" providerId="LiveId" clId="{64D1738D-F0F2-4F33-B73E-6056640154D5}" dt="2020-04-13T08:54:32.861" v="18178"/>
          <ac:grpSpMkLst>
            <pc:docMk/>
            <pc:sldMk cId="1761259662" sldId="299"/>
            <ac:grpSpMk id="12" creationId="{B61DC41F-839C-4C7E-A41E-BA5379A74FAD}"/>
          </ac:grpSpMkLst>
        </pc:grpChg>
        <pc:grpChg chg="add del mod">
          <ac:chgData name="Chew Leng Lim" userId="f4956819b06a5395" providerId="LiveId" clId="{64D1738D-F0F2-4F33-B73E-6056640154D5}" dt="2020-04-13T08:54:32.861" v="18178"/>
          <ac:grpSpMkLst>
            <pc:docMk/>
            <pc:sldMk cId="1761259662" sldId="299"/>
            <ac:grpSpMk id="13" creationId="{8519CA46-2C20-4033-AB0C-A06A63B79213}"/>
          </ac:grpSpMkLst>
        </pc:grpChg>
        <pc:grpChg chg="add del mod">
          <ac:chgData name="Chew Leng Lim" userId="f4956819b06a5395" providerId="LiveId" clId="{64D1738D-F0F2-4F33-B73E-6056640154D5}" dt="2020-04-13T08:54:32.861" v="18178"/>
          <ac:grpSpMkLst>
            <pc:docMk/>
            <pc:sldMk cId="1761259662" sldId="299"/>
            <ac:grpSpMk id="14" creationId="{B5D05B7E-FD2A-4687-899A-C0210649C4AD}"/>
          </ac:grpSpMkLst>
        </pc:grpChg>
        <pc:grpChg chg="add mod">
          <ac:chgData name="Chew Leng Lim" userId="f4956819b06a5395" providerId="LiveId" clId="{64D1738D-F0F2-4F33-B73E-6056640154D5}" dt="2020-04-13T06:23:37.518" v="10414" actId="1076"/>
          <ac:grpSpMkLst>
            <pc:docMk/>
            <pc:sldMk cId="1761259662" sldId="299"/>
            <ac:grpSpMk id="69" creationId="{8CE6741D-9AF0-4859-99C7-2275CAC8143A}"/>
          </ac:grpSpMkLst>
        </pc:grpChg>
        <pc:graphicFrameChg chg="mod">
          <ac:chgData name="Chew Leng Lim" userId="f4956819b06a5395" providerId="LiveId" clId="{64D1738D-F0F2-4F33-B73E-6056640154D5}" dt="2020-04-13T08:46:10.856" v="17116" actId="164"/>
          <ac:graphicFrameMkLst>
            <pc:docMk/>
            <pc:sldMk cId="1761259662" sldId="299"/>
            <ac:graphicFrameMk id="9" creationId="{375A63CD-F656-4DBC-9E97-A61C06BB2E31}"/>
          </ac:graphicFrameMkLst>
        </pc:graphicFrameChg>
        <pc:graphicFrameChg chg="mod">
          <ac:chgData name="Chew Leng Lim" userId="f4956819b06a5395" providerId="LiveId" clId="{64D1738D-F0F2-4F33-B73E-6056640154D5}" dt="2020-04-13T08:48:06.107" v="17533" actId="164"/>
          <ac:graphicFrameMkLst>
            <pc:docMk/>
            <pc:sldMk cId="1761259662" sldId="299"/>
            <ac:graphicFrameMk id="41" creationId="{E053C582-9EDB-4C2A-8316-AE1F97B54AB6}"/>
          </ac:graphicFrameMkLst>
        </pc:graphicFrameChg>
        <pc:graphicFrameChg chg="mod">
          <ac:chgData name="Chew Leng Lim" userId="f4956819b06a5395" providerId="LiveId" clId="{64D1738D-F0F2-4F33-B73E-6056640154D5}" dt="2020-04-13T08:47:58.163" v="17521" actId="164"/>
          <ac:graphicFrameMkLst>
            <pc:docMk/>
            <pc:sldMk cId="1761259662" sldId="299"/>
            <ac:graphicFrameMk id="46" creationId="{76820563-9C99-4E40-959D-F8774CC02C23}"/>
          </ac:graphicFrameMkLst>
        </pc:graphicFrameChg>
        <pc:graphicFrameChg chg="mod">
          <ac:chgData name="Chew Leng Lim" userId="f4956819b06a5395" providerId="LiveId" clId="{64D1738D-F0F2-4F33-B73E-6056640154D5}" dt="2020-04-13T08:46:08.800" v="17115" actId="164"/>
          <ac:graphicFrameMkLst>
            <pc:docMk/>
            <pc:sldMk cId="1761259662" sldId="299"/>
            <ac:graphicFrameMk id="48" creationId="{61777650-55B6-468A-89D8-A1A2EBDBCAEC}"/>
          </ac:graphicFrameMkLst>
        </pc:graphicFrameChg>
        <pc:graphicFrameChg chg="mod">
          <ac:chgData name="Chew Leng Lim" userId="f4956819b06a5395" providerId="LiveId" clId="{64D1738D-F0F2-4F33-B73E-6056640154D5}" dt="2020-04-13T08:47:45.910" v="17505" actId="164"/>
          <ac:graphicFrameMkLst>
            <pc:docMk/>
            <pc:sldMk cId="1761259662" sldId="299"/>
            <ac:graphicFrameMk id="56" creationId="{73158DE8-DBE0-4DEE-A5D2-3C9502DF4E53}"/>
          </ac:graphicFrameMkLst>
        </pc:graphicFrameChg>
        <pc:graphicFrameChg chg="mod">
          <ac:chgData name="Chew Leng Lim" userId="f4956819b06a5395" providerId="LiveId" clId="{64D1738D-F0F2-4F33-B73E-6056640154D5}" dt="2020-04-13T08:48:14.306" v="17546" actId="164"/>
          <ac:graphicFrameMkLst>
            <pc:docMk/>
            <pc:sldMk cId="1761259662" sldId="299"/>
            <ac:graphicFrameMk id="73" creationId="{738FFADE-1236-4723-B407-0F6CBB40EC39}"/>
          </ac:graphicFrameMkLst>
        </pc:graphicFrameChg>
        <pc:graphicFrameChg chg="mod">
          <ac:chgData name="Chew Leng Lim" userId="f4956819b06a5395" providerId="LiveId" clId="{64D1738D-F0F2-4F33-B73E-6056640154D5}" dt="2020-04-13T08:46:05.756" v="17114" actId="164"/>
          <ac:graphicFrameMkLst>
            <pc:docMk/>
            <pc:sldMk cId="1761259662" sldId="299"/>
            <ac:graphicFrameMk id="89" creationId="{F12495DD-6928-4DC5-9F54-D9B81C965D7B}"/>
          </ac:graphicFrameMkLst>
        </pc:graphicFrameChg>
        <pc:graphicFrameChg chg="mod">
          <ac:chgData name="Chew Leng Lim" userId="f4956819b06a5395" providerId="LiveId" clId="{64D1738D-F0F2-4F33-B73E-6056640154D5}" dt="2020-04-13T08:46:14.041" v="17117" actId="164"/>
          <ac:graphicFrameMkLst>
            <pc:docMk/>
            <pc:sldMk cId="1761259662" sldId="299"/>
            <ac:graphicFrameMk id="125" creationId="{4C93C5FB-CC3C-4F3A-97B6-ED0C0E763C80}"/>
          </ac:graphicFrameMkLst>
        </pc:graphicFrameChg>
        <pc:cxnChg chg="add del mod">
          <ac:chgData name="Chew Leng Lim" userId="f4956819b06a5395" providerId="LiveId" clId="{64D1738D-F0F2-4F33-B73E-6056640154D5}" dt="2020-04-13T08:54:32.861" v="18178"/>
          <ac:cxnSpMkLst>
            <pc:docMk/>
            <pc:sldMk cId="1761259662" sldId="299"/>
            <ac:cxnSpMk id="84" creationId="{A908CED8-3B6C-476F-8A0D-038809A8F8BD}"/>
          </ac:cxnSpMkLst>
        </pc:cxnChg>
      </pc:sldChg>
      <pc:sldChg chg="addSp modSp add ord">
        <pc:chgData name="Chew Leng Lim" userId="f4956819b06a5395" providerId="LiveId" clId="{64D1738D-F0F2-4F33-B73E-6056640154D5}" dt="2020-04-14T11:53:08.530" v="34355" actId="20577"/>
        <pc:sldMkLst>
          <pc:docMk/>
          <pc:sldMk cId="1899335485" sldId="303"/>
        </pc:sldMkLst>
        <pc:spChg chg="mod">
          <ac:chgData name="Chew Leng Lim" userId="f4956819b06a5395" providerId="LiveId" clId="{64D1738D-F0F2-4F33-B73E-6056640154D5}" dt="2020-04-14T11:53:08.530" v="34355" actId="20577"/>
          <ac:spMkLst>
            <pc:docMk/>
            <pc:sldMk cId="1899335485" sldId="303"/>
            <ac:spMk id="62" creationId="{D6F591BD-BD60-4822-A0F8-4C14C47BEC33}"/>
          </ac:spMkLst>
        </pc:spChg>
        <pc:spChg chg="mod">
          <ac:chgData name="Chew Leng Lim" userId="f4956819b06a5395" providerId="LiveId" clId="{64D1738D-F0F2-4F33-B73E-6056640154D5}" dt="2020-04-13T11:01:39.891" v="28706" actId="164"/>
          <ac:spMkLst>
            <pc:docMk/>
            <pc:sldMk cId="1899335485" sldId="303"/>
            <ac:spMk id="63" creationId="{76CD3956-4202-4DDA-8E0B-23A08AD39BC4}"/>
          </ac:spMkLst>
        </pc:spChg>
        <pc:spChg chg="mod">
          <ac:chgData name="Chew Leng Lim" userId="f4956819b06a5395" providerId="LiveId" clId="{64D1738D-F0F2-4F33-B73E-6056640154D5}" dt="2020-04-13T11:05:09.067" v="29328" actId="164"/>
          <ac:spMkLst>
            <pc:docMk/>
            <pc:sldMk cId="1899335485" sldId="303"/>
            <ac:spMk id="65" creationId="{99EBA92A-F832-48E8-A93C-9DC3C8272BE8}"/>
          </ac:spMkLst>
        </pc:spChg>
        <pc:spChg chg="mod">
          <ac:chgData name="Chew Leng Lim" userId="f4956819b06a5395" providerId="LiveId" clId="{64D1738D-F0F2-4F33-B73E-6056640154D5}" dt="2020-04-13T11:01:39.891" v="28706" actId="164"/>
          <ac:spMkLst>
            <pc:docMk/>
            <pc:sldMk cId="1899335485" sldId="303"/>
            <ac:spMk id="72" creationId="{61BEC96E-1E07-40BD-87D6-740D0FE4C726}"/>
          </ac:spMkLst>
        </pc:spChg>
        <pc:spChg chg="mod">
          <ac:chgData name="Chew Leng Lim" userId="f4956819b06a5395" providerId="LiveId" clId="{64D1738D-F0F2-4F33-B73E-6056640154D5}" dt="2020-04-13T11:01:39.891" v="28706" actId="164"/>
          <ac:spMkLst>
            <pc:docMk/>
            <pc:sldMk cId="1899335485" sldId="303"/>
            <ac:spMk id="76" creationId="{94B8BD76-F5C6-472E-AC18-BC9471AB03A7}"/>
          </ac:spMkLst>
        </pc:spChg>
        <pc:spChg chg="mod">
          <ac:chgData name="Chew Leng Lim" userId="f4956819b06a5395" providerId="LiveId" clId="{64D1738D-F0F2-4F33-B73E-6056640154D5}" dt="2020-04-13T11:01:39.891" v="28706" actId="164"/>
          <ac:spMkLst>
            <pc:docMk/>
            <pc:sldMk cId="1899335485" sldId="303"/>
            <ac:spMk id="77" creationId="{5D1E5CC5-D812-4DCD-B416-A90ED8536B0A}"/>
          </ac:spMkLst>
        </pc:spChg>
        <pc:spChg chg="mod">
          <ac:chgData name="Chew Leng Lim" userId="f4956819b06a5395" providerId="LiveId" clId="{64D1738D-F0F2-4F33-B73E-6056640154D5}" dt="2020-04-13T11:05:09.067" v="29328" actId="164"/>
          <ac:spMkLst>
            <pc:docMk/>
            <pc:sldMk cId="1899335485" sldId="303"/>
            <ac:spMk id="78" creationId="{F30B2BE5-49EC-4F71-AD97-7E33DB6B44B4}"/>
          </ac:spMkLst>
        </pc:spChg>
        <pc:spChg chg="mod">
          <ac:chgData name="Chew Leng Lim" userId="f4956819b06a5395" providerId="LiveId" clId="{64D1738D-F0F2-4F33-B73E-6056640154D5}" dt="2020-04-13T11:05:09.067" v="29328" actId="164"/>
          <ac:spMkLst>
            <pc:docMk/>
            <pc:sldMk cId="1899335485" sldId="303"/>
            <ac:spMk id="79" creationId="{6C8A0764-7036-4479-8417-5081E422E455}"/>
          </ac:spMkLst>
        </pc:spChg>
        <pc:spChg chg="mod">
          <ac:chgData name="Chew Leng Lim" userId="f4956819b06a5395" providerId="LiveId" clId="{64D1738D-F0F2-4F33-B73E-6056640154D5}" dt="2020-04-13T11:05:09.067" v="29328" actId="164"/>
          <ac:spMkLst>
            <pc:docMk/>
            <pc:sldMk cId="1899335485" sldId="303"/>
            <ac:spMk id="80" creationId="{DB7D9CE7-0F46-44B4-9C78-40AFA30475F0}"/>
          </ac:spMkLst>
        </pc:spChg>
        <pc:spChg chg="mod">
          <ac:chgData name="Chew Leng Lim" userId="f4956819b06a5395" providerId="LiveId" clId="{64D1738D-F0F2-4F33-B73E-6056640154D5}" dt="2020-04-13T11:05:09.067" v="29328" actId="164"/>
          <ac:spMkLst>
            <pc:docMk/>
            <pc:sldMk cId="1899335485" sldId="303"/>
            <ac:spMk id="81" creationId="{6B9E7652-A7A6-4158-A48F-8616049A2FA1}"/>
          </ac:spMkLst>
        </pc:spChg>
        <pc:spChg chg="mod">
          <ac:chgData name="Chew Leng Lim" userId="f4956819b06a5395" providerId="LiveId" clId="{64D1738D-F0F2-4F33-B73E-6056640154D5}" dt="2020-04-13T11:01:39.891" v="28706" actId="164"/>
          <ac:spMkLst>
            <pc:docMk/>
            <pc:sldMk cId="1899335485" sldId="303"/>
            <ac:spMk id="83" creationId="{6CC308C5-22F3-4794-9F3A-296C8C2B4698}"/>
          </ac:spMkLst>
        </pc:spChg>
        <pc:spChg chg="mod">
          <ac:chgData name="Chew Leng Lim" userId="f4956819b06a5395" providerId="LiveId" clId="{64D1738D-F0F2-4F33-B73E-6056640154D5}" dt="2020-04-13T11:01:39.891" v="28706" actId="164"/>
          <ac:spMkLst>
            <pc:docMk/>
            <pc:sldMk cId="1899335485" sldId="303"/>
            <ac:spMk id="84" creationId="{C7CEA3B3-CB7D-417D-AC90-82DE4D1113FD}"/>
          </ac:spMkLst>
        </pc:spChg>
        <pc:spChg chg="mod">
          <ac:chgData name="Chew Leng Lim" userId="f4956819b06a5395" providerId="LiveId" clId="{64D1738D-F0F2-4F33-B73E-6056640154D5}" dt="2020-04-13T11:01:39.891" v="28706" actId="164"/>
          <ac:spMkLst>
            <pc:docMk/>
            <pc:sldMk cId="1899335485" sldId="303"/>
            <ac:spMk id="85" creationId="{04C53E39-A367-4784-A9BD-B1266FF52526}"/>
          </ac:spMkLst>
        </pc:spChg>
        <pc:spChg chg="mod">
          <ac:chgData name="Chew Leng Lim" userId="f4956819b06a5395" providerId="LiveId" clId="{64D1738D-F0F2-4F33-B73E-6056640154D5}" dt="2020-04-13T11:01:39.891" v="28706" actId="164"/>
          <ac:spMkLst>
            <pc:docMk/>
            <pc:sldMk cId="1899335485" sldId="303"/>
            <ac:spMk id="86" creationId="{AA41C000-6EA3-4830-9743-44132511D41C}"/>
          </ac:spMkLst>
        </pc:spChg>
        <pc:spChg chg="mod">
          <ac:chgData name="Chew Leng Lim" userId="f4956819b06a5395" providerId="LiveId" clId="{64D1738D-F0F2-4F33-B73E-6056640154D5}" dt="2020-04-13T11:01:39.891" v="28706" actId="164"/>
          <ac:spMkLst>
            <pc:docMk/>
            <pc:sldMk cId="1899335485" sldId="303"/>
            <ac:spMk id="87" creationId="{E0EED011-549A-4EEF-8E70-61C29F25203F}"/>
          </ac:spMkLst>
        </pc:spChg>
        <pc:spChg chg="mod">
          <ac:chgData name="Chew Leng Lim" userId="f4956819b06a5395" providerId="LiveId" clId="{64D1738D-F0F2-4F33-B73E-6056640154D5}" dt="2020-04-13T11:05:09.067" v="29328" actId="164"/>
          <ac:spMkLst>
            <pc:docMk/>
            <pc:sldMk cId="1899335485" sldId="303"/>
            <ac:spMk id="88" creationId="{C60C3C09-D450-4C72-ABF3-2A5A24F092DE}"/>
          </ac:spMkLst>
        </pc:spChg>
        <pc:spChg chg="mod">
          <ac:chgData name="Chew Leng Lim" userId="f4956819b06a5395" providerId="LiveId" clId="{64D1738D-F0F2-4F33-B73E-6056640154D5}" dt="2020-04-13T11:05:09.067" v="29328" actId="164"/>
          <ac:spMkLst>
            <pc:docMk/>
            <pc:sldMk cId="1899335485" sldId="303"/>
            <ac:spMk id="89" creationId="{BF6F9342-B17A-40B2-A1A6-01EEE09B773C}"/>
          </ac:spMkLst>
        </pc:spChg>
        <pc:spChg chg="mod">
          <ac:chgData name="Chew Leng Lim" userId="f4956819b06a5395" providerId="LiveId" clId="{64D1738D-F0F2-4F33-B73E-6056640154D5}" dt="2020-04-13T11:05:09.067" v="29328" actId="164"/>
          <ac:spMkLst>
            <pc:docMk/>
            <pc:sldMk cId="1899335485" sldId="303"/>
            <ac:spMk id="90" creationId="{DE40EBC8-FFD8-4FE5-826D-E27A714914B6}"/>
          </ac:spMkLst>
        </pc:spChg>
        <pc:spChg chg="mod">
          <ac:chgData name="Chew Leng Lim" userId="f4956819b06a5395" providerId="LiveId" clId="{64D1738D-F0F2-4F33-B73E-6056640154D5}" dt="2020-04-13T11:05:09.067" v="29328" actId="164"/>
          <ac:spMkLst>
            <pc:docMk/>
            <pc:sldMk cId="1899335485" sldId="303"/>
            <ac:spMk id="91" creationId="{0347DC07-7ACE-4231-A868-D71C8A00C851}"/>
          </ac:spMkLst>
        </pc:spChg>
        <pc:spChg chg="mod">
          <ac:chgData name="Chew Leng Lim" userId="f4956819b06a5395" providerId="LiveId" clId="{64D1738D-F0F2-4F33-B73E-6056640154D5}" dt="2020-04-13T11:05:09.067" v="29328" actId="164"/>
          <ac:spMkLst>
            <pc:docMk/>
            <pc:sldMk cId="1899335485" sldId="303"/>
            <ac:spMk id="92" creationId="{5C7E415C-1F8D-4BC6-B0D9-28B9C5E41EEA}"/>
          </ac:spMkLst>
        </pc:spChg>
        <pc:spChg chg="mod">
          <ac:chgData name="Chew Leng Lim" userId="f4956819b06a5395" providerId="LiveId" clId="{64D1738D-F0F2-4F33-B73E-6056640154D5}" dt="2020-04-13T11:46:43.666" v="33389" actId="1038"/>
          <ac:spMkLst>
            <pc:docMk/>
            <pc:sldMk cId="1899335485" sldId="303"/>
            <ac:spMk id="93" creationId="{9200F3CF-F978-4303-8320-B7E51048B8A6}"/>
          </ac:spMkLst>
        </pc:spChg>
        <pc:spChg chg="mod">
          <ac:chgData name="Chew Leng Lim" userId="f4956819b06a5395" providerId="LiveId" clId="{64D1738D-F0F2-4F33-B73E-6056640154D5}" dt="2020-04-13T11:43:52.635" v="33100" actId="14100"/>
          <ac:spMkLst>
            <pc:docMk/>
            <pc:sldMk cId="1899335485" sldId="303"/>
            <ac:spMk id="94" creationId="{2A48CC68-6F39-4AB5-8B66-687E1496AAAE}"/>
          </ac:spMkLst>
        </pc:spChg>
        <pc:spChg chg="add mod">
          <ac:chgData name="Chew Leng Lim" userId="f4956819b06a5395" providerId="LiveId" clId="{64D1738D-F0F2-4F33-B73E-6056640154D5}" dt="2020-04-13T11:46:50.132" v="33393" actId="1038"/>
          <ac:spMkLst>
            <pc:docMk/>
            <pc:sldMk cId="1899335485" sldId="303"/>
            <ac:spMk id="95" creationId="{42AD6A7E-BD55-4839-B4DD-D78E992774B7}"/>
          </ac:spMkLst>
        </pc:spChg>
        <pc:spChg chg="add mod">
          <ac:chgData name="Chew Leng Lim" userId="f4956819b06a5395" providerId="LiveId" clId="{64D1738D-F0F2-4F33-B73E-6056640154D5}" dt="2020-04-13T11:46:43.666" v="33389" actId="1038"/>
          <ac:spMkLst>
            <pc:docMk/>
            <pc:sldMk cId="1899335485" sldId="303"/>
            <ac:spMk id="96" creationId="{9C339767-7F17-4D74-80EC-50CE86D2E109}"/>
          </ac:spMkLst>
        </pc:spChg>
        <pc:spChg chg="add mod">
          <ac:chgData name="Chew Leng Lim" userId="f4956819b06a5395" providerId="LiveId" clId="{64D1738D-F0F2-4F33-B73E-6056640154D5}" dt="2020-04-13T11:46:43.666" v="33389" actId="1038"/>
          <ac:spMkLst>
            <pc:docMk/>
            <pc:sldMk cId="1899335485" sldId="303"/>
            <ac:spMk id="97" creationId="{8729DA03-EB59-415E-88B2-B2DE566DD506}"/>
          </ac:spMkLst>
        </pc:spChg>
        <pc:spChg chg="mod">
          <ac:chgData name="Chew Leng Lim" userId="f4956819b06a5395" providerId="LiveId" clId="{64D1738D-F0F2-4F33-B73E-6056640154D5}" dt="2020-04-13T11:08:05.333" v="29969" actId="164"/>
          <ac:spMkLst>
            <pc:docMk/>
            <pc:sldMk cId="1899335485" sldId="303"/>
            <ac:spMk id="98" creationId="{8DDCDB3B-5039-48C8-88D1-BA4516C11C00}"/>
          </ac:spMkLst>
        </pc:spChg>
        <pc:spChg chg="add mod">
          <ac:chgData name="Chew Leng Lim" userId="f4956819b06a5395" providerId="LiveId" clId="{64D1738D-F0F2-4F33-B73E-6056640154D5}" dt="2020-04-13T11:46:43.666" v="33389" actId="1038"/>
          <ac:spMkLst>
            <pc:docMk/>
            <pc:sldMk cId="1899335485" sldId="303"/>
            <ac:spMk id="99" creationId="{2617E36A-7DFA-4AC5-B42F-94D4C4C45BD7}"/>
          </ac:spMkLst>
        </pc:spChg>
        <pc:spChg chg="mod">
          <ac:chgData name="Chew Leng Lim" userId="f4956819b06a5395" providerId="LiveId" clId="{64D1738D-F0F2-4F33-B73E-6056640154D5}" dt="2020-04-13T11:03:14.174" v="28987" actId="164"/>
          <ac:spMkLst>
            <pc:docMk/>
            <pc:sldMk cId="1899335485" sldId="303"/>
            <ac:spMk id="108" creationId="{0D2BBFB2-F9A9-419F-8E42-C466A32F67EA}"/>
          </ac:spMkLst>
        </pc:spChg>
        <pc:spChg chg="mod">
          <ac:chgData name="Chew Leng Lim" userId="f4956819b06a5395" providerId="LiveId" clId="{64D1738D-F0F2-4F33-B73E-6056640154D5}" dt="2020-04-13T11:03:14.174" v="28987" actId="164"/>
          <ac:spMkLst>
            <pc:docMk/>
            <pc:sldMk cId="1899335485" sldId="303"/>
            <ac:spMk id="109" creationId="{4CDA43DF-8EF5-42E8-B32D-B00CDDC2EA59}"/>
          </ac:spMkLst>
        </pc:spChg>
        <pc:spChg chg="mod">
          <ac:chgData name="Chew Leng Lim" userId="f4956819b06a5395" providerId="LiveId" clId="{64D1738D-F0F2-4F33-B73E-6056640154D5}" dt="2020-04-13T11:03:14.174" v="28987" actId="164"/>
          <ac:spMkLst>
            <pc:docMk/>
            <pc:sldMk cId="1899335485" sldId="303"/>
            <ac:spMk id="111" creationId="{59EA5145-D37E-4369-91F7-0431FBA911A4}"/>
          </ac:spMkLst>
        </pc:spChg>
        <pc:spChg chg="mod">
          <ac:chgData name="Chew Leng Lim" userId="f4956819b06a5395" providerId="LiveId" clId="{64D1738D-F0F2-4F33-B73E-6056640154D5}" dt="2020-04-13T11:03:14.174" v="28987" actId="164"/>
          <ac:spMkLst>
            <pc:docMk/>
            <pc:sldMk cId="1899335485" sldId="303"/>
            <ac:spMk id="112" creationId="{31746764-9EB8-4523-8C89-5799862B7DD7}"/>
          </ac:spMkLst>
        </pc:spChg>
        <pc:spChg chg="mod">
          <ac:chgData name="Chew Leng Lim" userId="f4956819b06a5395" providerId="LiveId" clId="{64D1738D-F0F2-4F33-B73E-6056640154D5}" dt="2020-04-13T11:03:14.174" v="28987" actId="164"/>
          <ac:spMkLst>
            <pc:docMk/>
            <pc:sldMk cId="1899335485" sldId="303"/>
            <ac:spMk id="113" creationId="{ADE618AD-04BB-454E-8C7D-79EF294233D8}"/>
          </ac:spMkLst>
        </pc:spChg>
        <pc:spChg chg="mod">
          <ac:chgData name="Chew Leng Lim" userId="f4956819b06a5395" providerId="LiveId" clId="{64D1738D-F0F2-4F33-B73E-6056640154D5}" dt="2020-04-13T11:03:14.174" v="28987" actId="164"/>
          <ac:spMkLst>
            <pc:docMk/>
            <pc:sldMk cId="1899335485" sldId="303"/>
            <ac:spMk id="114" creationId="{1A533221-1090-4B77-B0F3-71D1E06B888F}"/>
          </ac:spMkLst>
        </pc:spChg>
        <pc:spChg chg="mod">
          <ac:chgData name="Chew Leng Lim" userId="f4956819b06a5395" providerId="LiveId" clId="{64D1738D-F0F2-4F33-B73E-6056640154D5}" dt="2020-04-13T11:03:14.174" v="28987" actId="164"/>
          <ac:spMkLst>
            <pc:docMk/>
            <pc:sldMk cId="1899335485" sldId="303"/>
            <ac:spMk id="115" creationId="{3C434F2C-6B8B-4CA5-8364-DD04256D0FC6}"/>
          </ac:spMkLst>
        </pc:spChg>
        <pc:spChg chg="mod">
          <ac:chgData name="Chew Leng Lim" userId="f4956819b06a5395" providerId="LiveId" clId="{64D1738D-F0F2-4F33-B73E-6056640154D5}" dt="2020-04-13T11:03:14.174" v="28987" actId="164"/>
          <ac:spMkLst>
            <pc:docMk/>
            <pc:sldMk cId="1899335485" sldId="303"/>
            <ac:spMk id="116" creationId="{72B7CFA6-2812-40B2-83AD-FF0EB4566724}"/>
          </ac:spMkLst>
        </pc:spChg>
        <pc:spChg chg="mod">
          <ac:chgData name="Chew Leng Lim" userId="f4956819b06a5395" providerId="LiveId" clId="{64D1738D-F0F2-4F33-B73E-6056640154D5}" dt="2020-04-13T11:03:14.174" v="28987" actId="164"/>
          <ac:spMkLst>
            <pc:docMk/>
            <pc:sldMk cId="1899335485" sldId="303"/>
            <ac:spMk id="117" creationId="{4A376A54-446B-446D-AB91-960E30E0AEAB}"/>
          </ac:spMkLst>
        </pc:spChg>
        <pc:spChg chg="mod">
          <ac:chgData name="Chew Leng Lim" userId="f4956819b06a5395" providerId="LiveId" clId="{64D1738D-F0F2-4F33-B73E-6056640154D5}" dt="2020-04-13T11:03:07.843" v="28986" actId="1035"/>
          <ac:spMkLst>
            <pc:docMk/>
            <pc:sldMk cId="1899335485" sldId="303"/>
            <ac:spMk id="119" creationId="{EA8862EC-F59E-4518-A083-9D5755F3BD7F}"/>
          </ac:spMkLst>
        </pc:spChg>
        <pc:spChg chg="mod">
          <ac:chgData name="Chew Leng Lim" userId="f4956819b06a5395" providerId="LiveId" clId="{64D1738D-F0F2-4F33-B73E-6056640154D5}" dt="2020-04-13T11:03:07.843" v="28986" actId="1035"/>
          <ac:spMkLst>
            <pc:docMk/>
            <pc:sldMk cId="1899335485" sldId="303"/>
            <ac:spMk id="120" creationId="{C3E8B9C3-8164-4748-A977-D94F8C23D92B}"/>
          </ac:spMkLst>
        </pc:spChg>
        <pc:spChg chg="mod">
          <ac:chgData name="Chew Leng Lim" userId="f4956819b06a5395" providerId="LiveId" clId="{64D1738D-F0F2-4F33-B73E-6056640154D5}" dt="2020-04-13T11:03:07.843" v="28986" actId="1035"/>
          <ac:spMkLst>
            <pc:docMk/>
            <pc:sldMk cId="1899335485" sldId="303"/>
            <ac:spMk id="121" creationId="{B4791457-3FBE-485C-8F45-7DF87D450EE3}"/>
          </ac:spMkLst>
        </pc:spChg>
        <pc:spChg chg="mod">
          <ac:chgData name="Chew Leng Lim" userId="f4956819b06a5395" providerId="LiveId" clId="{64D1738D-F0F2-4F33-B73E-6056640154D5}" dt="2020-04-13T11:03:07.843" v="28986" actId="1035"/>
          <ac:spMkLst>
            <pc:docMk/>
            <pc:sldMk cId="1899335485" sldId="303"/>
            <ac:spMk id="122" creationId="{FC398615-FD18-4A8A-903D-1A57E0E1EE60}"/>
          </ac:spMkLst>
        </pc:spChg>
        <pc:spChg chg="mod">
          <ac:chgData name="Chew Leng Lim" userId="f4956819b06a5395" providerId="LiveId" clId="{64D1738D-F0F2-4F33-B73E-6056640154D5}" dt="2020-04-13T11:06:35.100" v="29684" actId="164"/>
          <ac:spMkLst>
            <pc:docMk/>
            <pc:sldMk cId="1899335485" sldId="303"/>
            <ac:spMk id="123" creationId="{9979580A-28AA-4361-8CC9-04EC12B8F9D6}"/>
          </ac:spMkLst>
        </pc:spChg>
        <pc:spChg chg="mod">
          <ac:chgData name="Chew Leng Lim" userId="f4956819b06a5395" providerId="LiveId" clId="{64D1738D-F0F2-4F33-B73E-6056640154D5}" dt="2020-04-13T11:03:07.843" v="28986" actId="1035"/>
          <ac:spMkLst>
            <pc:docMk/>
            <pc:sldMk cId="1899335485" sldId="303"/>
            <ac:spMk id="124" creationId="{90A8E483-9A94-4114-851D-EC775D7B1577}"/>
          </ac:spMkLst>
        </pc:spChg>
        <pc:spChg chg="mod">
          <ac:chgData name="Chew Leng Lim" userId="f4956819b06a5395" providerId="LiveId" clId="{64D1738D-F0F2-4F33-B73E-6056640154D5}" dt="2020-04-13T11:06:35.100" v="29684" actId="164"/>
          <ac:spMkLst>
            <pc:docMk/>
            <pc:sldMk cId="1899335485" sldId="303"/>
            <ac:spMk id="125" creationId="{AF2B8464-83EA-4836-9FC8-C0D0220B4ED8}"/>
          </ac:spMkLst>
        </pc:spChg>
        <pc:spChg chg="mod">
          <ac:chgData name="Chew Leng Lim" userId="f4956819b06a5395" providerId="LiveId" clId="{64D1738D-F0F2-4F33-B73E-6056640154D5}" dt="2020-04-13T11:06:35.100" v="29684" actId="164"/>
          <ac:spMkLst>
            <pc:docMk/>
            <pc:sldMk cId="1899335485" sldId="303"/>
            <ac:spMk id="126" creationId="{56F8A849-DB58-45B7-B199-7E56BA0888FE}"/>
          </ac:spMkLst>
        </pc:spChg>
        <pc:spChg chg="mod">
          <ac:chgData name="Chew Leng Lim" userId="f4956819b06a5395" providerId="LiveId" clId="{64D1738D-F0F2-4F33-B73E-6056640154D5}" dt="2020-04-13T11:06:35.100" v="29684" actId="164"/>
          <ac:spMkLst>
            <pc:docMk/>
            <pc:sldMk cId="1899335485" sldId="303"/>
            <ac:spMk id="127" creationId="{CC62A2C1-1268-4828-B08D-CED580798E60}"/>
          </ac:spMkLst>
        </pc:spChg>
        <pc:spChg chg="mod">
          <ac:chgData name="Chew Leng Lim" userId="f4956819b06a5395" providerId="LiveId" clId="{64D1738D-F0F2-4F33-B73E-6056640154D5}" dt="2020-04-13T11:06:35.100" v="29684" actId="164"/>
          <ac:spMkLst>
            <pc:docMk/>
            <pc:sldMk cId="1899335485" sldId="303"/>
            <ac:spMk id="128" creationId="{D9D0C8CA-4AF3-4A44-A6C1-14D68BCE3625}"/>
          </ac:spMkLst>
        </pc:spChg>
        <pc:spChg chg="mod">
          <ac:chgData name="Chew Leng Lim" userId="f4956819b06a5395" providerId="LiveId" clId="{64D1738D-F0F2-4F33-B73E-6056640154D5}" dt="2020-04-13T11:07:23.451" v="29832" actId="1038"/>
          <ac:spMkLst>
            <pc:docMk/>
            <pc:sldMk cId="1899335485" sldId="303"/>
            <ac:spMk id="129" creationId="{474FCB39-5A16-41E8-8BD8-EAC760DF0DFF}"/>
          </ac:spMkLst>
        </pc:spChg>
        <pc:spChg chg="mod">
          <ac:chgData name="Chew Leng Lim" userId="f4956819b06a5395" providerId="LiveId" clId="{64D1738D-F0F2-4F33-B73E-6056640154D5}" dt="2020-04-13T11:08:05.333" v="29969" actId="164"/>
          <ac:spMkLst>
            <pc:docMk/>
            <pc:sldMk cId="1899335485" sldId="303"/>
            <ac:spMk id="130" creationId="{1107C72D-D9B5-4150-B99B-BDA4607FB2F3}"/>
          </ac:spMkLst>
        </pc:spChg>
        <pc:spChg chg="mod">
          <ac:chgData name="Chew Leng Lim" userId="f4956819b06a5395" providerId="LiveId" clId="{64D1738D-F0F2-4F33-B73E-6056640154D5}" dt="2020-04-13T11:08:05.333" v="29969" actId="164"/>
          <ac:spMkLst>
            <pc:docMk/>
            <pc:sldMk cId="1899335485" sldId="303"/>
            <ac:spMk id="131" creationId="{8C6E31EE-6930-42E1-BB65-9123233D8A9E}"/>
          </ac:spMkLst>
        </pc:spChg>
        <pc:spChg chg="mod">
          <ac:chgData name="Chew Leng Lim" userId="f4956819b06a5395" providerId="LiveId" clId="{64D1738D-F0F2-4F33-B73E-6056640154D5}" dt="2020-04-13T11:08:05.333" v="29969" actId="164"/>
          <ac:spMkLst>
            <pc:docMk/>
            <pc:sldMk cId="1899335485" sldId="303"/>
            <ac:spMk id="133" creationId="{C19FA46C-A268-4673-B7B9-3503C6E8F02B}"/>
          </ac:spMkLst>
        </pc:spChg>
        <pc:spChg chg="mod">
          <ac:chgData name="Chew Leng Lim" userId="f4956819b06a5395" providerId="LiveId" clId="{64D1738D-F0F2-4F33-B73E-6056640154D5}" dt="2020-04-13T11:08:05.333" v="29969" actId="164"/>
          <ac:spMkLst>
            <pc:docMk/>
            <pc:sldMk cId="1899335485" sldId="303"/>
            <ac:spMk id="134" creationId="{C2F3D555-57B4-4B87-B61C-DC38FDFB7CA9}"/>
          </ac:spMkLst>
        </pc:spChg>
        <pc:spChg chg="mod">
          <ac:chgData name="Chew Leng Lim" userId="f4956819b06a5395" providerId="LiveId" clId="{64D1738D-F0F2-4F33-B73E-6056640154D5}" dt="2020-04-13T11:08:05.333" v="29969" actId="164"/>
          <ac:spMkLst>
            <pc:docMk/>
            <pc:sldMk cId="1899335485" sldId="303"/>
            <ac:spMk id="136" creationId="{25CC13E5-38AE-4A6A-8460-10BD8C44E3E9}"/>
          </ac:spMkLst>
        </pc:spChg>
        <pc:spChg chg="mod">
          <ac:chgData name="Chew Leng Lim" userId="f4956819b06a5395" providerId="LiveId" clId="{64D1738D-F0F2-4F33-B73E-6056640154D5}" dt="2020-04-13T11:08:05.333" v="29969" actId="164"/>
          <ac:spMkLst>
            <pc:docMk/>
            <pc:sldMk cId="1899335485" sldId="303"/>
            <ac:spMk id="137" creationId="{8C73A436-1FA2-41A9-BCA2-895B35643995}"/>
          </ac:spMkLst>
        </pc:spChg>
        <pc:spChg chg="mod">
          <ac:chgData name="Chew Leng Lim" userId="f4956819b06a5395" providerId="LiveId" clId="{64D1738D-F0F2-4F33-B73E-6056640154D5}" dt="2020-04-13T11:08:05.333" v="29969" actId="164"/>
          <ac:spMkLst>
            <pc:docMk/>
            <pc:sldMk cId="1899335485" sldId="303"/>
            <ac:spMk id="138" creationId="{F31FAB75-2440-4B9C-ADA3-37B0182393D6}"/>
          </ac:spMkLst>
        </pc:spChg>
        <pc:spChg chg="mod">
          <ac:chgData name="Chew Leng Lim" userId="f4956819b06a5395" providerId="LiveId" clId="{64D1738D-F0F2-4F33-B73E-6056640154D5}" dt="2020-04-13T11:08:05.333" v="29969" actId="164"/>
          <ac:spMkLst>
            <pc:docMk/>
            <pc:sldMk cId="1899335485" sldId="303"/>
            <ac:spMk id="139" creationId="{9808A3A1-C7B6-4654-983C-AE6F2645D4C5}"/>
          </ac:spMkLst>
        </pc:spChg>
        <pc:spChg chg="mod">
          <ac:chgData name="Chew Leng Lim" userId="f4956819b06a5395" providerId="LiveId" clId="{64D1738D-F0F2-4F33-B73E-6056640154D5}" dt="2020-04-13T11:06:35.100" v="29684" actId="164"/>
          <ac:spMkLst>
            <pc:docMk/>
            <pc:sldMk cId="1899335485" sldId="303"/>
            <ac:spMk id="140" creationId="{C92DA7B8-EF55-4E58-B8BB-36B6B0FAE3AF}"/>
          </ac:spMkLst>
        </pc:spChg>
        <pc:spChg chg="mod">
          <ac:chgData name="Chew Leng Lim" userId="f4956819b06a5395" providerId="LiveId" clId="{64D1738D-F0F2-4F33-B73E-6056640154D5}" dt="2020-04-13T11:06:35.100" v="29684" actId="164"/>
          <ac:spMkLst>
            <pc:docMk/>
            <pc:sldMk cId="1899335485" sldId="303"/>
            <ac:spMk id="141" creationId="{20516AC8-E065-4B2C-B125-A0792858B091}"/>
          </ac:spMkLst>
        </pc:spChg>
        <pc:spChg chg="mod">
          <ac:chgData name="Chew Leng Lim" userId="f4956819b06a5395" providerId="LiveId" clId="{64D1738D-F0F2-4F33-B73E-6056640154D5}" dt="2020-04-13T11:06:35.100" v="29684" actId="164"/>
          <ac:spMkLst>
            <pc:docMk/>
            <pc:sldMk cId="1899335485" sldId="303"/>
            <ac:spMk id="142" creationId="{6F04F6DF-F696-4E6E-BA61-A94ABC578D86}"/>
          </ac:spMkLst>
        </pc:spChg>
        <pc:spChg chg="mod">
          <ac:chgData name="Chew Leng Lim" userId="f4956819b06a5395" providerId="LiveId" clId="{64D1738D-F0F2-4F33-B73E-6056640154D5}" dt="2020-04-13T11:06:35.100" v="29684" actId="164"/>
          <ac:spMkLst>
            <pc:docMk/>
            <pc:sldMk cId="1899335485" sldId="303"/>
            <ac:spMk id="143" creationId="{D5A428D4-35E1-45EB-A7BC-F42E00D3B145}"/>
          </ac:spMkLst>
        </pc:spChg>
        <pc:spChg chg="mod">
          <ac:chgData name="Chew Leng Lim" userId="f4956819b06a5395" providerId="LiveId" clId="{64D1738D-F0F2-4F33-B73E-6056640154D5}" dt="2020-04-13T11:46:43.666" v="33389" actId="1038"/>
          <ac:spMkLst>
            <pc:docMk/>
            <pc:sldMk cId="1899335485" sldId="303"/>
            <ac:spMk id="144" creationId="{7B07E4E2-0206-4A74-9052-4C142563F084}"/>
          </ac:spMkLst>
        </pc:spChg>
        <pc:spChg chg="mod">
          <ac:chgData name="Chew Leng Lim" userId="f4956819b06a5395" providerId="LiveId" clId="{64D1738D-F0F2-4F33-B73E-6056640154D5}" dt="2020-04-13T11:44:17.648" v="33216" actId="1038"/>
          <ac:spMkLst>
            <pc:docMk/>
            <pc:sldMk cId="1899335485" sldId="303"/>
            <ac:spMk id="145" creationId="{A669F274-CFAB-4842-A3F4-6234AEA654F3}"/>
          </ac:spMkLst>
        </pc:spChg>
        <pc:spChg chg="mod">
          <ac:chgData name="Chew Leng Lim" userId="f4956819b06a5395" providerId="LiveId" clId="{64D1738D-F0F2-4F33-B73E-6056640154D5}" dt="2020-04-13T11:46:43.666" v="33389" actId="1038"/>
          <ac:spMkLst>
            <pc:docMk/>
            <pc:sldMk cId="1899335485" sldId="303"/>
            <ac:spMk id="146" creationId="{EE6FF34F-A2F9-4903-8852-9A0D092949FD}"/>
          </ac:spMkLst>
        </pc:spChg>
        <pc:spChg chg="mod">
          <ac:chgData name="Chew Leng Lim" userId="f4956819b06a5395" providerId="LiveId" clId="{64D1738D-F0F2-4F33-B73E-6056640154D5}" dt="2020-04-13T11:46:50.132" v="33393" actId="1038"/>
          <ac:spMkLst>
            <pc:docMk/>
            <pc:sldMk cId="1899335485" sldId="303"/>
            <ac:spMk id="147" creationId="{B6DEA4E9-8E61-4A53-832A-A3398D3792AA}"/>
          </ac:spMkLst>
        </pc:spChg>
        <pc:spChg chg="mod">
          <ac:chgData name="Chew Leng Lim" userId="f4956819b06a5395" providerId="LiveId" clId="{64D1738D-F0F2-4F33-B73E-6056640154D5}" dt="2020-04-13T11:44:29.571" v="33223" actId="554"/>
          <ac:spMkLst>
            <pc:docMk/>
            <pc:sldMk cId="1899335485" sldId="303"/>
            <ac:spMk id="148" creationId="{4BC5927F-1B5F-4238-BB57-8B7728BCDF53}"/>
          </ac:spMkLst>
        </pc:spChg>
        <pc:grpChg chg="add mod">
          <ac:chgData name="Chew Leng Lim" userId="f4956819b06a5395" providerId="LiveId" clId="{64D1738D-F0F2-4F33-B73E-6056640154D5}" dt="2020-04-13T11:44:03.739" v="33173" actId="1037"/>
          <ac:grpSpMkLst>
            <pc:docMk/>
            <pc:sldMk cId="1899335485" sldId="303"/>
            <ac:grpSpMk id="2" creationId="{A4C27E72-1E4A-4808-B6EE-D717F5EF6E40}"/>
          </ac:grpSpMkLst>
        </pc:grpChg>
        <pc:grpChg chg="add mod">
          <ac:chgData name="Chew Leng Lim" userId="f4956819b06a5395" providerId="LiveId" clId="{64D1738D-F0F2-4F33-B73E-6056640154D5}" dt="2020-04-13T11:46:50.132" v="33393" actId="1038"/>
          <ac:grpSpMkLst>
            <pc:docMk/>
            <pc:sldMk cId="1899335485" sldId="303"/>
            <ac:grpSpMk id="3" creationId="{48267681-4F62-40A7-BB91-19BDEE716B7E}"/>
          </ac:grpSpMkLst>
        </pc:grpChg>
        <pc:grpChg chg="add mod">
          <ac:chgData name="Chew Leng Lim" userId="f4956819b06a5395" providerId="LiveId" clId="{64D1738D-F0F2-4F33-B73E-6056640154D5}" dt="2020-04-13T11:46:43.666" v="33389" actId="1038"/>
          <ac:grpSpMkLst>
            <pc:docMk/>
            <pc:sldMk cId="1899335485" sldId="303"/>
            <ac:grpSpMk id="4" creationId="{8384AFF6-EF21-4F64-9B2D-93A4FA18FC08}"/>
          </ac:grpSpMkLst>
        </pc:grpChg>
        <pc:grpChg chg="add mod">
          <ac:chgData name="Chew Leng Lim" userId="f4956819b06a5395" providerId="LiveId" clId="{64D1738D-F0F2-4F33-B73E-6056640154D5}" dt="2020-04-13T11:46:43.666" v="33389" actId="1038"/>
          <ac:grpSpMkLst>
            <pc:docMk/>
            <pc:sldMk cId="1899335485" sldId="303"/>
            <ac:grpSpMk id="5" creationId="{C369492E-6740-4BB8-A03A-D7B71BF8FDAA}"/>
          </ac:grpSpMkLst>
        </pc:grpChg>
        <pc:grpChg chg="add mod">
          <ac:chgData name="Chew Leng Lim" userId="f4956819b06a5395" providerId="LiveId" clId="{64D1738D-F0F2-4F33-B73E-6056640154D5}" dt="2020-04-13T11:46:43.666" v="33389" actId="1038"/>
          <ac:grpSpMkLst>
            <pc:docMk/>
            <pc:sldMk cId="1899335485" sldId="303"/>
            <ac:grpSpMk id="6" creationId="{DE9753F5-68ED-4284-83A7-232C19637C23}"/>
          </ac:grpSpMkLst>
        </pc:grpChg>
        <pc:graphicFrameChg chg="mod">
          <ac:chgData name="Chew Leng Lim" userId="f4956819b06a5395" providerId="LiveId" clId="{64D1738D-F0F2-4F33-B73E-6056640154D5}" dt="2020-04-13T11:05:09.067" v="29328" actId="164"/>
          <ac:graphicFrameMkLst>
            <pc:docMk/>
            <pc:sldMk cId="1899335485" sldId="303"/>
            <ac:graphicFrameMk id="64" creationId="{F7BBCD3D-F04B-4D4C-85C4-3819108B8429}"/>
          </ac:graphicFrameMkLst>
        </pc:graphicFrameChg>
        <pc:graphicFrameChg chg="mod">
          <ac:chgData name="Chew Leng Lim" userId="f4956819b06a5395" providerId="LiveId" clId="{64D1738D-F0F2-4F33-B73E-6056640154D5}" dt="2020-04-13T11:01:39.891" v="28706" actId="164"/>
          <ac:graphicFrameMkLst>
            <pc:docMk/>
            <pc:sldMk cId="1899335485" sldId="303"/>
            <ac:graphicFrameMk id="82" creationId="{30F93569-02D5-41F2-8B0D-ACB3F9481E14}"/>
          </ac:graphicFrameMkLst>
        </pc:graphicFrameChg>
        <pc:graphicFrameChg chg="mod">
          <ac:chgData name="Chew Leng Lim" userId="f4956819b06a5395" providerId="LiveId" clId="{64D1738D-F0F2-4F33-B73E-6056640154D5}" dt="2020-04-13T11:03:14.174" v="28987" actId="164"/>
          <ac:graphicFrameMkLst>
            <pc:docMk/>
            <pc:sldMk cId="1899335485" sldId="303"/>
            <ac:graphicFrameMk id="101" creationId="{09816226-A95F-4D55-AE08-BA7D46777699}"/>
          </ac:graphicFrameMkLst>
        </pc:graphicFrameChg>
        <pc:graphicFrameChg chg="mod">
          <ac:chgData name="Chew Leng Lim" userId="f4956819b06a5395" providerId="LiveId" clId="{64D1738D-F0F2-4F33-B73E-6056640154D5}" dt="2020-04-13T11:06:35.100" v="29684" actId="164"/>
          <ac:graphicFrameMkLst>
            <pc:docMk/>
            <pc:sldMk cId="1899335485" sldId="303"/>
            <ac:graphicFrameMk id="102" creationId="{DF817276-B741-4CA3-BF5E-57D2A3ACFF6E}"/>
          </ac:graphicFrameMkLst>
        </pc:graphicFrameChg>
        <pc:graphicFrameChg chg="mod">
          <ac:chgData name="Chew Leng Lim" userId="f4956819b06a5395" providerId="LiveId" clId="{64D1738D-F0F2-4F33-B73E-6056640154D5}" dt="2020-04-13T11:08:05.333" v="29969" actId="164"/>
          <ac:graphicFrameMkLst>
            <pc:docMk/>
            <pc:sldMk cId="1899335485" sldId="303"/>
            <ac:graphicFrameMk id="103" creationId="{C19A3F99-15A4-42D8-A8A6-4BED89EC3036}"/>
          </ac:graphicFrameMkLst>
        </pc:graphicFrameChg>
        <pc:cxnChg chg="mod">
          <ac:chgData name="Chew Leng Lim" userId="f4956819b06a5395" providerId="LiveId" clId="{64D1738D-F0F2-4F33-B73E-6056640154D5}" dt="2020-04-13T11:01:39.891" v="28706" actId="164"/>
          <ac:cxnSpMkLst>
            <pc:docMk/>
            <pc:sldMk cId="1899335485" sldId="303"/>
            <ac:cxnSpMk id="66" creationId="{70B2492C-E2CF-4BDF-ADC0-52653781029C}"/>
          </ac:cxnSpMkLst>
        </pc:cxnChg>
        <pc:cxnChg chg="mod">
          <ac:chgData name="Chew Leng Lim" userId="f4956819b06a5395" providerId="LiveId" clId="{64D1738D-F0F2-4F33-B73E-6056640154D5}" dt="2020-04-13T11:01:39.891" v="28706" actId="164"/>
          <ac:cxnSpMkLst>
            <pc:docMk/>
            <pc:sldMk cId="1899335485" sldId="303"/>
            <ac:cxnSpMk id="67" creationId="{5F14F05B-3F35-4453-98A5-2615F17CB7FF}"/>
          </ac:cxnSpMkLst>
        </pc:cxnChg>
        <pc:cxnChg chg="mod">
          <ac:chgData name="Chew Leng Lim" userId="f4956819b06a5395" providerId="LiveId" clId="{64D1738D-F0F2-4F33-B73E-6056640154D5}" dt="2020-04-13T11:01:39.891" v="28706" actId="164"/>
          <ac:cxnSpMkLst>
            <pc:docMk/>
            <pc:sldMk cId="1899335485" sldId="303"/>
            <ac:cxnSpMk id="68" creationId="{049A5F86-99BD-4A73-BEFF-F44C20E301F8}"/>
          </ac:cxnSpMkLst>
        </pc:cxnChg>
        <pc:cxnChg chg="mod">
          <ac:chgData name="Chew Leng Lim" userId="f4956819b06a5395" providerId="LiveId" clId="{64D1738D-F0F2-4F33-B73E-6056640154D5}" dt="2020-04-13T11:01:39.891" v="28706" actId="164"/>
          <ac:cxnSpMkLst>
            <pc:docMk/>
            <pc:sldMk cId="1899335485" sldId="303"/>
            <ac:cxnSpMk id="69" creationId="{7851EFCC-0B90-415F-8868-47D7DF51E9B8}"/>
          </ac:cxnSpMkLst>
        </pc:cxnChg>
        <pc:cxnChg chg="mod">
          <ac:chgData name="Chew Leng Lim" userId="f4956819b06a5395" providerId="LiveId" clId="{64D1738D-F0F2-4F33-B73E-6056640154D5}" dt="2020-04-13T11:01:39.891" v="28706" actId="164"/>
          <ac:cxnSpMkLst>
            <pc:docMk/>
            <pc:sldMk cId="1899335485" sldId="303"/>
            <ac:cxnSpMk id="70" creationId="{A0F6C711-B696-447B-9123-1C1C705EB54A}"/>
          </ac:cxnSpMkLst>
        </pc:cxnChg>
        <pc:cxnChg chg="mod">
          <ac:chgData name="Chew Leng Lim" userId="f4956819b06a5395" providerId="LiveId" clId="{64D1738D-F0F2-4F33-B73E-6056640154D5}" dt="2020-04-13T11:01:39.891" v="28706" actId="164"/>
          <ac:cxnSpMkLst>
            <pc:docMk/>
            <pc:sldMk cId="1899335485" sldId="303"/>
            <ac:cxnSpMk id="71" creationId="{2EBF13DC-1567-4D21-9A9B-E441FD023408}"/>
          </ac:cxnSpMkLst>
        </pc:cxnChg>
        <pc:cxnChg chg="mod">
          <ac:chgData name="Chew Leng Lim" userId="f4956819b06a5395" providerId="LiveId" clId="{64D1738D-F0F2-4F33-B73E-6056640154D5}" dt="2020-04-13T11:01:39.891" v="28706" actId="164"/>
          <ac:cxnSpMkLst>
            <pc:docMk/>
            <pc:sldMk cId="1899335485" sldId="303"/>
            <ac:cxnSpMk id="73" creationId="{B12D9158-0E00-4E6E-8A19-A15CB8B32E9B}"/>
          </ac:cxnSpMkLst>
        </pc:cxnChg>
        <pc:cxnChg chg="mod">
          <ac:chgData name="Chew Leng Lim" userId="f4956819b06a5395" providerId="LiveId" clId="{64D1738D-F0F2-4F33-B73E-6056640154D5}" dt="2020-04-13T11:01:39.891" v="28706" actId="164"/>
          <ac:cxnSpMkLst>
            <pc:docMk/>
            <pc:sldMk cId="1899335485" sldId="303"/>
            <ac:cxnSpMk id="74" creationId="{C2BBF189-0E65-4473-BB2B-F377C3CFDF29}"/>
          </ac:cxnSpMkLst>
        </pc:cxnChg>
        <pc:cxnChg chg="mod">
          <ac:chgData name="Chew Leng Lim" userId="f4956819b06a5395" providerId="LiveId" clId="{64D1738D-F0F2-4F33-B73E-6056640154D5}" dt="2020-04-13T11:01:39.891" v="28706" actId="164"/>
          <ac:cxnSpMkLst>
            <pc:docMk/>
            <pc:sldMk cId="1899335485" sldId="303"/>
            <ac:cxnSpMk id="75" creationId="{E9E2257E-B4DB-4F8C-A3A9-367BD181371B}"/>
          </ac:cxnSpMkLst>
        </pc:cxnChg>
      </pc:sldChg>
      <pc:sldChg chg="addSp modSp del">
        <pc:chgData name="Chew Leng Lim" userId="f4956819b06a5395" providerId="LiveId" clId="{64D1738D-F0F2-4F33-B73E-6056640154D5}" dt="2020-04-13T06:02:02.773" v="7798" actId="2696"/>
        <pc:sldMkLst>
          <pc:docMk/>
          <pc:sldMk cId="2352783057" sldId="303"/>
        </pc:sldMkLst>
        <pc:spChg chg="mod">
          <ac:chgData name="Chew Leng Lim" userId="f4956819b06a5395" providerId="LiveId" clId="{64D1738D-F0F2-4F33-B73E-6056640154D5}" dt="2020-04-07T06:35:35.480" v="45" actId="1076"/>
          <ac:spMkLst>
            <pc:docMk/>
            <pc:sldMk cId="2352783057" sldId="303"/>
            <ac:spMk id="62" creationId="{D6F591BD-BD60-4822-A0F8-4C14C47BEC33}"/>
          </ac:spMkLst>
        </pc:spChg>
        <pc:spChg chg="add mod">
          <ac:chgData name="Chew Leng Lim" userId="f4956819b06a5395" providerId="LiveId" clId="{64D1738D-F0F2-4F33-B73E-6056640154D5}" dt="2020-04-13T04:48:50.763" v="5221" actId="1076"/>
          <ac:spMkLst>
            <pc:docMk/>
            <pc:sldMk cId="2352783057" sldId="303"/>
            <ac:spMk id="94" creationId="{2A48CC68-6F39-4AB5-8B66-687E1496AAAE}"/>
          </ac:spMkLst>
        </pc:spChg>
      </pc:sldChg>
      <pc:sldChg chg="addSp delSp modSp ord">
        <pc:chgData name="Chew Leng Lim" userId="f4956819b06a5395" providerId="LiveId" clId="{64D1738D-F0F2-4F33-B73E-6056640154D5}" dt="2020-04-15T08:26:42.648" v="34375" actId="478"/>
        <pc:sldMkLst>
          <pc:docMk/>
          <pc:sldMk cId="4078230159" sldId="304"/>
        </pc:sldMkLst>
        <pc:spChg chg="mod topLvl">
          <ac:chgData name="Chew Leng Lim" userId="f4956819b06a5395" providerId="LiveId" clId="{64D1738D-F0F2-4F33-B73E-6056640154D5}" dt="2020-04-13T10:13:03.196" v="24012" actId="164"/>
          <ac:spMkLst>
            <pc:docMk/>
            <pc:sldMk cId="4078230159" sldId="304"/>
            <ac:spMk id="12" creationId="{BCB1B8DC-0882-426A-B855-4C9A9634FD41}"/>
          </ac:spMkLst>
        </pc:spChg>
        <pc:spChg chg="mod topLvl">
          <ac:chgData name="Chew Leng Lim" userId="f4956819b06a5395" providerId="LiveId" clId="{64D1738D-F0F2-4F33-B73E-6056640154D5}" dt="2020-04-13T10:13:03.196" v="24012" actId="164"/>
          <ac:spMkLst>
            <pc:docMk/>
            <pc:sldMk cId="4078230159" sldId="304"/>
            <ac:spMk id="13" creationId="{0CA9D9CD-7067-48FE-AEC0-95EE1BE702A5}"/>
          </ac:spMkLst>
        </pc:spChg>
        <pc:spChg chg="mod topLvl">
          <ac:chgData name="Chew Leng Lim" userId="f4956819b06a5395" providerId="LiveId" clId="{64D1738D-F0F2-4F33-B73E-6056640154D5}" dt="2020-04-13T10:13:03.196" v="24012" actId="164"/>
          <ac:spMkLst>
            <pc:docMk/>
            <pc:sldMk cId="4078230159" sldId="304"/>
            <ac:spMk id="14" creationId="{5CF4056F-922A-49AC-A738-F0A1B1DD307A}"/>
          </ac:spMkLst>
        </pc:spChg>
        <pc:spChg chg="mod topLvl">
          <ac:chgData name="Chew Leng Lim" userId="f4956819b06a5395" providerId="LiveId" clId="{64D1738D-F0F2-4F33-B73E-6056640154D5}" dt="2020-04-13T10:13:03.196" v="24012" actId="164"/>
          <ac:spMkLst>
            <pc:docMk/>
            <pc:sldMk cId="4078230159" sldId="304"/>
            <ac:spMk id="15" creationId="{A8F540DD-6BAB-458E-AC75-E00A801B1B9B}"/>
          </ac:spMkLst>
        </pc:spChg>
        <pc:spChg chg="mod topLvl">
          <ac:chgData name="Chew Leng Lim" userId="f4956819b06a5395" providerId="LiveId" clId="{64D1738D-F0F2-4F33-B73E-6056640154D5}" dt="2020-04-13T10:13:03.196" v="24012" actId="164"/>
          <ac:spMkLst>
            <pc:docMk/>
            <pc:sldMk cId="4078230159" sldId="304"/>
            <ac:spMk id="16" creationId="{CF8EC215-9A28-4B13-A791-13A1B277880F}"/>
          </ac:spMkLst>
        </pc:spChg>
        <pc:spChg chg="mod topLvl">
          <ac:chgData name="Chew Leng Lim" userId="f4956819b06a5395" providerId="LiveId" clId="{64D1738D-F0F2-4F33-B73E-6056640154D5}" dt="2020-04-13T10:13:43.085" v="24070" actId="1038"/>
          <ac:spMkLst>
            <pc:docMk/>
            <pc:sldMk cId="4078230159" sldId="304"/>
            <ac:spMk id="17" creationId="{DCB12DD8-DE24-463D-A68C-1AB2BBB327D3}"/>
          </ac:spMkLst>
        </pc:spChg>
        <pc:spChg chg="mod topLvl">
          <ac:chgData name="Chew Leng Lim" userId="f4956819b06a5395" providerId="LiveId" clId="{64D1738D-F0F2-4F33-B73E-6056640154D5}" dt="2020-04-13T10:13:03.196" v="24012" actId="164"/>
          <ac:spMkLst>
            <pc:docMk/>
            <pc:sldMk cId="4078230159" sldId="304"/>
            <ac:spMk id="22" creationId="{CEF14E02-37F1-4D2F-9883-46002522BB3B}"/>
          </ac:spMkLst>
        </pc:spChg>
        <pc:spChg chg="mod topLvl">
          <ac:chgData name="Chew Leng Lim" userId="f4956819b06a5395" providerId="LiveId" clId="{64D1738D-F0F2-4F33-B73E-6056640154D5}" dt="2020-04-13T10:38:05.480" v="26971" actId="1038"/>
          <ac:spMkLst>
            <pc:docMk/>
            <pc:sldMk cId="4078230159" sldId="304"/>
            <ac:spMk id="24" creationId="{3EE0209A-EB39-4FD5-BC2E-5B97D50EB3D6}"/>
          </ac:spMkLst>
        </pc:spChg>
        <pc:spChg chg="mod">
          <ac:chgData name="Chew Leng Lim" userId="f4956819b06a5395" providerId="LiveId" clId="{64D1738D-F0F2-4F33-B73E-6056640154D5}" dt="2020-04-13T10:13:12.132" v="24033" actId="164"/>
          <ac:spMkLst>
            <pc:docMk/>
            <pc:sldMk cId="4078230159" sldId="304"/>
            <ac:spMk id="34" creationId="{60344ECC-0FDC-4001-B2CC-3D8B4A7B850D}"/>
          </ac:spMkLst>
        </pc:spChg>
        <pc:spChg chg="mod">
          <ac:chgData name="Chew Leng Lim" userId="f4956819b06a5395" providerId="LiveId" clId="{64D1738D-F0F2-4F33-B73E-6056640154D5}" dt="2020-04-13T10:13:12.132" v="24033" actId="164"/>
          <ac:spMkLst>
            <pc:docMk/>
            <pc:sldMk cId="4078230159" sldId="304"/>
            <ac:spMk id="35" creationId="{52593526-BADF-4DCA-9783-AE50237EE42B}"/>
          </ac:spMkLst>
        </pc:spChg>
        <pc:spChg chg="mod">
          <ac:chgData name="Chew Leng Lim" userId="f4956819b06a5395" providerId="LiveId" clId="{64D1738D-F0F2-4F33-B73E-6056640154D5}" dt="2020-04-13T10:13:12.132" v="24033" actId="164"/>
          <ac:spMkLst>
            <pc:docMk/>
            <pc:sldMk cId="4078230159" sldId="304"/>
            <ac:spMk id="36" creationId="{53C26EF9-CDC0-47DA-A8B8-F7B00567CC9F}"/>
          </ac:spMkLst>
        </pc:spChg>
        <pc:spChg chg="mod">
          <ac:chgData name="Chew Leng Lim" userId="f4956819b06a5395" providerId="LiveId" clId="{64D1738D-F0F2-4F33-B73E-6056640154D5}" dt="2020-04-13T10:13:12.132" v="24033" actId="164"/>
          <ac:spMkLst>
            <pc:docMk/>
            <pc:sldMk cId="4078230159" sldId="304"/>
            <ac:spMk id="38" creationId="{FD3B3532-F396-4532-8723-BC320D23E2C5}"/>
          </ac:spMkLst>
        </pc:spChg>
        <pc:spChg chg="mod topLvl">
          <ac:chgData name="Chew Leng Lim" userId="f4956819b06a5395" providerId="LiveId" clId="{64D1738D-F0F2-4F33-B73E-6056640154D5}" dt="2020-04-13T10:18:32.578" v="24914" actId="164"/>
          <ac:spMkLst>
            <pc:docMk/>
            <pc:sldMk cId="4078230159" sldId="304"/>
            <ac:spMk id="39" creationId="{7630177B-181A-462D-938E-3DE48EB12B97}"/>
          </ac:spMkLst>
        </pc:spChg>
        <pc:spChg chg="mod topLvl">
          <ac:chgData name="Chew Leng Lim" userId="f4956819b06a5395" providerId="LiveId" clId="{64D1738D-F0F2-4F33-B73E-6056640154D5}" dt="2020-04-13T10:18:32.578" v="24914" actId="164"/>
          <ac:spMkLst>
            <pc:docMk/>
            <pc:sldMk cId="4078230159" sldId="304"/>
            <ac:spMk id="40" creationId="{86EE2203-2203-44DF-96BC-ED9A54D3259C}"/>
          </ac:spMkLst>
        </pc:spChg>
        <pc:spChg chg="mod topLvl">
          <ac:chgData name="Chew Leng Lim" userId="f4956819b06a5395" providerId="LiveId" clId="{64D1738D-F0F2-4F33-B73E-6056640154D5}" dt="2020-04-13T10:18:32.578" v="24914" actId="164"/>
          <ac:spMkLst>
            <pc:docMk/>
            <pc:sldMk cId="4078230159" sldId="304"/>
            <ac:spMk id="41" creationId="{08DC3FC6-A5A8-4634-880F-3780A8BA7078}"/>
          </ac:spMkLst>
        </pc:spChg>
        <pc:spChg chg="mod topLvl">
          <ac:chgData name="Chew Leng Lim" userId="f4956819b06a5395" providerId="LiveId" clId="{64D1738D-F0F2-4F33-B73E-6056640154D5}" dt="2020-04-13T10:18:32.578" v="24914" actId="164"/>
          <ac:spMkLst>
            <pc:docMk/>
            <pc:sldMk cId="4078230159" sldId="304"/>
            <ac:spMk id="42" creationId="{69D4D1D5-3B69-48DD-9FB7-3D0DEDE0A1A8}"/>
          </ac:spMkLst>
        </pc:spChg>
        <pc:spChg chg="mod topLvl">
          <ac:chgData name="Chew Leng Lim" userId="f4956819b06a5395" providerId="LiveId" clId="{64D1738D-F0F2-4F33-B73E-6056640154D5}" dt="2020-04-13T10:18:32.578" v="24914" actId="164"/>
          <ac:spMkLst>
            <pc:docMk/>
            <pc:sldMk cId="4078230159" sldId="304"/>
            <ac:spMk id="43" creationId="{6A967BC9-4B81-455A-98C0-515E4B575805}"/>
          </ac:spMkLst>
        </pc:spChg>
        <pc:spChg chg="mod">
          <ac:chgData name="Chew Leng Lim" userId="f4956819b06a5395" providerId="LiveId" clId="{64D1738D-F0F2-4F33-B73E-6056640154D5}" dt="2020-04-15T08:26:39.598" v="34374" actId="207"/>
          <ac:spMkLst>
            <pc:docMk/>
            <pc:sldMk cId="4078230159" sldId="304"/>
            <ac:spMk id="45" creationId="{109F8E0E-298C-47CD-AB37-C9CE844D1384}"/>
          </ac:spMkLst>
        </pc:spChg>
        <pc:spChg chg="add mod">
          <ac:chgData name="Chew Leng Lim" userId="f4956819b06a5395" providerId="LiveId" clId="{64D1738D-F0F2-4F33-B73E-6056640154D5}" dt="2020-04-13T10:49:14.879" v="27841" actId="1037"/>
          <ac:spMkLst>
            <pc:docMk/>
            <pc:sldMk cId="4078230159" sldId="304"/>
            <ac:spMk id="46" creationId="{6D8C173E-8999-40FE-B729-0A9D136EDB4E}"/>
          </ac:spMkLst>
        </pc:spChg>
        <pc:spChg chg="mod">
          <ac:chgData name="Chew Leng Lim" userId="f4956819b06a5395" providerId="LiveId" clId="{64D1738D-F0F2-4F33-B73E-6056640154D5}" dt="2020-04-13T10:13:32.795" v="24051" actId="1035"/>
          <ac:spMkLst>
            <pc:docMk/>
            <pc:sldMk cId="4078230159" sldId="304"/>
            <ac:spMk id="49" creationId="{27D7296A-ECEE-4B27-9166-FBDB7F1BF6F5}"/>
          </ac:spMkLst>
        </pc:spChg>
        <pc:spChg chg="mod topLvl">
          <ac:chgData name="Chew Leng Lim" userId="f4956819b06a5395" providerId="LiveId" clId="{64D1738D-F0F2-4F33-B73E-6056640154D5}" dt="2020-04-13T10:18:45.588" v="24927" actId="164"/>
          <ac:spMkLst>
            <pc:docMk/>
            <pc:sldMk cId="4078230159" sldId="304"/>
            <ac:spMk id="50" creationId="{AF297971-81B5-4976-8C2A-43CB08E090C3}"/>
          </ac:spMkLst>
        </pc:spChg>
        <pc:spChg chg="mod topLvl">
          <ac:chgData name="Chew Leng Lim" userId="f4956819b06a5395" providerId="LiveId" clId="{64D1738D-F0F2-4F33-B73E-6056640154D5}" dt="2020-04-13T10:18:45.588" v="24927" actId="164"/>
          <ac:spMkLst>
            <pc:docMk/>
            <pc:sldMk cId="4078230159" sldId="304"/>
            <ac:spMk id="51" creationId="{8172092E-F505-407B-8D73-473EEF26B232}"/>
          </ac:spMkLst>
        </pc:spChg>
        <pc:spChg chg="mod topLvl">
          <ac:chgData name="Chew Leng Lim" userId="f4956819b06a5395" providerId="LiveId" clId="{64D1738D-F0F2-4F33-B73E-6056640154D5}" dt="2020-04-13T10:18:45.588" v="24927" actId="164"/>
          <ac:spMkLst>
            <pc:docMk/>
            <pc:sldMk cId="4078230159" sldId="304"/>
            <ac:spMk id="52" creationId="{703EE93B-FDBC-4CE5-8865-4CC2417A94D2}"/>
          </ac:spMkLst>
        </pc:spChg>
        <pc:spChg chg="mod topLvl">
          <ac:chgData name="Chew Leng Lim" userId="f4956819b06a5395" providerId="LiveId" clId="{64D1738D-F0F2-4F33-B73E-6056640154D5}" dt="2020-04-13T10:18:45.588" v="24927" actId="164"/>
          <ac:spMkLst>
            <pc:docMk/>
            <pc:sldMk cId="4078230159" sldId="304"/>
            <ac:spMk id="53" creationId="{1C5D0AA7-CE2E-4205-950C-1BB76A3F8909}"/>
          </ac:spMkLst>
        </pc:spChg>
        <pc:spChg chg="add del mod">
          <ac:chgData name="Chew Leng Lim" userId="f4956819b06a5395" providerId="LiveId" clId="{64D1738D-F0F2-4F33-B73E-6056640154D5}" dt="2020-04-13T10:49:04.558" v="27837" actId="478"/>
          <ac:spMkLst>
            <pc:docMk/>
            <pc:sldMk cId="4078230159" sldId="304"/>
            <ac:spMk id="54" creationId="{CC26BA95-F64D-4095-9678-8FF8EC6A5CCB}"/>
          </ac:spMkLst>
        </pc:spChg>
        <pc:spChg chg="mod topLvl">
          <ac:chgData name="Chew Leng Lim" userId="f4956819b06a5395" providerId="LiveId" clId="{64D1738D-F0F2-4F33-B73E-6056640154D5}" dt="2020-04-13T10:18:32.578" v="24914" actId="164"/>
          <ac:spMkLst>
            <pc:docMk/>
            <pc:sldMk cId="4078230159" sldId="304"/>
            <ac:spMk id="55" creationId="{5DB31EF2-92BF-4868-A33F-0E1FC9C954F4}"/>
          </ac:spMkLst>
        </pc:spChg>
        <pc:spChg chg="add mod">
          <ac:chgData name="Chew Leng Lim" userId="f4956819b06a5395" providerId="LiveId" clId="{64D1738D-F0F2-4F33-B73E-6056640154D5}" dt="2020-04-13T10:49:14.879" v="27841" actId="1037"/>
          <ac:spMkLst>
            <pc:docMk/>
            <pc:sldMk cId="4078230159" sldId="304"/>
            <ac:spMk id="56" creationId="{E56D78C4-C90D-4526-849F-8B2A612AF930}"/>
          </ac:spMkLst>
        </pc:spChg>
        <pc:spChg chg="mod topLvl">
          <ac:chgData name="Chew Leng Lim" userId="f4956819b06a5395" providerId="LiveId" clId="{64D1738D-F0F2-4F33-B73E-6056640154D5}" dt="2020-04-13T10:18:45.588" v="24927" actId="164"/>
          <ac:spMkLst>
            <pc:docMk/>
            <pc:sldMk cId="4078230159" sldId="304"/>
            <ac:spMk id="57" creationId="{DA3327B8-1E4F-4C5C-83D6-3CEC7595290F}"/>
          </ac:spMkLst>
        </pc:spChg>
        <pc:spChg chg="mod">
          <ac:chgData name="Chew Leng Lim" userId="f4956819b06a5395" providerId="LiveId" clId="{64D1738D-F0F2-4F33-B73E-6056640154D5}" dt="2020-04-13T10:49:14.879" v="27841" actId="1037"/>
          <ac:spMkLst>
            <pc:docMk/>
            <pc:sldMk cId="4078230159" sldId="304"/>
            <ac:spMk id="63" creationId="{9D79B5C3-85C0-48B8-80C5-752A5FB0A6E1}"/>
          </ac:spMkLst>
        </pc:spChg>
        <pc:spChg chg="mod">
          <ac:chgData name="Chew Leng Lim" userId="f4956819b06a5395" providerId="LiveId" clId="{64D1738D-F0F2-4F33-B73E-6056640154D5}" dt="2020-04-13T10:49:14.879" v="27841" actId="1037"/>
          <ac:spMkLst>
            <pc:docMk/>
            <pc:sldMk cId="4078230159" sldId="304"/>
            <ac:spMk id="65" creationId="{E3BA0D93-A363-4228-81D6-2902BEB6F4C2}"/>
          </ac:spMkLst>
        </pc:spChg>
        <pc:spChg chg="mod">
          <ac:chgData name="Chew Leng Lim" userId="f4956819b06a5395" providerId="LiveId" clId="{64D1738D-F0F2-4F33-B73E-6056640154D5}" dt="2020-04-13T10:49:14.879" v="27841" actId="1037"/>
          <ac:spMkLst>
            <pc:docMk/>
            <pc:sldMk cId="4078230159" sldId="304"/>
            <ac:spMk id="66" creationId="{74F78DE2-EF9D-4724-A5DF-A74E6602E5A2}"/>
          </ac:spMkLst>
        </pc:spChg>
        <pc:spChg chg="mod">
          <ac:chgData name="Chew Leng Lim" userId="f4956819b06a5395" providerId="LiveId" clId="{64D1738D-F0F2-4F33-B73E-6056640154D5}" dt="2020-04-13T10:49:14.879" v="27841" actId="1037"/>
          <ac:spMkLst>
            <pc:docMk/>
            <pc:sldMk cId="4078230159" sldId="304"/>
            <ac:spMk id="67" creationId="{5256C104-F8D0-47FF-A7B3-8277C42B8F6B}"/>
          </ac:spMkLst>
        </pc:spChg>
        <pc:spChg chg="mod topLvl">
          <ac:chgData name="Chew Leng Lim" userId="f4956819b06a5395" providerId="LiveId" clId="{64D1738D-F0F2-4F33-B73E-6056640154D5}" dt="2020-04-13T10:29:53.696" v="26124" actId="164"/>
          <ac:spMkLst>
            <pc:docMk/>
            <pc:sldMk cId="4078230159" sldId="304"/>
            <ac:spMk id="76" creationId="{C34AFFEA-0098-4859-AE06-ABFB456A4FEB}"/>
          </ac:spMkLst>
        </pc:spChg>
        <pc:spChg chg="mod topLvl">
          <ac:chgData name="Chew Leng Lim" userId="f4956819b06a5395" providerId="LiveId" clId="{64D1738D-F0F2-4F33-B73E-6056640154D5}" dt="2020-04-13T10:29:53.696" v="26124" actId="164"/>
          <ac:spMkLst>
            <pc:docMk/>
            <pc:sldMk cId="4078230159" sldId="304"/>
            <ac:spMk id="77" creationId="{9AC8E83F-1E73-4842-8BE1-8E3C1D9ACDF1}"/>
          </ac:spMkLst>
        </pc:spChg>
        <pc:spChg chg="mod topLvl">
          <ac:chgData name="Chew Leng Lim" userId="f4956819b06a5395" providerId="LiveId" clId="{64D1738D-F0F2-4F33-B73E-6056640154D5}" dt="2020-04-13T10:29:53.696" v="26124" actId="164"/>
          <ac:spMkLst>
            <pc:docMk/>
            <pc:sldMk cId="4078230159" sldId="304"/>
            <ac:spMk id="78" creationId="{80AABF3E-1CC2-45AF-BB30-EDBAF40748BD}"/>
          </ac:spMkLst>
        </pc:spChg>
        <pc:spChg chg="mod topLvl">
          <ac:chgData name="Chew Leng Lim" userId="f4956819b06a5395" providerId="LiveId" clId="{64D1738D-F0F2-4F33-B73E-6056640154D5}" dt="2020-04-13T10:29:53.696" v="26124" actId="164"/>
          <ac:spMkLst>
            <pc:docMk/>
            <pc:sldMk cId="4078230159" sldId="304"/>
            <ac:spMk id="79" creationId="{D81ED210-3E84-45C4-B2B5-D5E7A2172C5B}"/>
          </ac:spMkLst>
        </pc:spChg>
        <pc:spChg chg="mod topLvl">
          <ac:chgData name="Chew Leng Lim" userId="f4956819b06a5395" providerId="LiveId" clId="{64D1738D-F0F2-4F33-B73E-6056640154D5}" dt="2020-04-13T10:29:53.696" v="26124" actId="164"/>
          <ac:spMkLst>
            <pc:docMk/>
            <pc:sldMk cId="4078230159" sldId="304"/>
            <ac:spMk id="80" creationId="{71055A62-BD5F-4BCF-8BB8-9544C3531264}"/>
          </ac:spMkLst>
        </pc:spChg>
        <pc:spChg chg="mod topLvl">
          <ac:chgData name="Chew Leng Lim" userId="f4956819b06a5395" providerId="LiveId" clId="{64D1738D-F0F2-4F33-B73E-6056640154D5}" dt="2020-04-13T10:29:53.696" v="26124" actId="164"/>
          <ac:spMkLst>
            <pc:docMk/>
            <pc:sldMk cId="4078230159" sldId="304"/>
            <ac:spMk id="81" creationId="{7E1A6EC8-112A-44E9-BE35-640982D8ED75}"/>
          </ac:spMkLst>
        </pc:spChg>
        <pc:spChg chg="mod topLvl">
          <ac:chgData name="Chew Leng Lim" userId="f4956819b06a5395" providerId="LiveId" clId="{64D1738D-F0F2-4F33-B73E-6056640154D5}" dt="2020-04-13T10:29:53.696" v="26124" actId="164"/>
          <ac:spMkLst>
            <pc:docMk/>
            <pc:sldMk cId="4078230159" sldId="304"/>
            <ac:spMk id="82" creationId="{F4BAB873-F724-494E-827B-A9BE768778B4}"/>
          </ac:spMkLst>
        </pc:spChg>
        <pc:spChg chg="add mod">
          <ac:chgData name="Chew Leng Lim" userId="f4956819b06a5395" providerId="LiveId" clId="{64D1738D-F0F2-4F33-B73E-6056640154D5}" dt="2020-04-13T10:49:14.879" v="27841" actId="1037"/>
          <ac:spMkLst>
            <pc:docMk/>
            <pc:sldMk cId="4078230159" sldId="304"/>
            <ac:spMk id="86" creationId="{85F164F5-5225-4FC6-A908-CD38FCDBE8F7}"/>
          </ac:spMkLst>
        </pc:spChg>
        <pc:spChg chg="mod topLvl">
          <ac:chgData name="Chew Leng Lim" userId="f4956819b06a5395" providerId="LiveId" clId="{64D1738D-F0F2-4F33-B73E-6056640154D5}" dt="2020-04-13T10:29:00.356" v="25963" actId="164"/>
          <ac:spMkLst>
            <pc:docMk/>
            <pc:sldMk cId="4078230159" sldId="304"/>
            <ac:spMk id="89" creationId="{27D3869A-F647-4C5D-B65D-A3A40139662F}"/>
          </ac:spMkLst>
        </pc:spChg>
        <pc:spChg chg="mod topLvl">
          <ac:chgData name="Chew Leng Lim" userId="f4956819b06a5395" providerId="LiveId" clId="{64D1738D-F0F2-4F33-B73E-6056640154D5}" dt="2020-04-13T10:29:00.356" v="25963" actId="164"/>
          <ac:spMkLst>
            <pc:docMk/>
            <pc:sldMk cId="4078230159" sldId="304"/>
            <ac:spMk id="90" creationId="{E4E82CBF-959B-4425-BC3D-2FFD873B182B}"/>
          </ac:spMkLst>
        </pc:spChg>
        <pc:spChg chg="mod topLvl">
          <ac:chgData name="Chew Leng Lim" userId="f4956819b06a5395" providerId="LiveId" clId="{64D1738D-F0F2-4F33-B73E-6056640154D5}" dt="2020-04-13T10:29:00.356" v="25963" actId="164"/>
          <ac:spMkLst>
            <pc:docMk/>
            <pc:sldMk cId="4078230159" sldId="304"/>
            <ac:spMk id="91" creationId="{76892175-1704-4AD1-8895-F7B020F220E9}"/>
          </ac:spMkLst>
        </pc:spChg>
        <pc:spChg chg="mod topLvl">
          <ac:chgData name="Chew Leng Lim" userId="f4956819b06a5395" providerId="LiveId" clId="{64D1738D-F0F2-4F33-B73E-6056640154D5}" dt="2020-04-13T10:29:00.356" v="25963" actId="164"/>
          <ac:spMkLst>
            <pc:docMk/>
            <pc:sldMk cId="4078230159" sldId="304"/>
            <ac:spMk id="92" creationId="{E0846C40-0BB7-48ED-AB4E-A8FFCE28D487}"/>
          </ac:spMkLst>
        </pc:spChg>
        <pc:spChg chg="mod topLvl">
          <ac:chgData name="Chew Leng Lim" userId="f4956819b06a5395" providerId="LiveId" clId="{64D1738D-F0F2-4F33-B73E-6056640154D5}" dt="2020-04-13T10:29:00.356" v="25963" actId="164"/>
          <ac:spMkLst>
            <pc:docMk/>
            <pc:sldMk cId="4078230159" sldId="304"/>
            <ac:spMk id="93" creationId="{13ED5210-8AB8-4A48-9DBD-E596AAC4A87E}"/>
          </ac:spMkLst>
        </pc:spChg>
        <pc:spChg chg="mod topLvl">
          <ac:chgData name="Chew Leng Lim" userId="f4956819b06a5395" providerId="LiveId" clId="{64D1738D-F0F2-4F33-B73E-6056640154D5}" dt="2020-04-13T10:29:00.356" v="25963" actId="164"/>
          <ac:spMkLst>
            <pc:docMk/>
            <pc:sldMk cId="4078230159" sldId="304"/>
            <ac:spMk id="94" creationId="{65CD22C8-D661-4FEE-9709-43BCFDF31253}"/>
          </ac:spMkLst>
        </pc:spChg>
        <pc:spChg chg="mod topLvl">
          <ac:chgData name="Chew Leng Lim" userId="f4956819b06a5395" providerId="LiveId" clId="{64D1738D-F0F2-4F33-B73E-6056640154D5}" dt="2020-04-13T10:29:00.356" v="25963" actId="164"/>
          <ac:spMkLst>
            <pc:docMk/>
            <pc:sldMk cId="4078230159" sldId="304"/>
            <ac:spMk id="95" creationId="{1EDF5388-0B7A-4F97-BFC8-7AAD1BDE440D}"/>
          </ac:spMkLst>
        </pc:spChg>
        <pc:spChg chg="mod topLvl">
          <ac:chgData name="Chew Leng Lim" userId="f4956819b06a5395" providerId="LiveId" clId="{64D1738D-F0F2-4F33-B73E-6056640154D5}" dt="2020-04-13T10:29:00.356" v="25963" actId="164"/>
          <ac:spMkLst>
            <pc:docMk/>
            <pc:sldMk cId="4078230159" sldId="304"/>
            <ac:spMk id="96" creationId="{1D8C73F3-5FF8-4FE1-9731-D1829B3DCC89}"/>
          </ac:spMkLst>
        </pc:spChg>
        <pc:spChg chg="add del mod">
          <ac:chgData name="Chew Leng Lim" userId="f4956819b06a5395" providerId="LiveId" clId="{64D1738D-F0F2-4F33-B73E-6056640154D5}" dt="2020-04-15T08:26:42.648" v="34375" actId="478"/>
          <ac:spMkLst>
            <pc:docMk/>
            <pc:sldMk cId="4078230159" sldId="304"/>
            <ac:spMk id="97" creationId="{422FEBAC-8F39-4C65-8E24-1063CBC7D021}"/>
          </ac:spMkLst>
        </pc:spChg>
        <pc:spChg chg="add mod">
          <ac:chgData name="Chew Leng Lim" userId="f4956819b06a5395" providerId="LiveId" clId="{64D1738D-F0F2-4F33-B73E-6056640154D5}" dt="2020-04-13T10:37:30.123" v="26952" actId="164"/>
          <ac:spMkLst>
            <pc:docMk/>
            <pc:sldMk cId="4078230159" sldId="304"/>
            <ac:spMk id="102" creationId="{15764585-626F-4A2F-944A-8F42332A22A0}"/>
          </ac:spMkLst>
        </pc:spChg>
        <pc:spChg chg="add mod">
          <ac:chgData name="Chew Leng Lim" userId="f4956819b06a5395" providerId="LiveId" clId="{64D1738D-F0F2-4F33-B73E-6056640154D5}" dt="2020-04-13T10:37:30.123" v="26952" actId="164"/>
          <ac:spMkLst>
            <pc:docMk/>
            <pc:sldMk cId="4078230159" sldId="304"/>
            <ac:spMk id="103" creationId="{053B137E-4704-4B8C-9F53-F5D27581A383}"/>
          </ac:spMkLst>
        </pc:spChg>
        <pc:spChg chg="add mod">
          <ac:chgData name="Chew Leng Lim" userId="f4956819b06a5395" providerId="LiveId" clId="{64D1738D-F0F2-4F33-B73E-6056640154D5}" dt="2020-04-13T10:37:30.123" v="26952" actId="164"/>
          <ac:spMkLst>
            <pc:docMk/>
            <pc:sldMk cId="4078230159" sldId="304"/>
            <ac:spMk id="104" creationId="{BDF2DCA1-B32D-4D19-9855-37218CDE05A7}"/>
          </ac:spMkLst>
        </pc:spChg>
        <pc:spChg chg="add mod">
          <ac:chgData name="Chew Leng Lim" userId="f4956819b06a5395" providerId="LiveId" clId="{64D1738D-F0F2-4F33-B73E-6056640154D5}" dt="2020-04-13T10:37:30.123" v="26952" actId="164"/>
          <ac:spMkLst>
            <pc:docMk/>
            <pc:sldMk cId="4078230159" sldId="304"/>
            <ac:spMk id="105" creationId="{0CFAA57F-D048-4FCF-97D6-FDCC3FD17C01}"/>
          </ac:spMkLst>
        </pc:spChg>
        <pc:spChg chg="add mod">
          <ac:chgData name="Chew Leng Lim" userId="f4956819b06a5395" providerId="LiveId" clId="{64D1738D-F0F2-4F33-B73E-6056640154D5}" dt="2020-04-13T10:29:53.696" v="26124" actId="164"/>
          <ac:spMkLst>
            <pc:docMk/>
            <pc:sldMk cId="4078230159" sldId="304"/>
            <ac:spMk id="106" creationId="{610FCE22-DBB4-4B75-A194-EA1C5FFD353E}"/>
          </ac:spMkLst>
        </pc:spChg>
        <pc:spChg chg="add mod">
          <ac:chgData name="Chew Leng Lim" userId="f4956819b06a5395" providerId="LiveId" clId="{64D1738D-F0F2-4F33-B73E-6056640154D5}" dt="2020-04-13T10:49:14.879" v="27841" actId="1037"/>
          <ac:spMkLst>
            <pc:docMk/>
            <pc:sldMk cId="4078230159" sldId="304"/>
            <ac:spMk id="107" creationId="{C43D1A06-F9EC-4E80-B7A5-B559BCD1D8FC}"/>
          </ac:spMkLst>
        </pc:spChg>
        <pc:spChg chg="add mod">
          <ac:chgData name="Chew Leng Lim" userId="f4956819b06a5395" providerId="LiveId" clId="{64D1738D-F0F2-4F33-B73E-6056640154D5}" dt="2020-04-13T10:49:14.879" v="27841" actId="1037"/>
          <ac:spMkLst>
            <pc:docMk/>
            <pc:sldMk cId="4078230159" sldId="304"/>
            <ac:spMk id="108" creationId="{B00C8C83-261C-4D01-A856-2A72F41E3346}"/>
          </ac:spMkLst>
        </pc:spChg>
        <pc:spChg chg="add mod">
          <ac:chgData name="Chew Leng Lim" userId="f4956819b06a5395" providerId="LiveId" clId="{64D1738D-F0F2-4F33-B73E-6056640154D5}" dt="2020-04-13T10:49:14.879" v="27841" actId="1037"/>
          <ac:spMkLst>
            <pc:docMk/>
            <pc:sldMk cId="4078230159" sldId="304"/>
            <ac:spMk id="109" creationId="{0D90DCD0-BEFD-4BA1-A84D-15E876E7E836}"/>
          </ac:spMkLst>
        </pc:spChg>
        <pc:grpChg chg="add del mod">
          <ac:chgData name="Chew Leng Lim" userId="f4956819b06a5395" providerId="LiveId" clId="{64D1738D-F0F2-4F33-B73E-6056640154D5}" dt="2020-04-13T10:12:49.016" v="24001" actId="165"/>
          <ac:grpSpMkLst>
            <pc:docMk/>
            <pc:sldMk cId="4078230159" sldId="304"/>
            <ac:grpSpMk id="6" creationId="{E9DDFF65-4B1B-4133-AA0D-CEE07228EB70}"/>
          </ac:grpSpMkLst>
        </pc:grpChg>
        <pc:grpChg chg="add mod">
          <ac:chgData name="Chew Leng Lim" userId="f4956819b06a5395" providerId="LiveId" clId="{64D1738D-F0F2-4F33-B73E-6056640154D5}" dt="2020-04-13T10:49:14.879" v="27841" actId="1037"/>
          <ac:grpSpMkLst>
            <pc:docMk/>
            <pc:sldMk cId="4078230159" sldId="304"/>
            <ac:grpSpMk id="7" creationId="{A528F5B3-7A22-494E-9580-1D40DCB07BB0}"/>
          </ac:grpSpMkLst>
        </pc:grpChg>
        <pc:grpChg chg="add mod">
          <ac:chgData name="Chew Leng Lim" userId="f4956819b06a5395" providerId="LiveId" clId="{64D1738D-F0F2-4F33-B73E-6056640154D5}" dt="2020-04-13T10:49:14.879" v="27841" actId="1037"/>
          <ac:grpSpMkLst>
            <pc:docMk/>
            <pc:sldMk cId="4078230159" sldId="304"/>
            <ac:grpSpMk id="8" creationId="{57B4CD8E-1550-4D37-80F8-A5E30F4057DB}"/>
          </ac:grpSpMkLst>
        </pc:grpChg>
        <pc:grpChg chg="add del mod">
          <ac:chgData name="Chew Leng Lim" userId="f4956819b06a5395" providerId="LiveId" clId="{64D1738D-F0F2-4F33-B73E-6056640154D5}" dt="2020-04-13T10:18:22.104" v="24901" actId="165"/>
          <ac:grpSpMkLst>
            <pc:docMk/>
            <pc:sldMk cId="4078230159" sldId="304"/>
            <ac:grpSpMk id="9" creationId="{DDDE1D4C-B135-40E7-8010-3D287241C5F4}"/>
          </ac:grpSpMkLst>
        </pc:grpChg>
        <pc:grpChg chg="add del mod">
          <ac:chgData name="Chew Leng Lim" userId="f4956819b06a5395" providerId="LiveId" clId="{64D1738D-F0F2-4F33-B73E-6056640154D5}" dt="2020-04-13T10:18:36.101" v="24915" actId="165"/>
          <ac:grpSpMkLst>
            <pc:docMk/>
            <pc:sldMk cId="4078230159" sldId="304"/>
            <ac:grpSpMk id="10" creationId="{84DDC58C-99EC-49AF-AFE9-7329B3E58667}"/>
          </ac:grpSpMkLst>
        </pc:grpChg>
        <pc:grpChg chg="add mod">
          <ac:chgData name="Chew Leng Lim" userId="f4956819b06a5395" providerId="LiveId" clId="{64D1738D-F0F2-4F33-B73E-6056640154D5}" dt="2020-04-13T10:49:14.879" v="27841" actId="1037"/>
          <ac:grpSpMkLst>
            <pc:docMk/>
            <pc:sldMk cId="4078230159" sldId="304"/>
            <ac:grpSpMk id="11" creationId="{70C172F4-FF37-4FDF-B1DC-4AE3386BA0FA}"/>
          </ac:grpSpMkLst>
        </pc:grpChg>
        <pc:grpChg chg="add mod">
          <ac:chgData name="Chew Leng Lim" userId="f4956819b06a5395" providerId="LiveId" clId="{64D1738D-F0F2-4F33-B73E-6056640154D5}" dt="2020-04-13T10:49:14.879" v="27841" actId="1037"/>
          <ac:grpSpMkLst>
            <pc:docMk/>
            <pc:sldMk cId="4078230159" sldId="304"/>
            <ac:grpSpMk id="18" creationId="{1ED01340-CF5F-4596-A672-E6C50B0AC3F7}"/>
          </ac:grpSpMkLst>
        </pc:grpChg>
        <pc:grpChg chg="add mod">
          <ac:chgData name="Chew Leng Lim" userId="f4956819b06a5395" providerId="LiveId" clId="{64D1738D-F0F2-4F33-B73E-6056640154D5}" dt="2020-04-13T10:49:14.879" v="27841" actId="1037"/>
          <ac:grpSpMkLst>
            <pc:docMk/>
            <pc:sldMk cId="4078230159" sldId="304"/>
            <ac:grpSpMk id="19" creationId="{3E8E116C-E754-47CD-90AF-02C346D58872}"/>
          </ac:grpSpMkLst>
        </pc:grpChg>
        <pc:grpChg chg="add mod">
          <ac:chgData name="Chew Leng Lim" userId="f4956819b06a5395" providerId="LiveId" clId="{64D1738D-F0F2-4F33-B73E-6056640154D5}" dt="2020-04-13T10:49:14.879" v="27841" actId="1037"/>
          <ac:grpSpMkLst>
            <pc:docMk/>
            <pc:sldMk cId="4078230159" sldId="304"/>
            <ac:grpSpMk id="20" creationId="{3FC7FEFE-59FE-4408-A530-1D202DA7DA72}"/>
          </ac:grpSpMkLst>
        </pc:grpChg>
        <pc:grpChg chg="add mod">
          <ac:chgData name="Chew Leng Lim" userId="f4956819b06a5395" providerId="LiveId" clId="{64D1738D-F0F2-4F33-B73E-6056640154D5}" dt="2020-04-13T10:49:14.879" v="27841" actId="1037"/>
          <ac:grpSpMkLst>
            <pc:docMk/>
            <pc:sldMk cId="4078230159" sldId="304"/>
            <ac:grpSpMk id="21" creationId="{A1E23E64-E0D7-445B-B305-7DEBACFB4444}"/>
          </ac:grpSpMkLst>
        </pc:grpChg>
        <pc:grpChg chg="add mod">
          <ac:chgData name="Chew Leng Lim" userId="f4956819b06a5395" providerId="LiveId" clId="{64D1738D-F0F2-4F33-B73E-6056640154D5}" dt="2020-04-13T10:49:14.879" v="27841" actId="1037"/>
          <ac:grpSpMkLst>
            <pc:docMk/>
            <pc:sldMk cId="4078230159" sldId="304"/>
            <ac:grpSpMk id="47" creationId="{4A49866B-AA5F-4736-AA9A-353B3202F0F7}"/>
          </ac:grpSpMkLst>
        </pc:grpChg>
        <pc:grpChg chg="del">
          <ac:chgData name="Chew Leng Lim" userId="f4956819b06a5395" providerId="LiveId" clId="{64D1738D-F0F2-4F33-B73E-6056640154D5}" dt="2020-04-13T06:23:49.360" v="10418" actId="478"/>
          <ac:grpSpMkLst>
            <pc:docMk/>
            <pc:sldMk cId="4078230159" sldId="304"/>
            <ac:grpSpMk id="54" creationId="{47A51CF1-2DE5-4F11-9E09-287F293B6C33}"/>
          </ac:grpSpMkLst>
        </pc:grpChg>
        <pc:grpChg chg="add mod">
          <ac:chgData name="Chew Leng Lim" userId="f4956819b06a5395" providerId="LiveId" clId="{64D1738D-F0F2-4F33-B73E-6056640154D5}" dt="2020-04-13T10:49:14.879" v="27841" actId="1037"/>
          <ac:grpSpMkLst>
            <pc:docMk/>
            <pc:sldMk cId="4078230159" sldId="304"/>
            <ac:grpSpMk id="58" creationId="{16C73B06-6460-4767-9B8F-05B22D1E3E49}"/>
          </ac:grpSpMkLst>
        </pc:grpChg>
        <pc:grpChg chg="add del mod">
          <ac:chgData name="Chew Leng Lim" userId="f4956819b06a5395" providerId="LiveId" clId="{64D1738D-F0F2-4F33-B73E-6056640154D5}" dt="2020-04-13T10:29:50.825" v="26123" actId="165"/>
          <ac:grpSpMkLst>
            <pc:docMk/>
            <pc:sldMk cId="4078230159" sldId="304"/>
            <ac:grpSpMk id="74" creationId="{BDC396C1-7908-4126-A19E-DF683FD103F3}"/>
          </ac:grpSpMkLst>
        </pc:grpChg>
        <pc:grpChg chg="add del mod">
          <ac:chgData name="Chew Leng Lim" userId="f4956819b06a5395" providerId="LiveId" clId="{64D1738D-F0F2-4F33-B73E-6056640154D5}" dt="2020-04-13T10:28:48.553" v="25960" actId="165"/>
          <ac:grpSpMkLst>
            <pc:docMk/>
            <pc:sldMk cId="4078230159" sldId="304"/>
            <ac:grpSpMk id="87" creationId="{CB78C336-FC89-431C-B84B-B57DE254C84E}"/>
          </ac:grpSpMkLst>
        </pc:grpChg>
        <pc:grpChg chg="add del mod">
          <ac:chgData name="Chew Leng Lim" userId="f4956819b06a5395" providerId="LiveId" clId="{64D1738D-F0F2-4F33-B73E-6056640154D5}" dt="2020-04-13T10:35:18.505" v="26633" actId="478"/>
          <ac:grpSpMkLst>
            <pc:docMk/>
            <pc:sldMk cId="4078230159" sldId="304"/>
            <ac:grpSpMk id="97" creationId="{8D4713E3-EE3E-4A45-B50C-88169FBC91DA}"/>
          </ac:grpSpMkLst>
        </pc:grpChg>
        <pc:graphicFrameChg chg="mod topLvl">
          <ac:chgData name="Chew Leng Lim" userId="f4956819b06a5395" providerId="LiveId" clId="{64D1738D-F0F2-4F33-B73E-6056640154D5}" dt="2020-04-13T10:13:03.196" v="24012" actId="164"/>
          <ac:graphicFrameMkLst>
            <pc:docMk/>
            <pc:sldMk cId="4078230159" sldId="304"/>
            <ac:graphicFrameMk id="2" creationId="{93E3B522-5319-4FCE-9C0C-F05A780072FD}"/>
          </ac:graphicFrameMkLst>
        </pc:graphicFrameChg>
        <pc:graphicFrameChg chg="mod">
          <ac:chgData name="Chew Leng Lim" userId="f4956819b06a5395" providerId="LiveId" clId="{64D1738D-F0F2-4F33-B73E-6056640154D5}" dt="2020-04-13T10:13:12.132" v="24033" actId="164"/>
          <ac:graphicFrameMkLst>
            <pc:docMk/>
            <pc:sldMk cId="4078230159" sldId="304"/>
            <ac:graphicFrameMk id="3" creationId="{74D1BB55-120B-4D14-80C9-5264090FCC49}"/>
          </ac:graphicFrameMkLst>
        </pc:graphicFrameChg>
        <pc:graphicFrameChg chg="mod topLvl">
          <ac:chgData name="Chew Leng Lim" userId="f4956819b06a5395" providerId="LiveId" clId="{64D1738D-F0F2-4F33-B73E-6056640154D5}" dt="2020-04-13T10:18:32.578" v="24914" actId="164"/>
          <ac:graphicFrameMkLst>
            <pc:docMk/>
            <pc:sldMk cId="4078230159" sldId="304"/>
            <ac:graphicFrameMk id="4" creationId="{CC958755-FF9A-47B7-A39B-A67C18C24446}"/>
          </ac:graphicFrameMkLst>
        </pc:graphicFrameChg>
        <pc:graphicFrameChg chg="mod topLvl">
          <ac:chgData name="Chew Leng Lim" userId="f4956819b06a5395" providerId="LiveId" clId="{64D1738D-F0F2-4F33-B73E-6056640154D5}" dt="2020-04-13T10:18:45.588" v="24927" actId="164"/>
          <ac:graphicFrameMkLst>
            <pc:docMk/>
            <pc:sldMk cId="4078230159" sldId="304"/>
            <ac:graphicFrameMk id="5" creationId="{9EFF4D88-8905-4328-912E-7888DF8E879F}"/>
          </ac:graphicFrameMkLst>
        </pc:graphicFrameChg>
        <pc:graphicFrameChg chg="mod topLvl">
          <ac:chgData name="Chew Leng Lim" userId="f4956819b06a5395" providerId="LiveId" clId="{64D1738D-F0F2-4F33-B73E-6056640154D5}" dt="2020-04-13T10:29:53.696" v="26124" actId="164"/>
          <ac:graphicFrameMkLst>
            <pc:docMk/>
            <pc:sldMk cId="4078230159" sldId="304"/>
            <ac:graphicFrameMk id="75" creationId="{DED302F1-E6DC-49C9-8EC3-0E6CC6A5AD17}"/>
          </ac:graphicFrameMkLst>
        </pc:graphicFrameChg>
        <pc:graphicFrameChg chg="mod topLvl">
          <ac:chgData name="Chew Leng Lim" userId="f4956819b06a5395" providerId="LiveId" clId="{64D1738D-F0F2-4F33-B73E-6056640154D5}" dt="2020-04-13T10:29:00.356" v="25963" actId="164"/>
          <ac:graphicFrameMkLst>
            <pc:docMk/>
            <pc:sldMk cId="4078230159" sldId="304"/>
            <ac:graphicFrameMk id="88" creationId="{C340E5FB-8611-498E-AD6C-385BA808BAE7}"/>
          </ac:graphicFrameMkLst>
        </pc:graphicFrameChg>
        <pc:cxnChg chg="mod topLvl">
          <ac:chgData name="Chew Leng Lim" userId="f4956819b06a5395" providerId="LiveId" clId="{64D1738D-F0F2-4F33-B73E-6056640154D5}" dt="2020-04-13T10:29:53.696" v="26124" actId="164"/>
          <ac:cxnSpMkLst>
            <pc:docMk/>
            <pc:sldMk cId="4078230159" sldId="304"/>
            <ac:cxnSpMk id="83" creationId="{C2871F9E-078C-47DD-8B26-DC15D88279F8}"/>
          </ac:cxnSpMkLst>
        </pc:cxnChg>
        <pc:cxnChg chg="mod topLvl">
          <ac:chgData name="Chew Leng Lim" userId="f4956819b06a5395" providerId="LiveId" clId="{64D1738D-F0F2-4F33-B73E-6056640154D5}" dt="2020-04-13T10:29:53.696" v="26124" actId="164"/>
          <ac:cxnSpMkLst>
            <pc:docMk/>
            <pc:sldMk cId="4078230159" sldId="304"/>
            <ac:cxnSpMk id="84" creationId="{DD990A8C-9F68-46BB-9A07-1FE76D77A3D5}"/>
          </ac:cxnSpMkLst>
        </pc:cxnChg>
        <pc:cxnChg chg="mod topLvl">
          <ac:chgData name="Chew Leng Lim" userId="f4956819b06a5395" providerId="LiveId" clId="{64D1738D-F0F2-4F33-B73E-6056640154D5}" dt="2020-04-13T10:29:53.696" v="26124" actId="164"/>
          <ac:cxnSpMkLst>
            <pc:docMk/>
            <pc:sldMk cId="4078230159" sldId="304"/>
            <ac:cxnSpMk id="85" creationId="{83596C57-2AA6-48B8-A75D-93D73D77E595}"/>
          </ac:cxnSpMkLst>
        </pc:cxnChg>
      </pc:sldChg>
      <pc:sldChg chg="addSp delSp modSp del">
        <pc:chgData name="Chew Leng Lim" userId="f4956819b06a5395" providerId="LiveId" clId="{64D1738D-F0F2-4F33-B73E-6056640154D5}" dt="2020-04-13T10:28:17.884" v="25959" actId="2696"/>
        <pc:sldMkLst>
          <pc:docMk/>
          <pc:sldMk cId="2182335463" sldId="325"/>
        </pc:sldMkLst>
        <pc:spChg chg="mod topLvl">
          <ac:chgData name="Chew Leng Lim" userId="f4956819b06a5395" providerId="LiveId" clId="{64D1738D-F0F2-4F33-B73E-6056640154D5}" dt="2020-04-13T10:25:46.089" v="25587" actId="164"/>
          <ac:spMkLst>
            <pc:docMk/>
            <pc:sldMk cId="2182335463" sldId="325"/>
            <ac:spMk id="21" creationId="{68F96259-526E-4174-AEE5-50BCE2A35463}"/>
          </ac:spMkLst>
        </pc:spChg>
        <pc:spChg chg="mod">
          <ac:chgData name="Chew Leng Lim" userId="f4956819b06a5395" providerId="LiveId" clId="{64D1738D-F0F2-4F33-B73E-6056640154D5}" dt="2020-04-13T10:28:05.887" v="25930" actId="164"/>
          <ac:spMkLst>
            <pc:docMk/>
            <pc:sldMk cId="2182335463" sldId="325"/>
            <ac:spMk id="33" creationId="{79A1C743-AB0F-46D8-A710-F75EE746C171}"/>
          </ac:spMkLst>
        </pc:spChg>
        <pc:spChg chg="mod">
          <ac:chgData name="Chew Leng Lim" userId="f4956819b06a5395" providerId="LiveId" clId="{64D1738D-F0F2-4F33-B73E-6056640154D5}" dt="2020-04-13T10:28:05.887" v="25930" actId="164"/>
          <ac:spMkLst>
            <pc:docMk/>
            <pc:sldMk cId="2182335463" sldId="325"/>
            <ac:spMk id="34" creationId="{C64373F7-7DD0-4EE0-A97A-CE8C5BCD371F}"/>
          </ac:spMkLst>
        </pc:spChg>
        <pc:spChg chg="mod">
          <ac:chgData name="Chew Leng Lim" userId="f4956819b06a5395" providerId="LiveId" clId="{64D1738D-F0F2-4F33-B73E-6056640154D5}" dt="2020-04-13T10:28:05.887" v="25930" actId="164"/>
          <ac:spMkLst>
            <pc:docMk/>
            <pc:sldMk cId="2182335463" sldId="325"/>
            <ac:spMk id="35" creationId="{2E13CF7B-0A5E-4F56-8C39-DE51C9AF8D7D}"/>
          </ac:spMkLst>
        </pc:spChg>
        <pc:spChg chg="mod">
          <ac:chgData name="Chew Leng Lim" userId="f4956819b06a5395" providerId="LiveId" clId="{64D1738D-F0F2-4F33-B73E-6056640154D5}" dt="2020-04-13T10:28:05.887" v="25930" actId="164"/>
          <ac:spMkLst>
            <pc:docMk/>
            <pc:sldMk cId="2182335463" sldId="325"/>
            <ac:spMk id="36" creationId="{427014C5-DBC1-48A2-83F1-F8C53E9D1666}"/>
          </ac:spMkLst>
        </pc:spChg>
        <pc:spChg chg="mod">
          <ac:chgData name="Chew Leng Lim" userId="f4956819b06a5395" providerId="LiveId" clId="{64D1738D-F0F2-4F33-B73E-6056640154D5}" dt="2020-04-13T10:28:05.887" v="25930" actId="164"/>
          <ac:spMkLst>
            <pc:docMk/>
            <pc:sldMk cId="2182335463" sldId="325"/>
            <ac:spMk id="37" creationId="{5D677237-190C-4B9C-AE60-17AA002DA160}"/>
          </ac:spMkLst>
        </pc:spChg>
        <pc:spChg chg="mod">
          <ac:chgData name="Chew Leng Lim" userId="f4956819b06a5395" providerId="LiveId" clId="{64D1738D-F0F2-4F33-B73E-6056640154D5}" dt="2020-04-13T10:28:05.887" v="25930" actId="164"/>
          <ac:spMkLst>
            <pc:docMk/>
            <pc:sldMk cId="2182335463" sldId="325"/>
            <ac:spMk id="39" creationId="{E754DBCB-AEB8-45C6-8208-9DB8F538E4F6}"/>
          </ac:spMkLst>
        </pc:spChg>
        <pc:spChg chg="add mod">
          <ac:chgData name="Chew Leng Lim" userId="f4956819b06a5395" providerId="LiveId" clId="{64D1738D-F0F2-4F33-B73E-6056640154D5}" dt="2020-04-13T04:49:15.208" v="5233" actId="1076"/>
          <ac:spMkLst>
            <pc:docMk/>
            <pc:sldMk cId="2182335463" sldId="325"/>
            <ac:spMk id="40" creationId="{5F543632-B320-433E-9AB4-7EE2CCFB558A}"/>
          </ac:spMkLst>
        </pc:spChg>
        <pc:spChg chg="mod topLvl">
          <ac:chgData name="Chew Leng Lim" userId="f4956819b06a5395" providerId="LiveId" clId="{64D1738D-F0F2-4F33-B73E-6056640154D5}" dt="2020-04-13T10:25:46.089" v="25587" actId="164"/>
          <ac:spMkLst>
            <pc:docMk/>
            <pc:sldMk cId="2182335463" sldId="325"/>
            <ac:spMk id="41" creationId="{7B327C12-B253-43DA-8915-8452963A60E6}"/>
          </ac:spMkLst>
        </pc:spChg>
        <pc:spChg chg="mod topLvl">
          <ac:chgData name="Chew Leng Lim" userId="f4956819b06a5395" providerId="LiveId" clId="{64D1738D-F0F2-4F33-B73E-6056640154D5}" dt="2020-04-13T10:25:46.089" v="25587" actId="164"/>
          <ac:spMkLst>
            <pc:docMk/>
            <pc:sldMk cId="2182335463" sldId="325"/>
            <ac:spMk id="42" creationId="{FF624C06-4F00-455D-A07A-8BFB693586F2}"/>
          </ac:spMkLst>
        </pc:spChg>
        <pc:spChg chg="mod topLvl">
          <ac:chgData name="Chew Leng Lim" userId="f4956819b06a5395" providerId="LiveId" clId="{64D1738D-F0F2-4F33-B73E-6056640154D5}" dt="2020-04-13T10:25:46.089" v="25587" actId="164"/>
          <ac:spMkLst>
            <pc:docMk/>
            <pc:sldMk cId="2182335463" sldId="325"/>
            <ac:spMk id="43" creationId="{14583AC5-9B6E-44DE-9E85-7206E26800CA}"/>
          </ac:spMkLst>
        </pc:spChg>
        <pc:spChg chg="mod topLvl">
          <ac:chgData name="Chew Leng Lim" userId="f4956819b06a5395" providerId="LiveId" clId="{64D1738D-F0F2-4F33-B73E-6056640154D5}" dt="2020-04-13T10:25:46.089" v="25587" actId="164"/>
          <ac:spMkLst>
            <pc:docMk/>
            <pc:sldMk cId="2182335463" sldId="325"/>
            <ac:spMk id="44" creationId="{D6332CEF-82F1-4978-BFFB-717374639AB3}"/>
          </ac:spMkLst>
        </pc:spChg>
        <pc:spChg chg="mod topLvl">
          <ac:chgData name="Chew Leng Lim" userId="f4956819b06a5395" providerId="LiveId" clId="{64D1738D-F0F2-4F33-B73E-6056640154D5}" dt="2020-04-13T10:25:46.089" v="25587" actId="164"/>
          <ac:spMkLst>
            <pc:docMk/>
            <pc:sldMk cId="2182335463" sldId="325"/>
            <ac:spMk id="45" creationId="{BE188AF2-5E98-4706-937A-EC884912C0B4}"/>
          </ac:spMkLst>
        </pc:spChg>
        <pc:spChg chg="mod topLvl">
          <ac:chgData name="Chew Leng Lim" userId="f4956819b06a5395" providerId="LiveId" clId="{64D1738D-F0F2-4F33-B73E-6056640154D5}" dt="2020-04-13T10:25:46.089" v="25587" actId="164"/>
          <ac:spMkLst>
            <pc:docMk/>
            <pc:sldMk cId="2182335463" sldId="325"/>
            <ac:spMk id="46" creationId="{AB1FD320-BBC4-4E67-B0CF-6EF123ED2C74}"/>
          </ac:spMkLst>
        </pc:spChg>
        <pc:spChg chg="del">
          <ac:chgData name="Chew Leng Lim" userId="f4956819b06a5395" providerId="LiveId" clId="{64D1738D-F0F2-4F33-B73E-6056640154D5}" dt="2020-04-13T10:28:09.343" v="25931"/>
          <ac:spMkLst>
            <pc:docMk/>
            <pc:sldMk cId="2182335463" sldId="325"/>
            <ac:spMk id="56" creationId="{8B8E8CFD-899D-4D67-9B64-BFC6E49C9BA2}"/>
          </ac:spMkLst>
        </pc:spChg>
        <pc:spChg chg="del">
          <ac:chgData name="Chew Leng Lim" userId="f4956819b06a5395" providerId="LiveId" clId="{64D1738D-F0F2-4F33-B73E-6056640154D5}" dt="2020-04-13T10:28:09.343" v="25931"/>
          <ac:spMkLst>
            <pc:docMk/>
            <pc:sldMk cId="2182335463" sldId="325"/>
            <ac:spMk id="57" creationId="{02C3851E-0B22-4EA0-A766-F624063A20EA}"/>
          </ac:spMkLst>
        </pc:spChg>
        <pc:spChg chg="del">
          <ac:chgData name="Chew Leng Lim" userId="f4956819b06a5395" providerId="LiveId" clId="{64D1738D-F0F2-4F33-B73E-6056640154D5}" dt="2020-04-13T10:28:09.343" v="25931"/>
          <ac:spMkLst>
            <pc:docMk/>
            <pc:sldMk cId="2182335463" sldId="325"/>
            <ac:spMk id="62" creationId="{2DAC8580-0A70-4CFA-A607-CF9B8CAB6511}"/>
          </ac:spMkLst>
        </pc:spChg>
        <pc:spChg chg="del">
          <ac:chgData name="Chew Leng Lim" userId="f4956819b06a5395" providerId="LiveId" clId="{64D1738D-F0F2-4F33-B73E-6056640154D5}" dt="2020-04-13T10:28:09.343" v="25931"/>
          <ac:spMkLst>
            <pc:docMk/>
            <pc:sldMk cId="2182335463" sldId="325"/>
            <ac:spMk id="63" creationId="{DA9EB389-2B78-4CA7-868F-AA0833B597E0}"/>
          </ac:spMkLst>
        </pc:spChg>
        <pc:spChg chg="del">
          <ac:chgData name="Chew Leng Lim" userId="f4956819b06a5395" providerId="LiveId" clId="{64D1738D-F0F2-4F33-B73E-6056640154D5}" dt="2020-04-13T06:23:57.566" v="10421" actId="478"/>
          <ac:spMkLst>
            <pc:docMk/>
            <pc:sldMk cId="2182335463" sldId="325"/>
            <ac:spMk id="88" creationId="{4E164404-3247-4925-ACC9-3BA596511132}"/>
          </ac:spMkLst>
        </pc:spChg>
        <pc:spChg chg="del">
          <ac:chgData name="Chew Leng Lim" userId="f4956819b06a5395" providerId="LiveId" clId="{64D1738D-F0F2-4F33-B73E-6056640154D5}" dt="2020-04-13T06:23:57.566" v="10421" actId="478"/>
          <ac:spMkLst>
            <pc:docMk/>
            <pc:sldMk cId="2182335463" sldId="325"/>
            <ac:spMk id="90" creationId="{647EDE83-E600-47E9-828D-68A804D1566D}"/>
          </ac:spMkLst>
        </pc:spChg>
        <pc:spChg chg="mod">
          <ac:chgData name="Chew Leng Lim" userId="f4956819b06a5395" providerId="LiveId" clId="{64D1738D-F0F2-4F33-B73E-6056640154D5}" dt="2020-04-13T10:28:05.887" v="25930" actId="164"/>
          <ac:spMkLst>
            <pc:docMk/>
            <pc:sldMk cId="2182335463" sldId="325"/>
            <ac:spMk id="100" creationId="{011ABE6E-150B-481A-BF96-40179291404A}"/>
          </ac:spMkLst>
        </pc:spChg>
        <pc:spChg chg="mod topLvl">
          <ac:chgData name="Chew Leng Lim" userId="f4956819b06a5395" providerId="LiveId" clId="{64D1738D-F0F2-4F33-B73E-6056640154D5}" dt="2020-04-13T10:26:58.618" v="25792" actId="164"/>
          <ac:spMkLst>
            <pc:docMk/>
            <pc:sldMk cId="2182335463" sldId="325"/>
            <ac:spMk id="107" creationId="{99819084-E777-43AB-8F78-942D279AE9F9}"/>
          </ac:spMkLst>
        </pc:spChg>
        <pc:spChg chg="mod topLvl">
          <ac:chgData name="Chew Leng Lim" userId="f4956819b06a5395" providerId="LiveId" clId="{64D1738D-F0F2-4F33-B73E-6056640154D5}" dt="2020-04-13T10:26:58.618" v="25792" actId="164"/>
          <ac:spMkLst>
            <pc:docMk/>
            <pc:sldMk cId="2182335463" sldId="325"/>
            <ac:spMk id="136" creationId="{3BFC7815-2557-4DB6-AF05-141AA5794543}"/>
          </ac:spMkLst>
        </pc:spChg>
        <pc:spChg chg="mod topLvl">
          <ac:chgData name="Chew Leng Lim" userId="f4956819b06a5395" providerId="LiveId" clId="{64D1738D-F0F2-4F33-B73E-6056640154D5}" dt="2020-04-13T10:26:58.618" v="25792" actId="164"/>
          <ac:spMkLst>
            <pc:docMk/>
            <pc:sldMk cId="2182335463" sldId="325"/>
            <ac:spMk id="137" creationId="{595A4991-EBEE-4627-8244-494A6B7F2C45}"/>
          </ac:spMkLst>
        </pc:spChg>
        <pc:spChg chg="mod topLvl">
          <ac:chgData name="Chew Leng Lim" userId="f4956819b06a5395" providerId="LiveId" clId="{64D1738D-F0F2-4F33-B73E-6056640154D5}" dt="2020-04-13T10:26:58.618" v="25792" actId="164"/>
          <ac:spMkLst>
            <pc:docMk/>
            <pc:sldMk cId="2182335463" sldId="325"/>
            <ac:spMk id="138" creationId="{E94A0683-9991-494A-BC11-92F2AF2D9593}"/>
          </ac:spMkLst>
        </pc:spChg>
        <pc:spChg chg="mod topLvl">
          <ac:chgData name="Chew Leng Lim" userId="f4956819b06a5395" providerId="LiveId" clId="{64D1738D-F0F2-4F33-B73E-6056640154D5}" dt="2020-04-13T10:26:58.618" v="25792" actId="164"/>
          <ac:spMkLst>
            <pc:docMk/>
            <pc:sldMk cId="2182335463" sldId="325"/>
            <ac:spMk id="139" creationId="{B31ADCE0-10BF-419E-9384-BEB86C745833}"/>
          </ac:spMkLst>
        </pc:spChg>
        <pc:spChg chg="mod topLvl">
          <ac:chgData name="Chew Leng Lim" userId="f4956819b06a5395" providerId="LiveId" clId="{64D1738D-F0F2-4F33-B73E-6056640154D5}" dt="2020-04-13T10:26:58.618" v="25792" actId="164"/>
          <ac:spMkLst>
            <pc:docMk/>
            <pc:sldMk cId="2182335463" sldId="325"/>
            <ac:spMk id="140" creationId="{5730C9F7-D9C3-4F5F-ABE5-A8A4B04D3DC1}"/>
          </ac:spMkLst>
        </pc:spChg>
        <pc:spChg chg="mod topLvl">
          <ac:chgData name="Chew Leng Lim" userId="f4956819b06a5395" providerId="LiveId" clId="{64D1738D-F0F2-4F33-B73E-6056640154D5}" dt="2020-04-13T10:26:58.618" v="25792" actId="164"/>
          <ac:spMkLst>
            <pc:docMk/>
            <pc:sldMk cId="2182335463" sldId="325"/>
            <ac:spMk id="141" creationId="{CDD0AB0C-50EA-4AB1-AA52-612AB70315E1}"/>
          </ac:spMkLst>
        </pc:spChg>
        <pc:spChg chg="mod topLvl">
          <ac:chgData name="Chew Leng Lim" userId="f4956819b06a5395" providerId="LiveId" clId="{64D1738D-F0F2-4F33-B73E-6056640154D5}" dt="2020-04-13T10:26:58.618" v="25792" actId="164"/>
          <ac:spMkLst>
            <pc:docMk/>
            <pc:sldMk cId="2182335463" sldId="325"/>
            <ac:spMk id="142" creationId="{60FBF934-D683-48EE-8CF2-6AABFE4AADFD}"/>
          </ac:spMkLst>
        </pc:spChg>
        <pc:spChg chg="del mod">
          <ac:chgData name="Chew Leng Lim" userId="f4956819b06a5395" providerId="LiveId" clId="{64D1738D-F0F2-4F33-B73E-6056640154D5}" dt="2020-04-13T10:27:33.594" v="25897"/>
          <ac:spMkLst>
            <pc:docMk/>
            <pc:sldMk cId="2182335463" sldId="325"/>
            <ac:spMk id="151" creationId="{25A1AB35-BF14-4722-8AD9-BA0B4BD22EB0}"/>
          </ac:spMkLst>
        </pc:spChg>
        <pc:spChg chg="del mod">
          <ac:chgData name="Chew Leng Lim" userId="f4956819b06a5395" providerId="LiveId" clId="{64D1738D-F0F2-4F33-B73E-6056640154D5}" dt="2020-04-13T10:28:09.343" v="25931"/>
          <ac:spMkLst>
            <pc:docMk/>
            <pc:sldMk cId="2182335463" sldId="325"/>
            <ac:spMk id="152" creationId="{A3C2F7C2-FA38-4671-B15B-E378FEFEFA0E}"/>
          </ac:spMkLst>
        </pc:spChg>
        <pc:spChg chg="del mod topLvl">
          <ac:chgData name="Chew Leng Lim" userId="f4956819b06a5395" providerId="LiveId" clId="{64D1738D-F0F2-4F33-B73E-6056640154D5}" dt="2020-04-13T10:28:09.343" v="25931"/>
          <ac:spMkLst>
            <pc:docMk/>
            <pc:sldMk cId="2182335463" sldId="325"/>
            <ac:spMk id="153" creationId="{1A0BBDE4-07D2-4DFC-B70D-3CC3B3205DA8}"/>
          </ac:spMkLst>
        </pc:spChg>
        <pc:grpChg chg="add del mod">
          <ac:chgData name="Chew Leng Lim" userId="f4956819b06a5395" providerId="LiveId" clId="{64D1738D-F0F2-4F33-B73E-6056640154D5}" dt="2020-04-13T10:28:09.343" v="25931"/>
          <ac:grpSpMkLst>
            <pc:docMk/>
            <pc:sldMk cId="2182335463" sldId="325"/>
            <ac:grpSpMk id="3" creationId="{37823D61-2942-4232-A808-C32C6E874C0F}"/>
          </ac:grpSpMkLst>
        </pc:grpChg>
        <pc:grpChg chg="add del mod">
          <ac:chgData name="Chew Leng Lim" userId="f4956819b06a5395" providerId="LiveId" clId="{64D1738D-F0F2-4F33-B73E-6056640154D5}" dt="2020-04-13T10:28:09.343" v="25931"/>
          <ac:grpSpMkLst>
            <pc:docMk/>
            <pc:sldMk cId="2182335463" sldId="325"/>
            <ac:grpSpMk id="4" creationId="{624C36C3-8547-4FA2-A830-FE890EDAE117}"/>
          </ac:grpSpMkLst>
        </pc:grpChg>
        <pc:grpChg chg="add del mod">
          <ac:chgData name="Chew Leng Lim" userId="f4956819b06a5395" providerId="LiveId" clId="{64D1738D-F0F2-4F33-B73E-6056640154D5}" dt="2020-04-13T10:28:09.343" v="25931"/>
          <ac:grpSpMkLst>
            <pc:docMk/>
            <pc:sldMk cId="2182335463" sldId="325"/>
            <ac:grpSpMk id="5" creationId="{3A06B9C9-1002-47C1-BC1A-3FE7FA7F61DD}"/>
          </ac:grpSpMkLst>
        </pc:grpChg>
        <pc:grpChg chg="del">
          <ac:chgData name="Chew Leng Lim" userId="f4956819b06a5395" providerId="LiveId" clId="{64D1738D-F0F2-4F33-B73E-6056640154D5}" dt="2020-04-13T10:19:04.361" v="24928" actId="165"/>
          <ac:grpSpMkLst>
            <pc:docMk/>
            <pc:sldMk cId="2182335463" sldId="325"/>
            <ac:grpSpMk id="13" creationId="{F838DFE0-BD30-4885-A589-7A18193CEFDA}"/>
          </ac:grpSpMkLst>
        </pc:grpChg>
        <pc:grpChg chg="del mod topLvl">
          <ac:chgData name="Chew Leng Lim" userId="f4956819b06a5395" providerId="LiveId" clId="{64D1738D-F0F2-4F33-B73E-6056640154D5}" dt="2020-04-13T10:19:10.466" v="24930" actId="165"/>
          <ac:grpSpMkLst>
            <pc:docMk/>
            <pc:sldMk cId="2182335463" sldId="325"/>
            <ac:grpSpMk id="25" creationId="{85CDBF8C-4D49-45B4-BEB9-D991C6AA3436}"/>
          </ac:grpSpMkLst>
        </pc:grpChg>
        <pc:grpChg chg="del mod topLvl">
          <ac:chgData name="Chew Leng Lim" userId="f4956819b06a5395" providerId="LiveId" clId="{64D1738D-F0F2-4F33-B73E-6056640154D5}" dt="2020-04-13T10:19:07.876" v="24929" actId="165"/>
          <ac:grpSpMkLst>
            <pc:docMk/>
            <pc:sldMk cId="2182335463" sldId="325"/>
            <ac:grpSpMk id="26" creationId="{E3A26052-EC29-4B70-9717-E4CB34EE2321}"/>
          </ac:grpSpMkLst>
        </pc:grpChg>
        <pc:grpChg chg="add del mod">
          <ac:chgData name="Chew Leng Lim" userId="f4956819b06a5395" providerId="LiveId" clId="{64D1738D-F0F2-4F33-B73E-6056640154D5}" dt="2020-04-13T10:28:09.343" v="25931"/>
          <ac:grpSpMkLst>
            <pc:docMk/>
            <pc:sldMk cId="2182335463" sldId="325"/>
            <ac:grpSpMk id="47" creationId="{63D7B333-6C5C-448D-AF89-71E0D48DBFAD}"/>
          </ac:grpSpMkLst>
        </pc:grpChg>
        <pc:graphicFrameChg chg="mod">
          <ac:chgData name="Chew Leng Lim" userId="f4956819b06a5395" providerId="LiveId" clId="{64D1738D-F0F2-4F33-B73E-6056640154D5}" dt="2020-04-13T10:28:05.887" v="25930" actId="164"/>
          <ac:graphicFrameMkLst>
            <pc:docMk/>
            <pc:sldMk cId="2182335463" sldId="325"/>
            <ac:graphicFrameMk id="2" creationId="{57C52FA1-7133-44B4-A3F3-DE8023A1DFC1}"/>
          </ac:graphicFrameMkLst>
        </pc:graphicFrameChg>
        <pc:graphicFrameChg chg="mod topLvl">
          <ac:chgData name="Chew Leng Lim" userId="f4956819b06a5395" providerId="LiveId" clId="{64D1738D-F0F2-4F33-B73E-6056640154D5}" dt="2020-04-13T10:25:46.089" v="25587" actId="164"/>
          <ac:graphicFrameMkLst>
            <pc:docMk/>
            <pc:sldMk cId="2182335463" sldId="325"/>
            <ac:graphicFrameMk id="10" creationId="{3E3C6CD0-E6A1-4857-8FF9-F7E90A1A10AF}"/>
          </ac:graphicFrameMkLst>
        </pc:graphicFrameChg>
        <pc:graphicFrameChg chg="mod topLvl">
          <ac:chgData name="Chew Leng Lim" userId="f4956819b06a5395" providerId="LiveId" clId="{64D1738D-F0F2-4F33-B73E-6056640154D5}" dt="2020-04-13T10:26:58.618" v="25792" actId="164"/>
          <ac:graphicFrameMkLst>
            <pc:docMk/>
            <pc:sldMk cId="2182335463" sldId="325"/>
            <ac:graphicFrameMk id="135" creationId="{5B3745C6-93DC-430E-A4B3-357942A2CB49}"/>
          </ac:graphicFrameMkLst>
        </pc:graphicFrameChg>
        <pc:picChg chg="del">
          <ac:chgData name="Chew Leng Lim" userId="f4956819b06a5395" providerId="LiveId" clId="{64D1738D-F0F2-4F33-B73E-6056640154D5}" dt="2020-04-13T06:23:57.566" v="10421" actId="478"/>
          <ac:picMkLst>
            <pc:docMk/>
            <pc:sldMk cId="2182335463" sldId="325"/>
            <ac:picMk id="87" creationId="{3AB32BD3-4230-4968-B02E-DD9055B00C75}"/>
          </ac:picMkLst>
        </pc:picChg>
        <pc:picChg chg="del">
          <ac:chgData name="Chew Leng Lim" userId="f4956819b06a5395" providerId="LiveId" clId="{64D1738D-F0F2-4F33-B73E-6056640154D5}" dt="2020-04-13T06:23:57.566" v="10421" actId="478"/>
          <ac:picMkLst>
            <pc:docMk/>
            <pc:sldMk cId="2182335463" sldId="325"/>
            <ac:picMk id="89" creationId="{1E937083-C77E-4ACD-9A12-885DF4C7F818}"/>
          </ac:picMkLst>
        </pc:picChg>
        <pc:cxnChg chg="mod topLvl">
          <ac:chgData name="Chew Leng Lim" userId="f4956819b06a5395" providerId="LiveId" clId="{64D1738D-F0F2-4F33-B73E-6056640154D5}" dt="2020-04-13T10:25:46.089" v="25587" actId="164"/>
          <ac:cxnSpMkLst>
            <pc:docMk/>
            <pc:sldMk cId="2182335463" sldId="325"/>
            <ac:cxnSpMk id="144" creationId="{92E52B82-D943-4E5F-A847-0D3FFC2895AC}"/>
          </ac:cxnSpMkLst>
        </pc:cxnChg>
        <pc:cxnChg chg="mod topLvl">
          <ac:chgData name="Chew Leng Lim" userId="f4956819b06a5395" providerId="LiveId" clId="{64D1738D-F0F2-4F33-B73E-6056640154D5}" dt="2020-04-13T10:25:46.089" v="25587" actId="164"/>
          <ac:cxnSpMkLst>
            <pc:docMk/>
            <pc:sldMk cId="2182335463" sldId="325"/>
            <ac:cxnSpMk id="145" creationId="{1CDE7E50-43F7-4996-A542-EB6D5A9DF705}"/>
          </ac:cxnSpMkLst>
        </pc:cxnChg>
        <pc:cxnChg chg="mod topLvl">
          <ac:chgData name="Chew Leng Lim" userId="f4956819b06a5395" providerId="LiveId" clId="{64D1738D-F0F2-4F33-B73E-6056640154D5}" dt="2020-04-13T10:25:46.089" v="25587" actId="164"/>
          <ac:cxnSpMkLst>
            <pc:docMk/>
            <pc:sldMk cId="2182335463" sldId="325"/>
            <ac:cxnSpMk id="146" creationId="{7E41087F-DEAD-4C6F-85D1-BE459068597E}"/>
          </ac:cxnSpMkLst>
        </pc:cxnChg>
      </pc:sldChg>
      <pc:sldChg chg="addSp modSp del">
        <pc:chgData name="Chew Leng Lim" userId="f4956819b06a5395" providerId="LiveId" clId="{64D1738D-F0F2-4F33-B73E-6056640154D5}" dt="2020-04-13T06:02:02.754" v="7797" actId="2696"/>
        <pc:sldMkLst>
          <pc:docMk/>
          <pc:sldMk cId="1759144904" sldId="326"/>
        </pc:sldMkLst>
        <pc:spChg chg="add mod">
          <ac:chgData name="Chew Leng Lim" userId="f4956819b06a5395" providerId="LiveId" clId="{64D1738D-F0F2-4F33-B73E-6056640154D5}" dt="2020-04-13T04:48:54.286" v="5223" actId="1076"/>
          <ac:spMkLst>
            <pc:docMk/>
            <pc:sldMk cId="1759144904" sldId="326"/>
            <ac:spMk id="48" creationId="{E27BE10F-BD50-435C-8E34-3177BB85124A}"/>
          </ac:spMkLst>
        </pc:spChg>
        <pc:spChg chg="mod">
          <ac:chgData name="Chew Leng Lim" userId="f4956819b06a5395" providerId="LiveId" clId="{64D1738D-F0F2-4F33-B73E-6056640154D5}" dt="2020-04-07T06:36:04.438" v="60" actId="20577"/>
          <ac:spMkLst>
            <pc:docMk/>
            <pc:sldMk cId="1759144904" sldId="326"/>
            <ac:spMk id="101" creationId="{BEC4EFF3-800D-4B2D-84C2-C6946D47B9E4}"/>
          </ac:spMkLst>
        </pc:spChg>
      </pc:sldChg>
      <pc:sldChg chg="addSp delSp modSp add ord">
        <pc:chgData name="Chew Leng Lim" userId="f4956819b06a5395" providerId="LiveId" clId="{64D1738D-F0F2-4F33-B73E-6056640154D5}" dt="2020-04-14T12:37:45.564" v="34360"/>
        <pc:sldMkLst>
          <pc:docMk/>
          <pc:sldMk cId="2148019920" sldId="326"/>
        </pc:sldMkLst>
        <pc:spChg chg="add del mod">
          <ac:chgData name="Chew Leng Lim" userId="f4956819b06a5395" providerId="LiveId" clId="{64D1738D-F0F2-4F33-B73E-6056640154D5}" dt="2020-04-13T11:59:16.724" v="34344" actId="478"/>
          <ac:spMkLst>
            <pc:docMk/>
            <pc:sldMk cId="2148019920" sldId="326"/>
            <ac:spMk id="7" creationId="{20C54211-F779-4FBE-9231-BDF5D70AA46D}"/>
          </ac:spMkLst>
        </pc:spChg>
        <pc:spChg chg="mod">
          <ac:chgData name="Chew Leng Lim" userId="f4956819b06a5395" providerId="LiveId" clId="{64D1738D-F0F2-4F33-B73E-6056640154D5}" dt="2020-04-13T11:14:28.370" v="31190" actId="164"/>
          <ac:spMkLst>
            <pc:docMk/>
            <pc:sldMk cId="2148019920" sldId="326"/>
            <ac:spMk id="43" creationId="{65E8C6D9-3FE0-4E71-A070-2DBC5D563DAF}"/>
          </ac:spMkLst>
        </pc:spChg>
        <pc:spChg chg="mod">
          <ac:chgData name="Chew Leng Lim" userId="f4956819b06a5395" providerId="LiveId" clId="{64D1738D-F0F2-4F33-B73E-6056640154D5}" dt="2020-04-13T11:14:28.370" v="31190" actId="164"/>
          <ac:spMkLst>
            <pc:docMk/>
            <pc:sldMk cId="2148019920" sldId="326"/>
            <ac:spMk id="44" creationId="{88C6A947-946B-4914-850F-B9F440738342}"/>
          </ac:spMkLst>
        </pc:spChg>
        <pc:spChg chg="mod">
          <ac:chgData name="Chew Leng Lim" userId="f4956819b06a5395" providerId="LiveId" clId="{64D1738D-F0F2-4F33-B73E-6056640154D5}" dt="2020-04-13T11:14:28.370" v="31190" actId="164"/>
          <ac:spMkLst>
            <pc:docMk/>
            <pc:sldMk cId="2148019920" sldId="326"/>
            <ac:spMk id="45" creationId="{333A7AEB-2074-4F5F-9AA0-72C7A6D89D40}"/>
          </ac:spMkLst>
        </pc:spChg>
        <pc:spChg chg="mod">
          <ac:chgData name="Chew Leng Lim" userId="f4956819b06a5395" providerId="LiveId" clId="{64D1738D-F0F2-4F33-B73E-6056640154D5}" dt="2020-04-13T11:14:28.370" v="31190" actId="164"/>
          <ac:spMkLst>
            <pc:docMk/>
            <pc:sldMk cId="2148019920" sldId="326"/>
            <ac:spMk id="46" creationId="{EF0F67B4-F713-4B74-8429-74CE408F2A4D}"/>
          </ac:spMkLst>
        </pc:spChg>
        <pc:spChg chg="mod">
          <ac:chgData name="Chew Leng Lim" userId="f4956819b06a5395" providerId="LiveId" clId="{64D1738D-F0F2-4F33-B73E-6056640154D5}" dt="2020-04-13T11:14:28.370" v="31190" actId="164"/>
          <ac:spMkLst>
            <pc:docMk/>
            <pc:sldMk cId="2148019920" sldId="326"/>
            <ac:spMk id="47" creationId="{383F0FFA-5219-4511-8D90-6EF4A58E3261}"/>
          </ac:spMkLst>
        </pc:spChg>
        <pc:spChg chg="mod">
          <ac:chgData name="Chew Leng Lim" userId="f4956819b06a5395" providerId="LiveId" clId="{64D1738D-F0F2-4F33-B73E-6056640154D5}" dt="2020-04-13T11:51:28.327" v="33764" actId="1038"/>
          <ac:spMkLst>
            <pc:docMk/>
            <pc:sldMk cId="2148019920" sldId="326"/>
            <ac:spMk id="48" creationId="{E27BE10F-BD50-435C-8E34-3177BB85124A}"/>
          </ac:spMkLst>
        </pc:spChg>
        <pc:spChg chg="mod">
          <ac:chgData name="Chew Leng Lim" userId="f4956819b06a5395" providerId="LiveId" clId="{64D1738D-F0F2-4F33-B73E-6056640154D5}" dt="2020-04-13T11:11:59.768" v="30590" actId="164"/>
          <ac:spMkLst>
            <pc:docMk/>
            <pc:sldMk cId="2148019920" sldId="326"/>
            <ac:spMk id="49" creationId="{B3CE5B5D-2E1D-4E71-9395-CFAB78DB04E8}"/>
          </ac:spMkLst>
        </pc:spChg>
        <pc:spChg chg="mod">
          <ac:chgData name="Chew Leng Lim" userId="f4956819b06a5395" providerId="LiveId" clId="{64D1738D-F0F2-4F33-B73E-6056640154D5}" dt="2020-04-13T11:15:22.643" v="31421" actId="164"/>
          <ac:spMkLst>
            <pc:docMk/>
            <pc:sldMk cId="2148019920" sldId="326"/>
            <ac:spMk id="50" creationId="{BF364605-BD05-4894-B332-98F465DFEF1F}"/>
          </ac:spMkLst>
        </pc:spChg>
        <pc:spChg chg="mod">
          <ac:chgData name="Chew Leng Lim" userId="f4956819b06a5395" providerId="LiveId" clId="{64D1738D-F0F2-4F33-B73E-6056640154D5}" dt="2020-04-13T11:15:22.643" v="31421" actId="164"/>
          <ac:spMkLst>
            <pc:docMk/>
            <pc:sldMk cId="2148019920" sldId="326"/>
            <ac:spMk id="51" creationId="{B916B9C2-6D7C-4911-9B26-209ADEF5B369}"/>
          </ac:spMkLst>
        </pc:spChg>
        <pc:spChg chg="mod">
          <ac:chgData name="Chew Leng Lim" userId="f4956819b06a5395" providerId="LiveId" clId="{64D1738D-F0F2-4F33-B73E-6056640154D5}" dt="2020-04-13T11:15:22.643" v="31421" actId="164"/>
          <ac:spMkLst>
            <pc:docMk/>
            <pc:sldMk cId="2148019920" sldId="326"/>
            <ac:spMk id="52" creationId="{CD522047-EF1F-482D-BF6F-A6B8749D1E87}"/>
          </ac:spMkLst>
        </pc:spChg>
        <pc:spChg chg="mod">
          <ac:chgData name="Chew Leng Lim" userId="f4956819b06a5395" providerId="LiveId" clId="{64D1738D-F0F2-4F33-B73E-6056640154D5}" dt="2020-04-13T11:15:22.643" v="31421" actId="164"/>
          <ac:spMkLst>
            <pc:docMk/>
            <pc:sldMk cId="2148019920" sldId="326"/>
            <ac:spMk id="53" creationId="{78953C15-02CD-45BD-967F-0A756F1AF664}"/>
          </ac:spMkLst>
        </pc:spChg>
        <pc:spChg chg="mod">
          <ac:chgData name="Chew Leng Lim" userId="f4956819b06a5395" providerId="LiveId" clId="{64D1738D-F0F2-4F33-B73E-6056640154D5}" dt="2020-04-13T11:15:22.643" v="31421" actId="164"/>
          <ac:spMkLst>
            <pc:docMk/>
            <pc:sldMk cId="2148019920" sldId="326"/>
            <ac:spMk id="54" creationId="{6066E554-9646-4ACB-89A9-C3BE0E020520}"/>
          </ac:spMkLst>
        </pc:spChg>
        <pc:spChg chg="mod">
          <ac:chgData name="Chew Leng Lim" userId="f4956819b06a5395" providerId="LiveId" clId="{64D1738D-F0F2-4F33-B73E-6056640154D5}" dt="2020-04-13T11:15:22.643" v="31421" actId="164"/>
          <ac:spMkLst>
            <pc:docMk/>
            <pc:sldMk cId="2148019920" sldId="326"/>
            <ac:spMk id="56" creationId="{95C642A8-1A49-4D24-969B-681EEB179B78}"/>
          </ac:spMkLst>
        </pc:spChg>
        <pc:spChg chg="mod">
          <ac:chgData name="Chew Leng Lim" userId="f4956819b06a5395" providerId="LiveId" clId="{64D1738D-F0F2-4F33-B73E-6056640154D5}" dt="2020-04-13T11:15:22.643" v="31421" actId="164"/>
          <ac:spMkLst>
            <pc:docMk/>
            <pc:sldMk cId="2148019920" sldId="326"/>
            <ac:spMk id="57" creationId="{3DB0ECB5-8BED-41E9-A8D7-1EFB9DBF1BB0}"/>
          </ac:spMkLst>
        </pc:spChg>
        <pc:spChg chg="mod">
          <ac:chgData name="Chew Leng Lim" userId="f4956819b06a5395" providerId="LiveId" clId="{64D1738D-F0F2-4F33-B73E-6056640154D5}" dt="2020-04-13T11:11:59.768" v="30590" actId="164"/>
          <ac:spMkLst>
            <pc:docMk/>
            <pc:sldMk cId="2148019920" sldId="326"/>
            <ac:spMk id="58" creationId="{714C603C-0E23-4053-B41C-BA8BF261AC0F}"/>
          </ac:spMkLst>
        </pc:spChg>
        <pc:spChg chg="mod">
          <ac:chgData name="Chew Leng Lim" userId="f4956819b06a5395" providerId="LiveId" clId="{64D1738D-F0F2-4F33-B73E-6056640154D5}" dt="2020-04-13T11:11:59.768" v="30590" actId="164"/>
          <ac:spMkLst>
            <pc:docMk/>
            <pc:sldMk cId="2148019920" sldId="326"/>
            <ac:spMk id="60" creationId="{B5EAFEDC-B7E7-4650-B60C-54CEA3991CDA}"/>
          </ac:spMkLst>
        </pc:spChg>
        <pc:spChg chg="mod">
          <ac:chgData name="Chew Leng Lim" userId="f4956819b06a5395" providerId="LiveId" clId="{64D1738D-F0F2-4F33-B73E-6056640154D5}" dt="2020-04-13T11:11:59.768" v="30590" actId="164"/>
          <ac:spMkLst>
            <pc:docMk/>
            <pc:sldMk cId="2148019920" sldId="326"/>
            <ac:spMk id="61" creationId="{0A9C46F0-C155-4850-9DBA-45510832EB15}"/>
          </ac:spMkLst>
        </pc:spChg>
        <pc:spChg chg="mod">
          <ac:chgData name="Chew Leng Lim" userId="f4956819b06a5395" providerId="LiveId" clId="{64D1738D-F0F2-4F33-B73E-6056640154D5}" dt="2020-04-13T11:14:28.370" v="31190" actId="164"/>
          <ac:spMkLst>
            <pc:docMk/>
            <pc:sldMk cId="2148019920" sldId="326"/>
            <ac:spMk id="62" creationId="{29781129-B277-4F11-94A4-6B6C531B5642}"/>
          </ac:spMkLst>
        </pc:spChg>
        <pc:spChg chg="mod">
          <ac:chgData name="Chew Leng Lim" userId="f4956819b06a5395" providerId="LiveId" clId="{64D1738D-F0F2-4F33-B73E-6056640154D5}" dt="2020-04-13T11:13:17.884" v="30909" actId="1035"/>
          <ac:spMkLst>
            <pc:docMk/>
            <pc:sldMk cId="2148019920" sldId="326"/>
            <ac:spMk id="63" creationId="{7F363B60-4345-4D66-B586-11FF7074D5BF}"/>
          </ac:spMkLst>
        </pc:spChg>
        <pc:spChg chg="mod">
          <ac:chgData name="Chew Leng Lim" userId="f4956819b06a5395" providerId="LiveId" clId="{64D1738D-F0F2-4F33-B73E-6056640154D5}" dt="2020-04-13T11:11:59.768" v="30590" actId="164"/>
          <ac:spMkLst>
            <pc:docMk/>
            <pc:sldMk cId="2148019920" sldId="326"/>
            <ac:spMk id="64" creationId="{7C847B10-81FE-493D-A527-8057B7B8260D}"/>
          </ac:spMkLst>
        </pc:spChg>
        <pc:spChg chg="mod">
          <ac:chgData name="Chew Leng Lim" userId="f4956819b06a5395" providerId="LiveId" clId="{64D1738D-F0F2-4F33-B73E-6056640154D5}" dt="2020-04-13T11:13:37.814" v="30985" actId="164"/>
          <ac:spMkLst>
            <pc:docMk/>
            <pc:sldMk cId="2148019920" sldId="326"/>
            <ac:spMk id="66" creationId="{92BACDF4-47CA-4D4E-9028-9D0FDA03C92C}"/>
          </ac:spMkLst>
        </pc:spChg>
        <pc:spChg chg="mod">
          <ac:chgData name="Chew Leng Lim" userId="f4956819b06a5395" providerId="LiveId" clId="{64D1738D-F0F2-4F33-B73E-6056640154D5}" dt="2020-04-13T11:50:21.869" v="33570" actId="1035"/>
          <ac:spMkLst>
            <pc:docMk/>
            <pc:sldMk cId="2148019920" sldId="326"/>
            <ac:spMk id="67" creationId="{BE74C571-F08C-4F7C-AD16-5CE08462A79E}"/>
          </ac:spMkLst>
        </pc:spChg>
        <pc:spChg chg="add mod">
          <ac:chgData name="Chew Leng Lim" userId="f4956819b06a5395" providerId="LiveId" clId="{64D1738D-F0F2-4F33-B73E-6056640154D5}" dt="2020-04-13T11:51:28.327" v="33764" actId="1038"/>
          <ac:spMkLst>
            <pc:docMk/>
            <pc:sldMk cId="2148019920" sldId="326"/>
            <ac:spMk id="70" creationId="{83B1C681-BF07-4758-BB8D-2127F60094B6}"/>
          </ac:spMkLst>
        </pc:spChg>
        <pc:spChg chg="add mod">
          <ac:chgData name="Chew Leng Lim" userId="f4956819b06a5395" providerId="LiveId" clId="{64D1738D-F0F2-4F33-B73E-6056640154D5}" dt="2020-04-13T11:51:28.327" v="33764" actId="1038"/>
          <ac:spMkLst>
            <pc:docMk/>
            <pc:sldMk cId="2148019920" sldId="326"/>
            <ac:spMk id="71" creationId="{6FB8095C-76A2-4C77-B5D2-EC2ACDBD1E33}"/>
          </ac:spMkLst>
        </pc:spChg>
        <pc:spChg chg="add">
          <ac:chgData name="Chew Leng Lim" userId="f4956819b06a5395" providerId="LiveId" clId="{64D1738D-F0F2-4F33-B73E-6056640154D5}" dt="2020-04-14T11:52:31.409" v="34352"/>
          <ac:spMkLst>
            <pc:docMk/>
            <pc:sldMk cId="2148019920" sldId="326"/>
            <ac:spMk id="72" creationId="{531C682E-67A6-4533-9C4B-470F32230B2E}"/>
          </ac:spMkLst>
        </pc:spChg>
        <pc:spChg chg="add del">
          <ac:chgData name="Chew Leng Lim" userId="f4956819b06a5395" providerId="LiveId" clId="{64D1738D-F0F2-4F33-B73E-6056640154D5}" dt="2020-04-13T11:48:30.879" v="33453" actId="478"/>
          <ac:spMkLst>
            <pc:docMk/>
            <pc:sldMk cId="2148019920" sldId="326"/>
            <ac:spMk id="72" creationId="{DB445D1C-67DF-434C-B54F-C4B4D66E5B81}"/>
          </ac:spMkLst>
        </pc:spChg>
        <pc:spChg chg="add mod">
          <ac:chgData name="Chew Leng Lim" userId="f4956819b06a5395" providerId="LiveId" clId="{64D1738D-F0F2-4F33-B73E-6056640154D5}" dt="2020-04-13T11:51:28.327" v="33764" actId="1038"/>
          <ac:spMkLst>
            <pc:docMk/>
            <pc:sldMk cId="2148019920" sldId="326"/>
            <ac:spMk id="73" creationId="{AE9F2414-D264-4A99-9D45-01B5B1CDFC40}"/>
          </ac:spMkLst>
        </pc:spChg>
        <pc:spChg chg="add mod">
          <ac:chgData name="Chew Leng Lim" userId="f4956819b06a5395" providerId="LiveId" clId="{64D1738D-F0F2-4F33-B73E-6056640154D5}" dt="2020-04-13T11:51:28.327" v="33764" actId="1038"/>
          <ac:spMkLst>
            <pc:docMk/>
            <pc:sldMk cId="2148019920" sldId="326"/>
            <ac:spMk id="74" creationId="{49649E2C-4197-406C-A8F2-95C590AAD8F7}"/>
          </ac:spMkLst>
        </pc:spChg>
        <pc:spChg chg="mod">
          <ac:chgData name="Chew Leng Lim" userId="f4956819b06a5395" providerId="LiveId" clId="{64D1738D-F0F2-4F33-B73E-6056640154D5}" dt="2020-04-13T11:12:39.601" v="30754" actId="164"/>
          <ac:spMkLst>
            <pc:docMk/>
            <pc:sldMk cId="2148019920" sldId="326"/>
            <ac:spMk id="79" creationId="{DD336327-0C28-48AE-8D92-4DC3626D90E7}"/>
          </ac:spMkLst>
        </pc:spChg>
        <pc:spChg chg="mod">
          <ac:chgData name="Chew Leng Lim" userId="f4956819b06a5395" providerId="LiveId" clId="{64D1738D-F0F2-4F33-B73E-6056640154D5}" dt="2020-04-13T11:12:39.601" v="30754" actId="164"/>
          <ac:spMkLst>
            <pc:docMk/>
            <pc:sldMk cId="2148019920" sldId="326"/>
            <ac:spMk id="88" creationId="{5BB6E7D2-F674-489B-A3D5-D40D5F623268}"/>
          </ac:spMkLst>
        </pc:spChg>
        <pc:spChg chg="mod">
          <ac:chgData name="Chew Leng Lim" userId="f4956819b06a5395" providerId="LiveId" clId="{64D1738D-F0F2-4F33-B73E-6056640154D5}" dt="2020-04-13T11:12:39.601" v="30754" actId="164"/>
          <ac:spMkLst>
            <pc:docMk/>
            <pc:sldMk cId="2148019920" sldId="326"/>
            <ac:spMk id="89" creationId="{2C876F91-EF0C-4419-AA73-02C10C9EABBE}"/>
          </ac:spMkLst>
        </pc:spChg>
        <pc:spChg chg="mod">
          <ac:chgData name="Chew Leng Lim" userId="f4956819b06a5395" providerId="LiveId" clId="{64D1738D-F0F2-4F33-B73E-6056640154D5}" dt="2020-04-13T11:12:39.601" v="30754" actId="164"/>
          <ac:spMkLst>
            <pc:docMk/>
            <pc:sldMk cId="2148019920" sldId="326"/>
            <ac:spMk id="90" creationId="{E1DDEA9E-4532-413B-8BA2-30802B7244EB}"/>
          </ac:spMkLst>
        </pc:spChg>
        <pc:spChg chg="mod">
          <ac:chgData name="Chew Leng Lim" userId="f4956819b06a5395" providerId="LiveId" clId="{64D1738D-F0F2-4F33-B73E-6056640154D5}" dt="2020-04-13T11:13:37.814" v="30985" actId="164"/>
          <ac:spMkLst>
            <pc:docMk/>
            <pc:sldMk cId="2148019920" sldId="326"/>
            <ac:spMk id="92" creationId="{FF3AB5FA-0249-472C-B20F-445EB5455B7F}"/>
          </ac:spMkLst>
        </pc:spChg>
        <pc:spChg chg="mod">
          <ac:chgData name="Chew Leng Lim" userId="f4956819b06a5395" providerId="LiveId" clId="{64D1738D-F0F2-4F33-B73E-6056640154D5}" dt="2020-04-13T11:13:37.814" v="30985" actId="164"/>
          <ac:spMkLst>
            <pc:docMk/>
            <pc:sldMk cId="2148019920" sldId="326"/>
            <ac:spMk id="93" creationId="{5E02FABB-B953-4FBE-8139-EAC6A435FB13}"/>
          </ac:spMkLst>
        </pc:spChg>
        <pc:spChg chg="mod">
          <ac:chgData name="Chew Leng Lim" userId="f4956819b06a5395" providerId="LiveId" clId="{64D1738D-F0F2-4F33-B73E-6056640154D5}" dt="2020-04-13T11:13:37.814" v="30985" actId="164"/>
          <ac:spMkLst>
            <pc:docMk/>
            <pc:sldMk cId="2148019920" sldId="326"/>
            <ac:spMk id="94" creationId="{5F161AB3-8B2F-4945-9D5A-2F9239954F27}"/>
          </ac:spMkLst>
        </pc:spChg>
        <pc:spChg chg="mod">
          <ac:chgData name="Chew Leng Lim" userId="f4956819b06a5395" providerId="LiveId" clId="{64D1738D-F0F2-4F33-B73E-6056640154D5}" dt="2020-04-13T11:13:37.814" v="30985" actId="164"/>
          <ac:spMkLst>
            <pc:docMk/>
            <pc:sldMk cId="2148019920" sldId="326"/>
            <ac:spMk id="95" creationId="{A5260C0E-4997-4568-A869-1FC184180695}"/>
          </ac:spMkLst>
        </pc:spChg>
        <pc:spChg chg="mod">
          <ac:chgData name="Chew Leng Lim" userId="f4956819b06a5395" providerId="LiveId" clId="{64D1738D-F0F2-4F33-B73E-6056640154D5}" dt="2020-04-13T11:13:37.814" v="30985" actId="164"/>
          <ac:spMkLst>
            <pc:docMk/>
            <pc:sldMk cId="2148019920" sldId="326"/>
            <ac:spMk id="96" creationId="{65BC36E3-F0DA-4FD8-8D6F-7CC048208E8F}"/>
          </ac:spMkLst>
        </pc:spChg>
        <pc:spChg chg="mod">
          <ac:chgData name="Chew Leng Lim" userId="f4956819b06a5395" providerId="LiveId" clId="{64D1738D-F0F2-4F33-B73E-6056640154D5}" dt="2020-04-14T11:52:35.731" v="34353" actId="207"/>
          <ac:spMkLst>
            <pc:docMk/>
            <pc:sldMk cId="2148019920" sldId="326"/>
            <ac:spMk id="101" creationId="{BEC4EFF3-800D-4B2D-84C2-C6946D47B9E4}"/>
          </ac:spMkLst>
        </pc:spChg>
        <pc:spChg chg="mod">
          <ac:chgData name="Chew Leng Lim" userId="f4956819b06a5395" providerId="LiveId" clId="{64D1738D-F0F2-4F33-B73E-6056640154D5}" dt="2020-04-13T11:51:28.327" v="33764" actId="1038"/>
          <ac:spMkLst>
            <pc:docMk/>
            <pc:sldMk cId="2148019920" sldId="326"/>
            <ac:spMk id="102" creationId="{425676BF-9C87-45FD-8008-AB8E2E85E067}"/>
          </ac:spMkLst>
        </pc:spChg>
        <pc:spChg chg="mod">
          <ac:chgData name="Chew Leng Lim" userId="f4956819b06a5395" providerId="LiveId" clId="{64D1738D-F0F2-4F33-B73E-6056640154D5}" dt="2020-04-13T11:51:28.327" v="33764" actId="1038"/>
          <ac:spMkLst>
            <pc:docMk/>
            <pc:sldMk cId="2148019920" sldId="326"/>
            <ac:spMk id="103" creationId="{3F60B062-7E1D-4C58-8EAA-59549FC3265C}"/>
          </ac:spMkLst>
        </pc:spChg>
        <pc:spChg chg="mod">
          <ac:chgData name="Chew Leng Lim" userId="f4956819b06a5395" providerId="LiveId" clId="{64D1738D-F0F2-4F33-B73E-6056640154D5}" dt="2020-04-13T11:51:28.327" v="33764" actId="1038"/>
          <ac:spMkLst>
            <pc:docMk/>
            <pc:sldMk cId="2148019920" sldId="326"/>
            <ac:spMk id="104" creationId="{6814D6D5-E9C2-4D1D-A89C-E69ABF3CCB5A}"/>
          </ac:spMkLst>
        </pc:spChg>
        <pc:spChg chg="mod">
          <ac:chgData name="Chew Leng Lim" userId="f4956819b06a5395" providerId="LiveId" clId="{64D1738D-F0F2-4F33-B73E-6056640154D5}" dt="2020-04-13T11:51:28.327" v="33764" actId="1038"/>
          <ac:spMkLst>
            <pc:docMk/>
            <pc:sldMk cId="2148019920" sldId="326"/>
            <ac:spMk id="105" creationId="{FDD8B1D6-E126-40E8-BABD-0C290A0E04A8}"/>
          </ac:spMkLst>
        </pc:spChg>
        <pc:spChg chg="mod">
          <ac:chgData name="Chew Leng Lim" userId="f4956819b06a5395" providerId="LiveId" clId="{64D1738D-F0F2-4F33-B73E-6056640154D5}" dt="2020-04-13T11:51:28.327" v="33764" actId="1038"/>
          <ac:spMkLst>
            <pc:docMk/>
            <pc:sldMk cId="2148019920" sldId="326"/>
            <ac:spMk id="106" creationId="{7E192D33-6EB1-4324-B2D6-F615F25485E5}"/>
          </ac:spMkLst>
        </pc:spChg>
        <pc:grpChg chg="add mod">
          <ac:chgData name="Chew Leng Lim" userId="f4956819b06a5395" providerId="LiveId" clId="{64D1738D-F0F2-4F33-B73E-6056640154D5}" dt="2020-04-13T11:51:28.327" v="33764" actId="1038"/>
          <ac:grpSpMkLst>
            <pc:docMk/>
            <pc:sldMk cId="2148019920" sldId="326"/>
            <ac:grpSpMk id="2" creationId="{8306AE01-188E-4B22-9BF3-E01EC1437933}"/>
          </ac:grpSpMkLst>
        </pc:grpChg>
        <pc:grpChg chg="add mod">
          <ac:chgData name="Chew Leng Lim" userId="f4956819b06a5395" providerId="LiveId" clId="{64D1738D-F0F2-4F33-B73E-6056640154D5}" dt="2020-04-13T11:51:28.327" v="33764" actId="1038"/>
          <ac:grpSpMkLst>
            <pc:docMk/>
            <pc:sldMk cId="2148019920" sldId="326"/>
            <ac:grpSpMk id="3" creationId="{937EE875-30E4-475F-858B-4B4E5927CD74}"/>
          </ac:grpSpMkLst>
        </pc:grpChg>
        <pc:grpChg chg="add mod">
          <ac:chgData name="Chew Leng Lim" userId="f4956819b06a5395" providerId="LiveId" clId="{64D1738D-F0F2-4F33-B73E-6056640154D5}" dt="2020-04-13T11:51:28.327" v="33764" actId="1038"/>
          <ac:grpSpMkLst>
            <pc:docMk/>
            <pc:sldMk cId="2148019920" sldId="326"/>
            <ac:grpSpMk id="4" creationId="{2EA1C577-D037-4F99-9D8B-8554687D7E33}"/>
          </ac:grpSpMkLst>
        </pc:grpChg>
        <pc:grpChg chg="add mod">
          <ac:chgData name="Chew Leng Lim" userId="f4956819b06a5395" providerId="LiveId" clId="{64D1738D-F0F2-4F33-B73E-6056640154D5}" dt="2020-04-13T11:51:28.327" v="33764" actId="1038"/>
          <ac:grpSpMkLst>
            <pc:docMk/>
            <pc:sldMk cId="2148019920" sldId="326"/>
            <ac:grpSpMk id="5" creationId="{52F22C39-BD76-400B-B1BF-32C362E5FEC7}"/>
          </ac:grpSpMkLst>
        </pc:grpChg>
        <pc:grpChg chg="add mod">
          <ac:chgData name="Chew Leng Lim" userId="f4956819b06a5395" providerId="LiveId" clId="{64D1738D-F0F2-4F33-B73E-6056640154D5}" dt="2020-04-13T11:51:28.327" v="33764" actId="1038"/>
          <ac:grpSpMkLst>
            <pc:docMk/>
            <pc:sldMk cId="2148019920" sldId="326"/>
            <ac:grpSpMk id="6" creationId="{64CAFF90-0C80-436D-8B38-7A0949B83D2B}"/>
          </ac:grpSpMkLst>
        </pc:grpChg>
        <pc:grpChg chg="add mod">
          <ac:chgData name="Chew Leng Lim" userId="f4956819b06a5395" providerId="LiveId" clId="{64D1738D-F0F2-4F33-B73E-6056640154D5}" dt="2020-04-13T11:51:28.327" v="33764" actId="1038"/>
          <ac:grpSpMkLst>
            <pc:docMk/>
            <pc:sldMk cId="2148019920" sldId="326"/>
            <ac:grpSpMk id="55" creationId="{DA14A828-F740-45E4-B569-C16C88F3D5BD}"/>
          </ac:grpSpMkLst>
        </pc:grpChg>
        <pc:grpChg chg="del">
          <ac:chgData name="Chew Leng Lim" userId="f4956819b06a5395" providerId="LiveId" clId="{64D1738D-F0F2-4F33-B73E-6056640154D5}" dt="2020-04-13T06:24:09.105" v="10424" actId="478"/>
          <ac:grpSpMkLst>
            <pc:docMk/>
            <pc:sldMk cId="2148019920" sldId="326"/>
            <ac:grpSpMk id="70" creationId="{31534A84-E2E2-4B86-AD6D-7E11D2598861}"/>
          </ac:grpSpMkLst>
        </pc:grpChg>
        <pc:graphicFrameChg chg="mod">
          <ac:chgData name="Chew Leng Lim" userId="f4956819b06a5395" providerId="LiveId" clId="{64D1738D-F0F2-4F33-B73E-6056640154D5}" dt="2020-04-13T11:15:22.643" v="31421" actId="164"/>
          <ac:graphicFrameMkLst>
            <pc:docMk/>
            <pc:sldMk cId="2148019920" sldId="326"/>
            <ac:graphicFrameMk id="31" creationId="{94D6A217-C557-4030-BA9B-CD51F7CCB70C}"/>
          </ac:graphicFrameMkLst>
        </pc:graphicFrameChg>
        <pc:graphicFrameChg chg="mod">
          <ac:chgData name="Chew Leng Lim" userId="f4956819b06a5395" providerId="LiveId" clId="{64D1738D-F0F2-4F33-B73E-6056640154D5}" dt="2020-04-13T11:14:28.370" v="31190" actId="164"/>
          <ac:graphicFrameMkLst>
            <pc:docMk/>
            <pc:sldMk cId="2148019920" sldId="326"/>
            <ac:graphicFrameMk id="32" creationId="{8C32667D-9726-4D01-9224-783A5EDE8DAD}"/>
          </ac:graphicFrameMkLst>
        </pc:graphicFrameChg>
        <pc:graphicFrameChg chg="mod">
          <ac:chgData name="Chew Leng Lim" userId="f4956819b06a5395" providerId="LiveId" clId="{64D1738D-F0F2-4F33-B73E-6056640154D5}" dt="2020-04-13T11:11:59.768" v="30590" actId="164"/>
          <ac:graphicFrameMkLst>
            <pc:docMk/>
            <pc:sldMk cId="2148019920" sldId="326"/>
            <ac:graphicFrameMk id="33" creationId="{046C3DEF-E85F-48C2-86EC-21FED874BF38}"/>
          </ac:graphicFrameMkLst>
        </pc:graphicFrameChg>
        <pc:graphicFrameChg chg="mod">
          <ac:chgData name="Chew Leng Lim" userId="f4956819b06a5395" providerId="LiveId" clId="{64D1738D-F0F2-4F33-B73E-6056640154D5}" dt="2020-04-13T11:12:39.601" v="30754" actId="164"/>
          <ac:graphicFrameMkLst>
            <pc:docMk/>
            <pc:sldMk cId="2148019920" sldId="326"/>
            <ac:graphicFrameMk id="34" creationId="{2BC8E8AF-63F4-4D76-8702-906E1700AFF9}"/>
          </ac:graphicFrameMkLst>
        </pc:graphicFrameChg>
        <pc:graphicFrameChg chg="mod">
          <ac:chgData name="Chew Leng Lim" userId="f4956819b06a5395" providerId="LiveId" clId="{64D1738D-F0F2-4F33-B73E-6056640154D5}" dt="2020-04-13T11:13:37.814" v="30985" actId="164"/>
          <ac:graphicFrameMkLst>
            <pc:docMk/>
            <pc:sldMk cId="2148019920" sldId="326"/>
            <ac:graphicFrameMk id="35" creationId="{0247C3F7-9CCB-489B-AE21-48E2F719553F}"/>
          </ac:graphicFrameMkLst>
        </pc:graphicFrameChg>
      </pc:sldChg>
      <pc:sldChg chg="addSp delSp modSp">
        <pc:chgData name="Chew Leng Lim" userId="f4956819b06a5395" providerId="LiveId" clId="{64D1738D-F0F2-4F33-B73E-6056640154D5}" dt="2020-04-14T13:04:19.934" v="34365" actId="1035"/>
        <pc:sldMkLst>
          <pc:docMk/>
          <pc:sldMk cId="1306267762" sldId="343"/>
        </pc:sldMkLst>
        <pc:spChg chg="mod">
          <ac:chgData name="Chew Leng Lim" userId="f4956819b06a5395" providerId="LiveId" clId="{64D1738D-F0F2-4F33-B73E-6056640154D5}" dt="2020-04-14T12:50:47.337" v="34364" actId="20577"/>
          <ac:spMkLst>
            <pc:docMk/>
            <pc:sldMk cId="1306267762" sldId="343"/>
            <ac:spMk id="2" creationId="{9006FD5F-E9F5-4916-8FD1-659895FDAA02}"/>
          </ac:spMkLst>
        </pc:spChg>
        <pc:spChg chg="mod">
          <ac:chgData name="Chew Leng Lim" userId="f4956819b06a5395" providerId="LiveId" clId="{64D1738D-F0F2-4F33-B73E-6056640154D5}" dt="2020-04-13T09:12:31.136" v="19138" actId="164"/>
          <ac:spMkLst>
            <pc:docMk/>
            <pc:sldMk cId="1306267762" sldId="343"/>
            <ac:spMk id="3" creationId="{B1EB761D-009A-45BA-BDE4-321E1811969C}"/>
          </ac:spMkLst>
        </pc:spChg>
        <pc:spChg chg="mod">
          <ac:chgData name="Chew Leng Lim" userId="f4956819b06a5395" providerId="LiveId" clId="{64D1738D-F0F2-4F33-B73E-6056640154D5}" dt="2020-04-13T09:12:31.136" v="19138" actId="164"/>
          <ac:spMkLst>
            <pc:docMk/>
            <pc:sldMk cId="1306267762" sldId="343"/>
            <ac:spMk id="4" creationId="{091A1140-239D-4884-80F6-39A578BC993A}"/>
          </ac:spMkLst>
        </pc:spChg>
        <pc:spChg chg="mod">
          <ac:chgData name="Chew Leng Lim" userId="f4956819b06a5395" providerId="LiveId" clId="{64D1738D-F0F2-4F33-B73E-6056640154D5}" dt="2020-04-13T09:12:31.136" v="19138" actId="164"/>
          <ac:spMkLst>
            <pc:docMk/>
            <pc:sldMk cId="1306267762" sldId="343"/>
            <ac:spMk id="5" creationId="{664BD555-5A2A-434F-9F90-A76B6AB950A9}"/>
          </ac:spMkLst>
        </pc:spChg>
        <pc:spChg chg="mod">
          <ac:chgData name="Chew Leng Lim" userId="f4956819b06a5395" providerId="LiveId" clId="{64D1738D-F0F2-4F33-B73E-6056640154D5}" dt="2020-04-13T09:12:31.136" v="19138" actId="164"/>
          <ac:spMkLst>
            <pc:docMk/>
            <pc:sldMk cId="1306267762" sldId="343"/>
            <ac:spMk id="6" creationId="{36BD451B-F8C1-4DC7-A709-C36066F89EEF}"/>
          </ac:spMkLst>
        </pc:spChg>
        <pc:spChg chg="mod">
          <ac:chgData name="Chew Leng Lim" userId="f4956819b06a5395" providerId="LiveId" clId="{64D1738D-F0F2-4F33-B73E-6056640154D5}" dt="2020-04-13T09:12:31.136" v="19138" actId="164"/>
          <ac:spMkLst>
            <pc:docMk/>
            <pc:sldMk cId="1306267762" sldId="343"/>
            <ac:spMk id="7" creationId="{CFAE22B7-DBEF-4705-8231-8008340F4204}"/>
          </ac:spMkLst>
        </pc:spChg>
        <pc:spChg chg="mod">
          <ac:chgData name="Chew Leng Lim" userId="f4956819b06a5395" providerId="LiveId" clId="{64D1738D-F0F2-4F33-B73E-6056640154D5}" dt="2020-04-13T09:12:31.136" v="19138" actId="164"/>
          <ac:spMkLst>
            <pc:docMk/>
            <pc:sldMk cId="1306267762" sldId="343"/>
            <ac:spMk id="8" creationId="{CEF3038D-1FF6-4163-9BE5-4F2568E4CA17}"/>
          </ac:spMkLst>
        </pc:spChg>
        <pc:spChg chg="mod">
          <ac:chgData name="Chew Leng Lim" userId="f4956819b06a5395" providerId="LiveId" clId="{64D1738D-F0F2-4F33-B73E-6056640154D5}" dt="2020-04-13T08:11:07.591" v="12816" actId="164"/>
          <ac:spMkLst>
            <pc:docMk/>
            <pc:sldMk cId="1306267762" sldId="343"/>
            <ac:spMk id="10" creationId="{FCB424C4-2B80-466D-A4DB-68CFC53BD9E2}"/>
          </ac:spMkLst>
        </pc:spChg>
        <pc:spChg chg="del mod">
          <ac:chgData name="Chew Leng Lim" userId="f4956819b06a5395" providerId="LiveId" clId="{64D1738D-F0F2-4F33-B73E-6056640154D5}" dt="2020-04-13T08:30:28.826" v="15725" actId="478"/>
          <ac:spMkLst>
            <pc:docMk/>
            <pc:sldMk cId="1306267762" sldId="343"/>
            <ac:spMk id="13" creationId="{BE066DEF-AB19-425B-AF88-A78EA498CA5E}"/>
          </ac:spMkLst>
        </pc:spChg>
        <pc:spChg chg="mod">
          <ac:chgData name="Chew Leng Lim" userId="f4956819b06a5395" providerId="LiveId" clId="{64D1738D-F0F2-4F33-B73E-6056640154D5}" dt="2020-04-13T08:11:07.591" v="12816" actId="164"/>
          <ac:spMkLst>
            <pc:docMk/>
            <pc:sldMk cId="1306267762" sldId="343"/>
            <ac:spMk id="14" creationId="{B39D1C02-63B8-474C-AA07-DDBA020E1E7B}"/>
          </ac:spMkLst>
        </pc:spChg>
        <pc:spChg chg="mod">
          <ac:chgData name="Chew Leng Lim" userId="f4956819b06a5395" providerId="LiveId" clId="{64D1738D-F0F2-4F33-B73E-6056640154D5}" dt="2020-04-13T08:11:07.591" v="12816" actId="164"/>
          <ac:spMkLst>
            <pc:docMk/>
            <pc:sldMk cId="1306267762" sldId="343"/>
            <ac:spMk id="16" creationId="{E66FF22E-1403-46D9-BA93-58E08026AB77}"/>
          </ac:spMkLst>
        </pc:spChg>
        <pc:spChg chg="mod">
          <ac:chgData name="Chew Leng Lim" userId="f4956819b06a5395" providerId="LiveId" clId="{64D1738D-F0F2-4F33-B73E-6056640154D5}" dt="2020-04-13T08:11:07.591" v="12816" actId="164"/>
          <ac:spMkLst>
            <pc:docMk/>
            <pc:sldMk cId="1306267762" sldId="343"/>
            <ac:spMk id="17" creationId="{7104BCE7-79D7-40CD-8C69-0BE78A74D4BE}"/>
          </ac:spMkLst>
        </pc:spChg>
        <pc:spChg chg="mod">
          <ac:chgData name="Chew Leng Lim" userId="f4956819b06a5395" providerId="LiveId" clId="{64D1738D-F0F2-4F33-B73E-6056640154D5}" dt="2020-04-13T08:11:07.591" v="12816" actId="164"/>
          <ac:spMkLst>
            <pc:docMk/>
            <pc:sldMk cId="1306267762" sldId="343"/>
            <ac:spMk id="21" creationId="{81DB62B1-7594-4AB4-B7FF-87D4205D66AA}"/>
          </ac:spMkLst>
        </pc:spChg>
        <pc:spChg chg="mod">
          <ac:chgData name="Chew Leng Lim" userId="f4956819b06a5395" providerId="LiveId" clId="{64D1738D-F0F2-4F33-B73E-6056640154D5}" dt="2020-04-13T08:15:59.991" v="13310" actId="164"/>
          <ac:spMkLst>
            <pc:docMk/>
            <pc:sldMk cId="1306267762" sldId="343"/>
            <ac:spMk id="23" creationId="{4C626C22-C4E1-46A6-AB13-08AC1AD19F53}"/>
          </ac:spMkLst>
        </pc:spChg>
        <pc:spChg chg="mod">
          <ac:chgData name="Chew Leng Lim" userId="f4956819b06a5395" providerId="LiveId" clId="{64D1738D-F0F2-4F33-B73E-6056640154D5}" dt="2020-04-13T08:15:59.991" v="13310" actId="164"/>
          <ac:spMkLst>
            <pc:docMk/>
            <pc:sldMk cId="1306267762" sldId="343"/>
            <ac:spMk id="24" creationId="{6E45E83F-0FB7-44F7-B9A1-8087131B59C1}"/>
          </ac:spMkLst>
        </pc:spChg>
        <pc:spChg chg="mod">
          <ac:chgData name="Chew Leng Lim" userId="f4956819b06a5395" providerId="LiveId" clId="{64D1738D-F0F2-4F33-B73E-6056640154D5}" dt="2020-04-13T08:15:59.991" v="13310" actId="164"/>
          <ac:spMkLst>
            <pc:docMk/>
            <pc:sldMk cId="1306267762" sldId="343"/>
            <ac:spMk id="27" creationId="{560E41BE-7922-4BF5-8C66-5002001C1EC4}"/>
          </ac:spMkLst>
        </pc:spChg>
        <pc:spChg chg="mod">
          <ac:chgData name="Chew Leng Lim" userId="f4956819b06a5395" providerId="LiveId" clId="{64D1738D-F0F2-4F33-B73E-6056640154D5}" dt="2020-04-13T08:15:59.991" v="13310" actId="164"/>
          <ac:spMkLst>
            <pc:docMk/>
            <pc:sldMk cId="1306267762" sldId="343"/>
            <ac:spMk id="28" creationId="{381ACC3A-5B94-44B1-BBF9-9AB1AD4F50FE}"/>
          </ac:spMkLst>
        </pc:spChg>
        <pc:spChg chg="mod">
          <ac:chgData name="Chew Leng Lim" userId="f4956819b06a5395" providerId="LiveId" clId="{64D1738D-F0F2-4F33-B73E-6056640154D5}" dt="2020-04-13T08:20:47.654" v="14122" actId="164"/>
          <ac:spMkLst>
            <pc:docMk/>
            <pc:sldMk cId="1306267762" sldId="343"/>
            <ac:spMk id="30" creationId="{F9D92842-FAA8-4DEA-9C37-3B0DE560D75D}"/>
          </ac:spMkLst>
        </pc:spChg>
        <pc:spChg chg="mod">
          <ac:chgData name="Chew Leng Lim" userId="f4956819b06a5395" providerId="LiveId" clId="{64D1738D-F0F2-4F33-B73E-6056640154D5}" dt="2020-04-13T08:20:47.654" v="14122" actId="164"/>
          <ac:spMkLst>
            <pc:docMk/>
            <pc:sldMk cId="1306267762" sldId="343"/>
            <ac:spMk id="31" creationId="{56399EBB-EB9C-410E-8D63-67E8DB425759}"/>
          </ac:spMkLst>
        </pc:spChg>
        <pc:spChg chg="mod">
          <ac:chgData name="Chew Leng Lim" userId="f4956819b06a5395" providerId="LiveId" clId="{64D1738D-F0F2-4F33-B73E-6056640154D5}" dt="2020-04-13T08:20:47.654" v="14122" actId="164"/>
          <ac:spMkLst>
            <pc:docMk/>
            <pc:sldMk cId="1306267762" sldId="343"/>
            <ac:spMk id="34" creationId="{1D63DDED-3269-49BA-97C3-55DBC3D0F596}"/>
          </ac:spMkLst>
        </pc:spChg>
        <pc:spChg chg="mod">
          <ac:chgData name="Chew Leng Lim" userId="f4956819b06a5395" providerId="LiveId" clId="{64D1738D-F0F2-4F33-B73E-6056640154D5}" dt="2020-04-13T08:20:47.654" v="14122" actId="164"/>
          <ac:spMkLst>
            <pc:docMk/>
            <pc:sldMk cId="1306267762" sldId="343"/>
            <ac:spMk id="35" creationId="{67191531-B9AC-4875-A05C-8F0B05FCFA7F}"/>
          </ac:spMkLst>
        </pc:spChg>
        <pc:spChg chg="mod">
          <ac:chgData name="Chew Leng Lim" userId="f4956819b06a5395" providerId="LiveId" clId="{64D1738D-F0F2-4F33-B73E-6056640154D5}" dt="2020-04-13T09:13:41.660" v="19144" actId="1035"/>
          <ac:spMkLst>
            <pc:docMk/>
            <pc:sldMk cId="1306267762" sldId="343"/>
            <ac:spMk id="36" creationId="{E901C42A-0FFE-4C5D-949E-86337E7AA2F0}"/>
          </ac:spMkLst>
        </pc:spChg>
        <pc:spChg chg="mod">
          <ac:chgData name="Chew Leng Lim" userId="f4956819b06a5395" providerId="LiveId" clId="{64D1738D-F0F2-4F33-B73E-6056640154D5}" dt="2020-04-13T08:18:23.973" v="13719" actId="164"/>
          <ac:spMkLst>
            <pc:docMk/>
            <pc:sldMk cId="1306267762" sldId="343"/>
            <ac:spMk id="42" creationId="{9AAA5F0C-1155-4471-949E-E04D9E612353}"/>
          </ac:spMkLst>
        </pc:spChg>
        <pc:spChg chg="mod">
          <ac:chgData name="Chew Leng Lim" userId="f4956819b06a5395" providerId="LiveId" clId="{64D1738D-F0F2-4F33-B73E-6056640154D5}" dt="2020-04-13T08:18:23.973" v="13719" actId="164"/>
          <ac:spMkLst>
            <pc:docMk/>
            <pc:sldMk cId="1306267762" sldId="343"/>
            <ac:spMk id="43" creationId="{0C55EA6C-BAD2-41D2-AC9C-EC3E29D1683C}"/>
          </ac:spMkLst>
        </pc:spChg>
        <pc:spChg chg="mod">
          <ac:chgData name="Chew Leng Lim" userId="f4956819b06a5395" providerId="LiveId" clId="{64D1738D-F0F2-4F33-B73E-6056640154D5}" dt="2020-04-13T08:18:23.973" v="13719" actId="164"/>
          <ac:spMkLst>
            <pc:docMk/>
            <pc:sldMk cId="1306267762" sldId="343"/>
            <ac:spMk id="44" creationId="{FA0A1F3D-18A8-4FC5-B730-8CA08C41C05E}"/>
          </ac:spMkLst>
        </pc:spChg>
        <pc:spChg chg="mod">
          <ac:chgData name="Chew Leng Lim" userId="f4956819b06a5395" providerId="LiveId" clId="{64D1738D-F0F2-4F33-B73E-6056640154D5}" dt="2020-04-13T08:18:23.973" v="13719" actId="164"/>
          <ac:spMkLst>
            <pc:docMk/>
            <pc:sldMk cId="1306267762" sldId="343"/>
            <ac:spMk id="45" creationId="{C9F651DD-6AE4-48E7-95C7-B51421E9A22E}"/>
          </ac:spMkLst>
        </pc:spChg>
        <pc:spChg chg="mod">
          <ac:chgData name="Chew Leng Lim" userId="f4956819b06a5395" providerId="LiveId" clId="{64D1738D-F0F2-4F33-B73E-6056640154D5}" dt="2020-04-13T08:15:59.991" v="13310" actId="164"/>
          <ac:spMkLst>
            <pc:docMk/>
            <pc:sldMk cId="1306267762" sldId="343"/>
            <ac:spMk id="46" creationId="{EEBBF98D-63B6-4299-A903-DAE21CF32B58}"/>
          </ac:spMkLst>
        </pc:spChg>
        <pc:spChg chg="mod">
          <ac:chgData name="Chew Leng Lim" userId="f4956819b06a5395" providerId="LiveId" clId="{64D1738D-F0F2-4F33-B73E-6056640154D5}" dt="2020-04-13T08:15:59.991" v="13310" actId="164"/>
          <ac:spMkLst>
            <pc:docMk/>
            <pc:sldMk cId="1306267762" sldId="343"/>
            <ac:spMk id="47" creationId="{8E7ECFCC-FBDC-4846-9DC0-0279A7D9FC38}"/>
          </ac:spMkLst>
        </pc:spChg>
        <pc:spChg chg="mod">
          <ac:chgData name="Chew Leng Lim" userId="f4956819b06a5395" providerId="LiveId" clId="{64D1738D-F0F2-4F33-B73E-6056640154D5}" dt="2020-04-13T08:11:04.454" v="12815" actId="164"/>
          <ac:spMkLst>
            <pc:docMk/>
            <pc:sldMk cId="1306267762" sldId="343"/>
            <ac:spMk id="49" creationId="{6A426DB6-2199-491E-9987-385CFB0EC68B}"/>
          </ac:spMkLst>
        </pc:spChg>
        <pc:spChg chg="mod">
          <ac:chgData name="Chew Leng Lim" userId="f4956819b06a5395" providerId="LiveId" clId="{64D1738D-F0F2-4F33-B73E-6056640154D5}" dt="2020-04-13T08:11:04.454" v="12815" actId="164"/>
          <ac:spMkLst>
            <pc:docMk/>
            <pc:sldMk cId="1306267762" sldId="343"/>
            <ac:spMk id="50" creationId="{33496F61-95E1-4923-9BBC-9F1EF1E94CC0}"/>
          </ac:spMkLst>
        </pc:spChg>
        <pc:spChg chg="mod">
          <ac:chgData name="Chew Leng Lim" userId="f4956819b06a5395" providerId="LiveId" clId="{64D1738D-F0F2-4F33-B73E-6056640154D5}" dt="2020-04-13T08:11:04.454" v="12815" actId="164"/>
          <ac:spMkLst>
            <pc:docMk/>
            <pc:sldMk cId="1306267762" sldId="343"/>
            <ac:spMk id="51" creationId="{1A245848-2B4E-4BFA-B85A-684FE3B08D67}"/>
          </ac:spMkLst>
        </pc:spChg>
        <pc:spChg chg="del mod">
          <ac:chgData name="Chew Leng Lim" userId="f4956819b06a5395" providerId="LiveId" clId="{64D1738D-F0F2-4F33-B73E-6056640154D5}" dt="2020-04-13T08:30:28.826" v="15725" actId="478"/>
          <ac:spMkLst>
            <pc:docMk/>
            <pc:sldMk cId="1306267762" sldId="343"/>
            <ac:spMk id="54" creationId="{430C11B6-F69B-48D9-B04E-613F939CCA71}"/>
          </ac:spMkLst>
        </pc:spChg>
        <pc:spChg chg="mod">
          <ac:chgData name="Chew Leng Lim" userId="f4956819b06a5395" providerId="LiveId" clId="{64D1738D-F0F2-4F33-B73E-6056640154D5}" dt="2020-04-13T08:11:04.454" v="12815" actId="164"/>
          <ac:spMkLst>
            <pc:docMk/>
            <pc:sldMk cId="1306267762" sldId="343"/>
            <ac:spMk id="55" creationId="{80300288-28A8-4CA3-9778-D3043C17C90F}"/>
          </ac:spMkLst>
        </pc:spChg>
        <pc:spChg chg="mod">
          <ac:chgData name="Chew Leng Lim" userId="f4956819b06a5395" providerId="LiveId" clId="{64D1738D-F0F2-4F33-B73E-6056640154D5}" dt="2020-04-13T08:11:04.454" v="12815" actId="164"/>
          <ac:spMkLst>
            <pc:docMk/>
            <pc:sldMk cId="1306267762" sldId="343"/>
            <ac:spMk id="57" creationId="{F8586946-7F9B-4996-AD5D-F7C4AD100132}"/>
          </ac:spMkLst>
        </pc:spChg>
        <pc:spChg chg="mod">
          <ac:chgData name="Chew Leng Lim" userId="f4956819b06a5395" providerId="LiveId" clId="{64D1738D-F0F2-4F33-B73E-6056640154D5}" dt="2020-04-13T08:11:04.454" v="12815" actId="164"/>
          <ac:spMkLst>
            <pc:docMk/>
            <pc:sldMk cId="1306267762" sldId="343"/>
            <ac:spMk id="58" creationId="{9FBF6673-07D8-4339-8B68-7BCF00C49722}"/>
          </ac:spMkLst>
        </pc:spChg>
        <pc:spChg chg="mod">
          <ac:chgData name="Chew Leng Lim" userId="f4956819b06a5395" providerId="LiveId" clId="{64D1738D-F0F2-4F33-B73E-6056640154D5}" dt="2020-04-13T08:15:48.797" v="13293" actId="164"/>
          <ac:spMkLst>
            <pc:docMk/>
            <pc:sldMk cId="1306267762" sldId="343"/>
            <ac:spMk id="63" creationId="{2EEF564A-5D86-46D1-B071-EC0F842FE3BF}"/>
          </ac:spMkLst>
        </pc:spChg>
        <pc:spChg chg="del mod">
          <ac:chgData name="Chew Leng Lim" userId="f4956819b06a5395" providerId="LiveId" clId="{64D1738D-F0F2-4F33-B73E-6056640154D5}" dt="2020-04-13T08:15:27.664" v="13275" actId="478"/>
          <ac:spMkLst>
            <pc:docMk/>
            <pc:sldMk cId="1306267762" sldId="343"/>
            <ac:spMk id="64" creationId="{2B1CB077-B485-40D6-9173-188E337DC0F5}"/>
          </ac:spMkLst>
        </pc:spChg>
        <pc:spChg chg="mod">
          <ac:chgData name="Chew Leng Lim" userId="f4956819b06a5395" providerId="LiveId" clId="{64D1738D-F0F2-4F33-B73E-6056640154D5}" dt="2020-04-13T08:15:48.797" v="13293" actId="164"/>
          <ac:spMkLst>
            <pc:docMk/>
            <pc:sldMk cId="1306267762" sldId="343"/>
            <ac:spMk id="67" creationId="{3A6FF504-3AC6-41CF-AC56-F1178C94F321}"/>
          </ac:spMkLst>
        </pc:spChg>
        <pc:spChg chg="mod">
          <ac:chgData name="Chew Leng Lim" userId="f4956819b06a5395" providerId="LiveId" clId="{64D1738D-F0F2-4F33-B73E-6056640154D5}" dt="2020-04-13T08:15:48.797" v="13293" actId="164"/>
          <ac:spMkLst>
            <pc:docMk/>
            <pc:sldMk cId="1306267762" sldId="343"/>
            <ac:spMk id="68" creationId="{3F534FC7-EC46-41C7-BB51-7BF63C2E14A4}"/>
          </ac:spMkLst>
        </pc:spChg>
        <pc:spChg chg="mod">
          <ac:chgData name="Chew Leng Lim" userId="f4956819b06a5395" providerId="LiveId" clId="{64D1738D-F0F2-4F33-B73E-6056640154D5}" dt="2020-04-13T08:20:36.043" v="14103" actId="164"/>
          <ac:spMkLst>
            <pc:docMk/>
            <pc:sldMk cId="1306267762" sldId="343"/>
            <ac:spMk id="70" creationId="{2FF886EC-FD5A-4A16-A0D5-9D63D850C54C}"/>
          </ac:spMkLst>
        </pc:spChg>
        <pc:spChg chg="mod">
          <ac:chgData name="Chew Leng Lim" userId="f4956819b06a5395" providerId="LiveId" clId="{64D1738D-F0F2-4F33-B73E-6056640154D5}" dt="2020-04-13T08:20:36.043" v="14103" actId="164"/>
          <ac:spMkLst>
            <pc:docMk/>
            <pc:sldMk cId="1306267762" sldId="343"/>
            <ac:spMk id="71" creationId="{D493F3E5-3904-45F8-8877-1C074F55CA21}"/>
          </ac:spMkLst>
        </pc:spChg>
        <pc:spChg chg="mod">
          <ac:chgData name="Chew Leng Lim" userId="f4956819b06a5395" providerId="LiveId" clId="{64D1738D-F0F2-4F33-B73E-6056640154D5}" dt="2020-04-13T08:20:36.043" v="14103" actId="164"/>
          <ac:spMkLst>
            <pc:docMk/>
            <pc:sldMk cId="1306267762" sldId="343"/>
            <ac:spMk id="74" creationId="{3A5BE36D-69DF-4455-8B6A-73F8C913392E}"/>
          </ac:spMkLst>
        </pc:spChg>
        <pc:spChg chg="mod">
          <ac:chgData name="Chew Leng Lim" userId="f4956819b06a5395" providerId="LiveId" clId="{64D1738D-F0F2-4F33-B73E-6056640154D5}" dt="2020-04-13T08:20:36.043" v="14103" actId="164"/>
          <ac:spMkLst>
            <pc:docMk/>
            <pc:sldMk cId="1306267762" sldId="343"/>
            <ac:spMk id="75" creationId="{A4674F1C-FD7E-474F-8217-9F90753F91D0}"/>
          </ac:spMkLst>
        </pc:spChg>
        <pc:spChg chg="mod">
          <ac:chgData name="Chew Leng Lim" userId="f4956819b06a5395" providerId="LiveId" clId="{64D1738D-F0F2-4F33-B73E-6056640154D5}" dt="2020-04-13T09:13:34.258" v="19143" actId="1037"/>
          <ac:spMkLst>
            <pc:docMk/>
            <pc:sldMk cId="1306267762" sldId="343"/>
            <ac:spMk id="78" creationId="{E9B99D94-AC06-4BD1-ACD6-9F6B46C47C79}"/>
          </ac:spMkLst>
        </pc:spChg>
        <pc:spChg chg="mod">
          <ac:chgData name="Chew Leng Lim" userId="f4956819b06a5395" providerId="LiveId" clId="{64D1738D-F0F2-4F33-B73E-6056640154D5}" dt="2020-04-13T08:18:15.042" v="13702" actId="164"/>
          <ac:spMkLst>
            <pc:docMk/>
            <pc:sldMk cId="1306267762" sldId="343"/>
            <ac:spMk id="84" creationId="{F89B6B6C-AD07-4220-936E-D4AE1A5AF837}"/>
          </ac:spMkLst>
        </pc:spChg>
        <pc:spChg chg="mod">
          <ac:chgData name="Chew Leng Lim" userId="f4956819b06a5395" providerId="LiveId" clId="{64D1738D-F0F2-4F33-B73E-6056640154D5}" dt="2020-04-13T08:18:15.042" v="13702" actId="164"/>
          <ac:spMkLst>
            <pc:docMk/>
            <pc:sldMk cId="1306267762" sldId="343"/>
            <ac:spMk id="85" creationId="{37581823-B60D-46CB-A61B-1FFC814C9F83}"/>
          </ac:spMkLst>
        </pc:spChg>
        <pc:spChg chg="mod">
          <ac:chgData name="Chew Leng Lim" userId="f4956819b06a5395" providerId="LiveId" clId="{64D1738D-F0F2-4F33-B73E-6056640154D5}" dt="2020-04-13T08:18:15.042" v="13702" actId="164"/>
          <ac:spMkLst>
            <pc:docMk/>
            <pc:sldMk cId="1306267762" sldId="343"/>
            <ac:spMk id="86" creationId="{9F52A5E1-63DC-431D-820F-77B637AA0FF5}"/>
          </ac:spMkLst>
        </pc:spChg>
        <pc:spChg chg="mod">
          <ac:chgData name="Chew Leng Lim" userId="f4956819b06a5395" providerId="LiveId" clId="{64D1738D-F0F2-4F33-B73E-6056640154D5}" dt="2020-04-13T08:18:15.042" v="13702" actId="164"/>
          <ac:spMkLst>
            <pc:docMk/>
            <pc:sldMk cId="1306267762" sldId="343"/>
            <ac:spMk id="87" creationId="{A3529174-D284-4C37-8EC1-ED01FC176C0B}"/>
          </ac:spMkLst>
        </pc:spChg>
        <pc:spChg chg="mod">
          <ac:chgData name="Chew Leng Lim" userId="f4956819b06a5395" providerId="LiveId" clId="{64D1738D-F0F2-4F33-B73E-6056640154D5}" dt="2020-04-13T08:18:15.042" v="13702" actId="164"/>
          <ac:spMkLst>
            <pc:docMk/>
            <pc:sldMk cId="1306267762" sldId="343"/>
            <ac:spMk id="88" creationId="{A2070BD9-BDE3-46C6-83A5-18D16B05405A}"/>
          </ac:spMkLst>
        </pc:spChg>
        <pc:spChg chg="mod">
          <ac:chgData name="Chew Leng Lim" userId="f4956819b06a5395" providerId="LiveId" clId="{64D1738D-F0F2-4F33-B73E-6056640154D5}" dt="2020-04-13T08:11:01.941" v="12814" actId="164"/>
          <ac:spMkLst>
            <pc:docMk/>
            <pc:sldMk cId="1306267762" sldId="343"/>
            <ac:spMk id="90" creationId="{3CD640B7-F59B-4615-BC1C-6532C95C998C}"/>
          </ac:spMkLst>
        </pc:spChg>
        <pc:spChg chg="mod">
          <ac:chgData name="Chew Leng Lim" userId="f4956819b06a5395" providerId="LiveId" clId="{64D1738D-F0F2-4F33-B73E-6056640154D5}" dt="2020-04-13T08:11:01.941" v="12814" actId="164"/>
          <ac:spMkLst>
            <pc:docMk/>
            <pc:sldMk cId="1306267762" sldId="343"/>
            <ac:spMk id="91" creationId="{327C55C4-11AC-4FC2-97C6-E11DA5D64E30}"/>
          </ac:spMkLst>
        </pc:spChg>
        <pc:spChg chg="del mod">
          <ac:chgData name="Chew Leng Lim" userId="f4956819b06a5395" providerId="LiveId" clId="{64D1738D-F0F2-4F33-B73E-6056640154D5}" dt="2020-04-13T08:30:28.826" v="15725" actId="478"/>
          <ac:spMkLst>
            <pc:docMk/>
            <pc:sldMk cId="1306267762" sldId="343"/>
            <ac:spMk id="94" creationId="{D8267FD7-BAEC-484B-8F56-2C55CCA054BD}"/>
          </ac:spMkLst>
        </pc:spChg>
        <pc:spChg chg="mod">
          <ac:chgData name="Chew Leng Lim" userId="f4956819b06a5395" providerId="LiveId" clId="{64D1738D-F0F2-4F33-B73E-6056640154D5}" dt="2020-04-13T08:11:01.941" v="12814" actId="164"/>
          <ac:spMkLst>
            <pc:docMk/>
            <pc:sldMk cId="1306267762" sldId="343"/>
            <ac:spMk id="95" creationId="{A0981889-8B65-46E0-BDC6-BADAF36C0876}"/>
          </ac:spMkLst>
        </pc:spChg>
        <pc:spChg chg="mod">
          <ac:chgData name="Chew Leng Lim" userId="f4956819b06a5395" providerId="LiveId" clId="{64D1738D-F0F2-4F33-B73E-6056640154D5}" dt="2020-04-13T08:11:01.941" v="12814" actId="164"/>
          <ac:spMkLst>
            <pc:docMk/>
            <pc:sldMk cId="1306267762" sldId="343"/>
            <ac:spMk id="96" creationId="{1DF1364A-FFB4-4463-8388-B6022B423D63}"/>
          </ac:spMkLst>
        </pc:spChg>
        <pc:spChg chg="mod">
          <ac:chgData name="Chew Leng Lim" userId="f4956819b06a5395" providerId="LiveId" clId="{64D1738D-F0F2-4F33-B73E-6056640154D5}" dt="2020-04-13T08:11:01.941" v="12814" actId="164"/>
          <ac:spMkLst>
            <pc:docMk/>
            <pc:sldMk cId="1306267762" sldId="343"/>
            <ac:spMk id="100" creationId="{CFC3A3A9-A13B-43C3-B397-FAA837AABE7A}"/>
          </ac:spMkLst>
        </pc:spChg>
        <pc:spChg chg="mod">
          <ac:chgData name="Chew Leng Lim" userId="f4956819b06a5395" providerId="LiveId" clId="{64D1738D-F0F2-4F33-B73E-6056640154D5}" dt="2020-04-13T08:13:36.849" v="13232" actId="164"/>
          <ac:spMkLst>
            <pc:docMk/>
            <pc:sldMk cId="1306267762" sldId="343"/>
            <ac:spMk id="102" creationId="{0FD24A21-6C9F-4825-B0AF-C4A4C23E8FC2}"/>
          </ac:spMkLst>
        </pc:spChg>
        <pc:spChg chg="mod">
          <ac:chgData name="Chew Leng Lim" userId="f4956819b06a5395" providerId="LiveId" clId="{64D1738D-F0F2-4F33-B73E-6056640154D5}" dt="2020-04-13T08:13:36.849" v="13232" actId="164"/>
          <ac:spMkLst>
            <pc:docMk/>
            <pc:sldMk cId="1306267762" sldId="343"/>
            <ac:spMk id="103" creationId="{69EB219C-4B99-4CAA-BB05-8C73B4E17992}"/>
          </ac:spMkLst>
        </pc:spChg>
        <pc:spChg chg="mod">
          <ac:chgData name="Chew Leng Lim" userId="f4956819b06a5395" providerId="LiveId" clId="{64D1738D-F0F2-4F33-B73E-6056640154D5}" dt="2020-04-13T08:13:36.849" v="13232" actId="164"/>
          <ac:spMkLst>
            <pc:docMk/>
            <pc:sldMk cId="1306267762" sldId="343"/>
            <ac:spMk id="106" creationId="{F9D038A8-E8DB-486F-9539-C64D908F9995}"/>
          </ac:spMkLst>
        </pc:spChg>
        <pc:spChg chg="mod">
          <ac:chgData name="Chew Leng Lim" userId="f4956819b06a5395" providerId="LiveId" clId="{64D1738D-F0F2-4F33-B73E-6056640154D5}" dt="2020-04-13T08:13:36.849" v="13232" actId="164"/>
          <ac:spMkLst>
            <pc:docMk/>
            <pc:sldMk cId="1306267762" sldId="343"/>
            <ac:spMk id="107" creationId="{A343873E-6CA9-4C00-86F6-2349A8B5CAA2}"/>
          </ac:spMkLst>
        </pc:spChg>
        <pc:spChg chg="mod">
          <ac:chgData name="Chew Leng Lim" userId="f4956819b06a5395" providerId="LiveId" clId="{64D1738D-F0F2-4F33-B73E-6056640154D5}" dt="2020-04-13T08:20:25.462" v="14083" actId="164"/>
          <ac:spMkLst>
            <pc:docMk/>
            <pc:sldMk cId="1306267762" sldId="343"/>
            <ac:spMk id="109" creationId="{EEDFD1AB-0937-4EE7-9009-797FFBE6A997}"/>
          </ac:spMkLst>
        </pc:spChg>
        <pc:spChg chg="mod">
          <ac:chgData name="Chew Leng Lim" userId="f4956819b06a5395" providerId="LiveId" clId="{64D1738D-F0F2-4F33-B73E-6056640154D5}" dt="2020-04-13T08:20:25.462" v="14083" actId="164"/>
          <ac:spMkLst>
            <pc:docMk/>
            <pc:sldMk cId="1306267762" sldId="343"/>
            <ac:spMk id="110" creationId="{6680781C-11FD-48EE-A575-2CB6A462E88A}"/>
          </ac:spMkLst>
        </pc:spChg>
        <pc:spChg chg="mod">
          <ac:chgData name="Chew Leng Lim" userId="f4956819b06a5395" providerId="LiveId" clId="{64D1738D-F0F2-4F33-B73E-6056640154D5}" dt="2020-04-13T08:20:25.462" v="14083" actId="164"/>
          <ac:spMkLst>
            <pc:docMk/>
            <pc:sldMk cId="1306267762" sldId="343"/>
            <ac:spMk id="111" creationId="{2005E05B-AD82-427A-8D17-3A882E5F925E}"/>
          </ac:spMkLst>
        </pc:spChg>
        <pc:spChg chg="mod">
          <ac:chgData name="Chew Leng Lim" userId="f4956819b06a5395" providerId="LiveId" clId="{64D1738D-F0F2-4F33-B73E-6056640154D5}" dt="2020-04-13T08:20:25.462" v="14083" actId="164"/>
          <ac:spMkLst>
            <pc:docMk/>
            <pc:sldMk cId="1306267762" sldId="343"/>
            <ac:spMk id="114" creationId="{B12BC90A-E1F3-402F-ACF2-1432767C2DA9}"/>
          </ac:spMkLst>
        </pc:spChg>
        <pc:spChg chg="mod">
          <ac:chgData name="Chew Leng Lim" userId="f4956819b06a5395" providerId="LiveId" clId="{64D1738D-F0F2-4F33-B73E-6056640154D5}" dt="2020-04-13T08:20:25.462" v="14083" actId="164"/>
          <ac:spMkLst>
            <pc:docMk/>
            <pc:sldMk cId="1306267762" sldId="343"/>
            <ac:spMk id="115" creationId="{B2006DAB-E193-40A6-923B-1ED448495DDE}"/>
          </ac:spMkLst>
        </pc:spChg>
        <pc:spChg chg="mod">
          <ac:chgData name="Chew Leng Lim" userId="f4956819b06a5395" providerId="LiveId" clId="{64D1738D-F0F2-4F33-B73E-6056640154D5}" dt="2020-04-13T08:11:01.941" v="12814" actId="164"/>
          <ac:spMkLst>
            <pc:docMk/>
            <pc:sldMk cId="1306267762" sldId="343"/>
            <ac:spMk id="116" creationId="{9460A5E8-DA84-4761-AD0A-3578D46E645B}"/>
          </ac:spMkLst>
        </pc:spChg>
        <pc:spChg chg="mod">
          <ac:chgData name="Chew Leng Lim" userId="f4956819b06a5395" providerId="LiveId" clId="{64D1738D-F0F2-4F33-B73E-6056640154D5}" dt="2020-04-13T08:18:04.267" v="13684" actId="164"/>
          <ac:spMkLst>
            <pc:docMk/>
            <pc:sldMk cId="1306267762" sldId="343"/>
            <ac:spMk id="119" creationId="{86AE4B32-571B-4F16-994D-F20CC1C3C9EF}"/>
          </ac:spMkLst>
        </pc:spChg>
        <pc:spChg chg="mod">
          <ac:chgData name="Chew Leng Lim" userId="f4956819b06a5395" providerId="LiveId" clId="{64D1738D-F0F2-4F33-B73E-6056640154D5}" dt="2020-04-13T08:18:04.267" v="13684" actId="164"/>
          <ac:spMkLst>
            <pc:docMk/>
            <pc:sldMk cId="1306267762" sldId="343"/>
            <ac:spMk id="122" creationId="{1DCE5A16-2B93-4EEF-9346-80E508AD7CBC}"/>
          </ac:spMkLst>
        </pc:spChg>
        <pc:spChg chg="mod">
          <ac:chgData name="Chew Leng Lim" userId="f4956819b06a5395" providerId="LiveId" clId="{64D1738D-F0F2-4F33-B73E-6056640154D5}" dt="2020-04-13T08:18:04.267" v="13684" actId="164"/>
          <ac:spMkLst>
            <pc:docMk/>
            <pc:sldMk cId="1306267762" sldId="343"/>
            <ac:spMk id="123" creationId="{712129D5-7C7F-459B-AF4D-4E136415E70B}"/>
          </ac:spMkLst>
        </pc:spChg>
        <pc:spChg chg="mod">
          <ac:chgData name="Chew Leng Lim" userId="f4956819b06a5395" providerId="LiveId" clId="{64D1738D-F0F2-4F33-B73E-6056640154D5}" dt="2020-04-13T08:18:04.267" v="13684" actId="164"/>
          <ac:spMkLst>
            <pc:docMk/>
            <pc:sldMk cId="1306267762" sldId="343"/>
            <ac:spMk id="124" creationId="{A9A31C55-1D93-45B0-808B-828137168FB5}"/>
          </ac:spMkLst>
        </pc:spChg>
        <pc:spChg chg="mod">
          <ac:chgData name="Chew Leng Lim" userId="f4956819b06a5395" providerId="LiveId" clId="{64D1738D-F0F2-4F33-B73E-6056640154D5}" dt="2020-04-13T08:11:11.817" v="12817" actId="164"/>
          <ac:spMkLst>
            <pc:docMk/>
            <pc:sldMk cId="1306267762" sldId="343"/>
            <ac:spMk id="126" creationId="{022DDA9F-8E9C-4AC6-9EA6-2B49255C8D30}"/>
          </ac:spMkLst>
        </pc:spChg>
        <pc:spChg chg="mod">
          <ac:chgData name="Chew Leng Lim" userId="f4956819b06a5395" providerId="LiveId" clId="{64D1738D-F0F2-4F33-B73E-6056640154D5}" dt="2020-04-13T08:18:04.267" v="13684" actId="164"/>
          <ac:spMkLst>
            <pc:docMk/>
            <pc:sldMk cId="1306267762" sldId="343"/>
            <ac:spMk id="127" creationId="{38D6BFFA-1309-45F6-9AA2-DA564BAF1B2C}"/>
          </ac:spMkLst>
        </pc:spChg>
        <pc:spChg chg="mod">
          <ac:chgData name="Chew Leng Lim" userId="f4956819b06a5395" providerId="LiveId" clId="{64D1738D-F0F2-4F33-B73E-6056640154D5}" dt="2020-04-13T08:18:04.267" v="13684" actId="164"/>
          <ac:spMkLst>
            <pc:docMk/>
            <pc:sldMk cId="1306267762" sldId="343"/>
            <ac:spMk id="128" creationId="{3C59C200-2488-4E62-9B0C-2D387857780A}"/>
          </ac:spMkLst>
        </pc:spChg>
        <pc:spChg chg="mod">
          <ac:chgData name="Chew Leng Lim" userId="f4956819b06a5395" providerId="LiveId" clId="{64D1738D-F0F2-4F33-B73E-6056640154D5}" dt="2020-04-13T08:18:04.267" v="13684" actId="164"/>
          <ac:spMkLst>
            <pc:docMk/>
            <pc:sldMk cId="1306267762" sldId="343"/>
            <ac:spMk id="129" creationId="{BB25C5F2-8D47-4391-86DC-8B9C667562E2}"/>
          </ac:spMkLst>
        </pc:spChg>
        <pc:spChg chg="mod">
          <ac:chgData name="Chew Leng Lim" userId="f4956819b06a5395" providerId="LiveId" clId="{64D1738D-F0F2-4F33-B73E-6056640154D5}" dt="2020-04-13T08:10:59.307" v="12813" actId="164"/>
          <ac:spMkLst>
            <pc:docMk/>
            <pc:sldMk cId="1306267762" sldId="343"/>
            <ac:spMk id="131" creationId="{3E8693AB-6882-4587-8DC3-866874AF849E}"/>
          </ac:spMkLst>
        </pc:spChg>
        <pc:spChg chg="mod">
          <ac:chgData name="Chew Leng Lim" userId="f4956819b06a5395" providerId="LiveId" clId="{64D1738D-F0F2-4F33-B73E-6056640154D5}" dt="2020-04-13T08:10:59.307" v="12813" actId="164"/>
          <ac:spMkLst>
            <pc:docMk/>
            <pc:sldMk cId="1306267762" sldId="343"/>
            <ac:spMk id="132" creationId="{EA542382-9747-4E03-9249-7B7CA088D741}"/>
          </ac:spMkLst>
        </pc:spChg>
        <pc:spChg chg="mod">
          <ac:chgData name="Chew Leng Lim" userId="f4956819b06a5395" providerId="LiveId" clId="{64D1738D-F0F2-4F33-B73E-6056640154D5}" dt="2020-04-13T08:10:59.307" v="12813" actId="164"/>
          <ac:spMkLst>
            <pc:docMk/>
            <pc:sldMk cId="1306267762" sldId="343"/>
            <ac:spMk id="133" creationId="{A7BBE4CD-65CD-46D0-891A-AC51D3ADEEA3}"/>
          </ac:spMkLst>
        </pc:spChg>
        <pc:spChg chg="mod">
          <ac:chgData name="Chew Leng Lim" userId="f4956819b06a5395" providerId="LiveId" clId="{64D1738D-F0F2-4F33-B73E-6056640154D5}" dt="2020-04-13T08:11:11.817" v="12817" actId="164"/>
          <ac:spMkLst>
            <pc:docMk/>
            <pc:sldMk cId="1306267762" sldId="343"/>
            <ac:spMk id="134" creationId="{80F9DA30-BCF3-4877-AC3A-6D0896EB02F5}"/>
          </ac:spMkLst>
        </pc:spChg>
        <pc:spChg chg="mod">
          <ac:chgData name="Chew Leng Lim" userId="f4956819b06a5395" providerId="LiveId" clId="{64D1738D-F0F2-4F33-B73E-6056640154D5}" dt="2020-04-13T08:11:11.817" v="12817" actId="164"/>
          <ac:spMkLst>
            <pc:docMk/>
            <pc:sldMk cId="1306267762" sldId="343"/>
            <ac:spMk id="135" creationId="{1FB06D5A-4FFF-4EBD-8B79-F09FAABF6051}"/>
          </ac:spMkLst>
        </pc:spChg>
        <pc:spChg chg="mod">
          <ac:chgData name="Chew Leng Lim" userId="f4956819b06a5395" providerId="LiveId" clId="{64D1738D-F0F2-4F33-B73E-6056640154D5}" dt="2020-04-13T08:10:59.307" v="12813" actId="164"/>
          <ac:spMkLst>
            <pc:docMk/>
            <pc:sldMk cId="1306267762" sldId="343"/>
            <ac:spMk id="137" creationId="{D320AD24-E4FF-40BE-AF1D-22238B614884}"/>
          </ac:spMkLst>
        </pc:spChg>
        <pc:spChg chg="mod">
          <ac:chgData name="Chew Leng Lim" userId="f4956819b06a5395" providerId="LiveId" clId="{64D1738D-F0F2-4F33-B73E-6056640154D5}" dt="2020-04-13T09:12:31.136" v="19138" actId="164"/>
          <ac:spMkLst>
            <pc:docMk/>
            <pc:sldMk cId="1306267762" sldId="343"/>
            <ac:spMk id="140" creationId="{3E90037C-293B-4361-A040-EC3648E308CC}"/>
          </ac:spMkLst>
        </pc:spChg>
        <pc:spChg chg="mod">
          <ac:chgData name="Chew Leng Lim" userId="f4956819b06a5395" providerId="LiveId" clId="{64D1738D-F0F2-4F33-B73E-6056640154D5}" dt="2020-04-13T08:10:59.307" v="12813" actId="164"/>
          <ac:spMkLst>
            <pc:docMk/>
            <pc:sldMk cId="1306267762" sldId="343"/>
            <ac:spMk id="141" creationId="{12918F8C-A095-4C51-BA68-C1D28B7F8E95}"/>
          </ac:spMkLst>
        </pc:spChg>
        <pc:spChg chg="mod">
          <ac:chgData name="Chew Leng Lim" userId="f4956819b06a5395" providerId="LiveId" clId="{64D1738D-F0F2-4F33-B73E-6056640154D5}" dt="2020-04-13T08:13:22.148" v="13213" actId="164"/>
          <ac:spMkLst>
            <pc:docMk/>
            <pc:sldMk cId="1306267762" sldId="343"/>
            <ac:spMk id="143" creationId="{1FD5575C-3912-48EB-842F-CE26ECD66E1C}"/>
          </ac:spMkLst>
        </pc:spChg>
        <pc:spChg chg="mod">
          <ac:chgData name="Chew Leng Lim" userId="f4956819b06a5395" providerId="LiveId" clId="{64D1738D-F0F2-4F33-B73E-6056640154D5}" dt="2020-04-13T08:13:22.148" v="13213" actId="164"/>
          <ac:spMkLst>
            <pc:docMk/>
            <pc:sldMk cId="1306267762" sldId="343"/>
            <ac:spMk id="144" creationId="{6F10942E-8CD1-4862-A122-2601C6709568}"/>
          </ac:spMkLst>
        </pc:spChg>
        <pc:spChg chg="mod">
          <ac:chgData name="Chew Leng Lim" userId="f4956819b06a5395" providerId="LiveId" clId="{64D1738D-F0F2-4F33-B73E-6056640154D5}" dt="2020-04-13T08:11:11.817" v="12817" actId="164"/>
          <ac:spMkLst>
            <pc:docMk/>
            <pc:sldMk cId="1306267762" sldId="343"/>
            <ac:spMk id="145" creationId="{9EDB8298-ADD8-44CD-A608-FFB71093EDCA}"/>
          </ac:spMkLst>
        </pc:spChg>
        <pc:spChg chg="mod">
          <ac:chgData name="Chew Leng Lim" userId="f4956819b06a5395" providerId="LiveId" clId="{64D1738D-F0F2-4F33-B73E-6056640154D5}" dt="2020-04-13T09:12:31.136" v="19138" actId="164"/>
          <ac:spMkLst>
            <pc:docMk/>
            <pc:sldMk cId="1306267762" sldId="343"/>
            <ac:spMk id="146" creationId="{A92697C3-5BF6-4188-80A9-BF751903E73E}"/>
          </ac:spMkLst>
        </pc:spChg>
        <pc:spChg chg="mod">
          <ac:chgData name="Chew Leng Lim" userId="f4956819b06a5395" providerId="LiveId" clId="{64D1738D-F0F2-4F33-B73E-6056640154D5}" dt="2020-04-13T08:13:22.148" v="13213" actId="164"/>
          <ac:spMkLst>
            <pc:docMk/>
            <pc:sldMk cId="1306267762" sldId="343"/>
            <ac:spMk id="147" creationId="{A85D46C9-833C-412D-B585-1813350F6F69}"/>
          </ac:spMkLst>
        </pc:spChg>
        <pc:spChg chg="mod">
          <ac:chgData name="Chew Leng Lim" userId="f4956819b06a5395" providerId="LiveId" clId="{64D1738D-F0F2-4F33-B73E-6056640154D5}" dt="2020-04-13T08:13:22.148" v="13213" actId="164"/>
          <ac:spMkLst>
            <pc:docMk/>
            <pc:sldMk cId="1306267762" sldId="343"/>
            <ac:spMk id="148" creationId="{DE5333C3-ABBB-4733-8EC8-C50504D926C0}"/>
          </ac:spMkLst>
        </pc:spChg>
        <pc:spChg chg="mod">
          <ac:chgData name="Chew Leng Lim" userId="f4956819b06a5395" providerId="LiveId" clId="{64D1738D-F0F2-4F33-B73E-6056640154D5}" dt="2020-04-13T09:12:31.136" v="19138" actId="164"/>
          <ac:spMkLst>
            <pc:docMk/>
            <pc:sldMk cId="1306267762" sldId="343"/>
            <ac:spMk id="150" creationId="{61108F21-3155-45DE-8B4A-332ACB3D577E}"/>
          </ac:spMkLst>
        </pc:spChg>
        <pc:spChg chg="mod">
          <ac:chgData name="Chew Leng Lim" userId="f4956819b06a5395" providerId="LiveId" clId="{64D1738D-F0F2-4F33-B73E-6056640154D5}" dt="2020-04-13T09:12:31.136" v="19138" actId="164"/>
          <ac:spMkLst>
            <pc:docMk/>
            <pc:sldMk cId="1306267762" sldId="343"/>
            <ac:spMk id="151" creationId="{1FCD2F2E-8426-4B36-A502-6D14FBEAFEA3}"/>
          </ac:spMkLst>
        </pc:spChg>
        <pc:spChg chg="mod">
          <ac:chgData name="Chew Leng Lim" userId="f4956819b06a5395" providerId="LiveId" clId="{64D1738D-F0F2-4F33-B73E-6056640154D5}" dt="2020-04-13T08:20:16.040" v="14068" actId="164"/>
          <ac:spMkLst>
            <pc:docMk/>
            <pc:sldMk cId="1306267762" sldId="343"/>
            <ac:spMk id="152" creationId="{56DDC5C5-EB2D-4124-901D-1BF98097CFAE}"/>
          </ac:spMkLst>
        </pc:spChg>
        <pc:spChg chg="mod">
          <ac:chgData name="Chew Leng Lim" userId="f4956819b06a5395" providerId="LiveId" clId="{64D1738D-F0F2-4F33-B73E-6056640154D5}" dt="2020-04-13T08:20:16.040" v="14068" actId="164"/>
          <ac:spMkLst>
            <pc:docMk/>
            <pc:sldMk cId="1306267762" sldId="343"/>
            <ac:spMk id="153" creationId="{CCBE019B-952D-4FE8-8C7B-F617D9291D43}"/>
          </ac:spMkLst>
        </pc:spChg>
        <pc:spChg chg="mod">
          <ac:chgData name="Chew Leng Lim" userId="f4956819b06a5395" providerId="LiveId" clId="{64D1738D-F0F2-4F33-B73E-6056640154D5}" dt="2020-04-13T08:20:16.040" v="14068" actId="164"/>
          <ac:spMkLst>
            <pc:docMk/>
            <pc:sldMk cId="1306267762" sldId="343"/>
            <ac:spMk id="154" creationId="{C0606CC8-03D5-46F1-92DB-EAD47B557A5A}"/>
          </ac:spMkLst>
        </pc:spChg>
        <pc:spChg chg="mod">
          <ac:chgData name="Chew Leng Lim" userId="f4956819b06a5395" providerId="LiveId" clId="{64D1738D-F0F2-4F33-B73E-6056640154D5}" dt="2020-04-13T08:20:16.040" v="14068" actId="164"/>
          <ac:spMkLst>
            <pc:docMk/>
            <pc:sldMk cId="1306267762" sldId="343"/>
            <ac:spMk id="155" creationId="{1517F0E8-54D3-4E68-B099-0FB216C8D56B}"/>
          </ac:spMkLst>
        </pc:spChg>
        <pc:spChg chg="mod">
          <ac:chgData name="Chew Leng Lim" userId="f4956819b06a5395" providerId="LiveId" clId="{64D1738D-F0F2-4F33-B73E-6056640154D5}" dt="2020-04-13T08:20:16.040" v="14068" actId="164"/>
          <ac:spMkLst>
            <pc:docMk/>
            <pc:sldMk cId="1306267762" sldId="343"/>
            <ac:spMk id="156" creationId="{0448E29C-0E99-4EAE-ACA2-AEA46215E72F}"/>
          </ac:spMkLst>
        </pc:spChg>
        <pc:spChg chg="mod">
          <ac:chgData name="Chew Leng Lim" userId="f4956819b06a5395" providerId="LiveId" clId="{64D1738D-F0F2-4F33-B73E-6056640154D5}" dt="2020-04-13T09:13:45.303" v="19145" actId="1035"/>
          <ac:spMkLst>
            <pc:docMk/>
            <pc:sldMk cId="1306267762" sldId="343"/>
            <ac:spMk id="157" creationId="{FABAC4F7-84C0-4D52-AB45-D126CC744185}"/>
          </ac:spMkLst>
        </pc:spChg>
        <pc:spChg chg="mod">
          <ac:chgData name="Chew Leng Lim" userId="f4956819b06a5395" providerId="LiveId" clId="{64D1738D-F0F2-4F33-B73E-6056640154D5}" dt="2020-04-13T08:15:48.797" v="13293" actId="164"/>
          <ac:spMkLst>
            <pc:docMk/>
            <pc:sldMk cId="1306267762" sldId="343"/>
            <ac:spMk id="158" creationId="{D57F114C-69E9-421E-9EDF-3DD5F6175512}"/>
          </ac:spMkLst>
        </pc:spChg>
        <pc:spChg chg="mod">
          <ac:chgData name="Chew Leng Lim" userId="f4956819b06a5395" providerId="LiveId" clId="{64D1738D-F0F2-4F33-B73E-6056640154D5}" dt="2020-04-13T08:11:11.817" v="12817" actId="164"/>
          <ac:spMkLst>
            <pc:docMk/>
            <pc:sldMk cId="1306267762" sldId="343"/>
            <ac:spMk id="161" creationId="{CEE6DA04-F3CB-4415-804C-4F4EBA2FE4BA}"/>
          </ac:spMkLst>
        </pc:spChg>
        <pc:spChg chg="mod">
          <ac:chgData name="Chew Leng Lim" userId="f4956819b06a5395" providerId="LiveId" clId="{64D1738D-F0F2-4F33-B73E-6056640154D5}" dt="2020-04-13T08:17:52.291" v="13672" actId="164"/>
          <ac:spMkLst>
            <pc:docMk/>
            <pc:sldMk cId="1306267762" sldId="343"/>
            <ac:spMk id="163" creationId="{84961433-7947-4405-83A8-DCD6E7A94004}"/>
          </ac:spMkLst>
        </pc:spChg>
        <pc:spChg chg="mod">
          <ac:chgData name="Chew Leng Lim" userId="f4956819b06a5395" providerId="LiveId" clId="{64D1738D-F0F2-4F33-B73E-6056640154D5}" dt="2020-04-13T08:16:10.412" v="13322" actId="164"/>
          <ac:spMkLst>
            <pc:docMk/>
            <pc:sldMk cId="1306267762" sldId="343"/>
            <ac:spMk id="164" creationId="{4982EE15-7A9F-483C-8D54-25482E49DC97}"/>
          </ac:spMkLst>
        </pc:spChg>
        <pc:spChg chg="mod">
          <ac:chgData name="Chew Leng Lim" userId="f4956819b06a5395" providerId="LiveId" clId="{64D1738D-F0F2-4F33-B73E-6056640154D5}" dt="2020-04-13T08:17:52.291" v="13672" actId="164"/>
          <ac:spMkLst>
            <pc:docMk/>
            <pc:sldMk cId="1306267762" sldId="343"/>
            <ac:spMk id="165" creationId="{C1184470-3607-451E-B6C7-1A044FA7BD35}"/>
          </ac:spMkLst>
        </pc:spChg>
        <pc:spChg chg="mod">
          <ac:chgData name="Chew Leng Lim" userId="f4956819b06a5395" providerId="LiveId" clId="{64D1738D-F0F2-4F33-B73E-6056640154D5}" dt="2020-04-13T08:17:52.291" v="13672" actId="164"/>
          <ac:spMkLst>
            <pc:docMk/>
            <pc:sldMk cId="1306267762" sldId="343"/>
            <ac:spMk id="166" creationId="{2A121843-3413-4D5E-92D4-42CA663A77DA}"/>
          </ac:spMkLst>
        </pc:spChg>
        <pc:spChg chg="mod">
          <ac:chgData name="Chew Leng Lim" userId="f4956819b06a5395" providerId="LiveId" clId="{64D1738D-F0F2-4F33-B73E-6056640154D5}" dt="2020-04-13T08:17:52.291" v="13672" actId="164"/>
          <ac:spMkLst>
            <pc:docMk/>
            <pc:sldMk cId="1306267762" sldId="343"/>
            <ac:spMk id="167" creationId="{6C644F29-891C-43C6-8200-C73DC2BD3D05}"/>
          </ac:spMkLst>
        </pc:spChg>
        <pc:spChg chg="mod">
          <ac:chgData name="Chew Leng Lim" userId="f4956819b06a5395" providerId="LiveId" clId="{64D1738D-F0F2-4F33-B73E-6056640154D5}" dt="2020-04-13T08:17:52.291" v="13672" actId="164"/>
          <ac:spMkLst>
            <pc:docMk/>
            <pc:sldMk cId="1306267762" sldId="343"/>
            <ac:spMk id="168" creationId="{4C9FDB61-F2A0-4897-8FED-DA31F2626E8B}"/>
          </ac:spMkLst>
        </pc:spChg>
        <pc:spChg chg="mod">
          <ac:chgData name="Chew Leng Lim" userId="f4956819b06a5395" providerId="LiveId" clId="{64D1738D-F0F2-4F33-B73E-6056640154D5}" dt="2020-04-13T08:17:52.291" v="13672" actId="164"/>
          <ac:spMkLst>
            <pc:docMk/>
            <pc:sldMk cId="1306267762" sldId="343"/>
            <ac:spMk id="169" creationId="{D288B13F-4FBA-40B7-B7EC-6F378D290651}"/>
          </ac:spMkLst>
        </pc:spChg>
        <pc:spChg chg="mod">
          <ac:chgData name="Chew Leng Lim" userId="f4956819b06a5395" providerId="LiveId" clId="{64D1738D-F0F2-4F33-B73E-6056640154D5}" dt="2020-04-13T08:16:10.412" v="13322" actId="164"/>
          <ac:spMkLst>
            <pc:docMk/>
            <pc:sldMk cId="1306267762" sldId="343"/>
            <ac:spMk id="170" creationId="{C144520B-2A42-4EBC-A67F-39C5A072B4DB}"/>
          </ac:spMkLst>
        </pc:spChg>
        <pc:spChg chg="mod">
          <ac:chgData name="Chew Leng Lim" userId="f4956819b06a5395" providerId="LiveId" clId="{64D1738D-F0F2-4F33-B73E-6056640154D5}" dt="2020-04-13T08:16:10.412" v="13322" actId="164"/>
          <ac:spMkLst>
            <pc:docMk/>
            <pc:sldMk cId="1306267762" sldId="343"/>
            <ac:spMk id="171" creationId="{A385BEB5-09D7-4F41-9A83-E8A881F36093}"/>
          </ac:spMkLst>
        </pc:spChg>
        <pc:spChg chg="mod">
          <ac:chgData name="Chew Leng Lim" userId="f4956819b06a5395" providerId="LiveId" clId="{64D1738D-F0F2-4F33-B73E-6056640154D5}" dt="2020-04-13T08:16:10.412" v="13322" actId="164"/>
          <ac:spMkLst>
            <pc:docMk/>
            <pc:sldMk cId="1306267762" sldId="343"/>
            <ac:spMk id="172" creationId="{B27F6A30-6417-4B27-8BDA-777FBB3EE27F}"/>
          </ac:spMkLst>
        </pc:spChg>
        <pc:spChg chg="mod">
          <ac:chgData name="Chew Leng Lim" userId="f4956819b06a5395" providerId="LiveId" clId="{64D1738D-F0F2-4F33-B73E-6056640154D5}" dt="2020-04-13T08:20:58.352" v="14140" actId="164"/>
          <ac:spMkLst>
            <pc:docMk/>
            <pc:sldMk cId="1306267762" sldId="343"/>
            <ac:spMk id="174" creationId="{652F6836-1EC1-465F-8307-6A5891485866}"/>
          </ac:spMkLst>
        </pc:spChg>
        <pc:spChg chg="mod">
          <ac:chgData name="Chew Leng Lim" userId="f4956819b06a5395" providerId="LiveId" clId="{64D1738D-F0F2-4F33-B73E-6056640154D5}" dt="2020-04-13T08:20:58.352" v="14140" actId="164"/>
          <ac:spMkLst>
            <pc:docMk/>
            <pc:sldMk cId="1306267762" sldId="343"/>
            <ac:spMk id="175" creationId="{A7BE1676-B29C-4C0C-98F3-8F602F6B8E02}"/>
          </ac:spMkLst>
        </pc:spChg>
        <pc:spChg chg="mod">
          <ac:chgData name="Chew Leng Lim" userId="f4956819b06a5395" providerId="LiveId" clId="{64D1738D-F0F2-4F33-B73E-6056640154D5}" dt="2020-04-13T08:20:58.352" v="14140" actId="164"/>
          <ac:spMkLst>
            <pc:docMk/>
            <pc:sldMk cId="1306267762" sldId="343"/>
            <ac:spMk id="176" creationId="{4F264D27-DB82-41D9-9A59-6949805A197A}"/>
          </ac:spMkLst>
        </pc:spChg>
        <pc:spChg chg="mod">
          <ac:chgData name="Chew Leng Lim" userId="f4956819b06a5395" providerId="LiveId" clId="{64D1738D-F0F2-4F33-B73E-6056640154D5}" dt="2020-04-13T08:20:58.352" v="14140" actId="164"/>
          <ac:spMkLst>
            <pc:docMk/>
            <pc:sldMk cId="1306267762" sldId="343"/>
            <ac:spMk id="177" creationId="{1437F214-B409-4C43-8234-856FEAA07555}"/>
          </ac:spMkLst>
        </pc:spChg>
        <pc:spChg chg="mod">
          <ac:chgData name="Chew Leng Lim" userId="f4956819b06a5395" providerId="LiveId" clId="{64D1738D-F0F2-4F33-B73E-6056640154D5}" dt="2020-04-13T09:12:31.136" v="19138" actId="164"/>
          <ac:spMkLst>
            <pc:docMk/>
            <pc:sldMk cId="1306267762" sldId="343"/>
            <ac:spMk id="178" creationId="{0C9088CA-9CD7-4B52-A2EE-57323C725F82}"/>
          </ac:spMkLst>
        </pc:spChg>
        <pc:spChg chg="del mod">
          <ac:chgData name="Chew Leng Lim" userId="f4956819b06a5395" providerId="LiveId" clId="{64D1738D-F0F2-4F33-B73E-6056640154D5}" dt="2020-04-13T08:07:13.702" v="12256" actId="478"/>
          <ac:spMkLst>
            <pc:docMk/>
            <pc:sldMk cId="1306267762" sldId="343"/>
            <ac:spMk id="180" creationId="{4AFFA86C-DAC4-4814-B1DB-FB63CBA541F7}"/>
          </ac:spMkLst>
        </pc:spChg>
        <pc:spChg chg="mod">
          <ac:chgData name="Chew Leng Lim" userId="f4956819b06a5395" providerId="LiveId" clId="{64D1738D-F0F2-4F33-B73E-6056640154D5}" dt="2020-04-13T08:18:37.115" v="13735" actId="164"/>
          <ac:spMkLst>
            <pc:docMk/>
            <pc:sldMk cId="1306267762" sldId="343"/>
            <ac:spMk id="181" creationId="{364BC1C6-3006-46DE-9444-672F58F27B50}"/>
          </ac:spMkLst>
        </pc:spChg>
        <pc:spChg chg="mod">
          <ac:chgData name="Chew Leng Lim" userId="f4956819b06a5395" providerId="LiveId" clId="{64D1738D-F0F2-4F33-B73E-6056640154D5}" dt="2020-04-13T08:18:37.115" v="13735" actId="164"/>
          <ac:spMkLst>
            <pc:docMk/>
            <pc:sldMk cId="1306267762" sldId="343"/>
            <ac:spMk id="182" creationId="{516361D7-FE82-46AF-B62F-8D52BC7E26F2}"/>
          </ac:spMkLst>
        </pc:spChg>
        <pc:spChg chg="mod">
          <ac:chgData name="Chew Leng Lim" userId="f4956819b06a5395" providerId="LiveId" clId="{64D1738D-F0F2-4F33-B73E-6056640154D5}" dt="2020-04-13T08:18:37.115" v="13735" actId="164"/>
          <ac:spMkLst>
            <pc:docMk/>
            <pc:sldMk cId="1306267762" sldId="343"/>
            <ac:spMk id="183" creationId="{864C9F62-4699-41F5-97C9-07E66F49098B}"/>
          </ac:spMkLst>
        </pc:spChg>
        <pc:spChg chg="mod">
          <ac:chgData name="Chew Leng Lim" userId="f4956819b06a5395" providerId="LiveId" clId="{64D1738D-F0F2-4F33-B73E-6056640154D5}" dt="2020-04-13T08:18:37.115" v="13735" actId="164"/>
          <ac:spMkLst>
            <pc:docMk/>
            <pc:sldMk cId="1306267762" sldId="343"/>
            <ac:spMk id="184" creationId="{C8EF24E5-AF47-41C9-9D20-2FC8307C8947}"/>
          </ac:spMkLst>
        </pc:spChg>
        <pc:spChg chg="mod">
          <ac:chgData name="Chew Leng Lim" userId="f4956819b06a5395" providerId="LiveId" clId="{64D1738D-F0F2-4F33-B73E-6056640154D5}" dt="2020-04-13T08:20:58.352" v="14140" actId="164"/>
          <ac:spMkLst>
            <pc:docMk/>
            <pc:sldMk cId="1306267762" sldId="343"/>
            <ac:spMk id="185" creationId="{EFBAC435-F28D-4BB7-ADFC-BCCDBFDD00E6}"/>
          </ac:spMkLst>
        </pc:spChg>
        <pc:spChg chg="mod">
          <ac:chgData name="Chew Leng Lim" userId="f4956819b06a5395" providerId="LiveId" clId="{64D1738D-F0F2-4F33-B73E-6056640154D5}" dt="2020-04-13T08:16:10.412" v="13322" actId="164"/>
          <ac:spMkLst>
            <pc:docMk/>
            <pc:sldMk cId="1306267762" sldId="343"/>
            <ac:spMk id="186" creationId="{F7EDED96-CC26-4D37-89DA-15AABA426DBC}"/>
          </ac:spMkLst>
        </pc:spChg>
        <pc:spChg chg="del mod">
          <ac:chgData name="Chew Leng Lim" userId="f4956819b06a5395" providerId="LiveId" clId="{64D1738D-F0F2-4F33-B73E-6056640154D5}" dt="2020-04-13T08:07:13.702" v="12256" actId="478"/>
          <ac:spMkLst>
            <pc:docMk/>
            <pc:sldMk cId="1306267762" sldId="343"/>
            <ac:spMk id="188" creationId="{1F18F9E7-5B36-4312-9F8C-F4103EBA7523}"/>
          </ac:spMkLst>
        </pc:spChg>
        <pc:spChg chg="del mod">
          <ac:chgData name="Chew Leng Lim" userId="f4956819b06a5395" providerId="LiveId" clId="{64D1738D-F0F2-4F33-B73E-6056640154D5}" dt="2020-04-13T08:07:13.702" v="12256" actId="478"/>
          <ac:spMkLst>
            <pc:docMk/>
            <pc:sldMk cId="1306267762" sldId="343"/>
            <ac:spMk id="189" creationId="{73DCFD1D-AA5A-431D-B1FE-3C894E39CCA9}"/>
          </ac:spMkLst>
        </pc:spChg>
        <pc:spChg chg="del mod">
          <ac:chgData name="Chew Leng Lim" userId="f4956819b06a5395" providerId="LiveId" clId="{64D1738D-F0F2-4F33-B73E-6056640154D5}" dt="2020-04-13T08:07:13.702" v="12256" actId="478"/>
          <ac:spMkLst>
            <pc:docMk/>
            <pc:sldMk cId="1306267762" sldId="343"/>
            <ac:spMk id="190" creationId="{C080ABF3-948E-4739-A7B6-B7245F62CBAD}"/>
          </ac:spMkLst>
        </pc:spChg>
        <pc:spChg chg="mod">
          <ac:chgData name="Chew Leng Lim" userId="f4956819b06a5395" providerId="LiveId" clId="{64D1738D-F0F2-4F33-B73E-6056640154D5}" dt="2020-04-13T08:11:11.817" v="12817" actId="164"/>
          <ac:spMkLst>
            <pc:docMk/>
            <pc:sldMk cId="1306267762" sldId="343"/>
            <ac:spMk id="191" creationId="{74C6EC32-69C1-4F32-8E97-62A38A8471DD}"/>
          </ac:spMkLst>
        </pc:spChg>
        <pc:spChg chg="mod">
          <ac:chgData name="Chew Leng Lim" userId="f4956819b06a5395" providerId="LiveId" clId="{64D1738D-F0F2-4F33-B73E-6056640154D5}" dt="2020-04-13T08:18:37.115" v="13735" actId="164"/>
          <ac:spMkLst>
            <pc:docMk/>
            <pc:sldMk cId="1306267762" sldId="343"/>
            <ac:spMk id="192" creationId="{DD1F38DA-39CF-419C-A3C0-75C71EB8A13F}"/>
          </ac:spMkLst>
        </pc:spChg>
        <pc:spChg chg="mod">
          <ac:chgData name="Chew Leng Lim" userId="f4956819b06a5395" providerId="LiveId" clId="{64D1738D-F0F2-4F33-B73E-6056640154D5}" dt="2020-04-13T09:12:31.136" v="19138" actId="164"/>
          <ac:spMkLst>
            <pc:docMk/>
            <pc:sldMk cId="1306267762" sldId="343"/>
            <ac:spMk id="193" creationId="{9AE0567A-BE26-4FCE-B6D5-4B6B1723E1A5}"/>
          </ac:spMkLst>
        </pc:spChg>
        <pc:spChg chg="del mod">
          <ac:chgData name="Chew Leng Lim" userId="f4956819b06a5395" providerId="LiveId" clId="{64D1738D-F0F2-4F33-B73E-6056640154D5}" dt="2020-04-13T08:07:13.702" v="12256" actId="478"/>
          <ac:spMkLst>
            <pc:docMk/>
            <pc:sldMk cId="1306267762" sldId="343"/>
            <ac:spMk id="198" creationId="{2B60FA06-7854-4756-BF96-FB245022C273}"/>
          </ac:spMkLst>
        </pc:spChg>
        <pc:spChg chg="del mod">
          <ac:chgData name="Chew Leng Lim" userId="f4956819b06a5395" providerId="LiveId" clId="{64D1738D-F0F2-4F33-B73E-6056640154D5}" dt="2020-04-13T08:07:13.702" v="12256" actId="478"/>
          <ac:spMkLst>
            <pc:docMk/>
            <pc:sldMk cId="1306267762" sldId="343"/>
            <ac:spMk id="199" creationId="{1471560B-9DA4-4E41-B334-19A1A812D378}"/>
          </ac:spMkLst>
        </pc:spChg>
        <pc:spChg chg="del mod">
          <ac:chgData name="Chew Leng Lim" userId="f4956819b06a5395" providerId="LiveId" clId="{64D1738D-F0F2-4F33-B73E-6056640154D5}" dt="2020-04-13T08:07:13.702" v="12256" actId="478"/>
          <ac:spMkLst>
            <pc:docMk/>
            <pc:sldMk cId="1306267762" sldId="343"/>
            <ac:spMk id="200" creationId="{91934FD5-6C35-4118-85E2-B0B8B4360691}"/>
          </ac:spMkLst>
        </pc:spChg>
        <pc:spChg chg="del mod">
          <ac:chgData name="Chew Leng Lim" userId="f4956819b06a5395" providerId="LiveId" clId="{64D1738D-F0F2-4F33-B73E-6056640154D5}" dt="2020-04-13T08:07:13.702" v="12256" actId="478"/>
          <ac:spMkLst>
            <pc:docMk/>
            <pc:sldMk cId="1306267762" sldId="343"/>
            <ac:spMk id="201" creationId="{057BF96E-3C81-42A1-8EBA-6D224EA22725}"/>
          </ac:spMkLst>
        </pc:spChg>
        <pc:spChg chg="del mod">
          <ac:chgData name="Chew Leng Lim" userId="f4956819b06a5395" providerId="LiveId" clId="{64D1738D-F0F2-4F33-B73E-6056640154D5}" dt="2020-04-13T08:07:13.702" v="12256" actId="478"/>
          <ac:spMkLst>
            <pc:docMk/>
            <pc:sldMk cId="1306267762" sldId="343"/>
            <ac:spMk id="202" creationId="{632ABA68-1FB1-477E-93EB-7FCF7DEBB9CB}"/>
          </ac:spMkLst>
        </pc:spChg>
        <pc:spChg chg="del mod">
          <ac:chgData name="Chew Leng Lim" userId="f4956819b06a5395" providerId="LiveId" clId="{64D1738D-F0F2-4F33-B73E-6056640154D5}" dt="2020-04-13T08:07:13.702" v="12256" actId="478"/>
          <ac:spMkLst>
            <pc:docMk/>
            <pc:sldMk cId="1306267762" sldId="343"/>
            <ac:spMk id="203" creationId="{4D00FB6E-5132-41EF-AF26-CFA1D692B722}"/>
          </ac:spMkLst>
        </pc:spChg>
        <pc:spChg chg="del mod">
          <ac:chgData name="Chew Leng Lim" userId="f4956819b06a5395" providerId="LiveId" clId="{64D1738D-F0F2-4F33-B73E-6056640154D5}" dt="2020-04-13T08:07:13.702" v="12256" actId="478"/>
          <ac:spMkLst>
            <pc:docMk/>
            <pc:sldMk cId="1306267762" sldId="343"/>
            <ac:spMk id="204" creationId="{E652C887-51EB-4769-B0B6-4D871AB9EFF4}"/>
          </ac:spMkLst>
        </pc:spChg>
        <pc:spChg chg="del mod">
          <ac:chgData name="Chew Leng Lim" userId="f4956819b06a5395" providerId="LiveId" clId="{64D1738D-F0F2-4F33-B73E-6056640154D5}" dt="2020-04-13T08:07:13.702" v="12256" actId="478"/>
          <ac:spMkLst>
            <pc:docMk/>
            <pc:sldMk cId="1306267762" sldId="343"/>
            <ac:spMk id="205" creationId="{31DBCB29-6BFE-4CD8-9934-7DF03EC211DF}"/>
          </ac:spMkLst>
        </pc:spChg>
        <pc:spChg chg="del mod">
          <ac:chgData name="Chew Leng Lim" userId="f4956819b06a5395" providerId="LiveId" clId="{64D1738D-F0F2-4F33-B73E-6056640154D5}" dt="2020-04-13T08:07:13.702" v="12256" actId="478"/>
          <ac:spMkLst>
            <pc:docMk/>
            <pc:sldMk cId="1306267762" sldId="343"/>
            <ac:spMk id="206" creationId="{4BC1752A-6B0A-42A8-AB7E-A465BC6AECE6}"/>
          </ac:spMkLst>
        </pc:spChg>
        <pc:spChg chg="del mod">
          <ac:chgData name="Chew Leng Lim" userId="f4956819b06a5395" providerId="LiveId" clId="{64D1738D-F0F2-4F33-B73E-6056640154D5}" dt="2020-04-13T08:07:13.702" v="12256" actId="478"/>
          <ac:spMkLst>
            <pc:docMk/>
            <pc:sldMk cId="1306267762" sldId="343"/>
            <ac:spMk id="208" creationId="{40D0F1B1-EEDF-427A-A25C-F60107B9DFA2}"/>
          </ac:spMkLst>
        </pc:spChg>
        <pc:spChg chg="del mod">
          <ac:chgData name="Chew Leng Lim" userId="f4956819b06a5395" providerId="LiveId" clId="{64D1738D-F0F2-4F33-B73E-6056640154D5}" dt="2020-04-13T08:07:13.702" v="12256" actId="478"/>
          <ac:spMkLst>
            <pc:docMk/>
            <pc:sldMk cId="1306267762" sldId="343"/>
            <ac:spMk id="209" creationId="{D67623EE-F041-42EC-9E9A-EF5E20423830}"/>
          </ac:spMkLst>
        </pc:spChg>
        <pc:spChg chg="del mod">
          <ac:chgData name="Chew Leng Lim" userId="f4956819b06a5395" providerId="LiveId" clId="{64D1738D-F0F2-4F33-B73E-6056640154D5}" dt="2020-04-13T08:07:13.702" v="12256" actId="478"/>
          <ac:spMkLst>
            <pc:docMk/>
            <pc:sldMk cId="1306267762" sldId="343"/>
            <ac:spMk id="210" creationId="{E047A7C0-5DC3-4BCA-8383-62DA2F959AF5}"/>
          </ac:spMkLst>
        </pc:spChg>
        <pc:spChg chg="del mod">
          <ac:chgData name="Chew Leng Lim" userId="f4956819b06a5395" providerId="LiveId" clId="{64D1738D-F0F2-4F33-B73E-6056640154D5}" dt="2020-04-13T08:07:13.702" v="12256" actId="478"/>
          <ac:spMkLst>
            <pc:docMk/>
            <pc:sldMk cId="1306267762" sldId="343"/>
            <ac:spMk id="211" creationId="{5CBCF310-A35E-46EE-8897-4DD4098D853A}"/>
          </ac:spMkLst>
        </pc:spChg>
        <pc:spChg chg="del mod">
          <ac:chgData name="Chew Leng Lim" userId="f4956819b06a5395" providerId="LiveId" clId="{64D1738D-F0F2-4F33-B73E-6056640154D5}" dt="2020-04-13T08:07:13.702" v="12256" actId="478"/>
          <ac:spMkLst>
            <pc:docMk/>
            <pc:sldMk cId="1306267762" sldId="343"/>
            <ac:spMk id="212" creationId="{55AD4BEA-251E-437F-B34A-B6363AAC7C83}"/>
          </ac:spMkLst>
        </pc:spChg>
        <pc:spChg chg="del mod">
          <ac:chgData name="Chew Leng Lim" userId="f4956819b06a5395" providerId="LiveId" clId="{64D1738D-F0F2-4F33-B73E-6056640154D5}" dt="2020-04-13T08:07:13.702" v="12256" actId="478"/>
          <ac:spMkLst>
            <pc:docMk/>
            <pc:sldMk cId="1306267762" sldId="343"/>
            <ac:spMk id="213" creationId="{4832DC4D-253E-417D-BEA3-453C1D950574}"/>
          </ac:spMkLst>
        </pc:spChg>
        <pc:spChg chg="del mod">
          <ac:chgData name="Chew Leng Lim" userId="f4956819b06a5395" providerId="LiveId" clId="{64D1738D-F0F2-4F33-B73E-6056640154D5}" dt="2020-04-13T08:07:13.702" v="12256" actId="478"/>
          <ac:spMkLst>
            <pc:docMk/>
            <pc:sldMk cId="1306267762" sldId="343"/>
            <ac:spMk id="214" creationId="{A0A7DABB-46A8-45F2-9D89-F443E33103CF}"/>
          </ac:spMkLst>
        </pc:spChg>
        <pc:spChg chg="del mod">
          <ac:chgData name="Chew Leng Lim" userId="f4956819b06a5395" providerId="LiveId" clId="{64D1738D-F0F2-4F33-B73E-6056640154D5}" dt="2020-04-13T08:07:13.702" v="12256" actId="478"/>
          <ac:spMkLst>
            <pc:docMk/>
            <pc:sldMk cId="1306267762" sldId="343"/>
            <ac:spMk id="215" creationId="{70CC0F91-4971-4F86-83CE-64EB5CEB57F1}"/>
          </ac:spMkLst>
        </pc:spChg>
        <pc:spChg chg="del mod">
          <ac:chgData name="Chew Leng Lim" userId="f4956819b06a5395" providerId="LiveId" clId="{64D1738D-F0F2-4F33-B73E-6056640154D5}" dt="2020-04-13T08:07:13.702" v="12256" actId="478"/>
          <ac:spMkLst>
            <pc:docMk/>
            <pc:sldMk cId="1306267762" sldId="343"/>
            <ac:spMk id="217" creationId="{02AB3F56-2CD5-4824-9188-404131462A5F}"/>
          </ac:spMkLst>
        </pc:spChg>
        <pc:spChg chg="del mod">
          <ac:chgData name="Chew Leng Lim" userId="f4956819b06a5395" providerId="LiveId" clId="{64D1738D-F0F2-4F33-B73E-6056640154D5}" dt="2020-04-13T08:42:23.420" v="16567" actId="478"/>
          <ac:spMkLst>
            <pc:docMk/>
            <pc:sldMk cId="1306267762" sldId="343"/>
            <ac:spMk id="219" creationId="{E0C90124-43D3-48FD-A020-9F11BD7C1345}"/>
          </ac:spMkLst>
        </pc:spChg>
        <pc:spChg chg="del mod">
          <ac:chgData name="Chew Leng Lim" userId="f4956819b06a5395" providerId="LiveId" clId="{64D1738D-F0F2-4F33-B73E-6056640154D5}" dt="2020-04-13T08:42:24.274" v="16568" actId="478"/>
          <ac:spMkLst>
            <pc:docMk/>
            <pc:sldMk cId="1306267762" sldId="343"/>
            <ac:spMk id="220" creationId="{0914CC85-5863-4BD7-BAFC-D3A61F9DA227}"/>
          </ac:spMkLst>
        </pc:spChg>
        <pc:spChg chg="add del mod">
          <ac:chgData name="Chew Leng Lim" userId="f4956819b06a5395" providerId="LiveId" clId="{64D1738D-F0F2-4F33-B73E-6056640154D5}" dt="2020-04-13T08:36:11.679" v="16307" actId="478"/>
          <ac:spMkLst>
            <pc:docMk/>
            <pc:sldMk cId="1306267762" sldId="343"/>
            <ac:spMk id="221" creationId="{46B2A587-3C33-4243-A75D-CF39DF665B9E}"/>
          </ac:spMkLst>
        </pc:spChg>
        <pc:spChg chg="add mod">
          <ac:chgData name="Chew Leng Lim" userId="f4956819b06a5395" providerId="LiveId" clId="{64D1738D-F0F2-4F33-B73E-6056640154D5}" dt="2020-04-13T08:15:48.797" v="13293" actId="164"/>
          <ac:spMkLst>
            <pc:docMk/>
            <pc:sldMk cId="1306267762" sldId="343"/>
            <ac:spMk id="227" creationId="{5A8B4F38-C218-47DE-A614-E215D3053456}"/>
          </ac:spMkLst>
        </pc:spChg>
        <pc:spChg chg="add mod">
          <ac:chgData name="Chew Leng Lim" userId="f4956819b06a5395" providerId="LiveId" clId="{64D1738D-F0F2-4F33-B73E-6056640154D5}" dt="2020-04-13T09:12:43.982" v="19139" actId="164"/>
          <ac:spMkLst>
            <pc:docMk/>
            <pc:sldMk cId="1306267762" sldId="343"/>
            <ac:spMk id="241" creationId="{1BBDA395-6EA8-447F-951E-D00EA51FABEE}"/>
          </ac:spMkLst>
        </pc:spChg>
        <pc:spChg chg="add mod">
          <ac:chgData name="Chew Leng Lim" userId="f4956819b06a5395" providerId="LiveId" clId="{64D1738D-F0F2-4F33-B73E-6056640154D5}" dt="2020-04-13T09:12:43.982" v="19139" actId="164"/>
          <ac:spMkLst>
            <pc:docMk/>
            <pc:sldMk cId="1306267762" sldId="343"/>
            <ac:spMk id="249" creationId="{29CAF6F3-CC76-4C3C-B109-3586E1C4D2DA}"/>
          </ac:spMkLst>
        </pc:spChg>
        <pc:spChg chg="add mod">
          <ac:chgData name="Chew Leng Lim" userId="f4956819b06a5395" providerId="LiveId" clId="{64D1738D-F0F2-4F33-B73E-6056640154D5}" dt="2020-04-13T09:12:43.982" v="19139" actId="164"/>
          <ac:spMkLst>
            <pc:docMk/>
            <pc:sldMk cId="1306267762" sldId="343"/>
            <ac:spMk id="250" creationId="{FFA315E0-F231-4BF3-B708-C173F1C57221}"/>
          </ac:spMkLst>
        </pc:spChg>
        <pc:spChg chg="add mod">
          <ac:chgData name="Chew Leng Lim" userId="f4956819b06a5395" providerId="LiveId" clId="{64D1738D-F0F2-4F33-B73E-6056640154D5}" dt="2020-04-13T09:12:43.982" v="19139" actId="164"/>
          <ac:spMkLst>
            <pc:docMk/>
            <pc:sldMk cId="1306267762" sldId="343"/>
            <ac:spMk id="251" creationId="{54AAAF8C-F4F6-4D5D-AB32-E06E7430D30A}"/>
          </ac:spMkLst>
        </pc:spChg>
        <pc:spChg chg="add mod">
          <ac:chgData name="Chew Leng Lim" userId="f4956819b06a5395" providerId="LiveId" clId="{64D1738D-F0F2-4F33-B73E-6056640154D5}" dt="2020-04-13T09:12:43.982" v="19139" actId="164"/>
          <ac:spMkLst>
            <pc:docMk/>
            <pc:sldMk cId="1306267762" sldId="343"/>
            <ac:spMk id="252" creationId="{032FFB19-BB0C-49BD-8050-C54BA469DEB3}"/>
          </ac:spMkLst>
        </pc:spChg>
        <pc:spChg chg="add mod">
          <ac:chgData name="Chew Leng Lim" userId="f4956819b06a5395" providerId="LiveId" clId="{64D1738D-F0F2-4F33-B73E-6056640154D5}" dt="2020-04-13T09:12:43.982" v="19139" actId="164"/>
          <ac:spMkLst>
            <pc:docMk/>
            <pc:sldMk cId="1306267762" sldId="343"/>
            <ac:spMk id="253" creationId="{F7A3B466-0545-499E-84C7-B7C7E2669C29}"/>
          </ac:spMkLst>
        </pc:spChg>
        <pc:spChg chg="mod">
          <ac:chgData name="Chew Leng Lim" userId="f4956819b06a5395" providerId="LiveId" clId="{64D1738D-F0F2-4F33-B73E-6056640154D5}" dt="2020-04-14T13:04:19.934" v="34365" actId="1035"/>
          <ac:spMkLst>
            <pc:docMk/>
            <pc:sldMk cId="1306267762" sldId="343"/>
            <ac:spMk id="275" creationId="{1C1E4FA2-92E2-4721-82F5-E50E86892226}"/>
          </ac:spMkLst>
        </pc:spChg>
        <pc:spChg chg="add mod">
          <ac:chgData name="Chew Leng Lim" userId="f4956819b06a5395" providerId="LiveId" clId="{64D1738D-F0F2-4F33-B73E-6056640154D5}" dt="2020-04-13T09:12:43.982" v="19139" actId="164"/>
          <ac:spMkLst>
            <pc:docMk/>
            <pc:sldMk cId="1306267762" sldId="343"/>
            <ac:spMk id="277" creationId="{D612CF09-895F-465B-800C-C64DE0732621}"/>
          </ac:spMkLst>
        </pc:spChg>
        <pc:spChg chg="add mod">
          <ac:chgData name="Chew Leng Lim" userId="f4956819b06a5395" providerId="LiveId" clId="{64D1738D-F0F2-4F33-B73E-6056640154D5}" dt="2020-04-13T09:12:19.148" v="19137" actId="1035"/>
          <ac:spMkLst>
            <pc:docMk/>
            <pc:sldMk cId="1306267762" sldId="343"/>
            <ac:spMk id="307" creationId="{9F300576-5A9F-4802-8C7F-1AF1C2946A23}"/>
          </ac:spMkLst>
        </pc:spChg>
        <pc:spChg chg="add mod">
          <ac:chgData name="Chew Leng Lim" userId="f4956819b06a5395" providerId="LiveId" clId="{64D1738D-F0F2-4F33-B73E-6056640154D5}" dt="2020-04-13T09:12:19.148" v="19137" actId="1035"/>
          <ac:spMkLst>
            <pc:docMk/>
            <pc:sldMk cId="1306267762" sldId="343"/>
            <ac:spMk id="308" creationId="{CCF6BA18-316A-43E4-A039-1952C3959A0E}"/>
          </ac:spMkLst>
        </pc:spChg>
        <pc:spChg chg="add mod">
          <ac:chgData name="Chew Leng Lim" userId="f4956819b06a5395" providerId="LiveId" clId="{64D1738D-F0F2-4F33-B73E-6056640154D5}" dt="2020-04-13T09:12:19.148" v="19137" actId="1035"/>
          <ac:spMkLst>
            <pc:docMk/>
            <pc:sldMk cId="1306267762" sldId="343"/>
            <ac:spMk id="309" creationId="{25ADFB08-BE71-4F2E-8B07-B639A2E78B62}"/>
          </ac:spMkLst>
        </pc:spChg>
        <pc:spChg chg="add mod">
          <ac:chgData name="Chew Leng Lim" userId="f4956819b06a5395" providerId="LiveId" clId="{64D1738D-F0F2-4F33-B73E-6056640154D5}" dt="2020-04-13T09:12:19.148" v="19137" actId="1035"/>
          <ac:spMkLst>
            <pc:docMk/>
            <pc:sldMk cId="1306267762" sldId="343"/>
            <ac:spMk id="310" creationId="{1AFD4077-37F2-4EBB-9108-D6D32A247ADF}"/>
          </ac:spMkLst>
        </pc:spChg>
        <pc:spChg chg="add del mod">
          <ac:chgData name="Chew Leng Lim" userId="f4956819b06a5395" providerId="LiveId" clId="{64D1738D-F0F2-4F33-B73E-6056640154D5}" dt="2020-04-13T09:05:53.345" v="18880" actId="478"/>
          <ac:spMkLst>
            <pc:docMk/>
            <pc:sldMk cId="1306267762" sldId="343"/>
            <ac:spMk id="311" creationId="{6DACF516-76D4-4AC2-AA36-EBABC3B21D72}"/>
          </ac:spMkLst>
        </pc:spChg>
        <pc:grpChg chg="add mod">
          <ac:chgData name="Chew Leng Lim" userId="f4956819b06a5395" providerId="LiveId" clId="{64D1738D-F0F2-4F33-B73E-6056640154D5}" dt="2020-04-13T09:12:31.136" v="19138" actId="164"/>
          <ac:grpSpMkLst>
            <pc:docMk/>
            <pc:sldMk cId="1306267762" sldId="343"/>
            <ac:grpSpMk id="11" creationId="{F6015B1B-AD0B-479E-9485-AA229C790B45}"/>
          </ac:grpSpMkLst>
        </pc:grpChg>
        <pc:grpChg chg="add mod">
          <ac:chgData name="Chew Leng Lim" userId="f4956819b06a5395" providerId="LiveId" clId="{64D1738D-F0F2-4F33-B73E-6056640154D5}" dt="2020-04-13T09:12:31.136" v="19138" actId="164"/>
          <ac:grpSpMkLst>
            <pc:docMk/>
            <pc:sldMk cId="1306267762" sldId="343"/>
            <ac:grpSpMk id="12" creationId="{6CDDD8DB-E687-4B9E-BB15-5400259A621F}"/>
          </ac:grpSpMkLst>
        </pc:grpChg>
        <pc:grpChg chg="add mod">
          <ac:chgData name="Chew Leng Lim" userId="f4956819b06a5395" providerId="LiveId" clId="{64D1738D-F0F2-4F33-B73E-6056640154D5}" dt="2020-04-13T09:12:31.136" v="19138" actId="164"/>
          <ac:grpSpMkLst>
            <pc:docMk/>
            <pc:sldMk cId="1306267762" sldId="343"/>
            <ac:grpSpMk id="15" creationId="{55DFF281-4D57-4EB6-8111-A8C73FD64C98}"/>
          </ac:grpSpMkLst>
        </pc:grpChg>
        <pc:grpChg chg="add mod">
          <ac:chgData name="Chew Leng Lim" userId="f4956819b06a5395" providerId="LiveId" clId="{64D1738D-F0F2-4F33-B73E-6056640154D5}" dt="2020-04-13T09:12:31.136" v="19138" actId="164"/>
          <ac:grpSpMkLst>
            <pc:docMk/>
            <pc:sldMk cId="1306267762" sldId="343"/>
            <ac:grpSpMk id="18" creationId="{2060547E-78F4-4850-BDA9-0B3143015DBC}"/>
          </ac:grpSpMkLst>
        </pc:grpChg>
        <pc:grpChg chg="add mod">
          <ac:chgData name="Chew Leng Lim" userId="f4956819b06a5395" providerId="LiveId" clId="{64D1738D-F0F2-4F33-B73E-6056640154D5}" dt="2020-04-13T09:12:31.136" v="19138" actId="164"/>
          <ac:grpSpMkLst>
            <pc:docMk/>
            <pc:sldMk cId="1306267762" sldId="343"/>
            <ac:grpSpMk id="19" creationId="{FDE03743-3E0B-4E90-A203-042B7E542B5C}"/>
          </ac:grpSpMkLst>
        </pc:grpChg>
        <pc:grpChg chg="add mod">
          <ac:chgData name="Chew Leng Lim" userId="f4956819b06a5395" providerId="LiveId" clId="{64D1738D-F0F2-4F33-B73E-6056640154D5}" dt="2020-04-13T09:12:31.136" v="19138" actId="164"/>
          <ac:grpSpMkLst>
            <pc:docMk/>
            <pc:sldMk cId="1306267762" sldId="343"/>
            <ac:grpSpMk id="20" creationId="{687B957F-12AB-43AC-92B7-B4DF79BB05EC}"/>
          </ac:grpSpMkLst>
        </pc:grpChg>
        <pc:grpChg chg="add mod">
          <ac:chgData name="Chew Leng Lim" userId="f4956819b06a5395" providerId="LiveId" clId="{64D1738D-F0F2-4F33-B73E-6056640154D5}" dt="2020-04-13T09:12:31.136" v="19138" actId="164"/>
          <ac:grpSpMkLst>
            <pc:docMk/>
            <pc:sldMk cId="1306267762" sldId="343"/>
            <ac:grpSpMk id="25" creationId="{E62CF62A-332C-426A-9C5F-B835C0DC91D7}"/>
          </ac:grpSpMkLst>
        </pc:grpChg>
        <pc:grpChg chg="add mod">
          <ac:chgData name="Chew Leng Lim" userId="f4956819b06a5395" providerId="LiveId" clId="{64D1738D-F0F2-4F33-B73E-6056640154D5}" dt="2020-04-13T09:12:31.136" v="19138" actId="164"/>
          <ac:grpSpMkLst>
            <pc:docMk/>
            <pc:sldMk cId="1306267762" sldId="343"/>
            <ac:grpSpMk id="26" creationId="{CCCCAA71-8D51-4CFC-BB65-7C69070527C6}"/>
          </ac:grpSpMkLst>
        </pc:grpChg>
        <pc:grpChg chg="add mod">
          <ac:chgData name="Chew Leng Lim" userId="f4956819b06a5395" providerId="LiveId" clId="{64D1738D-F0F2-4F33-B73E-6056640154D5}" dt="2020-04-13T09:12:31.136" v="19138" actId="164"/>
          <ac:grpSpMkLst>
            <pc:docMk/>
            <pc:sldMk cId="1306267762" sldId="343"/>
            <ac:grpSpMk id="32" creationId="{11083C9F-233D-48C4-8BF0-C61DC103C0E9}"/>
          </ac:grpSpMkLst>
        </pc:grpChg>
        <pc:grpChg chg="add mod">
          <ac:chgData name="Chew Leng Lim" userId="f4956819b06a5395" providerId="LiveId" clId="{64D1738D-F0F2-4F33-B73E-6056640154D5}" dt="2020-04-13T09:12:43.982" v="19139" actId="164"/>
          <ac:grpSpMkLst>
            <pc:docMk/>
            <pc:sldMk cId="1306267762" sldId="343"/>
            <ac:grpSpMk id="33" creationId="{F20941D4-22CA-4885-B935-4FCD3B0E217A}"/>
          </ac:grpSpMkLst>
        </pc:grpChg>
        <pc:grpChg chg="del mod">
          <ac:chgData name="Chew Leng Lim" userId="f4956819b06a5395" providerId="LiveId" clId="{64D1738D-F0F2-4F33-B73E-6056640154D5}" dt="2020-04-13T06:23:25.788" v="10412" actId="478"/>
          <ac:grpSpMkLst>
            <pc:docMk/>
            <pc:sldMk cId="1306267762" sldId="343"/>
            <ac:grpSpMk id="159" creationId="{5C788242-A179-4883-9FCD-AB635F96A044}"/>
          </ac:grpSpMkLst>
        </pc:grpChg>
        <pc:grpChg chg="add mod">
          <ac:chgData name="Chew Leng Lim" userId="f4956819b06a5395" providerId="LiveId" clId="{64D1738D-F0F2-4F33-B73E-6056640154D5}" dt="2020-04-13T09:12:19.148" v="19137" actId="1035"/>
          <ac:grpSpMkLst>
            <pc:docMk/>
            <pc:sldMk cId="1306267762" sldId="343"/>
            <ac:grpSpMk id="222" creationId="{DBDB863B-E43A-4E15-8E3E-C37AF6F58A93}"/>
          </ac:grpSpMkLst>
        </pc:grpChg>
        <pc:grpChg chg="add mod">
          <ac:chgData name="Chew Leng Lim" userId="f4956819b06a5395" providerId="LiveId" clId="{64D1738D-F0F2-4F33-B73E-6056640154D5}" dt="2020-04-13T09:12:31.136" v="19138" actId="164"/>
          <ac:grpSpMkLst>
            <pc:docMk/>
            <pc:sldMk cId="1306267762" sldId="343"/>
            <ac:grpSpMk id="228" creationId="{C1FD476B-D50E-4DD4-9F2A-AB3DD10F6FD4}"/>
          </ac:grpSpMkLst>
        </pc:grpChg>
        <pc:grpChg chg="add mod">
          <ac:chgData name="Chew Leng Lim" userId="f4956819b06a5395" providerId="LiveId" clId="{64D1738D-F0F2-4F33-B73E-6056640154D5}" dt="2020-04-13T09:12:31.136" v="19138" actId="164"/>
          <ac:grpSpMkLst>
            <pc:docMk/>
            <pc:sldMk cId="1306267762" sldId="343"/>
            <ac:grpSpMk id="229" creationId="{FF7FEE60-D342-43DE-A48D-24629238DC48}"/>
          </ac:grpSpMkLst>
        </pc:grpChg>
        <pc:grpChg chg="add mod">
          <ac:chgData name="Chew Leng Lim" userId="f4956819b06a5395" providerId="LiveId" clId="{64D1738D-F0F2-4F33-B73E-6056640154D5}" dt="2020-04-13T09:12:31.136" v="19138" actId="164"/>
          <ac:grpSpMkLst>
            <pc:docMk/>
            <pc:sldMk cId="1306267762" sldId="343"/>
            <ac:grpSpMk id="230" creationId="{84D91900-1E44-4AD5-BDAD-3C21F11B2814}"/>
          </ac:grpSpMkLst>
        </pc:grpChg>
        <pc:grpChg chg="add mod">
          <ac:chgData name="Chew Leng Lim" userId="f4956819b06a5395" providerId="LiveId" clId="{64D1738D-F0F2-4F33-B73E-6056640154D5}" dt="2020-04-13T09:12:31.136" v="19138" actId="164"/>
          <ac:grpSpMkLst>
            <pc:docMk/>
            <pc:sldMk cId="1306267762" sldId="343"/>
            <ac:grpSpMk id="231" creationId="{B583D474-82D1-41FB-9AD4-F485B497721D}"/>
          </ac:grpSpMkLst>
        </pc:grpChg>
        <pc:grpChg chg="add mod">
          <ac:chgData name="Chew Leng Lim" userId="f4956819b06a5395" providerId="LiveId" clId="{64D1738D-F0F2-4F33-B73E-6056640154D5}" dt="2020-04-13T09:12:31.136" v="19138" actId="164"/>
          <ac:grpSpMkLst>
            <pc:docMk/>
            <pc:sldMk cId="1306267762" sldId="343"/>
            <ac:grpSpMk id="232" creationId="{1D06F6DA-D384-42A1-A4EF-9BB561946ECB}"/>
          </ac:grpSpMkLst>
        </pc:grpChg>
        <pc:grpChg chg="add mod">
          <ac:chgData name="Chew Leng Lim" userId="f4956819b06a5395" providerId="LiveId" clId="{64D1738D-F0F2-4F33-B73E-6056640154D5}" dt="2020-04-13T09:12:31.136" v="19138" actId="164"/>
          <ac:grpSpMkLst>
            <pc:docMk/>
            <pc:sldMk cId="1306267762" sldId="343"/>
            <ac:grpSpMk id="233" creationId="{4D05B67F-7F21-4E92-90EF-4671955F8842}"/>
          </ac:grpSpMkLst>
        </pc:grpChg>
        <pc:grpChg chg="add mod">
          <ac:chgData name="Chew Leng Lim" userId="f4956819b06a5395" providerId="LiveId" clId="{64D1738D-F0F2-4F33-B73E-6056640154D5}" dt="2020-04-13T09:12:31.136" v="19138" actId="164"/>
          <ac:grpSpMkLst>
            <pc:docMk/>
            <pc:sldMk cId="1306267762" sldId="343"/>
            <ac:grpSpMk id="234" creationId="{A4E2FFC3-4D54-41EF-8D5B-938260780617}"/>
          </ac:grpSpMkLst>
        </pc:grpChg>
        <pc:grpChg chg="add mod">
          <ac:chgData name="Chew Leng Lim" userId="f4956819b06a5395" providerId="LiveId" clId="{64D1738D-F0F2-4F33-B73E-6056640154D5}" dt="2020-04-13T09:12:31.136" v="19138" actId="164"/>
          <ac:grpSpMkLst>
            <pc:docMk/>
            <pc:sldMk cId="1306267762" sldId="343"/>
            <ac:grpSpMk id="235" creationId="{7E9F7DC6-C60F-4E10-85E2-26F7B6BB47BE}"/>
          </ac:grpSpMkLst>
        </pc:grpChg>
        <pc:grpChg chg="add mod">
          <ac:chgData name="Chew Leng Lim" userId="f4956819b06a5395" providerId="LiveId" clId="{64D1738D-F0F2-4F33-B73E-6056640154D5}" dt="2020-04-13T09:12:31.136" v="19138" actId="164"/>
          <ac:grpSpMkLst>
            <pc:docMk/>
            <pc:sldMk cId="1306267762" sldId="343"/>
            <ac:grpSpMk id="236" creationId="{78362A5D-7AE9-41BE-8661-B553A0118123}"/>
          </ac:grpSpMkLst>
        </pc:grpChg>
        <pc:grpChg chg="add mod">
          <ac:chgData name="Chew Leng Lim" userId="f4956819b06a5395" providerId="LiveId" clId="{64D1738D-F0F2-4F33-B73E-6056640154D5}" dt="2020-04-13T09:12:31.136" v="19138" actId="164"/>
          <ac:grpSpMkLst>
            <pc:docMk/>
            <pc:sldMk cId="1306267762" sldId="343"/>
            <ac:grpSpMk id="237" creationId="{CDC22E41-F81A-4495-9402-D9D2CD6C76E0}"/>
          </ac:grpSpMkLst>
        </pc:grpChg>
        <pc:grpChg chg="add mod">
          <ac:chgData name="Chew Leng Lim" userId="f4956819b06a5395" providerId="LiveId" clId="{64D1738D-F0F2-4F33-B73E-6056640154D5}" dt="2020-04-13T09:12:31.136" v="19138" actId="164"/>
          <ac:grpSpMkLst>
            <pc:docMk/>
            <pc:sldMk cId="1306267762" sldId="343"/>
            <ac:grpSpMk id="238" creationId="{A6183CDD-72DE-42D0-A37B-5F67A008B950}"/>
          </ac:grpSpMkLst>
        </pc:grpChg>
        <pc:grpChg chg="add mod">
          <ac:chgData name="Chew Leng Lim" userId="f4956819b06a5395" providerId="LiveId" clId="{64D1738D-F0F2-4F33-B73E-6056640154D5}" dt="2020-04-13T09:12:31.136" v="19138" actId="164"/>
          <ac:grpSpMkLst>
            <pc:docMk/>
            <pc:sldMk cId="1306267762" sldId="343"/>
            <ac:grpSpMk id="239" creationId="{D6E970E6-FA85-4C89-9847-2F1A3B49C386}"/>
          </ac:grpSpMkLst>
        </pc:grpChg>
        <pc:grpChg chg="add mod">
          <ac:chgData name="Chew Leng Lim" userId="f4956819b06a5395" providerId="LiveId" clId="{64D1738D-F0F2-4F33-B73E-6056640154D5}" dt="2020-04-13T09:12:43.982" v="19139" actId="164"/>
          <ac:grpSpMkLst>
            <pc:docMk/>
            <pc:sldMk cId="1306267762" sldId="343"/>
            <ac:grpSpMk id="242" creationId="{BA6F5052-24C7-4354-A885-913C2C2B93D6}"/>
          </ac:grpSpMkLst>
        </pc:grpChg>
        <pc:grpChg chg="add mod">
          <ac:chgData name="Chew Leng Lim" userId="f4956819b06a5395" providerId="LiveId" clId="{64D1738D-F0F2-4F33-B73E-6056640154D5}" dt="2020-04-13T09:12:43.982" v="19139" actId="164"/>
          <ac:grpSpMkLst>
            <pc:docMk/>
            <pc:sldMk cId="1306267762" sldId="343"/>
            <ac:grpSpMk id="254" creationId="{CA6F0281-352D-4736-BB55-46A3335654BA}"/>
          </ac:grpSpMkLst>
        </pc:grpChg>
        <pc:grpChg chg="add mod">
          <ac:chgData name="Chew Leng Lim" userId="f4956819b06a5395" providerId="LiveId" clId="{64D1738D-F0F2-4F33-B73E-6056640154D5}" dt="2020-04-13T09:12:43.982" v="19139" actId="164"/>
          <ac:grpSpMkLst>
            <pc:docMk/>
            <pc:sldMk cId="1306267762" sldId="343"/>
            <ac:grpSpMk id="260" creationId="{0F3DBD5B-6DF5-4B69-8198-F75DFB5ED5DC}"/>
          </ac:grpSpMkLst>
        </pc:grpChg>
        <pc:grpChg chg="add mod">
          <ac:chgData name="Chew Leng Lim" userId="f4956819b06a5395" providerId="LiveId" clId="{64D1738D-F0F2-4F33-B73E-6056640154D5}" dt="2020-04-13T09:12:43.982" v="19139" actId="164"/>
          <ac:grpSpMkLst>
            <pc:docMk/>
            <pc:sldMk cId="1306267762" sldId="343"/>
            <ac:grpSpMk id="268" creationId="{C7454EE1-AC26-45E5-8317-FB7FDEA3EB90}"/>
          </ac:grpSpMkLst>
        </pc:grpChg>
        <pc:grpChg chg="add mod">
          <ac:chgData name="Chew Leng Lim" userId="f4956819b06a5395" providerId="LiveId" clId="{64D1738D-F0F2-4F33-B73E-6056640154D5}" dt="2020-04-13T09:12:43.982" v="19139" actId="164"/>
          <ac:grpSpMkLst>
            <pc:docMk/>
            <pc:sldMk cId="1306267762" sldId="343"/>
            <ac:grpSpMk id="278" creationId="{579522D5-9B33-45B0-A7C2-A1CD4600247A}"/>
          </ac:grpSpMkLst>
        </pc:grpChg>
        <pc:grpChg chg="add mod">
          <ac:chgData name="Chew Leng Lim" userId="f4956819b06a5395" providerId="LiveId" clId="{64D1738D-F0F2-4F33-B73E-6056640154D5}" dt="2020-04-13T09:12:43.982" v="19139" actId="164"/>
          <ac:grpSpMkLst>
            <pc:docMk/>
            <pc:sldMk cId="1306267762" sldId="343"/>
            <ac:grpSpMk id="284" creationId="{0AF0021F-44CF-4273-8BE2-1FD07AA9A575}"/>
          </ac:grpSpMkLst>
        </pc:grpChg>
        <pc:grpChg chg="add mod">
          <ac:chgData name="Chew Leng Lim" userId="f4956819b06a5395" providerId="LiveId" clId="{64D1738D-F0F2-4F33-B73E-6056640154D5}" dt="2020-04-13T09:12:43.982" v="19139" actId="164"/>
          <ac:grpSpMkLst>
            <pc:docMk/>
            <pc:sldMk cId="1306267762" sldId="343"/>
            <ac:grpSpMk id="290" creationId="{218AC76C-5927-4ADB-8E99-A6D5285F4398}"/>
          </ac:grpSpMkLst>
        </pc:grpChg>
        <pc:grpChg chg="add mod">
          <ac:chgData name="Chew Leng Lim" userId="f4956819b06a5395" providerId="LiveId" clId="{64D1738D-F0F2-4F33-B73E-6056640154D5}" dt="2020-04-13T09:12:43.982" v="19139" actId="164"/>
          <ac:grpSpMkLst>
            <pc:docMk/>
            <pc:sldMk cId="1306267762" sldId="343"/>
            <ac:grpSpMk id="298" creationId="{9F341B63-5C1F-4535-9A10-EF30612A0555}"/>
          </ac:grpSpMkLst>
        </pc:grpChg>
        <pc:graphicFrameChg chg="mod">
          <ac:chgData name="Chew Leng Lim" userId="f4956819b06a5395" providerId="LiveId" clId="{64D1738D-F0F2-4F33-B73E-6056640154D5}" dt="2020-04-13T08:11:07.591" v="12816" actId="164"/>
          <ac:graphicFrameMkLst>
            <pc:docMk/>
            <pc:sldMk cId="1306267762" sldId="343"/>
            <ac:graphicFrameMk id="9" creationId="{375A63CD-F656-4DBC-9E97-A61C06BB2E31}"/>
          </ac:graphicFrameMkLst>
        </pc:graphicFrameChg>
        <pc:graphicFrameChg chg="mod">
          <ac:chgData name="Chew Leng Lim" userId="f4956819b06a5395" providerId="LiveId" clId="{64D1738D-F0F2-4F33-B73E-6056640154D5}" dt="2020-04-13T08:15:59.991" v="13310" actId="164"/>
          <ac:graphicFrameMkLst>
            <pc:docMk/>
            <pc:sldMk cId="1306267762" sldId="343"/>
            <ac:graphicFrameMk id="22" creationId="{9192B6A1-B55C-48E3-9921-8CD99B6B94DA}"/>
          </ac:graphicFrameMkLst>
        </pc:graphicFrameChg>
        <pc:graphicFrameChg chg="mod">
          <ac:chgData name="Chew Leng Lim" userId="f4956819b06a5395" providerId="LiveId" clId="{64D1738D-F0F2-4F33-B73E-6056640154D5}" dt="2020-04-13T08:20:47.654" v="14122" actId="164"/>
          <ac:graphicFrameMkLst>
            <pc:docMk/>
            <pc:sldMk cId="1306267762" sldId="343"/>
            <ac:graphicFrameMk id="29" creationId="{92B9AA66-63B5-4DCD-ACF0-8CA676ECBA45}"/>
          </ac:graphicFrameMkLst>
        </pc:graphicFrameChg>
        <pc:graphicFrameChg chg="mod">
          <ac:chgData name="Chew Leng Lim" userId="f4956819b06a5395" providerId="LiveId" clId="{64D1738D-F0F2-4F33-B73E-6056640154D5}" dt="2020-04-13T08:18:23.973" v="13719" actId="164"/>
          <ac:graphicFrameMkLst>
            <pc:docMk/>
            <pc:sldMk cId="1306267762" sldId="343"/>
            <ac:graphicFrameMk id="39" creationId="{CFB8996B-BAE9-4475-9AD5-ED75A7BD9375}"/>
          </ac:graphicFrameMkLst>
        </pc:graphicFrameChg>
        <pc:graphicFrameChg chg="mod">
          <ac:chgData name="Chew Leng Lim" userId="f4956819b06a5395" providerId="LiveId" clId="{64D1738D-F0F2-4F33-B73E-6056640154D5}" dt="2020-04-13T08:11:04.454" v="12815" actId="164"/>
          <ac:graphicFrameMkLst>
            <pc:docMk/>
            <pc:sldMk cId="1306267762" sldId="343"/>
            <ac:graphicFrameMk id="48" creationId="{61777650-55B6-468A-89D8-A1A2EBDBCAEC}"/>
          </ac:graphicFrameMkLst>
        </pc:graphicFrameChg>
        <pc:graphicFrameChg chg="mod">
          <ac:chgData name="Chew Leng Lim" userId="f4956819b06a5395" providerId="LiveId" clId="{64D1738D-F0F2-4F33-B73E-6056640154D5}" dt="2020-04-13T08:15:48.797" v="13293" actId="164"/>
          <ac:graphicFrameMkLst>
            <pc:docMk/>
            <pc:sldMk cId="1306267762" sldId="343"/>
            <ac:graphicFrameMk id="62" creationId="{21841224-7521-45E0-8542-8ED7746FDC31}"/>
          </ac:graphicFrameMkLst>
        </pc:graphicFrameChg>
        <pc:graphicFrameChg chg="mod">
          <ac:chgData name="Chew Leng Lim" userId="f4956819b06a5395" providerId="LiveId" clId="{64D1738D-F0F2-4F33-B73E-6056640154D5}" dt="2020-04-13T08:20:36.043" v="14103" actId="164"/>
          <ac:graphicFrameMkLst>
            <pc:docMk/>
            <pc:sldMk cId="1306267762" sldId="343"/>
            <ac:graphicFrameMk id="69" creationId="{4C9F6713-4A5D-4F1A-B9B8-B787BDB6E6E6}"/>
          </ac:graphicFrameMkLst>
        </pc:graphicFrameChg>
        <pc:graphicFrameChg chg="mod">
          <ac:chgData name="Chew Leng Lim" userId="f4956819b06a5395" providerId="LiveId" clId="{64D1738D-F0F2-4F33-B73E-6056640154D5}" dt="2020-04-13T08:18:15.042" v="13702" actId="164"/>
          <ac:graphicFrameMkLst>
            <pc:docMk/>
            <pc:sldMk cId="1306267762" sldId="343"/>
            <ac:graphicFrameMk id="81" creationId="{C577B973-8769-497E-9527-BF70FD3C81F5}"/>
          </ac:graphicFrameMkLst>
        </pc:graphicFrameChg>
        <pc:graphicFrameChg chg="mod">
          <ac:chgData name="Chew Leng Lim" userId="f4956819b06a5395" providerId="LiveId" clId="{64D1738D-F0F2-4F33-B73E-6056640154D5}" dt="2020-04-13T08:11:01.941" v="12814" actId="164"/>
          <ac:graphicFrameMkLst>
            <pc:docMk/>
            <pc:sldMk cId="1306267762" sldId="343"/>
            <ac:graphicFrameMk id="89" creationId="{F12495DD-6928-4DC5-9F54-D9B81C965D7B}"/>
          </ac:graphicFrameMkLst>
        </pc:graphicFrameChg>
        <pc:graphicFrameChg chg="mod">
          <ac:chgData name="Chew Leng Lim" userId="f4956819b06a5395" providerId="LiveId" clId="{64D1738D-F0F2-4F33-B73E-6056640154D5}" dt="2020-04-13T08:13:36.849" v="13232" actId="164"/>
          <ac:graphicFrameMkLst>
            <pc:docMk/>
            <pc:sldMk cId="1306267762" sldId="343"/>
            <ac:graphicFrameMk id="101" creationId="{B8F94947-963D-4F88-933D-1B1963CD9073}"/>
          </ac:graphicFrameMkLst>
        </pc:graphicFrameChg>
        <pc:graphicFrameChg chg="mod">
          <ac:chgData name="Chew Leng Lim" userId="f4956819b06a5395" providerId="LiveId" clId="{64D1738D-F0F2-4F33-B73E-6056640154D5}" dt="2020-04-13T08:20:25.462" v="14083" actId="164"/>
          <ac:graphicFrameMkLst>
            <pc:docMk/>
            <pc:sldMk cId="1306267762" sldId="343"/>
            <ac:graphicFrameMk id="108" creationId="{9A7447DA-9CB3-40D0-A537-B5E2AD101C31}"/>
          </ac:graphicFrameMkLst>
        </pc:graphicFrameChg>
        <pc:graphicFrameChg chg="mod">
          <ac:chgData name="Chew Leng Lim" userId="f4956819b06a5395" providerId="LiveId" clId="{64D1738D-F0F2-4F33-B73E-6056640154D5}" dt="2020-04-13T08:18:04.267" v="13684" actId="164"/>
          <ac:graphicFrameMkLst>
            <pc:docMk/>
            <pc:sldMk cId="1306267762" sldId="343"/>
            <ac:graphicFrameMk id="118" creationId="{A42F715F-C125-4B47-A51F-0858B121F7B7}"/>
          </ac:graphicFrameMkLst>
        </pc:graphicFrameChg>
        <pc:graphicFrameChg chg="mod">
          <ac:chgData name="Chew Leng Lim" userId="f4956819b06a5395" providerId="LiveId" clId="{64D1738D-F0F2-4F33-B73E-6056640154D5}" dt="2020-04-13T08:11:11.817" v="12817" actId="164"/>
          <ac:graphicFrameMkLst>
            <pc:docMk/>
            <pc:sldMk cId="1306267762" sldId="343"/>
            <ac:graphicFrameMk id="125" creationId="{4C93C5FB-CC3C-4F3A-97B6-ED0C0E763C80}"/>
          </ac:graphicFrameMkLst>
        </pc:graphicFrameChg>
        <pc:graphicFrameChg chg="mod">
          <ac:chgData name="Chew Leng Lim" userId="f4956819b06a5395" providerId="LiveId" clId="{64D1738D-F0F2-4F33-B73E-6056640154D5}" dt="2020-04-13T08:10:59.307" v="12813" actId="164"/>
          <ac:graphicFrameMkLst>
            <pc:docMk/>
            <pc:sldMk cId="1306267762" sldId="343"/>
            <ac:graphicFrameMk id="130" creationId="{F24897CD-E322-4721-939E-E4D75D01BA58}"/>
          </ac:graphicFrameMkLst>
        </pc:graphicFrameChg>
        <pc:graphicFrameChg chg="mod">
          <ac:chgData name="Chew Leng Lim" userId="f4956819b06a5395" providerId="LiveId" clId="{64D1738D-F0F2-4F33-B73E-6056640154D5}" dt="2020-04-13T08:13:22.148" v="13213" actId="164"/>
          <ac:graphicFrameMkLst>
            <pc:docMk/>
            <pc:sldMk cId="1306267762" sldId="343"/>
            <ac:graphicFrameMk id="142" creationId="{9FDD7051-D3F9-4D7C-91C8-2C78F51E90A5}"/>
          </ac:graphicFrameMkLst>
        </pc:graphicFrameChg>
        <pc:graphicFrameChg chg="mod">
          <ac:chgData name="Chew Leng Lim" userId="f4956819b06a5395" providerId="LiveId" clId="{64D1738D-F0F2-4F33-B73E-6056640154D5}" dt="2020-04-13T08:20:16.040" v="14068" actId="164"/>
          <ac:graphicFrameMkLst>
            <pc:docMk/>
            <pc:sldMk cId="1306267762" sldId="343"/>
            <ac:graphicFrameMk id="149" creationId="{8419D0EB-134E-4ECA-AB18-8C8305154235}"/>
          </ac:graphicFrameMkLst>
        </pc:graphicFrameChg>
        <pc:graphicFrameChg chg="mod">
          <ac:chgData name="Chew Leng Lim" userId="f4956819b06a5395" providerId="LiveId" clId="{64D1738D-F0F2-4F33-B73E-6056640154D5}" dt="2020-04-13T08:17:52.291" v="13672" actId="164"/>
          <ac:graphicFrameMkLst>
            <pc:docMk/>
            <pc:sldMk cId="1306267762" sldId="343"/>
            <ac:graphicFrameMk id="160" creationId="{59BB64B7-EDD3-4AEC-B4AC-125AC3B07835}"/>
          </ac:graphicFrameMkLst>
        </pc:graphicFrameChg>
        <pc:graphicFrameChg chg="mod">
          <ac:chgData name="Chew Leng Lim" userId="f4956819b06a5395" providerId="LiveId" clId="{64D1738D-F0F2-4F33-B73E-6056640154D5}" dt="2020-04-13T08:16:10.412" v="13322" actId="164"/>
          <ac:graphicFrameMkLst>
            <pc:docMk/>
            <pc:sldMk cId="1306267762" sldId="343"/>
            <ac:graphicFrameMk id="162" creationId="{B27476D0-F5EA-4EAA-86F0-EAD21D7C2D39}"/>
          </ac:graphicFrameMkLst>
        </pc:graphicFrameChg>
        <pc:graphicFrameChg chg="mod">
          <ac:chgData name="Chew Leng Lim" userId="f4956819b06a5395" providerId="LiveId" clId="{64D1738D-F0F2-4F33-B73E-6056640154D5}" dt="2020-04-13T08:20:58.352" v="14140" actId="164"/>
          <ac:graphicFrameMkLst>
            <pc:docMk/>
            <pc:sldMk cId="1306267762" sldId="343"/>
            <ac:graphicFrameMk id="173" creationId="{0ABCEB06-8F66-42CF-B5CD-401D1A3BBC19}"/>
          </ac:graphicFrameMkLst>
        </pc:graphicFrameChg>
        <pc:graphicFrameChg chg="mod">
          <ac:chgData name="Chew Leng Lim" userId="f4956819b06a5395" providerId="LiveId" clId="{64D1738D-F0F2-4F33-B73E-6056640154D5}" dt="2020-04-13T08:18:37.115" v="13735" actId="164"/>
          <ac:graphicFrameMkLst>
            <pc:docMk/>
            <pc:sldMk cId="1306267762" sldId="343"/>
            <ac:graphicFrameMk id="179" creationId="{D3E80071-9011-4EA2-8BEB-95398F46BD4D}"/>
          </ac:graphicFrameMkLst>
        </pc:graphicFrameChg>
        <pc:graphicFrameChg chg="del mod">
          <ac:chgData name="Chew Leng Lim" userId="f4956819b06a5395" providerId="LiveId" clId="{64D1738D-F0F2-4F33-B73E-6056640154D5}" dt="2020-04-13T08:07:15.978" v="12257" actId="478"/>
          <ac:graphicFrameMkLst>
            <pc:docMk/>
            <pc:sldMk cId="1306267762" sldId="343"/>
            <ac:graphicFrameMk id="187" creationId="{7ED028A1-7FC3-40FF-B4BF-60826291F08D}"/>
          </ac:graphicFrameMkLst>
        </pc:graphicFrameChg>
        <pc:picChg chg="del mod">
          <ac:chgData name="Chew Leng Lim" userId="f4956819b06a5395" providerId="LiveId" clId="{64D1738D-F0F2-4F33-B73E-6056640154D5}" dt="2020-04-13T08:07:13.702" v="12256" actId="478"/>
          <ac:picMkLst>
            <pc:docMk/>
            <pc:sldMk cId="1306267762" sldId="343"/>
            <ac:picMk id="218" creationId="{DDC34DFB-87CC-48CC-B25A-9626100A217C}"/>
          </ac:picMkLst>
        </pc:picChg>
        <pc:cxnChg chg="mod">
          <ac:chgData name="Chew Leng Lim" userId="f4956819b06a5395" providerId="LiveId" clId="{64D1738D-F0F2-4F33-B73E-6056640154D5}" dt="2020-04-13T09:12:31.136" v="19138" actId="164"/>
          <ac:cxnSpMkLst>
            <pc:docMk/>
            <pc:sldMk cId="1306267762" sldId="343"/>
            <ac:cxnSpMk id="207" creationId="{C7CF3A41-4A22-4F9B-84DA-F035BD072310}"/>
          </ac:cxnSpMkLst>
        </pc:cxnChg>
        <pc:cxnChg chg="mod">
          <ac:chgData name="Chew Leng Lim" userId="f4956819b06a5395" providerId="LiveId" clId="{64D1738D-F0F2-4F33-B73E-6056640154D5}" dt="2020-04-13T09:12:31.136" v="19138" actId="164"/>
          <ac:cxnSpMkLst>
            <pc:docMk/>
            <pc:sldMk cId="1306267762" sldId="343"/>
            <ac:cxnSpMk id="216" creationId="{E54E1B68-3959-4B7D-B03F-D487442470C7}"/>
          </ac:cxnSpMkLst>
        </pc:cxnChg>
        <pc:cxnChg chg="add mod">
          <ac:chgData name="Chew Leng Lim" userId="f4956819b06a5395" providerId="LiveId" clId="{64D1738D-F0F2-4F33-B73E-6056640154D5}" dt="2020-04-13T09:12:31.136" v="19138" actId="164"/>
          <ac:cxnSpMkLst>
            <pc:docMk/>
            <pc:sldMk cId="1306267762" sldId="343"/>
            <ac:cxnSpMk id="240" creationId="{DA37D7E7-E603-4BAF-A51D-F8378E66EB7F}"/>
          </ac:cxnSpMkLst>
        </pc:cxnChg>
        <pc:cxnChg chg="add mod">
          <ac:chgData name="Chew Leng Lim" userId="f4956819b06a5395" providerId="LiveId" clId="{64D1738D-F0F2-4F33-B73E-6056640154D5}" dt="2020-04-13T09:12:43.982" v="19139" actId="164"/>
          <ac:cxnSpMkLst>
            <pc:docMk/>
            <pc:sldMk cId="1306267762" sldId="343"/>
            <ac:cxnSpMk id="306" creationId="{63ADFBA9-821D-416B-B613-306C63E05703}"/>
          </ac:cxnSpMkLst>
        </pc:cxnChg>
      </pc:sldChg>
      <pc:sldChg chg="addSp delSp modSp">
        <pc:chgData name="Chew Leng Lim" userId="f4956819b06a5395" providerId="LiveId" clId="{64D1738D-F0F2-4F33-B73E-6056640154D5}" dt="2020-04-13T11:56:54.678" v="34290" actId="1076"/>
        <pc:sldMkLst>
          <pc:docMk/>
          <pc:sldMk cId="835735679" sldId="362"/>
        </pc:sldMkLst>
        <pc:spChg chg="mod topLvl">
          <ac:chgData name="Chew Leng Lim" userId="f4956819b06a5395" providerId="LiveId" clId="{64D1738D-F0F2-4F33-B73E-6056640154D5}" dt="2020-04-13T06:38:23.209" v="11081" actId="1037"/>
          <ac:spMkLst>
            <pc:docMk/>
            <pc:sldMk cId="835735679" sldId="362"/>
            <ac:spMk id="29" creationId="{80B474F0-7053-43B6-BEEC-E0BE03CABCD7}"/>
          </ac:spMkLst>
        </pc:spChg>
        <pc:spChg chg="mod topLvl">
          <ac:chgData name="Chew Leng Lim" userId="f4956819b06a5395" providerId="LiveId" clId="{64D1738D-F0F2-4F33-B73E-6056640154D5}" dt="2020-04-13T06:09:00.724" v="8443" actId="164"/>
          <ac:spMkLst>
            <pc:docMk/>
            <pc:sldMk cId="835735679" sldId="362"/>
            <ac:spMk id="48" creationId="{CA838B5B-0C44-4B99-8A99-450611C3E23A}"/>
          </ac:spMkLst>
        </pc:spChg>
        <pc:spChg chg="mod topLvl">
          <ac:chgData name="Chew Leng Lim" userId="f4956819b06a5395" providerId="LiveId" clId="{64D1738D-F0F2-4F33-B73E-6056640154D5}" dt="2020-04-13T06:09:00.724" v="8443" actId="164"/>
          <ac:spMkLst>
            <pc:docMk/>
            <pc:sldMk cId="835735679" sldId="362"/>
            <ac:spMk id="49" creationId="{9E722F8C-9D6C-438D-9D36-7D1F1FABFF77}"/>
          </ac:spMkLst>
        </pc:spChg>
        <pc:spChg chg="mod topLvl">
          <ac:chgData name="Chew Leng Lim" userId="f4956819b06a5395" providerId="LiveId" clId="{64D1738D-F0F2-4F33-B73E-6056640154D5}" dt="2020-04-13T06:09:00.724" v="8443" actId="164"/>
          <ac:spMkLst>
            <pc:docMk/>
            <pc:sldMk cId="835735679" sldId="362"/>
            <ac:spMk id="50" creationId="{7C993F45-2A85-4B38-8A21-307F70B09AB7}"/>
          </ac:spMkLst>
        </pc:spChg>
        <pc:spChg chg="mod topLvl">
          <ac:chgData name="Chew Leng Lim" userId="f4956819b06a5395" providerId="LiveId" clId="{64D1738D-F0F2-4F33-B73E-6056640154D5}" dt="2020-04-13T06:09:00.724" v="8443" actId="164"/>
          <ac:spMkLst>
            <pc:docMk/>
            <pc:sldMk cId="835735679" sldId="362"/>
            <ac:spMk id="51" creationId="{4F9EE00E-64BA-4E1D-9E00-431223F78525}"/>
          </ac:spMkLst>
        </pc:spChg>
        <pc:spChg chg="mod topLvl">
          <ac:chgData name="Chew Leng Lim" userId="f4956819b06a5395" providerId="LiveId" clId="{64D1738D-F0F2-4F33-B73E-6056640154D5}" dt="2020-04-13T06:09:00.724" v="8443" actId="164"/>
          <ac:spMkLst>
            <pc:docMk/>
            <pc:sldMk cId="835735679" sldId="362"/>
            <ac:spMk id="52" creationId="{4DCB0E8E-337F-479C-88BD-33937B9ECE20}"/>
          </ac:spMkLst>
        </pc:spChg>
        <pc:spChg chg="mod topLvl">
          <ac:chgData name="Chew Leng Lim" userId="f4956819b06a5395" providerId="LiveId" clId="{64D1738D-F0F2-4F33-B73E-6056640154D5}" dt="2020-04-13T06:14:03.389" v="9328" actId="1038"/>
          <ac:spMkLst>
            <pc:docMk/>
            <pc:sldMk cId="835735679" sldId="362"/>
            <ac:spMk id="53" creationId="{47C58E3A-F3A6-4DA2-BA75-B4FBE68DEEFC}"/>
          </ac:spMkLst>
        </pc:spChg>
        <pc:spChg chg="mod topLvl">
          <ac:chgData name="Chew Leng Lim" userId="f4956819b06a5395" providerId="LiveId" clId="{64D1738D-F0F2-4F33-B73E-6056640154D5}" dt="2020-04-13T06:09:00.724" v="8443" actId="164"/>
          <ac:spMkLst>
            <pc:docMk/>
            <pc:sldMk cId="835735679" sldId="362"/>
            <ac:spMk id="54" creationId="{CE0AD4D1-4958-4B94-A24C-8FF7E0A0A778}"/>
          </ac:spMkLst>
        </pc:spChg>
        <pc:spChg chg="add mod">
          <ac:chgData name="Chew Leng Lim" userId="f4956819b06a5395" providerId="LiveId" clId="{64D1738D-F0F2-4F33-B73E-6056640154D5}" dt="2020-04-13T11:56:54.678" v="34290" actId="1076"/>
          <ac:spMkLst>
            <pc:docMk/>
            <pc:sldMk cId="835735679" sldId="362"/>
            <ac:spMk id="55" creationId="{3351F4CC-6DEC-4630-8369-CEEE768BF542}"/>
          </ac:spMkLst>
        </pc:spChg>
        <pc:spChg chg="mod">
          <ac:chgData name="Chew Leng Lim" userId="f4956819b06a5395" providerId="LiveId" clId="{64D1738D-F0F2-4F33-B73E-6056640154D5}" dt="2020-04-13T06:09:02.861" v="8444" actId="164"/>
          <ac:spMkLst>
            <pc:docMk/>
            <pc:sldMk cId="835735679" sldId="362"/>
            <ac:spMk id="56" creationId="{0E3D82E6-E9FD-478F-89C7-6556227C6924}"/>
          </ac:spMkLst>
        </pc:spChg>
        <pc:spChg chg="mod">
          <ac:chgData name="Chew Leng Lim" userId="f4956819b06a5395" providerId="LiveId" clId="{64D1738D-F0F2-4F33-B73E-6056640154D5}" dt="2020-04-13T06:09:02.861" v="8444" actId="164"/>
          <ac:spMkLst>
            <pc:docMk/>
            <pc:sldMk cId="835735679" sldId="362"/>
            <ac:spMk id="57" creationId="{91C45102-82F8-4545-BD90-6F3871037F37}"/>
          </ac:spMkLst>
        </pc:spChg>
        <pc:spChg chg="mod">
          <ac:chgData name="Chew Leng Lim" userId="f4956819b06a5395" providerId="LiveId" clId="{64D1738D-F0F2-4F33-B73E-6056640154D5}" dt="2020-04-13T06:09:02.861" v="8444" actId="164"/>
          <ac:spMkLst>
            <pc:docMk/>
            <pc:sldMk cId="835735679" sldId="362"/>
            <ac:spMk id="59" creationId="{F2255AB6-331E-460D-BDE9-318864B831EB}"/>
          </ac:spMkLst>
        </pc:spChg>
        <pc:spChg chg="mod">
          <ac:chgData name="Chew Leng Lim" userId="f4956819b06a5395" providerId="LiveId" clId="{64D1738D-F0F2-4F33-B73E-6056640154D5}" dt="2020-04-13T06:09:02.861" v="8444" actId="164"/>
          <ac:spMkLst>
            <pc:docMk/>
            <pc:sldMk cId="835735679" sldId="362"/>
            <ac:spMk id="60" creationId="{EB4759B2-DA79-4023-B080-E39BE93898C6}"/>
          </ac:spMkLst>
        </pc:spChg>
        <pc:spChg chg="add mod">
          <ac:chgData name="Chew Leng Lim" userId="f4956819b06a5395" providerId="LiveId" clId="{64D1738D-F0F2-4F33-B73E-6056640154D5}" dt="2020-04-13T11:56:54.678" v="34290" actId="1076"/>
          <ac:spMkLst>
            <pc:docMk/>
            <pc:sldMk cId="835735679" sldId="362"/>
            <ac:spMk id="61" creationId="{3C239B19-B5B1-48FA-B3D0-8D1556CF9A98}"/>
          </ac:spMkLst>
        </pc:spChg>
        <pc:spChg chg="mod">
          <ac:chgData name="Chew Leng Lim" userId="f4956819b06a5395" providerId="LiveId" clId="{64D1738D-F0F2-4F33-B73E-6056640154D5}" dt="2020-04-13T06:09:02.861" v="8444" actId="164"/>
          <ac:spMkLst>
            <pc:docMk/>
            <pc:sldMk cId="835735679" sldId="362"/>
            <ac:spMk id="62" creationId="{DB4783F4-1D8E-4D58-95F4-68B589B3B128}"/>
          </ac:spMkLst>
        </pc:spChg>
        <pc:spChg chg="add mod">
          <ac:chgData name="Chew Leng Lim" userId="f4956819b06a5395" providerId="LiveId" clId="{64D1738D-F0F2-4F33-B73E-6056640154D5}" dt="2020-04-13T11:56:54.678" v="34290" actId="1076"/>
          <ac:spMkLst>
            <pc:docMk/>
            <pc:sldMk cId="835735679" sldId="362"/>
            <ac:spMk id="63" creationId="{4001171A-B651-4EE6-9082-7891369CBD83}"/>
          </ac:spMkLst>
        </pc:spChg>
        <pc:spChg chg="add del">
          <ac:chgData name="Chew Leng Lim" userId="f4956819b06a5395" providerId="LiveId" clId="{64D1738D-F0F2-4F33-B73E-6056640154D5}" dt="2020-04-13T06:23:10.208" v="10407" actId="478"/>
          <ac:spMkLst>
            <pc:docMk/>
            <pc:sldMk cId="835735679" sldId="362"/>
            <ac:spMk id="65" creationId="{020A0F13-134C-4E7F-9D55-C5379268D78E}"/>
          </ac:spMkLst>
        </pc:spChg>
        <pc:spChg chg="add del">
          <ac:chgData name="Chew Leng Lim" userId="f4956819b06a5395" providerId="LiveId" clId="{64D1738D-F0F2-4F33-B73E-6056640154D5}" dt="2020-04-13T06:23:10.208" v="10407" actId="478"/>
          <ac:spMkLst>
            <pc:docMk/>
            <pc:sldMk cId="835735679" sldId="362"/>
            <ac:spMk id="67" creationId="{97334685-6B69-4CF6-B855-1CD8165D36B6}"/>
          </ac:spMkLst>
        </pc:spChg>
        <pc:spChg chg="mod">
          <ac:chgData name="Chew Leng Lim" userId="f4956819b06a5395" providerId="LiveId" clId="{64D1738D-F0F2-4F33-B73E-6056640154D5}" dt="2020-04-13T06:14:19.492" v="9331" actId="164"/>
          <ac:spMkLst>
            <pc:docMk/>
            <pc:sldMk cId="835735679" sldId="362"/>
            <ac:spMk id="72" creationId="{FCFEED18-EDDD-4227-A8BF-F19FAF70AE7A}"/>
          </ac:spMkLst>
        </pc:spChg>
        <pc:spChg chg="mod">
          <ac:chgData name="Chew Leng Lim" userId="f4956819b06a5395" providerId="LiveId" clId="{64D1738D-F0F2-4F33-B73E-6056640154D5}" dt="2020-04-13T06:14:19.492" v="9331" actId="164"/>
          <ac:spMkLst>
            <pc:docMk/>
            <pc:sldMk cId="835735679" sldId="362"/>
            <ac:spMk id="73" creationId="{5A0C0184-199D-42CA-9C11-64C56A75D59A}"/>
          </ac:spMkLst>
        </pc:spChg>
        <pc:spChg chg="mod">
          <ac:chgData name="Chew Leng Lim" userId="f4956819b06a5395" providerId="LiveId" clId="{64D1738D-F0F2-4F33-B73E-6056640154D5}" dt="2020-04-13T06:14:19.492" v="9331" actId="164"/>
          <ac:spMkLst>
            <pc:docMk/>
            <pc:sldMk cId="835735679" sldId="362"/>
            <ac:spMk id="74" creationId="{50660BC9-D514-43E8-8B33-A9582B7045D4}"/>
          </ac:spMkLst>
        </pc:spChg>
        <pc:spChg chg="mod">
          <ac:chgData name="Chew Leng Lim" userId="f4956819b06a5395" providerId="LiveId" clId="{64D1738D-F0F2-4F33-B73E-6056640154D5}" dt="2020-04-13T06:14:19.492" v="9331" actId="164"/>
          <ac:spMkLst>
            <pc:docMk/>
            <pc:sldMk cId="835735679" sldId="362"/>
            <ac:spMk id="75" creationId="{45D33B87-B245-494B-AC8E-6110D422AAD0}"/>
          </ac:spMkLst>
        </pc:spChg>
        <pc:spChg chg="mod">
          <ac:chgData name="Chew Leng Lim" userId="f4956819b06a5395" providerId="LiveId" clId="{64D1738D-F0F2-4F33-B73E-6056640154D5}" dt="2020-04-13T06:19:32.986" v="10152" actId="1035"/>
          <ac:spMkLst>
            <pc:docMk/>
            <pc:sldMk cId="835735679" sldId="362"/>
            <ac:spMk id="76" creationId="{EFAE1FB3-DA63-4A77-8809-8F387B1620E8}"/>
          </ac:spMkLst>
        </pc:spChg>
        <pc:spChg chg="mod">
          <ac:chgData name="Chew Leng Lim" userId="f4956819b06a5395" providerId="LiveId" clId="{64D1738D-F0F2-4F33-B73E-6056640154D5}" dt="2020-04-13T06:14:17.256" v="9330" actId="164"/>
          <ac:spMkLst>
            <pc:docMk/>
            <pc:sldMk cId="835735679" sldId="362"/>
            <ac:spMk id="94" creationId="{F41F0F44-AE5B-4099-ACFC-D1A03E658D5B}"/>
          </ac:spMkLst>
        </pc:spChg>
        <pc:spChg chg="mod">
          <ac:chgData name="Chew Leng Lim" userId="f4956819b06a5395" providerId="LiveId" clId="{64D1738D-F0F2-4F33-B73E-6056640154D5}" dt="2020-04-13T06:14:17.256" v="9330" actId="164"/>
          <ac:spMkLst>
            <pc:docMk/>
            <pc:sldMk cId="835735679" sldId="362"/>
            <ac:spMk id="95" creationId="{72E29307-07F0-4A7B-8EE4-8CD7981196E3}"/>
          </ac:spMkLst>
        </pc:spChg>
        <pc:spChg chg="mod">
          <ac:chgData name="Chew Leng Lim" userId="f4956819b06a5395" providerId="LiveId" clId="{64D1738D-F0F2-4F33-B73E-6056640154D5}" dt="2020-04-13T06:14:17.256" v="9330" actId="164"/>
          <ac:spMkLst>
            <pc:docMk/>
            <pc:sldMk cId="835735679" sldId="362"/>
            <ac:spMk id="96" creationId="{6061268A-5FE9-4677-9BAF-BD0AE4FF83C5}"/>
          </ac:spMkLst>
        </pc:spChg>
        <pc:spChg chg="mod">
          <ac:chgData name="Chew Leng Lim" userId="f4956819b06a5395" providerId="LiveId" clId="{64D1738D-F0F2-4F33-B73E-6056640154D5}" dt="2020-04-13T06:14:17.256" v="9330" actId="164"/>
          <ac:spMkLst>
            <pc:docMk/>
            <pc:sldMk cId="835735679" sldId="362"/>
            <ac:spMk id="97" creationId="{DA4774DD-C1D2-4E3B-A557-8233BCCF36DE}"/>
          </ac:spMkLst>
        </pc:spChg>
        <pc:spChg chg="mod">
          <ac:chgData name="Chew Leng Lim" userId="f4956819b06a5395" providerId="LiveId" clId="{64D1738D-F0F2-4F33-B73E-6056640154D5}" dt="2020-04-13T06:19:26.843" v="10138" actId="1036"/>
          <ac:spMkLst>
            <pc:docMk/>
            <pc:sldMk cId="835735679" sldId="362"/>
            <ac:spMk id="98" creationId="{8BED6139-9446-499E-941F-86B0168A866A}"/>
          </ac:spMkLst>
        </pc:spChg>
        <pc:spChg chg="mod">
          <ac:chgData name="Chew Leng Lim" userId="f4956819b06a5395" providerId="LiveId" clId="{64D1738D-F0F2-4F33-B73E-6056640154D5}" dt="2020-04-13T06:14:17.256" v="9330" actId="164"/>
          <ac:spMkLst>
            <pc:docMk/>
            <pc:sldMk cId="835735679" sldId="362"/>
            <ac:spMk id="99" creationId="{53B4215A-F5C8-469B-AC3E-ABB06FD4F675}"/>
          </ac:spMkLst>
        </pc:spChg>
        <pc:spChg chg="mod">
          <ac:chgData name="Chew Leng Lim" userId="f4956819b06a5395" providerId="LiveId" clId="{64D1738D-F0F2-4F33-B73E-6056640154D5}" dt="2020-04-13T06:14:19.492" v="9331" actId="164"/>
          <ac:spMkLst>
            <pc:docMk/>
            <pc:sldMk cId="835735679" sldId="362"/>
            <ac:spMk id="104" creationId="{BED65025-9C0F-4697-A02D-E514F14FE334}"/>
          </ac:spMkLst>
        </pc:spChg>
        <pc:spChg chg="mod">
          <ac:chgData name="Chew Leng Lim" userId="f4956819b06a5395" providerId="LiveId" clId="{64D1738D-F0F2-4F33-B73E-6056640154D5}" dt="2020-04-13T06:13:59.912" v="9325" actId="1038"/>
          <ac:spMkLst>
            <pc:docMk/>
            <pc:sldMk cId="835735679" sldId="362"/>
            <ac:spMk id="105" creationId="{84BB76F6-7488-4B1B-8398-4F17944D3F4E}"/>
          </ac:spMkLst>
        </pc:spChg>
        <pc:spChg chg="mod">
          <ac:chgData name="Chew Leng Lim" userId="f4956819b06a5395" providerId="LiveId" clId="{64D1738D-F0F2-4F33-B73E-6056640154D5}" dt="2020-04-13T06:14:17.256" v="9330" actId="164"/>
          <ac:spMkLst>
            <pc:docMk/>
            <pc:sldMk cId="835735679" sldId="362"/>
            <ac:spMk id="106" creationId="{AAED3BF0-D8B5-4DC1-80D6-A3CD24F2F981}"/>
          </ac:spMkLst>
        </pc:spChg>
        <pc:spChg chg="mod topLvl">
          <ac:chgData name="Chew Leng Lim" userId="f4956819b06a5395" providerId="LiveId" clId="{64D1738D-F0F2-4F33-B73E-6056640154D5}" dt="2020-04-13T06:23:12.311" v="10408" actId="164"/>
          <ac:spMkLst>
            <pc:docMk/>
            <pc:sldMk cId="835735679" sldId="362"/>
            <ac:spMk id="109" creationId="{4732DCA8-8D21-4776-B008-1FC55926C591}"/>
          </ac:spMkLst>
        </pc:spChg>
        <pc:spChg chg="mod topLvl">
          <ac:chgData name="Chew Leng Lim" userId="f4956819b06a5395" providerId="LiveId" clId="{64D1738D-F0F2-4F33-B73E-6056640154D5}" dt="2020-04-13T06:23:12.311" v="10408" actId="164"/>
          <ac:spMkLst>
            <pc:docMk/>
            <pc:sldMk cId="835735679" sldId="362"/>
            <ac:spMk id="111" creationId="{42501097-89E6-4010-838E-F3C3DC332601}"/>
          </ac:spMkLst>
        </pc:spChg>
        <pc:spChg chg="mod">
          <ac:chgData name="Chew Leng Lim" userId="f4956819b06a5395" providerId="LiveId" clId="{64D1738D-F0F2-4F33-B73E-6056640154D5}" dt="2020-04-13T06:14:13.922" v="9329" actId="164"/>
          <ac:spMkLst>
            <pc:docMk/>
            <pc:sldMk cId="835735679" sldId="362"/>
            <ac:spMk id="126" creationId="{57C803E6-3859-42AD-AD41-457AD89C0E50}"/>
          </ac:spMkLst>
        </pc:spChg>
        <pc:spChg chg="mod">
          <ac:chgData name="Chew Leng Lim" userId="f4956819b06a5395" providerId="LiveId" clId="{64D1738D-F0F2-4F33-B73E-6056640154D5}" dt="2020-04-13T06:38:30.941" v="11088" actId="1036"/>
          <ac:spMkLst>
            <pc:docMk/>
            <pc:sldMk cId="835735679" sldId="362"/>
            <ac:spMk id="127" creationId="{6D7C4176-02EB-46C9-9468-FBFA3D43A755}"/>
          </ac:spMkLst>
        </pc:spChg>
        <pc:spChg chg="mod">
          <ac:chgData name="Chew Leng Lim" userId="f4956819b06a5395" providerId="LiveId" clId="{64D1738D-F0F2-4F33-B73E-6056640154D5}" dt="2020-04-13T06:14:13.922" v="9329" actId="164"/>
          <ac:spMkLst>
            <pc:docMk/>
            <pc:sldMk cId="835735679" sldId="362"/>
            <ac:spMk id="128" creationId="{C199D322-DCAA-44BC-96A9-5F9B1446A192}"/>
          </ac:spMkLst>
        </pc:spChg>
        <pc:spChg chg="mod">
          <ac:chgData name="Chew Leng Lim" userId="f4956819b06a5395" providerId="LiveId" clId="{64D1738D-F0F2-4F33-B73E-6056640154D5}" dt="2020-04-13T06:14:13.922" v="9329" actId="164"/>
          <ac:spMkLst>
            <pc:docMk/>
            <pc:sldMk cId="835735679" sldId="362"/>
            <ac:spMk id="129" creationId="{A5CA9725-FE8B-429D-81D7-27C757107A99}"/>
          </ac:spMkLst>
        </pc:spChg>
        <pc:spChg chg="mod">
          <ac:chgData name="Chew Leng Lim" userId="f4956819b06a5395" providerId="LiveId" clId="{64D1738D-F0F2-4F33-B73E-6056640154D5}" dt="2020-04-13T06:14:13.922" v="9329" actId="164"/>
          <ac:spMkLst>
            <pc:docMk/>
            <pc:sldMk cId="835735679" sldId="362"/>
            <ac:spMk id="130" creationId="{84681A5F-CB82-41C5-A162-0B0396301698}"/>
          </ac:spMkLst>
        </pc:spChg>
        <pc:spChg chg="mod">
          <ac:chgData name="Chew Leng Lim" userId="f4956819b06a5395" providerId="LiveId" clId="{64D1738D-F0F2-4F33-B73E-6056640154D5}" dt="2020-04-13T06:14:13.922" v="9329" actId="164"/>
          <ac:spMkLst>
            <pc:docMk/>
            <pc:sldMk cId="835735679" sldId="362"/>
            <ac:spMk id="131" creationId="{44114566-6EDE-4B6C-9330-78971C8DB84A}"/>
          </ac:spMkLst>
        </pc:spChg>
        <pc:spChg chg="mod">
          <ac:chgData name="Chew Leng Lim" userId="f4956819b06a5395" providerId="LiveId" clId="{64D1738D-F0F2-4F33-B73E-6056640154D5}" dt="2020-04-13T06:14:13.922" v="9329" actId="164"/>
          <ac:spMkLst>
            <pc:docMk/>
            <pc:sldMk cId="835735679" sldId="362"/>
            <ac:spMk id="132" creationId="{4DC00B12-906C-482B-8252-BC087618A830}"/>
          </ac:spMkLst>
        </pc:spChg>
        <pc:spChg chg="mod">
          <ac:chgData name="Chew Leng Lim" userId="f4956819b06a5395" providerId="LiveId" clId="{64D1738D-F0F2-4F33-B73E-6056640154D5}" dt="2020-04-13T11:56:29.742" v="34280" actId="1037"/>
          <ac:spMkLst>
            <pc:docMk/>
            <pc:sldMk cId="835735679" sldId="362"/>
            <ac:spMk id="133" creationId="{4361BD0E-5CC3-4379-A90C-5F770BCDFA9B}"/>
          </ac:spMkLst>
        </pc:spChg>
        <pc:spChg chg="mod">
          <ac:chgData name="Chew Leng Lim" userId="f4956819b06a5395" providerId="LiveId" clId="{64D1738D-F0F2-4F33-B73E-6056640154D5}" dt="2020-04-13T11:55:48.449" v="34236" actId="20577"/>
          <ac:spMkLst>
            <pc:docMk/>
            <pc:sldMk cId="835735679" sldId="362"/>
            <ac:spMk id="151" creationId="{25A1AB35-BF14-4722-8AD9-BA0B4BD22EB0}"/>
          </ac:spMkLst>
        </pc:spChg>
        <pc:spChg chg="mod">
          <ac:chgData name="Chew Leng Lim" userId="f4956819b06a5395" providerId="LiveId" clId="{64D1738D-F0F2-4F33-B73E-6056640154D5}" dt="2020-04-13T11:56:54.678" v="34290" actId="1076"/>
          <ac:spMkLst>
            <pc:docMk/>
            <pc:sldMk cId="835735679" sldId="362"/>
            <ac:spMk id="155" creationId="{F40DB2B2-E67B-4811-8A1C-9CE4F6533071}"/>
          </ac:spMkLst>
        </pc:spChg>
        <pc:spChg chg="mod">
          <ac:chgData name="Chew Leng Lim" userId="f4956819b06a5395" providerId="LiveId" clId="{64D1738D-F0F2-4F33-B73E-6056640154D5}" dt="2020-04-13T11:56:54.678" v="34290" actId="1076"/>
          <ac:spMkLst>
            <pc:docMk/>
            <pc:sldMk cId="835735679" sldId="362"/>
            <ac:spMk id="156" creationId="{443C59FA-09C1-4D6E-9C3B-ABA2B24404F9}"/>
          </ac:spMkLst>
        </pc:spChg>
        <pc:spChg chg="mod">
          <ac:chgData name="Chew Leng Lim" userId="f4956819b06a5395" providerId="LiveId" clId="{64D1738D-F0F2-4F33-B73E-6056640154D5}" dt="2020-04-13T11:56:54.678" v="34290" actId="1076"/>
          <ac:spMkLst>
            <pc:docMk/>
            <pc:sldMk cId="835735679" sldId="362"/>
            <ac:spMk id="157" creationId="{5BA6D875-C8DB-4382-AD9B-53EF47958091}"/>
          </ac:spMkLst>
        </pc:spChg>
        <pc:spChg chg="mod">
          <ac:chgData name="Chew Leng Lim" userId="f4956819b06a5395" providerId="LiveId" clId="{64D1738D-F0F2-4F33-B73E-6056640154D5}" dt="2020-04-13T11:56:54.678" v="34290" actId="1076"/>
          <ac:spMkLst>
            <pc:docMk/>
            <pc:sldMk cId="835735679" sldId="362"/>
            <ac:spMk id="158" creationId="{13D8758B-FD49-4F90-A7BF-5B864E52FF81}"/>
          </ac:spMkLst>
        </pc:spChg>
        <pc:spChg chg="mod">
          <ac:chgData name="Chew Leng Lim" userId="f4956819b06a5395" providerId="LiveId" clId="{64D1738D-F0F2-4F33-B73E-6056640154D5}" dt="2020-04-13T11:56:54.678" v="34290" actId="1076"/>
          <ac:spMkLst>
            <pc:docMk/>
            <pc:sldMk cId="835735679" sldId="362"/>
            <ac:spMk id="159" creationId="{EC06AE8E-61F9-42C8-A7D9-4C112E77E053}"/>
          </ac:spMkLst>
        </pc:spChg>
        <pc:grpChg chg="add del mod">
          <ac:chgData name="Chew Leng Lim" userId="f4956819b06a5395" providerId="LiveId" clId="{64D1738D-F0F2-4F33-B73E-6056640154D5}" dt="2020-04-13T06:08:46.140" v="8403" actId="165"/>
          <ac:grpSpMkLst>
            <pc:docMk/>
            <pc:sldMk cId="835735679" sldId="362"/>
            <ac:grpSpMk id="2" creationId="{B7DC4238-9434-4095-9D16-1AF4E2F7DD16}"/>
          </ac:grpSpMkLst>
        </pc:grpChg>
        <pc:grpChg chg="add mod">
          <ac:chgData name="Chew Leng Lim" userId="f4956819b06a5395" providerId="LiveId" clId="{64D1738D-F0F2-4F33-B73E-6056640154D5}" dt="2020-04-13T11:56:54.678" v="34290" actId="1076"/>
          <ac:grpSpMkLst>
            <pc:docMk/>
            <pc:sldMk cId="835735679" sldId="362"/>
            <ac:grpSpMk id="5" creationId="{512B117C-3DA9-44B7-A8F5-E55DEB8E38A5}"/>
          </ac:grpSpMkLst>
        </pc:grpChg>
        <pc:grpChg chg="add mod">
          <ac:chgData name="Chew Leng Lim" userId="f4956819b06a5395" providerId="LiveId" clId="{64D1738D-F0F2-4F33-B73E-6056640154D5}" dt="2020-04-13T11:56:54.678" v="34290" actId="1076"/>
          <ac:grpSpMkLst>
            <pc:docMk/>
            <pc:sldMk cId="835735679" sldId="362"/>
            <ac:grpSpMk id="7" creationId="{6EEC3F94-B29B-4B47-A2BE-B1ACB678E0B3}"/>
          </ac:grpSpMkLst>
        </pc:grpChg>
        <pc:grpChg chg="add mod">
          <ac:chgData name="Chew Leng Lim" userId="f4956819b06a5395" providerId="LiveId" clId="{64D1738D-F0F2-4F33-B73E-6056640154D5}" dt="2020-04-13T11:56:54.678" v="34290" actId="1076"/>
          <ac:grpSpMkLst>
            <pc:docMk/>
            <pc:sldMk cId="835735679" sldId="362"/>
            <ac:grpSpMk id="8" creationId="{C89526AB-1D4D-4289-A419-74BED20FA6BA}"/>
          </ac:grpSpMkLst>
        </pc:grpChg>
        <pc:grpChg chg="add mod">
          <ac:chgData name="Chew Leng Lim" userId="f4956819b06a5395" providerId="LiveId" clId="{64D1738D-F0F2-4F33-B73E-6056640154D5}" dt="2020-04-13T11:56:54.678" v="34290" actId="1076"/>
          <ac:grpSpMkLst>
            <pc:docMk/>
            <pc:sldMk cId="835735679" sldId="362"/>
            <ac:grpSpMk id="10" creationId="{109D38F5-C04A-49FF-819D-1C990051EC23}"/>
          </ac:grpSpMkLst>
        </pc:grpChg>
        <pc:grpChg chg="add mod">
          <ac:chgData name="Chew Leng Lim" userId="f4956819b06a5395" providerId="LiveId" clId="{64D1738D-F0F2-4F33-B73E-6056640154D5}" dt="2020-04-13T11:56:54.678" v="34290" actId="1076"/>
          <ac:grpSpMkLst>
            <pc:docMk/>
            <pc:sldMk cId="835735679" sldId="362"/>
            <ac:grpSpMk id="11" creationId="{11847A7F-A6B6-4D3D-9DC0-4ECCD5449E90}"/>
          </ac:grpSpMkLst>
        </pc:grpChg>
        <pc:grpChg chg="add mod">
          <ac:chgData name="Chew Leng Lim" userId="f4956819b06a5395" providerId="LiveId" clId="{64D1738D-F0F2-4F33-B73E-6056640154D5}" dt="2020-04-13T11:56:54.678" v="34290" actId="1076"/>
          <ac:grpSpMkLst>
            <pc:docMk/>
            <pc:sldMk cId="835735679" sldId="362"/>
            <ac:grpSpMk id="12" creationId="{564779E6-83FD-4354-B94C-D0E24CBC0AD8}"/>
          </ac:grpSpMkLst>
        </pc:grpChg>
        <pc:grpChg chg="del mod">
          <ac:chgData name="Chew Leng Lim" userId="f4956819b06a5395" providerId="LiveId" clId="{64D1738D-F0F2-4F33-B73E-6056640154D5}" dt="2020-04-13T06:22:08.745" v="10358" actId="165"/>
          <ac:grpSpMkLst>
            <pc:docMk/>
            <pc:sldMk cId="835735679" sldId="362"/>
            <ac:grpSpMk id="103" creationId="{D6B54850-C8E8-408A-9922-F52A3F11B422}"/>
          </ac:grpSpMkLst>
        </pc:grpChg>
        <pc:graphicFrameChg chg="mod topLvl">
          <ac:chgData name="Chew Leng Lim" userId="f4956819b06a5395" providerId="LiveId" clId="{64D1738D-F0F2-4F33-B73E-6056640154D5}" dt="2020-04-13T06:09:00.724" v="8443" actId="164"/>
          <ac:graphicFrameMkLst>
            <pc:docMk/>
            <pc:sldMk cId="835735679" sldId="362"/>
            <ac:graphicFrameMk id="3" creationId="{6F8B8A1E-B820-47CA-8D30-AAAB5FF8645E}"/>
          </ac:graphicFrameMkLst>
        </pc:graphicFrameChg>
        <pc:graphicFrameChg chg="mod">
          <ac:chgData name="Chew Leng Lim" userId="f4956819b06a5395" providerId="LiveId" clId="{64D1738D-F0F2-4F33-B73E-6056640154D5}" dt="2020-04-13T06:09:02.861" v="8444" actId="164"/>
          <ac:graphicFrameMkLst>
            <pc:docMk/>
            <pc:sldMk cId="835735679" sldId="362"/>
            <ac:graphicFrameMk id="4" creationId="{563EC79B-9AC0-49DC-9447-7C68610E8D0F}"/>
          </ac:graphicFrameMkLst>
        </pc:graphicFrameChg>
        <pc:graphicFrameChg chg="mod">
          <ac:chgData name="Chew Leng Lim" userId="f4956819b06a5395" providerId="LiveId" clId="{64D1738D-F0F2-4F33-B73E-6056640154D5}" dt="2020-04-13T06:14:19.492" v="9331" actId="164"/>
          <ac:graphicFrameMkLst>
            <pc:docMk/>
            <pc:sldMk cId="835735679" sldId="362"/>
            <ac:graphicFrameMk id="6" creationId="{6014448D-0B98-4534-929C-E4E8AB99E2B7}"/>
          </ac:graphicFrameMkLst>
        </pc:graphicFrameChg>
        <pc:graphicFrameChg chg="mod">
          <ac:chgData name="Chew Leng Lim" userId="f4956819b06a5395" providerId="LiveId" clId="{64D1738D-F0F2-4F33-B73E-6056640154D5}" dt="2020-04-13T06:14:17.256" v="9330" actId="164"/>
          <ac:graphicFrameMkLst>
            <pc:docMk/>
            <pc:sldMk cId="835735679" sldId="362"/>
            <ac:graphicFrameMk id="9" creationId="{53803493-0463-4DB9-BB49-2A61F67C7666}"/>
          </ac:graphicFrameMkLst>
        </pc:graphicFrameChg>
        <pc:graphicFrameChg chg="mod">
          <ac:chgData name="Chew Leng Lim" userId="f4956819b06a5395" providerId="LiveId" clId="{64D1738D-F0F2-4F33-B73E-6056640154D5}" dt="2020-04-13T06:14:13.922" v="9329" actId="164"/>
          <ac:graphicFrameMkLst>
            <pc:docMk/>
            <pc:sldMk cId="835735679" sldId="362"/>
            <ac:graphicFrameMk id="125" creationId="{429450BC-E6FA-4849-8420-37A9105A7399}"/>
          </ac:graphicFrameMkLst>
        </pc:graphicFrameChg>
        <pc:picChg chg="add del">
          <ac:chgData name="Chew Leng Lim" userId="f4956819b06a5395" providerId="LiveId" clId="{64D1738D-F0F2-4F33-B73E-6056640154D5}" dt="2020-04-13T06:23:10.208" v="10407" actId="478"/>
          <ac:picMkLst>
            <pc:docMk/>
            <pc:sldMk cId="835735679" sldId="362"/>
            <ac:picMk id="64" creationId="{8FDF446A-CBF6-44B8-B2CC-16E97631DCDD}"/>
          </ac:picMkLst>
        </pc:picChg>
        <pc:picChg chg="add del">
          <ac:chgData name="Chew Leng Lim" userId="f4956819b06a5395" providerId="LiveId" clId="{64D1738D-F0F2-4F33-B73E-6056640154D5}" dt="2020-04-13T06:23:10.208" v="10407" actId="478"/>
          <ac:picMkLst>
            <pc:docMk/>
            <pc:sldMk cId="835735679" sldId="362"/>
            <ac:picMk id="66" creationId="{F0FF6D85-530F-473D-B432-13756FCEF451}"/>
          </ac:picMkLst>
        </pc:picChg>
        <pc:picChg chg="mod topLvl">
          <ac:chgData name="Chew Leng Lim" userId="f4956819b06a5395" providerId="LiveId" clId="{64D1738D-F0F2-4F33-B73E-6056640154D5}" dt="2020-04-13T06:23:12.311" v="10408" actId="164"/>
          <ac:picMkLst>
            <pc:docMk/>
            <pc:sldMk cId="835735679" sldId="362"/>
            <ac:picMk id="108" creationId="{6BD0AE93-26D8-4938-8D21-2A1FCDDAB9C7}"/>
          </ac:picMkLst>
        </pc:picChg>
        <pc:picChg chg="mod topLvl">
          <ac:chgData name="Chew Leng Lim" userId="f4956819b06a5395" providerId="LiveId" clId="{64D1738D-F0F2-4F33-B73E-6056640154D5}" dt="2020-04-13T06:23:12.311" v="10408" actId="164"/>
          <ac:picMkLst>
            <pc:docMk/>
            <pc:sldMk cId="835735679" sldId="362"/>
            <ac:picMk id="110" creationId="{E77512DB-AA7F-4727-9464-680B94992651}"/>
          </ac:picMkLst>
        </pc:picChg>
      </pc:sldChg>
      <pc:sldChg chg="addSp delSp modSp">
        <pc:chgData name="Chew Leng Lim" userId="f4956819b06a5395" providerId="LiveId" clId="{64D1738D-F0F2-4F33-B73E-6056640154D5}" dt="2020-04-13T11:55:33.162" v="34234" actId="20577"/>
        <pc:sldMkLst>
          <pc:docMk/>
          <pc:sldMk cId="3170069621" sldId="364"/>
        </pc:sldMkLst>
        <pc:spChg chg="mod">
          <ac:chgData name="Chew Leng Lim" userId="f4956819b06a5395" providerId="LiveId" clId="{64D1738D-F0F2-4F33-B73E-6056640154D5}" dt="2020-04-13T11:55:33.162" v="34234" actId="20577"/>
          <ac:spMkLst>
            <pc:docMk/>
            <pc:sldMk cId="3170069621" sldId="364"/>
            <ac:spMk id="56" creationId="{64C060FB-CAF9-4F7D-9505-A6240E94336C}"/>
          </ac:spMkLst>
        </pc:spChg>
        <pc:spChg chg="mod topLvl">
          <ac:chgData name="Chew Leng Lim" userId="f4956819b06a5395" providerId="LiveId" clId="{64D1738D-F0F2-4F33-B73E-6056640154D5}" dt="2020-04-13T09:33:49.919" v="20053" actId="164"/>
          <ac:spMkLst>
            <pc:docMk/>
            <pc:sldMk cId="3170069621" sldId="364"/>
            <ac:spMk id="65" creationId="{51118955-5CEA-4259-BE09-D15FF1FCCB8D}"/>
          </ac:spMkLst>
        </pc:spChg>
        <pc:spChg chg="mod topLvl">
          <ac:chgData name="Chew Leng Lim" userId="f4956819b06a5395" providerId="LiveId" clId="{64D1738D-F0F2-4F33-B73E-6056640154D5}" dt="2020-04-13T09:33:49.919" v="20053" actId="164"/>
          <ac:spMkLst>
            <pc:docMk/>
            <pc:sldMk cId="3170069621" sldId="364"/>
            <ac:spMk id="66" creationId="{0FDC31F0-45B2-498E-AD21-48D798A5E95F}"/>
          </ac:spMkLst>
        </pc:spChg>
        <pc:spChg chg="mod topLvl">
          <ac:chgData name="Chew Leng Lim" userId="f4956819b06a5395" providerId="LiveId" clId="{64D1738D-F0F2-4F33-B73E-6056640154D5}" dt="2020-04-13T09:33:49.919" v="20053" actId="164"/>
          <ac:spMkLst>
            <pc:docMk/>
            <pc:sldMk cId="3170069621" sldId="364"/>
            <ac:spMk id="67" creationId="{84E19F47-2AA5-442A-A609-B59620732631}"/>
          </ac:spMkLst>
        </pc:spChg>
        <pc:spChg chg="mod topLvl">
          <ac:chgData name="Chew Leng Lim" userId="f4956819b06a5395" providerId="LiveId" clId="{64D1738D-F0F2-4F33-B73E-6056640154D5}" dt="2020-04-13T09:33:49.919" v="20053" actId="164"/>
          <ac:spMkLst>
            <pc:docMk/>
            <pc:sldMk cId="3170069621" sldId="364"/>
            <ac:spMk id="72" creationId="{FEA7F284-341D-4D5E-8F7D-2CB66B932815}"/>
          </ac:spMkLst>
        </pc:spChg>
        <pc:spChg chg="mod topLvl">
          <ac:chgData name="Chew Leng Lim" userId="f4956819b06a5395" providerId="LiveId" clId="{64D1738D-F0F2-4F33-B73E-6056640154D5}" dt="2020-04-13T09:35:56.709" v="20232" actId="164"/>
          <ac:spMkLst>
            <pc:docMk/>
            <pc:sldMk cId="3170069621" sldId="364"/>
            <ac:spMk id="79" creationId="{9AE754B4-53A6-4F2D-ACB3-9A010F3673F3}"/>
          </ac:spMkLst>
        </pc:spChg>
        <pc:spChg chg="mod topLvl">
          <ac:chgData name="Chew Leng Lim" userId="f4956819b06a5395" providerId="LiveId" clId="{64D1738D-F0F2-4F33-B73E-6056640154D5}" dt="2020-04-13T09:35:56.709" v="20232" actId="164"/>
          <ac:spMkLst>
            <pc:docMk/>
            <pc:sldMk cId="3170069621" sldId="364"/>
            <ac:spMk id="80" creationId="{A4320EE2-CED6-409D-8312-800D621906CB}"/>
          </ac:spMkLst>
        </pc:spChg>
        <pc:spChg chg="mod topLvl">
          <ac:chgData name="Chew Leng Lim" userId="f4956819b06a5395" providerId="LiveId" clId="{64D1738D-F0F2-4F33-B73E-6056640154D5}" dt="2020-04-13T09:35:56.709" v="20232" actId="164"/>
          <ac:spMkLst>
            <pc:docMk/>
            <pc:sldMk cId="3170069621" sldId="364"/>
            <ac:spMk id="81" creationId="{05BF436C-FFEE-40A9-9879-301B7802CE5D}"/>
          </ac:spMkLst>
        </pc:spChg>
        <pc:spChg chg="mod topLvl">
          <ac:chgData name="Chew Leng Lim" userId="f4956819b06a5395" providerId="LiveId" clId="{64D1738D-F0F2-4F33-B73E-6056640154D5}" dt="2020-04-13T09:35:56.709" v="20232" actId="164"/>
          <ac:spMkLst>
            <pc:docMk/>
            <pc:sldMk cId="3170069621" sldId="364"/>
            <ac:spMk id="82" creationId="{ADE28946-EF79-44A5-8A49-ADB78A17999A}"/>
          </ac:spMkLst>
        </pc:spChg>
        <pc:spChg chg="mod topLvl">
          <ac:chgData name="Chew Leng Lim" userId="f4956819b06a5395" providerId="LiveId" clId="{64D1738D-F0F2-4F33-B73E-6056640154D5}" dt="2020-04-13T09:35:56.709" v="20232" actId="164"/>
          <ac:spMkLst>
            <pc:docMk/>
            <pc:sldMk cId="3170069621" sldId="364"/>
            <ac:spMk id="83" creationId="{220FC59B-1454-460C-B56B-55782C8310AD}"/>
          </ac:spMkLst>
        </pc:spChg>
        <pc:spChg chg="mod topLvl">
          <ac:chgData name="Chew Leng Lim" userId="f4956819b06a5395" providerId="LiveId" clId="{64D1738D-F0F2-4F33-B73E-6056640154D5}" dt="2020-04-13T09:35:56.709" v="20232" actId="164"/>
          <ac:spMkLst>
            <pc:docMk/>
            <pc:sldMk cId="3170069621" sldId="364"/>
            <ac:spMk id="84" creationId="{FEA0804C-714C-420E-A79C-58F40A1E6341}"/>
          </ac:spMkLst>
        </pc:spChg>
        <pc:spChg chg="mod topLvl">
          <ac:chgData name="Chew Leng Lim" userId="f4956819b06a5395" providerId="LiveId" clId="{64D1738D-F0F2-4F33-B73E-6056640154D5}" dt="2020-04-13T09:35:56.709" v="20232" actId="164"/>
          <ac:spMkLst>
            <pc:docMk/>
            <pc:sldMk cId="3170069621" sldId="364"/>
            <ac:spMk id="85" creationId="{B52AFFCD-5B72-4D6D-8BF6-BF06FEAD0794}"/>
          </ac:spMkLst>
        </pc:spChg>
        <pc:spChg chg="mod topLvl">
          <ac:chgData name="Chew Leng Lim" userId="f4956819b06a5395" providerId="LiveId" clId="{64D1738D-F0F2-4F33-B73E-6056640154D5}" dt="2020-04-13T09:33:49.919" v="20053" actId="164"/>
          <ac:spMkLst>
            <pc:docMk/>
            <pc:sldMk cId="3170069621" sldId="364"/>
            <ac:spMk id="88" creationId="{100B61FB-5B88-4C86-83BA-FB34B07ED47F}"/>
          </ac:spMkLst>
        </pc:spChg>
        <pc:spChg chg="mod topLvl">
          <ac:chgData name="Chew Leng Lim" userId="f4956819b06a5395" providerId="LiveId" clId="{64D1738D-F0F2-4F33-B73E-6056640154D5}" dt="2020-04-13T09:33:49.919" v="20053" actId="164"/>
          <ac:spMkLst>
            <pc:docMk/>
            <pc:sldMk cId="3170069621" sldId="364"/>
            <ac:spMk id="91" creationId="{DEBDA7CD-F771-47BA-A2BC-7A8B3B53EC24}"/>
          </ac:spMkLst>
        </pc:spChg>
        <pc:spChg chg="mod topLvl">
          <ac:chgData name="Chew Leng Lim" userId="f4956819b06a5395" providerId="LiveId" clId="{64D1738D-F0F2-4F33-B73E-6056640154D5}" dt="2020-04-13T09:33:49.919" v="20053" actId="164"/>
          <ac:spMkLst>
            <pc:docMk/>
            <pc:sldMk cId="3170069621" sldId="364"/>
            <ac:spMk id="94" creationId="{C61327E2-9672-4FB6-8985-C50DD5038801}"/>
          </ac:spMkLst>
        </pc:spChg>
        <pc:spChg chg="mod">
          <ac:chgData name="Chew Leng Lim" userId="f4956819b06a5395" providerId="LiveId" clId="{64D1738D-F0F2-4F33-B73E-6056640154D5}" dt="2020-04-13T09:45:14.505" v="21242" actId="164"/>
          <ac:spMkLst>
            <pc:docMk/>
            <pc:sldMk cId="3170069621" sldId="364"/>
            <ac:spMk id="99" creationId="{409E17C7-4701-44C6-B5FE-79CD980A027A}"/>
          </ac:spMkLst>
        </pc:spChg>
        <pc:spChg chg="mod">
          <ac:chgData name="Chew Leng Lim" userId="f4956819b06a5395" providerId="LiveId" clId="{64D1738D-F0F2-4F33-B73E-6056640154D5}" dt="2020-04-13T09:45:14.505" v="21242" actId="164"/>
          <ac:spMkLst>
            <pc:docMk/>
            <pc:sldMk cId="3170069621" sldId="364"/>
            <ac:spMk id="100" creationId="{77A1BF7F-C15B-42D9-B89C-31DC4683950F}"/>
          </ac:spMkLst>
        </pc:spChg>
        <pc:spChg chg="mod topLvl">
          <ac:chgData name="Chew Leng Lim" userId="f4956819b06a5395" providerId="LiveId" clId="{64D1738D-F0F2-4F33-B73E-6056640154D5}" dt="2020-04-13T09:33:49.919" v="20053" actId="164"/>
          <ac:spMkLst>
            <pc:docMk/>
            <pc:sldMk cId="3170069621" sldId="364"/>
            <ac:spMk id="101" creationId="{066E0809-B785-42C2-8F7D-3C932CB8EC80}"/>
          </ac:spMkLst>
        </pc:spChg>
        <pc:spChg chg="mod">
          <ac:chgData name="Chew Leng Lim" userId="f4956819b06a5395" providerId="LiveId" clId="{64D1738D-F0F2-4F33-B73E-6056640154D5}" dt="2020-04-13T10:09:42.317" v="23485" actId="1036"/>
          <ac:spMkLst>
            <pc:docMk/>
            <pc:sldMk cId="3170069621" sldId="364"/>
            <ac:spMk id="102" creationId="{8E4BDA1A-96E2-4679-99CC-0ECA28BC0CF2}"/>
          </ac:spMkLst>
        </pc:spChg>
        <pc:spChg chg="mod topLvl">
          <ac:chgData name="Chew Leng Lim" userId="f4956819b06a5395" providerId="LiveId" clId="{64D1738D-F0F2-4F33-B73E-6056640154D5}" dt="2020-04-13T10:09:42.317" v="23485" actId="1036"/>
          <ac:spMkLst>
            <pc:docMk/>
            <pc:sldMk cId="3170069621" sldId="364"/>
            <ac:spMk id="103" creationId="{C247B8A6-F80F-4607-97E7-BF3DE8217AE9}"/>
          </ac:spMkLst>
        </pc:spChg>
        <pc:spChg chg="mod topLvl">
          <ac:chgData name="Chew Leng Lim" userId="f4956819b06a5395" providerId="LiveId" clId="{64D1738D-F0F2-4F33-B73E-6056640154D5}" dt="2020-04-13T10:09:42.317" v="23485" actId="1036"/>
          <ac:spMkLst>
            <pc:docMk/>
            <pc:sldMk cId="3170069621" sldId="364"/>
            <ac:spMk id="104" creationId="{1E3F0FFD-9EBD-43E1-AD5E-D20282C9ED3C}"/>
          </ac:spMkLst>
        </pc:spChg>
        <pc:spChg chg="mod">
          <ac:chgData name="Chew Leng Lim" userId="f4956819b06a5395" providerId="LiveId" clId="{64D1738D-F0F2-4F33-B73E-6056640154D5}" dt="2020-04-13T09:45:14.505" v="21242" actId="164"/>
          <ac:spMkLst>
            <pc:docMk/>
            <pc:sldMk cId="3170069621" sldId="364"/>
            <ac:spMk id="106" creationId="{7CBBA212-157F-484E-A1CB-98B408BC79D1}"/>
          </ac:spMkLst>
        </pc:spChg>
        <pc:spChg chg="mod">
          <ac:chgData name="Chew Leng Lim" userId="f4956819b06a5395" providerId="LiveId" clId="{64D1738D-F0F2-4F33-B73E-6056640154D5}" dt="2020-04-13T09:45:14.505" v="21242" actId="164"/>
          <ac:spMkLst>
            <pc:docMk/>
            <pc:sldMk cId="3170069621" sldId="364"/>
            <ac:spMk id="110" creationId="{3B16565B-F1AA-4A9C-9F74-E95366F50B58}"/>
          </ac:spMkLst>
        </pc:spChg>
        <pc:spChg chg="mod">
          <ac:chgData name="Chew Leng Lim" userId="f4956819b06a5395" providerId="LiveId" clId="{64D1738D-F0F2-4F33-B73E-6056640154D5}" dt="2020-04-13T09:45:14.505" v="21242" actId="164"/>
          <ac:spMkLst>
            <pc:docMk/>
            <pc:sldMk cId="3170069621" sldId="364"/>
            <ac:spMk id="113" creationId="{A191C67F-7F2A-42F8-A013-1B80C96D81C3}"/>
          </ac:spMkLst>
        </pc:spChg>
        <pc:spChg chg="mod">
          <ac:chgData name="Chew Leng Lim" userId="f4956819b06a5395" providerId="LiveId" clId="{64D1738D-F0F2-4F33-B73E-6056640154D5}" dt="2020-04-13T09:45:14.505" v="21242" actId="164"/>
          <ac:spMkLst>
            <pc:docMk/>
            <pc:sldMk cId="3170069621" sldId="364"/>
            <ac:spMk id="116" creationId="{C4ECC555-00EE-4577-9671-B421BF499D59}"/>
          </ac:spMkLst>
        </pc:spChg>
        <pc:spChg chg="mod">
          <ac:chgData name="Chew Leng Lim" userId="f4956819b06a5395" providerId="LiveId" clId="{64D1738D-F0F2-4F33-B73E-6056640154D5}" dt="2020-04-13T09:45:14.505" v="21242" actId="164"/>
          <ac:spMkLst>
            <pc:docMk/>
            <pc:sldMk cId="3170069621" sldId="364"/>
            <ac:spMk id="117" creationId="{CC828BE9-FAF4-45D2-B912-B7C3A46B3652}"/>
          </ac:spMkLst>
        </pc:spChg>
        <pc:spChg chg="mod">
          <ac:chgData name="Chew Leng Lim" userId="f4956819b06a5395" providerId="LiveId" clId="{64D1738D-F0F2-4F33-B73E-6056640154D5}" dt="2020-04-13T09:45:14.505" v="21242" actId="164"/>
          <ac:spMkLst>
            <pc:docMk/>
            <pc:sldMk cId="3170069621" sldId="364"/>
            <ac:spMk id="119" creationId="{C3DA5CD0-1840-4E81-A049-2728C24657B6}"/>
          </ac:spMkLst>
        </pc:spChg>
        <pc:spChg chg="mod">
          <ac:chgData name="Chew Leng Lim" userId="f4956819b06a5395" providerId="LiveId" clId="{64D1738D-F0F2-4F33-B73E-6056640154D5}" dt="2020-04-13T09:45:14.505" v="21242" actId="164"/>
          <ac:spMkLst>
            <pc:docMk/>
            <pc:sldMk cId="3170069621" sldId="364"/>
            <ac:spMk id="120" creationId="{3D6F10CC-8C3A-4686-9C97-4FFF097757A5}"/>
          </ac:spMkLst>
        </pc:spChg>
        <pc:spChg chg="mod">
          <ac:chgData name="Chew Leng Lim" userId="f4956819b06a5395" providerId="LiveId" clId="{64D1738D-F0F2-4F33-B73E-6056640154D5}" dt="2020-04-13T09:45:14.505" v="21242" actId="164"/>
          <ac:spMkLst>
            <pc:docMk/>
            <pc:sldMk cId="3170069621" sldId="364"/>
            <ac:spMk id="122" creationId="{7A7375FD-5A12-4910-AE0F-3791FB45CC54}"/>
          </ac:spMkLst>
        </pc:spChg>
        <pc:spChg chg="mod">
          <ac:chgData name="Chew Leng Lim" userId="f4956819b06a5395" providerId="LiveId" clId="{64D1738D-F0F2-4F33-B73E-6056640154D5}" dt="2020-04-13T09:45:14.505" v="21242" actId="164"/>
          <ac:spMkLst>
            <pc:docMk/>
            <pc:sldMk cId="3170069621" sldId="364"/>
            <ac:spMk id="123" creationId="{E7EE2B5B-589A-4FDA-A432-640FBFFE7203}"/>
          </ac:spMkLst>
        </pc:spChg>
        <pc:spChg chg="mod">
          <ac:chgData name="Chew Leng Lim" userId="f4956819b06a5395" providerId="LiveId" clId="{64D1738D-F0F2-4F33-B73E-6056640154D5}" dt="2020-04-13T09:45:14.505" v="21242" actId="164"/>
          <ac:spMkLst>
            <pc:docMk/>
            <pc:sldMk cId="3170069621" sldId="364"/>
            <ac:spMk id="124" creationId="{6539115E-152F-4214-9251-60A33465A958}"/>
          </ac:spMkLst>
        </pc:spChg>
        <pc:spChg chg="mod">
          <ac:chgData name="Chew Leng Lim" userId="f4956819b06a5395" providerId="LiveId" clId="{64D1738D-F0F2-4F33-B73E-6056640154D5}" dt="2020-04-13T10:14:28.655" v="24140" actId="1038"/>
          <ac:spMkLst>
            <pc:docMk/>
            <pc:sldMk cId="3170069621" sldId="364"/>
            <ac:spMk id="125" creationId="{A98501AB-76C5-4F4D-A654-ABD2B10B4038}"/>
          </ac:spMkLst>
        </pc:spChg>
        <pc:spChg chg="mod">
          <ac:chgData name="Chew Leng Lim" userId="f4956819b06a5395" providerId="LiveId" clId="{64D1738D-F0F2-4F33-B73E-6056640154D5}" dt="2020-04-13T09:45:14.505" v="21242" actId="164"/>
          <ac:spMkLst>
            <pc:docMk/>
            <pc:sldMk cId="3170069621" sldId="364"/>
            <ac:spMk id="126" creationId="{AACB294E-CFB5-4A7C-9DAC-FFEBEA043380}"/>
          </ac:spMkLst>
        </pc:spChg>
        <pc:spChg chg="mod">
          <ac:chgData name="Chew Leng Lim" userId="f4956819b06a5395" providerId="LiveId" clId="{64D1738D-F0F2-4F33-B73E-6056640154D5}" dt="2020-04-13T09:35:05.676" v="20208" actId="164"/>
          <ac:spMkLst>
            <pc:docMk/>
            <pc:sldMk cId="3170069621" sldId="364"/>
            <ac:spMk id="131" creationId="{94AAE797-FD82-41E4-AFE6-601483E66DD3}"/>
          </ac:spMkLst>
        </pc:spChg>
        <pc:spChg chg="mod">
          <ac:chgData name="Chew Leng Lim" userId="f4956819b06a5395" providerId="LiveId" clId="{64D1738D-F0F2-4F33-B73E-6056640154D5}" dt="2020-04-13T09:35:05.676" v="20208" actId="164"/>
          <ac:spMkLst>
            <pc:docMk/>
            <pc:sldMk cId="3170069621" sldId="364"/>
            <ac:spMk id="132" creationId="{28CBF801-9630-47FA-BB44-BF212F28CF7A}"/>
          </ac:spMkLst>
        </pc:spChg>
        <pc:spChg chg="mod">
          <ac:chgData name="Chew Leng Lim" userId="f4956819b06a5395" providerId="LiveId" clId="{64D1738D-F0F2-4F33-B73E-6056640154D5}" dt="2020-04-13T09:35:05.676" v="20208" actId="164"/>
          <ac:spMkLst>
            <pc:docMk/>
            <pc:sldMk cId="3170069621" sldId="364"/>
            <ac:spMk id="133" creationId="{A54618D4-5108-4637-8260-132C6933E66D}"/>
          </ac:spMkLst>
        </pc:spChg>
        <pc:spChg chg="mod">
          <ac:chgData name="Chew Leng Lim" userId="f4956819b06a5395" providerId="LiveId" clId="{64D1738D-F0F2-4F33-B73E-6056640154D5}" dt="2020-04-13T09:35:05.676" v="20208" actId="164"/>
          <ac:spMkLst>
            <pc:docMk/>
            <pc:sldMk cId="3170069621" sldId="364"/>
            <ac:spMk id="134" creationId="{938B83F6-1F12-45E7-8488-56F13BE4D487}"/>
          </ac:spMkLst>
        </pc:spChg>
        <pc:spChg chg="mod">
          <ac:chgData name="Chew Leng Lim" userId="f4956819b06a5395" providerId="LiveId" clId="{64D1738D-F0F2-4F33-B73E-6056640154D5}" dt="2020-04-13T09:35:05.676" v="20208" actId="164"/>
          <ac:spMkLst>
            <pc:docMk/>
            <pc:sldMk cId="3170069621" sldId="364"/>
            <ac:spMk id="135" creationId="{551CA3DB-4791-4718-A79D-A46F7ECFEE86}"/>
          </ac:spMkLst>
        </pc:spChg>
        <pc:spChg chg="mod">
          <ac:chgData name="Chew Leng Lim" userId="f4956819b06a5395" providerId="LiveId" clId="{64D1738D-F0F2-4F33-B73E-6056640154D5}" dt="2020-04-13T09:35:05.676" v="20208" actId="164"/>
          <ac:spMkLst>
            <pc:docMk/>
            <pc:sldMk cId="3170069621" sldId="364"/>
            <ac:spMk id="136" creationId="{EC074743-2914-4992-A941-2F1BA626D848}"/>
          </ac:spMkLst>
        </pc:spChg>
        <pc:spChg chg="mod">
          <ac:chgData name="Chew Leng Lim" userId="f4956819b06a5395" providerId="LiveId" clId="{64D1738D-F0F2-4F33-B73E-6056640154D5}" dt="2020-04-13T09:35:05.676" v="20208" actId="164"/>
          <ac:spMkLst>
            <pc:docMk/>
            <pc:sldMk cId="3170069621" sldId="364"/>
            <ac:spMk id="137" creationId="{CAD06FCB-01FE-4E62-BBC0-97AE69A15A43}"/>
          </ac:spMkLst>
        </pc:spChg>
        <pc:spChg chg="mod">
          <ac:chgData name="Chew Leng Lim" userId="f4956819b06a5395" providerId="LiveId" clId="{64D1738D-F0F2-4F33-B73E-6056640154D5}" dt="2020-04-13T09:35:05.676" v="20208" actId="164"/>
          <ac:spMkLst>
            <pc:docMk/>
            <pc:sldMk cId="3170069621" sldId="364"/>
            <ac:spMk id="138" creationId="{077D57F7-325C-4B28-A082-87810B9BDEA5}"/>
          </ac:spMkLst>
        </pc:spChg>
        <pc:spChg chg="mod">
          <ac:chgData name="Chew Leng Lim" userId="f4956819b06a5395" providerId="LiveId" clId="{64D1738D-F0F2-4F33-B73E-6056640154D5}" dt="2020-04-13T09:35:05.676" v="20208" actId="164"/>
          <ac:spMkLst>
            <pc:docMk/>
            <pc:sldMk cId="3170069621" sldId="364"/>
            <ac:spMk id="139" creationId="{29C789A1-D1DF-4A19-8EF2-C5BB4E312888}"/>
          </ac:spMkLst>
        </pc:spChg>
        <pc:spChg chg="mod">
          <ac:chgData name="Chew Leng Lim" userId="f4956819b06a5395" providerId="LiveId" clId="{64D1738D-F0F2-4F33-B73E-6056640154D5}" dt="2020-04-13T10:15:00.491" v="24176" actId="1036"/>
          <ac:spMkLst>
            <pc:docMk/>
            <pc:sldMk cId="3170069621" sldId="364"/>
            <ac:spMk id="140" creationId="{634A8DC0-F68E-4EA3-B026-BE5B09BCD85A}"/>
          </ac:spMkLst>
        </pc:spChg>
        <pc:spChg chg="mod">
          <ac:chgData name="Chew Leng Lim" userId="f4956819b06a5395" providerId="LiveId" clId="{64D1738D-F0F2-4F33-B73E-6056640154D5}" dt="2020-04-13T09:45:14.505" v="21242" actId="164"/>
          <ac:spMkLst>
            <pc:docMk/>
            <pc:sldMk cId="3170069621" sldId="364"/>
            <ac:spMk id="141" creationId="{68E790DC-44D9-4B05-83EB-CA3CC9DDDFDD}"/>
          </ac:spMkLst>
        </pc:spChg>
        <pc:spChg chg="mod">
          <ac:chgData name="Chew Leng Lim" userId="f4956819b06a5395" providerId="LiveId" clId="{64D1738D-F0F2-4F33-B73E-6056640154D5}" dt="2020-04-13T09:35:05.676" v="20208" actId="164"/>
          <ac:spMkLst>
            <pc:docMk/>
            <pc:sldMk cId="3170069621" sldId="364"/>
            <ac:spMk id="142" creationId="{551DA58D-A36C-4A0C-B930-CFFEB558F6D0}"/>
          </ac:spMkLst>
        </pc:spChg>
        <pc:spChg chg="mod">
          <ac:chgData name="Chew Leng Lim" userId="f4956819b06a5395" providerId="LiveId" clId="{64D1738D-F0F2-4F33-B73E-6056640154D5}" dt="2020-04-13T09:35:05.676" v="20208" actId="164"/>
          <ac:spMkLst>
            <pc:docMk/>
            <pc:sldMk cId="3170069621" sldId="364"/>
            <ac:spMk id="143" creationId="{E994F8BB-655A-4907-AE17-84AE22109E0C}"/>
          </ac:spMkLst>
        </pc:spChg>
        <pc:spChg chg="mod">
          <ac:chgData name="Chew Leng Lim" userId="f4956819b06a5395" providerId="LiveId" clId="{64D1738D-F0F2-4F33-B73E-6056640154D5}" dt="2020-04-13T09:56:21.334" v="22517" actId="1036"/>
          <ac:spMkLst>
            <pc:docMk/>
            <pc:sldMk cId="3170069621" sldId="364"/>
            <ac:spMk id="145" creationId="{741555F6-F794-4E7F-A3BC-30794F2E65E9}"/>
          </ac:spMkLst>
        </pc:spChg>
        <pc:spChg chg="mod">
          <ac:chgData name="Chew Leng Lim" userId="f4956819b06a5395" providerId="LiveId" clId="{64D1738D-F0F2-4F33-B73E-6056640154D5}" dt="2020-04-13T09:56:23.505" v="22518" actId="1036"/>
          <ac:spMkLst>
            <pc:docMk/>
            <pc:sldMk cId="3170069621" sldId="364"/>
            <ac:spMk id="147" creationId="{E0F47861-C836-4616-83F5-295EEE1E65F8}"/>
          </ac:spMkLst>
        </pc:spChg>
        <pc:spChg chg="mod">
          <ac:chgData name="Chew Leng Lim" userId="f4956819b06a5395" providerId="LiveId" clId="{64D1738D-F0F2-4F33-B73E-6056640154D5}" dt="2020-04-13T09:35:05.676" v="20208" actId="164"/>
          <ac:spMkLst>
            <pc:docMk/>
            <pc:sldMk cId="3170069621" sldId="364"/>
            <ac:spMk id="149" creationId="{03C362FA-A0C6-4E4C-ABFA-DA0546011237}"/>
          </ac:spMkLst>
        </pc:spChg>
        <pc:spChg chg="mod topLvl">
          <ac:chgData name="Chew Leng Lim" userId="f4956819b06a5395" providerId="LiveId" clId="{64D1738D-F0F2-4F33-B73E-6056640154D5}" dt="2020-04-13T09:33:49.919" v="20053" actId="164"/>
          <ac:spMkLst>
            <pc:docMk/>
            <pc:sldMk cId="3170069621" sldId="364"/>
            <ac:spMk id="151" creationId="{2CD06626-C54C-4E7F-B2C2-8D77314B1DF3}"/>
          </ac:spMkLst>
        </pc:spChg>
        <pc:spChg chg="mod">
          <ac:chgData name="Chew Leng Lim" userId="f4956819b06a5395" providerId="LiveId" clId="{64D1738D-F0F2-4F33-B73E-6056640154D5}" dt="2020-04-13T09:35:05.676" v="20208" actId="164"/>
          <ac:spMkLst>
            <pc:docMk/>
            <pc:sldMk cId="3170069621" sldId="364"/>
            <ac:spMk id="152" creationId="{49D6FB6F-A982-4F92-BE44-957435B8EB41}"/>
          </ac:spMkLst>
        </pc:spChg>
        <pc:spChg chg="mod topLvl">
          <ac:chgData name="Chew Leng Lim" userId="f4956819b06a5395" providerId="LiveId" clId="{64D1738D-F0F2-4F33-B73E-6056640154D5}" dt="2020-04-13T10:50:24.166" v="27875" actId="20577"/>
          <ac:spMkLst>
            <pc:docMk/>
            <pc:sldMk cId="3170069621" sldId="364"/>
            <ac:spMk id="153" creationId="{D5A04AA4-64A2-47CD-961C-067C7F85C20E}"/>
          </ac:spMkLst>
        </pc:spChg>
        <pc:spChg chg="mod">
          <ac:chgData name="Chew Leng Lim" userId="f4956819b06a5395" providerId="LiveId" clId="{64D1738D-F0F2-4F33-B73E-6056640154D5}" dt="2020-04-13T10:50:29.729" v="27877" actId="20577"/>
          <ac:spMkLst>
            <pc:docMk/>
            <pc:sldMk cId="3170069621" sldId="364"/>
            <ac:spMk id="154" creationId="{999F4F04-28D8-4AB7-9E89-97F945F4EF68}"/>
          </ac:spMkLst>
        </pc:spChg>
        <pc:spChg chg="mod">
          <ac:chgData name="Chew Leng Lim" userId="f4956819b06a5395" providerId="LiveId" clId="{64D1738D-F0F2-4F33-B73E-6056640154D5}" dt="2020-04-13T09:35:05.676" v="20208" actId="164"/>
          <ac:spMkLst>
            <pc:docMk/>
            <pc:sldMk cId="3170069621" sldId="364"/>
            <ac:spMk id="155" creationId="{B965E252-32A2-4382-90B7-7498A3B3EC20}"/>
          </ac:spMkLst>
        </pc:spChg>
        <pc:spChg chg="mod">
          <ac:chgData name="Chew Leng Lim" userId="f4956819b06a5395" providerId="LiveId" clId="{64D1738D-F0F2-4F33-B73E-6056640154D5}" dt="2020-04-13T09:35:05.676" v="20208" actId="164"/>
          <ac:spMkLst>
            <pc:docMk/>
            <pc:sldMk cId="3170069621" sldId="364"/>
            <ac:spMk id="156" creationId="{B294435A-49F1-497C-B7A3-8E0E1924F5D2}"/>
          </ac:spMkLst>
        </pc:spChg>
        <pc:spChg chg="mod topLvl">
          <ac:chgData name="Chew Leng Lim" userId="f4956819b06a5395" providerId="LiveId" clId="{64D1738D-F0F2-4F33-B73E-6056640154D5}" dt="2020-04-13T09:52:24.850" v="22188" actId="164"/>
          <ac:spMkLst>
            <pc:docMk/>
            <pc:sldMk cId="3170069621" sldId="364"/>
            <ac:spMk id="158" creationId="{058580B5-AF37-4A35-B7A5-576F3D49B991}"/>
          </ac:spMkLst>
        </pc:spChg>
        <pc:spChg chg="mod topLvl">
          <ac:chgData name="Chew Leng Lim" userId="f4956819b06a5395" providerId="LiveId" clId="{64D1738D-F0F2-4F33-B73E-6056640154D5}" dt="2020-04-13T09:52:24.850" v="22188" actId="164"/>
          <ac:spMkLst>
            <pc:docMk/>
            <pc:sldMk cId="3170069621" sldId="364"/>
            <ac:spMk id="159" creationId="{779A73BD-0CBF-4F7F-B4AC-4583C4017F41}"/>
          </ac:spMkLst>
        </pc:spChg>
        <pc:spChg chg="mod topLvl">
          <ac:chgData name="Chew Leng Lim" userId="f4956819b06a5395" providerId="LiveId" clId="{64D1738D-F0F2-4F33-B73E-6056640154D5}" dt="2020-04-13T09:52:24.850" v="22188" actId="164"/>
          <ac:spMkLst>
            <pc:docMk/>
            <pc:sldMk cId="3170069621" sldId="364"/>
            <ac:spMk id="160" creationId="{D9AC1CD2-99C6-412C-B508-A7A17BB74DF9}"/>
          </ac:spMkLst>
        </pc:spChg>
        <pc:spChg chg="mod topLvl">
          <ac:chgData name="Chew Leng Lim" userId="f4956819b06a5395" providerId="LiveId" clId="{64D1738D-F0F2-4F33-B73E-6056640154D5}" dt="2020-04-13T09:52:24.850" v="22188" actId="164"/>
          <ac:spMkLst>
            <pc:docMk/>
            <pc:sldMk cId="3170069621" sldId="364"/>
            <ac:spMk id="161" creationId="{280FA2A3-3132-42C9-877E-0BC412FD3754}"/>
          </ac:spMkLst>
        </pc:spChg>
        <pc:spChg chg="mod">
          <ac:chgData name="Chew Leng Lim" userId="f4956819b06a5395" providerId="LiveId" clId="{64D1738D-F0F2-4F33-B73E-6056640154D5}" dt="2020-04-13T09:35:05.676" v="20208" actId="164"/>
          <ac:spMkLst>
            <pc:docMk/>
            <pc:sldMk cId="3170069621" sldId="364"/>
            <ac:spMk id="162" creationId="{B3230BA5-3634-4690-8B35-BC78764AB246}"/>
          </ac:spMkLst>
        </pc:spChg>
        <pc:spChg chg="mod topLvl">
          <ac:chgData name="Chew Leng Lim" userId="f4956819b06a5395" providerId="LiveId" clId="{64D1738D-F0F2-4F33-B73E-6056640154D5}" dt="2020-04-13T09:52:24.850" v="22188" actId="164"/>
          <ac:spMkLst>
            <pc:docMk/>
            <pc:sldMk cId="3170069621" sldId="364"/>
            <ac:spMk id="163" creationId="{F4A1BE81-D9F5-4800-AF07-5871ABE43025}"/>
          </ac:spMkLst>
        </pc:spChg>
        <pc:spChg chg="add mod">
          <ac:chgData name="Chew Leng Lim" userId="f4956819b06a5395" providerId="LiveId" clId="{64D1738D-F0F2-4F33-B73E-6056640154D5}" dt="2020-04-13T10:09:42.317" v="23485" actId="1036"/>
          <ac:spMkLst>
            <pc:docMk/>
            <pc:sldMk cId="3170069621" sldId="364"/>
            <ac:spMk id="164" creationId="{43210DBF-F4B3-41FA-B19A-2CC6591358B4}"/>
          </ac:spMkLst>
        </pc:spChg>
        <pc:spChg chg="mod topLvl">
          <ac:chgData name="Chew Leng Lim" userId="f4956819b06a5395" providerId="LiveId" clId="{64D1738D-F0F2-4F33-B73E-6056640154D5}" dt="2020-04-13T09:33:49.919" v="20053" actId="164"/>
          <ac:spMkLst>
            <pc:docMk/>
            <pc:sldMk cId="3170069621" sldId="364"/>
            <ac:spMk id="168" creationId="{540D2FB4-3171-404E-A96A-03A72B4DBF39}"/>
          </ac:spMkLst>
        </pc:spChg>
        <pc:spChg chg="del mod">
          <ac:chgData name="Chew Leng Lim" userId="f4956819b06a5395" providerId="LiveId" clId="{64D1738D-F0F2-4F33-B73E-6056640154D5}" dt="2020-04-13T09:44:26.120" v="20899" actId="478"/>
          <ac:spMkLst>
            <pc:docMk/>
            <pc:sldMk cId="3170069621" sldId="364"/>
            <ac:spMk id="169" creationId="{08257E8E-FA50-4ACF-BF4C-96BE939A05C4}"/>
          </ac:spMkLst>
        </pc:spChg>
        <pc:spChg chg="del mod">
          <ac:chgData name="Chew Leng Lim" userId="f4956819b06a5395" providerId="LiveId" clId="{64D1738D-F0F2-4F33-B73E-6056640154D5}" dt="2020-04-13T09:44:26.120" v="20899" actId="478"/>
          <ac:spMkLst>
            <pc:docMk/>
            <pc:sldMk cId="3170069621" sldId="364"/>
            <ac:spMk id="172" creationId="{6EE5C238-4380-49DA-B295-8C828D09C735}"/>
          </ac:spMkLst>
        </pc:spChg>
        <pc:spChg chg="del mod">
          <ac:chgData name="Chew Leng Lim" userId="f4956819b06a5395" providerId="LiveId" clId="{64D1738D-F0F2-4F33-B73E-6056640154D5}" dt="2020-04-13T09:44:26.120" v="20899" actId="478"/>
          <ac:spMkLst>
            <pc:docMk/>
            <pc:sldMk cId="3170069621" sldId="364"/>
            <ac:spMk id="173" creationId="{943584EA-499C-43A2-9B6E-012A65FD769C}"/>
          </ac:spMkLst>
        </pc:spChg>
        <pc:spChg chg="del mod">
          <ac:chgData name="Chew Leng Lim" userId="f4956819b06a5395" providerId="LiveId" clId="{64D1738D-F0F2-4F33-B73E-6056640154D5}" dt="2020-04-13T09:44:26.120" v="20899" actId="478"/>
          <ac:spMkLst>
            <pc:docMk/>
            <pc:sldMk cId="3170069621" sldId="364"/>
            <ac:spMk id="174" creationId="{807B200E-0F80-4EE9-8C6E-C0E6060F3D15}"/>
          </ac:spMkLst>
        </pc:spChg>
        <pc:spChg chg="del mod">
          <ac:chgData name="Chew Leng Lim" userId="f4956819b06a5395" providerId="LiveId" clId="{64D1738D-F0F2-4F33-B73E-6056640154D5}" dt="2020-04-13T09:44:26.120" v="20899" actId="478"/>
          <ac:spMkLst>
            <pc:docMk/>
            <pc:sldMk cId="3170069621" sldId="364"/>
            <ac:spMk id="175" creationId="{AF64334C-A116-405E-B7D9-7B3BD798198F}"/>
          </ac:spMkLst>
        </pc:spChg>
        <pc:spChg chg="del mod">
          <ac:chgData name="Chew Leng Lim" userId="f4956819b06a5395" providerId="LiveId" clId="{64D1738D-F0F2-4F33-B73E-6056640154D5}" dt="2020-04-13T09:44:26.120" v="20899" actId="478"/>
          <ac:spMkLst>
            <pc:docMk/>
            <pc:sldMk cId="3170069621" sldId="364"/>
            <ac:spMk id="176" creationId="{8FA410D4-1F28-438D-9FAE-AD52EF8EABF6}"/>
          </ac:spMkLst>
        </pc:spChg>
        <pc:spChg chg="mod topLvl">
          <ac:chgData name="Chew Leng Lim" userId="f4956819b06a5395" providerId="LiveId" clId="{64D1738D-F0F2-4F33-B73E-6056640154D5}" dt="2020-04-13T09:56:30.153" v="22519" actId="1036"/>
          <ac:spMkLst>
            <pc:docMk/>
            <pc:sldMk cId="3170069621" sldId="364"/>
            <ac:spMk id="179" creationId="{83A5CF1E-565D-49AD-A079-DA3917B6A4BB}"/>
          </ac:spMkLst>
        </pc:spChg>
        <pc:spChg chg="mod topLvl">
          <ac:chgData name="Chew Leng Lim" userId="f4956819b06a5395" providerId="LiveId" clId="{64D1738D-F0F2-4F33-B73E-6056640154D5}" dt="2020-04-13T09:52:24.850" v="22188" actId="164"/>
          <ac:spMkLst>
            <pc:docMk/>
            <pc:sldMk cId="3170069621" sldId="364"/>
            <ac:spMk id="180" creationId="{E2A6E13E-3143-4125-B32B-6228EC70865B}"/>
          </ac:spMkLst>
        </pc:spChg>
        <pc:spChg chg="mod topLvl">
          <ac:chgData name="Chew Leng Lim" userId="f4956819b06a5395" providerId="LiveId" clId="{64D1738D-F0F2-4F33-B73E-6056640154D5}" dt="2020-04-13T09:58:10.322" v="22532" actId="1035"/>
          <ac:spMkLst>
            <pc:docMk/>
            <pc:sldMk cId="3170069621" sldId="364"/>
            <ac:spMk id="184" creationId="{24219249-6E98-495B-9B89-A8390676B630}"/>
          </ac:spMkLst>
        </pc:spChg>
        <pc:spChg chg="mod">
          <ac:chgData name="Chew Leng Lim" userId="f4956819b06a5395" providerId="LiveId" clId="{64D1738D-F0F2-4F33-B73E-6056640154D5}" dt="2020-04-13T09:52:20.450" v="22187" actId="164"/>
          <ac:spMkLst>
            <pc:docMk/>
            <pc:sldMk cId="3170069621" sldId="364"/>
            <ac:spMk id="190" creationId="{5A3D3865-61DF-4B21-A513-493BF72A4E2F}"/>
          </ac:spMkLst>
        </pc:spChg>
        <pc:spChg chg="mod">
          <ac:chgData name="Chew Leng Lim" userId="f4956819b06a5395" providerId="LiveId" clId="{64D1738D-F0F2-4F33-B73E-6056640154D5}" dt="2020-04-13T09:52:20.450" v="22187" actId="164"/>
          <ac:spMkLst>
            <pc:docMk/>
            <pc:sldMk cId="3170069621" sldId="364"/>
            <ac:spMk id="191" creationId="{50CD04FA-9313-4F79-85B9-C604FA620F55}"/>
          </ac:spMkLst>
        </pc:spChg>
        <pc:spChg chg="mod">
          <ac:chgData name="Chew Leng Lim" userId="f4956819b06a5395" providerId="LiveId" clId="{64D1738D-F0F2-4F33-B73E-6056640154D5}" dt="2020-04-13T09:52:20.450" v="22187" actId="164"/>
          <ac:spMkLst>
            <pc:docMk/>
            <pc:sldMk cId="3170069621" sldId="364"/>
            <ac:spMk id="192" creationId="{276D8CDA-0629-455A-BE86-1E6604D17AC3}"/>
          </ac:spMkLst>
        </pc:spChg>
        <pc:spChg chg="mod">
          <ac:chgData name="Chew Leng Lim" userId="f4956819b06a5395" providerId="LiveId" clId="{64D1738D-F0F2-4F33-B73E-6056640154D5}" dt="2020-04-13T09:52:20.450" v="22187" actId="164"/>
          <ac:spMkLst>
            <pc:docMk/>
            <pc:sldMk cId="3170069621" sldId="364"/>
            <ac:spMk id="193" creationId="{D9479CC2-3AFE-429B-B9CB-6EDFABDBADB5}"/>
          </ac:spMkLst>
        </pc:spChg>
        <pc:spChg chg="del mod">
          <ac:chgData name="Chew Leng Lim" userId="f4956819b06a5395" providerId="LiveId" clId="{64D1738D-F0F2-4F33-B73E-6056640154D5}" dt="2020-04-13T09:44:26.120" v="20899" actId="478"/>
          <ac:spMkLst>
            <pc:docMk/>
            <pc:sldMk cId="3170069621" sldId="364"/>
            <ac:spMk id="194" creationId="{E54F6718-7BAD-4C35-8BC9-099745D43FD9}"/>
          </ac:spMkLst>
        </pc:spChg>
        <pc:spChg chg="del mod">
          <ac:chgData name="Chew Leng Lim" userId="f4956819b06a5395" providerId="LiveId" clId="{64D1738D-F0F2-4F33-B73E-6056640154D5}" dt="2020-04-13T09:44:26.120" v="20899" actId="478"/>
          <ac:spMkLst>
            <pc:docMk/>
            <pc:sldMk cId="3170069621" sldId="364"/>
            <ac:spMk id="195" creationId="{A7556020-405A-4312-83B8-290F22F9316E}"/>
          </ac:spMkLst>
        </pc:spChg>
        <pc:spChg chg="del mod">
          <ac:chgData name="Chew Leng Lim" userId="f4956819b06a5395" providerId="LiveId" clId="{64D1738D-F0F2-4F33-B73E-6056640154D5}" dt="2020-04-13T09:44:26.120" v="20899" actId="478"/>
          <ac:spMkLst>
            <pc:docMk/>
            <pc:sldMk cId="3170069621" sldId="364"/>
            <ac:spMk id="196" creationId="{A971748D-6DC8-441B-B3A4-4EC5E2513F05}"/>
          </ac:spMkLst>
        </pc:spChg>
        <pc:spChg chg="del mod">
          <ac:chgData name="Chew Leng Lim" userId="f4956819b06a5395" providerId="LiveId" clId="{64D1738D-F0F2-4F33-B73E-6056640154D5}" dt="2020-04-13T09:44:26.120" v="20899" actId="478"/>
          <ac:spMkLst>
            <pc:docMk/>
            <pc:sldMk cId="3170069621" sldId="364"/>
            <ac:spMk id="197" creationId="{17A1789D-838E-4275-AC1D-36C4DA5091CD}"/>
          </ac:spMkLst>
        </pc:spChg>
        <pc:spChg chg="del mod">
          <ac:chgData name="Chew Leng Lim" userId="f4956819b06a5395" providerId="LiveId" clId="{64D1738D-F0F2-4F33-B73E-6056640154D5}" dt="2020-04-13T09:44:26.120" v="20899" actId="478"/>
          <ac:spMkLst>
            <pc:docMk/>
            <pc:sldMk cId="3170069621" sldId="364"/>
            <ac:spMk id="198" creationId="{0F0803D5-C42A-4847-8BAC-103C46F232D8}"/>
          </ac:spMkLst>
        </pc:spChg>
        <pc:spChg chg="del mod">
          <ac:chgData name="Chew Leng Lim" userId="f4956819b06a5395" providerId="LiveId" clId="{64D1738D-F0F2-4F33-B73E-6056640154D5}" dt="2020-04-13T09:44:26.120" v="20899" actId="478"/>
          <ac:spMkLst>
            <pc:docMk/>
            <pc:sldMk cId="3170069621" sldId="364"/>
            <ac:spMk id="199" creationId="{BF69A443-C15A-43E2-BA6E-BB6C14C165E5}"/>
          </ac:spMkLst>
        </pc:spChg>
        <pc:spChg chg="del mod">
          <ac:chgData name="Chew Leng Lim" userId="f4956819b06a5395" providerId="LiveId" clId="{64D1738D-F0F2-4F33-B73E-6056640154D5}" dt="2020-04-13T09:51:53.132" v="22053" actId="478"/>
          <ac:spMkLst>
            <pc:docMk/>
            <pc:sldMk cId="3170069621" sldId="364"/>
            <ac:spMk id="203" creationId="{8F77818A-02A3-4C21-9056-46897183C8B2}"/>
          </ac:spMkLst>
        </pc:spChg>
        <pc:spChg chg="del mod">
          <ac:chgData name="Chew Leng Lim" userId="f4956819b06a5395" providerId="LiveId" clId="{64D1738D-F0F2-4F33-B73E-6056640154D5}" dt="2020-04-13T09:51:53.132" v="22053" actId="478"/>
          <ac:spMkLst>
            <pc:docMk/>
            <pc:sldMk cId="3170069621" sldId="364"/>
            <ac:spMk id="204" creationId="{ED323F9B-4949-4226-B8C4-EF3B3A08AA2E}"/>
          </ac:spMkLst>
        </pc:spChg>
        <pc:spChg chg="mod">
          <ac:chgData name="Chew Leng Lim" userId="f4956819b06a5395" providerId="LiveId" clId="{64D1738D-F0F2-4F33-B73E-6056640154D5}" dt="2020-04-13T11:31:22.464" v="32242" actId="1035"/>
          <ac:spMkLst>
            <pc:docMk/>
            <pc:sldMk cId="3170069621" sldId="364"/>
            <ac:spMk id="208" creationId="{67B9D7BA-026D-4564-954B-474A1FE04319}"/>
          </ac:spMkLst>
        </pc:spChg>
        <pc:spChg chg="mod">
          <ac:chgData name="Chew Leng Lim" userId="f4956819b06a5395" providerId="LiveId" clId="{64D1738D-F0F2-4F33-B73E-6056640154D5}" dt="2020-04-13T11:31:22.464" v="32242" actId="1035"/>
          <ac:spMkLst>
            <pc:docMk/>
            <pc:sldMk cId="3170069621" sldId="364"/>
            <ac:spMk id="209" creationId="{0C23EBC1-8D26-4E4B-95FB-C2EB629A0A91}"/>
          </ac:spMkLst>
        </pc:spChg>
        <pc:spChg chg="mod">
          <ac:chgData name="Chew Leng Lim" userId="f4956819b06a5395" providerId="LiveId" clId="{64D1738D-F0F2-4F33-B73E-6056640154D5}" dt="2020-04-13T11:31:22.464" v="32242" actId="1035"/>
          <ac:spMkLst>
            <pc:docMk/>
            <pc:sldMk cId="3170069621" sldId="364"/>
            <ac:spMk id="210" creationId="{200DDC37-203D-49BF-979F-4F5756D46EEE}"/>
          </ac:spMkLst>
        </pc:spChg>
        <pc:spChg chg="add mod">
          <ac:chgData name="Chew Leng Lim" userId="f4956819b06a5395" providerId="LiveId" clId="{64D1738D-F0F2-4F33-B73E-6056640154D5}" dt="2020-04-13T10:09:42.317" v="23485" actId="1036"/>
          <ac:spMkLst>
            <pc:docMk/>
            <pc:sldMk cId="3170069621" sldId="364"/>
            <ac:spMk id="221" creationId="{886F36F9-99BB-4CEC-AA37-B51B4A79099B}"/>
          </ac:spMkLst>
        </pc:spChg>
        <pc:spChg chg="add mod">
          <ac:chgData name="Chew Leng Lim" userId="f4956819b06a5395" providerId="LiveId" clId="{64D1738D-F0F2-4F33-B73E-6056640154D5}" dt="2020-04-13T10:09:42.317" v="23485" actId="1036"/>
          <ac:spMkLst>
            <pc:docMk/>
            <pc:sldMk cId="3170069621" sldId="364"/>
            <ac:spMk id="222" creationId="{9CCE1873-EEBD-4A98-9282-A55A13A94882}"/>
          </ac:spMkLst>
        </pc:spChg>
        <pc:spChg chg="add mod topLvl">
          <ac:chgData name="Chew Leng Lim" userId="f4956819b06a5395" providerId="LiveId" clId="{64D1738D-F0F2-4F33-B73E-6056640154D5}" dt="2020-04-13T09:52:24.850" v="22188" actId="164"/>
          <ac:spMkLst>
            <pc:docMk/>
            <pc:sldMk cId="3170069621" sldId="364"/>
            <ac:spMk id="223" creationId="{F2FC921F-A63A-4DF8-A395-ED6B4187D105}"/>
          </ac:spMkLst>
        </pc:spChg>
        <pc:spChg chg="add mod topLvl">
          <ac:chgData name="Chew Leng Lim" userId="f4956819b06a5395" providerId="LiveId" clId="{64D1738D-F0F2-4F33-B73E-6056640154D5}" dt="2020-04-13T09:52:24.850" v="22188" actId="164"/>
          <ac:spMkLst>
            <pc:docMk/>
            <pc:sldMk cId="3170069621" sldId="364"/>
            <ac:spMk id="224" creationId="{09C3DDC0-0AFE-4216-AD37-F638668A0D4D}"/>
          </ac:spMkLst>
        </pc:spChg>
        <pc:spChg chg="add mod topLvl">
          <ac:chgData name="Chew Leng Lim" userId="f4956819b06a5395" providerId="LiveId" clId="{64D1738D-F0F2-4F33-B73E-6056640154D5}" dt="2020-04-13T09:52:24.850" v="22188" actId="164"/>
          <ac:spMkLst>
            <pc:docMk/>
            <pc:sldMk cId="3170069621" sldId="364"/>
            <ac:spMk id="225" creationId="{88851151-2BC3-43D0-B948-3E1E4429A5A1}"/>
          </ac:spMkLst>
        </pc:spChg>
        <pc:spChg chg="add mod topLvl">
          <ac:chgData name="Chew Leng Lim" userId="f4956819b06a5395" providerId="LiveId" clId="{64D1738D-F0F2-4F33-B73E-6056640154D5}" dt="2020-04-13T09:52:24.850" v="22188" actId="164"/>
          <ac:spMkLst>
            <pc:docMk/>
            <pc:sldMk cId="3170069621" sldId="364"/>
            <ac:spMk id="226" creationId="{41A0950E-5AAD-4EEA-8622-FF2F54096FF4}"/>
          </ac:spMkLst>
        </pc:spChg>
        <pc:spChg chg="add mod topLvl">
          <ac:chgData name="Chew Leng Lim" userId="f4956819b06a5395" providerId="LiveId" clId="{64D1738D-F0F2-4F33-B73E-6056640154D5}" dt="2020-04-13T09:52:24.850" v="22188" actId="164"/>
          <ac:spMkLst>
            <pc:docMk/>
            <pc:sldMk cId="3170069621" sldId="364"/>
            <ac:spMk id="227" creationId="{70D8AE32-0BF8-4519-8BC2-2CF5A7B838B3}"/>
          </ac:spMkLst>
        </pc:spChg>
        <pc:spChg chg="add mod topLvl">
          <ac:chgData name="Chew Leng Lim" userId="f4956819b06a5395" providerId="LiveId" clId="{64D1738D-F0F2-4F33-B73E-6056640154D5}" dt="2020-04-13T09:52:24.850" v="22188" actId="164"/>
          <ac:spMkLst>
            <pc:docMk/>
            <pc:sldMk cId="3170069621" sldId="364"/>
            <ac:spMk id="228" creationId="{B6F80B00-900D-414C-A081-42A29B59481B}"/>
          </ac:spMkLst>
        </pc:spChg>
        <pc:spChg chg="add mod">
          <ac:chgData name="Chew Leng Lim" userId="f4956819b06a5395" providerId="LiveId" clId="{64D1738D-F0F2-4F33-B73E-6056640154D5}" dt="2020-04-13T09:52:20.450" v="22187" actId="164"/>
          <ac:spMkLst>
            <pc:docMk/>
            <pc:sldMk cId="3170069621" sldId="364"/>
            <ac:spMk id="229" creationId="{CCA9A8EB-4965-450B-A94B-16423553AA16}"/>
          </ac:spMkLst>
        </pc:spChg>
        <pc:spChg chg="add mod">
          <ac:chgData name="Chew Leng Lim" userId="f4956819b06a5395" providerId="LiveId" clId="{64D1738D-F0F2-4F33-B73E-6056640154D5}" dt="2020-04-13T09:52:20.450" v="22187" actId="164"/>
          <ac:spMkLst>
            <pc:docMk/>
            <pc:sldMk cId="3170069621" sldId="364"/>
            <ac:spMk id="230" creationId="{481DE565-6C09-4FC3-814B-D9F362C7CA38}"/>
          </ac:spMkLst>
        </pc:spChg>
        <pc:spChg chg="add mod">
          <ac:chgData name="Chew Leng Lim" userId="f4956819b06a5395" providerId="LiveId" clId="{64D1738D-F0F2-4F33-B73E-6056640154D5}" dt="2020-04-13T09:52:20.450" v="22187" actId="164"/>
          <ac:spMkLst>
            <pc:docMk/>
            <pc:sldMk cId="3170069621" sldId="364"/>
            <ac:spMk id="231" creationId="{6997C7C4-9878-47E3-A822-C6403E67F30A}"/>
          </ac:spMkLst>
        </pc:spChg>
        <pc:spChg chg="add mod">
          <ac:chgData name="Chew Leng Lim" userId="f4956819b06a5395" providerId="LiveId" clId="{64D1738D-F0F2-4F33-B73E-6056640154D5}" dt="2020-04-13T09:52:20.450" v="22187" actId="164"/>
          <ac:spMkLst>
            <pc:docMk/>
            <pc:sldMk cId="3170069621" sldId="364"/>
            <ac:spMk id="232" creationId="{A43F385B-E690-4C56-AEFB-B7A7E81FC060}"/>
          </ac:spMkLst>
        </pc:spChg>
        <pc:spChg chg="add mod">
          <ac:chgData name="Chew Leng Lim" userId="f4956819b06a5395" providerId="LiveId" clId="{64D1738D-F0F2-4F33-B73E-6056640154D5}" dt="2020-04-13T09:52:20.450" v="22187" actId="164"/>
          <ac:spMkLst>
            <pc:docMk/>
            <pc:sldMk cId="3170069621" sldId="364"/>
            <ac:spMk id="233" creationId="{6F0486DE-5E9E-4A1E-A7DE-CD826CF7A39C}"/>
          </ac:spMkLst>
        </pc:spChg>
        <pc:spChg chg="add mod">
          <ac:chgData name="Chew Leng Lim" userId="f4956819b06a5395" providerId="LiveId" clId="{64D1738D-F0F2-4F33-B73E-6056640154D5}" dt="2020-04-13T09:52:20.450" v="22187" actId="164"/>
          <ac:spMkLst>
            <pc:docMk/>
            <pc:sldMk cId="3170069621" sldId="364"/>
            <ac:spMk id="234" creationId="{F0D23985-10D5-4518-BCC5-F3DFBAEDD94F}"/>
          </ac:spMkLst>
        </pc:spChg>
        <pc:spChg chg="add mod">
          <ac:chgData name="Chew Leng Lim" userId="f4956819b06a5395" providerId="LiveId" clId="{64D1738D-F0F2-4F33-B73E-6056640154D5}" dt="2020-04-13T09:52:20.450" v="22187" actId="164"/>
          <ac:spMkLst>
            <pc:docMk/>
            <pc:sldMk cId="3170069621" sldId="364"/>
            <ac:spMk id="237" creationId="{44253403-F235-4530-B592-4B881CB59A7B}"/>
          </ac:spMkLst>
        </pc:spChg>
        <pc:spChg chg="add mod">
          <ac:chgData name="Chew Leng Lim" userId="f4956819b06a5395" providerId="LiveId" clId="{64D1738D-F0F2-4F33-B73E-6056640154D5}" dt="2020-04-13T09:52:20.450" v="22187" actId="164"/>
          <ac:spMkLst>
            <pc:docMk/>
            <pc:sldMk cId="3170069621" sldId="364"/>
            <ac:spMk id="238" creationId="{D7758853-C2E1-4F59-98DB-4B8F133745C0}"/>
          </ac:spMkLst>
        </pc:spChg>
        <pc:spChg chg="add mod">
          <ac:chgData name="Chew Leng Lim" userId="f4956819b06a5395" providerId="LiveId" clId="{64D1738D-F0F2-4F33-B73E-6056640154D5}" dt="2020-04-13T11:31:22.464" v="32242" actId="1035"/>
          <ac:spMkLst>
            <pc:docMk/>
            <pc:sldMk cId="3170069621" sldId="364"/>
            <ac:spMk id="242" creationId="{B194B555-7E92-4F58-88AB-B2DF21573551}"/>
          </ac:spMkLst>
        </pc:spChg>
        <pc:grpChg chg="add del mod">
          <ac:chgData name="Chew Leng Lim" userId="f4956819b06a5395" providerId="LiveId" clId="{64D1738D-F0F2-4F33-B73E-6056640154D5}" dt="2020-04-13T09:33:44.658" v="20052" actId="165"/>
          <ac:grpSpMkLst>
            <pc:docMk/>
            <pc:sldMk cId="3170069621" sldId="364"/>
            <ac:grpSpMk id="2" creationId="{63E9A293-1B55-41D1-ABE0-E3D4F768F22C}"/>
          </ac:grpSpMkLst>
        </pc:grpChg>
        <pc:grpChg chg="add mod">
          <ac:chgData name="Chew Leng Lim" userId="f4956819b06a5395" providerId="LiveId" clId="{64D1738D-F0F2-4F33-B73E-6056640154D5}" dt="2020-04-13T10:09:42.317" v="23485" actId="1036"/>
          <ac:grpSpMkLst>
            <pc:docMk/>
            <pc:sldMk cId="3170069621" sldId="364"/>
            <ac:grpSpMk id="3" creationId="{51251FFB-3D27-4040-92A1-AAE34C78AB2B}"/>
          </ac:grpSpMkLst>
        </pc:grpChg>
        <pc:grpChg chg="del mod topLvl">
          <ac:chgData name="Chew Leng Lim" userId="f4956819b06a5395" providerId="LiveId" clId="{64D1738D-F0F2-4F33-B73E-6056640154D5}" dt="2020-04-13T09:22:30.870" v="19215" actId="165"/>
          <ac:grpSpMkLst>
            <pc:docMk/>
            <pc:sldMk cId="3170069621" sldId="364"/>
            <ac:grpSpMk id="4" creationId="{520D7BD3-C2C8-4EBE-AC2F-4D1AF994CEC2}"/>
          </ac:grpSpMkLst>
        </pc:grpChg>
        <pc:grpChg chg="del mod">
          <ac:chgData name="Chew Leng Lim" userId="f4956819b06a5395" providerId="LiveId" clId="{64D1738D-F0F2-4F33-B73E-6056640154D5}" dt="2020-04-13T09:22:22.331" v="19214" actId="165"/>
          <ac:grpSpMkLst>
            <pc:docMk/>
            <pc:sldMk cId="3170069621" sldId="364"/>
            <ac:grpSpMk id="5" creationId="{9F591A7B-EB8B-4509-B4E7-21861D4DB552}"/>
          </ac:grpSpMkLst>
        </pc:grpChg>
        <pc:grpChg chg="add mod">
          <ac:chgData name="Chew Leng Lim" userId="f4956819b06a5395" providerId="LiveId" clId="{64D1738D-F0F2-4F33-B73E-6056640154D5}" dt="2020-04-13T10:15:21.103" v="24181" actId="1036"/>
          <ac:grpSpMkLst>
            <pc:docMk/>
            <pc:sldMk cId="3170069621" sldId="364"/>
            <ac:grpSpMk id="6" creationId="{A0B760F5-CA0D-43BC-8BD4-1E6EB243B9BC}"/>
          </ac:grpSpMkLst>
        </pc:grpChg>
        <pc:grpChg chg="add mod">
          <ac:chgData name="Chew Leng Lim" userId="f4956819b06a5395" providerId="LiveId" clId="{64D1738D-F0F2-4F33-B73E-6056640154D5}" dt="2020-04-13T10:09:42.317" v="23485" actId="1036"/>
          <ac:grpSpMkLst>
            <pc:docMk/>
            <pc:sldMk cId="3170069621" sldId="364"/>
            <ac:grpSpMk id="7" creationId="{11936811-3414-4869-9990-EAB2F5BA421D}"/>
          </ac:grpSpMkLst>
        </pc:grpChg>
        <pc:grpChg chg="del mod topLvl">
          <ac:chgData name="Chew Leng Lim" userId="f4956819b06a5395" providerId="LiveId" clId="{64D1738D-F0F2-4F33-B73E-6056640154D5}" dt="2020-04-13T09:22:49.070" v="19252" actId="165"/>
          <ac:grpSpMkLst>
            <pc:docMk/>
            <pc:sldMk cId="3170069621" sldId="364"/>
            <ac:grpSpMk id="8" creationId="{B583A35F-9AE5-40AF-8048-0C4CFBADD19E}"/>
          </ac:grpSpMkLst>
        </pc:grpChg>
        <pc:grpChg chg="add mod">
          <ac:chgData name="Chew Leng Lim" userId="f4956819b06a5395" providerId="LiveId" clId="{64D1738D-F0F2-4F33-B73E-6056640154D5}" dt="2020-04-13T11:31:22.464" v="32242" actId="1035"/>
          <ac:grpSpMkLst>
            <pc:docMk/>
            <pc:sldMk cId="3170069621" sldId="364"/>
            <ac:grpSpMk id="9" creationId="{51FE359D-FFC6-45A1-97A5-5B7C0814EDD8}"/>
          </ac:grpSpMkLst>
        </pc:grpChg>
        <pc:grpChg chg="add del mod">
          <ac:chgData name="Chew Leng Lim" userId="f4956819b06a5395" providerId="LiveId" clId="{64D1738D-F0F2-4F33-B73E-6056640154D5}" dt="2020-04-13T09:51:41.179" v="22052" actId="165"/>
          <ac:grpSpMkLst>
            <pc:docMk/>
            <pc:sldMk cId="3170069621" sldId="364"/>
            <ac:grpSpMk id="10" creationId="{18BE3489-FC05-4AC1-9F81-92E4DDFA6EB0}"/>
          </ac:grpSpMkLst>
        </pc:grpChg>
        <pc:grpChg chg="add mod">
          <ac:chgData name="Chew Leng Lim" userId="f4956819b06a5395" providerId="LiveId" clId="{64D1738D-F0F2-4F33-B73E-6056640154D5}" dt="2020-04-13T11:31:22.464" v="32242" actId="1035"/>
          <ac:grpSpMkLst>
            <pc:docMk/>
            <pc:sldMk cId="3170069621" sldId="364"/>
            <ac:grpSpMk id="11" creationId="{6030D88B-EDF2-44A0-BD98-667384278CD6}"/>
          </ac:grpSpMkLst>
        </pc:grpChg>
        <pc:grpChg chg="add mod">
          <ac:chgData name="Chew Leng Lim" userId="f4956819b06a5395" providerId="LiveId" clId="{64D1738D-F0F2-4F33-B73E-6056640154D5}" dt="2020-04-13T11:31:22.464" v="32242" actId="1035"/>
          <ac:grpSpMkLst>
            <pc:docMk/>
            <pc:sldMk cId="3170069621" sldId="364"/>
            <ac:grpSpMk id="12" creationId="{05B415D3-BEC7-49D2-9B61-3787DE909B01}"/>
          </ac:grpSpMkLst>
        </pc:grpChg>
        <pc:grpChg chg="del mod">
          <ac:chgData name="Chew Leng Lim" userId="f4956819b06a5395" providerId="LiveId" clId="{64D1738D-F0F2-4F33-B73E-6056640154D5}" dt="2020-04-13T09:22:45.835" v="19251" actId="165"/>
          <ac:grpSpMkLst>
            <pc:docMk/>
            <pc:sldMk cId="3170069621" sldId="364"/>
            <ac:grpSpMk id="13" creationId="{9A913A42-A443-4CC3-89FB-78FA54C681D3}"/>
          </ac:grpSpMkLst>
        </pc:grpChg>
        <pc:grpChg chg="add mod">
          <ac:chgData name="Chew Leng Lim" userId="f4956819b06a5395" providerId="LiveId" clId="{64D1738D-F0F2-4F33-B73E-6056640154D5}" dt="2020-04-13T10:09:42.317" v="23485" actId="1036"/>
          <ac:grpSpMkLst>
            <pc:docMk/>
            <pc:sldMk cId="3170069621" sldId="364"/>
            <ac:grpSpMk id="188" creationId="{CEAF0F92-D666-4860-B59E-7B88B431077B}"/>
          </ac:grpSpMkLst>
        </pc:grpChg>
        <pc:graphicFrameChg chg="mod topLvl">
          <ac:chgData name="Chew Leng Lim" userId="f4956819b06a5395" providerId="LiveId" clId="{64D1738D-F0F2-4F33-B73E-6056640154D5}" dt="2020-04-13T09:33:49.919" v="20053" actId="164"/>
          <ac:graphicFrameMkLst>
            <pc:docMk/>
            <pc:sldMk cId="3170069621" sldId="364"/>
            <ac:graphicFrameMk id="62" creationId="{526897DF-36CD-46A2-AE95-2E369D41A64F}"/>
          </ac:graphicFrameMkLst>
        </pc:graphicFrameChg>
        <pc:graphicFrameChg chg="mod">
          <ac:chgData name="Chew Leng Lim" userId="f4956819b06a5395" providerId="LiveId" clId="{64D1738D-F0F2-4F33-B73E-6056640154D5}" dt="2020-04-13T09:45:14.505" v="21242" actId="164"/>
          <ac:graphicFrameMkLst>
            <pc:docMk/>
            <pc:sldMk cId="3170069621" sldId="364"/>
            <ac:graphicFrameMk id="98" creationId="{D3EB3D33-28EE-45D3-AE15-7C67392ED26B}"/>
          </ac:graphicFrameMkLst>
        </pc:graphicFrameChg>
        <pc:graphicFrameChg chg="mod">
          <ac:chgData name="Chew Leng Lim" userId="f4956819b06a5395" providerId="LiveId" clId="{64D1738D-F0F2-4F33-B73E-6056640154D5}" dt="2020-04-13T09:35:05.676" v="20208" actId="164"/>
          <ac:graphicFrameMkLst>
            <pc:docMk/>
            <pc:sldMk cId="3170069621" sldId="364"/>
            <ac:graphicFrameMk id="130" creationId="{21B1168D-3416-491D-95D9-F3D7C0A80C1F}"/>
          </ac:graphicFrameMkLst>
        </pc:graphicFrameChg>
        <pc:graphicFrameChg chg="mod topLvl">
          <ac:chgData name="Chew Leng Lim" userId="f4956819b06a5395" providerId="LiveId" clId="{64D1738D-F0F2-4F33-B73E-6056640154D5}" dt="2020-04-13T09:52:24.850" v="22188" actId="164"/>
          <ac:graphicFrameMkLst>
            <pc:docMk/>
            <pc:sldMk cId="3170069621" sldId="364"/>
            <ac:graphicFrameMk id="157" creationId="{5A442EA5-4E25-4063-AB66-64522CCADEA2}"/>
          </ac:graphicFrameMkLst>
        </pc:graphicFrameChg>
        <pc:graphicFrameChg chg="mod">
          <ac:chgData name="Chew Leng Lim" userId="f4956819b06a5395" providerId="LiveId" clId="{64D1738D-F0F2-4F33-B73E-6056640154D5}" dt="2020-04-13T09:52:20.450" v="22187" actId="164"/>
          <ac:graphicFrameMkLst>
            <pc:docMk/>
            <pc:sldMk cId="3170069621" sldId="364"/>
            <ac:graphicFrameMk id="189" creationId="{5F5B5F91-672B-41B8-8448-45871599C5BF}"/>
          </ac:graphicFrameMkLst>
        </pc:graphicFrameChg>
        <pc:picChg chg="mod topLvl">
          <ac:chgData name="Chew Leng Lim" userId="f4956819b06a5395" providerId="LiveId" clId="{64D1738D-F0F2-4F33-B73E-6056640154D5}" dt="2020-04-13T09:35:56.709" v="20232" actId="164"/>
          <ac:picMkLst>
            <pc:docMk/>
            <pc:sldMk cId="3170069621" sldId="364"/>
            <ac:picMk id="73" creationId="{1CAA91C7-F606-46BA-94A5-A17895D13780}"/>
          </ac:picMkLst>
        </pc:picChg>
        <pc:picChg chg="mod topLvl">
          <ac:chgData name="Chew Leng Lim" userId="f4956819b06a5395" providerId="LiveId" clId="{64D1738D-F0F2-4F33-B73E-6056640154D5}" dt="2020-04-13T09:35:56.709" v="20232" actId="164"/>
          <ac:picMkLst>
            <pc:docMk/>
            <pc:sldMk cId="3170069621" sldId="364"/>
            <ac:picMk id="74" creationId="{DA1EB563-A2A9-457D-AF5E-116B698D0AAA}"/>
          </ac:picMkLst>
        </pc:picChg>
        <pc:picChg chg="mod topLvl">
          <ac:chgData name="Chew Leng Lim" userId="f4956819b06a5395" providerId="LiveId" clId="{64D1738D-F0F2-4F33-B73E-6056640154D5}" dt="2020-04-13T09:35:56.709" v="20232" actId="164"/>
          <ac:picMkLst>
            <pc:docMk/>
            <pc:sldMk cId="3170069621" sldId="364"/>
            <ac:picMk id="75" creationId="{E89D246E-E3BA-46B2-9CF0-D06BC4704246}"/>
          </ac:picMkLst>
        </pc:picChg>
        <pc:picChg chg="mod topLvl">
          <ac:chgData name="Chew Leng Lim" userId="f4956819b06a5395" providerId="LiveId" clId="{64D1738D-F0F2-4F33-B73E-6056640154D5}" dt="2020-04-13T09:35:56.709" v="20232" actId="164"/>
          <ac:picMkLst>
            <pc:docMk/>
            <pc:sldMk cId="3170069621" sldId="364"/>
            <ac:picMk id="76" creationId="{133E982B-24E6-4B70-A796-BBAD4B900FD0}"/>
          </ac:picMkLst>
        </pc:picChg>
        <pc:picChg chg="mod topLvl">
          <ac:chgData name="Chew Leng Lim" userId="f4956819b06a5395" providerId="LiveId" clId="{64D1738D-F0F2-4F33-B73E-6056640154D5}" dt="2020-04-13T09:35:56.709" v="20232" actId="164"/>
          <ac:picMkLst>
            <pc:docMk/>
            <pc:sldMk cId="3170069621" sldId="364"/>
            <ac:picMk id="86" creationId="{1C56D0EC-F3D1-4FCA-AEE5-2347AA8B8A3F}"/>
          </ac:picMkLst>
        </pc:picChg>
        <pc:picChg chg="mod topLvl">
          <ac:chgData name="Chew Leng Lim" userId="f4956819b06a5395" providerId="LiveId" clId="{64D1738D-F0F2-4F33-B73E-6056640154D5}" dt="2020-04-13T09:35:56.709" v="20232" actId="164"/>
          <ac:picMkLst>
            <pc:docMk/>
            <pc:sldMk cId="3170069621" sldId="364"/>
            <ac:picMk id="87" creationId="{D6CEFE2F-6CE0-4E24-9A61-BAF561A9080F}"/>
          </ac:picMkLst>
        </pc:picChg>
        <pc:cxnChg chg="mod topLvl">
          <ac:chgData name="Chew Leng Lim" userId="f4956819b06a5395" providerId="LiveId" clId="{64D1738D-F0F2-4F33-B73E-6056640154D5}" dt="2020-04-13T09:35:56.709" v="20232" actId="164"/>
          <ac:cxnSpMkLst>
            <pc:docMk/>
            <pc:sldMk cId="3170069621" sldId="364"/>
            <ac:cxnSpMk id="77" creationId="{7A9A1E42-4C6E-4364-AB38-0DB3C3943867}"/>
          </ac:cxnSpMkLst>
        </pc:cxnChg>
        <pc:cxnChg chg="mod topLvl">
          <ac:chgData name="Chew Leng Lim" userId="f4956819b06a5395" providerId="LiveId" clId="{64D1738D-F0F2-4F33-B73E-6056640154D5}" dt="2020-04-13T09:35:56.709" v="20232" actId="164"/>
          <ac:cxnSpMkLst>
            <pc:docMk/>
            <pc:sldMk cId="3170069621" sldId="364"/>
            <ac:cxnSpMk id="78" creationId="{9AF5FADC-E3E6-4CBA-A354-3547655F83CB}"/>
          </ac:cxnSpMkLst>
        </pc:cxnChg>
        <pc:cxnChg chg="mod topLvl">
          <ac:chgData name="Chew Leng Lim" userId="f4956819b06a5395" providerId="LiveId" clId="{64D1738D-F0F2-4F33-B73E-6056640154D5}" dt="2020-04-13T09:33:49.919" v="20053" actId="164"/>
          <ac:cxnSpMkLst>
            <pc:docMk/>
            <pc:sldMk cId="3170069621" sldId="364"/>
            <ac:cxnSpMk id="89" creationId="{7D2E9910-DC55-42F5-AE31-0599ED16E9F2}"/>
          </ac:cxnSpMkLst>
        </pc:cxnChg>
        <pc:cxnChg chg="mod">
          <ac:chgData name="Chew Leng Lim" userId="f4956819b06a5395" providerId="LiveId" clId="{64D1738D-F0F2-4F33-B73E-6056640154D5}" dt="2020-04-13T09:35:05.676" v="20208" actId="164"/>
          <ac:cxnSpMkLst>
            <pc:docMk/>
            <pc:sldMk cId="3170069621" sldId="364"/>
            <ac:cxnSpMk id="90" creationId="{F3333445-3510-4EE7-8C8F-9FFB66CA023D}"/>
          </ac:cxnSpMkLst>
        </pc:cxnChg>
        <pc:cxnChg chg="mod topLvl">
          <ac:chgData name="Chew Leng Lim" userId="f4956819b06a5395" providerId="LiveId" clId="{64D1738D-F0F2-4F33-B73E-6056640154D5}" dt="2020-04-13T09:33:49.919" v="20053" actId="164"/>
          <ac:cxnSpMkLst>
            <pc:docMk/>
            <pc:sldMk cId="3170069621" sldId="364"/>
            <ac:cxnSpMk id="92" creationId="{95B7B67F-DC9A-40B2-BFDA-BD7898DA992C}"/>
          </ac:cxnSpMkLst>
        </pc:cxnChg>
        <pc:cxnChg chg="mod topLvl">
          <ac:chgData name="Chew Leng Lim" userId="f4956819b06a5395" providerId="LiveId" clId="{64D1738D-F0F2-4F33-B73E-6056640154D5}" dt="2020-04-13T09:33:49.919" v="20053" actId="164"/>
          <ac:cxnSpMkLst>
            <pc:docMk/>
            <pc:sldMk cId="3170069621" sldId="364"/>
            <ac:cxnSpMk id="93" creationId="{06142311-4FA7-4939-9885-096AED1A5B9F}"/>
          </ac:cxnSpMkLst>
        </pc:cxnChg>
        <pc:cxnChg chg="mod">
          <ac:chgData name="Chew Leng Lim" userId="f4956819b06a5395" providerId="LiveId" clId="{64D1738D-F0F2-4F33-B73E-6056640154D5}" dt="2020-04-13T09:35:05.676" v="20208" actId="164"/>
          <ac:cxnSpMkLst>
            <pc:docMk/>
            <pc:sldMk cId="3170069621" sldId="364"/>
            <ac:cxnSpMk id="105" creationId="{81D3BC2A-5B88-4F16-9234-220CD732AFB2}"/>
          </ac:cxnSpMkLst>
        </pc:cxnChg>
        <pc:cxnChg chg="mod">
          <ac:chgData name="Chew Leng Lim" userId="f4956819b06a5395" providerId="LiveId" clId="{64D1738D-F0F2-4F33-B73E-6056640154D5}" dt="2020-04-13T09:35:05.676" v="20208" actId="164"/>
          <ac:cxnSpMkLst>
            <pc:docMk/>
            <pc:sldMk cId="3170069621" sldId="364"/>
            <ac:cxnSpMk id="107" creationId="{E58F2C32-267C-4A42-BDD8-5F59692A49D3}"/>
          </ac:cxnSpMkLst>
        </pc:cxnChg>
        <pc:cxnChg chg="mod">
          <ac:chgData name="Chew Leng Lim" userId="f4956819b06a5395" providerId="LiveId" clId="{64D1738D-F0F2-4F33-B73E-6056640154D5}" dt="2020-04-13T09:35:05.676" v="20208" actId="164"/>
          <ac:cxnSpMkLst>
            <pc:docMk/>
            <pc:sldMk cId="3170069621" sldId="364"/>
            <ac:cxnSpMk id="108" creationId="{9CB7F51D-ACD5-48B1-8345-01DE216F2EEF}"/>
          </ac:cxnSpMkLst>
        </pc:cxnChg>
        <pc:cxnChg chg="mod">
          <ac:chgData name="Chew Leng Lim" userId="f4956819b06a5395" providerId="LiveId" clId="{64D1738D-F0F2-4F33-B73E-6056640154D5}" dt="2020-04-13T09:35:05.676" v="20208" actId="164"/>
          <ac:cxnSpMkLst>
            <pc:docMk/>
            <pc:sldMk cId="3170069621" sldId="364"/>
            <ac:cxnSpMk id="109" creationId="{7A21DFA5-2270-4636-8FB1-9F6DE936A12D}"/>
          </ac:cxnSpMkLst>
        </pc:cxnChg>
        <pc:cxnChg chg="mod">
          <ac:chgData name="Chew Leng Lim" userId="f4956819b06a5395" providerId="LiveId" clId="{64D1738D-F0F2-4F33-B73E-6056640154D5}" dt="2020-04-13T09:35:05.676" v="20208" actId="164"/>
          <ac:cxnSpMkLst>
            <pc:docMk/>
            <pc:sldMk cId="3170069621" sldId="364"/>
            <ac:cxnSpMk id="111" creationId="{05AD26B6-CE6B-4AC4-9C03-36BAF65E4AAE}"/>
          </ac:cxnSpMkLst>
        </pc:cxnChg>
        <pc:cxnChg chg="mod">
          <ac:chgData name="Chew Leng Lim" userId="f4956819b06a5395" providerId="LiveId" clId="{64D1738D-F0F2-4F33-B73E-6056640154D5}" dt="2020-04-13T09:35:05.676" v="20208" actId="164"/>
          <ac:cxnSpMkLst>
            <pc:docMk/>
            <pc:sldMk cId="3170069621" sldId="364"/>
            <ac:cxnSpMk id="112" creationId="{710EA026-092D-4E4F-9055-74F15B5C5F07}"/>
          </ac:cxnSpMkLst>
        </pc:cxnChg>
        <pc:cxnChg chg="mod">
          <ac:chgData name="Chew Leng Lim" userId="f4956819b06a5395" providerId="LiveId" clId="{64D1738D-F0F2-4F33-B73E-6056640154D5}" dt="2020-04-13T09:35:05.676" v="20208" actId="164"/>
          <ac:cxnSpMkLst>
            <pc:docMk/>
            <pc:sldMk cId="3170069621" sldId="364"/>
            <ac:cxnSpMk id="114" creationId="{67EF0043-8089-4AF8-9EC0-F959AE7AD32D}"/>
          </ac:cxnSpMkLst>
        </pc:cxnChg>
        <pc:cxnChg chg="mod">
          <ac:chgData name="Chew Leng Lim" userId="f4956819b06a5395" providerId="LiveId" clId="{64D1738D-F0F2-4F33-B73E-6056640154D5}" dt="2020-04-13T09:35:05.676" v="20208" actId="164"/>
          <ac:cxnSpMkLst>
            <pc:docMk/>
            <pc:sldMk cId="3170069621" sldId="364"/>
            <ac:cxnSpMk id="115" creationId="{87394CB1-FE84-4035-81B2-1AD27EAEA124}"/>
          </ac:cxnSpMkLst>
        </pc:cxnChg>
        <pc:cxnChg chg="mod">
          <ac:chgData name="Chew Leng Lim" userId="f4956819b06a5395" providerId="LiveId" clId="{64D1738D-F0F2-4F33-B73E-6056640154D5}" dt="2020-04-13T09:35:05.676" v="20208" actId="164"/>
          <ac:cxnSpMkLst>
            <pc:docMk/>
            <pc:sldMk cId="3170069621" sldId="364"/>
            <ac:cxnSpMk id="118" creationId="{DCBF7B52-A8AD-4144-ADE7-BF461AF25263}"/>
          </ac:cxnSpMkLst>
        </pc:cxnChg>
        <pc:cxnChg chg="mod">
          <ac:chgData name="Chew Leng Lim" userId="f4956819b06a5395" providerId="LiveId" clId="{64D1738D-F0F2-4F33-B73E-6056640154D5}" dt="2020-04-13T09:35:05.676" v="20208" actId="164"/>
          <ac:cxnSpMkLst>
            <pc:docMk/>
            <pc:sldMk cId="3170069621" sldId="364"/>
            <ac:cxnSpMk id="121" creationId="{543ACC84-11C0-4078-8DCD-923BBD538C22}"/>
          </ac:cxnSpMkLst>
        </pc:cxnChg>
        <pc:cxnChg chg="mod">
          <ac:chgData name="Chew Leng Lim" userId="f4956819b06a5395" providerId="LiveId" clId="{64D1738D-F0F2-4F33-B73E-6056640154D5}" dt="2020-04-13T09:45:14.505" v="21242" actId="164"/>
          <ac:cxnSpMkLst>
            <pc:docMk/>
            <pc:sldMk cId="3170069621" sldId="364"/>
            <ac:cxnSpMk id="127" creationId="{50C76F91-6244-447D-B140-D274952103D9}"/>
          </ac:cxnSpMkLst>
        </pc:cxnChg>
        <pc:cxnChg chg="mod">
          <ac:chgData name="Chew Leng Lim" userId="f4956819b06a5395" providerId="LiveId" clId="{64D1738D-F0F2-4F33-B73E-6056640154D5}" dt="2020-04-13T09:45:14.505" v="21242" actId="164"/>
          <ac:cxnSpMkLst>
            <pc:docMk/>
            <pc:sldMk cId="3170069621" sldId="364"/>
            <ac:cxnSpMk id="128" creationId="{BB3AE685-A98E-410F-B339-6AEE7E63C507}"/>
          </ac:cxnSpMkLst>
        </pc:cxnChg>
        <pc:cxnChg chg="mod">
          <ac:chgData name="Chew Leng Lim" userId="f4956819b06a5395" providerId="LiveId" clId="{64D1738D-F0F2-4F33-B73E-6056640154D5}" dt="2020-04-13T09:45:14.505" v="21242" actId="164"/>
          <ac:cxnSpMkLst>
            <pc:docMk/>
            <pc:sldMk cId="3170069621" sldId="364"/>
            <ac:cxnSpMk id="129" creationId="{39205B86-7A62-45E7-9842-2C9972021FA4}"/>
          </ac:cxnSpMkLst>
        </pc:cxnChg>
        <pc:cxnChg chg="mod">
          <ac:chgData name="Chew Leng Lim" userId="f4956819b06a5395" providerId="LiveId" clId="{64D1738D-F0F2-4F33-B73E-6056640154D5}" dt="2020-04-13T09:45:14.505" v="21242" actId="164"/>
          <ac:cxnSpMkLst>
            <pc:docMk/>
            <pc:sldMk cId="3170069621" sldId="364"/>
            <ac:cxnSpMk id="144" creationId="{2FC9A154-E822-4C3D-9EDB-EB5150E1D5DE}"/>
          </ac:cxnSpMkLst>
        </pc:cxnChg>
        <pc:cxnChg chg="mod">
          <ac:chgData name="Chew Leng Lim" userId="f4956819b06a5395" providerId="LiveId" clId="{64D1738D-F0F2-4F33-B73E-6056640154D5}" dt="2020-04-13T09:45:14.505" v="21242" actId="164"/>
          <ac:cxnSpMkLst>
            <pc:docMk/>
            <pc:sldMk cId="3170069621" sldId="364"/>
            <ac:cxnSpMk id="146" creationId="{3F5A0563-3610-445E-9F81-A1228ECC7F02}"/>
          </ac:cxnSpMkLst>
        </pc:cxnChg>
        <pc:cxnChg chg="mod">
          <ac:chgData name="Chew Leng Lim" userId="f4956819b06a5395" providerId="LiveId" clId="{64D1738D-F0F2-4F33-B73E-6056640154D5}" dt="2020-04-13T09:45:14.505" v="21242" actId="164"/>
          <ac:cxnSpMkLst>
            <pc:docMk/>
            <pc:sldMk cId="3170069621" sldId="364"/>
            <ac:cxnSpMk id="148" creationId="{2D2EDF35-5E1E-4BFC-AC37-9630C1B63A97}"/>
          </ac:cxnSpMkLst>
        </pc:cxnChg>
        <pc:cxnChg chg="mod">
          <ac:chgData name="Chew Leng Lim" userId="f4956819b06a5395" providerId="LiveId" clId="{64D1738D-F0F2-4F33-B73E-6056640154D5}" dt="2020-04-13T09:35:05.676" v="20208" actId="164"/>
          <ac:cxnSpMkLst>
            <pc:docMk/>
            <pc:sldMk cId="3170069621" sldId="364"/>
            <ac:cxnSpMk id="150" creationId="{4214B715-085C-4CB0-B685-83CED5A7A268}"/>
          </ac:cxnSpMkLst>
        </pc:cxnChg>
        <pc:cxnChg chg="mod topLvl">
          <ac:chgData name="Chew Leng Lim" userId="f4956819b06a5395" providerId="LiveId" clId="{64D1738D-F0F2-4F33-B73E-6056640154D5}" dt="2020-04-13T09:33:49.919" v="20053" actId="164"/>
          <ac:cxnSpMkLst>
            <pc:docMk/>
            <pc:sldMk cId="3170069621" sldId="364"/>
            <ac:cxnSpMk id="165" creationId="{E6220BA7-0289-4A40-A2F6-E24BE28FAB2A}"/>
          </ac:cxnSpMkLst>
        </pc:cxnChg>
        <pc:cxnChg chg="mod topLvl">
          <ac:chgData name="Chew Leng Lim" userId="f4956819b06a5395" providerId="LiveId" clId="{64D1738D-F0F2-4F33-B73E-6056640154D5}" dt="2020-04-13T09:33:49.919" v="20053" actId="164"/>
          <ac:cxnSpMkLst>
            <pc:docMk/>
            <pc:sldMk cId="3170069621" sldId="364"/>
            <ac:cxnSpMk id="166" creationId="{F4817EAC-37C9-4BD8-9290-45876B9AB374}"/>
          </ac:cxnSpMkLst>
        </pc:cxnChg>
        <pc:cxnChg chg="mod topLvl">
          <ac:chgData name="Chew Leng Lim" userId="f4956819b06a5395" providerId="LiveId" clId="{64D1738D-F0F2-4F33-B73E-6056640154D5}" dt="2020-04-13T09:33:49.919" v="20053" actId="164"/>
          <ac:cxnSpMkLst>
            <pc:docMk/>
            <pc:sldMk cId="3170069621" sldId="364"/>
            <ac:cxnSpMk id="167" creationId="{4494A581-27D5-4DC5-8384-4B6A1B0C63CD}"/>
          </ac:cxnSpMkLst>
        </pc:cxnChg>
        <pc:cxnChg chg="mod topLvl">
          <ac:chgData name="Chew Leng Lim" userId="f4956819b06a5395" providerId="LiveId" clId="{64D1738D-F0F2-4F33-B73E-6056640154D5}" dt="2020-04-13T09:33:49.919" v="20053" actId="164"/>
          <ac:cxnSpMkLst>
            <pc:docMk/>
            <pc:sldMk cId="3170069621" sldId="364"/>
            <ac:cxnSpMk id="170" creationId="{6D16FAEA-FBA5-4DBE-8613-5A95C646EC1C}"/>
          </ac:cxnSpMkLst>
        </pc:cxnChg>
        <pc:cxnChg chg="mod topLvl">
          <ac:chgData name="Chew Leng Lim" userId="f4956819b06a5395" providerId="LiveId" clId="{64D1738D-F0F2-4F33-B73E-6056640154D5}" dt="2020-04-13T09:33:49.919" v="20053" actId="164"/>
          <ac:cxnSpMkLst>
            <pc:docMk/>
            <pc:sldMk cId="3170069621" sldId="364"/>
            <ac:cxnSpMk id="171" creationId="{040DF15E-EF80-4986-A4A4-109688B4FE30}"/>
          </ac:cxnSpMkLst>
        </pc:cxnChg>
        <pc:cxnChg chg="mod topLvl">
          <ac:chgData name="Chew Leng Lim" userId="f4956819b06a5395" providerId="LiveId" clId="{64D1738D-F0F2-4F33-B73E-6056640154D5}" dt="2020-04-13T09:52:24.850" v="22188" actId="164"/>
          <ac:cxnSpMkLst>
            <pc:docMk/>
            <pc:sldMk cId="3170069621" sldId="364"/>
            <ac:cxnSpMk id="177" creationId="{AB8A47BD-E462-486F-B364-360282AF84B7}"/>
          </ac:cxnSpMkLst>
        </pc:cxnChg>
        <pc:cxnChg chg="mod topLvl">
          <ac:chgData name="Chew Leng Lim" userId="f4956819b06a5395" providerId="LiveId" clId="{64D1738D-F0F2-4F33-B73E-6056640154D5}" dt="2020-04-13T09:52:24.850" v="22188" actId="164"/>
          <ac:cxnSpMkLst>
            <pc:docMk/>
            <pc:sldMk cId="3170069621" sldId="364"/>
            <ac:cxnSpMk id="178" creationId="{1B7E16A7-7AD0-4FC6-AA06-158FDC88463B}"/>
          </ac:cxnSpMkLst>
        </pc:cxnChg>
        <pc:cxnChg chg="mod topLvl">
          <ac:chgData name="Chew Leng Lim" userId="f4956819b06a5395" providerId="LiveId" clId="{64D1738D-F0F2-4F33-B73E-6056640154D5}" dt="2020-04-13T09:52:24.850" v="22188" actId="164"/>
          <ac:cxnSpMkLst>
            <pc:docMk/>
            <pc:sldMk cId="3170069621" sldId="364"/>
            <ac:cxnSpMk id="181" creationId="{7E0FB8BA-6A48-4BBC-BFA2-121C6725F2B7}"/>
          </ac:cxnSpMkLst>
        </pc:cxnChg>
        <pc:cxnChg chg="mod topLvl">
          <ac:chgData name="Chew Leng Lim" userId="f4956819b06a5395" providerId="LiveId" clId="{64D1738D-F0F2-4F33-B73E-6056640154D5}" dt="2020-04-13T09:52:24.850" v="22188" actId="164"/>
          <ac:cxnSpMkLst>
            <pc:docMk/>
            <pc:sldMk cId="3170069621" sldId="364"/>
            <ac:cxnSpMk id="182" creationId="{60733E15-EC91-4EAB-A838-9EFF58B40B77}"/>
          </ac:cxnSpMkLst>
        </pc:cxnChg>
        <pc:cxnChg chg="mod topLvl">
          <ac:chgData name="Chew Leng Lim" userId="f4956819b06a5395" providerId="LiveId" clId="{64D1738D-F0F2-4F33-B73E-6056640154D5}" dt="2020-04-13T09:52:24.850" v="22188" actId="164"/>
          <ac:cxnSpMkLst>
            <pc:docMk/>
            <pc:sldMk cId="3170069621" sldId="364"/>
            <ac:cxnSpMk id="183" creationId="{3B8FECA4-E767-4493-AAAE-5E0370661E9B}"/>
          </ac:cxnSpMkLst>
        </pc:cxnChg>
        <pc:cxnChg chg="mod topLvl">
          <ac:chgData name="Chew Leng Lim" userId="f4956819b06a5395" providerId="LiveId" clId="{64D1738D-F0F2-4F33-B73E-6056640154D5}" dt="2020-04-13T09:58:10.322" v="22532" actId="1035"/>
          <ac:cxnSpMkLst>
            <pc:docMk/>
            <pc:sldMk cId="3170069621" sldId="364"/>
            <ac:cxnSpMk id="185" creationId="{2CCCE4D4-FA16-4084-B280-D17BABD89211}"/>
          </ac:cxnSpMkLst>
        </pc:cxnChg>
        <pc:cxnChg chg="mod topLvl">
          <ac:chgData name="Chew Leng Lim" userId="f4956819b06a5395" providerId="LiveId" clId="{64D1738D-F0F2-4F33-B73E-6056640154D5}" dt="2020-04-13T09:58:10.322" v="22532" actId="1035"/>
          <ac:cxnSpMkLst>
            <pc:docMk/>
            <pc:sldMk cId="3170069621" sldId="364"/>
            <ac:cxnSpMk id="186" creationId="{AE2137F0-06D1-4856-9456-831F8531FF1A}"/>
          </ac:cxnSpMkLst>
        </pc:cxnChg>
        <pc:cxnChg chg="mod topLvl">
          <ac:chgData name="Chew Leng Lim" userId="f4956819b06a5395" providerId="LiveId" clId="{64D1738D-F0F2-4F33-B73E-6056640154D5}" dt="2020-04-13T09:58:10.322" v="22532" actId="1035"/>
          <ac:cxnSpMkLst>
            <pc:docMk/>
            <pc:sldMk cId="3170069621" sldId="364"/>
            <ac:cxnSpMk id="187" creationId="{8D7A09EE-78F5-46B8-A214-1DDFDAF1F679}"/>
          </ac:cxnSpMkLst>
        </pc:cxnChg>
        <pc:cxnChg chg="del mod">
          <ac:chgData name="Chew Leng Lim" userId="f4956819b06a5395" providerId="LiveId" clId="{64D1738D-F0F2-4F33-B73E-6056640154D5}" dt="2020-04-13T09:51:53.132" v="22053" actId="478"/>
          <ac:cxnSpMkLst>
            <pc:docMk/>
            <pc:sldMk cId="3170069621" sldId="364"/>
            <ac:cxnSpMk id="201" creationId="{251E741A-FB87-4ADC-B357-01F4141AA603}"/>
          </ac:cxnSpMkLst>
        </pc:cxnChg>
        <pc:cxnChg chg="del mod">
          <ac:chgData name="Chew Leng Lim" userId="f4956819b06a5395" providerId="LiveId" clId="{64D1738D-F0F2-4F33-B73E-6056640154D5}" dt="2020-04-13T09:51:53.132" v="22053" actId="478"/>
          <ac:cxnSpMkLst>
            <pc:docMk/>
            <pc:sldMk cId="3170069621" sldId="364"/>
            <ac:cxnSpMk id="202" creationId="{3163A85B-69FF-4640-96F8-C988B282D979}"/>
          </ac:cxnSpMkLst>
        </pc:cxnChg>
        <pc:cxnChg chg="del mod">
          <ac:chgData name="Chew Leng Lim" userId="f4956819b06a5395" providerId="LiveId" clId="{64D1738D-F0F2-4F33-B73E-6056640154D5}" dt="2020-04-13T09:51:53.132" v="22053" actId="478"/>
          <ac:cxnSpMkLst>
            <pc:docMk/>
            <pc:sldMk cId="3170069621" sldId="364"/>
            <ac:cxnSpMk id="205" creationId="{AC047DB6-5715-44C5-89D3-DF39F79682BF}"/>
          </ac:cxnSpMkLst>
        </pc:cxnChg>
        <pc:cxnChg chg="del mod">
          <ac:chgData name="Chew Leng Lim" userId="f4956819b06a5395" providerId="LiveId" clId="{64D1738D-F0F2-4F33-B73E-6056640154D5}" dt="2020-04-13T09:51:53.132" v="22053" actId="478"/>
          <ac:cxnSpMkLst>
            <pc:docMk/>
            <pc:sldMk cId="3170069621" sldId="364"/>
            <ac:cxnSpMk id="206" creationId="{3FE62509-E658-41B4-B091-13E2F230ACE6}"/>
          </ac:cxnSpMkLst>
        </pc:cxnChg>
        <pc:cxnChg chg="del mod">
          <ac:chgData name="Chew Leng Lim" userId="f4956819b06a5395" providerId="LiveId" clId="{64D1738D-F0F2-4F33-B73E-6056640154D5}" dt="2020-04-13T09:51:53.132" v="22053" actId="478"/>
          <ac:cxnSpMkLst>
            <pc:docMk/>
            <pc:sldMk cId="3170069621" sldId="364"/>
            <ac:cxnSpMk id="207" creationId="{09972716-88E6-4F24-89D5-54706DA3B28F}"/>
          </ac:cxnSpMkLst>
        </pc:cxnChg>
        <pc:cxnChg chg="add mod">
          <ac:chgData name="Chew Leng Lim" userId="f4956819b06a5395" providerId="LiveId" clId="{64D1738D-F0F2-4F33-B73E-6056640154D5}" dt="2020-04-13T09:52:20.450" v="22187" actId="164"/>
          <ac:cxnSpMkLst>
            <pc:docMk/>
            <pc:sldMk cId="3170069621" sldId="364"/>
            <ac:cxnSpMk id="235" creationId="{743F3787-647E-4466-A450-36090267100D}"/>
          </ac:cxnSpMkLst>
        </pc:cxnChg>
        <pc:cxnChg chg="add mod">
          <ac:chgData name="Chew Leng Lim" userId="f4956819b06a5395" providerId="LiveId" clId="{64D1738D-F0F2-4F33-B73E-6056640154D5}" dt="2020-04-13T09:52:20.450" v="22187" actId="164"/>
          <ac:cxnSpMkLst>
            <pc:docMk/>
            <pc:sldMk cId="3170069621" sldId="364"/>
            <ac:cxnSpMk id="236" creationId="{C1A16F8A-A34A-48FC-A88A-7697396EEEA9}"/>
          </ac:cxnSpMkLst>
        </pc:cxnChg>
        <pc:cxnChg chg="add mod">
          <ac:chgData name="Chew Leng Lim" userId="f4956819b06a5395" providerId="LiveId" clId="{64D1738D-F0F2-4F33-B73E-6056640154D5}" dt="2020-04-13T09:52:20.450" v="22187" actId="164"/>
          <ac:cxnSpMkLst>
            <pc:docMk/>
            <pc:sldMk cId="3170069621" sldId="364"/>
            <ac:cxnSpMk id="239" creationId="{0C03D8FD-ACB8-4BB8-81ED-8FF40033D3D4}"/>
          </ac:cxnSpMkLst>
        </pc:cxnChg>
        <pc:cxnChg chg="add mod">
          <ac:chgData name="Chew Leng Lim" userId="f4956819b06a5395" providerId="LiveId" clId="{64D1738D-F0F2-4F33-B73E-6056640154D5}" dt="2020-04-13T09:52:20.450" v="22187" actId="164"/>
          <ac:cxnSpMkLst>
            <pc:docMk/>
            <pc:sldMk cId="3170069621" sldId="364"/>
            <ac:cxnSpMk id="240" creationId="{080B79DE-504C-4FFA-B6EF-DAD790334191}"/>
          </ac:cxnSpMkLst>
        </pc:cxnChg>
        <pc:cxnChg chg="add mod">
          <ac:chgData name="Chew Leng Lim" userId="f4956819b06a5395" providerId="LiveId" clId="{64D1738D-F0F2-4F33-B73E-6056640154D5}" dt="2020-04-13T09:52:20.450" v="22187" actId="164"/>
          <ac:cxnSpMkLst>
            <pc:docMk/>
            <pc:sldMk cId="3170069621" sldId="364"/>
            <ac:cxnSpMk id="241" creationId="{990B9C53-3C57-4F6E-932F-3206E2B36250}"/>
          </ac:cxnSpMkLst>
        </pc:cxnChg>
      </pc:sldChg>
      <pc:sldChg chg="modSp add">
        <pc:chgData name="Chew Leng Lim" userId="f4956819b06a5395" providerId="LiveId" clId="{64D1738D-F0F2-4F33-B73E-6056640154D5}" dt="2020-04-13T11:59:28.130" v="34347" actId="6549"/>
        <pc:sldMkLst>
          <pc:docMk/>
          <pc:sldMk cId="3269692437" sldId="365"/>
        </pc:sldMkLst>
        <pc:spChg chg="mod">
          <ac:chgData name="Chew Leng Lim" userId="f4956819b06a5395" providerId="LiveId" clId="{64D1738D-F0F2-4F33-B73E-6056640154D5}" dt="2020-04-13T11:59:28.130" v="34347" actId="6549"/>
          <ac:spMkLst>
            <pc:docMk/>
            <pc:sldMk cId="3269692437" sldId="365"/>
            <ac:spMk id="2" creationId="{C496CA6B-71AE-4B3B-9EF5-2F1413B12F19}"/>
          </ac:spMkLst>
        </pc:spChg>
      </pc:sldChg>
      <pc:sldChg chg="addSp modSp add">
        <pc:chgData name="Chew Leng Lim" userId="f4956819b06a5395" providerId="LiveId" clId="{64D1738D-F0F2-4F33-B73E-6056640154D5}" dt="2020-04-13T10:49:25.062" v="27842" actId="1076"/>
        <pc:sldMkLst>
          <pc:docMk/>
          <pc:sldMk cId="1280494245" sldId="366"/>
        </pc:sldMkLst>
        <pc:spChg chg="add mod">
          <ac:chgData name="Chew Leng Lim" userId="f4956819b06a5395" providerId="LiveId" clId="{64D1738D-F0F2-4F33-B73E-6056640154D5}" dt="2020-04-13T10:49:25.062" v="27842" actId="1076"/>
          <ac:spMkLst>
            <pc:docMk/>
            <pc:sldMk cId="1280494245" sldId="366"/>
            <ac:spMk id="2" creationId="{8076C3F3-D9BF-4AE3-9649-932598BE5A98}"/>
          </ac:spMkLst>
        </pc:spChg>
      </pc:sldChg>
      <pc:sldChg chg="addSp delSp modSp add">
        <pc:chgData name="Chew Leng Lim" userId="f4956819b06a5395" providerId="LiveId" clId="{64D1738D-F0F2-4F33-B73E-6056640154D5}" dt="2020-04-14T11:53:35.220" v="34358" actId="207"/>
        <pc:sldMkLst>
          <pc:docMk/>
          <pc:sldMk cId="764140126" sldId="367"/>
        </pc:sldMkLst>
        <pc:spChg chg="mod">
          <ac:chgData name="Chew Leng Lim" userId="f4956819b06a5395" providerId="LiveId" clId="{64D1738D-F0F2-4F33-B73E-6056640154D5}" dt="2020-04-14T11:53:35.220" v="34358" actId="207"/>
          <ac:spMkLst>
            <pc:docMk/>
            <pc:sldMk cId="764140126" sldId="367"/>
            <ac:spMk id="2" creationId="{9006FD5F-E9F5-4916-8FD1-659895FDAA02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3" creationId="{B1EB761D-009A-45BA-BDE4-321E1811969C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4" creationId="{091A1140-239D-4884-80F6-39A578BC993A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5" creationId="{664BD555-5A2A-434F-9F90-A76B6AB950A9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6" creationId="{36BD451B-F8C1-4DC7-A709-C36066F89EEF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7" creationId="{CFAE22B7-DBEF-4705-8231-8008340F4204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8" creationId="{CEF3038D-1FF6-4163-9BE5-4F2568E4CA17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0" creationId="{FCB424C4-2B80-466D-A4DB-68CFC53BD9E2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3" creationId="{BE066DEF-AB19-425B-AF88-A78EA498CA5E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4" creationId="{B39D1C02-63B8-474C-AA07-DDBA020E1E7B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6" creationId="{E66FF22E-1403-46D9-BA93-58E08026AB77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7" creationId="{7104BCE7-79D7-40CD-8C69-0BE78A74D4BE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21" creationId="{81DB62B1-7594-4AB4-B7FF-87D4205D66AA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23" creationId="{4C626C22-C4E1-46A6-AB13-08AC1AD19F53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24" creationId="{6E45E83F-0FB7-44F7-B9A1-8087131B59C1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27" creationId="{560E41BE-7922-4BF5-8C66-5002001C1EC4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28" creationId="{381ACC3A-5B94-44B1-BBF9-9AB1AD4F50FE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30" creationId="{F9D92842-FAA8-4DEA-9C37-3B0DE560D75D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31" creationId="{56399EBB-EB9C-410E-8D63-67E8DB425759}"/>
          </ac:spMkLst>
        </pc:spChg>
        <pc:spChg chg="add mod">
          <ac:chgData name="Chew Leng Lim" userId="f4956819b06a5395" providerId="LiveId" clId="{64D1738D-F0F2-4F33-B73E-6056640154D5}" dt="2020-04-13T11:24:06.883" v="31966" actId="207"/>
          <ac:spMkLst>
            <pc:docMk/>
            <pc:sldMk cId="764140126" sldId="367"/>
            <ac:spMk id="32" creationId="{D96AB3C2-6106-421B-A50A-90DABE05B73F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34" creationId="{1D63DDED-3269-49BA-97C3-55DBC3D0F596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35" creationId="{67191531-B9AC-4875-A05C-8F0B05FCFA7F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36" creationId="{E901C42A-0FFE-4C5D-949E-86337E7AA2F0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42" creationId="{9AAA5F0C-1155-4471-949E-E04D9E612353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43" creationId="{0C55EA6C-BAD2-41D2-AC9C-EC3E29D1683C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44" creationId="{FA0A1F3D-18A8-4FC5-B730-8CA08C41C05E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45" creationId="{C9F651DD-6AE4-48E7-95C7-B51421E9A22E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46" creationId="{EEBBF98D-63B6-4299-A903-DAE21CF32B58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47" creationId="{8E7ECFCC-FBDC-4846-9DC0-0279A7D9FC38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49" creationId="{6A426DB6-2199-491E-9987-385CFB0EC68B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50" creationId="{33496F61-95E1-4923-9BBC-9F1EF1E94CC0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51" creationId="{1A245848-2B4E-4BFA-B85A-684FE3B08D67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54" creationId="{430C11B6-F69B-48D9-B04E-613F939CCA71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55" creationId="{80300288-28A8-4CA3-9778-D3043C17C90F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57" creationId="{F8586946-7F9B-4996-AD5D-F7C4AD100132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58" creationId="{9FBF6673-07D8-4339-8B68-7BCF00C49722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63" creationId="{2EEF564A-5D86-46D1-B071-EC0F842FE3BF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64" creationId="{2B1CB077-B485-40D6-9173-188E337DC0F5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67" creationId="{3A6FF504-3AC6-41CF-AC56-F1178C94F321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68" creationId="{3F534FC7-EC46-41C7-BB51-7BF63C2E14A4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70" creationId="{2FF886EC-FD5A-4A16-A0D5-9D63D850C54C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71" creationId="{D493F3E5-3904-45F8-8877-1C074F55CA21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74" creationId="{3A5BE36D-69DF-4455-8B6A-73F8C913392E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75" creationId="{A4674F1C-FD7E-474F-8217-9F90753F91D0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78" creationId="{E9B99D94-AC06-4BD1-ACD6-9F6B46C47C79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84" creationId="{F89B6B6C-AD07-4220-936E-D4AE1A5AF837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85" creationId="{37581823-B60D-46CB-A61B-1FFC814C9F83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86" creationId="{9F52A5E1-63DC-431D-820F-77B637AA0FF5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87" creationId="{A3529174-D284-4C37-8EC1-ED01FC176C0B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88" creationId="{A2070BD9-BDE3-46C6-83A5-18D16B05405A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90" creationId="{3CD640B7-F59B-4615-BC1C-6532C95C998C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91" creationId="{327C55C4-11AC-4FC2-97C6-E11DA5D64E30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94" creationId="{D8267FD7-BAEC-484B-8F56-2C55CCA054BD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95" creationId="{A0981889-8B65-46E0-BDC6-BADAF36C0876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96" creationId="{1DF1364A-FFB4-4463-8388-B6022B423D63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00" creationId="{CFC3A3A9-A13B-43C3-B397-FAA837AABE7A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02" creationId="{0FD24A21-6C9F-4825-B0AF-C4A4C23E8FC2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03" creationId="{69EB219C-4B99-4CAA-BB05-8C73B4E17992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06" creationId="{F9D038A8-E8DB-486F-9539-C64D908F9995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07" creationId="{A343873E-6CA9-4C00-86F6-2349A8B5CAA2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09" creationId="{EEDFD1AB-0937-4EE7-9009-797FFBE6A997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10" creationId="{6680781C-11FD-48EE-A575-2CB6A462E88A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11" creationId="{2005E05B-AD82-427A-8D17-3A882E5F925E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14" creationId="{B12BC90A-E1F3-402F-ACF2-1432767C2DA9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15" creationId="{B2006DAB-E193-40A6-923B-1ED448495DDE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16" creationId="{9460A5E8-DA84-4761-AD0A-3578D46E645B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19" creationId="{86AE4B32-571B-4F16-994D-F20CC1C3C9EF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22" creationId="{1DCE5A16-2B93-4EEF-9346-80E508AD7CBC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23" creationId="{712129D5-7C7F-459B-AF4D-4E136415E70B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24" creationId="{A9A31C55-1D93-45B0-808B-828137168FB5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26" creationId="{022DDA9F-8E9C-4AC6-9EA6-2B49255C8D30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27" creationId="{38D6BFFA-1309-45F6-9AA2-DA564BAF1B2C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28" creationId="{3C59C200-2488-4E62-9B0C-2D387857780A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29" creationId="{BB25C5F2-8D47-4391-86DC-8B9C667562E2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31" creationId="{3E8693AB-6882-4587-8DC3-866874AF849E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32" creationId="{EA542382-9747-4E03-9249-7B7CA088D741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33" creationId="{A7BBE4CD-65CD-46D0-891A-AC51D3ADEEA3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34" creationId="{80F9DA30-BCF3-4877-AC3A-6D0896EB02F5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35" creationId="{1FB06D5A-4FFF-4EBD-8B79-F09FAABF6051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37" creationId="{D320AD24-E4FF-40BE-AF1D-22238B614884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40" creationId="{3E90037C-293B-4361-A040-EC3648E308CC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41" creationId="{12918F8C-A095-4C51-BA68-C1D28B7F8E95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43" creationId="{1FD5575C-3912-48EB-842F-CE26ECD66E1C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44" creationId="{6F10942E-8CD1-4862-A122-2601C6709568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45" creationId="{9EDB8298-ADD8-44CD-A608-FFB71093EDCA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46" creationId="{A92697C3-5BF6-4188-80A9-BF751903E73E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47" creationId="{A85D46C9-833C-412D-B585-1813350F6F69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48" creationId="{DE5333C3-ABBB-4733-8EC8-C50504D926C0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50" creationId="{61108F21-3155-45DE-8B4A-332ACB3D577E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51" creationId="{1FCD2F2E-8426-4B36-A502-6D14FBEAFEA3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52" creationId="{56DDC5C5-EB2D-4124-901D-1BF98097CFAE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53" creationId="{CCBE019B-952D-4FE8-8C7B-F617D9291D43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54" creationId="{C0606CC8-03D5-46F1-92DB-EAD47B557A5A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55" creationId="{1517F0E8-54D3-4E68-B099-0FB216C8D56B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56" creationId="{0448E29C-0E99-4EAE-ACA2-AEA46215E72F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57" creationId="{FABAC4F7-84C0-4D52-AB45-D126CC744185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58" creationId="{D57F114C-69E9-421E-9EDF-3DD5F6175512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61" creationId="{CEE6DA04-F3CB-4415-804C-4F4EBA2FE4BA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63" creationId="{84961433-7947-4405-83A8-DCD6E7A94004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64" creationId="{4982EE15-7A9F-483C-8D54-25482E49DC97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65" creationId="{C1184470-3607-451E-B6C7-1A044FA7BD35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66" creationId="{2A121843-3413-4D5E-92D4-42CA663A77DA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67" creationId="{6C644F29-891C-43C6-8200-C73DC2BD3D05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68" creationId="{4C9FDB61-F2A0-4897-8FED-DA31F2626E8B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69" creationId="{D288B13F-4FBA-40B7-B7EC-6F378D290651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70" creationId="{C144520B-2A42-4EBC-A67F-39C5A072B4DB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71" creationId="{A385BEB5-09D7-4F41-9A83-E8A881F36093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72" creationId="{B27F6A30-6417-4B27-8BDA-777FBB3EE27F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74" creationId="{652F6836-1EC1-465F-8307-6A5891485866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75" creationId="{A7BE1676-B29C-4C0C-98F3-8F602F6B8E02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76" creationId="{4F264D27-DB82-41D9-9A59-6949805A197A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77" creationId="{1437F214-B409-4C43-8234-856FEAA07555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78" creationId="{0C9088CA-9CD7-4B52-A2EE-57323C725F82}"/>
          </ac:spMkLst>
        </pc:spChg>
        <pc:spChg chg="mod">
          <ac:chgData name="Chew Leng Lim" userId="f4956819b06a5395" providerId="LiveId" clId="{64D1738D-F0F2-4F33-B73E-6056640154D5}" dt="2020-04-13T11:26:09.318" v="32140" actId="1037"/>
          <ac:spMkLst>
            <pc:docMk/>
            <pc:sldMk cId="764140126" sldId="367"/>
            <ac:spMk id="180" creationId="{4AFFA86C-DAC4-4814-B1DB-FB63CBA541F7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81" creationId="{364BC1C6-3006-46DE-9444-672F58F27B50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82" creationId="{516361D7-FE82-46AF-B62F-8D52BC7E26F2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83" creationId="{864C9F62-4699-41F5-97C9-07E66F49098B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84" creationId="{C8EF24E5-AF47-41C9-9D20-2FC8307C8947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85" creationId="{EFBAC435-F28D-4BB7-ADFC-BCCDBFDD00E6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86" creationId="{F7EDED96-CC26-4D37-89DA-15AABA426DBC}"/>
          </ac:spMkLst>
        </pc:spChg>
        <pc:spChg chg="mod">
          <ac:chgData name="Chew Leng Lim" userId="f4956819b06a5395" providerId="LiveId" clId="{64D1738D-F0F2-4F33-B73E-6056640154D5}" dt="2020-04-13T11:26:09.318" v="32140" actId="1037"/>
          <ac:spMkLst>
            <pc:docMk/>
            <pc:sldMk cId="764140126" sldId="367"/>
            <ac:spMk id="188" creationId="{1F18F9E7-5B36-4312-9F8C-F4103EBA7523}"/>
          </ac:spMkLst>
        </pc:spChg>
        <pc:spChg chg="mod">
          <ac:chgData name="Chew Leng Lim" userId="f4956819b06a5395" providerId="LiveId" clId="{64D1738D-F0F2-4F33-B73E-6056640154D5}" dt="2020-04-13T11:26:09.318" v="32140" actId="1037"/>
          <ac:spMkLst>
            <pc:docMk/>
            <pc:sldMk cId="764140126" sldId="367"/>
            <ac:spMk id="189" creationId="{73DCFD1D-AA5A-431D-B1FE-3C894E39CCA9}"/>
          </ac:spMkLst>
        </pc:spChg>
        <pc:spChg chg="mod">
          <ac:chgData name="Chew Leng Lim" userId="f4956819b06a5395" providerId="LiveId" clId="{64D1738D-F0F2-4F33-B73E-6056640154D5}" dt="2020-04-13T11:26:09.318" v="32140" actId="1037"/>
          <ac:spMkLst>
            <pc:docMk/>
            <pc:sldMk cId="764140126" sldId="367"/>
            <ac:spMk id="190" creationId="{C080ABF3-948E-4739-A7B6-B7245F62CBAD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91" creationId="{74C6EC32-69C1-4F32-8E97-62A38A8471DD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92" creationId="{DD1F38DA-39CF-419C-A3C0-75C71EB8A13F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193" creationId="{9AE0567A-BE26-4FCE-B6D5-4B6B1723E1A5}"/>
          </ac:spMkLst>
        </pc:spChg>
        <pc:spChg chg="mod">
          <ac:chgData name="Chew Leng Lim" userId="f4956819b06a5395" providerId="LiveId" clId="{64D1738D-F0F2-4F33-B73E-6056640154D5}" dt="2020-04-13T11:26:09.318" v="32140" actId="1037"/>
          <ac:spMkLst>
            <pc:docMk/>
            <pc:sldMk cId="764140126" sldId="367"/>
            <ac:spMk id="198" creationId="{2B60FA06-7854-4756-BF96-FB245022C273}"/>
          </ac:spMkLst>
        </pc:spChg>
        <pc:spChg chg="mod">
          <ac:chgData name="Chew Leng Lim" userId="f4956819b06a5395" providerId="LiveId" clId="{64D1738D-F0F2-4F33-B73E-6056640154D5}" dt="2020-04-13T11:26:09.318" v="32140" actId="1037"/>
          <ac:spMkLst>
            <pc:docMk/>
            <pc:sldMk cId="764140126" sldId="367"/>
            <ac:spMk id="199" creationId="{1471560B-9DA4-4E41-B334-19A1A812D378}"/>
          </ac:spMkLst>
        </pc:spChg>
        <pc:spChg chg="mod">
          <ac:chgData name="Chew Leng Lim" userId="f4956819b06a5395" providerId="LiveId" clId="{64D1738D-F0F2-4F33-B73E-6056640154D5}" dt="2020-04-13T11:26:09.318" v="32140" actId="1037"/>
          <ac:spMkLst>
            <pc:docMk/>
            <pc:sldMk cId="764140126" sldId="367"/>
            <ac:spMk id="200" creationId="{91934FD5-6C35-4118-85E2-B0B8B4360691}"/>
          </ac:spMkLst>
        </pc:spChg>
        <pc:spChg chg="mod">
          <ac:chgData name="Chew Leng Lim" userId="f4956819b06a5395" providerId="LiveId" clId="{64D1738D-F0F2-4F33-B73E-6056640154D5}" dt="2020-04-13T11:26:09.318" v="32140" actId="1037"/>
          <ac:spMkLst>
            <pc:docMk/>
            <pc:sldMk cId="764140126" sldId="367"/>
            <ac:spMk id="201" creationId="{057BF96E-3C81-42A1-8EBA-6D224EA22725}"/>
          </ac:spMkLst>
        </pc:spChg>
        <pc:spChg chg="mod">
          <ac:chgData name="Chew Leng Lim" userId="f4956819b06a5395" providerId="LiveId" clId="{64D1738D-F0F2-4F33-B73E-6056640154D5}" dt="2020-04-13T11:26:09.318" v="32140" actId="1037"/>
          <ac:spMkLst>
            <pc:docMk/>
            <pc:sldMk cId="764140126" sldId="367"/>
            <ac:spMk id="202" creationId="{632ABA68-1FB1-477E-93EB-7FCF7DEBB9CB}"/>
          </ac:spMkLst>
        </pc:spChg>
        <pc:spChg chg="mod">
          <ac:chgData name="Chew Leng Lim" userId="f4956819b06a5395" providerId="LiveId" clId="{64D1738D-F0F2-4F33-B73E-6056640154D5}" dt="2020-04-13T11:26:09.318" v="32140" actId="1037"/>
          <ac:spMkLst>
            <pc:docMk/>
            <pc:sldMk cId="764140126" sldId="367"/>
            <ac:spMk id="203" creationId="{4D00FB6E-5132-41EF-AF26-CFA1D692B722}"/>
          </ac:spMkLst>
        </pc:spChg>
        <pc:spChg chg="mod">
          <ac:chgData name="Chew Leng Lim" userId="f4956819b06a5395" providerId="LiveId" clId="{64D1738D-F0F2-4F33-B73E-6056640154D5}" dt="2020-04-13T11:26:09.318" v="32140" actId="1037"/>
          <ac:spMkLst>
            <pc:docMk/>
            <pc:sldMk cId="764140126" sldId="367"/>
            <ac:spMk id="204" creationId="{E652C887-51EB-4769-B0B6-4D871AB9EFF4}"/>
          </ac:spMkLst>
        </pc:spChg>
        <pc:spChg chg="mod">
          <ac:chgData name="Chew Leng Lim" userId="f4956819b06a5395" providerId="LiveId" clId="{64D1738D-F0F2-4F33-B73E-6056640154D5}" dt="2020-04-13T11:26:09.318" v="32140" actId="1037"/>
          <ac:spMkLst>
            <pc:docMk/>
            <pc:sldMk cId="764140126" sldId="367"/>
            <ac:spMk id="205" creationId="{31DBCB29-6BFE-4CD8-9934-7DF03EC211DF}"/>
          </ac:spMkLst>
        </pc:spChg>
        <pc:spChg chg="mod">
          <ac:chgData name="Chew Leng Lim" userId="f4956819b06a5395" providerId="LiveId" clId="{64D1738D-F0F2-4F33-B73E-6056640154D5}" dt="2020-04-13T11:26:09.318" v="32140" actId="1037"/>
          <ac:spMkLst>
            <pc:docMk/>
            <pc:sldMk cId="764140126" sldId="367"/>
            <ac:spMk id="206" creationId="{4BC1752A-6B0A-42A8-AB7E-A465BC6AECE6}"/>
          </ac:spMkLst>
        </pc:spChg>
        <pc:spChg chg="mod">
          <ac:chgData name="Chew Leng Lim" userId="f4956819b06a5395" providerId="LiveId" clId="{64D1738D-F0F2-4F33-B73E-6056640154D5}" dt="2020-04-13T11:26:09.318" v="32140" actId="1037"/>
          <ac:spMkLst>
            <pc:docMk/>
            <pc:sldMk cId="764140126" sldId="367"/>
            <ac:spMk id="208" creationId="{40D0F1B1-EEDF-427A-A25C-F60107B9DFA2}"/>
          </ac:spMkLst>
        </pc:spChg>
        <pc:spChg chg="mod">
          <ac:chgData name="Chew Leng Lim" userId="f4956819b06a5395" providerId="LiveId" clId="{64D1738D-F0F2-4F33-B73E-6056640154D5}" dt="2020-04-13T11:26:09.318" v="32140" actId="1037"/>
          <ac:spMkLst>
            <pc:docMk/>
            <pc:sldMk cId="764140126" sldId="367"/>
            <ac:spMk id="209" creationId="{D67623EE-F041-42EC-9E9A-EF5E20423830}"/>
          </ac:spMkLst>
        </pc:spChg>
        <pc:spChg chg="mod">
          <ac:chgData name="Chew Leng Lim" userId="f4956819b06a5395" providerId="LiveId" clId="{64D1738D-F0F2-4F33-B73E-6056640154D5}" dt="2020-04-13T11:26:09.318" v="32140" actId="1037"/>
          <ac:spMkLst>
            <pc:docMk/>
            <pc:sldMk cId="764140126" sldId="367"/>
            <ac:spMk id="210" creationId="{E047A7C0-5DC3-4BCA-8383-62DA2F959AF5}"/>
          </ac:spMkLst>
        </pc:spChg>
        <pc:spChg chg="mod">
          <ac:chgData name="Chew Leng Lim" userId="f4956819b06a5395" providerId="LiveId" clId="{64D1738D-F0F2-4F33-B73E-6056640154D5}" dt="2020-04-13T11:26:09.318" v="32140" actId="1037"/>
          <ac:spMkLst>
            <pc:docMk/>
            <pc:sldMk cId="764140126" sldId="367"/>
            <ac:spMk id="211" creationId="{5CBCF310-A35E-46EE-8897-4DD4098D853A}"/>
          </ac:spMkLst>
        </pc:spChg>
        <pc:spChg chg="mod">
          <ac:chgData name="Chew Leng Lim" userId="f4956819b06a5395" providerId="LiveId" clId="{64D1738D-F0F2-4F33-B73E-6056640154D5}" dt="2020-04-13T11:26:09.318" v="32140" actId="1037"/>
          <ac:spMkLst>
            <pc:docMk/>
            <pc:sldMk cId="764140126" sldId="367"/>
            <ac:spMk id="212" creationId="{55AD4BEA-251E-437F-B34A-B6363AAC7C83}"/>
          </ac:spMkLst>
        </pc:spChg>
        <pc:spChg chg="mod">
          <ac:chgData name="Chew Leng Lim" userId="f4956819b06a5395" providerId="LiveId" clId="{64D1738D-F0F2-4F33-B73E-6056640154D5}" dt="2020-04-13T11:26:09.318" v="32140" actId="1037"/>
          <ac:spMkLst>
            <pc:docMk/>
            <pc:sldMk cId="764140126" sldId="367"/>
            <ac:spMk id="213" creationId="{4832DC4D-253E-417D-BEA3-453C1D950574}"/>
          </ac:spMkLst>
        </pc:spChg>
        <pc:spChg chg="mod">
          <ac:chgData name="Chew Leng Lim" userId="f4956819b06a5395" providerId="LiveId" clId="{64D1738D-F0F2-4F33-B73E-6056640154D5}" dt="2020-04-13T11:26:09.318" v="32140" actId="1037"/>
          <ac:spMkLst>
            <pc:docMk/>
            <pc:sldMk cId="764140126" sldId="367"/>
            <ac:spMk id="214" creationId="{A0A7DABB-46A8-45F2-9D89-F443E33103CF}"/>
          </ac:spMkLst>
        </pc:spChg>
        <pc:spChg chg="mod">
          <ac:chgData name="Chew Leng Lim" userId="f4956819b06a5395" providerId="LiveId" clId="{64D1738D-F0F2-4F33-B73E-6056640154D5}" dt="2020-04-13T11:26:09.318" v="32140" actId="1037"/>
          <ac:spMkLst>
            <pc:docMk/>
            <pc:sldMk cId="764140126" sldId="367"/>
            <ac:spMk id="215" creationId="{70CC0F91-4971-4F86-83CE-64EB5CEB57F1}"/>
          </ac:spMkLst>
        </pc:spChg>
        <pc:spChg chg="mod">
          <ac:chgData name="Chew Leng Lim" userId="f4956819b06a5395" providerId="LiveId" clId="{64D1738D-F0F2-4F33-B73E-6056640154D5}" dt="2020-04-13T11:26:09.318" v="32140" actId="1037"/>
          <ac:spMkLst>
            <pc:docMk/>
            <pc:sldMk cId="764140126" sldId="367"/>
            <ac:spMk id="217" creationId="{02AB3F56-2CD5-4824-9188-404131462A5F}"/>
          </ac:spMkLst>
        </pc:spChg>
        <pc:spChg chg="del">
          <ac:chgData name="Chew Leng Lim" userId="f4956819b06a5395" providerId="LiveId" clId="{64D1738D-F0F2-4F33-B73E-6056640154D5}" dt="2020-04-13T11:16:25.372" v="31755" actId="478"/>
          <ac:spMkLst>
            <pc:docMk/>
            <pc:sldMk cId="764140126" sldId="367"/>
            <ac:spMk id="219" creationId="{E0C90124-43D3-48FD-A020-9F11BD7C1345}"/>
          </ac:spMkLst>
        </pc:spChg>
        <pc:spChg chg="del">
          <ac:chgData name="Chew Leng Lim" userId="f4956819b06a5395" providerId="LiveId" clId="{64D1738D-F0F2-4F33-B73E-6056640154D5}" dt="2020-04-13T11:16:23.305" v="31754" actId="478"/>
          <ac:spMkLst>
            <pc:docMk/>
            <pc:sldMk cId="764140126" sldId="367"/>
            <ac:spMk id="220" creationId="{0914CC85-5863-4BD7-BAFC-D3A61F9DA227}"/>
          </ac:spMkLst>
        </pc:spChg>
        <pc:spChg chg="del">
          <ac:chgData name="Chew Leng Lim" userId="f4956819b06a5395" providerId="LiveId" clId="{64D1738D-F0F2-4F33-B73E-6056640154D5}" dt="2020-04-13T11:17:25.956" v="31760" actId="478"/>
          <ac:spMkLst>
            <pc:docMk/>
            <pc:sldMk cId="764140126" sldId="367"/>
            <ac:spMk id="221" creationId="{46B2A587-3C33-4243-A75D-CF39DF665B9E}"/>
          </ac:spMkLst>
        </pc:spChg>
        <pc:spChg chg="add mod">
          <ac:chgData name="Chew Leng Lim" userId="f4956819b06a5395" providerId="LiveId" clId="{64D1738D-F0F2-4F33-B73E-6056640154D5}" dt="2020-04-13T11:23:22.254" v="31946" actId="164"/>
          <ac:spMkLst>
            <pc:docMk/>
            <pc:sldMk cId="764140126" sldId="367"/>
            <ac:spMk id="244" creationId="{7F4D7A4C-1DBA-417F-9ED5-7D314F524E07}"/>
          </ac:spMkLst>
        </pc:spChg>
        <pc:spChg chg="add mod">
          <ac:chgData name="Chew Leng Lim" userId="f4956819b06a5395" providerId="LiveId" clId="{64D1738D-F0F2-4F33-B73E-6056640154D5}" dt="2020-04-13T11:23:22.254" v="31946" actId="164"/>
          <ac:spMkLst>
            <pc:docMk/>
            <pc:sldMk cId="764140126" sldId="367"/>
            <ac:spMk id="245" creationId="{0E71C340-6E19-4D4B-A484-B098B893A420}"/>
          </ac:spMkLst>
        </pc:spChg>
        <pc:spChg chg="add mod">
          <ac:chgData name="Chew Leng Lim" userId="f4956819b06a5395" providerId="LiveId" clId="{64D1738D-F0F2-4F33-B73E-6056640154D5}" dt="2020-04-13T11:23:22.254" v="31946" actId="164"/>
          <ac:spMkLst>
            <pc:docMk/>
            <pc:sldMk cId="764140126" sldId="367"/>
            <ac:spMk id="246" creationId="{80195F44-EA0B-4284-BC2D-6861EF1631F2}"/>
          </ac:spMkLst>
        </pc:spChg>
        <pc:spChg chg="add mod">
          <ac:chgData name="Chew Leng Lim" userId="f4956819b06a5395" providerId="LiveId" clId="{64D1738D-F0F2-4F33-B73E-6056640154D5}" dt="2020-04-13T11:23:22.254" v="31946" actId="164"/>
          <ac:spMkLst>
            <pc:docMk/>
            <pc:sldMk cId="764140126" sldId="367"/>
            <ac:spMk id="247" creationId="{0EE8C542-57A1-4ED9-A0A0-3603092B50F9}"/>
          </ac:spMkLst>
        </pc:spChg>
        <pc:spChg chg="add mod">
          <ac:chgData name="Chew Leng Lim" userId="f4956819b06a5395" providerId="LiveId" clId="{64D1738D-F0F2-4F33-B73E-6056640154D5}" dt="2020-04-13T11:23:22.254" v="31946" actId="164"/>
          <ac:spMkLst>
            <pc:docMk/>
            <pc:sldMk cId="764140126" sldId="367"/>
            <ac:spMk id="251" creationId="{7EC0AD4B-7BF1-4792-9B60-FAF0891AD0D6}"/>
          </ac:spMkLst>
        </pc:spChg>
        <pc:spChg chg="add mod">
          <ac:chgData name="Chew Leng Lim" userId="f4956819b06a5395" providerId="LiveId" clId="{64D1738D-F0F2-4F33-B73E-6056640154D5}" dt="2020-04-13T11:23:22.254" v="31946" actId="164"/>
          <ac:spMkLst>
            <pc:docMk/>
            <pc:sldMk cId="764140126" sldId="367"/>
            <ac:spMk id="252" creationId="{DBAE9FCD-4FFE-4DFF-885E-B7789EE45F21}"/>
          </ac:spMkLst>
        </pc:spChg>
        <pc:spChg chg="add mod">
          <ac:chgData name="Chew Leng Lim" userId="f4956819b06a5395" providerId="LiveId" clId="{64D1738D-F0F2-4F33-B73E-6056640154D5}" dt="2020-04-13T11:23:22.254" v="31946" actId="164"/>
          <ac:spMkLst>
            <pc:docMk/>
            <pc:sldMk cId="764140126" sldId="367"/>
            <ac:spMk id="253" creationId="{27D63036-6601-4597-917F-634E0C45C17E}"/>
          </ac:spMkLst>
        </pc:spChg>
        <pc:spChg chg="add mod">
          <ac:chgData name="Chew Leng Lim" userId="f4956819b06a5395" providerId="LiveId" clId="{64D1738D-F0F2-4F33-B73E-6056640154D5}" dt="2020-04-13T11:23:22.254" v="31946" actId="164"/>
          <ac:spMkLst>
            <pc:docMk/>
            <pc:sldMk cId="764140126" sldId="367"/>
            <ac:spMk id="254" creationId="{B5CB06B1-67E0-4D72-981A-7E60072E41E2}"/>
          </ac:spMkLst>
        </pc:spChg>
        <pc:grpChg chg="mod">
          <ac:chgData name="Chew Leng Lim" userId="f4956819b06a5395" providerId="LiveId" clId="{64D1738D-F0F2-4F33-B73E-6056640154D5}" dt="2020-04-13T11:16:55.053" v="31757" actId="338"/>
          <ac:grpSpMkLst>
            <pc:docMk/>
            <pc:sldMk cId="764140126" sldId="367"/>
            <ac:grpSpMk id="11" creationId="{C7AF07B9-19BE-44E0-899C-B0F343611AA0}"/>
          </ac:grpSpMkLst>
        </pc:grpChg>
        <pc:grpChg chg="del">
          <ac:chgData name="Chew Leng Lim" userId="f4956819b06a5395" providerId="LiveId" clId="{64D1738D-F0F2-4F33-B73E-6056640154D5}" dt="2020-04-13T11:16:23.305" v="31754" actId="478"/>
          <ac:grpSpMkLst>
            <pc:docMk/>
            <pc:sldMk cId="764140126" sldId="367"/>
            <ac:grpSpMk id="222" creationId="{DBDB863B-E43A-4E15-8E3E-C37AF6F58A93}"/>
          </ac:grpSpMkLst>
        </pc:grpChg>
        <pc:grpChg chg="add mod">
          <ac:chgData name="Chew Leng Lim" userId="f4956819b06a5395" providerId="LiveId" clId="{64D1738D-F0F2-4F33-B73E-6056640154D5}" dt="2020-04-13T11:26:09.318" v="32140" actId="1037"/>
          <ac:grpSpMkLst>
            <pc:docMk/>
            <pc:sldMk cId="764140126" sldId="367"/>
            <ac:grpSpMk id="255" creationId="{BA18EA7C-2782-428E-AFF8-E6CD40EEC0FC}"/>
          </ac:grpSpMkLst>
        </pc:grpChg>
        <pc:graphicFrameChg chg="del">
          <ac:chgData name="Chew Leng Lim" userId="f4956819b06a5395" providerId="LiveId" clId="{64D1738D-F0F2-4F33-B73E-6056640154D5}" dt="2020-04-13T11:16:23.305" v="31754" actId="478"/>
          <ac:graphicFrameMkLst>
            <pc:docMk/>
            <pc:sldMk cId="764140126" sldId="367"/>
            <ac:graphicFrameMk id="9" creationId="{375A63CD-F656-4DBC-9E97-A61C06BB2E31}"/>
          </ac:graphicFrameMkLst>
        </pc:graphicFrameChg>
        <pc:graphicFrameChg chg="del">
          <ac:chgData name="Chew Leng Lim" userId="f4956819b06a5395" providerId="LiveId" clId="{64D1738D-F0F2-4F33-B73E-6056640154D5}" dt="2020-04-13T11:16:23.305" v="31754" actId="478"/>
          <ac:graphicFrameMkLst>
            <pc:docMk/>
            <pc:sldMk cId="764140126" sldId="367"/>
            <ac:graphicFrameMk id="22" creationId="{9192B6A1-B55C-48E3-9921-8CD99B6B94DA}"/>
          </ac:graphicFrameMkLst>
        </pc:graphicFrameChg>
        <pc:graphicFrameChg chg="del">
          <ac:chgData name="Chew Leng Lim" userId="f4956819b06a5395" providerId="LiveId" clId="{64D1738D-F0F2-4F33-B73E-6056640154D5}" dt="2020-04-13T11:16:23.305" v="31754" actId="478"/>
          <ac:graphicFrameMkLst>
            <pc:docMk/>
            <pc:sldMk cId="764140126" sldId="367"/>
            <ac:graphicFrameMk id="29" creationId="{92B9AA66-63B5-4DCD-ACF0-8CA676ECBA45}"/>
          </ac:graphicFrameMkLst>
        </pc:graphicFrameChg>
        <pc:graphicFrameChg chg="del">
          <ac:chgData name="Chew Leng Lim" userId="f4956819b06a5395" providerId="LiveId" clId="{64D1738D-F0F2-4F33-B73E-6056640154D5}" dt="2020-04-13T11:16:23.305" v="31754" actId="478"/>
          <ac:graphicFrameMkLst>
            <pc:docMk/>
            <pc:sldMk cId="764140126" sldId="367"/>
            <ac:graphicFrameMk id="39" creationId="{CFB8996B-BAE9-4475-9AD5-ED75A7BD9375}"/>
          </ac:graphicFrameMkLst>
        </pc:graphicFrameChg>
        <pc:graphicFrameChg chg="del">
          <ac:chgData name="Chew Leng Lim" userId="f4956819b06a5395" providerId="LiveId" clId="{64D1738D-F0F2-4F33-B73E-6056640154D5}" dt="2020-04-13T11:16:23.305" v="31754" actId="478"/>
          <ac:graphicFrameMkLst>
            <pc:docMk/>
            <pc:sldMk cId="764140126" sldId="367"/>
            <ac:graphicFrameMk id="48" creationId="{61777650-55B6-468A-89D8-A1A2EBDBCAEC}"/>
          </ac:graphicFrameMkLst>
        </pc:graphicFrameChg>
        <pc:graphicFrameChg chg="del">
          <ac:chgData name="Chew Leng Lim" userId="f4956819b06a5395" providerId="LiveId" clId="{64D1738D-F0F2-4F33-B73E-6056640154D5}" dt="2020-04-13T11:16:23.305" v="31754" actId="478"/>
          <ac:graphicFrameMkLst>
            <pc:docMk/>
            <pc:sldMk cId="764140126" sldId="367"/>
            <ac:graphicFrameMk id="62" creationId="{21841224-7521-45E0-8542-8ED7746FDC31}"/>
          </ac:graphicFrameMkLst>
        </pc:graphicFrameChg>
        <pc:graphicFrameChg chg="del">
          <ac:chgData name="Chew Leng Lim" userId="f4956819b06a5395" providerId="LiveId" clId="{64D1738D-F0F2-4F33-B73E-6056640154D5}" dt="2020-04-13T11:16:23.305" v="31754" actId="478"/>
          <ac:graphicFrameMkLst>
            <pc:docMk/>
            <pc:sldMk cId="764140126" sldId="367"/>
            <ac:graphicFrameMk id="69" creationId="{4C9F6713-4A5D-4F1A-B9B8-B787BDB6E6E6}"/>
          </ac:graphicFrameMkLst>
        </pc:graphicFrameChg>
        <pc:graphicFrameChg chg="del">
          <ac:chgData name="Chew Leng Lim" userId="f4956819b06a5395" providerId="LiveId" clId="{64D1738D-F0F2-4F33-B73E-6056640154D5}" dt="2020-04-13T11:16:23.305" v="31754" actId="478"/>
          <ac:graphicFrameMkLst>
            <pc:docMk/>
            <pc:sldMk cId="764140126" sldId="367"/>
            <ac:graphicFrameMk id="81" creationId="{C577B973-8769-497E-9527-BF70FD3C81F5}"/>
          </ac:graphicFrameMkLst>
        </pc:graphicFrameChg>
        <pc:graphicFrameChg chg="del">
          <ac:chgData name="Chew Leng Lim" userId="f4956819b06a5395" providerId="LiveId" clId="{64D1738D-F0F2-4F33-B73E-6056640154D5}" dt="2020-04-13T11:16:23.305" v="31754" actId="478"/>
          <ac:graphicFrameMkLst>
            <pc:docMk/>
            <pc:sldMk cId="764140126" sldId="367"/>
            <ac:graphicFrameMk id="89" creationId="{F12495DD-6928-4DC5-9F54-D9B81C965D7B}"/>
          </ac:graphicFrameMkLst>
        </pc:graphicFrameChg>
        <pc:graphicFrameChg chg="del">
          <ac:chgData name="Chew Leng Lim" userId="f4956819b06a5395" providerId="LiveId" clId="{64D1738D-F0F2-4F33-B73E-6056640154D5}" dt="2020-04-13T11:16:23.305" v="31754" actId="478"/>
          <ac:graphicFrameMkLst>
            <pc:docMk/>
            <pc:sldMk cId="764140126" sldId="367"/>
            <ac:graphicFrameMk id="101" creationId="{B8F94947-963D-4F88-933D-1B1963CD9073}"/>
          </ac:graphicFrameMkLst>
        </pc:graphicFrameChg>
        <pc:graphicFrameChg chg="del">
          <ac:chgData name="Chew Leng Lim" userId="f4956819b06a5395" providerId="LiveId" clId="{64D1738D-F0F2-4F33-B73E-6056640154D5}" dt="2020-04-13T11:16:23.305" v="31754" actId="478"/>
          <ac:graphicFrameMkLst>
            <pc:docMk/>
            <pc:sldMk cId="764140126" sldId="367"/>
            <ac:graphicFrameMk id="108" creationId="{9A7447DA-9CB3-40D0-A537-B5E2AD101C31}"/>
          </ac:graphicFrameMkLst>
        </pc:graphicFrameChg>
        <pc:graphicFrameChg chg="del">
          <ac:chgData name="Chew Leng Lim" userId="f4956819b06a5395" providerId="LiveId" clId="{64D1738D-F0F2-4F33-B73E-6056640154D5}" dt="2020-04-13T11:16:23.305" v="31754" actId="478"/>
          <ac:graphicFrameMkLst>
            <pc:docMk/>
            <pc:sldMk cId="764140126" sldId="367"/>
            <ac:graphicFrameMk id="118" creationId="{A42F715F-C125-4B47-A51F-0858B121F7B7}"/>
          </ac:graphicFrameMkLst>
        </pc:graphicFrameChg>
        <pc:graphicFrameChg chg="del">
          <ac:chgData name="Chew Leng Lim" userId="f4956819b06a5395" providerId="LiveId" clId="{64D1738D-F0F2-4F33-B73E-6056640154D5}" dt="2020-04-13T11:16:23.305" v="31754" actId="478"/>
          <ac:graphicFrameMkLst>
            <pc:docMk/>
            <pc:sldMk cId="764140126" sldId="367"/>
            <ac:graphicFrameMk id="125" creationId="{4C93C5FB-CC3C-4F3A-97B6-ED0C0E763C80}"/>
          </ac:graphicFrameMkLst>
        </pc:graphicFrameChg>
        <pc:graphicFrameChg chg="del">
          <ac:chgData name="Chew Leng Lim" userId="f4956819b06a5395" providerId="LiveId" clId="{64D1738D-F0F2-4F33-B73E-6056640154D5}" dt="2020-04-13T11:16:23.305" v="31754" actId="478"/>
          <ac:graphicFrameMkLst>
            <pc:docMk/>
            <pc:sldMk cId="764140126" sldId="367"/>
            <ac:graphicFrameMk id="130" creationId="{F24897CD-E322-4721-939E-E4D75D01BA58}"/>
          </ac:graphicFrameMkLst>
        </pc:graphicFrameChg>
        <pc:graphicFrameChg chg="del">
          <ac:chgData name="Chew Leng Lim" userId="f4956819b06a5395" providerId="LiveId" clId="{64D1738D-F0F2-4F33-B73E-6056640154D5}" dt="2020-04-13T11:16:23.305" v="31754" actId="478"/>
          <ac:graphicFrameMkLst>
            <pc:docMk/>
            <pc:sldMk cId="764140126" sldId="367"/>
            <ac:graphicFrameMk id="142" creationId="{9FDD7051-D3F9-4D7C-91C8-2C78F51E90A5}"/>
          </ac:graphicFrameMkLst>
        </pc:graphicFrameChg>
        <pc:graphicFrameChg chg="del">
          <ac:chgData name="Chew Leng Lim" userId="f4956819b06a5395" providerId="LiveId" clId="{64D1738D-F0F2-4F33-B73E-6056640154D5}" dt="2020-04-13T11:16:23.305" v="31754" actId="478"/>
          <ac:graphicFrameMkLst>
            <pc:docMk/>
            <pc:sldMk cId="764140126" sldId="367"/>
            <ac:graphicFrameMk id="149" creationId="{8419D0EB-134E-4ECA-AB18-8C8305154235}"/>
          </ac:graphicFrameMkLst>
        </pc:graphicFrameChg>
        <pc:graphicFrameChg chg="del">
          <ac:chgData name="Chew Leng Lim" userId="f4956819b06a5395" providerId="LiveId" clId="{64D1738D-F0F2-4F33-B73E-6056640154D5}" dt="2020-04-13T11:16:23.305" v="31754" actId="478"/>
          <ac:graphicFrameMkLst>
            <pc:docMk/>
            <pc:sldMk cId="764140126" sldId="367"/>
            <ac:graphicFrameMk id="160" creationId="{59BB64B7-EDD3-4AEC-B4AC-125AC3B07835}"/>
          </ac:graphicFrameMkLst>
        </pc:graphicFrameChg>
        <pc:graphicFrameChg chg="del">
          <ac:chgData name="Chew Leng Lim" userId="f4956819b06a5395" providerId="LiveId" clId="{64D1738D-F0F2-4F33-B73E-6056640154D5}" dt="2020-04-13T11:16:23.305" v="31754" actId="478"/>
          <ac:graphicFrameMkLst>
            <pc:docMk/>
            <pc:sldMk cId="764140126" sldId="367"/>
            <ac:graphicFrameMk id="162" creationId="{B27476D0-F5EA-4EAA-86F0-EAD21D7C2D39}"/>
          </ac:graphicFrameMkLst>
        </pc:graphicFrameChg>
        <pc:graphicFrameChg chg="del">
          <ac:chgData name="Chew Leng Lim" userId="f4956819b06a5395" providerId="LiveId" clId="{64D1738D-F0F2-4F33-B73E-6056640154D5}" dt="2020-04-13T11:16:23.305" v="31754" actId="478"/>
          <ac:graphicFrameMkLst>
            <pc:docMk/>
            <pc:sldMk cId="764140126" sldId="367"/>
            <ac:graphicFrameMk id="173" creationId="{0ABCEB06-8F66-42CF-B5CD-401D1A3BBC19}"/>
          </ac:graphicFrameMkLst>
        </pc:graphicFrameChg>
        <pc:graphicFrameChg chg="del">
          <ac:chgData name="Chew Leng Lim" userId="f4956819b06a5395" providerId="LiveId" clId="{64D1738D-F0F2-4F33-B73E-6056640154D5}" dt="2020-04-13T11:16:23.305" v="31754" actId="478"/>
          <ac:graphicFrameMkLst>
            <pc:docMk/>
            <pc:sldMk cId="764140126" sldId="367"/>
            <ac:graphicFrameMk id="179" creationId="{D3E80071-9011-4EA2-8BEB-95398F46BD4D}"/>
          </ac:graphicFrameMkLst>
        </pc:graphicFrameChg>
        <pc:graphicFrameChg chg="mod">
          <ac:chgData name="Chew Leng Lim" userId="f4956819b06a5395" providerId="LiveId" clId="{64D1738D-F0F2-4F33-B73E-6056640154D5}" dt="2020-04-13T11:26:09.318" v="32140" actId="1037"/>
          <ac:graphicFrameMkLst>
            <pc:docMk/>
            <pc:sldMk cId="764140126" sldId="367"/>
            <ac:graphicFrameMk id="187" creationId="{7ED028A1-7FC3-40FF-B4BF-60826291F08D}"/>
          </ac:graphicFrameMkLst>
        </pc:graphicFrameChg>
        <pc:picChg chg="add del mod">
          <ac:chgData name="Chew Leng Lim" userId="f4956819b06a5395" providerId="LiveId" clId="{64D1738D-F0F2-4F33-B73E-6056640154D5}" dt="2020-04-13T11:21:44.774" v="31879" actId="478"/>
          <ac:picMkLst>
            <pc:docMk/>
            <pc:sldMk cId="764140126" sldId="367"/>
            <ac:picMk id="218" creationId="{DDC34DFB-87CC-48CC-B25A-9626100A217C}"/>
          </ac:picMkLst>
        </pc:picChg>
        <pc:picChg chg="add del mod">
          <ac:chgData name="Chew Leng Lim" userId="f4956819b06a5395" providerId="LiveId" clId="{64D1738D-F0F2-4F33-B73E-6056640154D5}" dt="2020-04-13T11:19:37.802" v="31856" actId="478"/>
          <ac:picMkLst>
            <pc:docMk/>
            <pc:sldMk cId="764140126" sldId="367"/>
            <ac:picMk id="248" creationId="{BEAF2E6D-20ED-4215-86EB-75AD96DFB94A}"/>
          </ac:picMkLst>
        </pc:picChg>
        <pc:picChg chg="add del mod modCrop">
          <ac:chgData name="Chew Leng Lim" userId="f4956819b06a5395" providerId="LiveId" clId="{64D1738D-F0F2-4F33-B73E-6056640154D5}" dt="2020-04-13T11:19:33.961" v="31855" actId="478"/>
          <ac:picMkLst>
            <pc:docMk/>
            <pc:sldMk cId="764140126" sldId="367"/>
            <ac:picMk id="249" creationId="{6F0BBC22-5C82-4ECB-A738-3D3260AFB220}"/>
          </ac:picMkLst>
        </pc:picChg>
        <pc:picChg chg="add del mod">
          <ac:chgData name="Chew Leng Lim" userId="f4956819b06a5395" providerId="LiveId" clId="{64D1738D-F0F2-4F33-B73E-6056640154D5}" dt="2020-04-13T11:19:37.802" v="31856" actId="478"/>
          <ac:picMkLst>
            <pc:docMk/>
            <pc:sldMk cId="764140126" sldId="367"/>
            <ac:picMk id="250" creationId="{890B1666-3179-46CD-9454-92C91804C685}"/>
          </ac:picMkLst>
        </pc:picChg>
        <pc:cxnChg chg="del">
          <ac:chgData name="Chew Leng Lim" userId="f4956819b06a5395" providerId="LiveId" clId="{64D1738D-F0F2-4F33-B73E-6056640154D5}" dt="2020-04-13T11:16:23.305" v="31754" actId="478"/>
          <ac:cxnSpMkLst>
            <pc:docMk/>
            <pc:sldMk cId="764140126" sldId="367"/>
            <ac:cxnSpMk id="207" creationId="{C7CF3A41-4A22-4F9B-84DA-F035BD072310}"/>
          </ac:cxnSpMkLst>
        </pc:cxnChg>
        <pc:cxnChg chg="del">
          <ac:chgData name="Chew Leng Lim" userId="f4956819b06a5395" providerId="LiveId" clId="{64D1738D-F0F2-4F33-B73E-6056640154D5}" dt="2020-04-13T11:16:23.305" v="31754" actId="478"/>
          <ac:cxnSpMkLst>
            <pc:docMk/>
            <pc:sldMk cId="764140126" sldId="367"/>
            <ac:cxnSpMk id="216" creationId="{E54E1B68-3959-4B7D-B03F-D487442470C7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SG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59A548F-6EE2-427C-999E-265E1FC541E0}" type="datetimeFigureOut">
              <a:rPr lang="en-SG" smtClean="0"/>
              <a:t>2/8/2021</a:t>
            </a:fld>
            <a:endParaRPr lang="en-SG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SG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81F60A-8B70-42D6-A302-B62DF2430768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523292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SG" dirty="0"/>
              <a:t>Tumour burden increases the % of neutrophils (out of live CD45+ population) in the circulation as compared to non-tumour burdened mice in both involuting and nulliparous animals</a:t>
            </a:r>
          </a:p>
          <a:p>
            <a:endParaRPr lang="en-SG" dirty="0"/>
          </a:p>
          <a:p>
            <a:r>
              <a:rPr lang="en-SG" dirty="0"/>
              <a:t>With estrogen treatment, the % of neutrophils in the tumour burden mice reduces as compared to non treated controls</a:t>
            </a:r>
          </a:p>
          <a:p>
            <a:endParaRPr lang="en-SG" dirty="0"/>
          </a:p>
          <a:p>
            <a:endParaRPr lang="en-SG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dirty="0"/>
              <a:t>**Representative flow cytometry dot plot of %LY6G+ CD11b+ cell population out of viable CD45+ cells from total blood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SG" dirty="0"/>
          </a:p>
          <a:p>
            <a:endParaRPr lang="en-SG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481F60A-8B70-42D6-A302-B62DF2430768}" type="slidenum">
              <a:rPr lang="en-SG" smtClean="0"/>
              <a:t>3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57943865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SG"/>
              <a:t>Tumour burden increases the amount of LDN, that is shown to have a suppressive function promoting tumour to grow. </a:t>
            </a:r>
          </a:p>
          <a:p>
            <a:endParaRPr lang="en-SG"/>
          </a:p>
          <a:p>
            <a:r>
              <a:rPr lang="en-SG"/>
              <a:t>However, with estrogen treatment, the amount of LDN decreases in the circulation as compared to control treated in both involution and nulliparous animal. </a:t>
            </a:r>
            <a:r>
              <a:rPr lang="en-SG" b="1" u="sng"/>
              <a:t>(how this can relate to the growth of tumour seen in the animal?)</a:t>
            </a:r>
          </a:p>
          <a:p>
            <a:endParaRPr lang="en-SG"/>
          </a:p>
          <a:p>
            <a:endParaRPr lang="en-SG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/>
              <a:t>**Representative flow cytometry dot plot of %LY6G+ CD11b+ cell population out of viable CD45+ cells from PERCOLL ISOLATED mononuclear layer</a:t>
            </a:r>
          </a:p>
          <a:p>
            <a:endParaRPr lang="en-SG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481F60A-8B70-42D6-A302-B62DF2430768}" type="slidenum">
              <a:rPr lang="en-SG" smtClean="0"/>
              <a:t>5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0481088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6F7A1-3437-4CEF-9853-873DF41E5BA0}" type="datetimeFigureOut">
              <a:rPr lang="en-SG" smtClean="0"/>
              <a:t>2/8/2021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5FFE0-FEFA-4487-B9DF-6FDB6EBA61E4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9130359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6F7A1-3437-4CEF-9853-873DF41E5BA0}" type="datetimeFigureOut">
              <a:rPr lang="en-SG" smtClean="0"/>
              <a:t>2/8/2021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5FFE0-FEFA-4487-B9DF-6FDB6EBA61E4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9023997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6F7A1-3437-4CEF-9853-873DF41E5BA0}" type="datetimeFigureOut">
              <a:rPr lang="en-SG" smtClean="0"/>
              <a:t>2/8/2021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5FFE0-FEFA-4487-B9DF-6FDB6EBA61E4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4013762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6F7A1-3437-4CEF-9853-873DF41E5BA0}" type="datetimeFigureOut">
              <a:rPr lang="en-SG" smtClean="0"/>
              <a:t>2/8/2021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5FFE0-FEFA-4487-B9DF-6FDB6EBA61E4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0560739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6F7A1-3437-4CEF-9853-873DF41E5BA0}" type="datetimeFigureOut">
              <a:rPr lang="en-SG" smtClean="0"/>
              <a:t>2/8/2021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5FFE0-FEFA-4487-B9DF-6FDB6EBA61E4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7980080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6F7A1-3437-4CEF-9853-873DF41E5BA0}" type="datetimeFigureOut">
              <a:rPr lang="en-SG" smtClean="0"/>
              <a:t>2/8/2021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5FFE0-FEFA-4487-B9DF-6FDB6EBA61E4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9040199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6F7A1-3437-4CEF-9853-873DF41E5BA0}" type="datetimeFigureOut">
              <a:rPr lang="en-SG" smtClean="0"/>
              <a:t>2/8/2021</a:t>
            </a:fld>
            <a:endParaRPr lang="en-SG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5FFE0-FEFA-4487-B9DF-6FDB6EBA61E4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5724141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6F7A1-3437-4CEF-9853-873DF41E5BA0}" type="datetimeFigureOut">
              <a:rPr lang="en-SG" smtClean="0"/>
              <a:t>2/8/2021</a:t>
            </a:fld>
            <a:endParaRPr lang="en-SG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5FFE0-FEFA-4487-B9DF-6FDB6EBA61E4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6013814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6F7A1-3437-4CEF-9853-873DF41E5BA0}" type="datetimeFigureOut">
              <a:rPr lang="en-SG" smtClean="0"/>
              <a:t>2/8/2021</a:t>
            </a:fld>
            <a:endParaRPr lang="en-SG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5FFE0-FEFA-4487-B9DF-6FDB6EBA61E4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7990108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6F7A1-3437-4CEF-9853-873DF41E5BA0}" type="datetimeFigureOut">
              <a:rPr lang="en-SG" smtClean="0"/>
              <a:t>2/8/2021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5FFE0-FEFA-4487-B9DF-6FDB6EBA61E4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6952456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6F7A1-3437-4CEF-9853-873DF41E5BA0}" type="datetimeFigureOut">
              <a:rPr lang="en-SG" smtClean="0"/>
              <a:t>2/8/2021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5FFE0-FEFA-4487-B9DF-6FDB6EBA61E4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7582128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66F7A1-3437-4CEF-9853-873DF41E5BA0}" type="datetimeFigureOut">
              <a:rPr lang="en-SG" smtClean="0"/>
              <a:t>2/8/2021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F5FFE0-FEFA-4487-B9DF-6FDB6EBA61E4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9497386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7" Type="http://schemas.openxmlformats.org/officeDocument/2006/relationships/image" Target="../media/image15.emf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emf"/><Relationship Id="rId5" Type="http://schemas.openxmlformats.org/officeDocument/2006/relationships/image" Target="../media/image13.emf"/><Relationship Id="rId4" Type="http://schemas.openxmlformats.org/officeDocument/2006/relationships/image" Target="../media/image12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emf"/><Relationship Id="rId13" Type="http://schemas.openxmlformats.org/officeDocument/2006/relationships/image" Target="../media/image33.emf"/><Relationship Id="rId3" Type="http://schemas.openxmlformats.org/officeDocument/2006/relationships/image" Target="../media/image23.emf"/><Relationship Id="rId7" Type="http://schemas.openxmlformats.org/officeDocument/2006/relationships/image" Target="../media/image27.emf"/><Relationship Id="rId12" Type="http://schemas.openxmlformats.org/officeDocument/2006/relationships/image" Target="../media/image32.emf"/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emf"/><Relationship Id="rId11" Type="http://schemas.openxmlformats.org/officeDocument/2006/relationships/image" Target="../media/image31.emf"/><Relationship Id="rId5" Type="http://schemas.openxmlformats.org/officeDocument/2006/relationships/image" Target="../media/image25.emf"/><Relationship Id="rId10" Type="http://schemas.openxmlformats.org/officeDocument/2006/relationships/image" Target="../media/image30.emf"/><Relationship Id="rId4" Type="http://schemas.openxmlformats.org/officeDocument/2006/relationships/image" Target="../media/image24.emf"/><Relationship Id="rId9" Type="http://schemas.openxmlformats.org/officeDocument/2006/relationships/image" Target="../media/image29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png"/><Relationship Id="rId3" Type="http://schemas.openxmlformats.org/officeDocument/2006/relationships/image" Target="../media/image34.png"/><Relationship Id="rId7" Type="http://schemas.openxmlformats.org/officeDocument/2006/relationships/image" Target="../media/image38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7.png"/><Relationship Id="rId5" Type="http://schemas.openxmlformats.org/officeDocument/2006/relationships/image" Target="../media/image36.png"/><Relationship Id="rId4" Type="http://schemas.openxmlformats.org/officeDocument/2006/relationships/image" Target="../media/image3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Group 48">
            <a:extLst>
              <a:ext uri="{FF2B5EF4-FFF2-40B4-BE49-F238E27FC236}">
                <a16:creationId xmlns:a16="http://schemas.microsoft.com/office/drawing/2014/main" id="{D377704D-D6D3-4B30-A0E6-04BC8C2990A4}"/>
              </a:ext>
            </a:extLst>
          </p:cNvPr>
          <p:cNvGrpSpPr/>
          <p:nvPr/>
        </p:nvGrpSpPr>
        <p:grpSpPr>
          <a:xfrm>
            <a:off x="2392366" y="2828723"/>
            <a:ext cx="1472714" cy="1476741"/>
            <a:chOff x="2643904" y="2989436"/>
            <a:chExt cx="1472714" cy="1476741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DA33350A-9A91-4709-B54C-E159692ECED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5307" t="1260" r="3460" b="16712"/>
            <a:stretch/>
          </p:blipFill>
          <p:spPr>
            <a:xfrm>
              <a:off x="2856618" y="2989436"/>
              <a:ext cx="1260000" cy="1264581"/>
            </a:xfrm>
            <a:prstGeom prst="rect">
              <a:avLst/>
            </a:prstGeom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0F53E775-A457-4BAC-A04C-7F1EF4E3E38C}"/>
                </a:ext>
              </a:extLst>
            </p:cNvPr>
            <p:cNvSpPr txBox="1"/>
            <p:nvPr/>
          </p:nvSpPr>
          <p:spPr>
            <a:xfrm rot="16200000">
              <a:off x="2502198" y="3514004"/>
              <a:ext cx="4988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B45FD101-765E-4CAE-8C0C-8B9BE08F4E67}"/>
                </a:ext>
              </a:extLst>
            </p:cNvPr>
            <p:cNvSpPr txBox="1"/>
            <p:nvPr/>
          </p:nvSpPr>
          <p:spPr>
            <a:xfrm>
              <a:off x="3262839" y="4250733"/>
              <a:ext cx="4475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CD45</a:t>
              </a:r>
            </a:p>
          </p:txBody>
        </p:sp>
      </p:grp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F437F463-96E7-41C9-93DE-B604EF8EB159}"/>
              </a:ext>
            </a:extLst>
          </p:cNvPr>
          <p:cNvCxnSpPr>
            <a:cxnSpLocks/>
          </p:cNvCxnSpPr>
          <p:nvPr/>
        </p:nvCxnSpPr>
        <p:spPr>
          <a:xfrm rot="5400000">
            <a:off x="2592503" y="5072534"/>
            <a:ext cx="2232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95F249C2-1D09-4F60-8DEC-D5181A245334}"/>
              </a:ext>
            </a:extLst>
          </p:cNvPr>
          <p:cNvSpPr txBox="1"/>
          <p:nvPr/>
        </p:nvSpPr>
        <p:spPr>
          <a:xfrm>
            <a:off x="593221" y="8311358"/>
            <a:ext cx="54088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G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A. Representative full flow cytometry analysis gating strategy.</a:t>
            </a:r>
          </a:p>
        </p:txBody>
      </p:sp>
      <p:grpSp>
        <p:nvGrpSpPr>
          <p:cNvPr id="40" name="Group 39">
            <a:extLst>
              <a:ext uri="{FF2B5EF4-FFF2-40B4-BE49-F238E27FC236}">
                <a16:creationId xmlns:a16="http://schemas.microsoft.com/office/drawing/2014/main" id="{7DF148A3-4F37-4C49-AB04-D5E4116A8196}"/>
              </a:ext>
            </a:extLst>
          </p:cNvPr>
          <p:cNvGrpSpPr/>
          <p:nvPr/>
        </p:nvGrpSpPr>
        <p:grpSpPr>
          <a:xfrm>
            <a:off x="4068000" y="1204055"/>
            <a:ext cx="1469941" cy="1479859"/>
            <a:chOff x="4045088" y="1146064"/>
            <a:chExt cx="1469941" cy="1479859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6A62B58E-BEA2-465C-93C2-B722739DD3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5321" t="2357" r="1416" b="14939"/>
            <a:stretch/>
          </p:blipFill>
          <p:spPr>
            <a:xfrm>
              <a:off x="4255029" y="1146064"/>
              <a:ext cx="1260000" cy="1264582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0A897907-E6E7-4517-96A1-5B6308D5019C}"/>
                </a:ext>
              </a:extLst>
            </p:cNvPr>
            <p:cNvSpPr txBox="1"/>
            <p:nvPr/>
          </p:nvSpPr>
          <p:spPr>
            <a:xfrm rot="16200000">
              <a:off x="3904184" y="1670634"/>
              <a:ext cx="4972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FSC-H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45368E4-0A91-443D-8939-6287C8CD3A0A}"/>
                </a:ext>
              </a:extLst>
            </p:cNvPr>
            <p:cNvSpPr txBox="1"/>
            <p:nvPr/>
          </p:nvSpPr>
          <p:spPr>
            <a:xfrm>
              <a:off x="4625182" y="2410479"/>
              <a:ext cx="5196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FSC-W</a:t>
              </a:r>
            </a:p>
          </p:txBody>
        </p:sp>
      </p:grpSp>
      <p:grpSp>
        <p:nvGrpSpPr>
          <p:cNvPr id="55" name="Group 54">
            <a:extLst>
              <a:ext uri="{FF2B5EF4-FFF2-40B4-BE49-F238E27FC236}">
                <a16:creationId xmlns:a16="http://schemas.microsoft.com/office/drawing/2014/main" id="{7D92AFA9-C759-444A-BC86-0FB246BFDD1E}"/>
              </a:ext>
            </a:extLst>
          </p:cNvPr>
          <p:cNvGrpSpPr/>
          <p:nvPr/>
        </p:nvGrpSpPr>
        <p:grpSpPr>
          <a:xfrm>
            <a:off x="2437195" y="1204055"/>
            <a:ext cx="1471428" cy="1473913"/>
            <a:chOff x="2139238" y="1149126"/>
            <a:chExt cx="1471428" cy="1473913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408F5E19-4260-4DF3-B23C-73BFE92F144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4602" t="4794" r="1924" b="15195"/>
            <a:stretch/>
          </p:blipFill>
          <p:spPr>
            <a:xfrm>
              <a:off x="2350666" y="1149126"/>
              <a:ext cx="1260000" cy="1258459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77F56288-D35B-4D13-BE0B-A52BE61BC997}"/>
                </a:ext>
              </a:extLst>
            </p:cNvPr>
            <p:cNvSpPr txBox="1"/>
            <p:nvPr/>
          </p:nvSpPr>
          <p:spPr>
            <a:xfrm rot="16200000">
              <a:off x="1995128" y="1670633"/>
              <a:ext cx="5036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SSC-H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4E843F4B-7DB2-4C36-9F99-4E55F065EFD3}"/>
                </a:ext>
              </a:extLst>
            </p:cNvPr>
            <p:cNvSpPr txBox="1"/>
            <p:nvPr/>
          </p:nvSpPr>
          <p:spPr>
            <a:xfrm>
              <a:off x="2717613" y="2407595"/>
              <a:ext cx="5261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SSC-W</a:t>
              </a:r>
            </a:p>
          </p:txBody>
        </p:sp>
      </p:grpSp>
      <p:grpSp>
        <p:nvGrpSpPr>
          <p:cNvPr id="48" name="Group 47">
            <a:extLst>
              <a:ext uri="{FF2B5EF4-FFF2-40B4-BE49-F238E27FC236}">
                <a16:creationId xmlns:a16="http://schemas.microsoft.com/office/drawing/2014/main" id="{D847E88C-DE04-440C-BE16-6F52F922986C}"/>
              </a:ext>
            </a:extLst>
          </p:cNvPr>
          <p:cNvGrpSpPr/>
          <p:nvPr/>
        </p:nvGrpSpPr>
        <p:grpSpPr>
          <a:xfrm>
            <a:off x="4010483" y="2828723"/>
            <a:ext cx="1470526" cy="1472505"/>
            <a:chOff x="689466" y="2989436"/>
            <a:chExt cx="1470526" cy="1472505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F35D3939-E80B-4EF9-B372-7E3EA5BF00C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5972" t="4168" r="2129" b="13972"/>
            <a:stretch/>
          </p:blipFill>
          <p:spPr>
            <a:xfrm>
              <a:off x="899992" y="2989436"/>
              <a:ext cx="1260000" cy="1264581"/>
            </a:xfrm>
            <a:prstGeom prst="rect">
              <a:avLst/>
            </a:prstGeom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E8EE4739-9B74-48CD-BEEF-ECCF97852B26}"/>
                </a:ext>
              </a:extLst>
            </p:cNvPr>
            <p:cNvSpPr txBox="1"/>
            <p:nvPr/>
          </p:nvSpPr>
          <p:spPr>
            <a:xfrm rot="16200000">
              <a:off x="547760" y="3514004"/>
              <a:ext cx="4988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CC75FDAF-465D-4322-B78D-DBED20992C2C}"/>
                </a:ext>
              </a:extLst>
            </p:cNvPr>
            <p:cNvSpPr txBox="1"/>
            <p:nvPr/>
          </p:nvSpPr>
          <p:spPr>
            <a:xfrm>
              <a:off x="1190797" y="4246497"/>
              <a:ext cx="6783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Dead stain</a:t>
              </a:r>
            </a:p>
          </p:txBody>
        </p:sp>
      </p:grpSp>
      <p:grpSp>
        <p:nvGrpSpPr>
          <p:cNvPr id="50" name="Group 49">
            <a:extLst>
              <a:ext uri="{FF2B5EF4-FFF2-40B4-BE49-F238E27FC236}">
                <a16:creationId xmlns:a16="http://schemas.microsoft.com/office/drawing/2014/main" id="{1E36A950-5BA3-4E54-8FC8-B4E32E507632}"/>
              </a:ext>
            </a:extLst>
          </p:cNvPr>
          <p:cNvGrpSpPr/>
          <p:nvPr/>
        </p:nvGrpSpPr>
        <p:grpSpPr>
          <a:xfrm>
            <a:off x="2577804" y="4453389"/>
            <a:ext cx="1470155" cy="1471209"/>
            <a:chOff x="815278" y="5002295"/>
            <a:chExt cx="1470155" cy="1471209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3D708F69-2F46-43C0-85D8-758860ABE50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6055" t="918" r="4279" b="15417"/>
            <a:stretch/>
          </p:blipFill>
          <p:spPr>
            <a:xfrm>
              <a:off x="1025433" y="5002295"/>
              <a:ext cx="1260000" cy="1261445"/>
            </a:xfrm>
            <a:prstGeom prst="rect">
              <a:avLst/>
            </a:prstGeom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FE317592-48F9-4A2A-B61F-E35376596C49}"/>
                </a:ext>
              </a:extLst>
            </p:cNvPr>
            <p:cNvSpPr txBox="1"/>
            <p:nvPr/>
          </p:nvSpPr>
          <p:spPr>
            <a:xfrm rot="16200000">
              <a:off x="670366" y="5525295"/>
              <a:ext cx="50526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CD11b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3A3C5BAD-443C-48C7-9984-D657EBCC9BB6}"/>
                </a:ext>
              </a:extLst>
            </p:cNvPr>
            <p:cNvSpPr txBox="1"/>
            <p:nvPr/>
          </p:nvSpPr>
          <p:spPr>
            <a:xfrm>
              <a:off x="1442875" y="6258060"/>
              <a:ext cx="4251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Ly6C</a:t>
              </a:r>
            </a:p>
          </p:txBody>
        </p:sp>
      </p:grpSp>
      <p:grpSp>
        <p:nvGrpSpPr>
          <p:cNvPr id="51" name="Group 50">
            <a:extLst>
              <a:ext uri="{FF2B5EF4-FFF2-40B4-BE49-F238E27FC236}">
                <a16:creationId xmlns:a16="http://schemas.microsoft.com/office/drawing/2014/main" id="{BE034AC4-ABF2-42F1-9724-C52ED4E13C4C}"/>
              </a:ext>
            </a:extLst>
          </p:cNvPr>
          <p:cNvGrpSpPr/>
          <p:nvPr/>
        </p:nvGrpSpPr>
        <p:grpSpPr>
          <a:xfrm>
            <a:off x="2815207" y="6243272"/>
            <a:ext cx="1472650" cy="1465874"/>
            <a:chOff x="2920757" y="5006963"/>
            <a:chExt cx="1472650" cy="1465874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8792C508-716F-4BB9-B470-EDB20EAFDC3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7067" t="3713" r="1700" b="16376"/>
            <a:stretch/>
          </p:blipFill>
          <p:spPr>
            <a:xfrm>
              <a:off x="3133407" y="5006963"/>
              <a:ext cx="1260000" cy="1252109"/>
            </a:xfrm>
            <a:prstGeom prst="rect">
              <a:avLst/>
            </a:prstGeom>
          </p:spPr>
        </p:pic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2518880B-4D7C-468C-961B-3DE020EE1838}"/>
                </a:ext>
              </a:extLst>
            </p:cNvPr>
            <p:cNvSpPr txBox="1"/>
            <p:nvPr/>
          </p:nvSpPr>
          <p:spPr>
            <a:xfrm rot="16200000">
              <a:off x="2775845" y="5525295"/>
              <a:ext cx="50526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CD11b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CF18058B-44BB-467B-98AB-98405D20AF9F}"/>
                </a:ext>
              </a:extLst>
            </p:cNvPr>
            <p:cNvSpPr txBox="1"/>
            <p:nvPr/>
          </p:nvSpPr>
          <p:spPr>
            <a:xfrm>
              <a:off x="3547643" y="6257393"/>
              <a:ext cx="43152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Ly6G</a:t>
              </a:r>
            </a:p>
          </p:txBody>
        </p:sp>
      </p:grpSp>
      <p:grpSp>
        <p:nvGrpSpPr>
          <p:cNvPr id="54" name="Group 53">
            <a:extLst>
              <a:ext uri="{FF2B5EF4-FFF2-40B4-BE49-F238E27FC236}">
                <a16:creationId xmlns:a16="http://schemas.microsoft.com/office/drawing/2014/main" id="{11D04C7F-BE61-4FD9-8883-7A9C5D6301F5}"/>
              </a:ext>
            </a:extLst>
          </p:cNvPr>
          <p:cNvGrpSpPr/>
          <p:nvPr/>
        </p:nvGrpSpPr>
        <p:grpSpPr>
          <a:xfrm>
            <a:off x="1126935" y="4453389"/>
            <a:ext cx="1474136" cy="1461954"/>
            <a:chOff x="940595" y="7245170"/>
            <a:chExt cx="1474136" cy="1461954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63D0A533-8E52-43F8-9C6B-E01C305DE05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13128" t="2436" r="8813" b="16670"/>
            <a:stretch/>
          </p:blipFill>
          <p:spPr>
            <a:xfrm>
              <a:off x="1154731" y="7245170"/>
              <a:ext cx="1260000" cy="1259850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531A5DDB-F079-423D-9B3B-F02FDFF80FDE}"/>
                </a:ext>
              </a:extLst>
            </p:cNvPr>
            <p:cNvSpPr txBox="1"/>
            <p:nvPr/>
          </p:nvSpPr>
          <p:spPr>
            <a:xfrm rot="16200000">
              <a:off x="853392" y="7767373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06AECA1F-315A-47E4-A3D2-F22326E6CDC3}"/>
                </a:ext>
              </a:extLst>
            </p:cNvPr>
            <p:cNvSpPr txBox="1"/>
            <p:nvPr/>
          </p:nvSpPr>
          <p:spPr>
            <a:xfrm>
              <a:off x="1589806" y="8491680"/>
              <a:ext cx="3898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</a:p>
          </p:txBody>
        </p:sp>
      </p:grpSp>
      <p:grpSp>
        <p:nvGrpSpPr>
          <p:cNvPr id="53" name="Group 52">
            <a:extLst>
              <a:ext uri="{FF2B5EF4-FFF2-40B4-BE49-F238E27FC236}">
                <a16:creationId xmlns:a16="http://schemas.microsoft.com/office/drawing/2014/main" id="{16A3C7D1-BB2E-42F8-B388-4E5241920D77}"/>
              </a:ext>
            </a:extLst>
          </p:cNvPr>
          <p:cNvGrpSpPr/>
          <p:nvPr/>
        </p:nvGrpSpPr>
        <p:grpSpPr>
          <a:xfrm>
            <a:off x="4353333" y="6246319"/>
            <a:ext cx="1468681" cy="1477646"/>
            <a:chOff x="3116680" y="7243085"/>
            <a:chExt cx="1468681" cy="1477646"/>
          </a:xfrm>
        </p:grpSpPr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896825F4-8791-4555-8703-FC847012EAF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13918" t="2918" r="7668" b="20820"/>
            <a:stretch/>
          </p:blipFill>
          <p:spPr>
            <a:xfrm>
              <a:off x="3325361" y="7243085"/>
              <a:ext cx="1260000" cy="1264020"/>
            </a:xfrm>
            <a:prstGeom prst="rect">
              <a:avLst/>
            </a:prstGeom>
          </p:spPr>
        </p:pic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CBC2BCFC-3D69-4939-8FE5-BB70CA760821}"/>
                </a:ext>
              </a:extLst>
            </p:cNvPr>
            <p:cNvSpPr txBox="1"/>
            <p:nvPr/>
          </p:nvSpPr>
          <p:spPr>
            <a:xfrm rot="16200000">
              <a:off x="3015050" y="7767373"/>
              <a:ext cx="4187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BrdU</a:t>
              </a:r>
              <a:endParaRPr lang="en-SG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D70F5585-F3CB-4D3E-96D0-0757E7B9623A}"/>
                </a:ext>
              </a:extLst>
            </p:cNvPr>
            <p:cNvSpPr txBox="1"/>
            <p:nvPr/>
          </p:nvSpPr>
          <p:spPr>
            <a:xfrm>
              <a:off x="3814136" y="8505287"/>
              <a:ext cx="2824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</a:p>
          </p:txBody>
        </p:sp>
      </p:grp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4FF4E3A1-F128-4E4A-99AD-0A5C77AFB882}"/>
              </a:ext>
            </a:extLst>
          </p:cNvPr>
          <p:cNvCxnSpPr>
            <a:cxnSpLocks/>
          </p:cNvCxnSpPr>
          <p:nvPr/>
        </p:nvCxnSpPr>
        <p:spPr>
          <a:xfrm>
            <a:off x="2206336" y="2082796"/>
            <a:ext cx="4381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2FEEC704-AAD3-4036-A5A1-CC5E83F25AF1}"/>
              </a:ext>
            </a:extLst>
          </p:cNvPr>
          <p:cNvCxnSpPr>
            <a:cxnSpLocks/>
          </p:cNvCxnSpPr>
          <p:nvPr/>
        </p:nvCxnSpPr>
        <p:spPr>
          <a:xfrm>
            <a:off x="3836989" y="2085116"/>
            <a:ext cx="4381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3FC62E96-FD87-4447-8552-4EA55CE6EFD1}"/>
              </a:ext>
            </a:extLst>
          </p:cNvPr>
          <p:cNvCxnSpPr>
            <a:cxnSpLocks/>
          </p:cNvCxnSpPr>
          <p:nvPr/>
        </p:nvCxnSpPr>
        <p:spPr>
          <a:xfrm>
            <a:off x="5177843" y="2142172"/>
            <a:ext cx="0" cy="66247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B9A595CA-53F7-401B-85EA-0F3CD1857329}"/>
              </a:ext>
            </a:extLst>
          </p:cNvPr>
          <p:cNvCxnSpPr>
            <a:cxnSpLocks/>
          </p:cNvCxnSpPr>
          <p:nvPr/>
        </p:nvCxnSpPr>
        <p:spPr>
          <a:xfrm flipH="1">
            <a:off x="3876829" y="3698657"/>
            <a:ext cx="4381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8219DCFC-5F42-457E-A1DB-E8805BA7D902}"/>
              </a:ext>
            </a:extLst>
          </p:cNvPr>
          <p:cNvCxnSpPr>
            <a:cxnSpLocks/>
          </p:cNvCxnSpPr>
          <p:nvPr/>
        </p:nvCxnSpPr>
        <p:spPr>
          <a:xfrm flipV="1">
            <a:off x="3986305" y="6585372"/>
            <a:ext cx="532766" cy="3132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75DDA9D0-0F93-42AE-AA7A-D773EB392776}"/>
              </a:ext>
            </a:extLst>
          </p:cNvPr>
          <p:cNvCxnSpPr>
            <a:cxnSpLocks/>
          </p:cNvCxnSpPr>
          <p:nvPr/>
        </p:nvCxnSpPr>
        <p:spPr>
          <a:xfrm flipH="1">
            <a:off x="2653714" y="3956534"/>
            <a:ext cx="545879" cy="43812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Arrow Connector 64">
            <a:extLst>
              <a:ext uri="{FF2B5EF4-FFF2-40B4-BE49-F238E27FC236}">
                <a16:creationId xmlns:a16="http://schemas.microsoft.com/office/drawing/2014/main" id="{4318A187-138C-4CFC-A78E-E71DC20102FA}"/>
              </a:ext>
            </a:extLst>
          </p:cNvPr>
          <p:cNvCxnSpPr>
            <a:cxnSpLocks/>
          </p:cNvCxnSpPr>
          <p:nvPr/>
        </p:nvCxnSpPr>
        <p:spPr>
          <a:xfrm rot="5400000">
            <a:off x="3298138" y="4175597"/>
            <a:ext cx="4381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Group 1">
            <a:extLst>
              <a:ext uri="{FF2B5EF4-FFF2-40B4-BE49-F238E27FC236}">
                <a16:creationId xmlns:a16="http://schemas.microsoft.com/office/drawing/2014/main" id="{30797CD6-F96F-467E-ACF8-1E7B351EB5E6}"/>
              </a:ext>
            </a:extLst>
          </p:cNvPr>
          <p:cNvGrpSpPr/>
          <p:nvPr/>
        </p:nvGrpSpPr>
        <p:grpSpPr>
          <a:xfrm>
            <a:off x="849095" y="1208826"/>
            <a:ext cx="1470549" cy="1469142"/>
            <a:chOff x="936181" y="867741"/>
            <a:chExt cx="1470549" cy="1469142"/>
          </a:xfrm>
        </p:grpSpPr>
        <p:grpSp>
          <p:nvGrpSpPr>
            <p:cNvPr id="42" name="Group 41">
              <a:extLst>
                <a:ext uri="{FF2B5EF4-FFF2-40B4-BE49-F238E27FC236}">
                  <a16:creationId xmlns:a16="http://schemas.microsoft.com/office/drawing/2014/main" id="{18F1D9CA-E5C9-4701-A628-DCAA04017E14}"/>
                </a:ext>
              </a:extLst>
            </p:cNvPr>
            <p:cNvGrpSpPr/>
            <p:nvPr/>
          </p:nvGrpSpPr>
          <p:grpSpPr>
            <a:xfrm>
              <a:off x="936181" y="867741"/>
              <a:ext cx="1470549" cy="1469142"/>
              <a:chOff x="404153" y="1146064"/>
              <a:chExt cx="1470549" cy="1469142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C062CCF7-CB79-4B55-9B5E-C0EC8B0B57D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18765" t="3318" r="1936" b="15811"/>
              <a:stretch/>
            </p:blipFill>
            <p:spPr>
              <a:xfrm>
                <a:off x="614702" y="1146064"/>
                <a:ext cx="1260000" cy="1264582"/>
              </a:xfrm>
              <a:prstGeom prst="rect">
                <a:avLst/>
              </a:prstGeom>
            </p:spPr>
          </p:pic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2F5BA413-18E5-4A86-B139-E2BF99E31CF0}"/>
                  </a:ext>
                </a:extLst>
              </p:cNvPr>
              <p:cNvSpPr txBox="1"/>
              <p:nvPr/>
            </p:nvSpPr>
            <p:spPr>
              <a:xfrm rot="16200000">
                <a:off x="262447" y="1670633"/>
                <a:ext cx="49885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SG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SC-A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1D814E6F-4B83-4475-A5AC-CF0A8B18976D}"/>
                  </a:ext>
                </a:extLst>
              </p:cNvPr>
              <p:cNvSpPr txBox="1"/>
              <p:nvPr/>
            </p:nvSpPr>
            <p:spPr>
              <a:xfrm>
                <a:off x="998481" y="2399762"/>
                <a:ext cx="49244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SG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SC-A</a:t>
                </a:r>
              </a:p>
            </p:txBody>
          </p:sp>
        </p:grp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5A4F97D6-9923-4172-B010-C7E2CABEB147}"/>
                </a:ext>
              </a:extLst>
            </p:cNvPr>
            <p:cNvSpPr txBox="1"/>
            <p:nvPr/>
          </p:nvSpPr>
          <p:spPr>
            <a:xfrm>
              <a:off x="1584828" y="1375616"/>
              <a:ext cx="438124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SG" sz="400" dirty="0">
                  <a:latin typeface="Arial" panose="020B0604020202020204" pitchFamily="34" charset="0"/>
                  <a:cs typeface="Arial" panose="020B0604020202020204" pitchFamily="34" charset="0"/>
                </a:rPr>
                <a:t>Non-debris</a:t>
              </a:r>
            </a:p>
            <a:p>
              <a:pPr algn="ctr"/>
              <a:r>
                <a:rPr lang="en-SG" sz="400" dirty="0">
                  <a:latin typeface="Arial" panose="020B0604020202020204" pitchFamily="34" charset="0"/>
                  <a:cs typeface="Arial" panose="020B0604020202020204" pitchFamily="34" charset="0"/>
                </a:rPr>
                <a:t>97.7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6907476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" name="Group 46">
            <a:extLst>
              <a:ext uri="{FF2B5EF4-FFF2-40B4-BE49-F238E27FC236}">
                <a16:creationId xmlns:a16="http://schemas.microsoft.com/office/drawing/2014/main" id="{C9FA28E0-222D-4E1C-A54F-3A85744202A5}"/>
              </a:ext>
            </a:extLst>
          </p:cNvPr>
          <p:cNvGrpSpPr/>
          <p:nvPr/>
        </p:nvGrpSpPr>
        <p:grpSpPr>
          <a:xfrm>
            <a:off x="4138584" y="4010711"/>
            <a:ext cx="1460503" cy="1467270"/>
            <a:chOff x="4283696" y="3771226"/>
            <a:chExt cx="1460503" cy="1467270"/>
          </a:xfrm>
        </p:grpSpPr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A2292081-529F-4CAB-987D-69C789AEF1E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5323" t="2397" r="20376" b="23192"/>
            <a:stretch/>
          </p:blipFill>
          <p:spPr>
            <a:xfrm>
              <a:off x="4484199" y="3771226"/>
              <a:ext cx="1260000" cy="1262083"/>
            </a:xfrm>
            <a:prstGeom prst="rect">
              <a:avLst/>
            </a:prstGeom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0F53E775-A457-4BAC-A04C-7F1EF4E3E38C}"/>
                </a:ext>
              </a:extLst>
            </p:cNvPr>
            <p:cNvSpPr txBox="1"/>
            <p:nvPr/>
          </p:nvSpPr>
          <p:spPr>
            <a:xfrm rot="16200000">
              <a:off x="4141990" y="4294545"/>
              <a:ext cx="4988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B45FD101-765E-4CAE-8C0C-8B9BE08F4E67}"/>
                </a:ext>
              </a:extLst>
            </p:cNvPr>
            <p:cNvSpPr txBox="1"/>
            <p:nvPr/>
          </p:nvSpPr>
          <p:spPr>
            <a:xfrm>
              <a:off x="4890420" y="5023052"/>
              <a:ext cx="4475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CD45</a:t>
              </a:r>
            </a:p>
          </p:txBody>
        </p: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95F249C2-1D09-4F60-8DEC-D5181A245334}"/>
              </a:ext>
            </a:extLst>
          </p:cNvPr>
          <p:cNvSpPr txBox="1"/>
          <p:nvPr/>
        </p:nvSpPr>
        <p:spPr>
          <a:xfrm>
            <a:off x="583231" y="6295508"/>
            <a:ext cx="56915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SG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B. Representative gating strategy for Annexin V flow cytometry analysis.</a:t>
            </a:r>
          </a:p>
        </p:txBody>
      </p:sp>
      <p:grpSp>
        <p:nvGrpSpPr>
          <p:cNvPr id="61" name="Group 60">
            <a:extLst>
              <a:ext uri="{FF2B5EF4-FFF2-40B4-BE49-F238E27FC236}">
                <a16:creationId xmlns:a16="http://schemas.microsoft.com/office/drawing/2014/main" id="{B7880BE8-F44C-4A52-B4E3-5E4DAD88236D}"/>
              </a:ext>
            </a:extLst>
          </p:cNvPr>
          <p:cNvGrpSpPr/>
          <p:nvPr/>
        </p:nvGrpSpPr>
        <p:grpSpPr>
          <a:xfrm>
            <a:off x="4138584" y="2334504"/>
            <a:ext cx="1460503" cy="1475574"/>
            <a:chOff x="4283696" y="2095019"/>
            <a:chExt cx="1460503" cy="1475574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AFBABDBC-1ED3-47DA-80F8-6A415B528DF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4624" t="11355" r="2682" b="16826"/>
            <a:stretch/>
          </p:blipFill>
          <p:spPr>
            <a:xfrm>
              <a:off x="4484199" y="2095019"/>
              <a:ext cx="1260000" cy="1254740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0A897907-E6E7-4517-96A1-5B6308D5019C}"/>
                </a:ext>
              </a:extLst>
            </p:cNvPr>
            <p:cNvSpPr txBox="1"/>
            <p:nvPr/>
          </p:nvSpPr>
          <p:spPr>
            <a:xfrm rot="16200000">
              <a:off x="4142792" y="2614667"/>
              <a:ext cx="4972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FSC-H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45368E4-0A91-443D-8939-6287C8CD3A0A}"/>
                </a:ext>
              </a:extLst>
            </p:cNvPr>
            <p:cNvSpPr txBox="1"/>
            <p:nvPr/>
          </p:nvSpPr>
          <p:spPr>
            <a:xfrm>
              <a:off x="4854352" y="3355149"/>
              <a:ext cx="5196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FSC-W</a:t>
              </a:r>
            </a:p>
          </p:txBody>
        </p:sp>
      </p:grpSp>
      <p:grpSp>
        <p:nvGrpSpPr>
          <p:cNvPr id="60" name="Group 59">
            <a:extLst>
              <a:ext uri="{FF2B5EF4-FFF2-40B4-BE49-F238E27FC236}">
                <a16:creationId xmlns:a16="http://schemas.microsoft.com/office/drawing/2014/main" id="{83B5E302-D0BE-48FD-87C4-A8569A3F6C2D}"/>
              </a:ext>
            </a:extLst>
          </p:cNvPr>
          <p:cNvGrpSpPr/>
          <p:nvPr/>
        </p:nvGrpSpPr>
        <p:grpSpPr>
          <a:xfrm>
            <a:off x="2549331" y="2334489"/>
            <a:ext cx="1469761" cy="1475589"/>
            <a:chOff x="2577478" y="2095004"/>
            <a:chExt cx="1469761" cy="1475589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408A93A0-AEEF-4116-A88E-D7721692DA1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4844" t="9018" r="8206" b="18619"/>
            <a:stretch/>
          </p:blipFill>
          <p:spPr>
            <a:xfrm>
              <a:off x="2787239" y="2095004"/>
              <a:ext cx="1260000" cy="1254771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77F56288-D35B-4D13-BE0B-A52BE61BC997}"/>
                </a:ext>
              </a:extLst>
            </p:cNvPr>
            <p:cNvSpPr txBox="1"/>
            <p:nvPr/>
          </p:nvSpPr>
          <p:spPr>
            <a:xfrm rot="16200000">
              <a:off x="2433368" y="2614668"/>
              <a:ext cx="5036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SSC-H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4E843F4B-7DB2-4C36-9F99-4E55F065EFD3}"/>
                </a:ext>
              </a:extLst>
            </p:cNvPr>
            <p:cNvSpPr txBox="1"/>
            <p:nvPr/>
          </p:nvSpPr>
          <p:spPr>
            <a:xfrm>
              <a:off x="3154186" y="3355149"/>
              <a:ext cx="5261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SSC-W</a:t>
              </a:r>
            </a:p>
          </p:txBody>
        </p:sp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id="{780A750D-E18A-42AF-8F92-31FC1EC5ED0D}"/>
              </a:ext>
            </a:extLst>
          </p:cNvPr>
          <p:cNvGrpSpPr/>
          <p:nvPr/>
        </p:nvGrpSpPr>
        <p:grpSpPr>
          <a:xfrm>
            <a:off x="2549331" y="4011635"/>
            <a:ext cx="1469761" cy="1466346"/>
            <a:chOff x="2577478" y="3772150"/>
            <a:chExt cx="1469761" cy="1466346"/>
          </a:xfrm>
        </p:grpSpPr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836133E1-1AD9-4659-BB3E-CB28CCFED21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9107" t="2263" r="6354" b="16971"/>
            <a:stretch/>
          </p:blipFill>
          <p:spPr>
            <a:xfrm>
              <a:off x="2787239" y="3772150"/>
              <a:ext cx="1260000" cy="1260235"/>
            </a:xfrm>
            <a:prstGeom prst="rect">
              <a:avLst/>
            </a:prstGeom>
          </p:spPr>
        </p:pic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2518880B-4D7C-468C-961B-3DE020EE1838}"/>
                </a:ext>
              </a:extLst>
            </p:cNvPr>
            <p:cNvSpPr txBox="1"/>
            <p:nvPr/>
          </p:nvSpPr>
          <p:spPr>
            <a:xfrm rot="16200000">
              <a:off x="2432566" y="4294545"/>
              <a:ext cx="50526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CD11b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CF18058B-44BB-467B-98AB-98405D20AF9F}"/>
                </a:ext>
              </a:extLst>
            </p:cNvPr>
            <p:cNvSpPr txBox="1"/>
            <p:nvPr/>
          </p:nvSpPr>
          <p:spPr>
            <a:xfrm>
              <a:off x="3201475" y="5023052"/>
              <a:ext cx="43152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Ly6G</a:t>
              </a:r>
            </a:p>
          </p:txBody>
        </p:sp>
      </p:grpSp>
      <p:grpSp>
        <p:nvGrpSpPr>
          <p:cNvPr id="45" name="Group 44">
            <a:extLst>
              <a:ext uri="{FF2B5EF4-FFF2-40B4-BE49-F238E27FC236}">
                <a16:creationId xmlns:a16="http://schemas.microsoft.com/office/drawing/2014/main" id="{D093D5FF-73D4-4646-8FF2-9F52433F5097}"/>
              </a:ext>
            </a:extLst>
          </p:cNvPr>
          <p:cNvGrpSpPr/>
          <p:nvPr/>
        </p:nvGrpSpPr>
        <p:grpSpPr>
          <a:xfrm>
            <a:off x="972467" y="4016458"/>
            <a:ext cx="1461582" cy="1461523"/>
            <a:chOff x="994238" y="3776973"/>
            <a:chExt cx="1461582" cy="1461523"/>
          </a:xfrm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D2316784-38D9-4BBA-8EE8-9DDA14EC1F7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3173" t="3843" r="13561" b="19086"/>
            <a:stretch/>
          </p:blipFill>
          <p:spPr>
            <a:xfrm>
              <a:off x="1195820" y="3776973"/>
              <a:ext cx="1260000" cy="1250588"/>
            </a:xfrm>
            <a:prstGeom prst="rect">
              <a:avLst/>
            </a:prstGeom>
          </p:spPr>
        </p:pic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5BAE306E-22C6-4A08-9F74-8684E5F11AA3}"/>
                </a:ext>
              </a:extLst>
            </p:cNvPr>
            <p:cNvSpPr txBox="1"/>
            <p:nvPr/>
          </p:nvSpPr>
          <p:spPr>
            <a:xfrm rot="16200000">
              <a:off x="762764" y="4294545"/>
              <a:ext cx="6783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Dead stain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AEEA30EC-DEC0-412C-8FCC-BA824B3CAEBD}"/>
                </a:ext>
              </a:extLst>
            </p:cNvPr>
            <p:cNvSpPr txBox="1"/>
            <p:nvPr/>
          </p:nvSpPr>
          <p:spPr>
            <a:xfrm>
              <a:off x="1497846" y="5023052"/>
              <a:ext cx="6559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Annexin V</a:t>
              </a:r>
            </a:p>
          </p:txBody>
        </p:sp>
      </p:grp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2FEEC704-AAD3-4036-A5A1-CC5E83F25AF1}"/>
              </a:ext>
            </a:extLst>
          </p:cNvPr>
          <p:cNvCxnSpPr>
            <a:cxnSpLocks/>
          </p:cNvCxnSpPr>
          <p:nvPr/>
        </p:nvCxnSpPr>
        <p:spPr>
          <a:xfrm>
            <a:off x="3896562" y="3217226"/>
            <a:ext cx="4381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3FC62E96-FD87-4447-8552-4EA55CE6EFD1}"/>
              </a:ext>
            </a:extLst>
          </p:cNvPr>
          <p:cNvCxnSpPr>
            <a:cxnSpLocks/>
          </p:cNvCxnSpPr>
          <p:nvPr/>
        </p:nvCxnSpPr>
        <p:spPr>
          <a:xfrm>
            <a:off x="5262937" y="3246635"/>
            <a:ext cx="0" cy="756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B9A595CA-53F7-401B-85EA-0F3CD1857329}"/>
              </a:ext>
            </a:extLst>
          </p:cNvPr>
          <p:cNvCxnSpPr>
            <a:cxnSpLocks/>
          </p:cNvCxnSpPr>
          <p:nvPr/>
        </p:nvCxnSpPr>
        <p:spPr>
          <a:xfrm flipH="1">
            <a:off x="4036753" y="5039173"/>
            <a:ext cx="972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4" name="Group 43">
            <a:extLst>
              <a:ext uri="{FF2B5EF4-FFF2-40B4-BE49-F238E27FC236}">
                <a16:creationId xmlns:a16="http://schemas.microsoft.com/office/drawing/2014/main" id="{AE00115F-E090-47A6-BF90-54AB1D518C93}"/>
              </a:ext>
            </a:extLst>
          </p:cNvPr>
          <p:cNvGrpSpPr/>
          <p:nvPr/>
        </p:nvGrpSpPr>
        <p:grpSpPr>
          <a:xfrm>
            <a:off x="972467" y="2337500"/>
            <a:ext cx="1461582" cy="1472578"/>
            <a:chOff x="994238" y="2098015"/>
            <a:chExt cx="1461582" cy="1472578"/>
          </a:xfrm>
        </p:grpSpPr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F5BA413-18E5-4A86-B139-E2BF99E31CF0}"/>
                </a:ext>
              </a:extLst>
            </p:cNvPr>
            <p:cNvSpPr txBox="1"/>
            <p:nvPr/>
          </p:nvSpPr>
          <p:spPr>
            <a:xfrm rot="16200000">
              <a:off x="852532" y="2614667"/>
              <a:ext cx="4988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1D814E6F-4B83-4475-A5AC-CF0A8B18976D}"/>
                </a:ext>
              </a:extLst>
            </p:cNvPr>
            <p:cNvSpPr txBox="1"/>
            <p:nvPr/>
          </p:nvSpPr>
          <p:spPr>
            <a:xfrm>
              <a:off x="1579599" y="3355149"/>
              <a:ext cx="49244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</a:p>
          </p:txBody>
        </p:sp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id="{BAB016BF-96DC-464C-803F-1C58B57B6FC7}"/>
                </a:ext>
              </a:extLst>
            </p:cNvPr>
            <p:cNvGrpSpPr/>
            <p:nvPr/>
          </p:nvGrpSpPr>
          <p:grpSpPr>
            <a:xfrm>
              <a:off x="1195820" y="2098015"/>
              <a:ext cx="1260000" cy="1248749"/>
              <a:chOff x="1195820" y="2095004"/>
              <a:chExt cx="1260000" cy="1248749"/>
            </a:xfrm>
          </p:grpSpPr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id="{629734F2-FFEE-4BDD-95D6-1247C0C7F84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15995" t="4152" r="4370" b="16695"/>
              <a:stretch/>
            </p:blipFill>
            <p:spPr>
              <a:xfrm>
                <a:off x="1195820" y="2095004"/>
                <a:ext cx="1260000" cy="1248749"/>
              </a:xfrm>
              <a:prstGeom prst="rect">
                <a:avLst/>
              </a:prstGeom>
            </p:spPr>
          </p:pic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5A4F97D6-9923-4172-B010-C7E2CABEB147}"/>
                  </a:ext>
                </a:extLst>
              </p:cNvPr>
              <p:cNvSpPr txBox="1"/>
              <p:nvPr/>
            </p:nvSpPr>
            <p:spPr>
              <a:xfrm>
                <a:off x="1651391" y="2566796"/>
                <a:ext cx="438124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SG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Non-debris</a:t>
                </a:r>
              </a:p>
              <a:p>
                <a:pPr algn="ctr"/>
                <a:r>
                  <a:rPr lang="en-SG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61.0</a:t>
                </a:r>
              </a:p>
            </p:txBody>
          </p:sp>
        </p:grpSp>
      </p:grp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CFEEA9AD-0EAD-41BE-888C-738F16839F27}"/>
              </a:ext>
            </a:extLst>
          </p:cNvPr>
          <p:cNvCxnSpPr>
            <a:cxnSpLocks/>
          </p:cNvCxnSpPr>
          <p:nvPr/>
        </p:nvCxnSpPr>
        <p:spPr>
          <a:xfrm flipH="1">
            <a:off x="2494470" y="4258121"/>
            <a:ext cx="1080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4FF4E3A1-F128-4E4A-99AD-0A5C77AFB882}"/>
              </a:ext>
            </a:extLst>
          </p:cNvPr>
          <p:cNvCxnSpPr>
            <a:cxnSpLocks/>
          </p:cNvCxnSpPr>
          <p:nvPr/>
        </p:nvCxnSpPr>
        <p:spPr>
          <a:xfrm>
            <a:off x="2329708" y="3214906"/>
            <a:ext cx="4381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675927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extBox 55">
            <a:extLst>
              <a:ext uri="{FF2B5EF4-FFF2-40B4-BE49-F238E27FC236}">
                <a16:creationId xmlns:a16="http://schemas.microsoft.com/office/drawing/2014/main" id="{64C060FB-CAF9-4F7D-9505-A6240E94336C}"/>
              </a:ext>
            </a:extLst>
          </p:cNvPr>
          <p:cNvSpPr txBox="1"/>
          <p:nvPr/>
        </p:nvSpPr>
        <p:spPr>
          <a:xfrm>
            <a:off x="294624" y="6320477"/>
            <a:ext cx="6228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SG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Representative flow cytometry dot plot of circulating neutrophils out of viable CD45+ population. 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11936811-3414-4869-9990-EAB2F5BA421D}"/>
              </a:ext>
            </a:extLst>
          </p:cNvPr>
          <p:cNvGrpSpPr/>
          <p:nvPr/>
        </p:nvGrpSpPr>
        <p:grpSpPr>
          <a:xfrm>
            <a:off x="1615454" y="2374853"/>
            <a:ext cx="3552457" cy="2512928"/>
            <a:chOff x="2557223" y="518890"/>
            <a:chExt cx="3552457" cy="2512928"/>
          </a:xfrm>
        </p:grpSpPr>
        <p:pic>
          <p:nvPicPr>
            <p:cNvPr id="73" name="Picture 72">
              <a:extLst>
                <a:ext uri="{FF2B5EF4-FFF2-40B4-BE49-F238E27FC236}">
                  <a16:creationId xmlns:a16="http://schemas.microsoft.com/office/drawing/2014/main" id="{1CAA91C7-F606-46BA-94A5-A17895D1378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132" t="15223" r="2457" b="13605"/>
            <a:stretch/>
          </p:blipFill>
          <p:spPr>
            <a:xfrm>
              <a:off x="5029680" y="706889"/>
              <a:ext cx="1080000" cy="1069200"/>
            </a:xfrm>
            <a:prstGeom prst="rect">
              <a:avLst/>
            </a:prstGeom>
          </p:spPr>
        </p:pic>
        <p:pic>
          <p:nvPicPr>
            <p:cNvPr id="74" name="Picture 73">
              <a:extLst>
                <a:ext uri="{FF2B5EF4-FFF2-40B4-BE49-F238E27FC236}">
                  <a16:creationId xmlns:a16="http://schemas.microsoft.com/office/drawing/2014/main" id="{DA1EB563-A2A9-457D-AF5E-116B698D0AA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676" t="3820" r="3179" b="15515"/>
            <a:stretch/>
          </p:blipFill>
          <p:spPr>
            <a:xfrm>
              <a:off x="3947070" y="704287"/>
              <a:ext cx="1080000" cy="1074405"/>
            </a:xfrm>
            <a:prstGeom prst="rect">
              <a:avLst/>
            </a:prstGeom>
          </p:spPr>
        </p:pic>
        <p:pic>
          <p:nvPicPr>
            <p:cNvPr id="75" name="Picture 74">
              <a:extLst>
                <a:ext uri="{FF2B5EF4-FFF2-40B4-BE49-F238E27FC236}">
                  <a16:creationId xmlns:a16="http://schemas.microsoft.com/office/drawing/2014/main" id="{E89D246E-E3BA-46B2-9CF0-D06BC470424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281" t="16238" r="3037" b="15827"/>
            <a:stretch/>
          </p:blipFill>
          <p:spPr>
            <a:xfrm>
              <a:off x="5029680" y="1784033"/>
              <a:ext cx="1080000" cy="1080000"/>
            </a:xfrm>
            <a:prstGeom prst="rect">
              <a:avLst/>
            </a:prstGeom>
          </p:spPr>
        </p:pic>
        <p:pic>
          <p:nvPicPr>
            <p:cNvPr id="76" name="Picture 75">
              <a:extLst>
                <a:ext uri="{FF2B5EF4-FFF2-40B4-BE49-F238E27FC236}">
                  <a16:creationId xmlns:a16="http://schemas.microsoft.com/office/drawing/2014/main" id="{133E982B-24E6-4B70-A796-BBAD4B900FD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544" t="16746" r="3909" b="22081"/>
            <a:stretch/>
          </p:blipFill>
          <p:spPr>
            <a:xfrm>
              <a:off x="3947070" y="1784033"/>
              <a:ext cx="1080000" cy="1080000"/>
            </a:xfrm>
            <a:prstGeom prst="rect">
              <a:avLst/>
            </a:prstGeom>
          </p:spPr>
        </p:pic>
        <p:cxnSp>
          <p:nvCxnSpPr>
            <p:cNvPr id="77" name="Straight Arrow Connector 76">
              <a:extLst>
                <a:ext uri="{FF2B5EF4-FFF2-40B4-BE49-F238E27FC236}">
                  <a16:creationId xmlns:a16="http://schemas.microsoft.com/office/drawing/2014/main" id="{7A9A1E42-4C6E-4364-AB38-0DB3C3943867}"/>
                </a:ext>
              </a:extLst>
            </p:cNvPr>
            <p:cNvCxnSpPr/>
            <p:nvPr/>
          </p:nvCxnSpPr>
          <p:spPr>
            <a:xfrm flipV="1">
              <a:off x="2826720" y="812697"/>
              <a:ext cx="0" cy="1584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Arrow Connector 77">
              <a:extLst>
                <a:ext uri="{FF2B5EF4-FFF2-40B4-BE49-F238E27FC236}">
                  <a16:creationId xmlns:a16="http://schemas.microsoft.com/office/drawing/2014/main" id="{9AF5FADC-E3E6-4CBA-A354-3547655F83CB}"/>
                </a:ext>
              </a:extLst>
            </p:cNvPr>
            <p:cNvCxnSpPr/>
            <p:nvPr/>
          </p:nvCxnSpPr>
          <p:spPr>
            <a:xfrm>
              <a:off x="3247910" y="2924096"/>
              <a:ext cx="2772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9AE754B4-53A6-4F2D-ACB3-9A010F3673F3}"/>
                </a:ext>
              </a:extLst>
            </p:cNvPr>
            <p:cNvSpPr txBox="1"/>
            <p:nvPr/>
          </p:nvSpPr>
          <p:spPr>
            <a:xfrm rot="16200000">
              <a:off x="2336971" y="2216311"/>
              <a:ext cx="6559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Involution 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A4320EE2-CED6-409D-8312-800D621906CB}"/>
                </a:ext>
              </a:extLst>
            </p:cNvPr>
            <p:cNvSpPr txBox="1"/>
            <p:nvPr/>
          </p:nvSpPr>
          <p:spPr>
            <a:xfrm rot="16200000">
              <a:off x="2300903" y="1133768"/>
              <a:ext cx="7280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Nulliparous 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05BF436C-FFEE-40A9-9879-301B7802CE5D}"/>
                </a:ext>
              </a:extLst>
            </p:cNvPr>
            <p:cNvSpPr txBox="1"/>
            <p:nvPr/>
          </p:nvSpPr>
          <p:spPr>
            <a:xfrm>
              <a:off x="4347447" y="518890"/>
              <a:ext cx="3433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ADE28946-EF79-44A5-8A49-ADB78A17999A}"/>
                </a:ext>
              </a:extLst>
            </p:cNvPr>
            <p:cNvSpPr txBox="1"/>
            <p:nvPr/>
          </p:nvSpPr>
          <p:spPr>
            <a:xfrm>
              <a:off x="5375556" y="518890"/>
              <a:ext cx="38824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E2V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220FC59B-1454-460C-B56B-55782C8310AD}"/>
                </a:ext>
              </a:extLst>
            </p:cNvPr>
            <p:cNvSpPr txBox="1"/>
            <p:nvPr/>
          </p:nvSpPr>
          <p:spPr>
            <a:xfrm>
              <a:off x="2851819" y="2816374"/>
              <a:ext cx="4491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SG" sz="800">
                  <a:latin typeface="Arial" panose="020B0604020202020204" pitchFamily="34" charset="0"/>
                  <a:cs typeface="Arial" panose="020B0604020202020204" pitchFamily="34" charset="0"/>
                </a:rPr>
                <a:t>LY6G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FEA0804C-714C-420E-A79C-58F40A1E6341}"/>
                </a:ext>
              </a:extLst>
            </p:cNvPr>
            <p:cNvSpPr txBox="1"/>
            <p:nvPr/>
          </p:nvSpPr>
          <p:spPr>
            <a:xfrm rot="16200000">
              <a:off x="2574087" y="2515455"/>
              <a:ext cx="50526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SG" sz="800">
                  <a:latin typeface="Arial" panose="020B0604020202020204" pitchFamily="34" charset="0"/>
                  <a:cs typeface="Arial" panose="020B0604020202020204" pitchFamily="34" charset="0"/>
                </a:rPr>
                <a:t>CD11b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B52AFFCD-5B72-4D6D-8BF6-BF06FEAD0794}"/>
                </a:ext>
              </a:extLst>
            </p:cNvPr>
            <p:cNvSpPr txBox="1"/>
            <p:nvPr/>
          </p:nvSpPr>
          <p:spPr>
            <a:xfrm>
              <a:off x="2912113" y="518890"/>
              <a:ext cx="108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NO TUMOUR (N.T)</a:t>
              </a:r>
            </a:p>
          </p:txBody>
        </p:sp>
        <p:pic>
          <p:nvPicPr>
            <p:cNvPr id="86" name="Picture 85">
              <a:extLst>
                <a:ext uri="{FF2B5EF4-FFF2-40B4-BE49-F238E27FC236}">
                  <a16:creationId xmlns:a16="http://schemas.microsoft.com/office/drawing/2014/main" id="{1C56D0EC-F3D1-4FCA-AEE5-2347AA8B8A3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487" t="18702" r="2986" b="13363"/>
            <a:stretch/>
          </p:blipFill>
          <p:spPr>
            <a:xfrm>
              <a:off x="2879865" y="701489"/>
              <a:ext cx="1080000" cy="1080000"/>
            </a:xfrm>
            <a:prstGeom prst="rect">
              <a:avLst/>
            </a:prstGeom>
          </p:spPr>
        </p:pic>
        <p:pic>
          <p:nvPicPr>
            <p:cNvPr id="87" name="Picture 86">
              <a:extLst>
                <a:ext uri="{FF2B5EF4-FFF2-40B4-BE49-F238E27FC236}">
                  <a16:creationId xmlns:a16="http://schemas.microsoft.com/office/drawing/2014/main" id="{D6CEFE2F-6CE0-4E24-9A61-BAF561A908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28309" t="18150" r="1489" b="15008"/>
            <a:stretch/>
          </p:blipFill>
          <p:spPr>
            <a:xfrm>
              <a:off x="2879865" y="1784033"/>
              <a:ext cx="1080000" cy="1080000"/>
            </a:xfrm>
            <a:prstGeom prst="rect">
              <a:avLst/>
            </a:prstGeom>
          </p:spPr>
        </p:pic>
      </p:grpSp>
      <p:sp>
        <p:nvSpPr>
          <p:cNvPr id="221" name="Rectangle 220">
            <a:extLst>
              <a:ext uri="{FF2B5EF4-FFF2-40B4-BE49-F238E27FC236}">
                <a16:creationId xmlns:a16="http://schemas.microsoft.com/office/drawing/2014/main" id="{886F36F9-99BB-4CEC-AA37-B51B4A79099B}"/>
              </a:ext>
            </a:extLst>
          </p:cNvPr>
          <p:cNvSpPr/>
          <p:nvPr/>
        </p:nvSpPr>
        <p:spPr>
          <a:xfrm>
            <a:off x="1612038" y="2374853"/>
            <a:ext cx="3633924" cy="2501346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1700696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F8A966D8-C935-45C3-96E4-14DC619B0743}"/>
              </a:ext>
            </a:extLst>
          </p:cNvPr>
          <p:cNvCxnSpPr/>
          <p:nvPr/>
        </p:nvCxnSpPr>
        <p:spPr>
          <a:xfrm flipV="1">
            <a:off x="1874278" y="1231838"/>
            <a:ext cx="0" cy="1584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0F25A756-8549-4524-B261-183EE4556E86}"/>
              </a:ext>
            </a:extLst>
          </p:cNvPr>
          <p:cNvCxnSpPr/>
          <p:nvPr/>
        </p:nvCxnSpPr>
        <p:spPr>
          <a:xfrm>
            <a:off x="2295468" y="3343237"/>
            <a:ext cx="2772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88B4CCCF-2CC5-44CB-848A-DB75FBA66EC7}"/>
              </a:ext>
            </a:extLst>
          </p:cNvPr>
          <p:cNvSpPr txBox="1"/>
          <p:nvPr/>
        </p:nvSpPr>
        <p:spPr>
          <a:xfrm rot="16200000">
            <a:off x="1384529" y="2635452"/>
            <a:ext cx="6559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SG" sz="800" dirty="0">
                <a:latin typeface="Arial" panose="020B0604020202020204" pitchFamily="34" charset="0"/>
                <a:cs typeface="Arial" panose="020B0604020202020204" pitchFamily="34" charset="0"/>
              </a:rPr>
              <a:t>Involution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A8F2B0C-39FB-44E2-96F3-F299BD66BC17}"/>
              </a:ext>
            </a:extLst>
          </p:cNvPr>
          <p:cNvSpPr txBox="1"/>
          <p:nvPr/>
        </p:nvSpPr>
        <p:spPr>
          <a:xfrm rot="16200000">
            <a:off x="1348461" y="1552909"/>
            <a:ext cx="72808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SG" sz="800" dirty="0">
                <a:latin typeface="Arial" panose="020B0604020202020204" pitchFamily="34" charset="0"/>
                <a:cs typeface="Arial" panose="020B0604020202020204" pitchFamily="34" charset="0"/>
              </a:rPr>
              <a:t>Nulliparous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74940A1-B3E7-4D43-A984-BBD82BFFB6B4}"/>
              </a:ext>
            </a:extLst>
          </p:cNvPr>
          <p:cNvSpPr txBox="1"/>
          <p:nvPr/>
        </p:nvSpPr>
        <p:spPr>
          <a:xfrm>
            <a:off x="3384201" y="938031"/>
            <a:ext cx="3433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SG" sz="8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37495ED-CA60-410F-8A38-F6EB472279A3}"/>
              </a:ext>
            </a:extLst>
          </p:cNvPr>
          <p:cNvSpPr txBox="1"/>
          <p:nvPr/>
        </p:nvSpPr>
        <p:spPr>
          <a:xfrm>
            <a:off x="4442457" y="938031"/>
            <a:ext cx="3882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G" sz="800" dirty="0">
                <a:latin typeface="Arial" panose="020B0604020202020204" pitchFamily="34" charset="0"/>
                <a:cs typeface="Arial" panose="020B0604020202020204" pitchFamily="34" charset="0"/>
              </a:rPr>
              <a:t>E2V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391F125-0F5F-4428-9FA1-666247CDF415}"/>
              </a:ext>
            </a:extLst>
          </p:cNvPr>
          <p:cNvSpPr txBox="1"/>
          <p:nvPr/>
        </p:nvSpPr>
        <p:spPr>
          <a:xfrm>
            <a:off x="1902583" y="3235515"/>
            <a:ext cx="4427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SG" sz="800" dirty="0">
                <a:latin typeface="Arial" panose="020B0604020202020204" pitchFamily="34" charset="0"/>
                <a:cs typeface="Arial" panose="020B0604020202020204" pitchFamily="34" charset="0"/>
              </a:rPr>
              <a:t>LY6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D58ECB6-5CBE-4E96-910E-83ACCF99056D}"/>
              </a:ext>
            </a:extLst>
          </p:cNvPr>
          <p:cNvSpPr txBox="1"/>
          <p:nvPr/>
        </p:nvSpPr>
        <p:spPr>
          <a:xfrm rot="16200000">
            <a:off x="1621645" y="2934596"/>
            <a:ext cx="5052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SG" sz="800">
                <a:latin typeface="Arial" panose="020B0604020202020204" pitchFamily="34" charset="0"/>
                <a:cs typeface="Arial" panose="020B0604020202020204" pitchFamily="34" charset="0"/>
              </a:rPr>
              <a:t>CD11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2725F03-EEA5-4085-8754-69F5EEB26FC0}"/>
              </a:ext>
            </a:extLst>
          </p:cNvPr>
          <p:cNvSpPr txBox="1"/>
          <p:nvPr/>
        </p:nvSpPr>
        <p:spPr>
          <a:xfrm>
            <a:off x="1934241" y="938031"/>
            <a:ext cx="108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G" sz="800" dirty="0">
                <a:latin typeface="Arial" panose="020B0604020202020204" pitchFamily="34" charset="0"/>
                <a:cs typeface="Arial" panose="020B0604020202020204" pitchFamily="34" charset="0"/>
              </a:rPr>
              <a:t>NO TUMOUR (N.T)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295053A0-4AFB-49E5-8459-EAA147FDC9CC}"/>
              </a:ext>
            </a:extLst>
          </p:cNvPr>
          <p:cNvSpPr/>
          <p:nvPr/>
        </p:nvSpPr>
        <p:spPr>
          <a:xfrm>
            <a:off x="1612038" y="937299"/>
            <a:ext cx="3633924" cy="2501346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SG"/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BC64BAB3-352B-4868-9BF1-4F4738E9D43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5774" t="6833" r="13785" b="16869"/>
          <a:stretch/>
        </p:blipFill>
        <p:spPr>
          <a:xfrm>
            <a:off x="1934241" y="1127292"/>
            <a:ext cx="1080000" cy="1090434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ECE68DD2-225F-443D-BC79-1B4AB218DB2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8419" t="6052" r="9302" b="19052"/>
          <a:stretch/>
        </p:blipFill>
        <p:spPr>
          <a:xfrm>
            <a:off x="3015882" y="2207841"/>
            <a:ext cx="1080000" cy="1071031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E847009F-D2A1-415B-A5AE-A317284959D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2387" t="7044" r="10083" b="19114"/>
          <a:stretch/>
        </p:blipFill>
        <p:spPr>
          <a:xfrm>
            <a:off x="4096581" y="1136993"/>
            <a:ext cx="1080000" cy="1071032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C3E10CC7-B478-4191-A108-FEEE7E271FD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4478" t="5713" r="8963" b="19237"/>
          <a:stretch/>
        </p:blipFill>
        <p:spPr>
          <a:xfrm>
            <a:off x="3015882" y="1136993"/>
            <a:ext cx="1080000" cy="1071032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51B003CD-9A54-4A72-AFE9-40ECEB2D46A0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7298" t="11162" r="8453" b="19407"/>
          <a:stretch/>
        </p:blipFill>
        <p:spPr>
          <a:xfrm>
            <a:off x="1934241" y="2203357"/>
            <a:ext cx="1080000" cy="1079998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377B43A5-A37B-4247-B709-A9C3DFB7EFB7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24747" t="8390" r="9170" b="13360"/>
          <a:stretch/>
        </p:blipFill>
        <p:spPr>
          <a:xfrm>
            <a:off x="4096581" y="2207840"/>
            <a:ext cx="1080000" cy="1071032"/>
          </a:xfrm>
          <a:prstGeom prst="rect">
            <a:avLst/>
          </a:prstGeom>
        </p:spPr>
      </p:pic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13E4E166-E7A9-441F-ACA1-14FD8C18A06E}"/>
              </a:ext>
            </a:extLst>
          </p:cNvPr>
          <p:cNvCxnSpPr/>
          <p:nvPr/>
        </p:nvCxnSpPr>
        <p:spPr>
          <a:xfrm flipV="1">
            <a:off x="1873507" y="3773553"/>
            <a:ext cx="0" cy="1584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6955E9E4-5C9F-46B8-9464-6343F516450D}"/>
              </a:ext>
            </a:extLst>
          </p:cNvPr>
          <p:cNvCxnSpPr/>
          <p:nvPr/>
        </p:nvCxnSpPr>
        <p:spPr>
          <a:xfrm>
            <a:off x="2288406" y="5908019"/>
            <a:ext cx="2772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6AAD734E-06EC-4B05-A30E-BACCE8500ADF}"/>
              </a:ext>
            </a:extLst>
          </p:cNvPr>
          <p:cNvSpPr txBox="1"/>
          <p:nvPr/>
        </p:nvSpPr>
        <p:spPr>
          <a:xfrm rot="16200000">
            <a:off x="1383758" y="5177167"/>
            <a:ext cx="6559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SG" sz="800" dirty="0">
                <a:latin typeface="Arial" panose="020B0604020202020204" pitchFamily="34" charset="0"/>
                <a:cs typeface="Arial" panose="020B0604020202020204" pitchFamily="34" charset="0"/>
              </a:rPr>
              <a:t>Involution 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0F332E5-E7A0-4528-8A16-4C708DE6A426}"/>
              </a:ext>
            </a:extLst>
          </p:cNvPr>
          <p:cNvSpPr txBox="1"/>
          <p:nvPr/>
        </p:nvSpPr>
        <p:spPr>
          <a:xfrm rot="16200000">
            <a:off x="1347690" y="4094624"/>
            <a:ext cx="72808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SG" sz="800" dirty="0">
                <a:latin typeface="Arial" panose="020B0604020202020204" pitchFamily="34" charset="0"/>
                <a:cs typeface="Arial" panose="020B0604020202020204" pitchFamily="34" charset="0"/>
              </a:rPr>
              <a:t>Nulliparous 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F822653-52FC-488A-A24F-30BCA4ACFC50}"/>
              </a:ext>
            </a:extLst>
          </p:cNvPr>
          <p:cNvSpPr txBox="1"/>
          <p:nvPr/>
        </p:nvSpPr>
        <p:spPr>
          <a:xfrm>
            <a:off x="3388499" y="3502813"/>
            <a:ext cx="3433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SG" sz="8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4145A9D-6AA5-4FD6-B5B9-4C9405AC3CC4}"/>
              </a:ext>
            </a:extLst>
          </p:cNvPr>
          <p:cNvSpPr txBox="1"/>
          <p:nvPr/>
        </p:nvSpPr>
        <p:spPr>
          <a:xfrm>
            <a:off x="4456272" y="3502813"/>
            <a:ext cx="3882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G" sz="800" dirty="0">
                <a:latin typeface="Arial" panose="020B0604020202020204" pitchFamily="34" charset="0"/>
                <a:cs typeface="Arial" panose="020B0604020202020204" pitchFamily="34" charset="0"/>
              </a:rPr>
              <a:t>E2V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2A6706B-A3F2-44D1-9725-6171415F77D5}"/>
              </a:ext>
            </a:extLst>
          </p:cNvPr>
          <p:cNvSpPr txBox="1"/>
          <p:nvPr/>
        </p:nvSpPr>
        <p:spPr>
          <a:xfrm>
            <a:off x="1928261" y="5777230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SG" sz="800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D8CA9B4-C688-4124-A2FC-DD2218110765}"/>
              </a:ext>
            </a:extLst>
          </p:cNvPr>
          <p:cNvSpPr txBox="1"/>
          <p:nvPr/>
        </p:nvSpPr>
        <p:spPr>
          <a:xfrm rot="16200000">
            <a:off x="1678582" y="5476311"/>
            <a:ext cx="3898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SG" sz="8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0A130DC8-038C-4EC0-A659-6B1F34CDCC71}"/>
              </a:ext>
            </a:extLst>
          </p:cNvPr>
          <p:cNvSpPr txBox="1"/>
          <p:nvPr/>
        </p:nvSpPr>
        <p:spPr>
          <a:xfrm>
            <a:off x="1941565" y="3502813"/>
            <a:ext cx="108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G" sz="800" dirty="0">
                <a:latin typeface="Arial" panose="020B0604020202020204" pitchFamily="34" charset="0"/>
                <a:cs typeface="Arial" panose="020B0604020202020204" pitchFamily="34" charset="0"/>
              </a:rPr>
              <a:t>NO TUMOUR (N.T)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1B0C173-FA5F-4E1F-B951-2145F84417BF}"/>
              </a:ext>
            </a:extLst>
          </p:cNvPr>
          <p:cNvSpPr txBox="1"/>
          <p:nvPr/>
        </p:nvSpPr>
        <p:spPr>
          <a:xfrm>
            <a:off x="314229" y="6640170"/>
            <a:ext cx="62280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SG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Representative flow cytometry dot plot. </a:t>
            </a:r>
          </a:p>
          <a:p>
            <a:pPr algn="just"/>
            <a:endParaRPr lang="en-SG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SG" sz="1000" dirty="0">
                <a:latin typeface="Arial" panose="020B0604020202020204" pitchFamily="34" charset="0"/>
                <a:cs typeface="Arial" panose="020B0604020202020204" pitchFamily="34" charset="0"/>
              </a:rPr>
              <a:t>A, Circulating monocytes (CD45+CD11b+Ly6G-hi) out of viable CD45+ population. </a:t>
            </a:r>
          </a:p>
          <a:p>
            <a:pPr algn="just"/>
            <a:r>
              <a:rPr lang="en-SG" sz="1000" dirty="0">
                <a:latin typeface="Arial" panose="020B0604020202020204" pitchFamily="34" charset="0"/>
                <a:cs typeface="Arial" panose="020B0604020202020204" pitchFamily="34" charset="0"/>
              </a:rPr>
              <a:t>B, Circulating CD4+ and CD8+ T-cells out of viable CD45+ population. </a:t>
            </a:r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A78E7EB3-42A6-4B50-B4FE-D7AA1A990553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2785" t="2164" r="10882" b="17484"/>
          <a:stretch/>
        </p:blipFill>
        <p:spPr>
          <a:xfrm>
            <a:off x="3020180" y="4765494"/>
            <a:ext cx="1080000" cy="1082844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E436FA36-0A4F-4217-8C4C-8C58C447B1A5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14642" t="3136" r="7742" b="17374"/>
          <a:stretch/>
        </p:blipFill>
        <p:spPr>
          <a:xfrm>
            <a:off x="4110396" y="4765494"/>
            <a:ext cx="1080000" cy="1082840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B4D61F69-3FC0-4460-9936-33E082CA7973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12118" t="2572" r="8939" b="16665"/>
          <a:stretch/>
        </p:blipFill>
        <p:spPr>
          <a:xfrm>
            <a:off x="3020180" y="3690380"/>
            <a:ext cx="1080000" cy="1071860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21108AB5-53C0-4217-9496-2A9BCAA920E7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11512" t="6770" r="16329" b="19006"/>
          <a:stretch/>
        </p:blipFill>
        <p:spPr>
          <a:xfrm>
            <a:off x="4110396" y="3690380"/>
            <a:ext cx="1080000" cy="1071859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7B552A25-6F0B-4EB9-B046-8B1DCEBE035B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14878" t="5365" r="9138" b="18247"/>
          <a:stretch/>
        </p:blipFill>
        <p:spPr>
          <a:xfrm>
            <a:off x="1941565" y="4765494"/>
            <a:ext cx="1080000" cy="1050738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E3369745-D2F4-4FDD-B625-4A7D1D3BE231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18807" t="6057" r="10687" b="19416"/>
          <a:stretch/>
        </p:blipFill>
        <p:spPr>
          <a:xfrm>
            <a:off x="1941565" y="3690380"/>
            <a:ext cx="1080000" cy="1071860"/>
          </a:xfrm>
          <a:prstGeom prst="rect">
            <a:avLst/>
          </a:prstGeom>
        </p:spPr>
      </p:pic>
      <p:sp>
        <p:nvSpPr>
          <p:cNvPr id="44" name="Rectangle 43">
            <a:extLst>
              <a:ext uri="{FF2B5EF4-FFF2-40B4-BE49-F238E27FC236}">
                <a16:creationId xmlns:a16="http://schemas.microsoft.com/office/drawing/2014/main" id="{EF68802B-C8AC-4943-B83F-475FE9A52167}"/>
              </a:ext>
            </a:extLst>
          </p:cNvPr>
          <p:cNvSpPr/>
          <p:nvPr/>
        </p:nvSpPr>
        <p:spPr>
          <a:xfrm>
            <a:off x="1611267" y="3489795"/>
            <a:ext cx="3633924" cy="2501346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SG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1E17B36F-1D33-4106-B8B6-2F0F8BBE9833}"/>
              </a:ext>
            </a:extLst>
          </p:cNvPr>
          <p:cNvSpPr txBox="1"/>
          <p:nvPr/>
        </p:nvSpPr>
        <p:spPr>
          <a:xfrm>
            <a:off x="1616033" y="3492642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SG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EEF87BD-238D-44BE-B33C-3F7048CA9A6E}"/>
              </a:ext>
            </a:extLst>
          </p:cNvPr>
          <p:cNvSpPr txBox="1"/>
          <p:nvPr/>
        </p:nvSpPr>
        <p:spPr>
          <a:xfrm>
            <a:off x="1616033" y="940932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SG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19739443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>
            <a:extLst>
              <a:ext uri="{FF2B5EF4-FFF2-40B4-BE49-F238E27FC236}">
                <a16:creationId xmlns:a16="http://schemas.microsoft.com/office/drawing/2014/main" id="{D84F9112-7388-419B-8840-5BBD25403A1B}"/>
              </a:ext>
            </a:extLst>
          </p:cNvPr>
          <p:cNvGrpSpPr/>
          <p:nvPr/>
        </p:nvGrpSpPr>
        <p:grpSpPr>
          <a:xfrm>
            <a:off x="1648838" y="2316062"/>
            <a:ext cx="3560324" cy="2481789"/>
            <a:chOff x="2575476" y="1401662"/>
            <a:chExt cx="3560324" cy="2481789"/>
          </a:xfrm>
        </p:grpSpPr>
        <p:cxnSp>
          <p:nvCxnSpPr>
            <p:cNvPr id="118" name="Straight Arrow Connector 117">
              <a:extLst>
                <a:ext uri="{FF2B5EF4-FFF2-40B4-BE49-F238E27FC236}">
                  <a16:creationId xmlns:a16="http://schemas.microsoft.com/office/drawing/2014/main" id="{A28B5A27-378F-46B1-BA1F-08519E2A7F33}"/>
                </a:ext>
              </a:extLst>
            </p:cNvPr>
            <p:cNvCxnSpPr/>
            <p:nvPr/>
          </p:nvCxnSpPr>
          <p:spPr>
            <a:xfrm flipV="1">
              <a:off x="2844972" y="1660422"/>
              <a:ext cx="0" cy="15840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Straight Arrow Connector 118">
              <a:extLst>
                <a:ext uri="{FF2B5EF4-FFF2-40B4-BE49-F238E27FC236}">
                  <a16:creationId xmlns:a16="http://schemas.microsoft.com/office/drawing/2014/main" id="{1DFF7467-B3BE-4127-A8FC-8B653DAEF361}"/>
                </a:ext>
              </a:extLst>
            </p:cNvPr>
            <p:cNvCxnSpPr/>
            <p:nvPr/>
          </p:nvCxnSpPr>
          <p:spPr>
            <a:xfrm>
              <a:off x="3266162" y="3775729"/>
              <a:ext cx="2772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FDCD3B8D-A37A-4FD0-927E-A417FD820736}"/>
                </a:ext>
              </a:extLst>
            </p:cNvPr>
            <p:cNvSpPr txBox="1"/>
            <p:nvPr/>
          </p:nvSpPr>
          <p:spPr>
            <a:xfrm rot="16200000">
              <a:off x="2355223" y="3081476"/>
              <a:ext cx="6559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Involution </a:t>
              </a: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C8950F38-8274-49AA-B566-EC7A2FE58322}"/>
                </a:ext>
              </a:extLst>
            </p:cNvPr>
            <p:cNvSpPr txBox="1"/>
            <p:nvPr/>
          </p:nvSpPr>
          <p:spPr>
            <a:xfrm rot="16200000">
              <a:off x="2319156" y="1996338"/>
              <a:ext cx="7280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Nulliparous </a:t>
              </a: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F1B87FB9-D37D-4264-9D00-601230AE8349}"/>
                </a:ext>
              </a:extLst>
            </p:cNvPr>
            <p:cNvSpPr txBox="1"/>
            <p:nvPr/>
          </p:nvSpPr>
          <p:spPr>
            <a:xfrm>
              <a:off x="4349371" y="1401662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C9249BAF-B6B9-4718-95DF-44DC9D17F989}"/>
                </a:ext>
              </a:extLst>
            </p:cNvPr>
            <p:cNvSpPr txBox="1"/>
            <p:nvPr/>
          </p:nvSpPr>
          <p:spPr>
            <a:xfrm>
              <a:off x="5401676" y="1401662"/>
              <a:ext cx="38824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E2V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2D5B0A6F-93A9-4E8D-8C4C-B9C1E9A1D663}"/>
                </a:ext>
              </a:extLst>
            </p:cNvPr>
            <p:cNvSpPr txBox="1"/>
            <p:nvPr/>
          </p:nvSpPr>
          <p:spPr>
            <a:xfrm>
              <a:off x="2870071" y="3668007"/>
              <a:ext cx="4491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SG" sz="800">
                  <a:latin typeface="Arial" panose="020B0604020202020204" pitchFamily="34" charset="0"/>
                  <a:cs typeface="Arial" panose="020B0604020202020204" pitchFamily="34" charset="0"/>
                </a:rPr>
                <a:t>LY6G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E1ED3D26-2C26-46A7-A796-1C263B061B22}"/>
                </a:ext>
              </a:extLst>
            </p:cNvPr>
            <p:cNvSpPr txBox="1"/>
            <p:nvPr/>
          </p:nvSpPr>
          <p:spPr>
            <a:xfrm rot="16200000">
              <a:off x="2592339" y="3363180"/>
              <a:ext cx="50526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SG" sz="800">
                  <a:latin typeface="Arial" panose="020B0604020202020204" pitchFamily="34" charset="0"/>
                  <a:cs typeface="Arial" panose="020B0604020202020204" pitchFamily="34" charset="0"/>
                </a:rPr>
                <a:t>CD11b</a:t>
              </a: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BEC0D342-5CFD-4935-B1B3-788FD5FB6E68}"/>
                </a:ext>
              </a:extLst>
            </p:cNvPr>
            <p:cNvSpPr txBox="1"/>
            <p:nvPr/>
          </p:nvSpPr>
          <p:spPr>
            <a:xfrm>
              <a:off x="2909734" y="1401662"/>
              <a:ext cx="1080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SG" sz="800" dirty="0">
                  <a:latin typeface="Arial" panose="020B0604020202020204" pitchFamily="34" charset="0"/>
                  <a:cs typeface="Arial" panose="020B0604020202020204" pitchFamily="34" charset="0"/>
                </a:rPr>
                <a:t>NO TUMOUR (N.T)</a:t>
              </a:r>
            </a:p>
          </p:txBody>
        </p:sp>
        <p:pic>
          <p:nvPicPr>
            <p:cNvPr id="65" name="Picture 64">
              <a:extLst>
                <a:ext uri="{FF2B5EF4-FFF2-40B4-BE49-F238E27FC236}">
                  <a16:creationId xmlns:a16="http://schemas.microsoft.com/office/drawing/2014/main" id="{80A59F2F-FE41-49A5-9D58-FFA27DFB6C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2594" t="20118" r="7280" b="13688"/>
            <a:stretch/>
          </p:blipFill>
          <p:spPr>
            <a:xfrm>
              <a:off x="2903615" y="2646095"/>
              <a:ext cx="1080000" cy="1086207"/>
            </a:xfrm>
            <a:prstGeom prst="rect">
              <a:avLst/>
            </a:prstGeom>
          </p:spPr>
        </p:pic>
        <p:pic>
          <p:nvPicPr>
            <p:cNvPr id="66" name="Picture 65">
              <a:extLst>
                <a:ext uri="{FF2B5EF4-FFF2-40B4-BE49-F238E27FC236}">
                  <a16:creationId xmlns:a16="http://schemas.microsoft.com/office/drawing/2014/main" id="{19E090FE-2149-4319-B1C7-CE57277CDCF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7465" t="21892" r="4986" b="14685"/>
            <a:stretch/>
          </p:blipFill>
          <p:spPr>
            <a:xfrm>
              <a:off x="5055800" y="1557854"/>
              <a:ext cx="1080000" cy="1092413"/>
            </a:xfrm>
            <a:prstGeom prst="rect">
              <a:avLst/>
            </a:prstGeom>
          </p:spPr>
        </p:pic>
        <p:pic>
          <p:nvPicPr>
            <p:cNvPr id="67" name="Picture 66">
              <a:extLst>
                <a:ext uri="{FF2B5EF4-FFF2-40B4-BE49-F238E27FC236}">
                  <a16:creationId xmlns:a16="http://schemas.microsoft.com/office/drawing/2014/main" id="{1AEB5FFD-BD53-41DA-945C-6BD6140FCA7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8241" t="22489" r="11809" b="14525"/>
            <a:stretch/>
          </p:blipFill>
          <p:spPr>
            <a:xfrm>
              <a:off x="3981054" y="1564060"/>
              <a:ext cx="1080000" cy="1080001"/>
            </a:xfrm>
            <a:prstGeom prst="rect">
              <a:avLst/>
            </a:prstGeom>
          </p:spPr>
        </p:pic>
        <p:pic>
          <p:nvPicPr>
            <p:cNvPr id="68" name="Picture 67">
              <a:extLst>
                <a:ext uri="{FF2B5EF4-FFF2-40B4-BE49-F238E27FC236}">
                  <a16:creationId xmlns:a16="http://schemas.microsoft.com/office/drawing/2014/main" id="{9139534B-3A97-436D-B381-8C5B51F4B78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6776" t="18155" r="6722" b="13884"/>
            <a:stretch/>
          </p:blipFill>
          <p:spPr>
            <a:xfrm>
              <a:off x="5055800" y="2649198"/>
              <a:ext cx="1080000" cy="1080000"/>
            </a:xfrm>
            <a:prstGeom prst="rect">
              <a:avLst/>
            </a:prstGeom>
          </p:spPr>
        </p:pic>
        <p:pic>
          <p:nvPicPr>
            <p:cNvPr id="70" name="Picture 69">
              <a:extLst>
                <a:ext uri="{FF2B5EF4-FFF2-40B4-BE49-F238E27FC236}">
                  <a16:creationId xmlns:a16="http://schemas.microsoft.com/office/drawing/2014/main" id="{E59A8BF8-F50C-4FC8-BC47-66762511C09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20753" t="18224" r="4408" b="16355"/>
            <a:stretch/>
          </p:blipFill>
          <p:spPr>
            <a:xfrm>
              <a:off x="3981054" y="2646095"/>
              <a:ext cx="1080000" cy="1086207"/>
            </a:xfrm>
            <a:prstGeom prst="rect">
              <a:avLst/>
            </a:prstGeom>
          </p:spPr>
        </p:pic>
        <p:pic>
          <p:nvPicPr>
            <p:cNvPr id="71" name="Picture 70">
              <a:extLst>
                <a:ext uri="{FF2B5EF4-FFF2-40B4-BE49-F238E27FC236}">
                  <a16:creationId xmlns:a16="http://schemas.microsoft.com/office/drawing/2014/main" id="{F9EDBE06-E3ED-4F7C-BDED-AEBFCF2A04F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21232" t="23978" r="9409" b="14484"/>
            <a:stretch/>
          </p:blipFill>
          <p:spPr>
            <a:xfrm>
              <a:off x="2903615" y="1567129"/>
              <a:ext cx="1080000" cy="1073863"/>
            </a:xfrm>
            <a:prstGeom prst="rect">
              <a:avLst/>
            </a:prstGeom>
          </p:spPr>
        </p:pic>
      </p:grpSp>
      <p:sp>
        <p:nvSpPr>
          <p:cNvPr id="239" name="TextBox 238">
            <a:extLst>
              <a:ext uri="{FF2B5EF4-FFF2-40B4-BE49-F238E27FC236}">
                <a16:creationId xmlns:a16="http://schemas.microsoft.com/office/drawing/2014/main" id="{8B2133BF-0AB1-4213-B5E1-A8C9B7AF17DC}"/>
              </a:ext>
            </a:extLst>
          </p:cNvPr>
          <p:cNvSpPr txBox="1"/>
          <p:nvPr/>
        </p:nvSpPr>
        <p:spPr>
          <a:xfrm>
            <a:off x="332247" y="5602400"/>
            <a:ext cx="622273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SG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. Representative flow cytometry dot plot of circulating LDN out of viable CD45+ population of the </a:t>
            </a:r>
            <a:r>
              <a:rPr lang="en-SG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ercoll</a:t>
            </a:r>
            <a:r>
              <a:rPr lang="en-SG" sz="1000" b="1" dirty="0">
                <a:latin typeface="Arial" panose="020B0604020202020204" pitchFamily="34" charset="0"/>
                <a:cs typeface="Arial" panose="020B0604020202020204" pitchFamily="34" charset="0"/>
              </a:rPr>
              <a:t> isolated mononuclear cell fraction from blood. </a:t>
            </a:r>
          </a:p>
        </p:txBody>
      </p:sp>
      <p:sp>
        <p:nvSpPr>
          <p:cNvPr id="103" name="Rectangle 102">
            <a:extLst>
              <a:ext uri="{FF2B5EF4-FFF2-40B4-BE49-F238E27FC236}">
                <a16:creationId xmlns:a16="http://schemas.microsoft.com/office/drawing/2014/main" id="{06D3E3ED-62D7-4161-925E-5441D934A19F}"/>
              </a:ext>
            </a:extLst>
          </p:cNvPr>
          <p:cNvSpPr/>
          <p:nvPr/>
        </p:nvSpPr>
        <p:spPr>
          <a:xfrm>
            <a:off x="1636947" y="2307729"/>
            <a:ext cx="3633924" cy="2501346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8968269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245</TotalTime>
  <Words>370</Words>
  <Application>Microsoft Office PowerPoint</Application>
  <PresentationFormat>A4 Paper (210x297 mm)</PresentationFormat>
  <Paragraphs>86</Paragraphs>
  <Slides>5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hesis outline</dc:title>
  <dc:creator>Chew Leng Lim</dc:creator>
  <cp:lastModifiedBy>Chew Leng Lim</cp:lastModifiedBy>
  <cp:revision>13</cp:revision>
  <dcterms:created xsi:type="dcterms:W3CDTF">2019-03-10T05:37:26Z</dcterms:created>
  <dcterms:modified xsi:type="dcterms:W3CDTF">2021-08-02T07:40:54Z</dcterms:modified>
</cp:coreProperties>
</file>